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52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891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8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47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280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455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77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594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03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419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54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505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582F1-A721-4DA1-AACB-B41E3E8BF30E}" type="datetimeFigureOut">
              <a:rPr lang="en-US" smtClean="0"/>
              <a:t>1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15438-42E1-490E-9D2E-6D8526EAC5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250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040525" y="2498321"/>
            <a:ext cx="4329545" cy="4094018"/>
            <a:chOff x="1040525" y="2498321"/>
            <a:chExt cx="4329545" cy="4094018"/>
          </a:xfrm>
        </p:grpSpPr>
        <p:grpSp>
          <p:nvGrpSpPr>
            <p:cNvPr id="99" name="Group 98"/>
            <p:cNvGrpSpPr/>
            <p:nvPr/>
          </p:nvGrpSpPr>
          <p:grpSpPr>
            <a:xfrm>
              <a:off x="1040525" y="2498321"/>
              <a:ext cx="4329545" cy="4094018"/>
              <a:chOff x="971945" y="2467841"/>
              <a:chExt cx="4329545" cy="4094018"/>
            </a:xfrm>
          </p:grpSpPr>
          <p:grpSp>
            <p:nvGrpSpPr>
              <p:cNvPr id="97" name="Group 96"/>
              <p:cNvGrpSpPr>
                <a:grpSpLocks noChangeAspect="1"/>
              </p:cNvGrpSpPr>
              <p:nvPr/>
            </p:nvGrpSpPr>
            <p:grpSpPr>
              <a:xfrm>
                <a:off x="1015433" y="2491153"/>
                <a:ext cx="4233403" cy="3937963"/>
                <a:chOff x="1015433" y="2491153"/>
                <a:chExt cx="4233403" cy="3937963"/>
              </a:xfrm>
            </p:grpSpPr>
            <p:grpSp>
              <p:nvGrpSpPr>
                <p:cNvPr id="42" name="Group 41"/>
                <p:cNvGrpSpPr>
                  <a:grpSpLocks noChangeAspect="1"/>
                </p:cNvGrpSpPr>
                <p:nvPr/>
              </p:nvGrpSpPr>
              <p:grpSpPr>
                <a:xfrm>
                  <a:off x="1015433" y="2555456"/>
                  <a:ext cx="963160" cy="1020014"/>
                  <a:chOff x="1611313" y="2995613"/>
                  <a:chExt cx="3657600" cy="3873500"/>
                </a:xfrm>
              </p:grpSpPr>
              <p:sp>
                <p:nvSpPr>
                  <p:cNvPr id="8" name="Freeform 7"/>
                  <p:cNvSpPr>
                    <a:spLocks/>
                  </p:cNvSpPr>
                  <p:nvPr/>
                </p:nvSpPr>
                <p:spPr bwMode="auto">
                  <a:xfrm>
                    <a:off x="1611313" y="2995613"/>
                    <a:ext cx="3657600" cy="3873500"/>
                  </a:xfrm>
                  <a:custGeom>
                    <a:avLst/>
                    <a:gdLst>
                      <a:gd name="T0" fmla="*/ 1527 w 2304"/>
                      <a:gd name="T1" fmla="*/ 215 h 2440"/>
                      <a:gd name="T2" fmla="*/ 1349 w 2304"/>
                      <a:gd name="T3" fmla="*/ 176 h 2440"/>
                      <a:gd name="T4" fmla="*/ 1243 w 2304"/>
                      <a:gd name="T5" fmla="*/ 216 h 2440"/>
                      <a:gd name="T6" fmla="*/ 1099 w 2304"/>
                      <a:gd name="T7" fmla="*/ 186 h 2440"/>
                      <a:gd name="T8" fmla="*/ 962 w 2304"/>
                      <a:gd name="T9" fmla="*/ 129 h 2440"/>
                      <a:gd name="T10" fmla="*/ 961 w 2304"/>
                      <a:gd name="T11" fmla="*/ 51 h 2440"/>
                      <a:gd name="T12" fmla="*/ 904 w 2304"/>
                      <a:gd name="T13" fmla="*/ 16 h 2440"/>
                      <a:gd name="T14" fmla="*/ 792 w 2304"/>
                      <a:gd name="T15" fmla="*/ 10 h 2440"/>
                      <a:gd name="T16" fmla="*/ 613 w 2304"/>
                      <a:gd name="T17" fmla="*/ 47 h 2440"/>
                      <a:gd name="T18" fmla="*/ 522 w 2304"/>
                      <a:gd name="T19" fmla="*/ 53 h 2440"/>
                      <a:gd name="T20" fmla="*/ 430 w 2304"/>
                      <a:gd name="T21" fmla="*/ 92 h 2440"/>
                      <a:gd name="T22" fmla="*/ 329 w 2304"/>
                      <a:gd name="T23" fmla="*/ 199 h 2440"/>
                      <a:gd name="T24" fmla="*/ 192 w 2304"/>
                      <a:gd name="T25" fmla="*/ 307 h 2440"/>
                      <a:gd name="T26" fmla="*/ 37 w 2304"/>
                      <a:gd name="T27" fmla="*/ 491 h 2440"/>
                      <a:gd name="T28" fmla="*/ 53 w 2304"/>
                      <a:gd name="T29" fmla="*/ 600 h 2440"/>
                      <a:gd name="T30" fmla="*/ 4 w 2304"/>
                      <a:gd name="T31" fmla="*/ 746 h 2440"/>
                      <a:gd name="T32" fmla="*/ 12 w 2304"/>
                      <a:gd name="T33" fmla="*/ 833 h 2440"/>
                      <a:gd name="T34" fmla="*/ 81 w 2304"/>
                      <a:gd name="T35" fmla="*/ 901 h 2440"/>
                      <a:gd name="T36" fmla="*/ 133 w 2304"/>
                      <a:gd name="T37" fmla="*/ 995 h 2440"/>
                      <a:gd name="T38" fmla="*/ 203 w 2304"/>
                      <a:gd name="T39" fmla="*/ 1050 h 2440"/>
                      <a:gd name="T40" fmla="*/ 290 w 2304"/>
                      <a:gd name="T41" fmla="*/ 1110 h 2440"/>
                      <a:gd name="T42" fmla="*/ 474 w 2304"/>
                      <a:gd name="T43" fmla="*/ 1092 h 2440"/>
                      <a:gd name="T44" fmla="*/ 588 w 2304"/>
                      <a:gd name="T45" fmla="*/ 1050 h 2440"/>
                      <a:gd name="T46" fmla="*/ 666 w 2304"/>
                      <a:gd name="T47" fmla="*/ 1040 h 2440"/>
                      <a:gd name="T48" fmla="*/ 798 w 2304"/>
                      <a:gd name="T49" fmla="*/ 1105 h 2440"/>
                      <a:gd name="T50" fmla="*/ 887 w 2304"/>
                      <a:gd name="T51" fmla="*/ 1185 h 2440"/>
                      <a:gd name="T52" fmla="*/ 882 w 2304"/>
                      <a:gd name="T53" fmla="*/ 1250 h 2440"/>
                      <a:gd name="T54" fmla="*/ 883 w 2304"/>
                      <a:gd name="T55" fmla="*/ 1347 h 2440"/>
                      <a:gd name="T56" fmla="*/ 961 w 2304"/>
                      <a:gd name="T57" fmla="*/ 1430 h 2440"/>
                      <a:gd name="T58" fmla="*/ 1006 w 2304"/>
                      <a:gd name="T59" fmla="*/ 1575 h 2440"/>
                      <a:gd name="T60" fmla="*/ 989 w 2304"/>
                      <a:gd name="T61" fmla="*/ 1721 h 2440"/>
                      <a:gd name="T62" fmla="*/ 963 w 2304"/>
                      <a:gd name="T63" fmla="*/ 1828 h 2440"/>
                      <a:gd name="T64" fmla="*/ 1018 w 2304"/>
                      <a:gd name="T65" fmla="*/ 1959 h 2440"/>
                      <a:gd name="T66" fmla="*/ 1072 w 2304"/>
                      <a:gd name="T67" fmla="*/ 2110 h 2440"/>
                      <a:gd name="T68" fmla="*/ 1130 w 2304"/>
                      <a:gd name="T69" fmla="*/ 2237 h 2440"/>
                      <a:gd name="T70" fmla="*/ 1191 w 2304"/>
                      <a:gd name="T71" fmla="*/ 2355 h 2440"/>
                      <a:gd name="T72" fmla="*/ 1198 w 2304"/>
                      <a:gd name="T73" fmla="*/ 2420 h 2440"/>
                      <a:gd name="T74" fmla="*/ 1324 w 2304"/>
                      <a:gd name="T75" fmla="*/ 2415 h 2440"/>
                      <a:gd name="T76" fmla="*/ 1427 w 2304"/>
                      <a:gd name="T77" fmla="*/ 2403 h 2440"/>
                      <a:gd name="T78" fmla="*/ 1561 w 2304"/>
                      <a:gd name="T79" fmla="*/ 2316 h 2440"/>
                      <a:gd name="T80" fmla="*/ 1667 w 2304"/>
                      <a:gd name="T81" fmla="*/ 2130 h 2440"/>
                      <a:gd name="T82" fmla="*/ 1733 w 2304"/>
                      <a:gd name="T83" fmla="*/ 1995 h 2440"/>
                      <a:gd name="T84" fmla="*/ 1792 w 2304"/>
                      <a:gd name="T85" fmla="*/ 1904 h 2440"/>
                      <a:gd name="T86" fmla="*/ 1929 w 2304"/>
                      <a:gd name="T87" fmla="*/ 1800 h 2440"/>
                      <a:gd name="T88" fmla="*/ 1935 w 2304"/>
                      <a:gd name="T89" fmla="*/ 1668 h 2440"/>
                      <a:gd name="T90" fmla="*/ 1904 w 2304"/>
                      <a:gd name="T91" fmla="*/ 1562 h 2440"/>
                      <a:gd name="T92" fmla="*/ 1890 w 2304"/>
                      <a:gd name="T93" fmla="*/ 1470 h 2440"/>
                      <a:gd name="T94" fmla="*/ 1957 w 2304"/>
                      <a:gd name="T95" fmla="*/ 1351 h 2440"/>
                      <a:gd name="T96" fmla="*/ 2207 w 2304"/>
                      <a:gd name="T97" fmla="*/ 1104 h 2440"/>
                      <a:gd name="T98" fmla="*/ 2299 w 2304"/>
                      <a:gd name="T99" fmla="*/ 879 h 2440"/>
                      <a:gd name="T100" fmla="*/ 2195 w 2304"/>
                      <a:gd name="T101" fmla="*/ 870 h 2440"/>
                      <a:gd name="T102" fmla="*/ 2055 w 2304"/>
                      <a:gd name="T103" fmla="*/ 886 h 2440"/>
                      <a:gd name="T104" fmla="*/ 2014 w 2304"/>
                      <a:gd name="T105" fmla="*/ 854 h 2440"/>
                      <a:gd name="T106" fmla="*/ 1970 w 2304"/>
                      <a:gd name="T107" fmla="*/ 773 h 2440"/>
                      <a:gd name="T108" fmla="*/ 1862 w 2304"/>
                      <a:gd name="T109" fmla="*/ 639 h 2440"/>
                      <a:gd name="T110" fmla="*/ 1780 w 2304"/>
                      <a:gd name="T111" fmla="*/ 494 h 2440"/>
                      <a:gd name="T112" fmla="*/ 1722 w 2304"/>
                      <a:gd name="T113" fmla="*/ 409 h 2440"/>
                      <a:gd name="T114" fmla="*/ 1624 w 2304"/>
                      <a:gd name="T115" fmla="*/ 248 h 2440"/>
                      <a:gd name="T116" fmla="*/ 1693 w 2304"/>
                      <a:gd name="T117" fmla="*/ 294 h 2440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  <a:cxn ang="0">
                        <a:pos x="T110" y="T111"/>
                      </a:cxn>
                      <a:cxn ang="0">
                        <a:pos x="T112" y="T113"/>
                      </a:cxn>
                      <a:cxn ang="0">
                        <a:pos x="T114" y="T115"/>
                      </a:cxn>
                      <a:cxn ang="0">
                        <a:pos x="T116" y="T117"/>
                      </a:cxn>
                    </a:cxnLst>
                    <a:rect l="0" t="0" r="r" b="b"/>
                    <a:pathLst>
                      <a:path w="2304" h="2440">
                        <a:moveTo>
                          <a:pt x="1679" y="197"/>
                        </a:moveTo>
                        <a:lnTo>
                          <a:pt x="1652" y="204"/>
                        </a:lnTo>
                        <a:lnTo>
                          <a:pt x="1625" y="208"/>
                        </a:lnTo>
                        <a:lnTo>
                          <a:pt x="1604" y="199"/>
                        </a:lnTo>
                        <a:lnTo>
                          <a:pt x="1587" y="190"/>
                        </a:lnTo>
                        <a:lnTo>
                          <a:pt x="1547" y="202"/>
                        </a:lnTo>
                        <a:lnTo>
                          <a:pt x="1527" y="215"/>
                        </a:lnTo>
                        <a:lnTo>
                          <a:pt x="1500" y="208"/>
                        </a:lnTo>
                        <a:lnTo>
                          <a:pt x="1484" y="212"/>
                        </a:lnTo>
                        <a:lnTo>
                          <a:pt x="1430" y="192"/>
                        </a:lnTo>
                        <a:lnTo>
                          <a:pt x="1416" y="197"/>
                        </a:lnTo>
                        <a:lnTo>
                          <a:pt x="1396" y="197"/>
                        </a:lnTo>
                        <a:lnTo>
                          <a:pt x="1395" y="183"/>
                        </a:lnTo>
                        <a:lnTo>
                          <a:pt x="1349" y="176"/>
                        </a:lnTo>
                        <a:lnTo>
                          <a:pt x="1336" y="169"/>
                        </a:lnTo>
                        <a:lnTo>
                          <a:pt x="1328" y="155"/>
                        </a:lnTo>
                        <a:lnTo>
                          <a:pt x="1280" y="153"/>
                        </a:lnTo>
                        <a:lnTo>
                          <a:pt x="1253" y="161"/>
                        </a:lnTo>
                        <a:lnTo>
                          <a:pt x="1238" y="184"/>
                        </a:lnTo>
                        <a:lnTo>
                          <a:pt x="1244" y="201"/>
                        </a:lnTo>
                        <a:lnTo>
                          <a:pt x="1243" y="216"/>
                        </a:lnTo>
                        <a:lnTo>
                          <a:pt x="1228" y="234"/>
                        </a:lnTo>
                        <a:lnTo>
                          <a:pt x="1206" y="240"/>
                        </a:lnTo>
                        <a:lnTo>
                          <a:pt x="1182" y="219"/>
                        </a:lnTo>
                        <a:lnTo>
                          <a:pt x="1147" y="206"/>
                        </a:lnTo>
                        <a:lnTo>
                          <a:pt x="1127" y="205"/>
                        </a:lnTo>
                        <a:lnTo>
                          <a:pt x="1109" y="199"/>
                        </a:lnTo>
                        <a:lnTo>
                          <a:pt x="1099" y="186"/>
                        </a:lnTo>
                        <a:lnTo>
                          <a:pt x="1098" y="169"/>
                        </a:lnTo>
                        <a:lnTo>
                          <a:pt x="1073" y="164"/>
                        </a:lnTo>
                        <a:lnTo>
                          <a:pt x="1050" y="151"/>
                        </a:lnTo>
                        <a:lnTo>
                          <a:pt x="1004" y="150"/>
                        </a:lnTo>
                        <a:lnTo>
                          <a:pt x="982" y="140"/>
                        </a:lnTo>
                        <a:lnTo>
                          <a:pt x="972" y="139"/>
                        </a:lnTo>
                        <a:lnTo>
                          <a:pt x="962" y="129"/>
                        </a:lnTo>
                        <a:lnTo>
                          <a:pt x="947" y="124"/>
                        </a:lnTo>
                        <a:lnTo>
                          <a:pt x="936" y="111"/>
                        </a:lnTo>
                        <a:lnTo>
                          <a:pt x="947" y="95"/>
                        </a:lnTo>
                        <a:lnTo>
                          <a:pt x="966" y="85"/>
                        </a:lnTo>
                        <a:lnTo>
                          <a:pt x="972" y="70"/>
                        </a:lnTo>
                        <a:lnTo>
                          <a:pt x="975" y="54"/>
                        </a:lnTo>
                        <a:lnTo>
                          <a:pt x="961" y="51"/>
                        </a:lnTo>
                        <a:lnTo>
                          <a:pt x="961" y="34"/>
                        </a:lnTo>
                        <a:lnTo>
                          <a:pt x="976" y="16"/>
                        </a:lnTo>
                        <a:lnTo>
                          <a:pt x="959" y="17"/>
                        </a:lnTo>
                        <a:lnTo>
                          <a:pt x="950" y="7"/>
                        </a:lnTo>
                        <a:lnTo>
                          <a:pt x="940" y="0"/>
                        </a:lnTo>
                        <a:lnTo>
                          <a:pt x="928" y="7"/>
                        </a:lnTo>
                        <a:lnTo>
                          <a:pt x="904" y="16"/>
                        </a:lnTo>
                        <a:lnTo>
                          <a:pt x="889" y="15"/>
                        </a:lnTo>
                        <a:lnTo>
                          <a:pt x="877" y="3"/>
                        </a:lnTo>
                        <a:lnTo>
                          <a:pt x="858" y="12"/>
                        </a:lnTo>
                        <a:lnTo>
                          <a:pt x="843" y="5"/>
                        </a:lnTo>
                        <a:lnTo>
                          <a:pt x="831" y="15"/>
                        </a:lnTo>
                        <a:lnTo>
                          <a:pt x="808" y="21"/>
                        </a:lnTo>
                        <a:lnTo>
                          <a:pt x="792" y="10"/>
                        </a:lnTo>
                        <a:lnTo>
                          <a:pt x="766" y="9"/>
                        </a:lnTo>
                        <a:lnTo>
                          <a:pt x="733" y="13"/>
                        </a:lnTo>
                        <a:lnTo>
                          <a:pt x="710" y="17"/>
                        </a:lnTo>
                        <a:lnTo>
                          <a:pt x="685" y="16"/>
                        </a:lnTo>
                        <a:lnTo>
                          <a:pt x="647" y="39"/>
                        </a:lnTo>
                        <a:lnTo>
                          <a:pt x="633" y="35"/>
                        </a:lnTo>
                        <a:lnTo>
                          <a:pt x="613" y="47"/>
                        </a:lnTo>
                        <a:lnTo>
                          <a:pt x="596" y="65"/>
                        </a:lnTo>
                        <a:lnTo>
                          <a:pt x="588" y="62"/>
                        </a:lnTo>
                        <a:lnTo>
                          <a:pt x="582" y="53"/>
                        </a:lnTo>
                        <a:lnTo>
                          <a:pt x="568" y="59"/>
                        </a:lnTo>
                        <a:lnTo>
                          <a:pt x="559" y="49"/>
                        </a:lnTo>
                        <a:lnTo>
                          <a:pt x="542" y="49"/>
                        </a:lnTo>
                        <a:lnTo>
                          <a:pt x="522" y="53"/>
                        </a:lnTo>
                        <a:lnTo>
                          <a:pt x="509" y="47"/>
                        </a:lnTo>
                        <a:lnTo>
                          <a:pt x="497" y="34"/>
                        </a:lnTo>
                        <a:lnTo>
                          <a:pt x="490" y="23"/>
                        </a:lnTo>
                        <a:lnTo>
                          <a:pt x="479" y="24"/>
                        </a:lnTo>
                        <a:lnTo>
                          <a:pt x="467" y="46"/>
                        </a:lnTo>
                        <a:lnTo>
                          <a:pt x="453" y="72"/>
                        </a:lnTo>
                        <a:lnTo>
                          <a:pt x="430" y="92"/>
                        </a:lnTo>
                        <a:lnTo>
                          <a:pt x="412" y="100"/>
                        </a:lnTo>
                        <a:lnTo>
                          <a:pt x="395" y="104"/>
                        </a:lnTo>
                        <a:lnTo>
                          <a:pt x="377" y="111"/>
                        </a:lnTo>
                        <a:lnTo>
                          <a:pt x="358" y="126"/>
                        </a:lnTo>
                        <a:lnTo>
                          <a:pt x="348" y="144"/>
                        </a:lnTo>
                        <a:lnTo>
                          <a:pt x="328" y="168"/>
                        </a:lnTo>
                        <a:lnTo>
                          <a:pt x="329" y="199"/>
                        </a:lnTo>
                        <a:lnTo>
                          <a:pt x="321" y="215"/>
                        </a:lnTo>
                        <a:lnTo>
                          <a:pt x="296" y="243"/>
                        </a:lnTo>
                        <a:lnTo>
                          <a:pt x="252" y="266"/>
                        </a:lnTo>
                        <a:lnTo>
                          <a:pt x="235" y="273"/>
                        </a:lnTo>
                        <a:lnTo>
                          <a:pt x="215" y="276"/>
                        </a:lnTo>
                        <a:lnTo>
                          <a:pt x="209" y="285"/>
                        </a:lnTo>
                        <a:lnTo>
                          <a:pt x="192" y="307"/>
                        </a:lnTo>
                        <a:lnTo>
                          <a:pt x="177" y="321"/>
                        </a:lnTo>
                        <a:lnTo>
                          <a:pt x="158" y="328"/>
                        </a:lnTo>
                        <a:lnTo>
                          <a:pt x="137" y="358"/>
                        </a:lnTo>
                        <a:lnTo>
                          <a:pt x="132" y="382"/>
                        </a:lnTo>
                        <a:lnTo>
                          <a:pt x="94" y="416"/>
                        </a:lnTo>
                        <a:lnTo>
                          <a:pt x="68" y="456"/>
                        </a:lnTo>
                        <a:lnTo>
                          <a:pt x="37" y="491"/>
                        </a:lnTo>
                        <a:lnTo>
                          <a:pt x="45" y="500"/>
                        </a:lnTo>
                        <a:lnTo>
                          <a:pt x="48" y="523"/>
                        </a:lnTo>
                        <a:lnTo>
                          <a:pt x="62" y="536"/>
                        </a:lnTo>
                        <a:lnTo>
                          <a:pt x="60" y="551"/>
                        </a:lnTo>
                        <a:lnTo>
                          <a:pt x="46" y="565"/>
                        </a:lnTo>
                        <a:lnTo>
                          <a:pt x="54" y="585"/>
                        </a:lnTo>
                        <a:lnTo>
                          <a:pt x="53" y="600"/>
                        </a:lnTo>
                        <a:lnTo>
                          <a:pt x="46" y="632"/>
                        </a:lnTo>
                        <a:lnTo>
                          <a:pt x="34" y="664"/>
                        </a:lnTo>
                        <a:lnTo>
                          <a:pt x="33" y="675"/>
                        </a:lnTo>
                        <a:lnTo>
                          <a:pt x="22" y="684"/>
                        </a:lnTo>
                        <a:lnTo>
                          <a:pt x="11" y="714"/>
                        </a:lnTo>
                        <a:lnTo>
                          <a:pt x="1" y="724"/>
                        </a:lnTo>
                        <a:lnTo>
                          <a:pt x="4" y="746"/>
                        </a:lnTo>
                        <a:lnTo>
                          <a:pt x="14" y="751"/>
                        </a:lnTo>
                        <a:lnTo>
                          <a:pt x="17" y="761"/>
                        </a:lnTo>
                        <a:lnTo>
                          <a:pt x="11" y="777"/>
                        </a:lnTo>
                        <a:lnTo>
                          <a:pt x="4" y="788"/>
                        </a:lnTo>
                        <a:lnTo>
                          <a:pt x="0" y="799"/>
                        </a:lnTo>
                        <a:lnTo>
                          <a:pt x="4" y="813"/>
                        </a:lnTo>
                        <a:lnTo>
                          <a:pt x="12" y="833"/>
                        </a:lnTo>
                        <a:lnTo>
                          <a:pt x="33" y="833"/>
                        </a:lnTo>
                        <a:lnTo>
                          <a:pt x="41" y="842"/>
                        </a:lnTo>
                        <a:lnTo>
                          <a:pt x="42" y="858"/>
                        </a:lnTo>
                        <a:lnTo>
                          <a:pt x="58" y="868"/>
                        </a:lnTo>
                        <a:lnTo>
                          <a:pt x="66" y="877"/>
                        </a:lnTo>
                        <a:lnTo>
                          <a:pt x="66" y="891"/>
                        </a:lnTo>
                        <a:lnTo>
                          <a:pt x="81" y="901"/>
                        </a:lnTo>
                        <a:lnTo>
                          <a:pt x="92" y="913"/>
                        </a:lnTo>
                        <a:lnTo>
                          <a:pt x="106" y="921"/>
                        </a:lnTo>
                        <a:lnTo>
                          <a:pt x="114" y="936"/>
                        </a:lnTo>
                        <a:lnTo>
                          <a:pt x="121" y="949"/>
                        </a:lnTo>
                        <a:lnTo>
                          <a:pt x="108" y="959"/>
                        </a:lnTo>
                        <a:lnTo>
                          <a:pt x="119" y="984"/>
                        </a:lnTo>
                        <a:lnTo>
                          <a:pt x="133" y="995"/>
                        </a:lnTo>
                        <a:lnTo>
                          <a:pt x="145" y="1006"/>
                        </a:lnTo>
                        <a:lnTo>
                          <a:pt x="154" y="1014"/>
                        </a:lnTo>
                        <a:lnTo>
                          <a:pt x="162" y="1014"/>
                        </a:lnTo>
                        <a:lnTo>
                          <a:pt x="167" y="1027"/>
                        </a:lnTo>
                        <a:lnTo>
                          <a:pt x="180" y="1029"/>
                        </a:lnTo>
                        <a:lnTo>
                          <a:pt x="190" y="1036"/>
                        </a:lnTo>
                        <a:lnTo>
                          <a:pt x="203" y="1050"/>
                        </a:lnTo>
                        <a:lnTo>
                          <a:pt x="213" y="1054"/>
                        </a:lnTo>
                        <a:lnTo>
                          <a:pt x="229" y="1079"/>
                        </a:lnTo>
                        <a:lnTo>
                          <a:pt x="241" y="1087"/>
                        </a:lnTo>
                        <a:lnTo>
                          <a:pt x="248" y="1088"/>
                        </a:lnTo>
                        <a:lnTo>
                          <a:pt x="258" y="1097"/>
                        </a:lnTo>
                        <a:lnTo>
                          <a:pt x="280" y="1104"/>
                        </a:lnTo>
                        <a:lnTo>
                          <a:pt x="290" y="1110"/>
                        </a:lnTo>
                        <a:lnTo>
                          <a:pt x="341" y="1089"/>
                        </a:lnTo>
                        <a:lnTo>
                          <a:pt x="383" y="1081"/>
                        </a:lnTo>
                        <a:lnTo>
                          <a:pt x="409" y="1083"/>
                        </a:lnTo>
                        <a:lnTo>
                          <a:pt x="439" y="1078"/>
                        </a:lnTo>
                        <a:lnTo>
                          <a:pt x="458" y="1079"/>
                        </a:lnTo>
                        <a:lnTo>
                          <a:pt x="463" y="1087"/>
                        </a:lnTo>
                        <a:lnTo>
                          <a:pt x="474" y="1092"/>
                        </a:lnTo>
                        <a:lnTo>
                          <a:pt x="485" y="1094"/>
                        </a:lnTo>
                        <a:lnTo>
                          <a:pt x="505" y="1080"/>
                        </a:lnTo>
                        <a:lnTo>
                          <a:pt x="526" y="1077"/>
                        </a:lnTo>
                        <a:lnTo>
                          <a:pt x="545" y="1063"/>
                        </a:lnTo>
                        <a:lnTo>
                          <a:pt x="561" y="1058"/>
                        </a:lnTo>
                        <a:lnTo>
                          <a:pt x="577" y="1052"/>
                        </a:lnTo>
                        <a:lnTo>
                          <a:pt x="588" y="1050"/>
                        </a:lnTo>
                        <a:lnTo>
                          <a:pt x="601" y="1050"/>
                        </a:lnTo>
                        <a:lnTo>
                          <a:pt x="607" y="1045"/>
                        </a:lnTo>
                        <a:lnTo>
                          <a:pt x="609" y="1040"/>
                        </a:lnTo>
                        <a:lnTo>
                          <a:pt x="619" y="1040"/>
                        </a:lnTo>
                        <a:lnTo>
                          <a:pt x="633" y="1046"/>
                        </a:lnTo>
                        <a:lnTo>
                          <a:pt x="644" y="1044"/>
                        </a:lnTo>
                        <a:lnTo>
                          <a:pt x="666" y="1040"/>
                        </a:lnTo>
                        <a:lnTo>
                          <a:pt x="689" y="1039"/>
                        </a:lnTo>
                        <a:lnTo>
                          <a:pt x="716" y="1052"/>
                        </a:lnTo>
                        <a:lnTo>
                          <a:pt x="733" y="1070"/>
                        </a:lnTo>
                        <a:lnTo>
                          <a:pt x="735" y="1090"/>
                        </a:lnTo>
                        <a:lnTo>
                          <a:pt x="744" y="1107"/>
                        </a:lnTo>
                        <a:lnTo>
                          <a:pt x="766" y="1113"/>
                        </a:lnTo>
                        <a:lnTo>
                          <a:pt x="798" y="1105"/>
                        </a:lnTo>
                        <a:lnTo>
                          <a:pt x="847" y="1097"/>
                        </a:lnTo>
                        <a:lnTo>
                          <a:pt x="858" y="1107"/>
                        </a:lnTo>
                        <a:lnTo>
                          <a:pt x="863" y="1129"/>
                        </a:lnTo>
                        <a:lnTo>
                          <a:pt x="880" y="1121"/>
                        </a:lnTo>
                        <a:lnTo>
                          <a:pt x="882" y="1140"/>
                        </a:lnTo>
                        <a:lnTo>
                          <a:pt x="892" y="1157"/>
                        </a:lnTo>
                        <a:lnTo>
                          <a:pt x="887" y="1185"/>
                        </a:lnTo>
                        <a:lnTo>
                          <a:pt x="884" y="1196"/>
                        </a:lnTo>
                        <a:lnTo>
                          <a:pt x="887" y="1208"/>
                        </a:lnTo>
                        <a:lnTo>
                          <a:pt x="874" y="1219"/>
                        </a:lnTo>
                        <a:lnTo>
                          <a:pt x="869" y="1226"/>
                        </a:lnTo>
                        <a:lnTo>
                          <a:pt x="880" y="1231"/>
                        </a:lnTo>
                        <a:lnTo>
                          <a:pt x="876" y="1241"/>
                        </a:lnTo>
                        <a:lnTo>
                          <a:pt x="882" y="1250"/>
                        </a:lnTo>
                        <a:lnTo>
                          <a:pt x="883" y="1262"/>
                        </a:lnTo>
                        <a:lnTo>
                          <a:pt x="872" y="1262"/>
                        </a:lnTo>
                        <a:lnTo>
                          <a:pt x="865" y="1278"/>
                        </a:lnTo>
                        <a:lnTo>
                          <a:pt x="855" y="1291"/>
                        </a:lnTo>
                        <a:lnTo>
                          <a:pt x="859" y="1312"/>
                        </a:lnTo>
                        <a:lnTo>
                          <a:pt x="866" y="1323"/>
                        </a:lnTo>
                        <a:lnTo>
                          <a:pt x="883" y="1347"/>
                        </a:lnTo>
                        <a:lnTo>
                          <a:pt x="898" y="1353"/>
                        </a:lnTo>
                        <a:lnTo>
                          <a:pt x="909" y="1368"/>
                        </a:lnTo>
                        <a:lnTo>
                          <a:pt x="914" y="1379"/>
                        </a:lnTo>
                        <a:lnTo>
                          <a:pt x="921" y="1388"/>
                        </a:lnTo>
                        <a:lnTo>
                          <a:pt x="932" y="1395"/>
                        </a:lnTo>
                        <a:lnTo>
                          <a:pt x="948" y="1416"/>
                        </a:lnTo>
                        <a:lnTo>
                          <a:pt x="961" y="1430"/>
                        </a:lnTo>
                        <a:lnTo>
                          <a:pt x="966" y="1445"/>
                        </a:lnTo>
                        <a:lnTo>
                          <a:pt x="969" y="1463"/>
                        </a:lnTo>
                        <a:lnTo>
                          <a:pt x="974" y="1474"/>
                        </a:lnTo>
                        <a:lnTo>
                          <a:pt x="993" y="1499"/>
                        </a:lnTo>
                        <a:lnTo>
                          <a:pt x="996" y="1516"/>
                        </a:lnTo>
                        <a:lnTo>
                          <a:pt x="1009" y="1551"/>
                        </a:lnTo>
                        <a:lnTo>
                          <a:pt x="1006" y="1575"/>
                        </a:lnTo>
                        <a:lnTo>
                          <a:pt x="1006" y="1595"/>
                        </a:lnTo>
                        <a:lnTo>
                          <a:pt x="1024" y="1624"/>
                        </a:lnTo>
                        <a:lnTo>
                          <a:pt x="1029" y="1643"/>
                        </a:lnTo>
                        <a:lnTo>
                          <a:pt x="1027" y="1662"/>
                        </a:lnTo>
                        <a:lnTo>
                          <a:pt x="1021" y="1687"/>
                        </a:lnTo>
                        <a:lnTo>
                          <a:pt x="1001" y="1699"/>
                        </a:lnTo>
                        <a:lnTo>
                          <a:pt x="989" y="1721"/>
                        </a:lnTo>
                        <a:lnTo>
                          <a:pt x="988" y="1736"/>
                        </a:lnTo>
                        <a:lnTo>
                          <a:pt x="975" y="1751"/>
                        </a:lnTo>
                        <a:lnTo>
                          <a:pt x="979" y="1769"/>
                        </a:lnTo>
                        <a:lnTo>
                          <a:pt x="970" y="1782"/>
                        </a:lnTo>
                        <a:lnTo>
                          <a:pt x="972" y="1798"/>
                        </a:lnTo>
                        <a:lnTo>
                          <a:pt x="959" y="1808"/>
                        </a:lnTo>
                        <a:lnTo>
                          <a:pt x="963" y="1828"/>
                        </a:lnTo>
                        <a:lnTo>
                          <a:pt x="962" y="1852"/>
                        </a:lnTo>
                        <a:lnTo>
                          <a:pt x="961" y="1870"/>
                        </a:lnTo>
                        <a:lnTo>
                          <a:pt x="963" y="1883"/>
                        </a:lnTo>
                        <a:lnTo>
                          <a:pt x="975" y="1900"/>
                        </a:lnTo>
                        <a:lnTo>
                          <a:pt x="990" y="1909"/>
                        </a:lnTo>
                        <a:lnTo>
                          <a:pt x="999" y="1931"/>
                        </a:lnTo>
                        <a:lnTo>
                          <a:pt x="1018" y="1959"/>
                        </a:lnTo>
                        <a:lnTo>
                          <a:pt x="1020" y="1978"/>
                        </a:lnTo>
                        <a:lnTo>
                          <a:pt x="1053" y="2022"/>
                        </a:lnTo>
                        <a:lnTo>
                          <a:pt x="1061" y="2034"/>
                        </a:lnTo>
                        <a:lnTo>
                          <a:pt x="1055" y="2049"/>
                        </a:lnTo>
                        <a:lnTo>
                          <a:pt x="1061" y="2070"/>
                        </a:lnTo>
                        <a:lnTo>
                          <a:pt x="1061" y="2092"/>
                        </a:lnTo>
                        <a:lnTo>
                          <a:pt x="1072" y="2110"/>
                        </a:lnTo>
                        <a:lnTo>
                          <a:pt x="1072" y="2133"/>
                        </a:lnTo>
                        <a:lnTo>
                          <a:pt x="1077" y="2149"/>
                        </a:lnTo>
                        <a:lnTo>
                          <a:pt x="1083" y="2162"/>
                        </a:lnTo>
                        <a:lnTo>
                          <a:pt x="1083" y="2179"/>
                        </a:lnTo>
                        <a:lnTo>
                          <a:pt x="1100" y="2206"/>
                        </a:lnTo>
                        <a:lnTo>
                          <a:pt x="1115" y="2226"/>
                        </a:lnTo>
                        <a:lnTo>
                          <a:pt x="1130" y="2237"/>
                        </a:lnTo>
                        <a:lnTo>
                          <a:pt x="1142" y="2253"/>
                        </a:lnTo>
                        <a:lnTo>
                          <a:pt x="1150" y="2276"/>
                        </a:lnTo>
                        <a:lnTo>
                          <a:pt x="1152" y="2291"/>
                        </a:lnTo>
                        <a:lnTo>
                          <a:pt x="1163" y="2304"/>
                        </a:lnTo>
                        <a:lnTo>
                          <a:pt x="1171" y="2322"/>
                        </a:lnTo>
                        <a:lnTo>
                          <a:pt x="1186" y="2340"/>
                        </a:lnTo>
                        <a:lnTo>
                          <a:pt x="1191" y="2355"/>
                        </a:lnTo>
                        <a:lnTo>
                          <a:pt x="1190" y="2369"/>
                        </a:lnTo>
                        <a:lnTo>
                          <a:pt x="1177" y="2372"/>
                        </a:lnTo>
                        <a:lnTo>
                          <a:pt x="1177" y="2382"/>
                        </a:lnTo>
                        <a:lnTo>
                          <a:pt x="1187" y="2392"/>
                        </a:lnTo>
                        <a:lnTo>
                          <a:pt x="1191" y="2403"/>
                        </a:lnTo>
                        <a:lnTo>
                          <a:pt x="1189" y="2414"/>
                        </a:lnTo>
                        <a:lnTo>
                          <a:pt x="1198" y="2420"/>
                        </a:lnTo>
                        <a:lnTo>
                          <a:pt x="1218" y="2426"/>
                        </a:lnTo>
                        <a:lnTo>
                          <a:pt x="1230" y="2439"/>
                        </a:lnTo>
                        <a:lnTo>
                          <a:pt x="1239" y="2440"/>
                        </a:lnTo>
                        <a:lnTo>
                          <a:pt x="1259" y="2427"/>
                        </a:lnTo>
                        <a:lnTo>
                          <a:pt x="1295" y="2427"/>
                        </a:lnTo>
                        <a:lnTo>
                          <a:pt x="1312" y="2415"/>
                        </a:lnTo>
                        <a:lnTo>
                          <a:pt x="1324" y="2415"/>
                        </a:lnTo>
                        <a:lnTo>
                          <a:pt x="1336" y="2418"/>
                        </a:lnTo>
                        <a:lnTo>
                          <a:pt x="1349" y="2411"/>
                        </a:lnTo>
                        <a:lnTo>
                          <a:pt x="1366" y="2418"/>
                        </a:lnTo>
                        <a:lnTo>
                          <a:pt x="1384" y="2423"/>
                        </a:lnTo>
                        <a:lnTo>
                          <a:pt x="1393" y="2413"/>
                        </a:lnTo>
                        <a:lnTo>
                          <a:pt x="1409" y="2414"/>
                        </a:lnTo>
                        <a:lnTo>
                          <a:pt x="1427" y="2403"/>
                        </a:lnTo>
                        <a:lnTo>
                          <a:pt x="1440" y="2404"/>
                        </a:lnTo>
                        <a:lnTo>
                          <a:pt x="1452" y="2402"/>
                        </a:lnTo>
                        <a:lnTo>
                          <a:pt x="1486" y="2383"/>
                        </a:lnTo>
                        <a:lnTo>
                          <a:pt x="1509" y="2362"/>
                        </a:lnTo>
                        <a:lnTo>
                          <a:pt x="1523" y="2347"/>
                        </a:lnTo>
                        <a:lnTo>
                          <a:pt x="1539" y="2338"/>
                        </a:lnTo>
                        <a:lnTo>
                          <a:pt x="1561" y="2316"/>
                        </a:lnTo>
                        <a:lnTo>
                          <a:pt x="1584" y="2281"/>
                        </a:lnTo>
                        <a:lnTo>
                          <a:pt x="1614" y="2247"/>
                        </a:lnTo>
                        <a:lnTo>
                          <a:pt x="1634" y="2235"/>
                        </a:lnTo>
                        <a:lnTo>
                          <a:pt x="1651" y="2183"/>
                        </a:lnTo>
                        <a:lnTo>
                          <a:pt x="1653" y="2164"/>
                        </a:lnTo>
                        <a:lnTo>
                          <a:pt x="1648" y="2142"/>
                        </a:lnTo>
                        <a:lnTo>
                          <a:pt x="1667" y="2130"/>
                        </a:lnTo>
                        <a:lnTo>
                          <a:pt x="1694" y="2120"/>
                        </a:lnTo>
                        <a:lnTo>
                          <a:pt x="1717" y="2108"/>
                        </a:lnTo>
                        <a:lnTo>
                          <a:pt x="1738" y="2098"/>
                        </a:lnTo>
                        <a:lnTo>
                          <a:pt x="1743" y="2067"/>
                        </a:lnTo>
                        <a:lnTo>
                          <a:pt x="1746" y="2046"/>
                        </a:lnTo>
                        <a:lnTo>
                          <a:pt x="1751" y="2033"/>
                        </a:lnTo>
                        <a:lnTo>
                          <a:pt x="1733" y="1995"/>
                        </a:lnTo>
                        <a:lnTo>
                          <a:pt x="1739" y="1980"/>
                        </a:lnTo>
                        <a:lnTo>
                          <a:pt x="1728" y="1967"/>
                        </a:lnTo>
                        <a:lnTo>
                          <a:pt x="1724" y="1954"/>
                        </a:lnTo>
                        <a:lnTo>
                          <a:pt x="1745" y="1938"/>
                        </a:lnTo>
                        <a:lnTo>
                          <a:pt x="1765" y="1918"/>
                        </a:lnTo>
                        <a:lnTo>
                          <a:pt x="1778" y="1907"/>
                        </a:lnTo>
                        <a:lnTo>
                          <a:pt x="1792" y="1904"/>
                        </a:lnTo>
                        <a:lnTo>
                          <a:pt x="1815" y="1875"/>
                        </a:lnTo>
                        <a:lnTo>
                          <a:pt x="1839" y="1861"/>
                        </a:lnTo>
                        <a:lnTo>
                          <a:pt x="1858" y="1852"/>
                        </a:lnTo>
                        <a:lnTo>
                          <a:pt x="1883" y="1850"/>
                        </a:lnTo>
                        <a:lnTo>
                          <a:pt x="1903" y="1835"/>
                        </a:lnTo>
                        <a:lnTo>
                          <a:pt x="1918" y="1817"/>
                        </a:lnTo>
                        <a:lnTo>
                          <a:pt x="1929" y="1800"/>
                        </a:lnTo>
                        <a:lnTo>
                          <a:pt x="1942" y="1779"/>
                        </a:lnTo>
                        <a:lnTo>
                          <a:pt x="1944" y="1763"/>
                        </a:lnTo>
                        <a:lnTo>
                          <a:pt x="1940" y="1747"/>
                        </a:lnTo>
                        <a:lnTo>
                          <a:pt x="1938" y="1728"/>
                        </a:lnTo>
                        <a:lnTo>
                          <a:pt x="1944" y="1707"/>
                        </a:lnTo>
                        <a:lnTo>
                          <a:pt x="1937" y="1688"/>
                        </a:lnTo>
                        <a:lnTo>
                          <a:pt x="1935" y="1668"/>
                        </a:lnTo>
                        <a:lnTo>
                          <a:pt x="1939" y="1646"/>
                        </a:lnTo>
                        <a:lnTo>
                          <a:pt x="1941" y="1629"/>
                        </a:lnTo>
                        <a:lnTo>
                          <a:pt x="1930" y="1617"/>
                        </a:lnTo>
                        <a:lnTo>
                          <a:pt x="1916" y="1609"/>
                        </a:lnTo>
                        <a:lnTo>
                          <a:pt x="1911" y="1595"/>
                        </a:lnTo>
                        <a:lnTo>
                          <a:pt x="1910" y="1578"/>
                        </a:lnTo>
                        <a:lnTo>
                          <a:pt x="1904" y="1562"/>
                        </a:lnTo>
                        <a:lnTo>
                          <a:pt x="1902" y="1529"/>
                        </a:lnTo>
                        <a:lnTo>
                          <a:pt x="1909" y="1517"/>
                        </a:lnTo>
                        <a:lnTo>
                          <a:pt x="1915" y="1501"/>
                        </a:lnTo>
                        <a:lnTo>
                          <a:pt x="1909" y="1495"/>
                        </a:lnTo>
                        <a:lnTo>
                          <a:pt x="1897" y="1494"/>
                        </a:lnTo>
                        <a:lnTo>
                          <a:pt x="1889" y="1483"/>
                        </a:lnTo>
                        <a:lnTo>
                          <a:pt x="1890" y="1470"/>
                        </a:lnTo>
                        <a:lnTo>
                          <a:pt x="1901" y="1437"/>
                        </a:lnTo>
                        <a:lnTo>
                          <a:pt x="1898" y="1421"/>
                        </a:lnTo>
                        <a:lnTo>
                          <a:pt x="1920" y="1411"/>
                        </a:lnTo>
                        <a:lnTo>
                          <a:pt x="1927" y="1388"/>
                        </a:lnTo>
                        <a:lnTo>
                          <a:pt x="1936" y="1373"/>
                        </a:lnTo>
                        <a:lnTo>
                          <a:pt x="1939" y="1358"/>
                        </a:lnTo>
                        <a:lnTo>
                          <a:pt x="1957" y="1351"/>
                        </a:lnTo>
                        <a:lnTo>
                          <a:pt x="1970" y="1335"/>
                        </a:lnTo>
                        <a:lnTo>
                          <a:pt x="1989" y="1321"/>
                        </a:lnTo>
                        <a:lnTo>
                          <a:pt x="2014" y="1284"/>
                        </a:lnTo>
                        <a:lnTo>
                          <a:pt x="2078" y="1217"/>
                        </a:lnTo>
                        <a:lnTo>
                          <a:pt x="2115" y="1196"/>
                        </a:lnTo>
                        <a:lnTo>
                          <a:pt x="2163" y="1159"/>
                        </a:lnTo>
                        <a:lnTo>
                          <a:pt x="2207" y="1104"/>
                        </a:lnTo>
                        <a:lnTo>
                          <a:pt x="2240" y="1047"/>
                        </a:lnTo>
                        <a:lnTo>
                          <a:pt x="2243" y="1026"/>
                        </a:lnTo>
                        <a:lnTo>
                          <a:pt x="2279" y="955"/>
                        </a:lnTo>
                        <a:lnTo>
                          <a:pt x="2292" y="921"/>
                        </a:lnTo>
                        <a:lnTo>
                          <a:pt x="2293" y="898"/>
                        </a:lnTo>
                        <a:lnTo>
                          <a:pt x="2304" y="892"/>
                        </a:lnTo>
                        <a:lnTo>
                          <a:pt x="2299" y="879"/>
                        </a:lnTo>
                        <a:lnTo>
                          <a:pt x="2296" y="861"/>
                        </a:lnTo>
                        <a:lnTo>
                          <a:pt x="2302" y="843"/>
                        </a:lnTo>
                        <a:lnTo>
                          <a:pt x="2281" y="835"/>
                        </a:lnTo>
                        <a:lnTo>
                          <a:pt x="2275" y="848"/>
                        </a:lnTo>
                        <a:lnTo>
                          <a:pt x="2233" y="867"/>
                        </a:lnTo>
                        <a:lnTo>
                          <a:pt x="2208" y="864"/>
                        </a:lnTo>
                        <a:lnTo>
                          <a:pt x="2195" y="870"/>
                        </a:lnTo>
                        <a:lnTo>
                          <a:pt x="2171" y="871"/>
                        </a:lnTo>
                        <a:lnTo>
                          <a:pt x="2158" y="882"/>
                        </a:lnTo>
                        <a:lnTo>
                          <a:pt x="2137" y="886"/>
                        </a:lnTo>
                        <a:lnTo>
                          <a:pt x="2120" y="883"/>
                        </a:lnTo>
                        <a:lnTo>
                          <a:pt x="2099" y="897"/>
                        </a:lnTo>
                        <a:lnTo>
                          <a:pt x="2078" y="901"/>
                        </a:lnTo>
                        <a:lnTo>
                          <a:pt x="2055" y="886"/>
                        </a:lnTo>
                        <a:lnTo>
                          <a:pt x="2037" y="865"/>
                        </a:lnTo>
                        <a:lnTo>
                          <a:pt x="2032" y="857"/>
                        </a:lnTo>
                        <a:lnTo>
                          <a:pt x="2021" y="858"/>
                        </a:lnTo>
                        <a:lnTo>
                          <a:pt x="2014" y="864"/>
                        </a:lnTo>
                        <a:lnTo>
                          <a:pt x="2007" y="864"/>
                        </a:lnTo>
                        <a:lnTo>
                          <a:pt x="2005" y="859"/>
                        </a:lnTo>
                        <a:lnTo>
                          <a:pt x="2014" y="854"/>
                        </a:lnTo>
                        <a:lnTo>
                          <a:pt x="2023" y="845"/>
                        </a:lnTo>
                        <a:lnTo>
                          <a:pt x="2037" y="843"/>
                        </a:lnTo>
                        <a:lnTo>
                          <a:pt x="2035" y="833"/>
                        </a:lnTo>
                        <a:lnTo>
                          <a:pt x="2029" y="826"/>
                        </a:lnTo>
                        <a:lnTo>
                          <a:pt x="2021" y="820"/>
                        </a:lnTo>
                        <a:lnTo>
                          <a:pt x="1991" y="788"/>
                        </a:lnTo>
                        <a:lnTo>
                          <a:pt x="1970" y="773"/>
                        </a:lnTo>
                        <a:lnTo>
                          <a:pt x="1954" y="754"/>
                        </a:lnTo>
                        <a:lnTo>
                          <a:pt x="1925" y="742"/>
                        </a:lnTo>
                        <a:lnTo>
                          <a:pt x="1900" y="729"/>
                        </a:lnTo>
                        <a:lnTo>
                          <a:pt x="1888" y="715"/>
                        </a:lnTo>
                        <a:lnTo>
                          <a:pt x="1884" y="690"/>
                        </a:lnTo>
                        <a:lnTo>
                          <a:pt x="1874" y="663"/>
                        </a:lnTo>
                        <a:lnTo>
                          <a:pt x="1862" y="639"/>
                        </a:lnTo>
                        <a:lnTo>
                          <a:pt x="1849" y="634"/>
                        </a:lnTo>
                        <a:lnTo>
                          <a:pt x="1840" y="621"/>
                        </a:lnTo>
                        <a:lnTo>
                          <a:pt x="1821" y="616"/>
                        </a:lnTo>
                        <a:lnTo>
                          <a:pt x="1815" y="578"/>
                        </a:lnTo>
                        <a:lnTo>
                          <a:pt x="1806" y="555"/>
                        </a:lnTo>
                        <a:lnTo>
                          <a:pt x="1792" y="499"/>
                        </a:lnTo>
                        <a:lnTo>
                          <a:pt x="1780" y="494"/>
                        </a:lnTo>
                        <a:lnTo>
                          <a:pt x="1770" y="483"/>
                        </a:lnTo>
                        <a:lnTo>
                          <a:pt x="1758" y="483"/>
                        </a:lnTo>
                        <a:lnTo>
                          <a:pt x="1750" y="470"/>
                        </a:lnTo>
                        <a:lnTo>
                          <a:pt x="1745" y="455"/>
                        </a:lnTo>
                        <a:lnTo>
                          <a:pt x="1752" y="441"/>
                        </a:lnTo>
                        <a:lnTo>
                          <a:pt x="1734" y="425"/>
                        </a:lnTo>
                        <a:lnTo>
                          <a:pt x="1722" y="409"/>
                        </a:lnTo>
                        <a:lnTo>
                          <a:pt x="1712" y="389"/>
                        </a:lnTo>
                        <a:lnTo>
                          <a:pt x="1692" y="361"/>
                        </a:lnTo>
                        <a:lnTo>
                          <a:pt x="1681" y="335"/>
                        </a:lnTo>
                        <a:lnTo>
                          <a:pt x="1660" y="305"/>
                        </a:lnTo>
                        <a:lnTo>
                          <a:pt x="1636" y="276"/>
                        </a:lnTo>
                        <a:lnTo>
                          <a:pt x="1624" y="256"/>
                        </a:lnTo>
                        <a:lnTo>
                          <a:pt x="1624" y="248"/>
                        </a:lnTo>
                        <a:lnTo>
                          <a:pt x="1632" y="248"/>
                        </a:lnTo>
                        <a:lnTo>
                          <a:pt x="1657" y="271"/>
                        </a:lnTo>
                        <a:lnTo>
                          <a:pt x="1657" y="287"/>
                        </a:lnTo>
                        <a:lnTo>
                          <a:pt x="1673" y="304"/>
                        </a:lnTo>
                        <a:lnTo>
                          <a:pt x="1689" y="311"/>
                        </a:lnTo>
                        <a:lnTo>
                          <a:pt x="1697" y="303"/>
                        </a:lnTo>
                        <a:lnTo>
                          <a:pt x="1693" y="294"/>
                        </a:lnTo>
                        <a:lnTo>
                          <a:pt x="1699" y="280"/>
                        </a:lnTo>
                        <a:lnTo>
                          <a:pt x="1699" y="262"/>
                        </a:lnTo>
                        <a:lnTo>
                          <a:pt x="1704" y="241"/>
                        </a:lnTo>
                        <a:lnTo>
                          <a:pt x="1695" y="222"/>
                        </a:lnTo>
                        <a:lnTo>
                          <a:pt x="1679" y="197"/>
                        </a:lnTo>
                        <a:close/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" name="Freeform 14"/>
                  <p:cNvSpPr>
                    <a:spLocks noChangeAspect="1"/>
                  </p:cNvSpPr>
                  <p:nvPr/>
                </p:nvSpPr>
                <p:spPr bwMode="auto">
                  <a:xfrm>
                    <a:off x="3115032" y="4542682"/>
                    <a:ext cx="1182926" cy="1167346"/>
                  </a:xfrm>
                  <a:custGeom>
                    <a:avLst/>
                    <a:gdLst>
                      <a:gd name="T0" fmla="*/ 8181 w 8352"/>
                      <a:gd name="T1" fmla="*/ 1100 h 8224"/>
                      <a:gd name="T2" fmla="*/ 8053 w 8352"/>
                      <a:gd name="T3" fmla="*/ 768 h 8224"/>
                      <a:gd name="T4" fmla="*/ 7709 w 8352"/>
                      <a:gd name="T5" fmla="*/ 457 h 8224"/>
                      <a:gd name="T6" fmla="*/ 7281 w 8352"/>
                      <a:gd name="T7" fmla="*/ 384 h 8224"/>
                      <a:gd name="T8" fmla="*/ 6941 w 8352"/>
                      <a:gd name="T9" fmla="*/ 402 h 8224"/>
                      <a:gd name="T10" fmla="*/ 6670 w 8352"/>
                      <a:gd name="T11" fmla="*/ 143 h 8224"/>
                      <a:gd name="T12" fmla="*/ 6206 w 8352"/>
                      <a:gd name="T13" fmla="*/ 99 h 8224"/>
                      <a:gd name="T14" fmla="*/ 5738 w 8352"/>
                      <a:gd name="T15" fmla="*/ 143 h 8224"/>
                      <a:gd name="T16" fmla="*/ 5314 w 8352"/>
                      <a:gd name="T17" fmla="*/ 161 h 8224"/>
                      <a:gd name="T18" fmla="*/ 4549 w 8352"/>
                      <a:gd name="T19" fmla="*/ 391 h 8224"/>
                      <a:gd name="T20" fmla="*/ 4144 w 8352"/>
                      <a:gd name="T21" fmla="*/ 461 h 8224"/>
                      <a:gd name="T22" fmla="*/ 3610 w 8352"/>
                      <a:gd name="T23" fmla="*/ 333 h 8224"/>
                      <a:gd name="T24" fmla="*/ 3068 w 8352"/>
                      <a:gd name="T25" fmla="*/ 179 h 8224"/>
                      <a:gd name="T26" fmla="*/ 2776 w 8352"/>
                      <a:gd name="T27" fmla="*/ 472 h 8224"/>
                      <a:gd name="T28" fmla="*/ 2721 w 8352"/>
                      <a:gd name="T29" fmla="*/ 1151 h 8224"/>
                      <a:gd name="T30" fmla="*/ 2520 w 8352"/>
                      <a:gd name="T31" fmla="*/ 1794 h 8224"/>
                      <a:gd name="T32" fmla="*/ 2458 w 8352"/>
                      <a:gd name="T33" fmla="*/ 2255 h 8224"/>
                      <a:gd name="T34" fmla="*/ 2052 w 8352"/>
                      <a:gd name="T35" fmla="*/ 2868 h 8224"/>
                      <a:gd name="T36" fmla="*/ 1748 w 8352"/>
                      <a:gd name="T37" fmla="*/ 3563 h 8224"/>
                      <a:gd name="T38" fmla="*/ 1529 w 8352"/>
                      <a:gd name="T39" fmla="*/ 4089 h 8224"/>
                      <a:gd name="T40" fmla="*/ 1247 w 8352"/>
                      <a:gd name="T41" fmla="*/ 4326 h 8224"/>
                      <a:gd name="T42" fmla="*/ 991 w 8352"/>
                      <a:gd name="T43" fmla="*/ 4282 h 8224"/>
                      <a:gd name="T44" fmla="*/ 670 w 8352"/>
                      <a:gd name="T45" fmla="*/ 4286 h 8224"/>
                      <a:gd name="T46" fmla="*/ 403 w 8352"/>
                      <a:gd name="T47" fmla="*/ 4344 h 8224"/>
                      <a:gd name="T48" fmla="*/ 70 w 8352"/>
                      <a:gd name="T49" fmla="*/ 4977 h 8224"/>
                      <a:gd name="T50" fmla="*/ 512 w 8352"/>
                      <a:gd name="T51" fmla="*/ 4922 h 8224"/>
                      <a:gd name="T52" fmla="*/ 1701 w 8352"/>
                      <a:gd name="T53" fmla="*/ 4907 h 8224"/>
                      <a:gd name="T54" fmla="*/ 2037 w 8352"/>
                      <a:gd name="T55" fmla="*/ 5316 h 8224"/>
                      <a:gd name="T56" fmla="*/ 2319 w 8352"/>
                      <a:gd name="T57" fmla="*/ 5853 h 8224"/>
                      <a:gd name="T58" fmla="*/ 2663 w 8352"/>
                      <a:gd name="T59" fmla="*/ 5839 h 8224"/>
                      <a:gd name="T60" fmla="*/ 3127 w 8352"/>
                      <a:gd name="T61" fmla="*/ 5824 h 8224"/>
                      <a:gd name="T62" fmla="*/ 3387 w 8352"/>
                      <a:gd name="T63" fmla="*/ 5400 h 8224"/>
                      <a:gd name="T64" fmla="*/ 4195 w 8352"/>
                      <a:gd name="T65" fmla="*/ 5539 h 8224"/>
                      <a:gd name="T66" fmla="*/ 4235 w 8352"/>
                      <a:gd name="T67" fmla="*/ 6390 h 8224"/>
                      <a:gd name="T68" fmla="*/ 4443 w 8352"/>
                      <a:gd name="T69" fmla="*/ 7066 h 8224"/>
                      <a:gd name="T70" fmla="*/ 4805 w 8352"/>
                      <a:gd name="T71" fmla="*/ 7201 h 8224"/>
                      <a:gd name="T72" fmla="*/ 5347 w 8352"/>
                      <a:gd name="T73" fmla="*/ 7249 h 8224"/>
                      <a:gd name="T74" fmla="*/ 5785 w 8352"/>
                      <a:gd name="T75" fmla="*/ 7446 h 8224"/>
                      <a:gd name="T76" fmla="*/ 6041 w 8352"/>
                      <a:gd name="T77" fmla="*/ 7567 h 8224"/>
                      <a:gd name="T78" fmla="*/ 6499 w 8352"/>
                      <a:gd name="T79" fmla="*/ 7417 h 8224"/>
                      <a:gd name="T80" fmla="*/ 6886 w 8352"/>
                      <a:gd name="T81" fmla="*/ 7698 h 8224"/>
                      <a:gd name="T82" fmla="*/ 7168 w 8352"/>
                      <a:gd name="T83" fmla="*/ 7980 h 8224"/>
                      <a:gd name="T84" fmla="*/ 7497 w 8352"/>
                      <a:gd name="T85" fmla="*/ 8181 h 8224"/>
                      <a:gd name="T86" fmla="*/ 7654 w 8352"/>
                      <a:gd name="T87" fmla="*/ 7684 h 8224"/>
                      <a:gd name="T88" fmla="*/ 7486 w 8352"/>
                      <a:gd name="T89" fmla="*/ 7775 h 8224"/>
                      <a:gd name="T90" fmla="*/ 7182 w 8352"/>
                      <a:gd name="T91" fmla="*/ 7556 h 8224"/>
                      <a:gd name="T92" fmla="*/ 7127 w 8352"/>
                      <a:gd name="T93" fmla="*/ 7201 h 8224"/>
                      <a:gd name="T94" fmla="*/ 7215 w 8352"/>
                      <a:gd name="T95" fmla="*/ 6635 h 8224"/>
                      <a:gd name="T96" fmla="*/ 7080 w 8352"/>
                      <a:gd name="T97" fmla="*/ 6449 h 8224"/>
                      <a:gd name="T98" fmla="*/ 7625 w 8352"/>
                      <a:gd name="T99" fmla="*/ 6014 h 8224"/>
                      <a:gd name="T100" fmla="*/ 7884 w 8352"/>
                      <a:gd name="T101" fmla="*/ 5649 h 8224"/>
                      <a:gd name="T102" fmla="*/ 7537 w 8352"/>
                      <a:gd name="T103" fmla="*/ 5188 h 8224"/>
                      <a:gd name="T104" fmla="*/ 7497 w 8352"/>
                      <a:gd name="T105" fmla="*/ 4889 h 8224"/>
                      <a:gd name="T106" fmla="*/ 7508 w 8352"/>
                      <a:gd name="T107" fmla="*/ 4538 h 8224"/>
                      <a:gd name="T108" fmla="*/ 7431 w 8352"/>
                      <a:gd name="T109" fmla="*/ 3665 h 8224"/>
                      <a:gd name="T110" fmla="*/ 7438 w 8352"/>
                      <a:gd name="T111" fmla="*/ 3281 h 8224"/>
                      <a:gd name="T112" fmla="*/ 7606 w 8352"/>
                      <a:gd name="T113" fmla="*/ 2784 h 8224"/>
                      <a:gd name="T114" fmla="*/ 7709 w 8352"/>
                      <a:gd name="T115" fmla="*/ 2266 h 8224"/>
                      <a:gd name="T116" fmla="*/ 7998 w 8352"/>
                      <a:gd name="T117" fmla="*/ 1820 h 8224"/>
                      <a:gd name="T118" fmla="*/ 8151 w 8352"/>
                      <a:gd name="T119" fmla="*/ 1561 h 822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  <a:cxn ang="0">
                        <a:pos x="T110" y="T111"/>
                      </a:cxn>
                      <a:cxn ang="0">
                        <a:pos x="T112" y="T113"/>
                      </a:cxn>
                      <a:cxn ang="0">
                        <a:pos x="T114" y="T115"/>
                      </a:cxn>
                      <a:cxn ang="0">
                        <a:pos x="T116" y="T117"/>
                      </a:cxn>
                      <a:cxn ang="0">
                        <a:pos x="T118" y="T119"/>
                      </a:cxn>
                    </a:cxnLst>
                    <a:rect l="0" t="0" r="r" b="b"/>
                    <a:pathLst>
                      <a:path w="8352" h="8224">
                        <a:moveTo>
                          <a:pt x="8323" y="1345"/>
                        </a:moveTo>
                        <a:cubicBezTo>
                          <a:pt x="8279" y="1345"/>
                          <a:pt x="8279" y="1345"/>
                          <a:pt x="8279" y="1345"/>
                        </a:cubicBezTo>
                        <a:cubicBezTo>
                          <a:pt x="8217" y="1286"/>
                          <a:pt x="8217" y="1286"/>
                          <a:pt x="8217" y="1286"/>
                        </a:cubicBezTo>
                        <a:cubicBezTo>
                          <a:pt x="8195" y="1330"/>
                          <a:pt x="8195" y="1330"/>
                          <a:pt x="8195" y="1330"/>
                        </a:cubicBezTo>
                        <a:cubicBezTo>
                          <a:pt x="8159" y="1297"/>
                          <a:pt x="8159" y="1297"/>
                          <a:pt x="8159" y="1297"/>
                        </a:cubicBezTo>
                        <a:cubicBezTo>
                          <a:pt x="8118" y="1261"/>
                          <a:pt x="8118" y="1261"/>
                          <a:pt x="8118" y="1261"/>
                        </a:cubicBezTo>
                        <a:cubicBezTo>
                          <a:pt x="8148" y="1184"/>
                          <a:pt x="8148" y="1184"/>
                          <a:pt x="8148" y="1184"/>
                        </a:cubicBezTo>
                        <a:cubicBezTo>
                          <a:pt x="8181" y="1100"/>
                          <a:pt x="8181" y="1100"/>
                          <a:pt x="8181" y="1100"/>
                        </a:cubicBezTo>
                        <a:cubicBezTo>
                          <a:pt x="8133" y="1031"/>
                          <a:pt x="8133" y="1031"/>
                          <a:pt x="8133" y="1031"/>
                        </a:cubicBezTo>
                        <a:cubicBezTo>
                          <a:pt x="8137" y="950"/>
                          <a:pt x="8137" y="950"/>
                          <a:pt x="8137" y="950"/>
                        </a:cubicBezTo>
                        <a:cubicBezTo>
                          <a:pt x="8188" y="888"/>
                          <a:pt x="8188" y="888"/>
                          <a:pt x="8188" y="888"/>
                        </a:cubicBezTo>
                        <a:cubicBezTo>
                          <a:pt x="8199" y="837"/>
                          <a:pt x="8199" y="837"/>
                          <a:pt x="8199" y="837"/>
                        </a:cubicBezTo>
                        <a:cubicBezTo>
                          <a:pt x="8170" y="819"/>
                          <a:pt x="8170" y="819"/>
                          <a:pt x="8170" y="819"/>
                        </a:cubicBezTo>
                        <a:cubicBezTo>
                          <a:pt x="8140" y="749"/>
                          <a:pt x="8140" y="749"/>
                          <a:pt x="8140" y="749"/>
                        </a:cubicBezTo>
                        <a:cubicBezTo>
                          <a:pt x="8111" y="749"/>
                          <a:pt x="8111" y="749"/>
                          <a:pt x="8111" y="749"/>
                        </a:cubicBezTo>
                        <a:cubicBezTo>
                          <a:pt x="8053" y="768"/>
                          <a:pt x="8053" y="768"/>
                          <a:pt x="8053" y="768"/>
                        </a:cubicBezTo>
                        <a:cubicBezTo>
                          <a:pt x="8045" y="724"/>
                          <a:pt x="8045" y="724"/>
                          <a:pt x="8045" y="724"/>
                        </a:cubicBezTo>
                        <a:cubicBezTo>
                          <a:pt x="8034" y="665"/>
                          <a:pt x="8034" y="665"/>
                          <a:pt x="8034" y="665"/>
                        </a:cubicBezTo>
                        <a:cubicBezTo>
                          <a:pt x="7976" y="643"/>
                          <a:pt x="7976" y="643"/>
                          <a:pt x="7976" y="643"/>
                        </a:cubicBezTo>
                        <a:cubicBezTo>
                          <a:pt x="7892" y="607"/>
                          <a:pt x="7892" y="607"/>
                          <a:pt x="7892" y="607"/>
                        </a:cubicBezTo>
                        <a:cubicBezTo>
                          <a:pt x="7855" y="559"/>
                          <a:pt x="7855" y="559"/>
                          <a:pt x="7855" y="559"/>
                        </a:cubicBezTo>
                        <a:cubicBezTo>
                          <a:pt x="7793" y="516"/>
                          <a:pt x="7793" y="516"/>
                          <a:pt x="7793" y="516"/>
                        </a:cubicBezTo>
                        <a:cubicBezTo>
                          <a:pt x="7767" y="464"/>
                          <a:pt x="7767" y="464"/>
                          <a:pt x="7767" y="464"/>
                        </a:cubicBezTo>
                        <a:cubicBezTo>
                          <a:pt x="7709" y="457"/>
                          <a:pt x="7709" y="457"/>
                          <a:pt x="7709" y="457"/>
                        </a:cubicBezTo>
                        <a:cubicBezTo>
                          <a:pt x="7709" y="359"/>
                          <a:pt x="7709" y="359"/>
                          <a:pt x="7709" y="359"/>
                        </a:cubicBezTo>
                        <a:cubicBezTo>
                          <a:pt x="7566" y="304"/>
                          <a:pt x="7566" y="304"/>
                          <a:pt x="7566" y="304"/>
                        </a:cubicBezTo>
                        <a:cubicBezTo>
                          <a:pt x="7559" y="340"/>
                          <a:pt x="7559" y="340"/>
                          <a:pt x="7559" y="340"/>
                        </a:cubicBezTo>
                        <a:cubicBezTo>
                          <a:pt x="7511" y="406"/>
                          <a:pt x="7511" y="406"/>
                          <a:pt x="7511" y="406"/>
                        </a:cubicBezTo>
                        <a:cubicBezTo>
                          <a:pt x="7468" y="454"/>
                          <a:pt x="7468" y="454"/>
                          <a:pt x="7468" y="454"/>
                        </a:cubicBezTo>
                        <a:cubicBezTo>
                          <a:pt x="7427" y="439"/>
                          <a:pt x="7427" y="439"/>
                          <a:pt x="7427" y="439"/>
                        </a:cubicBezTo>
                        <a:cubicBezTo>
                          <a:pt x="7361" y="384"/>
                          <a:pt x="7361" y="384"/>
                          <a:pt x="7361" y="384"/>
                        </a:cubicBezTo>
                        <a:cubicBezTo>
                          <a:pt x="7281" y="384"/>
                          <a:pt x="7281" y="384"/>
                          <a:pt x="7281" y="384"/>
                        </a:cubicBezTo>
                        <a:cubicBezTo>
                          <a:pt x="7241" y="355"/>
                          <a:pt x="7241" y="355"/>
                          <a:pt x="7241" y="355"/>
                        </a:cubicBezTo>
                        <a:cubicBezTo>
                          <a:pt x="7201" y="413"/>
                          <a:pt x="7201" y="413"/>
                          <a:pt x="7201" y="413"/>
                        </a:cubicBezTo>
                        <a:cubicBezTo>
                          <a:pt x="7142" y="461"/>
                          <a:pt x="7142" y="461"/>
                          <a:pt x="7142" y="461"/>
                        </a:cubicBezTo>
                        <a:cubicBezTo>
                          <a:pt x="7095" y="479"/>
                          <a:pt x="7095" y="479"/>
                          <a:pt x="7095" y="479"/>
                        </a:cubicBezTo>
                        <a:cubicBezTo>
                          <a:pt x="7076" y="446"/>
                          <a:pt x="7076" y="446"/>
                          <a:pt x="7076" y="446"/>
                        </a:cubicBezTo>
                        <a:cubicBezTo>
                          <a:pt x="7021" y="457"/>
                          <a:pt x="7021" y="457"/>
                          <a:pt x="7021" y="457"/>
                        </a:cubicBezTo>
                        <a:cubicBezTo>
                          <a:pt x="6996" y="413"/>
                          <a:pt x="6996" y="413"/>
                          <a:pt x="6996" y="413"/>
                        </a:cubicBezTo>
                        <a:cubicBezTo>
                          <a:pt x="6941" y="402"/>
                          <a:pt x="6941" y="402"/>
                          <a:pt x="6941" y="402"/>
                        </a:cubicBezTo>
                        <a:cubicBezTo>
                          <a:pt x="6937" y="366"/>
                          <a:pt x="6937" y="366"/>
                          <a:pt x="6937" y="366"/>
                        </a:cubicBezTo>
                        <a:cubicBezTo>
                          <a:pt x="6879" y="366"/>
                          <a:pt x="6879" y="366"/>
                          <a:pt x="6879" y="366"/>
                        </a:cubicBezTo>
                        <a:cubicBezTo>
                          <a:pt x="6820" y="333"/>
                          <a:pt x="6820" y="333"/>
                          <a:pt x="6820" y="333"/>
                        </a:cubicBezTo>
                        <a:cubicBezTo>
                          <a:pt x="6820" y="271"/>
                          <a:pt x="6820" y="271"/>
                          <a:pt x="6820" y="271"/>
                        </a:cubicBezTo>
                        <a:cubicBezTo>
                          <a:pt x="6780" y="220"/>
                          <a:pt x="6780" y="220"/>
                          <a:pt x="6780" y="220"/>
                        </a:cubicBezTo>
                        <a:cubicBezTo>
                          <a:pt x="6733" y="209"/>
                          <a:pt x="6733" y="209"/>
                          <a:pt x="6733" y="209"/>
                        </a:cubicBezTo>
                        <a:cubicBezTo>
                          <a:pt x="6714" y="176"/>
                          <a:pt x="6714" y="176"/>
                          <a:pt x="6714" y="176"/>
                        </a:cubicBezTo>
                        <a:cubicBezTo>
                          <a:pt x="6670" y="143"/>
                          <a:pt x="6670" y="143"/>
                          <a:pt x="6670" y="143"/>
                        </a:cubicBezTo>
                        <a:cubicBezTo>
                          <a:pt x="6531" y="66"/>
                          <a:pt x="6531" y="66"/>
                          <a:pt x="6531" y="66"/>
                        </a:cubicBezTo>
                        <a:cubicBezTo>
                          <a:pt x="6451" y="106"/>
                          <a:pt x="6451" y="106"/>
                          <a:pt x="6451" y="106"/>
                        </a:cubicBezTo>
                        <a:cubicBezTo>
                          <a:pt x="6436" y="143"/>
                          <a:pt x="6436" y="143"/>
                          <a:pt x="6436" y="143"/>
                        </a:cubicBezTo>
                        <a:cubicBezTo>
                          <a:pt x="6418" y="143"/>
                          <a:pt x="6418" y="143"/>
                          <a:pt x="6418" y="143"/>
                        </a:cubicBezTo>
                        <a:cubicBezTo>
                          <a:pt x="6418" y="143"/>
                          <a:pt x="6418" y="143"/>
                          <a:pt x="6418" y="143"/>
                        </a:cubicBezTo>
                        <a:cubicBezTo>
                          <a:pt x="6385" y="121"/>
                          <a:pt x="6385" y="121"/>
                          <a:pt x="6385" y="121"/>
                        </a:cubicBezTo>
                        <a:cubicBezTo>
                          <a:pt x="6264" y="139"/>
                          <a:pt x="6264" y="139"/>
                          <a:pt x="6264" y="139"/>
                        </a:cubicBezTo>
                        <a:cubicBezTo>
                          <a:pt x="6206" y="99"/>
                          <a:pt x="6206" y="99"/>
                          <a:pt x="6206" y="99"/>
                        </a:cubicBezTo>
                        <a:cubicBezTo>
                          <a:pt x="6107" y="52"/>
                          <a:pt x="6107" y="52"/>
                          <a:pt x="6107" y="52"/>
                        </a:cubicBezTo>
                        <a:cubicBezTo>
                          <a:pt x="6005" y="70"/>
                          <a:pt x="6005" y="70"/>
                          <a:pt x="6005" y="70"/>
                        </a:cubicBezTo>
                        <a:cubicBezTo>
                          <a:pt x="5928" y="52"/>
                          <a:pt x="5928" y="52"/>
                          <a:pt x="5928" y="52"/>
                        </a:cubicBezTo>
                        <a:cubicBezTo>
                          <a:pt x="5870" y="0"/>
                          <a:pt x="5870" y="0"/>
                          <a:pt x="5870" y="0"/>
                        </a:cubicBezTo>
                        <a:cubicBezTo>
                          <a:pt x="5782" y="26"/>
                          <a:pt x="5782" y="26"/>
                          <a:pt x="5782" y="26"/>
                        </a:cubicBezTo>
                        <a:cubicBezTo>
                          <a:pt x="5745" y="74"/>
                          <a:pt x="5745" y="74"/>
                          <a:pt x="5745" y="74"/>
                        </a:cubicBezTo>
                        <a:cubicBezTo>
                          <a:pt x="5763" y="99"/>
                          <a:pt x="5763" y="99"/>
                          <a:pt x="5763" y="99"/>
                        </a:cubicBezTo>
                        <a:cubicBezTo>
                          <a:pt x="5738" y="143"/>
                          <a:pt x="5738" y="143"/>
                          <a:pt x="5738" y="143"/>
                        </a:cubicBezTo>
                        <a:cubicBezTo>
                          <a:pt x="5668" y="150"/>
                          <a:pt x="5668" y="150"/>
                          <a:pt x="5668" y="150"/>
                        </a:cubicBezTo>
                        <a:cubicBezTo>
                          <a:pt x="5639" y="190"/>
                          <a:pt x="5639" y="190"/>
                          <a:pt x="5639" y="190"/>
                        </a:cubicBezTo>
                        <a:cubicBezTo>
                          <a:pt x="5588" y="158"/>
                          <a:pt x="5588" y="158"/>
                          <a:pt x="5588" y="158"/>
                        </a:cubicBezTo>
                        <a:cubicBezTo>
                          <a:pt x="5544" y="190"/>
                          <a:pt x="5544" y="190"/>
                          <a:pt x="5544" y="190"/>
                        </a:cubicBezTo>
                        <a:cubicBezTo>
                          <a:pt x="5456" y="198"/>
                          <a:pt x="5456" y="198"/>
                          <a:pt x="5456" y="198"/>
                        </a:cubicBezTo>
                        <a:cubicBezTo>
                          <a:pt x="5401" y="136"/>
                          <a:pt x="5401" y="136"/>
                          <a:pt x="5401" y="136"/>
                        </a:cubicBezTo>
                        <a:cubicBezTo>
                          <a:pt x="5401" y="136"/>
                          <a:pt x="5358" y="121"/>
                          <a:pt x="5339" y="117"/>
                        </a:cubicBezTo>
                        <a:cubicBezTo>
                          <a:pt x="5321" y="114"/>
                          <a:pt x="5314" y="161"/>
                          <a:pt x="5314" y="161"/>
                        </a:cubicBezTo>
                        <a:cubicBezTo>
                          <a:pt x="4908" y="311"/>
                          <a:pt x="4908" y="311"/>
                          <a:pt x="4908" y="311"/>
                        </a:cubicBezTo>
                        <a:cubicBezTo>
                          <a:pt x="4904" y="344"/>
                          <a:pt x="4904" y="344"/>
                          <a:pt x="4904" y="344"/>
                        </a:cubicBezTo>
                        <a:cubicBezTo>
                          <a:pt x="4802" y="282"/>
                          <a:pt x="4802" y="282"/>
                          <a:pt x="4802" y="282"/>
                        </a:cubicBezTo>
                        <a:cubicBezTo>
                          <a:pt x="4743" y="278"/>
                          <a:pt x="4743" y="278"/>
                          <a:pt x="4743" y="278"/>
                        </a:cubicBezTo>
                        <a:cubicBezTo>
                          <a:pt x="4707" y="242"/>
                          <a:pt x="4707" y="242"/>
                          <a:pt x="4707" y="242"/>
                        </a:cubicBezTo>
                        <a:cubicBezTo>
                          <a:pt x="4634" y="278"/>
                          <a:pt x="4634" y="278"/>
                          <a:pt x="4634" y="278"/>
                        </a:cubicBezTo>
                        <a:cubicBezTo>
                          <a:pt x="4582" y="399"/>
                          <a:pt x="4582" y="399"/>
                          <a:pt x="4582" y="399"/>
                        </a:cubicBezTo>
                        <a:cubicBezTo>
                          <a:pt x="4549" y="391"/>
                          <a:pt x="4549" y="391"/>
                          <a:pt x="4549" y="391"/>
                        </a:cubicBezTo>
                        <a:cubicBezTo>
                          <a:pt x="4538" y="446"/>
                          <a:pt x="4538" y="446"/>
                          <a:pt x="4538" y="446"/>
                        </a:cubicBezTo>
                        <a:cubicBezTo>
                          <a:pt x="4502" y="527"/>
                          <a:pt x="4502" y="527"/>
                          <a:pt x="4502" y="527"/>
                        </a:cubicBezTo>
                        <a:cubicBezTo>
                          <a:pt x="4506" y="530"/>
                          <a:pt x="4506" y="530"/>
                          <a:pt x="4506" y="530"/>
                        </a:cubicBezTo>
                        <a:cubicBezTo>
                          <a:pt x="4495" y="538"/>
                          <a:pt x="4473" y="545"/>
                          <a:pt x="4473" y="545"/>
                        </a:cubicBezTo>
                        <a:cubicBezTo>
                          <a:pt x="4370" y="538"/>
                          <a:pt x="4370" y="538"/>
                          <a:pt x="4370" y="538"/>
                        </a:cubicBezTo>
                        <a:cubicBezTo>
                          <a:pt x="4286" y="486"/>
                          <a:pt x="4286" y="486"/>
                          <a:pt x="4286" y="486"/>
                        </a:cubicBezTo>
                        <a:cubicBezTo>
                          <a:pt x="4246" y="497"/>
                          <a:pt x="4246" y="497"/>
                          <a:pt x="4246" y="497"/>
                        </a:cubicBezTo>
                        <a:cubicBezTo>
                          <a:pt x="4144" y="461"/>
                          <a:pt x="4144" y="461"/>
                          <a:pt x="4144" y="461"/>
                        </a:cubicBezTo>
                        <a:cubicBezTo>
                          <a:pt x="4092" y="494"/>
                          <a:pt x="4092" y="494"/>
                          <a:pt x="4092" y="494"/>
                        </a:cubicBezTo>
                        <a:cubicBezTo>
                          <a:pt x="3972" y="446"/>
                          <a:pt x="3972" y="446"/>
                          <a:pt x="3972" y="446"/>
                        </a:cubicBezTo>
                        <a:cubicBezTo>
                          <a:pt x="3942" y="472"/>
                          <a:pt x="3942" y="472"/>
                          <a:pt x="3942" y="472"/>
                        </a:cubicBezTo>
                        <a:cubicBezTo>
                          <a:pt x="3869" y="417"/>
                          <a:pt x="3869" y="417"/>
                          <a:pt x="3869" y="417"/>
                        </a:cubicBezTo>
                        <a:cubicBezTo>
                          <a:pt x="3778" y="402"/>
                          <a:pt x="3778" y="402"/>
                          <a:pt x="3778" y="402"/>
                        </a:cubicBezTo>
                        <a:cubicBezTo>
                          <a:pt x="3668" y="421"/>
                          <a:pt x="3668" y="421"/>
                          <a:pt x="3668" y="421"/>
                        </a:cubicBezTo>
                        <a:cubicBezTo>
                          <a:pt x="3613" y="380"/>
                          <a:pt x="3613" y="380"/>
                          <a:pt x="3613" y="380"/>
                        </a:cubicBezTo>
                        <a:cubicBezTo>
                          <a:pt x="3610" y="333"/>
                          <a:pt x="3610" y="333"/>
                          <a:pt x="3610" y="333"/>
                        </a:cubicBezTo>
                        <a:cubicBezTo>
                          <a:pt x="3555" y="264"/>
                          <a:pt x="3555" y="264"/>
                          <a:pt x="3555" y="264"/>
                        </a:cubicBezTo>
                        <a:cubicBezTo>
                          <a:pt x="3518" y="260"/>
                          <a:pt x="3518" y="260"/>
                          <a:pt x="3518" y="260"/>
                        </a:cubicBezTo>
                        <a:cubicBezTo>
                          <a:pt x="3409" y="172"/>
                          <a:pt x="3409" y="172"/>
                          <a:pt x="3409" y="172"/>
                        </a:cubicBezTo>
                        <a:cubicBezTo>
                          <a:pt x="3368" y="179"/>
                          <a:pt x="3368" y="179"/>
                          <a:pt x="3368" y="179"/>
                        </a:cubicBezTo>
                        <a:cubicBezTo>
                          <a:pt x="3332" y="128"/>
                          <a:pt x="3332" y="128"/>
                          <a:pt x="3332" y="128"/>
                        </a:cubicBezTo>
                        <a:cubicBezTo>
                          <a:pt x="3207" y="99"/>
                          <a:pt x="3207" y="99"/>
                          <a:pt x="3207" y="99"/>
                        </a:cubicBezTo>
                        <a:cubicBezTo>
                          <a:pt x="3142" y="117"/>
                          <a:pt x="3142" y="117"/>
                          <a:pt x="3142" y="117"/>
                        </a:cubicBezTo>
                        <a:cubicBezTo>
                          <a:pt x="3068" y="179"/>
                          <a:pt x="3068" y="179"/>
                          <a:pt x="3068" y="179"/>
                        </a:cubicBezTo>
                        <a:cubicBezTo>
                          <a:pt x="3003" y="198"/>
                          <a:pt x="3003" y="198"/>
                          <a:pt x="3003" y="198"/>
                        </a:cubicBezTo>
                        <a:cubicBezTo>
                          <a:pt x="2970" y="256"/>
                          <a:pt x="2970" y="256"/>
                          <a:pt x="2970" y="256"/>
                        </a:cubicBezTo>
                        <a:cubicBezTo>
                          <a:pt x="2944" y="300"/>
                          <a:pt x="2944" y="300"/>
                          <a:pt x="2944" y="300"/>
                        </a:cubicBezTo>
                        <a:cubicBezTo>
                          <a:pt x="2900" y="359"/>
                          <a:pt x="2900" y="359"/>
                          <a:pt x="2900" y="359"/>
                        </a:cubicBezTo>
                        <a:cubicBezTo>
                          <a:pt x="2882" y="413"/>
                          <a:pt x="2882" y="413"/>
                          <a:pt x="2882" y="413"/>
                        </a:cubicBezTo>
                        <a:cubicBezTo>
                          <a:pt x="2842" y="439"/>
                          <a:pt x="2842" y="439"/>
                          <a:pt x="2842" y="439"/>
                        </a:cubicBezTo>
                        <a:cubicBezTo>
                          <a:pt x="2776" y="439"/>
                          <a:pt x="2776" y="439"/>
                          <a:pt x="2776" y="439"/>
                        </a:cubicBezTo>
                        <a:cubicBezTo>
                          <a:pt x="2776" y="472"/>
                          <a:pt x="2776" y="472"/>
                          <a:pt x="2776" y="472"/>
                        </a:cubicBezTo>
                        <a:cubicBezTo>
                          <a:pt x="2816" y="581"/>
                          <a:pt x="2816" y="581"/>
                          <a:pt x="2816" y="581"/>
                        </a:cubicBezTo>
                        <a:cubicBezTo>
                          <a:pt x="2798" y="643"/>
                          <a:pt x="2798" y="643"/>
                          <a:pt x="2798" y="643"/>
                        </a:cubicBezTo>
                        <a:cubicBezTo>
                          <a:pt x="2805" y="738"/>
                          <a:pt x="2805" y="738"/>
                          <a:pt x="2805" y="738"/>
                        </a:cubicBezTo>
                        <a:cubicBezTo>
                          <a:pt x="2823" y="888"/>
                          <a:pt x="2823" y="888"/>
                          <a:pt x="2823" y="888"/>
                        </a:cubicBezTo>
                        <a:cubicBezTo>
                          <a:pt x="2805" y="969"/>
                          <a:pt x="2805" y="969"/>
                          <a:pt x="2805" y="969"/>
                        </a:cubicBezTo>
                        <a:cubicBezTo>
                          <a:pt x="2758" y="1020"/>
                          <a:pt x="2758" y="1020"/>
                          <a:pt x="2758" y="1020"/>
                        </a:cubicBezTo>
                        <a:cubicBezTo>
                          <a:pt x="2725" y="1100"/>
                          <a:pt x="2725" y="1100"/>
                          <a:pt x="2725" y="1100"/>
                        </a:cubicBezTo>
                        <a:cubicBezTo>
                          <a:pt x="2721" y="1151"/>
                          <a:pt x="2721" y="1151"/>
                          <a:pt x="2721" y="1151"/>
                        </a:cubicBezTo>
                        <a:cubicBezTo>
                          <a:pt x="2637" y="1265"/>
                          <a:pt x="2637" y="1265"/>
                          <a:pt x="2637" y="1265"/>
                        </a:cubicBezTo>
                        <a:cubicBezTo>
                          <a:pt x="2604" y="1338"/>
                          <a:pt x="2604" y="1338"/>
                          <a:pt x="2604" y="1338"/>
                        </a:cubicBezTo>
                        <a:cubicBezTo>
                          <a:pt x="2578" y="1371"/>
                          <a:pt x="2578" y="1371"/>
                          <a:pt x="2578" y="1371"/>
                        </a:cubicBezTo>
                        <a:cubicBezTo>
                          <a:pt x="2571" y="1469"/>
                          <a:pt x="2571" y="1469"/>
                          <a:pt x="2571" y="1469"/>
                        </a:cubicBezTo>
                        <a:cubicBezTo>
                          <a:pt x="2564" y="1553"/>
                          <a:pt x="2564" y="1553"/>
                          <a:pt x="2564" y="1553"/>
                        </a:cubicBezTo>
                        <a:cubicBezTo>
                          <a:pt x="2564" y="1579"/>
                          <a:pt x="2564" y="1579"/>
                          <a:pt x="2564" y="1579"/>
                        </a:cubicBezTo>
                        <a:cubicBezTo>
                          <a:pt x="2564" y="1670"/>
                          <a:pt x="2564" y="1670"/>
                          <a:pt x="2564" y="1670"/>
                        </a:cubicBezTo>
                        <a:cubicBezTo>
                          <a:pt x="2520" y="1794"/>
                          <a:pt x="2520" y="1794"/>
                          <a:pt x="2520" y="1794"/>
                        </a:cubicBezTo>
                        <a:cubicBezTo>
                          <a:pt x="2513" y="1845"/>
                          <a:pt x="2513" y="1845"/>
                          <a:pt x="2513" y="1845"/>
                        </a:cubicBezTo>
                        <a:cubicBezTo>
                          <a:pt x="2465" y="1911"/>
                          <a:pt x="2465" y="1911"/>
                          <a:pt x="2465" y="1911"/>
                        </a:cubicBezTo>
                        <a:cubicBezTo>
                          <a:pt x="2480" y="1981"/>
                          <a:pt x="2480" y="1981"/>
                          <a:pt x="2480" y="1981"/>
                        </a:cubicBezTo>
                        <a:cubicBezTo>
                          <a:pt x="2494" y="2065"/>
                          <a:pt x="2494" y="2065"/>
                          <a:pt x="2494" y="2065"/>
                        </a:cubicBezTo>
                        <a:cubicBezTo>
                          <a:pt x="2483" y="2087"/>
                          <a:pt x="2483" y="2087"/>
                          <a:pt x="2483" y="2087"/>
                        </a:cubicBezTo>
                        <a:cubicBezTo>
                          <a:pt x="2520" y="2152"/>
                          <a:pt x="2520" y="2152"/>
                          <a:pt x="2520" y="2152"/>
                        </a:cubicBezTo>
                        <a:cubicBezTo>
                          <a:pt x="2513" y="2204"/>
                          <a:pt x="2513" y="2204"/>
                          <a:pt x="2513" y="2204"/>
                        </a:cubicBezTo>
                        <a:cubicBezTo>
                          <a:pt x="2458" y="2255"/>
                          <a:pt x="2458" y="2255"/>
                          <a:pt x="2458" y="2255"/>
                        </a:cubicBezTo>
                        <a:cubicBezTo>
                          <a:pt x="2418" y="2368"/>
                          <a:pt x="2418" y="2368"/>
                          <a:pt x="2418" y="2368"/>
                        </a:cubicBezTo>
                        <a:cubicBezTo>
                          <a:pt x="2414" y="2452"/>
                          <a:pt x="2414" y="2452"/>
                          <a:pt x="2414" y="2452"/>
                        </a:cubicBezTo>
                        <a:cubicBezTo>
                          <a:pt x="2414" y="2551"/>
                          <a:pt x="2414" y="2551"/>
                          <a:pt x="2414" y="2551"/>
                        </a:cubicBezTo>
                        <a:cubicBezTo>
                          <a:pt x="2374" y="2649"/>
                          <a:pt x="2374" y="2649"/>
                          <a:pt x="2374" y="2649"/>
                        </a:cubicBezTo>
                        <a:cubicBezTo>
                          <a:pt x="2282" y="2741"/>
                          <a:pt x="2282" y="2741"/>
                          <a:pt x="2282" y="2741"/>
                        </a:cubicBezTo>
                        <a:cubicBezTo>
                          <a:pt x="2209" y="2795"/>
                          <a:pt x="2209" y="2795"/>
                          <a:pt x="2209" y="2795"/>
                        </a:cubicBezTo>
                        <a:cubicBezTo>
                          <a:pt x="2162" y="2795"/>
                          <a:pt x="2162" y="2795"/>
                          <a:pt x="2162" y="2795"/>
                        </a:cubicBezTo>
                        <a:cubicBezTo>
                          <a:pt x="2052" y="2868"/>
                          <a:pt x="2052" y="2868"/>
                          <a:pt x="2052" y="2868"/>
                        </a:cubicBezTo>
                        <a:cubicBezTo>
                          <a:pt x="2001" y="2945"/>
                          <a:pt x="2001" y="2945"/>
                          <a:pt x="2001" y="2945"/>
                        </a:cubicBezTo>
                        <a:cubicBezTo>
                          <a:pt x="1884" y="3157"/>
                          <a:pt x="1884" y="3157"/>
                          <a:pt x="1884" y="3157"/>
                        </a:cubicBezTo>
                        <a:cubicBezTo>
                          <a:pt x="1891" y="3168"/>
                          <a:pt x="1891" y="3168"/>
                          <a:pt x="1891" y="3168"/>
                        </a:cubicBezTo>
                        <a:cubicBezTo>
                          <a:pt x="1792" y="3256"/>
                          <a:pt x="1792" y="3256"/>
                          <a:pt x="1792" y="3256"/>
                        </a:cubicBezTo>
                        <a:cubicBezTo>
                          <a:pt x="1748" y="3300"/>
                          <a:pt x="1748" y="3300"/>
                          <a:pt x="1748" y="3300"/>
                        </a:cubicBezTo>
                        <a:cubicBezTo>
                          <a:pt x="1745" y="3413"/>
                          <a:pt x="1745" y="3413"/>
                          <a:pt x="1745" y="3413"/>
                        </a:cubicBezTo>
                        <a:cubicBezTo>
                          <a:pt x="1767" y="3490"/>
                          <a:pt x="1767" y="3490"/>
                          <a:pt x="1767" y="3490"/>
                        </a:cubicBezTo>
                        <a:cubicBezTo>
                          <a:pt x="1748" y="3563"/>
                          <a:pt x="1748" y="3563"/>
                          <a:pt x="1748" y="3563"/>
                        </a:cubicBezTo>
                        <a:cubicBezTo>
                          <a:pt x="1741" y="3698"/>
                          <a:pt x="1741" y="3698"/>
                          <a:pt x="1741" y="3698"/>
                        </a:cubicBezTo>
                        <a:cubicBezTo>
                          <a:pt x="1741" y="3760"/>
                          <a:pt x="1741" y="3760"/>
                          <a:pt x="1741" y="3760"/>
                        </a:cubicBezTo>
                        <a:cubicBezTo>
                          <a:pt x="1763" y="3782"/>
                          <a:pt x="1763" y="3782"/>
                          <a:pt x="1763" y="3782"/>
                        </a:cubicBezTo>
                        <a:cubicBezTo>
                          <a:pt x="1726" y="3840"/>
                          <a:pt x="1726" y="3840"/>
                          <a:pt x="1726" y="3840"/>
                        </a:cubicBezTo>
                        <a:cubicBezTo>
                          <a:pt x="1628" y="4063"/>
                          <a:pt x="1628" y="4063"/>
                          <a:pt x="1628" y="4063"/>
                        </a:cubicBezTo>
                        <a:cubicBezTo>
                          <a:pt x="1628" y="4063"/>
                          <a:pt x="1628" y="4063"/>
                          <a:pt x="1628" y="4063"/>
                        </a:cubicBezTo>
                        <a:cubicBezTo>
                          <a:pt x="1598" y="4085"/>
                          <a:pt x="1598" y="4085"/>
                          <a:pt x="1598" y="4085"/>
                        </a:cubicBezTo>
                        <a:cubicBezTo>
                          <a:pt x="1529" y="4089"/>
                          <a:pt x="1529" y="4089"/>
                          <a:pt x="1529" y="4089"/>
                        </a:cubicBezTo>
                        <a:cubicBezTo>
                          <a:pt x="1460" y="4125"/>
                          <a:pt x="1460" y="4125"/>
                          <a:pt x="1460" y="4125"/>
                        </a:cubicBezTo>
                        <a:cubicBezTo>
                          <a:pt x="1445" y="4173"/>
                          <a:pt x="1445" y="4173"/>
                          <a:pt x="1445" y="4173"/>
                        </a:cubicBezTo>
                        <a:cubicBezTo>
                          <a:pt x="1427" y="4209"/>
                          <a:pt x="1427" y="4209"/>
                          <a:pt x="1427" y="4209"/>
                        </a:cubicBezTo>
                        <a:cubicBezTo>
                          <a:pt x="1390" y="4220"/>
                          <a:pt x="1390" y="4220"/>
                          <a:pt x="1390" y="4220"/>
                        </a:cubicBezTo>
                        <a:cubicBezTo>
                          <a:pt x="1324" y="4213"/>
                          <a:pt x="1324" y="4213"/>
                          <a:pt x="1324" y="4213"/>
                        </a:cubicBezTo>
                        <a:cubicBezTo>
                          <a:pt x="1321" y="4231"/>
                          <a:pt x="1321" y="4231"/>
                          <a:pt x="1321" y="4231"/>
                        </a:cubicBezTo>
                        <a:cubicBezTo>
                          <a:pt x="1317" y="4228"/>
                          <a:pt x="1317" y="4228"/>
                          <a:pt x="1317" y="4228"/>
                        </a:cubicBezTo>
                        <a:cubicBezTo>
                          <a:pt x="1247" y="4326"/>
                          <a:pt x="1247" y="4326"/>
                          <a:pt x="1247" y="4326"/>
                        </a:cubicBezTo>
                        <a:cubicBezTo>
                          <a:pt x="1178" y="4407"/>
                          <a:pt x="1178" y="4407"/>
                          <a:pt x="1178" y="4407"/>
                        </a:cubicBezTo>
                        <a:cubicBezTo>
                          <a:pt x="1156" y="4450"/>
                          <a:pt x="1156" y="4450"/>
                          <a:pt x="1156" y="4450"/>
                        </a:cubicBezTo>
                        <a:cubicBezTo>
                          <a:pt x="1087" y="4491"/>
                          <a:pt x="1087" y="4491"/>
                          <a:pt x="1087" y="4491"/>
                        </a:cubicBezTo>
                        <a:cubicBezTo>
                          <a:pt x="1006" y="4465"/>
                          <a:pt x="1006" y="4465"/>
                          <a:pt x="1006" y="4465"/>
                        </a:cubicBezTo>
                        <a:cubicBezTo>
                          <a:pt x="962" y="4476"/>
                          <a:pt x="962" y="4476"/>
                          <a:pt x="962" y="4476"/>
                        </a:cubicBezTo>
                        <a:cubicBezTo>
                          <a:pt x="962" y="4374"/>
                          <a:pt x="962" y="4374"/>
                          <a:pt x="962" y="4374"/>
                        </a:cubicBezTo>
                        <a:cubicBezTo>
                          <a:pt x="940" y="4326"/>
                          <a:pt x="940" y="4326"/>
                          <a:pt x="940" y="4326"/>
                        </a:cubicBezTo>
                        <a:cubicBezTo>
                          <a:pt x="991" y="4282"/>
                          <a:pt x="991" y="4282"/>
                          <a:pt x="991" y="4282"/>
                        </a:cubicBezTo>
                        <a:cubicBezTo>
                          <a:pt x="962" y="4249"/>
                          <a:pt x="962" y="4249"/>
                          <a:pt x="962" y="4249"/>
                        </a:cubicBezTo>
                        <a:cubicBezTo>
                          <a:pt x="977" y="4206"/>
                          <a:pt x="977" y="4206"/>
                          <a:pt x="977" y="4206"/>
                        </a:cubicBezTo>
                        <a:cubicBezTo>
                          <a:pt x="904" y="4246"/>
                          <a:pt x="904" y="4246"/>
                          <a:pt x="904" y="4246"/>
                        </a:cubicBezTo>
                        <a:cubicBezTo>
                          <a:pt x="809" y="4271"/>
                          <a:pt x="809" y="4271"/>
                          <a:pt x="809" y="4271"/>
                        </a:cubicBezTo>
                        <a:cubicBezTo>
                          <a:pt x="772" y="4315"/>
                          <a:pt x="772" y="4315"/>
                          <a:pt x="772" y="4315"/>
                        </a:cubicBezTo>
                        <a:cubicBezTo>
                          <a:pt x="732" y="4293"/>
                          <a:pt x="732" y="4293"/>
                          <a:pt x="732" y="4293"/>
                        </a:cubicBezTo>
                        <a:cubicBezTo>
                          <a:pt x="710" y="4268"/>
                          <a:pt x="710" y="4268"/>
                          <a:pt x="710" y="4268"/>
                        </a:cubicBezTo>
                        <a:cubicBezTo>
                          <a:pt x="670" y="4286"/>
                          <a:pt x="670" y="4286"/>
                          <a:pt x="670" y="4286"/>
                        </a:cubicBezTo>
                        <a:cubicBezTo>
                          <a:pt x="677" y="4341"/>
                          <a:pt x="677" y="4341"/>
                          <a:pt x="677" y="4341"/>
                        </a:cubicBezTo>
                        <a:cubicBezTo>
                          <a:pt x="662" y="4388"/>
                          <a:pt x="662" y="4388"/>
                          <a:pt x="662" y="4388"/>
                        </a:cubicBezTo>
                        <a:cubicBezTo>
                          <a:pt x="618" y="4428"/>
                          <a:pt x="618" y="4428"/>
                          <a:pt x="618" y="4428"/>
                        </a:cubicBezTo>
                        <a:cubicBezTo>
                          <a:pt x="534" y="4487"/>
                          <a:pt x="534" y="4487"/>
                          <a:pt x="534" y="4487"/>
                        </a:cubicBezTo>
                        <a:cubicBezTo>
                          <a:pt x="516" y="4443"/>
                          <a:pt x="516" y="4443"/>
                          <a:pt x="516" y="4443"/>
                        </a:cubicBezTo>
                        <a:cubicBezTo>
                          <a:pt x="469" y="4421"/>
                          <a:pt x="469" y="4421"/>
                          <a:pt x="469" y="4421"/>
                        </a:cubicBezTo>
                        <a:cubicBezTo>
                          <a:pt x="465" y="4388"/>
                          <a:pt x="465" y="4388"/>
                          <a:pt x="465" y="4388"/>
                        </a:cubicBezTo>
                        <a:cubicBezTo>
                          <a:pt x="403" y="4344"/>
                          <a:pt x="403" y="4344"/>
                          <a:pt x="403" y="4344"/>
                        </a:cubicBezTo>
                        <a:cubicBezTo>
                          <a:pt x="395" y="4388"/>
                          <a:pt x="395" y="4388"/>
                          <a:pt x="395" y="4388"/>
                        </a:cubicBezTo>
                        <a:cubicBezTo>
                          <a:pt x="297" y="4421"/>
                          <a:pt x="297" y="4421"/>
                          <a:pt x="297" y="4421"/>
                        </a:cubicBezTo>
                        <a:cubicBezTo>
                          <a:pt x="235" y="4483"/>
                          <a:pt x="235" y="4483"/>
                          <a:pt x="235" y="4483"/>
                        </a:cubicBezTo>
                        <a:cubicBezTo>
                          <a:pt x="128" y="4571"/>
                          <a:pt x="128" y="4571"/>
                          <a:pt x="128" y="4571"/>
                        </a:cubicBezTo>
                        <a:cubicBezTo>
                          <a:pt x="150" y="4593"/>
                          <a:pt x="150" y="4593"/>
                          <a:pt x="150" y="4593"/>
                        </a:cubicBezTo>
                        <a:cubicBezTo>
                          <a:pt x="143" y="4852"/>
                          <a:pt x="143" y="4852"/>
                          <a:pt x="143" y="4852"/>
                        </a:cubicBezTo>
                        <a:cubicBezTo>
                          <a:pt x="0" y="4867"/>
                          <a:pt x="0" y="4867"/>
                          <a:pt x="0" y="4867"/>
                        </a:cubicBezTo>
                        <a:cubicBezTo>
                          <a:pt x="70" y="4977"/>
                          <a:pt x="70" y="4977"/>
                          <a:pt x="70" y="4977"/>
                        </a:cubicBezTo>
                        <a:cubicBezTo>
                          <a:pt x="88" y="4984"/>
                          <a:pt x="88" y="4984"/>
                          <a:pt x="88" y="4984"/>
                        </a:cubicBezTo>
                        <a:cubicBezTo>
                          <a:pt x="132" y="4980"/>
                          <a:pt x="132" y="4980"/>
                          <a:pt x="132" y="4980"/>
                        </a:cubicBezTo>
                        <a:cubicBezTo>
                          <a:pt x="242" y="4962"/>
                          <a:pt x="242" y="4962"/>
                          <a:pt x="242" y="4962"/>
                        </a:cubicBezTo>
                        <a:cubicBezTo>
                          <a:pt x="322" y="4922"/>
                          <a:pt x="322" y="4922"/>
                          <a:pt x="322" y="4922"/>
                        </a:cubicBezTo>
                        <a:cubicBezTo>
                          <a:pt x="392" y="4914"/>
                          <a:pt x="392" y="4914"/>
                          <a:pt x="392" y="4914"/>
                        </a:cubicBezTo>
                        <a:cubicBezTo>
                          <a:pt x="428" y="4922"/>
                          <a:pt x="428" y="4922"/>
                          <a:pt x="428" y="4922"/>
                        </a:cubicBezTo>
                        <a:cubicBezTo>
                          <a:pt x="472" y="4911"/>
                          <a:pt x="472" y="4911"/>
                          <a:pt x="472" y="4911"/>
                        </a:cubicBezTo>
                        <a:cubicBezTo>
                          <a:pt x="512" y="4922"/>
                          <a:pt x="512" y="4922"/>
                          <a:pt x="512" y="4922"/>
                        </a:cubicBezTo>
                        <a:cubicBezTo>
                          <a:pt x="534" y="4907"/>
                          <a:pt x="534" y="4907"/>
                          <a:pt x="534" y="4907"/>
                        </a:cubicBezTo>
                        <a:cubicBezTo>
                          <a:pt x="732" y="4914"/>
                          <a:pt x="732" y="4914"/>
                          <a:pt x="732" y="4914"/>
                        </a:cubicBezTo>
                        <a:cubicBezTo>
                          <a:pt x="776" y="4900"/>
                          <a:pt x="776" y="4900"/>
                          <a:pt x="776" y="4900"/>
                        </a:cubicBezTo>
                        <a:cubicBezTo>
                          <a:pt x="809" y="4914"/>
                          <a:pt x="809" y="4914"/>
                          <a:pt x="809" y="4914"/>
                        </a:cubicBezTo>
                        <a:cubicBezTo>
                          <a:pt x="834" y="4900"/>
                          <a:pt x="834" y="4900"/>
                          <a:pt x="834" y="4900"/>
                        </a:cubicBezTo>
                        <a:cubicBezTo>
                          <a:pt x="1046" y="4933"/>
                          <a:pt x="1046" y="4933"/>
                          <a:pt x="1046" y="4933"/>
                        </a:cubicBezTo>
                        <a:cubicBezTo>
                          <a:pt x="1087" y="4911"/>
                          <a:pt x="1087" y="4911"/>
                          <a:pt x="1087" y="4911"/>
                        </a:cubicBezTo>
                        <a:cubicBezTo>
                          <a:pt x="1701" y="4907"/>
                          <a:pt x="1701" y="4907"/>
                          <a:pt x="1701" y="4907"/>
                        </a:cubicBezTo>
                        <a:cubicBezTo>
                          <a:pt x="1814" y="4907"/>
                          <a:pt x="1814" y="4907"/>
                          <a:pt x="1814" y="4907"/>
                        </a:cubicBezTo>
                        <a:cubicBezTo>
                          <a:pt x="1851" y="4929"/>
                          <a:pt x="1851" y="4929"/>
                          <a:pt x="1851" y="4929"/>
                        </a:cubicBezTo>
                        <a:cubicBezTo>
                          <a:pt x="1887" y="4907"/>
                          <a:pt x="1887" y="4907"/>
                          <a:pt x="1887" y="4907"/>
                        </a:cubicBezTo>
                        <a:cubicBezTo>
                          <a:pt x="1917" y="4936"/>
                          <a:pt x="1917" y="4936"/>
                          <a:pt x="1917" y="4936"/>
                        </a:cubicBezTo>
                        <a:cubicBezTo>
                          <a:pt x="1924" y="4998"/>
                          <a:pt x="1924" y="4998"/>
                          <a:pt x="1924" y="4998"/>
                        </a:cubicBezTo>
                        <a:cubicBezTo>
                          <a:pt x="1975" y="5042"/>
                          <a:pt x="1975" y="5042"/>
                          <a:pt x="1975" y="5042"/>
                        </a:cubicBezTo>
                        <a:cubicBezTo>
                          <a:pt x="1968" y="5137"/>
                          <a:pt x="1968" y="5137"/>
                          <a:pt x="1968" y="5137"/>
                        </a:cubicBezTo>
                        <a:cubicBezTo>
                          <a:pt x="2037" y="5316"/>
                          <a:pt x="2037" y="5316"/>
                          <a:pt x="2037" y="5316"/>
                        </a:cubicBezTo>
                        <a:cubicBezTo>
                          <a:pt x="2081" y="5375"/>
                          <a:pt x="2081" y="5375"/>
                          <a:pt x="2081" y="5375"/>
                        </a:cubicBezTo>
                        <a:cubicBezTo>
                          <a:pt x="2074" y="5444"/>
                          <a:pt x="2074" y="5444"/>
                          <a:pt x="2074" y="5444"/>
                        </a:cubicBezTo>
                        <a:cubicBezTo>
                          <a:pt x="2092" y="5517"/>
                          <a:pt x="2092" y="5517"/>
                          <a:pt x="2092" y="5517"/>
                        </a:cubicBezTo>
                        <a:cubicBezTo>
                          <a:pt x="2147" y="5568"/>
                          <a:pt x="2147" y="5568"/>
                          <a:pt x="2147" y="5568"/>
                        </a:cubicBezTo>
                        <a:cubicBezTo>
                          <a:pt x="2191" y="5630"/>
                          <a:pt x="2191" y="5630"/>
                          <a:pt x="2191" y="5630"/>
                        </a:cubicBezTo>
                        <a:cubicBezTo>
                          <a:pt x="2227" y="5682"/>
                          <a:pt x="2227" y="5682"/>
                          <a:pt x="2227" y="5682"/>
                        </a:cubicBezTo>
                        <a:cubicBezTo>
                          <a:pt x="2238" y="5722"/>
                          <a:pt x="2238" y="5722"/>
                          <a:pt x="2238" y="5722"/>
                        </a:cubicBezTo>
                        <a:cubicBezTo>
                          <a:pt x="2319" y="5853"/>
                          <a:pt x="2319" y="5853"/>
                          <a:pt x="2319" y="5853"/>
                        </a:cubicBezTo>
                        <a:cubicBezTo>
                          <a:pt x="2348" y="5901"/>
                          <a:pt x="2348" y="5901"/>
                          <a:pt x="2348" y="5901"/>
                        </a:cubicBezTo>
                        <a:cubicBezTo>
                          <a:pt x="2388" y="5883"/>
                          <a:pt x="2388" y="5883"/>
                          <a:pt x="2388" y="5883"/>
                        </a:cubicBezTo>
                        <a:cubicBezTo>
                          <a:pt x="2440" y="5890"/>
                          <a:pt x="2440" y="5890"/>
                          <a:pt x="2440" y="5890"/>
                        </a:cubicBezTo>
                        <a:cubicBezTo>
                          <a:pt x="2476" y="5879"/>
                          <a:pt x="2476" y="5879"/>
                          <a:pt x="2476" y="5879"/>
                        </a:cubicBezTo>
                        <a:cubicBezTo>
                          <a:pt x="2513" y="5886"/>
                          <a:pt x="2513" y="5886"/>
                          <a:pt x="2513" y="5886"/>
                        </a:cubicBezTo>
                        <a:cubicBezTo>
                          <a:pt x="2586" y="5890"/>
                          <a:pt x="2586" y="5890"/>
                          <a:pt x="2586" y="5890"/>
                        </a:cubicBezTo>
                        <a:cubicBezTo>
                          <a:pt x="2575" y="5853"/>
                          <a:pt x="2575" y="5853"/>
                          <a:pt x="2575" y="5853"/>
                        </a:cubicBezTo>
                        <a:cubicBezTo>
                          <a:pt x="2663" y="5839"/>
                          <a:pt x="2663" y="5839"/>
                          <a:pt x="2663" y="5839"/>
                        </a:cubicBezTo>
                        <a:cubicBezTo>
                          <a:pt x="2688" y="5850"/>
                          <a:pt x="2688" y="5850"/>
                          <a:pt x="2688" y="5850"/>
                        </a:cubicBezTo>
                        <a:cubicBezTo>
                          <a:pt x="2703" y="5839"/>
                          <a:pt x="2703" y="5839"/>
                          <a:pt x="2703" y="5839"/>
                        </a:cubicBezTo>
                        <a:cubicBezTo>
                          <a:pt x="2769" y="5842"/>
                          <a:pt x="2769" y="5842"/>
                          <a:pt x="2769" y="5842"/>
                        </a:cubicBezTo>
                        <a:cubicBezTo>
                          <a:pt x="2758" y="5810"/>
                          <a:pt x="2758" y="5810"/>
                          <a:pt x="2758" y="5810"/>
                        </a:cubicBezTo>
                        <a:cubicBezTo>
                          <a:pt x="2871" y="5813"/>
                          <a:pt x="2871" y="5813"/>
                          <a:pt x="2871" y="5813"/>
                        </a:cubicBezTo>
                        <a:cubicBezTo>
                          <a:pt x="2886" y="5846"/>
                          <a:pt x="2886" y="5846"/>
                          <a:pt x="2886" y="5846"/>
                        </a:cubicBezTo>
                        <a:cubicBezTo>
                          <a:pt x="3145" y="5846"/>
                          <a:pt x="3145" y="5846"/>
                          <a:pt x="3145" y="5846"/>
                        </a:cubicBezTo>
                        <a:cubicBezTo>
                          <a:pt x="3127" y="5824"/>
                          <a:pt x="3127" y="5824"/>
                          <a:pt x="3127" y="5824"/>
                        </a:cubicBezTo>
                        <a:cubicBezTo>
                          <a:pt x="3149" y="5711"/>
                          <a:pt x="3149" y="5711"/>
                          <a:pt x="3149" y="5711"/>
                        </a:cubicBezTo>
                        <a:cubicBezTo>
                          <a:pt x="3131" y="5660"/>
                          <a:pt x="3131" y="5660"/>
                          <a:pt x="3131" y="5660"/>
                        </a:cubicBezTo>
                        <a:cubicBezTo>
                          <a:pt x="3171" y="5656"/>
                          <a:pt x="3171" y="5656"/>
                          <a:pt x="3171" y="5656"/>
                        </a:cubicBezTo>
                        <a:cubicBezTo>
                          <a:pt x="3204" y="5623"/>
                          <a:pt x="3204" y="5623"/>
                          <a:pt x="3204" y="5623"/>
                        </a:cubicBezTo>
                        <a:cubicBezTo>
                          <a:pt x="3193" y="5488"/>
                          <a:pt x="3193" y="5488"/>
                          <a:pt x="3193" y="5488"/>
                        </a:cubicBezTo>
                        <a:cubicBezTo>
                          <a:pt x="3222" y="5441"/>
                          <a:pt x="3222" y="5441"/>
                          <a:pt x="3222" y="5441"/>
                        </a:cubicBezTo>
                        <a:cubicBezTo>
                          <a:pt x="3207" y="5404"/>
                          <a:pt x="3207" y="5404"/>
                          <a:pt x="3207" y="5404"/>
                        </a:cubicBezTo>
                        <a:cubicBezTo>
                          <a:pt x="3387" y="5400"/>
                          <a:pt x="3387" y="5400"/>
                          <a:pt x="3387" y="5400"/>
                        </a:cubicBezTo>
                        <a:cubicBezTo>
                          <a:pt x="3387" y="5404"/>
                          <a:pt x="3387" y="5404"/>
                          <a:pt x="3387" y="5404"/>
                        </a:cubicBezTo>
                        <a:cubicBezTo>
                          <a:pt x="3548" y="5408"/>
                          <a:pt x="3548" y="5408"/>
                          <a:pt x="3548" y="5408"/>
                        </a:cubicBezTo>
                        <a:cubicBezTo>
                          <a:pt x="3551" y="5367"/>
                          <a:pt x="3551" y="5367"/>
                          <a:pt x="3551" y="5367"/>
                        </a:cubicBezTo>
                        <a:cubicBezTo>
                          <a:pt x="3679" y="5367"/>
                          <a:pt x="3679" y="5367"/>
                          <a:pt x="3679" y="5367"/>
                        </a:cubicBezTo>
                        <a:cubicBezTo>
                          <a:pt x="3650" y="5466"/>
                          <a:pt x="3650" y="5466"/>
                          <a:pt x="3650" y="5466"/>
                        </a:cubicBezTo>
                        <a:cubicBezTo>
                          <a:pt x="3646" y="5528"/>
                          <a:pt x="3646" y="5528"/>
                          <a:pt x="3646" y="5528"/>
                        </a:cubicBezTo>
                        <a:cubicBezTo>
                          <a:pt x="4184" y="5539"/>
                          <a:pt x="4184" y="5539"/>
                          <a:pt x="4184" y="5539"/>
                        </a:cubicBezTo>
                        <a:cubicBezTo>
                          <a:pt x="4195" y="5539"/>
                          <a:pt x="4195" y="5539"/>
                          <a:pt x="4195" y="5539"/>
                        </a:cubicBezTo>
                        <a:cubicBezTo>
                          <a:pt x="4217" y="5605"/>
                          <a:pt x="4217" y="5605"/>
                          <a:pt x="4217" y="5605"/>
                        </a:cubicBezTo>
                        <a:cubicBezTo>
                          <a:pt x="4202" y="5689"/>
                          <a:pt x="4202" y="5689"/>
                          <a:pt x="4202" y="5689"/>
                        </a:cubicBezTo>
                        <a:cubicBezTo>
                          <a:pt x="4202" y="5689"/>
                          <a:pt x="4209" y="5700"/>
                          <a:pt x="4213" y="5704"/>
                        </a:cubicBezTo>
                        <a:cubicBezTo>
                          <a:pt x="4209" y="5704"/>
                          <a:pt x="4209" y="5704"/>
                          <a:pt x="4209" y="5704"/>
                        </a:cubicBezTo>
                        <a:cubicBezTo>
                          <a:pt x="4195" y="5828"/>
                          <a:pt x="4195" y="5828"/>
                          <a:pt x="4195" y="5828"/>
                        </a:cubicBezTo>
                        <a:cubicBezTo>
                          <a:pt x="4272" y="6021"/>
                          <a:pt x="4272" y="6021"/>
                          <a:pt x="4272" y="6021"/>
                        </a:cubicBezTo>
                        <a:cubicBezTo>
                          <a:pt x="4231" y="6303"/>
                          <a:pt x="4231" y="6303"/>
                          <a:pt x="4231" y="6303"/>
                        </a:cubicBezTo>
                        <a:cubicBezTo>
                          <a:pt x="4235" y="6390"/>
                          <a:pt x="4235" y="6390"/>
                          <a:pt x="4235" y="6390"/>
                        </a:cubicBezTo>
                        <a:cubicBezTo>
                          <a:pt x="4206" y="6456"/>
                          <a:pt x="4206" y="6456"/>
                          <a:pt x="4206" y="6456"/>
                        </a:cubicBezTo>
                        <a:cubicBezTo>
                          <a:pt x="4246" y="6558"/>
                          <a:pt x="4246" y="6558"/>
                          <a:pt x="4246" y="6558"/>
                        </a:cubicBezTo>
                        <a:cubicBezTo>
                          <a:pt x="4326" y="6646"/>
                          <a:pt x="4326" y="6646"/>
                          <a:pt x="4326" y="6646"/>
                        </a:cubicBezTo>
                        <a:cubicBezTo>
                          <a:pt x="4381" y="6679"/>
                          <a:pt x="4381" y="6679"/>
                          <a:pt x="4381" y="6679"/>
                        </a:cubicBezTo>
                        <a:cubicBezTo>
                          <a:pt x="4400" y="6803"/>
                          <a:pt x="4400" y="6803"/>
                          <a:pt x="4400" y="6803"/>
                        </a:cubicBezTo>
                        <a:cubicBezTo>
                          <a:pt x="4440" y="6913"/>
                          <a:pt x="4440" y="6913"/>
                          <a:pt x="4440" y="6913"/>
                        </a:cubicBezTo>
                        <a:cubicBezTo>
                          <a:pt x="4447" y="7022"/>
                          <a:pt x="4447" y="7022"/>
                          <a:pt x="4447" y="7022"/>
                        </a:cubicBezTo>
                        <a:cubicBezTo>
                          <a:pt x="4443" y="7066"/>
                          <a:pt x="4443" y="7066"/>
                          <a:pt x="4443" y="7066"/>
                        </a:cubicBezTo>
                        <a:cubicBezTo>
                          <a:pt x="4381" y="7099"/>
                          <a:pt x="4381" y="7099"/>
                          <a:pt x="4381" y="7099"/>
                        </a:cubicBezTo>
                        <a:cubicBezTo>
                          <a:pt x="4421" y="7238"/>
                          <a:pt x="4421" y="7238"/>
                          <a:pt x="4421" y="7238"/>
                        </a:cubicBezTo>
                        <a:cubicBezTo>
                          <a:pt x="4487" y="7245"/>
                          <a:pt x="4487" y="7245"/>
                          <a:pt x="4487" y="7245"/>
                        </a:cubicBezTo>
                        <a:cubicBezTo>
                          <a:pt x="4528" y="7201"/>
                          <a:pt x="4528" y="7201"/>
                          <a:pt x="4528" y="7201"/>
                        </a:cubicBezTo>
                        <a:cubicBezTo>
                          <a:pt x="4542" y="7180"/>
                          <a:pt x="4542" y="7180"/>
                          <a:pt x="4542" y="7180"/>
                        </a:cubicBezTo>
                        <a:cubicBezTo>
                          <a:pt x="4666" y="7209"/>
                          <a:pt x="4666" y="7209"/>
                          <a:pt x="4666" y="7209"/>
                        </a:cubicBezTo>
                        <a:cubicBezTo>
                          <a:pt x="4696" y="7183"/>
                          <a:pt x="4696" y="7183"/>
                          <a:pt x="4696" y="7183"/>
                        </a:cubicBezTo>
                        <a:cubicBezTo>
                          <a:pt x="4805" y="7201"/>
                          <a:pt x="4805" y="7201"/>
                          <a:pt x="4805" y="7201"/>
                        </a:cubicBezTo>
                        <a:cubicBezTo>
                          <a:pt x="4922" y="7128"/>
                          <a:pt x="4922" y="7128"/>
                          <a:pt x="4922" y="7128"/>
                        </a:cubicBezTo>
                        <a:cubicBezTo>
                          <a:pt x="5116" y="7169"/>
                          <a:pt x="5116" y="7169"/>
                          <a:pt x="5116" y="7169"/>
                        </a:cubicBezTo>
                        <a:cubicBezTo>
                          <a:pt x="5193" y="7103"/>
                          <a:pt x="5193" y="7103"/>
                          <a:pt x="5193" y="7103"/>
                        </a:cubicBezTo>
                        <a:cubicBezTo>
                          <a:pt x="5233" y="7121"/>
                          <a:pt x="5233" y="7121"/>
                          <a:pt x="5233" y="7121"/>
                        </a:cubicBezTo>
                        <a:cubicBezTo>
                          <a:pt x="5237" y="7169"/>
                          <a:pt x="5237" y="7169"/>
                          <a:pt x="5237" y="7169"/>
                        </a:cubicBezTo>
                        <a:cubicBezTo>
                          <a:pt x="5295" y="7183"/>
                          <a:pt x="5295" y="7183"/>
                          <a:pt x="5295" y="7183"/>
                        </a:cubicBezTo>
                        <a:cubicBezTo>
                          <a:pt x="5328" y="7191"/>
                          <a:pt x="5328" y="7191"/>
                          <a:pt x="5328" y="7191"/>
                        </a:cubicBezTo>
                        <a:cubicBezTo>
                          <a:pt x="5347" y="7249"/>
                          <a:pt x="5347" y="7249"/>
                          <a:pt x="5347" y="7249"/>
                        </a:cubicBezTo>
                        <a:cubicBezTo>
                          <a:pt x="5328" y="7315"/>
                          <a:pt x="5328" y="7315"/>
                          <a:pt x="5328" y="7315"/>
                        </a:cubicBezTo>
                        <a:cubicBezTo>
                          <a:pt x="5358" y="7351"/>
                          <a:pt x="5358" y="7351"/>
                          <a:pt x="5358" y="7351"/>
                        </a:cubicBezTo>
                        <a:cubicBezTo>
                          <a:pt x="5427" y="7348"/>
                          <a:pt x="5427" y="7348"/>
                          <a:pt x="5427" y="7348"/>
                        </a:cubicBezTo>
                        <a:cubicBezTo>
                          <a:pt x="5537" y="7275"/>
                          <a:pt x="5537" y="7275"/>
                          <a:pt x="5537" y="7275"/>
                        </a:cubicBezTo>
                        <a:cubicBezTo>
                          <a:pt x="5756" y="7242"/>
                          <a:pt x="5756" y="7242"/>
                          <a:pt x="5756" y="7242"/>
                        </a:cubicBezTo>
                        <a:cubicBezTo>
                          <a:pt x="5738" y="7340"/>
                          <a:pt x="5738" y="7340"/>
                          <a:pt x="5738" y="7340"/>
                        </a:cubicBezTo>
                        <a:cubicBezTo>
                          <a:pt x="5745" y="7410"/>
                          <a:pt x="5745" y="7410"/>
                          <a:pt x="5745" y="7410"/>
                        </a:cubicBezTo>
                        <a:cubicBezTo>
                          <a:pt x="5785" y="7446"/>
                          <a:pt x="5785" y="7446"/>
                          <a:pt x="5785" y="7446"/>
                        </a:cubicBezTo>
                        <a:cubicBezTo>
                          <a:pt x="5826" y="7465"/>
                          <a:pt x="5826" y="7465"/>
                          <a:pt x="5826" y="7465"/>
                        </a:cubicBezTo>
                        <a:cubicBezTo>
                          <a:pt x="5826" y="7465"/>
                          <a:pt x="5818" y="7494"/>
                          <a:pt x="5826" y="7494"/>
                        </a:cubicBezTo>
                        <a:cubicBezTo>
                          <a:pt x="5833" y="7497"/>
                          <a:pt x="5895" y="7479"/>
                          <a:pt x="5895" y="7479"/>
                        </a:cubicBezTo>
                        <a:cubicBezTo>
                          <a:pt x="5924" y="7508"/>
                          <a:pt x="5924" y="7508"/>
                          <a:pt x="5924" y="7508"/>
                        </a:cubicBezTo>
                        <a:cubicBezTo>
                          <a:pt x="5935" y="7516"/>
                          <a:pt x="5935" y="7516"/>
                          <a:pt x="5935" y="7516"/>
                        </a:cubicBezTo>
                        <a:cubicBezTo>
                          <a:pt x="5998" y="7512"/>
                          <a:pt x="5998" y="7512"/>
                          <a:pt x="5998" y="7512"/>
                        </a:cubicBezTo>
                        <a:cubicBezTo>
                          <a:pt x="6038" y="7549"/>
                          <a:pt x="6038" y="7549"/>
                          <a:pt x="6038" y="7549"/>
                        </a:cubicBezTo>
                        <a:cubicBezTo>
                          <a:pt x="6041" y="7567"/>
                          <a:pt x="6041" y="7567"/>
                          <a:pt x="6041" y="7567"/>
                        </a:cubicBezTo>
                        <a:cubicBezTo>
                          <a:pt x="6169" y="7567"/>
                          <a:pt x="6169" y="7567"/>
                          <a:pt x="6169" y="7567"/>
                        </a:cubicBezTo>
                        <a:cubicBezTo>
                          <a:pt x="6253" y="7556"/>
                          <a:pt x="6253" y="7556"/>
                          <a:pt x="6253" y="7556"/>
                        </a:cubicBezTo>
                        <a:cubicBezTo>
                          <a:pt x="6349" y="7596"/>
                          <a:pt x="6349" y="7596"/>
                          <a:pt x="6349" y="7596"/>
                        </a:cubicBezTo>
                        <a:cubicBezTo>
                          <a:pt x="6381" y="7574"/>
                          <a:pt x="6381" y="7574"/>
                          <a:pt x="6381" y="7574"/>
                        </a:cubicBezTo>
                        <a:cubicBezTo>
                          <a:pt x="6414" y="7581"/>
                          <a:pt x="6414" y="7581"/>
                          <a:pt x="6414" y="7581"/>
                        </a:cubicBezTo>
                        <a:cubicBezTo>
                          <a:pt x="6458" y="7556"/>
                          <a:pt x="6458" y="7556"/>
                          <a:pt x="6458" y="7556"/>
                        </a:cubicBezTo>
                        <a:cubicBezTo>
                          <a:pt x="6506" y="7461"/>
                          <a:pt x="6506" y="7461"/>
                          <a:pt x="6506" y="7461"/>
                        </a:cubicBezTo>
                        <a:cubicBezTo>
                          <a:pt x="6499" y="7417"/>
                          <a:pt x="6499" y="7417"/>
                          <a:pt x="6499" y="7417"/>
                        </a:cubicBezTo>
                        <a:cubicBezTo>
                          <a:pt x="6583" y="7417"/>
                          <a:pt x="6583" y="7417"/>
                          <a:pt x="6583" y="7417"/>
                        </a:cubicBezTo>
                        <a:cubicBezTo>
                          <a:pt x="6568" y="7497"/>
                          <a:pt x="6568" y="7497"/>
                          <a:pt x="6568" y="7497"/>
                        </a:cubicBezTo>
                        <a:cubicBezTo>
                          <a:pt x="6659" y="7541"/>
                          <a:pt x="6659" y="7541"/>
                          <a:pt x="6659" y="7541"/>
                        </a:cubicBezTo>
                        <a:cubicBezTo>
                          <a:pt x="6689" y="7614"/>
                          <a:pt x="6689" y="7614"/>
                          <a:pt x="6689" y="7614"/>
                        </a:cubicBezTo>
                        <a:cubicBezTo>
                          <a:pt x="6729" y="7684"/>
                          <a:pt x="6729" y="7684"/>
                          <a:pt x="6729" y="7684"/>
                        </a:cubicBezTo>
                        <a:cubicBezTo>
                          <a:pt x="6776" y="7717"/>
                          <a:pt x="6776" y="7717"/>
                          <a:pt x="6776" y="7717"/>
                        </a:cubicBezTo>
                        <a:cubicBezTo>
                          <a:pt x="6824" y="7713"/>
                          <a:pt x="6824" y="7713"/>
                          <a:pt x="6824" y="7713"/>
                        </a:cubicBezTo>
                        <a:cubicBezTo>
                          <a:pt x="6886" y="7698"/>
                          <a:pt x="6886" y="7698"/>
                          <a:pt x="6886" y="7698"/>
                        </a:cubicBezTo>
                        <a:cubicBezTo>
                          <a:pt x="6901" y="7742"/>
                          <a:pt x="6901" y="7742"/>
                          <a:pt x="6901" y="7742"/>
                        </a:cubicBezTo>
                        <a:cubicBezTo>
                          <a:pt x="6952" y="7753"/>
                          <a:pt x="6952" y="7753"/>
                          <a:pt x="6952" y="7753"/>
                        </a:cubicBezTo>
                        <a:cubicBezTo>
                          <a:pt x="6974" y="7782"/>
                          <a:pt x="6974" y="7782"/>
                          <a:pt x="6974" y="7782"/>
                        </a:cubicBezTo>
                        <a:cubicBezTo>
                          <a:pt x="6999" y="7753"/>
                          <a:pt x="6999" y="7753"/>
                          <a:pt x="6999" y="7753"/>
                        </a:cubicBezTo>
                        <a:cubicBezTo>
                          <a:pt x="7062" y="7786"/>
                          <a:pt x="7062" y="7786"/>
                          <a:pt x="7062" y="7786"/>
                        </a:cubicBezTo>
                        <a:cubicBezTo>
                          <a:pt x="7138" y="7870"/>
                          <a:pt x="7138" y="7870"/>
                          <a:pt x="7138" y="7870"/>
                        </a:cubicBezTo>
                        <a:cubicBezTo>
                          <a:pt x="7116" y="7907"/>
                          <a:pt x="7116" y="7907"/>
                          <a:pt x="7116" y="7907"/>
                        </a:cubicBezTo>
                        <a:cubicBezTo>
                          <a:pt x="7168" y="7980"/>
                          <a:pt x="7168" y="7980"/>
                          <a:pt x="7168" y="7980"/>
                        </a:cubicBezTo>
                        <a:cubicBezTo>
                          <a:pt x="7201" y="7950"/>
                          <a:pt x="7201" y="7950"/>
                          <a:pt x="7201" y="7950"/>
                        </a:cubicBezTo>
                        <a:cubicBezTo>
                          <a:pt x="7266" y="8020"/>
                          <a:pt x="7266" y="8020"/>
                          <a:pt x="7266" y="8020"/>
                        </a:cubicBezTo>
                        <a:cubicBezTo>
                          <a:pt x="7288" y="8071"/>
                          <a:pt x="7288" y="8071"/>
                          <a:pt x="7288" y="8071"/>
                        </a:cubicBezTo>
                        <a:cubicBezTo>
                          <a:pt x="7318" y="8115"/>
                          <a:pt x="7318" y="8115"/>
                          <a:pt x="7318" y="8115"/>
                        </a:cubicBezTo>
                        <a:cubicBezTo>
                          <a:pt x="7361" y="8206"/>
                          <a:pt x="7361" y="8206"/>
                          <a:pt x="7361" y="8206"/>
                        </a:cubicBezTo>
                        <a:cubicBezTo>
                          <a:pt x="7413" y="8188"/>
                          <a:pt x="7413" y="8188"/>
                          <a:pt x="7413" y="8188"/>
                        </a:cubicBezTo>
                        <a:cubicBezTo>
                          <a:pt x="7435" y="8217"/>
                          <a:pt x="7435" y="8217"/>
                          <a:pt x="7435" y="8217"/>
                        </a:cubicBezTo>
                        <a:cubicBezTo>
                          <a:pt x="7497" y="8181"/>
                          <a:pt x="7497" y="8181"/>
                          <a:pt x="7497" y="8181"/>
                        </a:cubicBezTo>
                        <a:cubicBezTo>
                          <a:pt x="7603" y="8122"/>
                          <a:pt x="7603" y="8122"/>
                          <a:pt x="7603" y="8122"/>
                        </a:cubicBezTo>
                        <a:cubicBezTo>
                          <a:pt x="7650" y="8133"/>
                          <a:pt x="7650" y="8133"/>
                          <a:pt x="7650" y="8133"/>
                        </a:cubicBezTo>
                        <a:cubicBezTo>
                          <a:pt x="7617" y="8206"/>
                          <a:pt x="7617" y="8206"/>
                          <a:pt x="7617" y="8206"/>
                        </a:cubicBezTo>
                        <a:cubicBezTo>
                          <a:pt x="7661" y="8224"/>
                          <a:pt x="7661" y="8224"/>
                          <a:pt x="7661" y="8224"/>
                        </a:cubicBezTo>
                        <a:cubicBezTo>
                          <a:pt x="7709" y="8224"/>
                          <a:pt x="7709" y="8224"/>
                          <a:pt x="7709" y="8224"/>
                        </a:cubicBezTo>
                        <a:cubicBezTo>
                          <a:pt x="7705" y="7662"/>
                          <a:pt x="7705" y="7662"/>
                          <a:pt x="7705" y="7662"/>
                        </a:cubicBezTo>
                        <a:cubicBezTo>
                          <a:pt x="7683" y="7665"/>
                          <a:pt x="7683" y="7665"/>
                          <a:pt x="7683" y="7665"/>
                        </a:cubicBezTo>
                        <a:cubicBezTo>
                          <a:pt x="7654" y="7684"/>
                          <a:pt x="7654" y="7684"/>
                          <a:pt x="7654" y="7684"/>
                        </a:cubicBezTo>
                        <a:cubicBezTo>
                          <a:pt x="7610" y="7676"/>
                          <a:pt x="7610" y="7676"/>
                          <a:pt x="7610" y="7676"/>
                        </a:cubicBezTo>
                        <a:cubicBezTo>
                          <a:pt x="7566" y="7698"/>
                          <a:pt x="7566" y="7698"/>
                          <a:pt x="7566" y="7698"/>
                        </a:cubicBezTo>
                        <a:cubicBezTo>
                          <a:pt x="7552" y="7742"/>
                          <a:pt x="7552" y="7742"/>
                          <a:pt x="7552" y="7742"/>
                        </a:cubicBezTo>
                        <a:cubicBezTo>
                          <a:pt x="7581" y="7768"/>
                          <a:pt x="7581" y="7768"/>
                          <a:pt x="7581" y="7768"/>
                        </a:cubicBezTo>
                        <a:cubicBezTo>
                          <a:pt x="7592" y="7779"/>
                          <a:pt x="7592" y="7779"/>
                          <a:pt x="7592" y="7779"/>
                        </a:cubicBezTo>
                        <a:cubicBezTo>
                          <a:pt x="7566" y="7804"/>
                          <a:pt x="7566" y="7804"/>
                          <a:pt x="7566" y="7804"/>
                        </a:cubicBezTo>
                        <a:cubicBezTo>
                          <a:pt x="7519" y="7775"/>
                          <a:pt x="7519" y="7775"/>
                          <a:pt x="7519" y="7775"/>
                        </a:cubicBezTo>
                        <a:cubicBezTo>
                          <a:pt x="7486" y="7775"/>
                          <a:pt x="7486" y="7775"/>
                          <a:pt x="7486" y="7775"/>
                        </a:cubicBezTo>
                        <a:cubicBezTo>
                          <a:pt x="7471" y="7750"/>
                          <a:pt x="7471" y="7750"/>
                          <a:pt x="7471" y="7750"/>
                        </a:cubicBezTo>
                        <a:cubicBezTo>
                          <a:pt x="7380" y="7764"/>
                          <a:pt x="7380" y="7764"/>
                          <a:pt x="7380" y="7764"/>
                        </a:cubicBezTo>
                        <a:cubicBezTo>
                          <a:pt x="7354" y="7728"/>
                          <a:pt x="7354" y="7728"/>
                          <a:pt x="7354" y="7728"/>
                        </a:cubicBezTo>
                        <a:cubicBezTo>
                          <a:pt x="7321" y="7676"/>
                          <a:pt x="7321" y="7676"/>
                          <a:pt x="7321" y="7676"/>
                        </a:cubicBezTo>
                        <a:cubicBezTo>
                          <a:pt x="7259" y="7614"/>
                          <a:pt x="7259" y="7614"/>
                          <a:pt x="7259" y="7614"/>
                        </a:cubicBezTo>
                        <a:cubicBezTo>
                          <a:pt x="7244" y="7581"/>
                          <a:pt x="7244" y="7581"/>
                          <a:pt x="7244" y="7581"/>
                        </a:cubicBezTo>
                        <a:cubicBezTo>
                          <a:pt x="7223" y="7589"/>
                          <a:pt x="7223" y="7589"/>
                          <a:pt x="7223" y="7589"/>
                        </a:cubicBezTo>
                        <a:cubicBezTo>
                          <a:pt x="7182" y="7556"/>
                          <a:pt x="7182" y="7556"/>
                          <a:pt x="7182" y="7556"/>
                        </a:cubicBezTo>
                        <a:cubicBezTo>
                          <a:pt x="7135" y="7538"/>
                          <a:pt x="7135" y="7538"/>
                          <a:pt x="7135" y="7538"/>
                        </a:cubicBezTo>
                        <a:cubicBezTo>
                          <a:pt x="7124" y="7512"/>
                          <a:pt x="7124" y="7512"/>
                          <a:pt x="7124" y="7512"/>
                        </a:cubicBezTo>
                        <a:cubicBezTo>
                          <a:pt x="7106" y="7512"/>
                          <a:pt x="7106" y="7512"/>
                          <a:pt x="7106" y="7512"/>
                        </a:cubicBezTo>
                        <a:cubicBezTo>
                          <a:pt x="7102" y="7439"/>
                          <a:pt x="7102" y="7439"/>
                          <a:pt x="7102" y="7439"/>
                        </a:cubicBezTo>
                        <a:cubicBezTo>
                          <a:pt x="7084" y="7413"/>
                          <a:pt x="7084" y="7413"/>
                          <a:pt x="7084" y="7413"/>
                        </a:cubicBezTo>
                        <a:cubicBezTo>
                          <a:pt x="7106" y="7322"/>
                          <a:pt x="7106" y="7322"/>
                          <a:pt x="7106" y="7322"/>
                        </a:cubicBezTo>
                        <a:cubicBezTo>
                          <a:pt x="7135" y="7231"/>
                          <a:pt x="7135" y="7231"/>
                          <a:pt x="7135" y="7231"/>
                        </a:cubicBezTo>
                        <a:cubicBezTo>
                          <a:pt x="7127" y="7201"/>
                          <a:pt x="7127" y="7201"/>
                          <a:pt x="7127" y="7201"/>
                        </a:cubicBezTo>
                        <a:cubicBezTo>
                          <a:pt x="7186" y="7037"/>
                          <a:pt x="7186" y="7037"/>
                          <a:pt x="7186" y="7037"/>
                        </a:cubicBezTo>
                        <a:cubicBezTo>
                          <a:pt x="7219" y="7012"/>
                          <a:pt x="7219" y="7012"/>
                          <a:pt x="7219" y="7012"/>
                        </a:cubicBezTo>
                        <a:cubicBezTo>
                          <a:pt x="7197" y="6935"/>
                          <a:pt x="7197" y="6935"/>
                          <a:pt x="7197" y="6935"/>
                        </a:cubicBezTo>
                        <a:cubicBezTo>
                          <a:pt x="7197" y="6854"/>
                          <a:pt x="7197" y="6854"/>
                          <a:pt x="7197" y="6854"/>
                        </a:cubicBezTo>
                        <a:cubicBezTo>
                          <a:pt x="7171" y="6822"/>
                          <a:pt x="7171" y="6822"/>
                          <a:pt x="7171" y="6822"/>
                        </a:cubicBezTo>
                        <a:cubicBezTo>
                          <a:pt x="7197" y="6756"/>
                          <a:pt x="7197" y="6756"/>
                          <a:pt x="7197" y="6756"/>
                        </a:cubicBezTo>
                        <a:cubicBezTo>
                          <a:pt x="7190" y="6701"/>
                          <a:pt x="7190" y="6701"/>
                          <a:pt x="7190" y="6701"/>
                        </a:cubicBezTo>
                        <a:cubicBezTo>
                          <a:pt x="7215" y="6635"/>
                          <a:pt x="7215" y="6635"/>
                          <a:pt x="7215" y="6635"/>
                        </a:cubicBezTo>
                        <a:cubicBezTo>
                          <a:pt x="7193" y="6602"/>
                          <a:pt x="7193" y="6602"/>
                          <a:pt x="7193" y="6602"/>
                        </a:cubicBezTo>
                        <a:cubicBezTo>
                          <a:pt x="7182" y="6529"/>
                          <a:pt x="7182" y="6529"/>
                          <a:pt x="7182" y="6529"/>
                        </a:cubicBezTo>
                        <a:cubicBezTo>
                          <a:pt x="7149" y="6474"/>
                          <a:pt x="7149" y="6474"/>
                          <a:pt x="7149" y="6474"/>
                        </a:cubicBezTo>
                        <a:cubicBezTo>
                          <a:pt x="7149" y="6460"/>
                          <a:pt x="7149" y="6460"/>
                          <a:pt x="7149" y="6460"/>
                        </a:cubicBezTo>
                        <a:cubicBezTo>
                          <a:pt x="7142" y="6460"/>
                          <a:pt x="7142" y="6460"/>
                          <a:pt x="7142" y="6460"/>
                        </a:cubicBezTo>
                        <a:cubicBezTo>
                          <a:pt x="7146" y="6438"/>
                          <a:pt x="7146" y="6438"/>
                          <a:pt x="7146" y="6438"/>
                        </a:cubicBezTo>
                        <a:cubicBezTo>
                          <a:pt x="7113" y="6456"/>
                          <a:pt x="7113" y="6456"/>
                          <a:pt x="7113" y="6456"/>
                        </a:cubicBezTo>
                        <a:cubicBezTo>
                          <a:pt x="7080" y="6449"/>
                          <a:pt x="7080" y="6449"/>
                          <a:pt x="7080" y="6449"/>
                        </a:cubicBezTo>
                        <a:cubicBezTo>
                          <a:pt x="7084" y="6442"/>
                          <a:pt x="7084" y="6442"/>
                          <a:pt x="7084" y="6442"/>
                        </a:cubicBezTo>
                        <a:cubicBezTo>
                          <a:pt x="7058" y="6434"/>
                          <a:pt x="7058" y="6434"/>
                          <a:pt x="7058" y="6434"/>
                        </a:cubicBezTo>
                        <a:cubicBezTo>
                          <a:pt x="7054" y="6358"/>
                          <a:pt x="7054" y="6358"/>
                          <a:pt x="7054" y="6358"/>
                        </a:cubicBezTo>
                        <a:cubicBezTo>
                          <a:pt x="7175" y="6186"/>
                          <a:pt x="7175" y="6186"/>
                          <a:pt x="7175" y="6186"/>
                        </a:cubicBezTo>
                        <a:cubicBezTo>
                          <a:pt x="7266" y="6084"/>
                          <a:pt x="7266" y="6084"/>
                          <a:pt x="7266" y="6084"/>
                        </a:cubicBezTo>
                        <a:cubicBezTo>
                          <a:pt x="7336" y="6102"/>
                          <a:pt x="7336" y="6102"/>
                          <a:pt x="7336" y="6102"/>
                        </a:cubicBezTo>
                        <a:cubicBezTo>
                          <a:pt x="7314" y="6054"/>
                          <a:pt x="7314" y="6054"/>
                          <a:pt x="7314" y="6054"/>
                        </a:cubicBezTo>
                        <a:cubicBezTo>
                          <a:pt x="7625" y="6014"/>
                          <a:pt x="7625" y="6014"/>
                          <a:pt x="7625" y="6014"/>
                        </a:cubicBezTo>
                        <a:cubicBezTo>
                          <a:pt x="7625" y="6010"/>
                          <a:pt x="7625" y="6010"/>
                          <a:pt x="7625" y="6010"/>
                        </a:cubicBezTo>
                        <a:cubicBezTo>
                          <a:pt x="8034" y="5956"/>
                          <a:pt x="8034" y="5956"/>
                          <a:pt x="8034" y="5956"/>
                        </a:cubicBezTo>
                        <a:cubicBezTo>
                          <a:pt x="8045" y="5912"/>
                          <a:pt x="8045" y="5912"/>
                          <a:pt x="8045" y="5912"/>
                        </a:cubicBezTo>
                        <a:cubicBezTo>
                          <a:pt x="7939" y="5795"/>
                          <a:pt x="7939" y="5795"/>
                          <a:pt x="7939" y="5795"/>
                        </a:cubicBezTo>
                        <a:cubicBezTo>
                          <a:pt x="7917" y="5799"/>
                          <a:pt x="7917" y="5799"/>
                          <a:pt x="7917" y="5799"/>
                        </a:cubicBezTo>
                        <a:cubicBezTo>
                          <a:pt x="7906" y="5736"/>
                          <a:pt x="7906" y="5736"/>
                          <a:pt x="7906" y="5736"/>
                        </a:cubicBezTo>
                        <a:cubicBezTo>
                          <a:pt x="7884" y="5704"/>
                          <a:pt x="7884" y="5704"/>
                          <a:pt x="7884" y="5704"/>
                        </a:cubicBezTo>
                        <a:cubicBezTo>
                          <a:pt x="7884" y="5649"/>
                          <a:pt x="7884" y="5649"/>
                          <a:pt x="7884" y="5649"/>
                        </a:cubicBezTo>
                        <a:cubicBezTo>
                          <a:pt x="7862" y="5568"/>
                          <a:pt x="7862" y="5568"/>
                          <a:pt x="7862" y="5568"/>
                        </a:cubicBezTo>
                        <a:cubicBezTo>
                          <a:pt x="7819" y="5488"/>
                          <a:pt x="7819" y="5488"/>
                          <a:pt x="7819" y="5488"/>
                        </a:cubicBezTo>
                        <a:cubicBezTo>
                          <a:pt x="7745" y="5444"/>
                          <a:pt x="7745" y="5444"/>
                          <a:pt x="7745" y="5444"/>
                        </a:cubicBezTo>
                        <a:cubicBezTo>
                          <a:pt x="7694" y="5433"/>
                          <a:pt x="7694" y="5433"/>
                          <a:pt x="7694" y="5433"/>
                        </a:cubicBezTo>
                        <a:cubicBezTo>
                          <a:pt x="7621" y="5335"/>
                          <a:pt x="7621" y="5335"/>
                          <a:pt x="7621" y="5335"/>
                        </a:cubicBezTo>
                        <a:cubicBezTo>
                          <a:pt x="7559" y="5236"/>
                          <a:pt x="7559" y="5236"/>
                          <a:pt x="7559" y="5236"/>
                        </a:cubicBezTo>
                        <a:cubicBezTo>
                          <a:pt x="7563" y="5199"/>
                          <a:pt x="7563" y="5199"/>
                          <a:pt x="7563" y="5199"/>
                        </a:cubicBezTo>
                        <a:cubicBezTo>
                          <a:pt x="7537" y="5188"/>
                          <a:pt x="7537" y="5188"/>
                          <a:pt x="7537" y="5188"/>
                        </a:cubicBezTo>
                        <a:cubicBezTo>
                          <a:pt x="7526" y="5145"/>
                          <a:pt x="7526" y="5145"/>
                          <a:pt x="7526" y="5145"/>
                        </a:cubicBezTo>
                        <a:cubicBezTo>
                          <a:pt x="7515" y="5115"/>
                          <a:pt x="7515" y="5115"/>
                          <a:pt x="7515" y="5115"/>
                        </a:cubicBezTo>
                        <a:cubicBezTo>
                          <a:pt x="7489" y="5053"/>
                          <a:pt x="7489" y="5053"/>
                          <a:pt x="7489" y="5053"/>
                        </a:cubicBezTo>
                        <a:cubicBezTo>
                          <a:pt x="7471" y="5028"/>
                          <a:pt x="7471" y="5028"/>
                          <a:pt x="7471" y="5028"/>
                        </a:cubicBezTo>
                        <a:cubicBezTo>
                          <a:pt x="7438" y="5002"/>
                          <a:pt x="7438" y="5002"/>
                          <a:pt x="7438" y="5002"/>
                        </a:cubicBezTo>
                        <a:cubicBezTo>
                          <a:pt x="7438" y="4951"/>
                          <a:pt x="7438" y="4951"/>
                          <a:pt x="7438" y="4951"/>
                        </a:cubicBezTo>
                        <a:cubicBezTo>
                          <a:pt x="7471" y="4918"/>
                          <a:pt x="7471" y="4918"/>
                          <a:pt x="7471" y="4918"/>
                        </a:cubicBezTo>
                        <a:cubicBezTo>
                          <a:pt x="7497" y="4889"/>
                          <a:pt x="7497" y="4889"/>
                          <a:pt x="7497" y="4889"/>
                        </a:cubicBezTo>
                        <a:cubicBezTo>
                          <a:pt x="7508" y="4808"/>
                          <a:pt x="7508" y="4808"/>
                          <a:pt x="7508" y="4808"/>
                        </a:cubicBezTo>
                        <a:cubicBezTo>
                          <a:pt x="7519" y="4816"/>
                          <a:pt x="7519" y="4816"/>
                          <a:pt x="7519" y="4816"/>
                        </a:cubicBezTo>
                        <a:cubicBezTo>
                          <a:pt x="7511" y="4779"/>
                          <a:pt x="7511" y="4779"/>
                          <a:pt x="7511" y="4779"/>
                        </a:cubicBezTo>
                        <a:cubicBezTo>
                          <a:pt x="7453" y="4699"/>
                          <a:pt x="7453" y="4699"/>
                          <a:pt x="7453" y="4699"/>
                        </a:cubicBezTo>
                        <a:cubicBezTo>
                          <a:pt x="7416" y="4618"/>
                          <a:pt x="7416" y="4618"/>
                          <a:pt x="7416" y="4618"/>
                        </a:cubicBezTo>
                        <a:cubicBezTo>
                          <a:pt x="7402" y="4571"/>
                          <a:pt x="7402" y="4571"/>
                          <a:pt x="7402" y="4571"/>
                        </a:cubicBezTo>
                        <a:cubicBezTo>
                          <a:pt x="7402" y="4534"/>
                          <a:pt x="7402" y="4534"/>
                          <a:pt x="7402" y="4534"/>
                        </a:cubicBezTo>
                        <a:cubicBezTo>
                          <a:pt x="7508" y="4538"/>
                          <a:pt x="7508" y="4538"/>
                          <a:pt x="7508" y="4538"/>
                        </a:cubicBezTo>
                        <a:cubicBezTo>
                          <a:pt x="7508" y="4381"/>
                          <a:pt x="7508" y="4381"/>
                          <a:pt x="7508" y="4381"/>
                        </a:cubicBezTo>
                        <a:cubicBezTo>
                          <a:pt x="7522" y="4249"/>
                          <a:pt x="7522" y="4249"/>
                          <a:pt x="7522" y="4249"/>
                        </a:cubicBezTo>
                        <a:cubicBezTo>
                          <a:pt x="7504" y="4118"/>
                          <a:pt x="7504" y="4118"/>
                          <a:pt x="7504" y="4118"/>
                        </a:cubicBezTo>
                        <a:cubicBezTo>
                          <a:pt x="7464" y="4063"/>
                          <a:pt x="7464" y="4063"/>
                          <a:pt x="7464" y="4063"/>
                        </a:cubicBezTo>
                        <a:cubicBezTo>
                          <a:pt x="7460" y="3975"/>
                          <a:pt x="7460" y="3975"/>
                          <a:pt x="7460" y="3975"/>
                        </a:cubicBezTo>
                        <a:cubicBezTo>
                          <a:pt x="7449" y="3756"/>
                          <a:pt x="7449" y="3756"/>
                          <a:pt x="7449" y="3756"/>
                        </a:cubicBezTo>
                        <a:cubicBezTo>
                          <a:pt x="7464" y="3661"/>
                          <a:pt x="7464" y="3661"/>
                          <a:pt x="7464" y="3661"/>
                        </a:cubicBezTo>
                        <a:cubicBezTo>
                          <a:pt x="7431" y="3665"/>
                          <a:pt x="7431" y="3665"/>
                          <a:pt x="7431" y="3665"/>
                        </a:cubicBezTo>
                        <a:cubicBezTo>
                          <a:pt x="7365" y="3585"/>
                          <a:pt x="7365" y="3585"/>
                          <a:pt x="7365" y="3585"/>
                        </a:cubicBezTo>
                        <a:cubicBezTo>
                          <a:pt x="7369" y="3537"/>
                          <a:pt x="7369" y="3537"/>
                          <a:pt x="7369" y="3537"/>
                        </a:cubicBezTo>
                        <a:cubicBezTo>
                          <a:pt x="7321" y="3511"/>
                          <a:pt x="7321" y="3511"/>
                          <a:pt x="7321" y="3511"/>
                        </a:cubicBezTo>
                        <a:cubicBezTo>
                          <a:pt x="7303" y="3449"/>
                          <a:pt x="7303" y="3449"/>
                          <a:pt x="7303" y="3449"/>
                        </a:cubicBezTo>
                        <a:cubicBezTo>
                          <a:pt x="7303" y="3391"/>
                          <a:pt x="7303" y="3391"/>
                          <a:pt x="7303" y="3391"/>
                        </a:cubicBezTo>
                        <a:cubicBezTo>
                          <a:pt x="7340" y="3351"/>
                          <a:pt x="7340" y="3351"/>
                          <a:pt x="7340" y="3351"/>
                        </a:cubicBezTo>
                        <a:cubicBezTo>
                          <a:pt x="7391" y="3347"/>
                          <a:pt x="7391" y="3347"/>
                          <a:pt x="7391" y="3347"/>
                        </a:cubicBezTo>
                        <a:cubicBezTo>
                          <a:pt x="7438" y="3281"/>
                          <a:pt x="7438" y="3281"/>
                          <a:pt x="7438" y="3281"/>
                        </a:cubicBezTo>
                        <a:cubicBezTo>
                          <a:pt x="7409" y="3190"/>
                          <a:pt x="7409" y="3190"/>
                          <a:pt x="7409" y="3190"/>
                        </a:cubicBezTo>
                        <a:cubicBezTo>
                          <a:pt x="7438" y="3099"/>
                          <a:pt x="7438" y="3099"/>
                          <a:pt x="7438" y="3099"/>
                        </a:cubicBezTo>
                        <a:cubicBezTo>
                          <a:pt x="7431" y="3095"/>
                          <a:pt x="7431" y="3095"/>
                          <a:pt x="7431" y="3095"/>
                        </a:cubicBezTo>
                        <a:cubicBezTo>
                          <a:pt x="7504" y="3011"/>
                          <a:pt x="7504" y="3011"/>
                          <a:pt x="7504" y="3011"/>
                        </a:cubicBezTo>
                        <a:cubicBezTo>
                          <a:pt x="7563" y="2985"/>
                          <a:pt x="7563" y="2985"/>
                          <a:pt x="7563" y="2985"/>
                        </a:cubicBezTo>
                        <a:cubicBezTo>
                          <a:pt x="7621" y="2949"/>
                          <a:pt x="7621" y="2949"/>
                          <a:pt x="7621" y="2949"/>
                        </a:cubicBezTo>
                        <a:cubicBezTo>
                          <a:pt x="7614" y="2865"/>
                          <a:pt x="7614" y="2865"/>
                          <a:pt x="7614" y="2865"/>
                        </a:cubicBezTo>
                        <a:cubicBezTo>
                          <a:pt x="7606" y="2784"/>
                          <a:pt x="7606" y="2784"/>
                          <a:pt x="7606" y="2784"/>
                        </a:cubicBezTo>
                        <a:cubicBezTo>
                          <a:pt x="7625" y="2730"/>
                          <a:pt x="7625" y="2730"/>
                          <a:pt x="7625" y="2730"/>
                        </a:cubicBezTo>
                        <a:cubicBezTo>
                          <a:pt x="7632" y="2660"/>
                          <a:pt x="7632" y="2660"/>
                          <a:pt x="7632" y="2660"/>
                        </a:cubicBezTo>
                        <a:cubicBezTo>
                          <a:pt x="7647" y="2598"/>
                          <a:pt x="7647" y="2598"/>
                          <a:pt x="7647" y="2598"/>
                        </a:cubicBezTo>
                        <a:cubicBezTo>
                          <a:pt x="7643" y="2547"/>
                          <a:pt x="7643" y="2547"/>
                          <a:pt x="7643" y="2547"/>
                        </a:cubicBezTo>
                        <a:cubicBezTo>
                          <a:pt x="7669" y="2430"/>
                          <a:pt x="7669" y="2430"/>
                          <a:pt x="7669" y="2430"/>
                        </a:cubicBezTo>
                        <a:cubicBezTo>
                          <a:pt x="7669" y="2342"/>
                          <a:pt x="7669" y="2342"/>
                          <a:pt x="7669" y="2342"/>
                        </a:cubicBezTo>
                        <a:cubicBezTo>
                          <a:pt x="7669" y="2299"/>
                          <a:pt x="7669" y="2299"/>
                          <a:pt x="7669" y="2299"/>
                        </a:cubicBezTo>
                        <a:cubicBezTo>
                          <a:pt x="7709" y="2266"/>
                          <a:pt x="7709" y="2266"/>
                          <a:pt x="7709" y="2266"/>
                        </a:cubicBezTo>
                        <a:cubicBezTo>
                          <a:pt x="7731" y="2193"/>
                          <a:pt x="7731" y="2193"/>
                          <a:pt x="7731" y="2193"/>
                        </a:cubicBezTo>
                        <a:cubicBezTo>
                          <a:pt x="7782" y="2127"/>
                          <a:pt x="7782" y="2127"/>
                          <a:pt x="7782" y="2127"/>
                        </a:cubicBezTo>
                        <a:cubicBezTo>
                          <a:pt x="7782" y="2079"/>
                          <a:pt x="7782" y="2079"/>
                          <a:pt x="7782" y="2079"/>
                        </a:cubicBezTo>
                        <a:cubicBezTo>
                          <a:pt x="7775" y="1992"/>
                          <a:pt x="7775" y="1992"/>
                          <a:pt x="7775" y="1992"/>
                        </a:cubicBezTo>
                        <a:cubicBezTo>
                          <a:pt x="7855" y="1955"/>
                          <a:pt x="7855" y="1955"/>
                          <a:pt x="7855" y="1955"/>
                        </a:cubicBezTo>
                        <a:cubicBezTo>
                          <a:pt x="7895" y="1875"/>
                          <a:pt x="7895" y="1875"/>
                          <a:pt x="7895" y="1875"/>
                        </a:cubicBezTo>
                        <a:cubicBezTo>
                          <a:pt x="7932" y="1835"/>
                          <a:pt x="7932" y="1835"/>
                          <a:pt x="7932" y="1835"/>
                        </a:cubicBezTo>
                        <a:cubicBezTo>
                          <a:pt x="7998" y="1820"/>
                          <a:pt x="7998" y="1820"/>
                          <a:pt x="7998" y="1820"/>
                        </a:cubicBezTo>
                        <a:cubicBezTo>
                          <a:pt x="8001" y="1820"/>
                          <a:pt x="8001" y="1820"/>
                          <a:pt x="8001" y="1820"/>
                        </a:cubicBezTo>
                        <a:cubicBezTo>
                          <a:pt x="7979" y="1798"/>
                          <a:pt x="7979" y="1798"/>
                          <a:pt x="7979" y="1798"/>
                        </a:cubicBezTo>
                        <a:cubicBezTo>
                          <a:pt x="7965" y="1794"/>
                          <a:pt x="7965" y="1794"/>
                          <a:pt x="7965" y="1794"/>
                        </a:cubicBezTo>
                        <a:cubicBezTo>
                          <a:pt x="7969" y="1769"/>
                          <a:pt x="7969" y="1769"/>
                          <a:pt x="7969" y="1769"/>
                        </a:cubicBezTo>
                        <a:cubicBezTo>
                          <a:pt x="8001" y="1729"/>
                          <a:pt x="8001" y="1729"/>
                          <a:pt x="8001" y="1729"/>
                        </a:cubicBezTo>
                        <a:cubicBezTo>
                          <a:pt x="8012" y="1688"/>
                          <a:pt x="8012" y="1688"/>
                          <a:pt x="8012" y="1688"/>
                        </a:cubicBezTo>
                        <a:cubicBezTo>
                          <a:pt x="8053" y="1652"/>
                          <a:pt x="8053" y="1652"/>
                          <a:pt x="8053" y="1652"/>
                        </a:cubicBezTo>
                        <a:cubicBezTo>
                          <a:pt x="8151" y="1561"/>
                          <a:pt x="8151" y="1561"/>
                          <a:pt x="8151" y="1561"/>
                        </a:cubicBezTo>
                        <a:cubicBezTo>
                          <a:pt x="8210" y="1498"/>
                          <a:pt x="8210" y="1498"/>
                          <a:pt x="8210" y="1498"/>
                        </a:cubicBezTo>
                        <a:cubicBezTo>
                          <a:pt x="8228" y="1498"/>
                          <a:pt x="8228" y="1498"/>
                          <a:pt x="8228" y="1498"/>
                        </a:cubicBezTo>
                        <a:cubicBezTo>
                          <a:pt x="8279" y="1462"/>
                          <a:pt x="8279" y="1462"/>
                          <a:pt x="8279" y="1462"/>
                        </a:cubicBezTo>
                        <a:cubicBezTo>
                          <a:pt x="8331" y="1418"/>
                          <a:pt x="8331" y="1418"/>
                          <a:pt x="8331" y="1418"/>
                        </a:cubicBezTo>
                        <a:cubicBezTo>
                          <a:pt x="8352" y="1392"/>
                          <a:pt x="8352" y="1392"/>
                          <a:pt x="8352" y="1392"/>
                        </a:cubicBezTo>
                        <a:cubicBezTo>
                          <a:pt x="8352" y="1392"/>
                          <a:pt x="8352" y="1392"/>
                          <a:pt x="8352" y="1392"/>
                        </a:cubicBezTo>
                        <a:lnTo>
                          <a:pt x="8323" y="1345"/>
                        </a:lnTo>
                        <a:close/>
                      </a:path>
                    </a:pathLst>
                  </a:custGeom>
                  <a:solidFill>
                    <a:schemeClr val="bg1">
                      <a:lumMod val="75000"/>
                    </a:schemeClr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grpSp>
              <p:nvGrpSpPr>
                <p:cNvPr id="47" name="Group 46"/>
                <p:cNvGrpSpPr>
                  <a:grpSpLocks noChangeAspect="1"/>
                </p:cNvGrpSpPr>
                <p:nvPr/>
              </p:nvGrpSpPr>
              <p:grpSpPr>
                <a:xfrm>
                  <a:off x="2009723" y="3235275"/>
                  <a:ext cx="3239113" cy="3193841"/>
                  <a:chOff x="610387" y="3240904"/>
                  <a:chExt cx="4742385" cy="4676102"/>
                </a:xfrm>
              </p:grpSpPr>
              <p:sp>
                <p:nvSpPr>
                  <p:cNvPr id="48" name="Freeform 6"/>
                  <p:cNvSpPr>
                    <a:spLocks/>
                  </p:cNvSpPr>
                  <p:nvPr/>
                </p:nvSpPr>
                <p:spPr bwMode="auto">
                  <a:xfrm>
                    <a:off x="3440037" y="6092648"/>
                    <a:ext cx="1082621" cy="1002134"/>
                  </a:xfrm>
                  <a:custGeom>
                    <a:avLst/>
                    <a:gdLst/>
                    <a:ahLst/>
                    <a:cxnLst>
                      <a:cxn ang="0">
                        <a:pos x="349" y="9"/>
                      </a:cxn>
                      <a:cxn ang="0">
                        <a:pos x="310" y="28"/>
                      </a:cxn>
                      <a:cxn ang="0">
                        <a:pos x="294" y="23"/>
                      </a:cxn>
                      <a:cxn ang="0">
                        <a:pos x="277" y="46"/>
                      </a:cxn>
                      <a:cxn ang="0">
                        <a:pos x="293" y="61"/>
                      </a:cxn>
                      <a:cxn ang="0">
                        <a:pos x="296" y="98"/>
                      </a:cxn>
                      <a:cxn ang="0">
                        <a:pos x="245" y="87"/>
                      </a:cxn>
                      <a:cxn ang="0">
                        <a:pos x="214" y="94"/>
                      </a:cxn>
                      <a:cxn ang="0">
                        <a:pos x="204" y="113"/>
                      </a:cxn>
                      <a:cxn ang="0">
                        <a:pos x="164" y="129"/>
                      </a:cxn>
                      <a:cxn ang="0">
                        <a:pos x="144" y="154"/>
                      </a:cxn>
                      <a:cxn ang="0">
                        <a:pos x="116" y="150"/>
                      </a:cxn>
                      <a:cxn ang="0">
                        <a:pos x="98" y="142"/>
                      </a:cxn>
                      <a:cxn ang="0">
                        <a:pos x="87" y="123"/>
                      </a:cxn>
                      <a:cxn ang="0">
                        <a:pos x="58" y="199"/>
                      </a:cxn>
                      <a:cxn ang="0">
                        <a:pos x="52" y="271"/>
                      </a:cxn>
                      <a:cxn ang="0">
                        <a:pos x="2" y="292"/>
                      </a:cxn>
                      <a:cxn ang="0">
                        <a:pos x="15" y="327"/>
                      </a:cxn>
                      <a:cxn ang="0">
                        <a:pos x="10" y="417"/>
                      </a:cxn>
                      <a:cxn ang="0">
                        <a:pos x="107" y="454"/>
                      </a:cxn>
                      <a:cxn ang="0">
                        <a:pos x="106" y="503"/>
                      </a:cxn>
                      <a:cxn ang="0">
                        <a:pos x="90" y="561"/>
                      </a:cxn>
                      <a:cxn ang="0">
                        <a:pos x="86" y="620"/>
                      </a:cxn>
                      <a:cxn ang="0">
                        <a:pos x="108" y="612"/>
                      </a:cxn>
                      <a:cxn ang="0">
                        <a:pos x="162" y="617"/>
                      </a:cxn>
                      <a:cxn ang="0">
                        <a:pos x="199" y="628"/>
                      </a:cxn>
                      <a:cxn ang="0">
                        <a:pos x="239" y="623"/>
                      </a:cxn>
                      <a:cxn ang="0">
                        <a:pos x="289" y="603"/>
                      </a:cxn>
                      <a:cxn ang="0">
                        <a:pos x="307" y="562"/>
                      </a:cxn>
                      <a:cxn ang="0">
                        <a:pos x="314" y="528"/>
                      </a:cxn>
                      <a:cxn ang="0">
                        <a:pos x="395" y="567"/>
                      </a:cxn>
                      <a:cxn ang="0">
                        <a:pos x="440" y="565"/>
                      </a:cxn>
                      <a:cxn ang="0">
                        <a:pos x="478" y="477"/>
                      </a:cxn>
                      <a:cxn ang="0">
                        <a:pos x="498" y="423"/>
                      </a:cxn>
                      <a:cxn ang="0">
                        <a:pos x="521" y="417"/>
                      </a:cxn>
                      <a:cxn ang="0">
                        <a:pos x="566" y="353"/>
                      </a:cxn>
                      <a:cxn ang="0">
                        <a:pos x="658" y="328"/>
                      </a:cxn>
                      <a:cxn ang="0">
                        <a:pos x="686" y="304"/>
                      </a:cxn>
                      <a:cxn ang="0">
                        <a:pos x="639" y="275"/>
                      </a:cxn>
                      <a:cxn ang="0">
                        <a:pos x="628" y="220"/>
                      </a:cxn>
                      <a:cxn ang="0">
                        <a:pos x="544" y="240"/>
                      </a:cxn>
                      <a:cxn ang="0">
                        <a:pos x="453" y="219"/>
                      </a:cxn>
                      <a:cxn ang="0">
                        <a:pos x="448" y="175"/>
                      </a:cxn>
                      <a:cxn ang="0">
                        <a:pos x="387" y="137"/>
                      </a:cxn>
                      <a:cxn ang="0">
                        <a:pos x="374" y="92"/>
                      </a:cxn>
                      <a:cxn ang="0">
                        <a:pos x="389" y="32"/>
                      </a:cxn>
                      <a:cxn ang="0">
                        <a:pos x="382" y="24"/>
                      </a:cxn>
                      <a:cxn ang="0">
                        <a:pos x="357" y="0"/>
                      </a:cxn>
                    </a:cxnLst>
                    <a:rect l="0" t="0" r="r" b="b"/>
                    <a:pathLst>
                      <a:path w="686" h="635">
                        <a:moveTo>
                          <a:pt x="357" y="0"/>
                        </a:moveTo>
                        <a:lnTo>
                          <a:pt x="349" y="9"/>
                        </a:lnTo>
                        <a:lnTo>
                          <a:pt x="315" y="21"/>
                        </a:lnTo>
                        <a:lnTo>
                          <a:pt x="310" y="28"/>
                        </a:lnTo>
                        <a:lnTo>
                          <a:pt x="302" y="29"/>
                        </a:lnTo>
                        <a:lnTo>
                          <a:pt x="294" y="23"/>
                        </a:lnTo>
                        <a:lnTo>
                          <a:pt x="268" y="29"/>
                        </a:lnTo>
                        <a:lnTo>
                          <a:pt x="277" y="46"/>
                        </a:lnTo>
                        <a:lnTo>
                          <a:pt x="274" y="50"/>
                        </a:lnTo>
                        <a:lnTo>
                          <a:pt x="293" y="61"/>
                        </a:lnTo>
                        <a:lnTo>
                          <a:pt x="299" y="77"/>
                        </a:lnTo>
                        <a:lnTo>
                          <a:pt x="296" y="98"/>
                        </a:lnTo>
                        <a:lnTo>
                          <a:pt x="260" y="107"/>
                        </a:lnTo>
                        <a:lnTo>
                          <a:pt x="245" y="87"/>
                        </a:lnTo>
                        <a:lnTo>
                          <a:pt x="211" y="83"/>
                        </a:lnTo>
                        <a:lnTo>
                          <a:pt x="214" y="94"/>
                        </a:lnTo>
                        <a:lnTo>
                          <a:pt x="200" y="99"/>
                        </a:lnTo>
                        <a:lnTo>
                          <a:pt x="204" y="113"/>
                        </a:lnTo>
                        <a:lnTo>
                          <a:pt x="193" y="127"/>
                        </a:lnTo>
                        <a:lnTo>
                          <a:pt x="164" y="129"/>
                        </a:lnTo>
                        <a:lnTo>
                          <a:pt x="148" y="146"/>
                        </a:lnTo>
                        <a:lnTo>
                          <a:pt x="144" y="154"/>
                        </a:lnTo>
                        <a:lnTo>
                          <a:pt x="132" y="157"/>
                        </a:lnTo>
                        <a:lnTo>
                          <a:pt x="116" y="150"/>
                        </a:lnTo>
                        <a:lnTo>
                          <a:pt x="114" y="142"/>
                        </a:lnTo>
                        <a:lnTo>
                          <a:pt x="98" y="142"/>
                        </a:lnTo>
                        <a:lnTo>
                          <a:pt x="95" y="127"/>
                        </a:lnTo>
                        <a:lnTo>
                          <a:pt x="87" y="123"/>
                        </a:lnTo>
                        <a:lnTo>
                          <a:pt x="67" y="157"/>
                        </a:lnTo>
                        <a:lnTo>
                          <a:pt x="58" y="199"/>
                        </a:lnTo>
                        <a:lnTo>
                          <a:pt x="48" y="232"/>
                        </a:lnTo>
                        <a:lnTo>
                          <a:pt x="52" y="271"/>
                        </a:lnTo>
                        <a:lnTo>
                          <a:pt x="53" y="283"/>
                        </a:lnTo>
                        <a:lnTo>
                          <a:pt x="2" y="292"/>
                        </a:lnTo>
                        <a:lnTo>
                          <a:pt x="0" y="292"/>
                        </a:lnTo>
                        <a:lnTo>
                          <a:pt x="15" y="327"/>
                        </a:lnTo>
                        <a:lnTo>
                          <a:pt x="6" y="362"/>
                        </a:lnTo>
                        <a:lnTo>
                          <a:pt x="10" y="417"/>
                        </a:lnTo>
                        <a:lnTo>
                          <a:pt x="53" y="431"/>
                        </a:lnTo>
                        <a:lnTo>
                          <a:pt x="107" y="454"/>
                        </a:lnTo>
                        <a:lnTo>
                          <a:pt x="117" y="496"/>
                        </a:lnTo>
                        <a:lnTo>
                          <a:pt x="106" y="503"/>
                        </a:lnTo>
                        <a:lnTo>
                          <a:pt x="95" y="520"/>
                        </a:lnTo>
                        <a:lnTo>
                          <a:pt x="90" y="561"/>
                        </a:lnTo>
                        <a:lnTo>
                          <a:pt x="83" y="582"/>
                        </a:lnTo>
                        <a:lnTo>
                          <a:pt x="86" y="620"/>
                        </a:lnTo>
                        <a:lnTo>
                          <a:pt x="90" y="621"/>
                        </a:lnTo>
                        <a:lnTo>
                          <a:pt x="108" y="612"/>
                        </a:lnTo>
                        <a:lnTo>
                          <a:pt x="141" y="621"/>
                        </a:lnTo>
                        <a:lnTo>
                          <a:pt x="162" y="617"/>
                        </a:lnTo>
                        <a:lnTo>
                          <a:pt x="189" y="628"/>
                        </a:lnTo>
                        <a:lnTo>
                          <a:pt x="199" y="628"/>
                        </a:lnTo>
                        <a:lnTo>
                          <a:pt x="224" y="635"/>
                        </a:lnTo>
                        <a:lnTo>
                          <a:pt x="239" y="623"/>
                        </a:lnTo>
                        <a:lnTo>
                          <a:pt x="257" y="619"/>
                        </a:lnTo>
                        <a:lnTo>
                          <a:pt x="289" y="603"/>
                        </a:lnTo>
                        <a:lnTo>
                          <a:pt x="310" y="588"/>
                        </a:lnTo>
                        <a:lnTo>
                          <a:pt x="307" y="562"/>
                        </a:lnTo>
                        <a:lnTo>
                          <a:pt x="303" y="535"/>
                        </a:lnTo>
                        <a:lnTo>
                          <a:pt x="314" y="528"/>
                        </a:lnTo>
                        <a:lnTo>
                          <a:pt x="341" y="545"/>
                        </a:lnTo>
                        <a:lnTo>
                          <a:pt x="395" y="567"/>
                        </a:lnTo>
                        <a:lnTo>
                          <a:pt x="421" y="574"/>
                        </a:lnTo>
                        <a:lnTo>
                          <a:pt x="440" y="565"/>
                        </a:lnTo>
                        <a:lnTo>
                          <a:pt x="470" y="511"/>
                        </a:lnTo>
                        <a:lnTo>
                          <a:pt x="478" y="477"/>
                        </a:lnTo>
                        <a:lnTo>
                          <a:pt x="493" y="465"/>
                        </a:lnTo>
                        <a:lnTo>
                          <a:pt x="498" y="423"/>
                        </a:lnTo>
                        <a:lnTo>
                          <a:pt x="506" y="415"/>
                        </a:lnTo>
                        <a:lnTo>
                          <a:pt x="521" y="417"/>
                        </a:lnTo>
                        <a:lnTo>
                          <a:pt x="539" y="408"/>
                        </a:lnTo>
                        <a:lnTo>
                          <a:pt x="566" y="353"/>
                        </a:lnTo>
                        <a:lnTo>
                          <a:pt x="629" y="321"/>
                        </a:lnTo>
                        <a:lnTo>
                          <a:pt x="658" y="328"/>
                        </a:lnTo>
                        <a:lnTo>
                          <a:pt x="671" y="332"/>
                        </a:lnTo>
                        <a:lnTo>
                          <a:pt x="686" y="304"/>
                        </a:lnTo>
                        <a:lnTo>
                          <a:pt x="673" y="287"/>
                        </a:lnTo>
                        <a:lnTo>
                          <a:pt x="639" y="275"/>
                        </a:lnTo>
                        <a:lnTo>
                          <a:pt x="637" y="231"/>
                        </a:lnTo>
                        <a:lnTo>
                          <a:pt x="628" y="220"/>
                        </a:lnTo>
                        <a:lnTo>
                          <a:pt x="574" y="224"/>
                        </a:lnTo>
                        <a:lnTo>
                          <a:pt x="544" y="240"/>
                        </a:lnTo>
                        <a:lnTo>
                          <a:pt x="477" y="225"/>
                        </a:lnTo>
                        <a:lnTo>
                          <a:pt x="453" y="219"/>
                        </a:lnTo>
                        <a:lnTo>
                          <a:pt x="433" y="198"/>
                        </a:lnTo>
                        <a:lnTo>
                          <a:pt x="448" y="175"/>
                        </a:lnTo>
                        <a:lnTo>
                          <a:pt x="439" y="159"/>
                        </a:lnTo>
                        <a:lnTo>
                          <a:pt x="387" y="137"/>
                        </a:lnTo>
                        <a:lnTo>
                          <a:pt x="382" y="108"/>
                        </a:lnTo>
                        <a:lnTo>
                          <a:pt x="374" y="92"/>
                        </a:lnTo>
                        <a:lnTo>
                          <a:pt x="365" y="71"/>
                        </a:lnTo>
                        <a:lnTo>
                          <a:pt x="389" y="32"/>
                        </a:lnTo>
                        <a:lnTo>
                          <a:pt x="386" y="24"/>
                        </a:lnTo>
                        <a:lnTo>
                          <a:pt x="382" y="24"/>
                        </a:lnTo>
                        <a:lnTo>
                          <a:pt x="371" y="9"/>
                        </a:lnTo>
                        <a:lnTo>
                          <a:pt x="357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49" name="Freeform 7"/>
                  <p:cNvSpPr>
                    <a:spLocks/>
                  </p:cNvSpPr>
                  <p:nvPr/>
                </p:nvSpPr>
                <p:spPr bwMode="auto">
                  <a:xfrm>
                    <a:off x="3269595" y="5977441"/>
                    <a:ext cx="310899" cy="260397"/>
                  </a:xfrm>
                  <a:custGeom>
                    <a:avLst/>
                    <a:gdLst/>
                    <a:ahLst/>
                    <a:cxnLst>
                      <a:cxn ang="0">
                        <a:pos x="106" y="0"/>
                      </a:cxn>
                      <a:cxn ang="0">
                        <a:pos x="102" y="6"/>
                      </a:cxn>
                      <a:cxn ang="0">
                        <a:pos x="79" y="17"/>
                      </a:cxn>
                      <a:cxn ang="0">
                        <a:pos x="66" y="10"/>
                      </a:cxn>
                      <a:cxn ang="0">
                        <a:pos x="45" y="19"/>
                      </a:cxn>
                      <a:cxn ang="0">
                        <a:pos x="16" y="21"/>
                      </a:cxn>
                      <a:cxn ang="0">
                        <a:pos x="0" y="64"/>
                      </a:cxn>
                      <a:cxn ang="0">
                        <a:pos x="31" y="88"/>
                      </a:cxn>
                      <a:cxn ang="0">
                        <a:pos x="19" y="100"/>
                      </a:cxn>
                      <a:cxn ang="0">
                        <a:pos x="31" y="109"/>
                      </a:cxn>
                      <a:cxn ang="0">
                        <a:pos x="29" y="130"/>
                      </a:cxn>
                      <a:cxn ang="0">
                        <a:pos x="58" y="139"/>
                      </a:cxn>
                      <a:cxn ang="0">
                        <a:pos x="65" y="147"/>
                      </a:cxn>
                      <a:cxn ang="0">
                        <a:pos x="74" y="147"/>
                      </a:cxn>
                      <a:cxn ang="0">
                        <a:pos x="91" y="163"/>
                      </a:cxn>
                      <a:cxn ang="0">
                        <a:pos x="123" y="165"/>
                      </a:cxn>
                      <a:cxn ang="0">
                        <a:pos x="132" y="126"/>
                      </a:cxn>
                      <a:cxn ang="0">
                        <a:pos x="140" y="107"/>
                      </a:cxn>
                      <a:cxn ang="0">
                        <a:pos x="164" y="110"/>
                      </a:cxn>
                      <a:cxn ang="0">
                        <a:pos x="197" y="73"/>
                      </a:cxn>
                      <a:cxn ang="0">
                        <a:pos x="191" y="51"/>
                      </a:cxn>
                      <a:cxn ang="0">
                        <a:pos x="185" y="27"/>
                      </a:cxn>
                      <a:cxn ang="0">
                        <a:pos x="181" y="21"/>
                      </a:cxn>
                      <a:cxn ang="0">
                        <a:pos x="149" y="17"/>
                      </a:cxn>
                      <a:cxn ang="0">
                        <a:pos x="128" y="21"/>
                      </a:cxn>
                      <a:cxn ang="0">
                        <a:pos x="106" y="0"/>
                      </a:cxn>
                    </a:cxnLst>
                    <a:rect l="0" t="0" r="r" b="b"/>
                    <a:pathLst>
                      <a:path w="197" h="165">
                        <a:moveTo>
                          <a:pt x="106" y="0"/>
                        </a:moveTo>
                        <a:lnTo>
                          <a:pt x="102" y="6"/>
                        </a:lnTo>
                        <a:lnTo>
                          <a:pt x="79" y="17"/>
                        </a:lnTo>
                        <a:lnTo>
                          <a:pt x="66" y="10"/>
                        </a:lnTo>
                        <a:lnTo>
                          <a:pt x="45" y="19"/>
                        </a:lnTo>
                        <a:lnTo>
                          <a:pt x="16" y="21"/>
                        </a:lnTo>
                        <a:lnTo>
                          <a:pt x="0" y="64"/>
                        </a:lnTo>
                        <a:lnTo>
                          <a:pt x="31" y="88"/>
                        </a:lnTo>
                        <a:lnTo>
                          <a:pt x="19" y="100"/>
                        </a:lnTo>
                        <a:lnTo>
                          <a:pt x="31" y="109"/>
                        </a:lnTo>
                        <a:lnTo>
                          <a:pt x="29" y="130"/>
                        </a:lnTo>
                        <a:lnTo>
                          <a:pt x="58" y="139"/>
                        </a:lnTo>
                        <a:lnTo>
                          <a:pt x="65" y="147"/>
                        </a:lnTo>
                        <a:lnTo>
                          <a:pt x="74" y="147"/>
                        </a:lnTo>
                        <a:lnTo>
                          <a:pt x="91" y="163"/>
                        </a:lnTo>
                        <a:lnTo>
                          <a:pt x="123" y="165"/>
                        </a:lnTo>
                        <a:lnTo>
                          <a:pt x="132" y="126"/>
                        </a:lnTo>
                        <a:lnTo>
                          <a:pt x="140" y="107"/>
                        </a:lnTo>
                        <a:lnTo>
                          <a:pt x="164" y="110"/>
                        </a:lnTo>
                        <a:lnTo>
                          <a:pt x="197" y="73"/>
                        </a:lnTo>
                        <a:lnTo>
                          <a:pt x="191" y="51"/>
                        </a:lnTo>
                        <a:lnTo>
                          <a:pt x="185" y="27"/>
                        </a:lnTo>
                        <a:lnTo>
                          <a:pt x="181" y="21"/>
                        </a:lnTo>
                        <a:lnTo>
                          <a:pt x="149" y="17"/>
                        </a:lnTo>
                        <a:lnTo>
                          <a:pt x="128" y="21"/>
                        </a:lnTo>
                        <a:lnTo>
                          <a:pt x="106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0" name="Freeform 8"/>
                  <p:cNvSpPr>
                    <a:spLocks/>
                  </p:cNvSpPr>
                  <p:nvPr/>
                </p:nvSpPr>
                <p:spPr bwMode="auto">
                  <a:xfrm>
                    <a:off x="3294845" y="5769124"/>
                    <a:ext cx="806443" cy="784347"/>
                  </a:xfrm>
                  <a:custGeom>
                    <a:avLst/>
                    <a:gdLst/>
                    <a:ahLst/>
                    <a:cxnLst>
                      <a:cxn ang="0">
                        <a:pos x="234" y="2"/>
                      </a:cxn>
                      <a:cxn ang="0">
                        <a:pos x="190" y="50"/>
                      </a:cxn>
                      <a:cxn ang="0">
                        <a:pos x="185" y="72"/>
                      </a:cxn>
                      <a:cxn ang="0">
                        <a:pos x="152" y="67"/>
                      </a:cxn>
                      <a:cxn ang="0">
                        <a:pos x="118" y="79"/>
                      </a:cxn>
                      <a:cxn ang="0">
                        <a:pos x="129" y="117"/>
                      </a:cxn>
                      <a:cxn ang="0">
                        <a:pos x="128" y="121"/>
                      </a:cxn>
                      <a:cxn ang="0">
                        <a:pos x="137" y="156"/>
                      </a:cxn>
                      <a:cxn ang="0">
                        <a:pos x="94" y="182"/>
                      </a:cxn>
                      <a:cxn ang="0">
                        <a:pos x="81" y="226"/>
                      </a:cxn>
                      <a:cxn ang="0">
                        <a:pos x="44" y="212"/>
                      </a:cxn>
                      <a:cxn ang="0">
                        <a:pos x="32" y="206"/>
                      </a:cxn>
                      <a:cxn ang="0">
                        <a:pos x="10" y="200"/>
                      </a:cxn>
                      <a:cxn ang="0">
                        <a:pos x="7" y="239"/>
                      </a:cxn>
                      <a:cxn ang="0">
                        <a:pos x="16" y="263"/>
                      </a:cxn>
                      <a:cxn ang="0">
                        <a:pos x="17" y="313"/>
                      </a:cxn>
                      <a:cxn ang="0">
                        <a:pos x="9" y="370"/>
                      </a:cxn>
                      <a:cxn ang="0">
                        <a:pos x="22" y="378"/>
                      </a:cxn>
                      <a:cxn ang="0">
                        <a:pos x="71" y="378"/>
                      </a:cxn>
                      <a:cxn ang="0">
                        <a:pos x="109" y="362"/>
                      </a:cxn>
                      <a:cxn ang="0">
                        <a:pos x="114" y="307"/>
                      </a:cxn>
                      <a:cxn ang="0">
                        <a:pos x="136" y="249"/>
                      </a:cxn>
                      <a:cxn ang="0">
                        <a:pos x="144" y="264"/>
                      </a:cxn>
                      <a:cxn ang="0">
                        <a:pos x="158" y="270"/>
                      </a:cxn>
                      <a:cxn ang="0">
                        <a:pos x="179" y="273"/>
                      </a:cxn>
                      <a:cxn ang="0">
                        <a:pos x="194" y="254"/>
                      </a:cxn>
                      <a:cxn ang="0">
                        <a:pos x="225" y="242"/>
                      </a:cxn>
                      <a:cxn ang="0">
                        <a:pos x="232" y="227"/>
                      </a:cxn>
                      <a:cxn ang="0">
                        <a:pos x="256" y="222"/>
                      </a:cxn>
                      <a:cxn ang="0">
                        <a:pos x="295" y="230"/>
                      </a:cxn>
                      <a:cxn ang="0">
                        <a:pos x="292" y="202"/>
                      </a:cxn>
                      <a:cxn ang="0">
                        <a:pos x="280" y="191"/>
                      </a:cxn>
                      <a:cxn ang="0">
                        <a:pos x="293" y="173"/>
                      </a:cxn>
                      <a:cxn ang="0">
                        <a:pos x="305" y="177"/>
                      </a:cxn>
                      <a:cxn ang="0">
                        <a:pos x="335" y="163"/>
                      </a:cxn>
                      <a:cxn ang="0">
                        <a:pos x="352" y="163"/>
                      </a:cxn>
                      <a:cxn ang="0">
                        <a:pos x="363" y="174"/>
                      </a:cxn>
                      <a:cxn ang="0">
                        <a:pos x="377" y="157"/>
                      </a:cxn>
                      <a:cxn ang="0">
                        <a:pos x="369" y="123"/>
                      </a:cxn>
                      <a:cxn ang="0">
                        <a:pos x="360" y="104"/>
                      </a:cxn>
                      <a:cxn ang="0">
                        <a:pos x="382" y="70"/>
                      </a:cxn>
                      <a:cxn ang="0">
                        <a:pos x="380" y="38"/>
                      </a:cxn>
                      <a:cxn ang="0">
                        <a:pos x="388" y="16"/>
                      </a:cxn>
                      <a:cxn ang="0">
                        <a:pos x="237" y="0"/>
                      </a:cxn>
                    </a:cxnLst>
                    <a:rect l="0" t="0" r="r" b="b"/>
                    <a:pathLst>
                      <a:path w="388" h="378">
                        <a:moveTo>
                          <a:pt x="237" y="0"/>
                        </a:moveTo>
                        <a:cubicBezTo>
                          <a:pt x="236" y="0"/>
                          <a:pt x="234" y="2"/>
                          <a:pt x="234" y="2"/>
                        </a:cubicBezTo>
                        <a:cubicBezTo>
                          <a:pt x="202" y="30"/>
                          <a:pt x="202" y="30"/>
                          <a:pt x="202" y="30"/>
                        </a:cubicBezTo>
                        <a:cubicBezTo>
                          <a:pt x="190" y="50"/>
                          <a:pt x="190" y="50"/>
                          <a:pt x="190" y="50"/>
                        </a:cubicBezTo>
                        <a:cubicBezTo>
                          <a:pt x="194" y="62"/>
                          <a:pt x="194" y="62"/>
                          <a:pt x="194" y="62"/>
                        </a:cubicBezTo>
                        <a:cubicBezTo>
                          <a:pt x="185" y="72"/>
                          <a:pt x="185" y="72"/>
                          <a:pt x="185" y="72"/>
                        </a:cubicBezTo>
                        <a:cubicBezTo>
                          <a:pt x="166" y="74"/>
                          <a:pt x="166" y="74"/>
                          <a:pt x="166" y="74"/>
                        </a:cubicBezTo>
                        <a:cubicBezTo>
                          <a:pt x="152" y="67"/>
                          <a:pt x="152" y="67"/>
                          <a:pt x="152" y="67"/>
                        </a:cubicBezTo>
                        <a:cubicBezTo>
                          <a:pt x="126" y="69"/>
                          <a:pt x="126" y="69"/>
                          <a:pt x="126" y="69"/>
                        </a:cubicBezTo>
                        <a:cubicBezTo>
                          <a:pt x="118" y="79"/>
                          <a:pt x="118" y="79"/>
                          <a:pt x="118" y="79"/>
                        </a:cubicBezTo>
                        <a:cubicBezTo>
                          <a:pt x="137" y="110"/>
                          <a:pt x="137" y="110"/>
                          <a:pt x="137" y="110"/>
                        </a:cubicBezTo>
                        <a:cubicBezTo>
                          <a:pt x="129" y="117"/>
                          <a:pt x="129" y="117"/>
                          <a:pt x="129" y="117"/>
                        </a:cubicBezTo>
                        <a:cubicBezTo>
                          <a:pt x="125" y="116"/>
                          <a:pt x="125" y="116"/>
                          <a:pt x="125" y="116"/>
                        </a:cubicBezTo>
                        <a:cubicBezTo>
                          <a:pt x="128" y="121"/>
                          <a:pt x="128" y="121"/>
                          <a:pt x="128" y="121"/>
                        </a:cubicBezTo>
                        <a:cubicBezTo>
                          <a:pt x="133" y="139"/>
                          <a:pt x="133" y="139"/>
                          <a:pt x="133" y="139"/>
                        </a:cubicBezTo>
                        <a:cubicBezTo>
                          <a:pt x="137" y="156"/>
                          <a:pt x="137" y="156"/>
                          <a:pt x="137" y="156"/>
                        </a:cubicBezTo>
                        <a:cubicBezTo>
                          <a:pt x="112" y="184"/>
                          <a:pt x="112" y="184"/>
                          <a:pt x="112" y="184"/>
                        </a:cubicBezTo>
                        <a:cubicBezTo>
                          <a:pt x="94" y="182"/>
                          <a:pt x="94" y="182"/>
                          <a:pt x="94" y="182"/>
                        </a:cubicBezTo>
                        <a:cubicBezTo>
                          <a:pt x="88" y="196"/>
                          <a:pt x="88" y="196"/>
                          <a:pt x="88" y="196"/>
                        </a:cubicBezTo>
                        <a:cubicBezTo>
                          <a:pt x="81" y="226"/>
                          <a:pt x="81" y="226"/>
                          <a:pt x="81" y="226"/>
                        </a:cubicBezTo>
                        <a:cubicBezTo>
                          <a:pt x="57" y="224"/>
                          <a:pt x="57" y="224"/>
                          <a:pt x="57" y="224"/>
                        </a:cubicBezTo>
                        <a:cubicBezTo>
                          <a:pt x="44" y="212"/>
                          <a:pt x="44" y="212"/>
                          <a:pt x="44" y="212"/>
                        </a:cubicBezTo>
                        <a:cubicBezTo>
                          <a:pt x="37" y="212"/>
                          <a:pt x="37" y="212"/>
                          <a:pt x="37" y="212"/>
                        </a:cubicBezTo>
                        <a:cubicBezTo>
                          <a:pt x="32" y="206"/>
                          <a:pt x="32" y="206"/>
                          <a:pt x="32" y="206"/>
                        </a:cubicBezTo>
                        <a:cubicBezTo>
                          <a:pt x="10" y="199"/>
                          <a:pt x="10" y="199"/>
                          <a:pt x="10" y="199"/>
                        </a:cubicBezTo>
                        <a:cubicBezTo>
                          <a:pt x="10" y="200"/>
                          <a:pt x="10" y="200"/>
                          <a:pt x="10" y="200"/>
                        </a:cubicBezTo>
                        <a:cubicBezTo>
                          <a:pt x="0" y="206"/>
                          <a:pt x="0" y="206"/>
                          <a:pt x="0" y="206"/>
                        </a:cubicBezTo>
                        <a:cubicBezTo>
                          <a:pt x="7" y="239"/>
                          <a:pt x="7" y="239"/>
                          <a:pt x="7" y="239"/>
                        </a:cubicBezTo>
                        <a:cubicBezTo>
                          <a:pt x="23" y="250"/>
                          <a:pt x="23" y="250"/>
                          <a:pt x="23" y="250"/>
                        </a:cubicBezTo>
                        <a:cubicBezTo>
                          <a:pt x="16" y="263"/>
                          <a:pt x="16" y="263"/>
                          <a:pt x="16" y="263"/>
                        </a:cubicBezTo>
                        <a:cubicBezTo>
                          <a:pt x="15" y="279"/>
                          <a:pt x="15" y="279"/>
                          <a:pt x="15" y="279"/>
                        </a:cubicBezTo>
                        <a:cubicBezTo>
                          <a:pt x="17" y="313"/>
                          <a:pt x="17" y="313"/>
                          <a:pt x="17" y="313"/>
                        </a:cubicBezTo>
                        <a:cubicBezTo>
                          <a:pt x="10" y="351"/>
                          <a:pt x="10" y="351"/>
                          <a:pt x="10" y="351"/>
                        </a:cubicBezTo>
                        <a:cubicBezTo>
                          <a:pt x="9" y="370"/>
                          <a:pt x="9" y="370"/>
                          <a:pt x="9" y="370"/>
                        </a:cubicBezTo>
                        <a:cubicBezTo>
                          <a:pt x="15" y="367"/>
                          <a:pt x="15" y="367"/>
                          <a:pt x="15" y="367"/>
                        </a:cubicBezTo>
                        <a:cubicBezTo>
                          <a:pt x="22" y="378"/>
                          <a:pt x="22" y="378"/>
                          <a:pt x="22" y="378"/>
                        </a:cubicBezTo>
                        <a:cubicBezTo>
                          <a:pt x="70" y="378"/>
                          <a:pt x="70" y="378"/>
                          <a:pt x="70" y="378"/>
                        </a:cubicBezTo>
                        <a:cubicBezTo>
                          <a:pt x="71" y="378"/>
                          <a:pt x="71" y="378"/>
                          <a:pt x="71" y="378"/>
                        </a:cubicBezTo>
                        <a:cubicBezTo>
                          <a:pt x="110" y="371"/>
                          <a:pt x="110" y="371"/>
                          <a:pt x="110" y="371"/>
                        </a:cubicBezTo>
                        <a:cubicBezTo>
                          <a:pt x="109" y="362"/>
                          <a:pt x="109" y="362"/>
                          <a:pt x="109" y="362"/>
                        </a:cubicBezTo>
                        <a:cubicBezTo>
                          <a:pt x="106" y="332"/>
                          <a:pt x="106" y="332"/>
                          <a:pt x="106" y="332"/>
                        </a:cubicBezTo>
                        <a:cubicBezTo>
                          <a:pt x="114" y="307"/>
                          <a:pt x="114" y="307"/>
                          <a:pt x="114" y="307"/>
                        </a:cubicBezTo>
                        <a:cubicBezTo>
                          <a:pt x="121" y="275"/>
                          <a:pt x="121" y="275"/>
                          <a:pt x="121" y="275"/>
                        </a:cubicBezTo>
                        <a:cubicBezTo>
                          <a:pt x="136" y="249"/>
                          <a:pt x="136" y="249"/>
                          <a:pt x="136" y="249"/>
                        </a:cubicBezTo>
                        <a:cubicBezTo>
                          <a:pt x="142" y="252"/>
                          <a:pt x="142" y="252"/>
                          <a:pt x="142" y="252"/>
                        </a:cubicBezTo>
                        <a:cubicBezTo>
                          <a:pt x="144" y="264"/>
                          <a:pt x="144" y="264"/>
                          <a:pt x="144" y="264"/>
                        </a:cubicBezTo>
                        <a:cubicBezTo>
                          <a:pt x="156" y="264"/>
                          <a:pt x="156" y="264"/>
                          <a:pt x="156" y="264"/>
                        </a:cubicBezTo>
                        <a:cubicBezTo>
                          <a:pt x="158" y="270"/>
                          <a:pt x="158" y="270"/>
                          <a:pt x="158" y="270"/>
                        </a:cubicBezTo>
                        <a:cubicBezTo>
                          <a:pt x="170" y="275"/>
                          <a:pt x="170" y="275"/>
                          <a:pt x="170" y="275"/>
                        </a:cubicBezTo>
                        <a:cubicBezTo>
                          <a:pt x="179" y="273"/>
                          <a:pt x="179" y="273"/>
                          <a:pt x="179" y="273"/>
                        </a:cubicBezTo>
                        <a:cubicBezTo>
                          <a:pt x="182" y="267"/>
                          <a:pt x="182" y="267"/>
                          <a:pt x="182" y="267"/>
                        </a:cubicBezTo>
                        <a:cubicBezTo>
                          <a:pt x="194" y="254"/>
                          <a:pt x="194" y="254"/>
                          <a:pt x="194" y="254"/>
                        </a:cubicBezTo>
                        <a:cubicBezTo>
                          <a:pt x="216" y="252"/>
                          <a:pt x="216" y="252"/>
                          <a:pt x="216" y="252"/>
                        </a:cubicBezTo>
                        <a:cubicBezTo>
                          <a:pt x="225" y="242"/>
                          <a:pt x="225" y="242"/>
                          <a:pt x="225" y="242"/>
                        </a:cubicBezTo>
                        <a:cubicBezTo>
                          <a:pt x="222" y="231"/>
                          <a:pt x="222" y="231"/>
                          <a:pt x="222" y="231"/>
                        </a:cubicBezTo>
                        <a:cubicBezTo>
                          <a:pt x="232" y="227"/>
                          <a:pt x="232" y="227"/>
                          <a:pt x="232" y="227"/>
                        </a:cubicBezTo>
                        <a:cubicBezTo>
                          <a:pt x="230" y="219"/>
                          <a:pt x="230" y="219"/>
                          <a:pt x="230" y="219"/>
                        </a:cubicBezTo>
                        <a:cubicBezTo>
                          <a:pt x="256" y="222"/>
                          <a:pt x="256" y="222"/>
                          <a:pt x="256" y="222"/>
                        </a:cubicBezTo>
                        <a:cubicBezTo>
                          <a:pt x="267" y="237"/>
                          <a:pt x="267" y="237"/>
                          <a:pt x="267" y="237"/>
                        </a:cubicBezTo>
                        <a:cubicBezTo>
                          <a:pt x="295" y="230"/>
                          <a:pt x="295" y="230"/>
                          <a:pt x="295" y="230"/>
                        </a:cubicBezTo>
                        <a:cubicBezTo>
                          <a:pt x="297" y="214"/>
                          <a:pt x="297" y="214"/>
                          <a:pt x="297" y="214"/>
                        </a:cubicBezTo>
                        <a:cubicBezTo>
                          <a:pt x="292" y="202"/>
                          <a:pt x="292" y="202"/>
                          <a:pt x="292" y="202"/>
                        </a:cubicBezTo>
                        <a:cubicBezTo>
                          <a:pt x="278" y="194"/>
                          <a:pt x="278" y="194"/>
                          <a:pt x="278" y="194"/>
                        </a:cubicBezTo>
                        <a:cubicBezTo>
                          <a:pt x="280" y="191"/>
                          <a:pt x="280" y="191"/>
                          <a:pt x="280" y="191"/>
                        </a:cubicBezTo>
                        <a:cubicBezTo>
                          <a:pt x="273" y="178"/>
                          <a:pt x="273" y="178"/>
                          <a:pt x="273" y="178"/>
                        </a:cubicBezTo>
                        <a:cubicBezTo>
                          <a:pt x="293" y="173"/>
                          <a:pt x="293" y="173"/>
                          <a:pt x="293" y="173"/>
                        </a:cubicBezTo>
                        <a:cubicBezTo>
                          <a:pt x="299" y="178"/>
                          <a:pt x="299" y="178"/>
                          <a:pt x="299" y="178"/>
                        </a:cubicBezTo>
                        <a:cubicBezTo>
                          <a:pt x="305" y="177"/>
                          <a:pt x="305" y="177"/>
                          <a:pt x="305" y="177"/>
                        </a:cubicBezTo>
                        <a:cubicBezTo>
                          <a:pt x="309" y="172"/>
                          <a:pt x="309" y="172"/>
                          <a:pt x="309" y="172"/>
                        </a:cubicBezTo>
                        <a:cubicBezTo>
                          <a:pt x="335" y="163"/>
                          <a:pt x="335" y="163"/>
                          <a:pt x="335" y="163"/>
                        </a:cubicBezTo>
                        <a:cubicBezTo>
                          <a:pt x="341" y="156"/>
                          <a:pt x="341" y="156"/>
                          <a:pt x="341" y="156"/>
                        </a:cubicBezTo>
                        <a:cubicBezTo>
                          <a:pt x="352" y="163"/>
                          <a:pt x="352" y="163"/>
                          <a:pt x="352" y="163"/>
                        </a:cubicBezTo>
                        <a:cubicBezTo>
                          <a:pt x="360" y="174"/>
                          <a:pt x="360" y="174"/>
                          <a:pt x="360" y="174"/>
                        </a:cubicBezTo>
                        <a:cubicBezTo>
                          <a:pt x="363" y="174"/>
                          <a:pt x="363" y="174"/>
                          <a:pt x="363" y="174"/>
                        </a:cubicBezTo>
                        <a:cubicBezTo>
                          <a:pt x="373" y="174"/>
                          <a:pt x="373" y="174"/>
                          <a:pt x="373" y="174"/>
                        </a:cubicBezTo>
                        <a:cubicBezTo>
                          <a:pt x="377" y="157"/>
                          <a:pt x="377" y="157"/>
                          <a:pt x="377" y="157"/>
                        </a:cubicBezTo>
                        <a:cubicBezTo>
                          <a:pt x="367" y="145"/>
                          <a:pt x="367" y="145"/>
                          <a:pt x="367" y="145"/>
                        </a:cubicBezTo>
                        <a:cubicBezTo>
                          <a:pt x="369" y="123"/>
                          <a:pt x="369" y="123"/>
                          <a:pt x="369" y="123"/>
                        </a:cubicBezTo>
                        <a:cubicBezTo>
                          <a:pt x="376" y="112"/>
                          <a:pt x="376" y="112"/>
                          <a:pt x="376" y="112"/>
                        </a:cubicBezTo>
                        <a:cubicBezTo>
                          <a:pt x="360" y="104"/>
                          <a:pt x="360" y="104"/>
                          <a:pt x="360" y="104"/>
                        </a:cubicBezTo>
                        <a:cubicBezTo>
                          <a:pt x="377" y="90"/>
                          <a:pt x="377" y="90"/>
                          <a:pt x="377" y="90"/>
                        </a:cubicBezTo>
                        <a:cubicBezTo>
                          <a:pt x="382" y="70"/>
                          <a:pt x="382" y="70"/>
                          <a:pt x="382" y="70"/>
                        </a:cubicBezTo>
                        <a:cubicBezTo>
                          <a:pt x="374" y="64"/>
                          <a:pt x="374" y="64"/>
                          <a:pt x="374" y="64"/>
                        </a:cubicBezTo>
                        <a:cubicBezTo>
                          <a:pt x="380" y="38"/>
                          <a:pt x="380" y="38"/>
                          <a:pt x="380" y="38"/>
                        </a:cubicBezTo>
                        <a:cubicBezTo>
                          <a:pt x="388" y="16"/>
                          <a:pt x="388" y="16"/>
                          <a:pt x="388" y="16"/>
                        </a:cubicBezTo>
                        <a:cubicBezTo>
                          <a:pt x="388" y="16"/>
                          <a:pt x="388" y="16"/>
                          <a:pt x="388" y="16"/>
                        </a:cubicBezTo>
                        <a:cubicBezTo>
                          <a:pt x="246" y="16"/>
                          <a:pt x="246" y="16"/>
                          <a:pt x="246" y="16"/>
                        </a:cubicBezTo>
                        <a:lnTo>
                          <a:pt x="237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1" name="Freeform 9"/>
                  <p:cNvSpPr>
                    <a:spLocks noEditPoints="1"/>
                  </p:cNvSpPr>
                  <p:nvPr/>
                </p:nvSpPr>
                <p:spPr bwMode="auto">
                  <a:xfrm>
                    <a:off x="4016066" y="5800687"/>
                    <a:ext cx="1163108" cy="904288"/>
                  </a:xfrm>
                  <a:custGeom>
                    <a:avLst/>
                    <a:gdLst/>
                    <a:ahLst/>
                    <a:cxnLst>
                      <a:cxn ang="0">
                        <a:pos x="43" y="30"/>
                      </a:cxn>
                      <a:cxn ang="0">
                        <a:pos x="46" y="72"/>
                      </a:cxn>
                      <a:cxn ang="0">
                        <a:pos x="17" y="117"/>
                      </a:cxn>
                      <a:cxn ang="0">
                        <a:pos x="29" y="142"/>
                      </a:cxn>
                      <a:cxn ang="0">
                        <a:pos x="39" y="187"/>
                      </a:cxn>
                      <a:cxn ang="0">
                        <a:pos x="21" y="209"/>
                      </a:cxn>
                      <a:cxn ang="0">
                        <a:pos x="0" y="256"/>
                      </a:cxn>
                      <a:cxn ang="0">
                        <a:pos x="17" y="293"/>
                      </a:cxn>
                      <a:cxn ang="0">
                        <a:pos x="74" y="344"/>
                      </a:cxn>
                      <a:cxn ang="0">
                        <a:pos x="68" y="383"/>
                      </a:cxn>
                      <a:cxn ang="0">
                        <a:pos x="112" y="410"/>
                      </a:cxn>
                      <a:cxn ang="0">
                        <a:pos x="209" y="409"/>
                      </a:cxn>
                      <a:cxn ang="0">
                        <a:pos x="272" y="416"/>
                      </a:cxn>
                      <a:cxn ang="0">
                        <a:pos x="308" y="472"/>
                      </a:cxn>
                      <a:cxn ang="0">
                        <a:pos x="306" y="517"/>
                      </a:cxn>
                      <a:cxn ang="0">
                        <a:pos x="333" y="534"/>
                      </a:cxn>
                      <a:cxn ang="0">
                        <a:pos x="355" y="558"/>
                      </a:cxn>
                      <a:cxn ang="0">
                        <a:pos x="389" y="529"/>
                      </a:cxn>
                      <a:cxn ang="0">
                        <a:pos x="405" y="526"/>
                      </a:cxn>
                      <a:cxn ang="0">
                        <a:pos x="392" y="446"/>
                      </a:cxn>
                      <a:cxn ang="0">
                        <a:pos x="420" y="435"/>
                      </a:cxn>
                      <a:cxn ang="0">
                        <a:pos x="462" y="481"/>
                      </a:cxn>
                      <a:cxn ang="0">
                        <a:pos x="487" y="468"/>
                      </a:cxn>
                      <a:cxn ang="0">
                        <a:pos x="528" y="456"/>
                      </a:cxn>
                      <a:cxn ang="0">
                        <a:pos x="578" y="472"/>
                      </a:cxn>
                      <a:cxn ang="0">
                        <a:pos x="608" y="498"/>
                      </a:cxn>
                      <a:cxn ang="0">
                        <a:pos x="585" y="541"/>
                      </a:cxn>
                      <a:cxn ang="0">
                        <a:pos x="733" y="523"/>
                      </a:cxn>
                      <a:cxn ang="0">
                        <a:pos x="699" y="466"/>
                      </a:cxn>
                      <a:cxn ang="0">
                        <a:pos x="687" y="444"/>
                      </a:cxn>
                      <a:cxn ang="0">
                        <a:pos x="679" y="413"/>
                      </a:cxn>
                      <a:cxn ang="0">
                        <a:pos x="655" y="355"/>
                      </a:cxn>
                      <a:cxn ang="0">
                        <a:pos x="610" y="335"/>
                      </a:cxn>
                      <a:cxn ang="0">
                        <a:pos x="562" y="264"/>
                      </a:cxn>
                      <a:cxn ang="0">
                        <a:pos x="554" y="247"/>
                      </a:cxn>
                      <a:cxn ang="0">
                        <a:pos x="546" y="221"/>
                      </a:cxn>
                      <a:cxn ang="0">
                        <a:pos x="530" y="189"/>
                      </a:cxn>
                      <a:cxn ang="0">
                        <a:pos x="518" y="162"/>
                      </a:cxn>
                      <a:cxn ang="0">
                        <a:pos x="539" y="139"/>
                      </a:cxn>
                      <a:cxn ang="0">
                        <a:pos x="547" y="113"/>
                      </a:cxn>
                      <a:cxn ang="0">
                        <a:pos x="524" y="71"/>
                      </a:cxn>
                      <a:cxn ang="0">
                        <a:pos x="505" y="25"/>
                      </a:cxn>
                      <a:cxn ang="0">
                        <a:pos x="55" y="0"/>
                      </a:cxn>
                      <a:cxn ang="0">
                        <a:pos x="184" y="573"/>
                      </a:cxn>
                      <a:cxn ang="0">
                        <a:pos x="201" y="538"/>
                      </a:cxn>
                    </a:cxnLst>
                    <a:rect l="0" t="0" r="r" b="b"/>
                    <a:pathLst>
                      <a:path w="737" h="573">
                        <a:moveTo>
                          <a:pt x="55" y="0"/>
                        </a:moveTo>
                        <a:lnTo>
                          <a:pt x="43" y="30"/>
                        </a:lnTo>
                        <a:lnTo>
                          <a:pt x="35" y="64"/>
                        </a:lnTo>
                        <a:lnTo>
                          <a:pt x="46" y="72"/>
                        </a:lnTo>
                        <a:lnTo>
                          <a:pt x="39" y="98"/>
                        </a:lnTo>
                        <a:lnTo>
                          <a:pt x="17" y="117"/>
                        </a:lnTo>
                        <a:lnTo>
                          <a:pt x="38" y="127"/>
                        </a:lnTo>
                        <a:lnTo>
                          <a:pt x="29" y="142"/>
                        </a:lnTo>
                        <a:lnTo>
                          <a:pt x="26" y="171"/>
                        </a:lnTo>
                        <a:lnTo>
                          <a:pt x="39" y="187"/>
                        </a:lnTo>
                        <a:lnTo>
                          <a:pt x="34" y="209"/>
                        </a:lnTo>
                        <a:lnTo>
                          <a:pt x="21" y="209"/>
                        </a:lnTo>
                        <a:lnTo>
                          <a:pt x="24" y="217"/>
                        </a:lnTo>
                        <a:lnTo>
                          <a:pt x="0" y="256"/>
                        </a:lnTo>
                        <a:lnTo>
                          <a:pt x="9" y="277"/>
                        </a:lnTo>
                        <a:lnTo>
                          <a:pt x="17" y="293"/>
                        </a:lnTo>
                        <a:lnTo>
                          <a:pt x="22" y="322"/>
                        </a:lnTo>
                        <a:lnTo>
                          <a:pt x="74" y="344"/>
                        </a:lnTo>
                        <a:lnTo>
                          <a:pt x="83" y="360"/>
                        </a:lnTo>
                        <a:lnTo>
                          <a:pt x="68" y="383"/>
                        </a:lnTo>
                        <a:lnTo>
                          <a:pt x="88" y="404"/>
                        </a:lnTo>
                        <a:lnTo>
                          <a:pt x="112" y="410"/>
                        </a:lnTo>
                        <a:lnTo>
                          <a:pt x="179" y="425"/>
                        </a:lnTo>
                        <a:lnTo>
                          <a:pt x="209" y="409"/>
                        </a:lnTo>
                        <a:lnTo>
                          <a:pt x="263" y="405"/>
                        </a:lnTo>
                        <a:lnTo>
                          <a:pt x="272" y="416"/>
                        </a:lnTo>
                        <a:lnTo>
                          <a:pt x="274" y="460"/>
                        </a:lnTo>
                        <a:lnTo>
                          <a:pt x="308" y="472"/>
                        </a:lnTo>
                        <a:lnTo>
                          <a:pt x="321" y="489"/>
                        </a:lnTo>
                        <a:lnTo>
                          <a:pt x="306" y="517"/>
                        </a:lnTo>
                        <a:lnTo>
                          <a:pt x="310" y="518"/>
                        </a:lnTo>
                        <a:lnTo>
                          <a:pt x="333" y="534"/>
                        </a:lnTo>
                        <a:lnTo>
                          <a:pt x="346" y="556"/>
                        </a:lnTo>
                        <a:lnTo>
                          <a:pt x="355" y="558"/>
                        </a:lnTo>
                        <a:lnTo>
                          <a:pt x="374" y="529"/>
                        </a:lnTo>
                        <a:lnTo>
                          <a:pt x="389" y="529"/>
                        </a:lnTo>
                        <a:lnTo>
                          <a:pt x="403" y="535"/>
                        </a:lnTo>
                        <a:lnTo>
                          <a:pt x="405" y="526"/>
                        </a:lnTo>
                        <a:lnTo>
                          <a:pt x="406" y="464"/>
                        </a:lnTo>
                        <a:lnTo>
                          <a:pt x="392" y="446"/>
                        </a:lnTo>
                        <a:lnTo>
                          <a:pt x="403" y="435"/>
                        </a:lnTo>
                        <a:lnTo>
                          <a:pt x="420" y="435"/>
                        </a:lnTo>
                        <a:lnTo>
                          <a:pt x="439" y="442"/>
                        </a:lnTo>
                        <a:lnTo>
                          <a:pt x="462" y="481"/>
                        </a:lnTo>
                        <a:lnTo>
                          <a:pt x="471" y="485"/>
                        </a:lnTo>
                        <a:lnTo>
                          <a:pt x="487" y="468"/>
                        </a:lnTo>
                        <a:lnTo>
                          <a:pt x="499" y="467"/>
                        </a:lnTo>
                        <a:lnTo>
                          <a:pt x="528" y="456"/>
                        </a:lnTo>
                        <a:lnTo>
                          <a:pt x="562" y="454"/>
                        </a:lnTo>
                        <a:lnTo>
                          <a:pt x="578" y="472"/>
                        </a:lnTo>
                        <a:lnTo>
                          <a:pt x="601" y="475"/>
                        </a:lnTo>
                        <a:lnTo>
                          <a:pt x="608" y="498"/>
                        </a:lnTo>
                        <a:lnTo>
                          <a:pt x="593" y="521"/>
                        </a:lnTo>
                        <a:lnTo>
                          <a:pt x="585" y="541"/>
                        </a:lnTo>
                        <a:lnTo>
                          <a:pt x="585" y="543"/>
                        </a:lnTo>
                        <a:lnTo>
                          <a:pt x="733" y="523"/>
                        </a:lnTo>
                        <a:lnTo>
                          <a:pt x="737" y="508"/>
                        </a:lnTo>
                        <a:lnTo>
                          <a:pt x="699" y="466"/>
                        </a:lnTo>
                        <a:lnTo>
                          <a:pt x="691" y="467"/>
                        </a:lnTo>
                        <a:lnTo>
                          <a:pt x="687" y="444"/>
                        </a:lnTo>
                        <a:lnTo>
                          <a:pt x="679" y="433"/>
                        </a:lnTo>
                        <a:lnTo>
                          <a:pt x="679" y="413"/>
                        </a:lnTo>
                        <a:lnTo>
                          <a:pt x="671" y="384"/>
                        </a:lnTo>
                        <a:lnTo>
                          <a:pt x="655" y="355"/>
                        </a:lnTo>
                        <a:lnTo>
                          <a:pt x="629" y="339"/>
                        </a:lnTo>
                        <a:lnTo>
                          <a:pt x="610" y="335"/>
                        </a:lnTo>
                        <a:lnTo>
                          <a:pt x="584" y="300"/>
                        </a:lnTo>
                        <a:lnTo>
                          <a:pt x="562" y="264"/>
                        </a:lnTo>
                        <a:lnTo>
                          <a:pt x="563" y="251"/>
                        </a:lnTo>
                        <a:lnTo>
                          <a:pt x="554" y="247"/>
                        </a:lnTo>
                        <a:lnTo>
                          <a:pt x="550" y="231"/>
                        </a:lnTo>
                        <a:lnTo>
                          <a:pt x="546" y="221"/>
                        </a:lnTo>
                        <a:lnTo>
                          <a:pt x="537" y="198"/>
                        </a:lnTo>
                        <a:lnTo>
                          <a:pt x="530" y="189"/>
                        </a:lnTo>
                        <a:lnTo>
                          <a:pt x="518" y="180"/>
                        </a:lnTo>
                        <a:lnTo>
                          <a:pt x="518" y="162"/>
                        </a:lnTo>
                        <a:lnTo>
                          <a:pt x="530" y="150"/>
                        </a:lnTo>
                        <a:lnTo>
                          <a:pt x="539" y="139"/>
                        </a:lnTo>
                        <a:lnTo>
                          <a:pt x="543" y="110"/>
                        </a:lnTo>
                        <a:lnTo>
                          <a:pt x="547" y="113"/>
                        </a:lnTo>
                        <a:lnTo>
                          <a:pt x="545" y="100"/>
                        </a:lnTo>
                        <a:lnTo>
                          <a:pt x="524" y="71"/>
                        </a:lnTo>
                        <a:lnTo>
                          <a:pt x="510" y="42"/>
                        </a:lnTo>
                        <a:lnTo>
                          <a:pt x="505" y="25"/>
                        </a:lnTo>
                        <a:lnTo>
                          <a:pt x="505" y="12"/>
                        </a:lnTo>
                        <a:lnTo>
                          <a:pt x="55" y="0"/>
                        </a:lnTo>
                        <a:close/>
                        <a:moveTo>
                          <a:pt x="201" y="538"/>
                        </a:moveTo>
                        <a:lnTo>
                          <a:pt x="184" y="573"/>
                        </a:lnTo>
                        <a:lnTo>
                          <a:pt x="184" y="573"/>
                        </a:lnTo>
                        <a:lnTo>
                          <a:pt x="201" y="538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2" name="Freeform 10"/>
                  <p:cNvSpPr>
                    <a:spLocks/>
                  </p:cNvSpPr>
                  <p:nvPr/>
                </p:nvSpPr>
                <p:spPr bwMode="auto">
                  <a:xfrm>
                    <a:off x="4259103" y="4980041"/>
                    <a:ext cx="623375" cy="841161"/>
                  </a:xfrm>
                  <a:custGeom>
                    <a:avLst/>
                    <a:gdLst/>
                    <a:ahLst/>
                    <a:cxnLst>
                      <a:cxn ang="0">
                        <a:pos x="261" y="0"/>
                      </a:cxn>
                      <a:cxn ang="0">
                        <a:pos x="253" y="10"/>
                      </a:cxn>
                      <a:cxn ang="0">
                        <a:pos x="223" y="15"/>
                      </a:cxn>
                      <a:cxn ang="0">
                        <a:pos x="217" y="27"/>
                      </a:cxn>
                      <a:cxn ang="0">
                        <a:pos x="200" y="33"/>
                      </a:cxn>
                      <a:cxn ang="0">
                        <a:pos x="185" y="20"/>
                      </a:cxn>
                      <a:cxn ang="0">
                        <a:pos x="180" y="44"/>
                      </a:cxn>
                      <a:cxn ang="0">
                        <a:pos x="161" y="49"/>
                      </a:cxn>
                      <a:cxn ang="0">
                        <a:pos x="117" y="46"/>
                      </a:cxn>
                      <a:cxn ang="0">
                        <a:pos x="104" y="36"/>
                      </a:cxn>
                      <a:cxn ang="0">
                        <a:pos x="106" y="42"/>
                      </a:cxn>
                      <a:cxn ang="0">
                        <a:pos x="72" y="58"/>
                      </a:cxn>
                      <a:cxn ang="0">
                        <a:pos x="56" y="75"/>
                      </a:cxn>
                      <a:cxn ang="0">
                        <a:pos x="33" y="77"/>
                      </a:cxn>
                      <a:cxn ang="0">
                        <a:pos x="17" y="65"/>
                      </a:cxn>
                      <a:cxn ang="0">
                        <a:pos x="6" y="72"/>
                      </a:cxn>
                      <a:cxn ang="0">
                        <a:pos x="0" y="99"/>
                      </a:cxn>
                      <a:cxn ang="0">
                        <a:pos x="9" y="142"/>
                      </a:cxn>
                      <a:cxn ang="0">
                        <a:pos x="25" y="158"/>
                      </a:cxn>
                      <a:cxn ang="0">
                        <a:pos x="30" y="186"/>
                      </a:cxn>
                      <a:cxn ang="0">
                        <a:pos x="30" y="230"/>
                      </a:cxn>
                      <a:cxn ang="0">
                        <a:pos x="26" y="260"/>
                      </a:cxn>
                      <a:cxn ang="0">
                        <a:pos x="47" y="270"/>
                      </a:cxn>
                      <a:cxn ang="0">
                        <a:pos x="85" y="277"/>
                      </a:cxn>
                      <a:cxn ang="0">
                        <a:pos x="109" y="277"/>
                      </a:cxn>
                      <a:cxn ang="0">
                        <a:pos x="119" y="294"/>
                      </a:cxn>
                      <a:cxn ang="0">
                        <a:pos x="135" y="298"/>
                      </a:cxn>
                      <a:cxn ang="0">
                        <a:pos x="149" y="303"/>
                      </a:cxn>
                      <a:cxn ang="0">
                        <a:pos x="158" y="297"/>
                      </a:cxn>
                      <a:cxn ang="0">
                        <a:pos x="190" y="321"/>
                      </a:cxn>
                      <a:cxn ang="0">
                        <a:pos x="202" y="342"/>
                      </a:cxn>
                      <a:cxn ang="0">
                        <a:pos x="225" y="402"/>
                      </a:cxn>
                      <a:cxn ang="0">
                        <a:pos x="226" y="403"/>
                      </a:cxn>
                      <a:cxn ang="0">
                        <a:pos x="296" y="405"/>
                      </a:cxn>
                      <a:cxn ang="0">
                        <a:pos x="296" y="362"/>
                      </a:cxn>
                      <a:cxn ang="0">
                        <a:pos x="300" y="326"/>
                      </a:cxn>
                      <a:cxn ang="0">
                        <a:pos x="295" y="290"/>
                      </a:cxn>
                      <a:cxn ang="0">
                        <a:pos x="284" y="275"/>
                      </a:cxn>
                      <a:cxn ang="0">
                        <a:pos x="283" y="251"/>
                      </a:cxn>
                      <a:cxn ang="0">
                        <a:pos x="280" y="191"/>
                      </a:cxn>
                      <a:cxn ang="0">
                        <a:pos x="284" y="165"/>
                      </a:cxn>
                      <a:cxn ang="0">
                        <a:pos x="275" y="166"/>
                      </a:cxn>
                      <a:cxn ang="0">
                        <a:pos x="257" y="144"/>
                      </a:cxn>
                      <a:cxn ang="0">
                        <a:pos x="258" y="131"/>
                      </a:cxn>
                      <a:cxn ang="0">
                        <a:pos x="245" y="124"/>
                      </a:cxn>
                      <a:cxn ang="0">
                        <a:pos x="240" y="107"/>
                      </a:cxn>
                      <a:cxn ang="0">
                        <a:pos x="240" y="91"/>
                      </a:cxn>
                      <a:cxn ang="0">
                        <a:pos x="250" y="80"/>
                      </a:cxn>
                      <a:cxn ang="0">
                        <a:pos x="264" y="79"/>
                      </a:cxn>
                      <a:cxn ang="0">
                        <a:pos x="277" y="61"/>
                      </a:cxn>
                      <a:cxn ang="0">
                        <a:pos x="269" y="36"/>
                      </a:cxn>
                      <a:cxn ang="0">
                        <a:pos x="277" y="11"/>
                      </a:cxn>
                      <a:cxn ang="0">
                        <a:pos x="261" y="0"/>
                      </a:cxn>
                    </a:cxnLst>
                    <a:rect l="0" t="0" r="r" b="b"/>
                    <a:pathLst>
                      <a:path w="300" h="405">
                        <a:moveTo>
                          <a:pt x="261" y="0"/>
                        </a:moveTo>
                        <a:cubicBezTo>
                          <a:pt x="253" y="10"/>
                          <a:pt x="253" y="10"/>
                          <a:pt x="253" y="10"/>
                        </a:cubicBezTo>
                        <a:cubicBezTo>
                          <a:pt x="223" y="15"/>
                          <a:pt x="223" y="15"/>
                          <a:pt x="223" y="15"/>
                        </a:cubicBezTo>
                        <a:cubicBezTo>
                          <a:pt x="217" y="27"/>
                          <a:pt x="217" y="27"/>
                          <a:pt x="217" y="27"/>
                        </a:cubicBezTo>
                        <a:cubicBezTo>
                          <a:pt x="200" y="33"/>
                          <a:pt x="200" y="33"/>
                          <a:pt x="200" y="33"/>
                        </a:cubicBezTo>
                        <a:cubicBezTo>
                          <a:pt x="185" y="20"/>
                          <a:pt x="185" y="20"/>
                          <a:pt x="185" y="20"/>
                        </a:cubicBezTo>
                        <a:cubicBezTo>
                          <a:pt x="180" y="44"/>
                          <a:pt x="180" y="44"/>
                          <a:pt x="180" y="44"/>
                        </a:cubicBezTo>
                        <a:cubicBezTo>
                          <a:pt x="161" y="49"/>
                          <a:pt x="161" y="49"/>
                          <a:pt x="161" y="49"/>
                        </a:cubicBezTo>
                        <a:cubicBezTo>
                          <a:pt x="117" y="46"/>
                          <a:pt x="117" y="46"/>
                          <a:pt x="117" y="46"/>
                        </a:cubicBezTo>
                        <a:cubicBezTo>
                          <a:pt x="117" y="46"/>
                          <a:pt x="110" y="41"/>
                          <a:pt x="104" y="36"/>
                        </a:cubicBezTo>
                        <a:cubicBezTo>
                          <a:pt x="106" y="42"/>
                          <a:pt x="106" y="42"/>
                          <a:pt x="106" y="42"/>
                        </a:cubicBezTo>
                        <a:cubicBezTo>
                          <a:pt x="72" y="58"/>
                          <a:pt x="72" y="58"/>
                          <a:pt x="72" y="58"/>
                        </a:cubicBezTo>
                        <a:cubicBezTo>
                          <a:pt x="56" y="75"/>
                          <a:pt x="56" y="75"/>
                          <a:pt x="56" y="75"/>
                        </a:cubicBezTo>
                        <a:cubicBezTo>
                          <a:pt x="33" y="77"/>
                          <a:pt x="33" y="77"/>
                          <a:pt x="33" y="77"/>
                        </a:cubicBezTo>
                        <a:cubicBezTo>
                          <a:pt x="17" y="65"/>
                          <a:pt x="17" y="65"/>
                          <a:pt x="17" y="65"/>
                        </a:cubicBezTo>
                        <a:cubicBezTo>
                          <a:pt x="6" y="72"/>
                          <a:pt x="6" y="72"/>
                          <a:pt x="6" y="72"/>
                        </a:cubicBezTo>
                        <a:cubicBezTo>
                          <a:pt x="0" y="99"/>
                          <a:pt x="0" y="99"/>
                          <a:pt x="0" y="99"/>
                        </a:cubicBezTo>
                        <a:cubicBezTo>
                          <a:pt x="9" y="142"/>
                          <a:pt x="9" y="142"/>
                          <a:pt x="9" y="142"/>
                        </a:cubicBezTo>
                        <a:cubicBezTo>
                          <a:pt x="25" y="158"/>
                          <a:pt x="25" y="158"/>
                          <a:pt x="25" y="158"/>
                        </a:cubicBezTo>
                        <a:cubicBezTo>
                          <a:pt x="30" y="186"/>
                          <a:pt x="30" y="186"/>
                          <a:pt x="30" y="186"/>
                        </a:cubicBezTo>
                        <a:cubicBezTo>
                          <a:pt x="30" y="230"/>
                          <a:pt x="30" y="230"/>
                          <a:pt x="30" y="230"/>
                        </a:cubicBezTo>
                        <a:cubicBezTo>
                          <a:pt x="30" y="230"/>
                          <a:pt x="22" y="260"/>
                          <a:pt x="26" y="260"/>
                        </a:cubicBezTo>
                        <a:cubicBezTo>
                          <a:pt x="31" y="260"/>
                          <a:pt x="47" y="270"/>
                          <a:pt x="47" y="270"/>
                        </a:cubicBezTo>
                        <a:cubicBezTo>
                          <a:pt x="85" y="277"/>
                          <a:pt x="85" y="277"/>
                          <a:pt x="85" y="277"/>
                        </a:cubicBezTo>
                        <a:cubicBezTo>
                          <a:pt x="109" y="277"/>
                          <a:pt x="109" y="277"/>
                          <a:pt x="109" y="277"/>
                        </a:cubicBezTo>
                        <a:cubicBezTo>
                          <a:pt x="119" y="294"/>
                          <a:pt x="119" y="294"/>
                          <a:pt x="119" y="294"/>
                        </a:cubicBezTo>
                        <a:cubicBezTo>
                          <a:pt x="135" y="298"/>
                          <a:pt x="135" y="298"/>
                          <a:pt x="135" y="298"/>
                        </a:cubicBezTo>
                        <a:cubicBezTo>
                          <a:pt x="149" y="303"/>
                          <a:pt x="149" y="303"/>
                          <a:pt x="149" y="303"/>
                        </a:cubicBezTo>
                        <a:cubicBezTo>
                          <a:pt x="158" y="297"/>
                          <a:pt x="158" y="297"/>
                          <a:pt x="158" y="297"/>
                        </a:cubicBezTo>
                        <a:cubicBezTo>
                          <a:pt x="190" y="321"/>
                          <a:pt x="190" y="321"/>
                          <a:pt x="190" y="321"/>
                        </a:cubicBezTo>
                        <a:cubicBezTo>
                          <a:pt x="202" y="342"/>
                          <a:pt x="202" y="342"/>
                          <a:pt x="202" y="342"/>
                        </a:cubicBezTo>
                        <a:cubicBezTo>
                          <a:pt x="225" y="402"/>
                          <a:pt x="225" y="402"/>
                          <a:pt x="225" y="402"/>
                        </a:cubicBezTo>
                        <a:cubicBezTo>
                          <a:pt x="226" y="403"/>
                          <a:pt x="226" y="403"/>
                          <a:pt x="226" y="403"/>
                        </a:cubicBezTo>
                        <a:cubicBezTo>
                          <a:pt x="296" y="405"/>
                          <a:pt x="296" y="405"/>
                          <a:pt x="296" y="405"/>
                        </a:cubicBezTo>
                        <a:cubicBezTo>
                          <a:pt x="296" y="362"/>
                          <a:pt x="296" y="362"/>
                          <a:pt x="296" y="362"/>
                        </a:cubicBezTo>
                        <a:cubicBezTo>
                          <a:pt x="300" y="326"/>
                          <a:pt x="300" y="326"/>
                          <a:pt x="300" y="326"/>
                        </a:cubicBezTo>
                        <a:cubicBezTo>
                          <a:pt x="295" y="290"/>
                          <a:pt x="295" y="290"/>
                          <a:pt x="295" y="290"/>
                        </a:cubicBezTo>
                        <a:cubicBezTo>
                          <a:pt x="284" y="275"/>
                          <a:pt x="284" y="275"/>
                          <a:pt x="284" y="275"/>
                        </a:cubicBezTo>
                        <a:cubicBezTo>
                          <a:pt x="283" y="251"/>
                          <a:pt x="283" y="251"/>
                          <a:pt x="283" y="251"/>
                        </a:cubicBezTo>
                        <a:cubicBezTo>
                          <a:pt x="280" y="191"/>
                          <a:pt x="280" y="191"/>
                          <a:pt x="280" y="191"/>
                        </a:cubicBezTo>
                        <a:cubicBezTo>
                          <a:pt x="284" y="165"/>
                          <a:pt x="284" y="165"/>
                          <a:pt x="284" y="165"/>
                        </a:cubicBezTo>
                        <a:cubicBezTo>
                          <a:pt x="275" y="166"/>
                          <a:pt x="275" y="166"/>
                          <a:pt x="275" y="166"/>
                        </a:cubicBezTo>
                        <a:cubicBezTo>
                          <a:pt x="257" y="144"/>
                          <a:pt x="257" y="144"/>
                          <a:pt x="257" y="144"/>
                        </a:cubicBezTo>
                        <a:cubicBezTo>
                          <a:pt x="258" y="131"/>
                          <a:pt x="258" y="131"/>
                          <a:pt x="258" y="131"/>
                        </a:cubicBezTo>
                        <a:cubicBezTo>
                          <a:pt x="245" y="124"/>
                          <a:pt x="245" y="124"/>
                          <a:pt x="245" y="124"/>
                        </a:cubicBezTo>
                        <a:cubicBezTo>
                          <a:pt x="240" y="107"/>
                          <a:pt x="240" y="107"/>
                          <a:pt x="240" y="107"/>
                        </a:cubicBezTo>
                        <a:cubicBezTo>
                          <a:pt x="240" y="91"/>
                          <a:pt x="240" y="91"/>
                          <a:pt x="240" y="91"/>
                        </a:cubicBezTo>
                        <a:cubicBezTo>
                          <a:pt x="250" y="80"/>
                          <a:pt x="250" y="80"/>
                          <a:pt x="250" y="80"/>
                        </a:cubicBezTo>
                        <a:cubicBezTo>
                          <a:pt x="264" y="79"/>
                          <a:pt x="264" y="79"/>
                          <a:pt x="264" y="79"/>
                        </a:cubicBezTo>
                        <a:cubicBezTo>
                          <a:pt x="277" y="61"/>
                          <a:pt x="277" y="61"/>
                          <a:pt x="277" y="61"/>
                        </a:cubicBezTo>
                        <a:cubicBezTo>
                          <a:pt x="269" y="36"/>
                          <a:pt x="269" y="36"/>
                          <a:pt x="269" y="36"/>
                        </a:cubicBezTo>
                        <a:cubicBezTo>
                          <a:pt x="277" y="11"/>
                          <a:pt x="277" y="11"/>
                          <a:pt x="277" y="11"/>
                        </a:cubicBezTo>
                        <a:lnTo>
                          <a:pt x="261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3" name="Freeform 11"/>
                  <p:cNvSpPr>
                    <a:spLocks/>
                  </p:cNvSpPr>
                  <p:nvPr/>
                </p:nvSpPr>
                <p:spPr bwMode="auto">
                  <a:xfrm>
                    <a:off x="3653088" y="4582344"/>
                    <a:ext cx="1074731" cy="1234125"/>
                  </a:xfrm>
                  <a:custGeom>
                    <a:avLst/>
                    <a:gdLst/>
                    <a:ahLst/>
                    <a:cxnLst>
                      <a:cxn ang="0">
                        <a:pos x="200" y="10"/>
                      </a:cxn>
                      <a:cxn ang="0">
                        <a:pos x="217" y="33"/>
                      </a:cxn>
                      <a:cxn ang="0">
                        <a:pos x="220" y="65"/>
                      </a:cxn>
                      <a:cxn ang="0">
                        <a:pos x="206" y="100"/>
                      </a:cxn>
                      <a:cxn ang="0">
                        <a:pos x="200" y="140"/>
                      </a:cxn>
                      <a:cxn ang="0">
                        <a:pos x="183" y="162"/>
                      </a:cxn>
                      <a:cxn ang="0">
                        <a:pos x="170" y="204"/>
                      </a:cxn>
                      <a:cxn ang="0">
                        <a:pos x="150" y="212"/>
                      </a:cxn>
                      <a:cxn ang="0">
                        <a:pos x="115" y="228"/>
                      </a:cxn>
                      <a:cxn ang="0">
                        <a:pos x="98" y="249"/>
                      </a:cxn>
                      <a:cxn ang="0">
                        <a:pos x="71" y="237"/>
                      </a:cxn>
                      <a:cxn ang="0">
                        <a:pos x="0" y="223"/>
                      </a:cxn>
                      <a:cxn ang="0">
                        <a:pos x="74" y="274"/>
                      </a:cxn>
                      <a:cxn ang="0">
                        <a:pos x="61" y="373"/>
                      </a:cxn>
                      <a:cxn ang="0">
                        <a:pos x="35" y="440"/>
                      </a:cxn>
                      <a:cxn ang="0">
                        <a:pos x="66" y="495"/>
                      </a:cxn>
                      <a:cxn ang="0">
                        <a:pos x="49" y="544"/>
                      </a:cxn>
                      <a:cxn ang="0">
                        <a:pos x="216" y="587"/>
                      </a:cxn>
                      <a:cxn ang="0">
                        <a:pos x="217" y="586"/>
                      </a:cxn>
                      <a:cxn ang="0">
                        <a:pos x="517" y="593"/>
                      </a:cxn>
                      <a:cxn ang="0">
                        <a:pos x="482" y="512"/>
                      </a:cxn>
                      <a:cxn ang="0">
                        <a:pos x="441" y="494"/>
                      </a:cxn>
                      <a:cxn ang="0">
                        <a:pos x="411" y="485"/>
                      </a:cxn>
                      <a:cxn ang="0">
                        <a:pos x="377" y="468"/>
                      </a:cxn>
                      <a:cxn ang="0">
                        <a:pos x="318" y="451"/>
                      </a:cxn>
                      <a:cxn ang="0">
                        <a:pos x="322" y="377"/>
                      </a:cxn>
                      <a:cxn ang="0">
                        <a:pos x="301" y="333"/>
                      </a:cxn>
                      <a:cxn ang="0">
                        <a:pos x="298" y="263"/>
                      </a:cxn>
                      <a:cxn ang="0">
                        <a:pos x="325" y="268"/>
                      </a:cxn>
                      <a:cxn ang="0">
                        <a:pos x="364" y="249"/>
                      </a:cxn>
                      <a:cxn ang="0">
                        <a:pos x="389" y="204"/>
                      </a:cxn>
                      <a:cxn ang="0">
                        <a:pos x="350" y="162"/>
                      </a:cxn>
                      <a:cxn ang="0">
                        <a:pos x="349" y="113"/>
                      </a:cxn>
                      <a:cxn ang="0">
                        <a:pos x="408" y="122"/>
                      </a:cxn>
                      <a:cxn ang="0">
                        <a:pos x="421" y="69"/>
                      </a:cxn>
                      <a:cxn ang="0">
                        <a:pos x="375" y="50"/>
                      </a:cxn>
                      <a:cxn ang="0">
                        <a:pos x="326" y="39"/>
                      </a:cxn>
                      <a:cxn ang="0">
                        <a:pos x="273" y="25"/>
                      </a:cxn>
                      <a:cxn ang="0">
                        <a:pos x="207" y="0"/>
                      </a:cxn>
                    </a:cxnLst>
                    <a:rect l="0" t="0" r="r" b="b"/>
                    <a:pathLst>
                      <a:path w="518" h="594">
                        <a:moveTo>
                          <a:pt x="207" y="0"/>
                        </a:moveTo>
                        <a:cubicBezTo>
                          <a:pt x="200" y="10"/>
                          <a:pt x="200" y="10"/>
                          <a:pt x="200" y="10"/>
                        </a:cubicBezTo>
                        <a:cubicBezTo>
                          <a:pt x="216" y="25"/>
                          <a:pt x="216" y="25"/>
                          <a:pt x="216" y="25"/>
                        </a:cubicBezTo>
                        <a:cubicBezTo>
                          <a:pt x="217" y="33"/>
                          <a:pt x="217" y="33"/>
                          <a:pt x="217" y="33"/>
                        </a:cubicBezTo>
                        <a:cubicBezTo>
                          <a:pt x="226" y="51"/>
                          <a:pt x="226" y="51"/>
                          <a:pt x="226" y="51"/>
                        </a:cubicBezTo>
                        <a:cubicBezTo>
                          <a:pt x="220" y="65"/>
                          <a:pt x="220" y="65"/>
                          <a:pt x="220" y="65"/>
                        </a:cubicBezTo>
                        <a:cubicBezTo>
                          <a:pt x="222" y="94"/>
                          <a:pt x="222" y="94"/>
                          <a:pt x="222" y="94"/>
                        </a:cubicBezTo>
                        <a:cubicBezTo>
                          <a:pt x="206" y="100"/>
                          <a:pt x="206" y="100"/>
                          <a:pt x="206" y="100"/>
                        </a:cubicBezTo>
                        <a:cubicBezTo>
                          <a:pt x="199" y="124"/>
                          <a:pt x="199" y="124"/>
                          <a:pt x="199" y="124"/>
                        </a:cubicBezTo>
                        <a:cubicBezTo>
                          <a:pt x="200" y="140"/>
                          <a:pt x="200" y="140"/>
                          <a:pt x="200" y="140"/>
                        </a:cubicBezTo>
                        <a:cubicBezTo>
                          <a:pt x="194" y="156"/>
                          <a:pt x="194" y="156"/>
                          <a:pt x="194" y="156"/>
                        </a:cubicBezTo>
                        <a:cubicBezTo>
                          <a:pt x="183" y="162"/>
                          <a:pt x="183" y="162"/>
                          <a:pt x="183" y="162"/>
                        </a:cubicBezTo>
                        <a:cubicBezTo>
                          <a:pt x="171" y="154"/>
                          <a:pt x="171" y="154"/>
                          <a:pt x="171" y="154"/>
                        </a:cubicBezTo>
                        <a:cubicBezTo>
                          <a:pt x="170" y="204"/>
                          <a:pt x="170" y="204"/>
                          <a:pt x="170" y="204"/>
                        </a:cubicBezTo>
                        <a:cubicBezTo>
                          <a:pt x="151" y="204"/>
                          <a:pt x="151" y="204"/>
                          <a:pt x="151" y="204"/>
                        </a:cubicBezTo>
                        <a:cubicBezTo>
                          <a:pt x="150" y="212"/>
                          <a:pt x="150" y="212"/>
                          <a:pt x="150" y="212"/>
                        </a:cubicBezTo>
                        <a:cubicBezTo>
                          <a:pt x="132" y="216"/>
                          <a:pt x="132" y="216"/>
                          <a:pt x="132" y="216"/>
                        </a:cubicBezTo>
                        <a:cubicBezTo>
                          <a:pt x="115" y="228"/>
                          <a:pt x="115" y="228"/>
                          <a:pt x="115" y="228"/>
                        </a:cubicBezTo>
                        <a:cubicBezTo>
                          <a:pt x="109" y="244"/>
                          <a:pt x="109" y="244"/>
                          <a:pt x="109" y="244"/>
                        </a:cubicBezTo>
                        <a:cubicBezTo>
                          <a:pt x="98" y="249"/>
                          <a:pt x="98" y="249"/>
                          <a:pt x="98" y="249"/>
                        </a:cubicBezTo>
                        <a:cubicBezTo>
                          <a:pt x="84" y="251"/>
                          <a:pt x="84" y="251"/>
                          <a:pt x="84" y="251"/>
                        </a:cubicBezTo>
                        <a:cubicBezTo>
                          <a:pt x="71" y="237"/>
                          <a:pt x="71" y="237"/>
                          <a:pt x="71" y="237"/>
                        </a:cubicBezTo>
                        <a:cubicBezTo>
                          <a:pt x="72" y="222"/>
                          <a:pt x="72" y="222"/>
                          <a:pt x="72" y="222"/>
                        </a:cubicBezTo>
                        <a:cubicBezTo>
                          <a:pt x="0" y="223"/>
                          <a:pt x="0" y="223"/>
                          <a:pt x="0" y="223"/>
                        </a:cubicBezTo>
                        <a:cubicBezTo>
                          <a:pt x="29" y="276"/>
                          <a:pt x="29" y="276"/>
                          <a:pt x="29" y="276"/>
                        </a:cubicBezTo>
                        <a:cubicBezTo>
                          <a:pt x="74" y="274"/>
                          <a:pt x="74" y="274"/>
                          <a:pt x="74" y="274"/>
                        </a:cubicBezTo>
                        <a:cubicBezTo>
                          <a:pt x="74" y="331"/>
                          <a:pt x="74" y="331"/>
                          <a:pt x="74" y="331"/>
                        </a:cubicBezTo>
                        <a:cubicBezTo>
                          <a:pt x="61" y="373"/>
                          <a:pt x="61" y="373"/>
                          <a:pt x="61" y="373"/>
                        </a:cubicBezTo>
                        <a:cubicBezTo>
                          <a:pt x="39" y="404"/>
                          <a:pt x="39" y="404"/>
                          <a:pt x="39" y="404"/>
                        </a:cubicBezTo>
                        <a:cubicBezTo>
                          <a:pt x="35" y="440"/>
                          <a:pt x="35" y="440"/>
                          <a:pt x="35" y="440"/>
                        </a:cubicBezTo>
                        <a:cubicBezTo>
                          <a:pt x="60" y="470"/>
                          <a:pt x="60" y="470"/>
                          <a:pt x="60" y="470"/>
                        </a:cubicBezTo>
                        <a:cubicBezTo>
                          <a:pt x="66" y="495"/>
                          <a:pt x="66" y="495"/>
                          <a:pt x="66" y="495"/>
                        </a:cubicBezTo>
                        <a:cubicBezTo>
                          <a:pt x="60" y="521"/>
                          <a:pt x="60" y="521"/>
                          <a:pt x="60" y="521"/>
                        </a:cubicBezTo>
                        <a:cubicBezTo>
                          <a:pt x="49" y="544"/>
                          <a:pt x="49" y="544"/>
                          <a:pt x="49" y="544"/>
                        </a:cubicBezTo>
                        <a:cubicBezTo>
                          <a:pt x="74" y="587"/>
                          <a:pt x="74" y="587"/>
                          <a:pt x="74" y="587"/>
                        </a:cubicBezTo>
                        <a:cubicBezTo>
                          <a:pt x="216" y="587"/>
                          <a:pt x="216" y="587"/>
                          <a:pt x="216" y="587"/>
                        </a:cubicBezTo>
                        <a:cubicBezTo>
                          <a:pt x="216" y="587"/>
                          <a:pt x="216" y="587"/>
                          <a:pt x="216" y="587"/>
                        </a:cubicBezTo>
                        <a:cubicBezTo>
                          <a:pt x="217" y="586"/>
                          <a:pt x="217" y="586"/>
                          <a:pt x="217" y="586"/>
                        </a:cubicBezTo>
                        <a:cubicBezTo>
                          <a:pt x="518" y="594"/>
                          <a:pt x="518" y="594"/>
                          <a:pt x="518" y="594"/>
                        </a:cubicBezTo>
                        <a:cubicBezTo>
                          <a:pt x="517" y="593"/>
                          <a:pt x="517" y="593"/>
                          <a:pt x="517" y="593"/>
                        </a:cubicBezTo>
                        <a:cubicBezTo>
                          <a:pt x="494" y="533"/>
                          <a:pt x="494" y="533"/>
                          <a:pt x="494" y="533"/>
                        </a:cubicBezTo>
                        <a:cubicBezTo>
                          <a:pt x="482" y="512"/>
                          <a:pt x="482" y="512"/>
                          <a:pt x="482" y="512"/>
                        </a:cubicBezTo>
                        <a:cubicBezTo>
                          <a:pt x="450" y="488"/>
                          <a:pt x="450" y="488"/>
                          <a:pt x="450" y="488"/>
                        </a:cubicBezTo>
                        <a:cubicBezTo>
                          <a:pt x="441" y="494"/>
                          <a:pt x="441" y="494"/>
                          <a:pt x="441" y="494"/>
                        </a:cubicBezTo>
                        <a:cubicBezTo>
                          <a:pt x="427" y="489"/>
                          <a:pt x="427" y="489"/>
                          <a:pt x="427" y="489"/>
                        </a:cubicBezTo>
                        <a:cubicBezTo>
                          <a:pt x="411" y="485"/>
                          <a:pt x="411" y="485"/>
                          <a:pt x="411" y="485"/>
                        </a:cubicBezTo>
                        <a:cubicBezTo>
                          <a:pt x="401" y="468"/>
                          <a:pt x="401" y="468"/>
                          <a:pt x="401" y="468"/>
                        </a:cubicBezTo>
                        <a:cubicBezTo>
                          <a:pt x="377" y="468"/>
                          <a:pt x="377" y="468"/>
                          <a:pt x="377" y="468"/>
                        </a:cubicBezTo>
                        <a:cubicBezTo>
                          <a:pt x="339" y="461"/>
                          <a:pt x="339" y="461"/>
                          <a:pt x="339" y="461"/>
                        </a:cubicBezTo>
                        <a:cubicBezTo>
                          <a:pt x="339" y="461"/>
                          <a:pt x="323" y="451"/>
                          <a:pt x="318" y="451"/>
                        </a:cubicBezTo>
                        <a:cubicBezTo>
                          <a:pt x="314" y="451"/>
                          <a:pt x="322" y="421"/>
                          <a:pt x="322" y="421"/>
                        </a:cubicBezTo>
                        <a:cubicBezTo>
                          <a:pt x="322" y="377"/>
                          <a:pt x="322" y="377"/>
                          <a:pt x="322" y="377"/>
                        </a:cubicBezTo>
                        <a:cubicBezTo>
                          <a:pt x="317" y="349"/>
                          <a:pt x="317" y="349"/>
                          <a:pt x="317" y="349"/>
                        </a:cubicBezTo>
                        <a:cubicBezTo>
                          <a:pt x="301" y="333"/>
                          <a:pt x="301" y="333"/>
                          <a:pt x="301" y="333"/>
                        </a:cubicBezTo>
                        <a:cubicBezTo>
                          <a:pt x="292" y="290"/>
                          <a:pt x="292" y="290"/>
                          <a:pt x="292" y="290"/>
                        </a:cubicBezTo>
                        <a:cubicBezTo>
                          <a:pt x="298" y="263"/>
                          <a:pt x="298" y="263"/>
                          <a:pt x="298" y="263"/>
                        </a:cubicBezTo>
                        <a:cubicBezTo>
                          <a:pt x="309" y="256"/>
                          <a:pt x="309" y="256"/>
                          <a:pt x="309" y="256"/>
                        </a:cubicBezTo>
                        <a:cubicBezTo>
                          <a:pt x="325" y="268"/>
                          <a:pt x="325" y="268"/>
                          <a:pt x="325" y="268"/>
                        </a:cubicBezTo>
                        <a:cubicBezTo>
                          <a:pt x="348" y="266"/>
                          <a:pt x="348" y="266"/>
                          <a:pt x="348" y="266"/>
                        </a:cubicBezTo>
                        <a:cubicBezTo>
                          <a:pt x="364" y="249"/>
                          <a:pt x="364" y="249"/>
                          <a:pt x="364" y="249"/>
                        </a:cubicBezTo>
                        <a:cubicBezTo>
                          <a:pt x="398" y="233"/>
                          <a:pt x="398" y="233"/>
                          <a:pt x="398" y="233"/>
                        </a:cubicBezTo>
                        <a:cubicBezTo>
                          <a:pt x="389" y="204"/>
                          <a:pt x="389" y="204"/>
                          <a:pt x="389" y="204"/>
                        </a:cubicBezTo>
                        <a:cubicBezTo>
                          <a:pt x="370" y="188"/>
                          <a:pt x="370" y="188"/>
                          <a:pt x="370" y="188"/>
                        </a:cubicBezTo>
                        <a:cubicBezTo>
                          <a:pt x="350" y="162"/>
                          <a:pt x="350" y="162"/>
                          <a:pt x="350" y="162"/>
                        </a:cubicBezTo>
                        <a:cubicBezTo>
                          <a:pt x="346" y="133"/>
                          <a:pt x="346" y="133"/>
                          <a:pt x="346" y="133"/>
                        </a:cubicBezTo>
                        <a:cubicBezTo>
                          <a:pt x="349" y="113"/>
                          <a:pt x="349" y="113"/>
                          <a:pt x="349" y="113"/>
                        </a:cubicBezTo>
                        <a:cubicBezTo>
                          <a:pt x="379" y="105"/>
                          <a:pt x="379" y="105"/>
                          <a:pt x="379" y="105"/>
                        </a:cubicBezTo>
                        <a:cubicBezTo>
                          <a:pt x="408" y="122"/>
                          <a:pt x="408" y="122"/>
                          <a:pt x="408" y="122"/>
                        </a:cubicBezTo>
                        <a:cubicBezTo>
                          <a:pt x="419" y="101"/>
                          <a:pt x="419" y="101"/>
                          <a:pt x="419" y="101"/>
                        </a:cubicBezTo>
                        <a:cubicBezTo>
                          <a:pt x="421" y="69"/>
                          <a:pt x="421" y="69"/>
                          <a:pt x="421" y="69"/>
                        </a:cubicBezTo>
                        <a:cubicBezTo>
                          <a:pt x="394" y="61"/>
                          <a:pt x="394" y="61"/>
                          <a:pt x="394" y="61"/>
                        </a:cubicBezTo>
                        <a:cubicBezTo>
                          <a:pt x="375" y="50"/>
                          <a:pt x="375" y="50"/>
                          <a:pt x="375" y="50"/>
                        </a:cubicBezTo>
                        <a:cubicBezTo>
                          <a:pt x="344" y="50"/>
                          <a:pt x="344" y="50"/>
                          <a:pt x="344" y="50"/>
                        </a:cubicBezTo>
                        <a:cubicBezTo>
                          <a:pt x="326" y="39"/>
                          <a:pt x="326" y="39"/>
                          <a:pt x="326" y="39"/>
                        </a:cubicBezTo>
                        <a:cubicBezTo>
                          <a:pt x="288" y="12"/>
                          <a:pt x="288" y="12"/>
                          <a:pt x="288" y="12"/>
                        </a:cubicBezTo>
                        <a:cubicBezTo>
                          <a:pt x="273" y="25"/>
                          <a:pt x="273" y="25"/>
                          <a:pt x="273" y="25"/>
                        </a:cubicBezTo>
                        <a:cubicBezTo>
                          <a:pt x="242" y="35"/>
                          <a:pt x="242" y="35"/>
                          <a:pt x="242" y="35"/>
                        </a:cubicBezTo>
                        <a:lnTo>
                          <a:pt x="207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4" name="Freeform 12"/>
                  <p:cNvSpPr>
                    <a:spLocks/>
                  </p:cNvSpPr>
                  <p:nvPr/>
                </p:nvSpPr>
                <p:spPr bwMode="auto">
                  <a:xfrm>
                    <a:off x="4371154" y="4328260"/>
                    <a:ext cx="658095" cy="752784"/>
                  </a:xfrm>
                  <a:custGeom>
                    <a:avLst/>
                    <a:gdLst/>
                    <a:ahLst/>
                    <a:cxnLst>
                      <a:cxn ang="0">
                        <a:pos x="285" y="8"/>
                      </a:cxn>
                      <a:cxn ang="0">
                        <a:pos x="268" y="17"/>
                      </a:cxn>
                      <a:cxn ang="0">
                        <a:pos x="240" y="23"/>
                      </a:cxn>
                      <a:cxn ang="0">
                        <a:pos x="247" y="36"/>
                      </a:cxn>
                      <a:cxn ang="0">
                        <a:pos x="229" y="37"/>
                      </a:cxn>
                      <a:cxn ang="0">
                        <a:pos x="198" y="41"/>
                      </a:cxn>
                      <a:cxn ang="0">
                        <a:pos x="143" y="44"/>
                      </a:cxn>
                      <a:cxn ang="0">
                        <a:pos x="108" y="24"/>
                      </a:cxn>
                      <a:cxn ang="0">
                        <a:pos x="76" y="30"/>
                      </a:cxn>
                      <a:cxn ang="0">
                        <a:pos x="46" y="44"/>
                      </a:cxn>
                      <a:cxn ang="0">
                        <a:pos x="74" y="53"/>
                      </a:cxn>
                      <a:cxn ang="0">
                        <a:pos x="93" y="101"/>
                      </a:cxn>
                      <a:cxn ang="0">
                        <a:pos x="71" y="153"/>
                      </a:cxn>
                      <a:cxn ang="0">
                        <a:pos x="59" y="172"/>
                      </a:cxn>
                      <a:cxn ang="0">
                        <a:pos x="75" y="192"/>
                      </a:cxn>
                      <a:cxn ang="0">
                        <a:pos x="62" y="245"/>
                      </a:cxn>
                      <a:cxn ang="0">
                        <a:pos x="3" y="236"/>
                      </a:cxn>
                      <a:cxn ang="0">
                        <a:pos x="4" y="285"/>
                      </a:cxn>
                      <a:cxn ang="0">
                        <a:pos x="43" y="327"/>
                      </a:cxn>
                      <a:cxn ang="0">
                        <a:pos x="63" y="360"/>
                      </a:cxn>
                      <a:cxn ang="0">
                        <a:pos x="126" y="358"/>
                      </a:cxn>
                      <a:cxn ang="0">
                        <a:pos x="146" y="347"/>
                      </a:cxn>
                      <a:cxn ang="0">
                        <a:pos x="169" y="329"/>
                      </a:cxn>
                      <a:cxn ang="0">
                        <a:pos x="207" y="314"/>
                      </a:cxn>
                      <a:cxn ang="0">
                        <a:pos x="241" y="301"/>
                      </a:cxn>
                      <a:cxn ang="0">
                        <a:pos x="273" y="284"/>
                      </a:cxn>
                      <a:cxn ang="0">
                        <a:pos x="269" y="239"/>
                      </a:cxn>
                      <a:cxn ang="0">
                        <a:pos x="276" y="205"/>
                      </a:cxn>
                      <a:cxn ang="0">
                        <a:pos x="279" y="174"/>
                      </a:cxn>
                      <a:cxn ang="0">
                        <a:pos x="286" y="118"/>
                      </a:cxn>
                      <a:cxn ang="0">
                        <a:pos x="297" y="97"/>
                      </a:cxn>
                      <a:cxn ang="0">
                        <a:pos x="317" y="59"/>
                      </a:cxn>
                      <a:cxn ang="0">
                        <a:pos x="315" y="22"/>
                      </a:cxn>
                      <a:cxn ang="0">
                        <a:pos x="298" y="20"/>
                      </a:cxn>
                      <a:cxn ang="0">
                        <a:pos x="296" y="0"/>
                      </a:cxn>
                    </a:cxnLst>
                    <a:rect l="0" t="0" r="r" b="b"/>
                    <a:pathLst>
                      <a:path w="317" h="363">
                        <a:moveTo>
                          <a:pt x="296" y="0"/>
                        </a:moveTo>
                        <a:cubicBezTo>
                          <a:pt x="285" y="8"/>
                          <a:pt x="285" y="8"/>
                          <a:pt x="285" y="8"/>
                        </a:cubicBezTo>
                        <a:cubicBezTo>
                          <a:pt x="264" y="9"/>
                          <a:pt x="264" y="9"/>
                          <a:pt x="264" y="9"/>
                        </a:cubicBezTo>
                        <a:cubicBezTo>
                          <a:pt x="268" y="17"/>
                          <a:pt x="268" y="17"/>
                          <a:pt x="268" y="17"/>
                        </a:cubicBezTo>
                        <a:cubicBezTo>
                          <a:pt x="246" y="12"/>
                          <a:pt x="246" y="12"/>
                          <a:pt x="246" y="12"/>
                        </a:cubicBezTo>
                        <a:cubicBezTo>
                          <a:pt x="240" y="23"/>
                          <a:pt x="240" y="23"/>
                          <a:pt x="240" y="23"/>
                        </a:cubicBezTo>
                        <a:cubicBezTo>
                          <a:pt x="252" y="31"/>
                          <a:pt x="252" y="31"/>
                          <a:pt x="252" y="31"/>
                        </a:cubicBezTo>
                        <a:cubicBezTo>
                          <a:pt x="247" y="36"/>
                          <a:pt x="247" y="36"/>
                          <a:pt x="247" y="36"/>
                        </a:cubicBezTo>
                        <a:cubicBezTo>
                          <a:pt x="235" y="34"/>
                          <a:pt x="235" y="34"/>
                          <a:pt x="235" y="34"/>
                        </a:cubicBezTo>
                        <a:cubicBezTo>
                          <a:pt x="229" y="37"/>
                          <a:pt x="229" y="37"/>
                          <a:pt x="229" y="37"/>
                        </a:cubicBezTo>
                        <a:cubicBezTo>
                          <a:pt x="209" y="35"/>
                          <a:pt x="209" y="35"/>
                          <a:pt x="209" y="35"/>
                        </a:cubicBezTo>
                        <a:cubicBezTo>
                          <a:pt x="198" y="41"/>
                          <a:pt x="198" y="41"/>
                          <a:pt x="198" y="41"/>
                        </a:cubicBezTo>
                        <a:cubicBezTo>
                          <a:pt x="180" y="36"/>
                          <a:pt x="180" y="36"/>
                          <a:pt x="180" y="36"/>
                        </a:cubicBezTo>
                        <a:cubicBezTo>
                          <a:pt x="143" y="44"/>
                          <a:pt x="143" y="44"/>
                          <a:pt x="143" y="44"/>
                        </a:cubicBezTo>
                        <a:cubicBezTo>
                          <a:pt x="121" y="25"/>
                          <a:pt x="121" y="25"/>
                          <a:pt x="121" y="25"/>
                        </a:cubicBezTo>
                        <a:cubicBezTo>
                          <a:pt x="108" y="24"/>
                          <a:pt x="108" y="24"/>
                          <a:pt x="108" y="24"/>
                        </a:cubicBezTo>
                        <a:cubicBezTo>
                          <a:pt x="93" y="29"/>
                          <a:pt x="93" y="29"/>
                          <a:pt x="93" y="29"/>
                        </a:cubicBezTo>
                        <a:cubicBezTo>
                          <a:pt x="76" y="30"/>
                          <a:pt x="76" y="30"/>
                          <a:pt x="76" y="30"/>
                        </a:cubicBezTo>
                        <a:cubicBezTo>
                          <a:pt x="65" y="39"/>
                          <a:pt x="65" y="39"/>
                          <a:pt x="65" y="39"/>
                        </a:cubicBezTo>
                        <a:cubicBezTo>
                          <a:pt x="46" y="44"/>
                          <a:pt x="46" y="44"/>
                          <a:pt x="46" y="44"/>
                        </a:cubicBezTo>
                        <a:cubicBezTo>
                          <a:pt x="51" y="56"/>
                          <a:pt x="51" y="56"/>
                          <a:pt x="51" y="56"/>
                        </a:cubicBezTo>
                        <a:cubicBezTo>
                          <a:pt x="74" y="53"/>
                          <a:pt x="74" y="53"/>
                          <a:pt x="74" y="53"/>
                        </a:cubicBezTo>
                        <a:cubicBezTo>
                          <a:pt x="82" y="75"/>
                          <a:pt x="82" y="75"/>
                          <a:pt x="82" y="75"/>
                        </a:cubicBezTo>
                        <a:cubicBezTo>
                          <a:pt x="93" y="101"/>
                          <a:pt x="93" y="101"/>
                          <a:pt x="93" y="101"/>
                        </a:cubicBezTo>
                        <a:cubicBezTo>
                          <a:pt x="91" y="141"/>
                          <a:pt x="91" y="141"/>
                          <a:pt x="91" y="141"/>
                        </a:cubicBezTo>
                        <a:cubicBezTo>
                          <a:pt x="71" y="153"/>
                          <a:pt x="71" y="153"/>
                          <a:pt x="71" y="153"/>
                        </a:cubicBezTo>
                        <a:cubicBezTo>
                          <a:pt x="70" y="168"/>
                          <a:pt x="70" y="168"/>
                          <a:pt x="70" y="168"/>
                        </a:cubicBezTo>
                        <a:cubicBezTo>
                          <a:pt x="59" y="172"/>
                          <a:pt x="59" y="172"/>
                          <a:pt x="59" y="172"/>
                        </a:cubicBezTo>
                        <a:cubicBezTo>
                          <a:pt x="49" y="184"/>
                          <a:pt x="49" y="184"/>
                          <a:pt x="49" y="184"/>
                        </a:cubicBezTo>
                        <a:cubicBezTo>
                          <a:pt x="75" y="192"/>
                          <a:pt x="75" y="192"/>
                          <a:pt x="75" y="192"/>
                        </a:cubicBezTo>
                        <a:cubicBezTo>
                          <a:pt x="73" y="224"/>
                          <a:pt x="73" y="224"/>
                          <a:pt x="73" y="224"/>
                        </a:cubicBezTo>
                        <a:cubicBezTo>
                          <a:pt x="62" y="245"/>
                          <a:pt x="62" y="245"/>
                          <a:pt x="62" y="245"/>
                        </a:cubicBezTo>
                        <a:cubicBezTo>
                          <a:pt x="33" y="228"/>
                          <a:pt x="33" y="228"/>
                          <a:pt x="33" y="228"/>
                        </a:cubicBezTo>
                        <a:cubicBezTo>
                          <a:pt x="3" y="236"/>
                          <a:pt x="3" y="236"/>
                          <a:pt x="3" y="236"/>
                        </a:cubicBezTo>
                        <a:cubicBezTo>
                          <a:pt x="0" y="256"/>
                          <a:pt x="0" y="256"/>
                          <a:pt x="0" y="256"/>
                        </a:cubicBezTo>
                        <a:cubicBezTo>
                          <a:pt x="4" y="285"/>
                          <a:pt x="4" y="285"/>
                          <a:pt x="4" y="285"/>
                        </a:cubicBezTo>
                        <a:cubicBezTo>
                          <a:pt x="24" y="311"/>
                          <a:pt x="24" y="311"/>
                          <a:pt x="24" y="311"/>
                        </a:cubicBezTo>
                        <a:cubicBezTo>
                          <a:pt x="43" y="327"/>
                          <a:pt x="43" y="327"/>
                          <a:pt x="43" y="327"/>
                        </a:cubicBezTo>
                        <a:cubicBezTo>
                          <a:pt x="50" y="350"/>
                          <a:pt x="50" y="350"/>
                          <a:pt x="50" y="350"/>
                        </a:cubicBezTo>
                        <a:cubicBezTo>
                          <a:pt x="56" y="355"/>
                          <a:pt x="63" y="360"/>
                          <a:pt x="63" y="360"/>
                        </a:cubicBezTo>
                        <a:cubicBezTo>
                          <a:pt x="107" y="363"/>
                          <a:pt x="107" y="363"/>
                          <a:pt x="107" y="363"/>
                        </a:cubicBezTo>
                        <a:cubicBezTo>
                          <a:pt x="126" y="358"/>
                          <a:pt x="126" y="358"/>
                          <a:pt x="126" y="358"/>
                        </a:cubicBezTo>
                        <a:cubicBezTo>
                          <a:pt x="131" y="334"/>
                          <a:pt x="131" y="334"/>
                          <a:pt x="131" y="334"/>
                        </a:cubicBezTo>
                        <a:cubicBezTo>
                          <a:pt x="146" y="347"/>
                          <a:pt x="146" y="347"/>
                          <a:pt x="146" y="347"/>
                        </a:cubicBezTo>
                        <a:cubicBezTo>
                          <a:pt x="163" y="341"/>
                          <a:pt x="163" y="341"/>
                          <a:pt x="163" y="341"/>
                        </a:cubicBezTo>
                        <a:cubicBezTo>
                          <a:pt x="169" y="329"/>
                          <a:pt x="169" y="329"/>
                          <a:pt x="169" y="329"/>
                        </a:cubicBezTo>
                        <a:cubicBezTo>
                          <a:pt x="199" y="324"/>
                          <a:pt x="199" y="324"/>
                          <a:pt x="199" y="324"/>
                        </a:cubicBezTo>
                        <a:cubicBezTo>
                          <a:pt x="207" y="314"/>
                          <a:pt x="207" y="314"/>
                          <a:pt x="207" y="314"/>
                        </a:cubicBezTo>
                        <a:cubicBezTo>
                          <a:pt x="221" y="324"/>
                          <a:pt x="221" y="324"/>
                          <a:pt x="221" y="324"/>
                        </a:cubicBezTo>
                        <a:cubicBezTo>
                          <a:pt x="241" y="301"/>
                          <a:pt x="241" y="301"/>
                          <a:pt x="241" y="301"/>
                        </a:cubicBezTo>
                        <a:cubicBezTo>
                          <a:pt x="257" y="294"/>
                          <a:pt x="257" y="294"/>
                          <a:pt x="257" y="294"/>
                        </a:cubicBezTo>
                        <a:cubicBezTo>
                          <a:pt x="273" y="284"/>
                          <a:pt x="273" y="284"/>
                          <a:pt x="273" y="284"/>
                        </a:cubicBezTo>
                        <a:cubicBezTo>
                          <a:pt x="271" y="261"/>
                          <a:pt x="271" y="261"/>
                          <a:pt x="271" y="261"/>
                        </a:cubicBezTo>
                        <a:cubicBezTo>
                          <a:pt x="269" y="239"/>
                          <a:pt x="269" y="239"/>
                          <a:pt x="269" y="239"/>
                        </a:cubicBezTo>
                        <a:cubicBezTo>
                          <a:pt x="274" y="224"/>
                          <a:pt x="274" y="224"/>
                          <a:pt x="274" y="224"/>
                        </a:cubicBezTo>
                        <a:cubicBezTo>
                          <a:pt x="276" y="205"/>
                          <a:pt x="276" y="205"/>
                          <a:pt x="276" y="205"/>
                        </a:cubicBezTo>
                        <a:cubicBezTo>
                          <a:pt x="280" y="188"/>
                          <a:pt x="280" y="188"/>
                          <a:pt x="280" y="188"/>
                        </a:cubicBezTo>
                        <a:cubicBezTo>
                          <a:pt x="279" y="174"/>
                          <a:pt x="279" y="174"/>
                          <a:pt x="279" y="174"/>
                        </a:cubicBezTo>
                        <a:cubicBezTo>
                          <a:pt x="286" y="142"/>
                          <a:pt x="286" y="142"/>
                          <a:pt x="286" y="142"/>
                        </a:cubicBezTo>
                        <a:cubicBezTo>
                          <a:pt x="286" y="118"/>
                          <a:pt x="286" y="118"/>
                          <a:pt x="286" y="118"/>
                        </a:cubicBezTo>
                        <a:cubicBezTo>
                          <a:pt x="286" y="106"/>
                          <a:pt x="286" y="106"/>
                          <a:pt x="286" y="106"/>
                        </a:cubicBezTo>
                        <a:cubicBezTo>
                          <a:pt x="297" y="97"/>
                          <a:pt x="297" y="97"/>
                          <a:pt x="297" y="97"/>
                        </a:cubicBezTo>
                        <a:cubicBezTo>
                          <a:pt x="303" y="77"/>
                          <a:pt x="303" y="77"/>
                          <a:pt x="303" y="77"/>
                        </a:cubicBezTo>
                        <a:cubicBezTo>
                          <a:pt x="317" y="59"/>
                          <a:pt x="317" y="59"/>
                          <a:pt x="317" y="59"/>
                        </a:cubicBezTo>
                        <a:cubicBezTo>
                          <a:pt x="317" y="46"/>
                          <a:pt x="317" y="46"/>
                          <a:pt x="317" y="46"/>
                        </a:cubicBezTo>
                        <a:cubicBezTo>
                          <a:pt x="315" y="22"/>
                          <a:pt x="315" y="22"/>
                          <a:pt x="315" y="22"/>
                        </a:cubicBezTo>
                        <a:cubicBezTo>
                          <a:pt x="313" y="20"/>
                          <a:pt x="313" y="20"/>
                          <a:pt x="313" y="20"/>
                        </a:cubicBezTo>
                        <a:cubicBezTo>
                          <a:pt x="298" y="20"/>
                          <a:pt x="298" y="20"/>
                          <a:pt x="298" y="20"/>
                        </a:cubicBezTo>
                        <a:cubicBezTo>
                          <a:pt x="304" y="4"/>
                          <a:pt x="304" y="4"/>
                          <a:pt x="304" y="4"/>
                        </a:cubicBezTo>
                        <a:lnTo>
                          <a:pt x="296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5" name="Freeform 13"/>
                  <p:cNvSpPr>
                    <a:spLocks/>
                  </p:cNvSpPr>
                  <p:nvPr/>
                </p:nvSpPr>
                <p:spPr bwMode="auto">
                  <a:xfrm>
                    <a:off x="4385357" y="3652805"/>
                    <a:ext cx="967415" cy="766988"/>
                  </a:xfrm>
                  <a:custGeom>
                    <a:avLst/>
                    <a:gdLst/>
                    <a:ahLst/>
                    <a:cxnLst>
                      <a:cxn ang="0">
                        <a:pos x="368" y="1"/>
                      </a:cxn>
                      <a:cxn ang="0">
                        <a:pos x="346" y="23"/>
                      </a:cxn>
                      <a:cxn ang="0">
                        <a:pos x="341" y="61"/>
                      </a:cxn>
                      <a:cxn ang="0">
                        <a:pos x="320" y="67"/>
                      </a:cxn>
                      <a:cxn ang="0">
                        <a:pos x="319" y="100"/>
                      </a:cxn>
                      <a:cxn ang="0">
                        <a:pos x="317" y="143"/>
                      </a:cxn>
                      <a:cxn ang="0">
                        <a:pos x="294" y="165"/>
                      </a:cxn>
                      <a:cxn ang="0">
                        <a:pos x="270" y="176"/>
                      </a:cxn>
                      <a:cxn ang="0">
                        <a:pos x="249" y="176"/>
                      </a:cxn>
                      <a:cxn ang="0">
                        <a:pos x="255" y="144"/>
                      </a:cxn>
                      <a:cxn ang="0">
                        <a:pos x="234" y="149"/>
                      </a:cxn>
                      <a:cxn ang="0">
                        <a:pos x="189" y="159"/>
                      </a:cxn>
                      <a:cxn ang="0">
                        <a:pos x="152" y="160"/>
                      </a:cxn>
                      <a:cxn ang="0">
                        <a:pos x="112" y="154"/>
                      </a:cxn>
                      <a:cxn ang="0">
                        <a:pos x="106" y="216"/>
                      </a:cxn>
                      <a:cxn ang="0">
                        <a:pos x="66" y="227"/>
                      </a:cxn>
                      <a:cxn ang="0">
                        <a:pos x="48" y="223"/>
                      </a:cxn>
                      <a:cxn ang="0">
                        <a:pos x="20" y="229"/>
                      </a:cxn>
                      <a:cxn ang="0">
                        <a:pos x="25" y="260"/>
                      </a:cxn>
                      <a:cxn ang="0">
                        <a:pos x="0" y="255"/>
                      </a:cxn>
                      <a:cxn ang="0">
                        <a:pos x="33" y="290"/>
                      </a:cxn>
                      <a:cxn ang="0">
                        <a:pos x="58" y="332"/>
                      </a:cxn>
                      <a:cxn ang="0">
                        <a:pos x="66" y="357"/>
                      </a:cxn>
                      <a:cxn ang="0">
                        <a:pos x="86" y="354"/>
                      </a:cxn>
                      <a:cxn ang="0">
                        <a:pos x="114" y="350"/>
                      </a:cxn>
                      <a:cxn ang="0">
                        <a:pos x="173" y="361"/>
                      </a:cxn>
                      <a:cxn ang="0">
                        <a:pos x="202" y="360"/>
                      </a:cxn>
                      <a:cxn ang="0">
                        <a:pos x="228" y="359"/>
                      </a:cxn>
                      <a:cxn ang="0">
                        <a:pos x="245" y="356"/>
                      </a:cxn>
                      <a:cxn ang="0">
                        <a:pos x="239" y="337"/>
                      </a:cxn>
                      <a:cxn ang="0">
                        <a:pos x="257" y="334"/>
                      </a:cxn>
                      <a:cxn ang="0">
                        <a:pos x="289" y="325"/>
                      </a:cxn>
                      <a:cxn ang="0">
                        <a:pos x="291" y="345"/>
                      </a:cxn>
                      <a:cxn ang="0">
                        <a:pos x="308" y="347"/>
                      </a:cxn>
                      <a:cxn ang="0">
                        <a:pos x="330" y="337"/>
                      </a:cxn>
                      <a:cxn ang="0">
                        <a:pos x="351" y="304"/>
                      </a:cxn>
                      <a:cxn ang="0">
                        <a:pos x="370" y="300"/>
                      </a:cxn>
                      <a:cxn ang="0">
                        <a:pos x="360" y="293"/>
                      </a:cxn>
                      <a:cxn ang="0">
                        <a:pos x="370" y="275"/>
                      </a:cxn>
                      <a:cxn ang="0">
                        <a:pos x="384" y="254"/>
                      </a:cxn>
                      <a:cxn ang="0">
                        <a:pos x="427" y="212"/>
                      </a:cxn>
                      <a:cxn ang="0">
                        <a:pos x="446" y="202"/>
                      </a:cxn>
                      <a:cxn ang="0">
                        <a:pos x="466" y="183"/>
                      </a:cxn>
                      <a:cxn ang="0">
                        <a:pos x="458" y="170"/>
                      </a:cxn>
                      <a:cxn ang="0">
                        <a:pos x="429" y="154"/>
                      </a:cxn>
                      <a:cxn ang="0">
                        <a:pos x="413" y="157"/>
                      </a:cxn>
                      <a:cxn ang="0">
                        <a:pos x="410" y="126"/>
                      </a:cxn>
                      <a:cxn ang="0">
                        <a:pos x="406" y="84"/>
                      </a:cxn>
                      <a:cxn ang="0">
                        <a:pos x="421" y="45"/>
                      </a:cxn>
                      <a:cxn ang="0">
                        <a:pos x="416" y="26"/>
                      </a:cxn>
                      <a:cxn ang="0">
                        <a:pos x="400" y="7"/>
                      </a:cxn>
                      <a:cxn ang="0">
                        <a:pos x="382" y="0"/>
                      </a:cxn>
                    </a:cxnLst>
                    <a:rect l="0" t="0" r="r" b="b"/>
                    <a:pathLst>
                      <a:path w="466" h="369">
                        <a:moveTo>
                          <a:pt x="382" y="0"/>
                        </a:moveTo>
                        <a:cubicBezTo>
                          <a:pt x="368" y="1"/>
                          <a:pt x="368" y="1"/>
                          <a:pt x="368" y="1"/>
                        </a:cubicBezTo>
                        <a:cubicBezTo>
                          <a:pt x="349" y="7"/>
                          <a:pt x="349" y="7"/>
                          <a:pt x="349" y="7"/>
                        </a:cubicBezTo>
                        <a:cubicBezTo>
                          <a:pt x="346" y="23"/>
                          <a:pt x="346" y="23"/>
                          <a:pt x="346" y="23"/>
                        </a:cubicBezTo>
                        <a:cubicBezTo>
                          <a:pt x="341" y="45"/>
                          <a:pt x="341" y="45"/>
                          <a:pt x="341" y="45"/>
                        </a:cubicBezTo>
                        <a:cubicBezTo>
                          <a:pt x="341" y="61"/>
                          <a:pt x="341" y="61"/>
                          <a:pt x="341" y="61"/>
                        </a:cubicBezTo>
                        <a:cubicBezTo>
                          <a:pt x="338" y="66"/>
                          <a:pt x="338" y="66"/>
                          <a:pt x="338" y="66"/>
                        </a:cubicBezTo>
                        <a:cubicBezTo>
                          <a:pt x="320" y="67"/>
                          <a:pt x="320" y="67"/>
                          <a:pt x="320" y="67"/>
                        </a:cubicBezTo>
                        <a:cubicBezTo>
                          <a:pt x="313" y="76"/>
                          <a:pt x="313" y="76"/>
                          <a:pt x="313" y="76"/>
                        </a:cubicBezTo>
                        <a:cubicBezTo>
                          <a:pt x="319" y="100"/>
                          <a:pt x="319" y="100"/>
                          <a:pt x="319" y="100"/>
                        </a:cubicBezTo>
                        <a:cubicBezTo>
                          <a:pt x="317" y="136"/>
                          <a:pt x="317" y="136"/>
                          <a:pt x="317" y="136"/>
                        </a:cubicBezTo>
                        <a:cubicBezTo>
                          <a:pt x="317" y="143"/>
                          <a:pt x="317" y="143"/>
                          <a:pt x="317" y="143"/>
                        </a:cubicBezTo>
                        <a:cubicBezTo>
                          <a:pt x="318" y="155"/>
                          <a:pt x="318" y="155"/>
                          <a:pt x="318" y="155"/>
                        </a:cubicBezTo>
                        <a:cubicBezTo>
                          <a:pt x="294" y="165"/>
                          <a:pt x="294" y="165"/>
                          <a:pt x="294" y="165"/>
                        </a:cubicBezTo>
                        <a:cubicBezTo>
                          <a:pt x="284" y="184"/>
                          <a:pt x="284" y="184"/>
                          <a:pt x="284" y="184"/>
                        </a:cubicBezTo>
                        <a:cubicBezTo>
                          <a:pt x="270" y="176"/>
                          <a:pt x="270" y="176"/>
                          <a:pt x="270" y="176"/>
                        </a:cubicBezTo>
                        <a:cubicBezTo>
                          <a:pt x="262" y="178"/>
                          <a:pt x="262" y="178"/>
                          <a:pt x="262" y="178"/>
                        </a:cubicBezTo>
                        <a:cubicBezTo>
                          <a:pt x="249" y="176"/>
                          <a:pt x="249" y="176"/>
                          <a:pt x="249" y="176"/>
                        </a:cubicBezTo>
                        <a:cubicBezTo>
                          <a:pt x="244" y="164"/>
                          <a:pt x="244" y="164"/>
                          <a:pt x="244" y="164"/>
                        </a:cubicBezTo>
                        <a:cubicBezTo>
                          <a:pt x="255" y="144"/>
                          <a:pt x="255" y="144"/>
                          <a:pt x="255" y="144"/>
                        </a:cubicBezTo>
                        <a:cubicBezTo>
                          <a:pt x="249" y="134"/>
                          <a:pt x="249" y="134"/>
                          <a:pt x="249" y="134"/>
                        </a:cubicBezTo>
                        <a:cubicBezTo>
                          <a:pt x="234" y="149"/>
                          <a:pt x="234" y="149"/>
                          <a:pt x="234" y="149"/>
                        </a:cubicBezTo>
                        <a:cubicBezTo>
                          <a:pt x="218" y="143"/>
                          <a:pt x="218" y="143"/>
                          <a:pt x="218" y="143"/>
                        </a:cubicBezTo>
                        <a:cubicBezTo>
                          <a:pt x="189" y="159"/>
                          <a:pt x="189" y="159"/>
                          <a:pt x="189" y="159"/>
                        </a:cubicBezTo>
                        <a:cubicBezTo>
                          <a:pt x="157" y="155"/>
                          <a:pt x="157" y="155"/>
                          <a:pt x="157" y="155"/>
                        </a:cubicBezTo>
                        <a:cubicBezTo>
                          <a:pt x="152" y="160"/>
                          <a:pt x="152" y="160"/>
                          <a:pt x="152" y="160"/>
                        </a:cubicBezTo>
                        <a:cubicBezTo>
                          <a:pt x="125" y="157"/>
                          <a:pt x="125" y="157"/>
                          <a:pt x="125" y="157"/>
                        </a:cubicBezTo>
                        <a:cubicBezTo>
                          <a:pt x="112" y="154"/>
                          <a:pt x="112" y="154"/>
                          <a:pt x="112" y="154"/>
                        </a:cubicBezTo>
                        <a:cubicBezTo>
                          <a:pt x="103" y="190"/>
                          <a:pt x="103" y="190"/>
                          <a:pt x="103" y="190"/>
                        </a:cubicBezTo>
                        <a:cubicBezTo>
                          <a:pt x="106" y="216"/>
                          <a:pt x="106" y="216"/>
                          <a:pt x="106" y="216"/>
                        </a:cubicBezTo>
                        <a:cubicBezTo>
                          <a:pt x="96" y="226"/>
                          <a:pt x="96" y="226"/>
                          <a:pt x="96" y="226"/>
                        </a:cubicBezTo>
                        <a:cubicBezTo>
                          <a:pt x="66" y="227"/>
                          <a:pt x="66" y="227"/>
                          <a:pt x="66" y="227"/>
                        </a:cubicBezTo>
                        <a:cubicBezTo>
                          <a:pt x="59" y="234"/>
                          <a:pt x="59" y="234"/>
                          <a:pt x="59" y="234"/>
                        </a:cubicBezTo>
                        <a:cubicBezTo>
                          <a:pt x="48" y="223"/>
                          <a:pt x="48" y="223"/>
                          <a:pt x="48" y="223"/>
                        </a:cubicBezTo>
                        <a:cubicBezTo>
                          <a:pt x="25" y="225"/>
                          <a:pt x="25" y="225"/>
                          <a:pt x="25" y="225"/>
                        </a:cubicBezTo>
                        <a:cubicBezTo>
                          <a:pt x="20" y="229"/>
                          <a:pt x="20" y="229"/>
                          <a:pt x="20" y="229"/>
                        </a:cubicBezTo>
                        <a:cubicBezTo>
                          <a:pt x="33" y="255"/>
                          <a:pt x="33" y="255"/>
                          <a:pt x="33" y="255"/>
                        </a:cubicBezTo>
                        <a:cubicBezTo>
                          <a:pt x="25" y="260"/>
                          <a:pt x="25" y="260"/>
                          <a:pt x="25" y="260"/>
                        </a:cubicBezTo>
                        <a:cubicBezTo>
                          <a:pt x="2" y="254"/>
                          <a:pt x="2" y="254"/>
                          <a:pt x="2" y="254"/>
                        </a:cubicBezTo>
                        <a:cubicBezTo>
                          <a:pt x="2" y="254"/>
                          <a:pt x="0" y="255"/>
                          <a:pt x="0" y="255"/>
                        </a:cubicBezTo>
                        <a:cubicBezTo>
                          <a:pt x="6" y="275"/>
                          <a:pt x="6" y="275"/>
                          <a:pt x="6" y="275"/>
                        </a:cubicBezTo>
                        <a:cubicBezTo>
                          <a:pt x="33" y="290"/>
                          <a:pt x="33" y="290"/>
                          <a:pt x="33" y="290"/>
                        </a:cubicBezTo>
                        <a:cubicBezTo>
                          <a:pt x="35" y="312"/>
                          <a:pt x="35" y="312"/>
                          <a:pt x="35" y="312"/>
                        </a:cubicBezTo>
                        <a:cubicBezTo>
                          <a:pt x="58" y="332"/>
                          <a:pt x="58" y="332"/>
                          <a:pt x="58" y="332"/>
                        </a:cubicBezTo>
                        <a:cubicBezTo>
                          <a:pt x="66" y="356"/>
                          <a:pt x="66" y="356"/>
                          <a:pt x="66" y="356"/>
                        </a:cubicBezTo>
                        <a:cubicBezTo>
                          <a:pt x="66" y="357"/>
                          <a:pt x="66" y="357"/>
                          <a:pt x="66" y="357"/>
                        </a:cubicBezTo>
                        <a:cubicBezTo>
                          <a:pt x="69" y="355"/>
                          <a:pt x="69" y="355"/>
                          <a:pt x="69" y="355"/>
                        </a:cubicBezTo>
                        <a:cubicBezTo>
                          <a:pt x="86" y="354"/>
                          <a:pt x="86" y="354"/>
                          <a:pt x="86" y="354"/>
                        </a:cubicBezTo>
                        <a:cubicBezTo>
                          <a:pt x="101" y="349"/>
                          <a:pt x="101" y="349"/>
                          <a:pt x="101" y="349"/>
                        </a:cubicBezTo>
                        <a:cubicBezTo>
                          <a:pt x="114" y="350"/>
                          <a:pt x="114" y="350"/>
                          <a:pt x="114" y="350"/>
                        </a:cubicBezTo>
                        <a:cubicBezTo>
                          <a:pt x="136" y="369"/>
                          <a:pt x="136" y="369"/>
                          <a:pt x="136" y="369"/>
                        </a:cubicBezTo>
                        <a:cubicBezTo>
                          <a:pt x="173" y="361"/>
                          <a:pt x="173" y="361"/>
                          <a:pt x="173" y="361"/>
                        </a:cubicBezTo>
                        <a:cubicBezTo>
                          <a:pt x="191" y="366"/>
                          <a:pt x="191" y="366"/>
                          <a:pt x="191" y="366"/>
                        </a:cubicBezTo>
                        <a:cubicBezTo>
                          <a:pt x="202" y="360"/>
                          <a:pt x="202" y="360"/>
                          <a:pt x="202" y="360"/>
                        </a:cubicBezTo>
                        <a:cubicBezTo>
                          <a:pt x="222" y="362"/>
                          <a:pt x="222" y="362"/>
                          <a:pt x="222" y="362"/>
                        </a:cubicBezTo>
                        <a:cubicBezTo>
                          <a:pt x="228" y="359"/>
                          <a:pt x="228" y="359"/>
                          <a:pt x="228" y="359"/>
                        </a:cubicBezTo>
                        <a:cubicBezTo>
                          <a:pt x="240" y="361"/>
                          <a:pt x="240" y="361"/>
                          <a:pt x="240" y="361"/>
                        </a:cubicBezTo>
                        <a:cubicBezTo>
                          <a:pt x="245" y="356"/>
                          <a:pt x="245" y="356"/>
                          <a:pt x="245" y="356"/>
                        </a:cubicBezTo>
                        <a:cubicBezTo>
                          <a:pt x="233" y="348"/>
                          <a:pt x="233" y="348"/>
                          <a:pt x="233" y="348"/>
                        </a:cubicBezTo>
                        <a:cubicBezTo>
                          <a:pt x="239" y="337"/>
                          <a:pt x="239" y="337"/>
                          <a:pt x="239" y="337"/>
                        </a:cubicBezTo>
                        <a:cubicBezTo>
                          <a:pt x="261" y="342"/>
                          <a:pt x="261" y="342"/>
                          <a:pt x="261" y="342"/>
                        </a:cubicBezTo>
                        <a:cubicBezTo>
                          <a:pt x="257" y="334"/>
                          <a:pt x="257" y="334"/>
                          <a:pt x="257" y="334"/>
                        </a:cubicBezTo>
                        <a:cubicBezTo>
                          <a:pt x="278" y="333"/>
                          <a:pt x="278" y="333"/>
                          <a:pt x="278" y="333"/>
                        </a:cubicBezTo>
                        <a:cubicBezTo>
                          <a:pt x="289" y="325"/>
                          <a:pt x="289" y="325"/>
                          <a:pt x="289" y="325"/>
                        </a:cubicBezTo>
                        <a:cubicBezTo>
                          <a:pt x="297" y="329"/>
                          <a:pt x="297" y="329"/>
                          <a:pt x="297" y="329"/>
                        </a:cubicBezTo>
                        <a:cubicBezTo>
                          <a:pt x="291" y="345"/>
                          <a:pt x="291" y="345"/>
                          <a:pt x="291" y="345"/>
                        </a:cubicBezTo>
                        <a:cubicBezTo>
                          <a:pt x="306" y="345"/>
                          <a:pt x="306" y="345"/>
                          <a:pt x="306" y="345"/>
                        </a:cubicBezTo>
                        <a:cubicBezTo>
                          <a:pt x="308" y="347"/>
                          <a:pt x="308" y="347"/>
                          <a:pt x="308" y="347"/>
                        </a:cubicBezTo>
                        <a:cubicBezTo>
                          <a:pt x="308" y="347"/>
                          <a:pt x="308" y="347"/>
                          <a:pt x="308" y="347"/>
                        </a:cubicBezTo>
                        <a:cubicBezTo>
                          <a:pt x="330" y="337"/>
                          <a:pt x="330" y="337"/>
                          <a:pt x="330" y="337"/>
                        </a:cubicBezTo>
                        <a:cubicBezTo>
                          <a:pt x="341" y="315"/>
                          <a:pt x="341" y="315"/>
                          <a:pt x="341" y="315"/>
                        </a:cubicBezTo>
                        <a:cubicBezTo>
                          <a:pt x="351" y="304"/>
                          <a:pt x="351" y="304"/>
                          <a:pt x="351" y="304"/>
                        </a:cubicBezTo>
                        <a:cubicBezTo>
                          <a:pt x="369" y="300"/>
                          <a:pt x="369" y="300"/>
                          <a:pt x="369" y="300"/>
                        </a:cubicBezTo>
                        <a:cubicBezTo>
                          <a:pt x="370" y="300"/>
                          <a:pt x="370" y="300"/>
                          <a:pt x="370" y="300"/>
                        </a:cubicBezTo>
                        <a:cubicBezTo>
                          <a:pt x="364" y="294"/>
                          <a:pt x="364" y="294"/>
                          <a:pt x="364" y="294"/>
                        </a:cubicBezTo>
                        <a:cubicBezTo>
                          <a:pt x="360" y="293"/>
                          <a:pt x="360" y="293"/>
                          <a:pt x="360" y="293"/>
                        </a:cubicBezTo>
                        <a:cubicBezTo>
                          <a:pt x="361" y="286"/>
                          <a:pt x="361" y="286"/>
                          <a:pt x="361" y="286"/>
                        </a:cubicBezTo>
                        <a:cubicBezTo>
                          <a:pt x="370" y="275"/>
                          <a:pt x="370" y="275"/>
                          <a:pt x="370" y="275"/>
                        </a:cubicBezTo>
                        <a:cubicBezTo>
                          <a:pt x="373" y="264"/>
                          <a:pt x="373" y="264"/>
                          <a:pt x="373" y="264"/>
                        </a:cubicBezTo>
                        <a:cubicBezTo>
                          <a:pt x="384" y="254"/>
                          <a:pt x="384" y="254"/>
                          <a:pt x="384" y="254"/>
                        </a:cubicBezTo>
                        <a:cubicBezTo>
                          <a:pt x="411" y="229"/>
                          <a:pt x="411" y="229"/>
                          <a:pt x="411" y="229"/>
                        </a:cubicBezTo>
                        <a:cubicBezTo>
                          <a:pt x="427" y="212"/>
                          <a:pt x="427" y="212"/>
                          <a:pt x="427" y="212"/>
                        </a:cubicBezTo>
                        <a:cubicBezTo>
                          <a:pt x="432" y="212"/>
                          <a:pt x="432" y="212"/>
                          <a:pt x="432" y="212"/>
                        </a:cubicBezTo>
                        <a:cubicBezTo>
                          <a:pt x="446" y="202"/>
                          <a:pt x="446" y="202"/>
                          <a:pt x="446" y="202"/>
                        </a:cubicBezTo>
                        <a:cubicBezTo>
                          <a:pt x="460" y="190"/>
                          <a:pt x="460" y="190"/>
                          <a:pt x="460" y="190"/>
                        </a:cubicBezTo>
                        <a:cubicBezTo>
                          <a:pt x="466" y="183"/>
                          <a:pt x="466" y="183"/>
                          <a:pt x="466" y="183"/>
                        </a:cubicBezTo>
                        <a:cubicBezTo>
                          <a:pt x="466" y="183"/>
                          <a:pt x="466" y="183"/>
                          <a:pt x="466" y="183"/>
                        </a:cubicBezTo>
                        <a:cubicBezTo>
                          <a:pt x="458" y="170"/>
                          <a:pt x="458" y="170"/>
                          <a:pt x="458" y="170"/>
                        </a:cubicBezTo>
                        <a:cubicBezTo>
                          <a:pt x="446" y="170"/>
                          <a:pt x="446" y="170"/>
                          <a:pt x="446" y="170"/>
                        </a:cubicBezTo>
                        <a:cubicBezTo>
                          <a:pt x="429" y="154"/>
                          <a:pt x="429" y="154"/>
                          <a:pt x="429" y="154"/>
                        </a:cubicBezTo>
                        <a:cubicBezTo>
                          <a:pt x="423" y="166"/>
                          <a:pt x="423" y="166"/>
                          <a:pt x="423" y="166"/>
                        </a:cubicBezTo>
                        <a:cubicBezTo>
                          <a:pt x="413" y="157"/>
                          <a:pt x="413" y="157"/>
                          <a:pt x="413" y="157"/>
                        </a:cubicBezTo>
                        <a:cubicBezTo>
                          <a:pt x="402" y="147"/>
                          <a:pt x="402" y="147"/>
                          <a:pt x="402" y="147"/>
                        </a:cubicBezTo>
                        <a:cubicBezTo>
                          <a:pt x="410" y="126"/>
                          <a:pt x="410" y="126"/>
                          <a:pt x="410" y="126"/>
                        </a:cubicBezTo>
                        <a:cubicBezTo>
                          <a:pt x="419" y="103"/>
                          <a:pt x="419" y="103"/>
                          <a:pt x="419" y="103"/>
                        </a:cubicBezTo>
                        <a:cubicBezTo>
                          <a:pt x="406" y="84"/>
                          <a:pt x="406" y="84"/>
                          <a:pt x="406" y="84"/>
                        </a:cubicBezTo>
                        <a:cubicBezTo>
                          <a:pt x="407" y="62"/>
                          <a:pt x="407" y="62"/>
                          <a:pt x="407" y="62"/>
                        </a:cubicBezTo>
                        <a:cubicBezTo>
                          <a:pt x="421" y="45"/>
                          <a:pt x="421" y="45"/>
                          <a:pt x="421" y="45"/>
                        </a:cubicBezTo>
                        <a:cubicBezTo>
                          <a:pt x="424" y="31"/>
                          <a:pt x="424" y="31"/>
                          <a:pt x="424" y="31"/>
                        </a:cubicBezTo>
                        <a:cubicBezTo>
                          <a:pt x="416" y="26"/>
                          <a:pt x="416" y="26"/>
                          <a:pt x="416" y="26"/>
                        </a:cubicBezTo>
                        <a:cubicBezTo>
                          <a:pt x="408" y="7"/>
                          <a:pt x="408" y="7"/>
                          <a:pt x="408" y="7"/>
                        </a:cubicBezTo>
                        <a:cubicBezTo>
                          <a:pt x="400" y="7"/>
                          <a:pt x="400" y="7"/>
                          <a:pt x="400" y="7"/>
                        </a:cubicBezTo>
                        <a:cubicBezTo>
                          <a:pt x="384" y="12"/>
                          <a:pt x="384" y="12"/>
                          <a:pt x="384" y="12"/>
                        </a:cubicBezTo>
                        <a:lnTo>
                          <a:pt x="382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900" b="1" kern="0">
                      <a:solidFill>
                        <a:srgbClr val="000000"/>
                      </a:solidFill>
                      <a:latin typeface="Arial" charset="0"/>
                    </a:endParaRPr>
                  </a:p>
                </p:txBody>
              </p:sp>
              <p:sp>
                <p:nvSpPr>
                  <p:cNvPr id="56" name="Freeform 14"/>
                  <p:cNvSpPr>
                    <a:spLocks/>
                  </p:cNvSpPr>
                  <p:nvPr/>
                </p:nvSpPr>
                <p:spPr bwMode="auto">
                  <a:xfrm>
                    <a:off x="4248057" y="3278780"/>
                    <a:ext cx="931117" cy="913757"/>
                  </a:xfrm>
                  <a:custGeom>
                    <a:avLst/>
                    <a:gdLst/>
                    <a:ahLst/>
                    <a:cxnLst>
                      <a:cxn ang="0">
                        <a:pos x="12" y="11"/>
                      </a:cxn>
                      <a:cxn ang="0">
                        <a:pos x="3" y="21"/>
                      </a:cxn>
                      <a:cxn ang="0">
                        <a:pos x="7" y="56"/>
                      </a:cxn>
                      <a:cxn ang="0">
                        <a:pos x="41" y="87"/>
                      </a:cxn>
                      <a:cxn ang="0">
                        <a:pos x="40" y="140"/>
                      </a:cxn>
                      <a:cxn ang="0">
                        <a:pos x="49" y="169"/>
                      </a:cxn>
                      <a:cxn ang="0">
                        <a:pos x="41" y="222"/>
                      </a:cxn>
                      <a:cxn ang="0">
                        <a:pos x="78" y="226"/>
                      </a:cxn>
                      <a:cxn ang="0">
                        <a:pos x="77" y="255"/>
                      </a:cxn>
                      <a:cxn ang="0">
                        <a:pos x="62" y="284"/>
                      </a:cxn>
                      <a:cxn ang="0">
                        <a:pos x="45" y="274"/>
                      </a:cxn>
                      <a:cxn ang="0">
                        <a:pos x="8" y="262"/>
                      </a:cxn>
                      <a:cxn ang="0">
                        <a:pos x="1" y="286"/>
                      </a:cxn>
                      <a:cxn ang="0">
                        <a:pos x="17" y="309"/>
                      </a:cxn>
                      <a:cxn ang="0">
                        <a:pos x="22" y="357"/>
                      </a:cxn>
                      <a:cxn ang="0">
                        <a:pos x="31" y="373"/>
                      </a:cxn>
                      <a:cxn ang="0">
                        <a:pos x="53" y="408"/>
                      </a:cxn>
                      <a:cxn ang="0">
                        <a:pos x="57" y="437"/>
                      </a:cxn>
                      <a:cxn ang="0">
                        <a:pos x="66" y="435"/>
                      </a:cxn>
                      <a:cxn ang="0">
                        <a:pos x="91" y="440"/>
                      </a:cxn>
                      <a:cxn ang="0">
                        <a:pos x="86" y="409"/>
                      </a:cxn>
                      <a:cxn ang="0">
                        <a:pos x="114" y="403"/>
                      </a:cxn>
                      <a:cxn ang="0">
                        <a:pos x="132" y="407"/>
                      </a:cxn>
                      <a:cxn ang="0">
                        <a:pos x="172" y="396"/>
                      </a:cxn>
                      <a:cxn ang="0">
                        <a:pos x="178" y="334"/>
                      </a:cxn>
                      <a:cxn ang="0">
                        <a:pos x="218" y="340"/>
                      </a:cxn>
                      <a:cxn ang="0">
                        <a:pos x="255" y="339"/>
                      </a:cxn>
                      <a:cxn ang="0">
                        <a:pos x="300" y="329"/>
                      </a:cxn>
                      <a:cxn ang="0">
                        <a:pos x="321" y="324"/>
                      </a:cxn>
                      <a:cxn ang="0">
                        <a:pos x="315" y="356"/>
                      </a:cxn>
                      <a:cxn ang="0">
                        <a:pos x="336" y="356"/>
                      </a:cxn>
                      <a:cxn ang="0">
                        <a:pos x="360" y="345"/>
                      </a:cxn>
                      <a:cxn ang="0">
                        <a:pos x="383" y="323"/>
                      </a:cxn>
                      <a:cxn ang="0">
                        <a:pos x="385" y="280"/>
                      </a:cxn>
                      <a:cxn ang="0">
                        <a:pos x="386" y="247"/>
                      </a:cxn>
                      <a:cxn ang="0">
                        <a:pos x="407" y="241"/>
                      </a:cxn>
                      <a:cxn ang="0">
                        <a:pos x="412" y="203"/>
                      </a:cxn>
                      <a:cxn ang="0">
                        <a:pos x="434" y="181"/>
                      </a:cxn>
                      <a:cxn ang="0">
                        <a:pos x="445" y="164"/>
                      </a:cxn>
                      <a:cxn ang="0">
                        <a:pos x="406" y="148"/>
                      </a:cxn>
                      <a:cxn ang="0">
                        <a:pos x="379" y="123"/>
                      </a:cxn>
                      <a:cxn ang="0">
                        <a:pos x="356" y="107"/>
                      </a:cxn>
                      <a:cxn ang="0">
                        <a:pos x="317" y="65"/>
                      </a:cxn>
                      <a:cxn ang="0">
                        <a:pos x="302" y="93"/>
                      </a:cxn>
                      <a:cxn ang="0">
                        <a:pos x="279" y="102"/>
                      </a:cxn>
                      <a:cxn ang="0">
                        <a:pos x="239" y="87"/>
                      </a:cxn>
                      <a:cxn ang="0">
                        <a:pos x="217" y="95"/>
                      </a:cxn>
                      <a:cxn ang="0">
                        <a:pos x="188" y="113"/>
                      </a:cxn>
                      <a:cxn ang="0">
                        <a:pos x="168" y="107"/>
                      </a:cxn>
                      <a:cxn ang="0">
                        <a:pos x="146" y="92"/>
                      </a:cxn>
                      <a:cxn ang="0">
                        <a:pos x="129" y="82"/>
                      </a:cxn>
                      <a:cxn ang="0">
                        <a:pos x="113" y="56"/>
                      </a:cxn>
                      <a:cxn ang="0">
                        <a:pos x="89" y="39"/>
                      </a:cxn>
                      <a:cxn ang="0">
                        <a:pos x="72" y="21"/>
                      </a:cxn>
                    </a:cxnLst>
                    <a:rect l="0" t="0" r="r" b="b"/>
                    <a:pathLst>
                      <a:path w="448" h="440">
                        <a:moveTo>
                          <a:pt x="34" y="0"/>
                        </a:moveTo>
                        <a:cubicBezTo>
                          <a:pt x="12" y="11"/>
                          <a:pt x="12" y="11"/>
                          <a:pt x="12" y="11"/>
                        </a:cubicBezTo>
                        <a:cubicBezTo>
                          <a:pt x="8" y="21"/>
                          <a:pt x="8" y="21"/>
                          <a:pt x="8" y="21"/>
                        </a:cubicBezTo>
                        <a:cubicBezTo>
                          <a:pt x="3" y="21"/>
                          <a:pt x="3" y="21"/>
                          <a:pt x="3" y="21"/>
                        </a:cubicBezTo>
                        <a:cubicBezTo>
                          <a:pt x="3" y="21"/>
                          <a:pt x="3" y="21"/>
                          <a:pt x="3" y="21"/>
                        </a:cubicBezTo>
                        <a:cubicBezTo>
                          <a:pt x="7" y="56"/>
                          <a:pt x="7" y="56"/>
                          <a:pt x="7" y="56"/>
                        </a:cubicBezTo>
                        <a:cubicBezTo>
                          <a:pt x="27" y="73"/>
                          <a:pt x="27" y="73"/>
                          <a:pt x="27" y="73"/>
                        </a:cubicBezTo>
                        <a:cubicBezTo>
                          <a:pt x="41" y="87"/>
                          <a:pt x="41" y="87"/>
                          <a:pt x="41" y="87"/>
                        </a:cubicBezTo>
                        <a:cubicBezTo>
                          <a:pt x="36" y="121"/>
                          <a:pt x="36" y="121"/>
                          <a:pt x="36" y="121"/>
                        </a:cubicBezTo>
                        <a:cubicBezTo>
                          <a:pt x="40" y="140"/>
                          <a:pt x="40" y="140"/>
                          <a:pt x="40" y="140"/>
                        </a:cubicBezTo>
                        <a:cubicBezTo>
                          <a:pt x="39" y="147"/>
                          <a:pt x="39" y="147"/>
                          <a:pt x="39" y="147"/>
                        </a:cubicBezTo>
                        <a:cubicBezTo>
                          <a:pt x="49" y="169"/>
                          <a:pt x="49" y="169"/>
                          <a:pt x="49" y="169"/>
                        </a:cubicBezTo>
                        <a:cubicBezTo>
                          <a:pt x="39" y="213"/>
                          <a:pt x="39" y="213"/>
                          <a:pt x="39" y="213"/>
                        </a:cubicBezTo>
                        <a:cubicBezTo>
                          <a:pt x="41" y="222"/>
                          <a:pt x="41" y="222"/>
                          <a:pt x="41" y="222"/>
                        </a:cubicBezTo>
                        <a:cubicBezTo>
                          <a:pt x="62" y="220"/>
                          <a:pt x="62" y="220"/>
                          <a:pt x="62" y="220"/>
                        </a:cubicBezTo>
                        <a:cubicBezTo>
                          <a:pt x="78" y="226"/>
                          <a:pt x="78" y="226"/>
                          <a:pt x="78" y="226"/>
                        </a:cubicBezTo>
                        <a:cubicBezTo>
                          <a:pt x="84" y="246"/>
                          <a:pt x="84" y="246"/>
                          <a:pt x="84" y="246"/>
                        </a:cubicBezTo>
                        <a:cubicBezTo>
                          <a:pt x="77" y="255"/>
                          <a:pt x="77" y="255"/>
                          <a:pt x="77" y="255"/>
                        </a:cubicBezTo>
                        <a:cubicBezTo>
                          <a:pt x="74" y="267"/>
                          <a:pt x="74" y="267"/>
                          <a:pt x="74" y="267"/>
                        </a:cubicBezTo>
                        <a:cubicBezTo>
                          <a:pt x="62" y="284"/>
                          <a:pt x="62" y="284"/>
                          <a:pt x="62" y="284"/>
                        </a:cubicBezTo>
                        <a:cubicBezTo>
                          <a:pt x="55" y="286"/>
                          <a:pt x="55" y="286"/>
                          <a:pt x="55" y="286"/>
                        </a:cubicBezTo>
                        <a:cubicBezTo>
                          <a:pt x="45" y="274"/>
                          <a:pt x="45" y="274"/>
                          <a:pt x="45" y="274"/>
                        </a:cubicBezTo>
                        <a:cubicBezTo>
                          <a:pt x="19" y="266"/>
                          <a:pt x="19" y="266"/>
                          <a:pt x="19" y="266"/>
                        </a:cubicBezTo>
                        <a:cubicBezTo>
                          <a:pt x="8" y="262"/>
                          <a:pt x="8" y="262"/>
                          <a:pt x="8" y="262"/>
                        </a:cubicBezTo>
                        <a:cubicBezTo>
                          <a:pt x="11" y="281"/>
                          <a:pt x="11" y="281"/>
                          <a:pt x="11" y="281"/>
                        </a:cubicBezTo>
                        <a:cubicBezTo>
                          <a:pt x="1" y="286"/>
                          <a:pt x="1" y="286"/>
                          <a:pt x="1" y="286"/>
                        </a:cubicBezTo>
                        <a:cubicBezTo>
                          <a:pt x="0" y="296"/>
                          <a:pt x="0" y="296"/>
                          <a:pt x="0" y="296"/>
                        </a:cubicBezTo>
                        <a:cubicBezTo>
                          <a:pt x="17" y="309"/>
                          <a:pt x="17" y="309"/>
                          <a:pt x="17" y="309"/>
                        </a:cubicBezTo>
                        <a:cubicBezTo>
                          <a:pt x="29" y="342"/>
                          <a:pt x="29" y="342"/>
                          <a:pt x="29" y="342"/>
                        </a:cubicBezTo>
                        <a:cubicBezTo>
                          <a:pt x="22" y="357"/>
                          <a:pt x="22" y="357"/>
                          <a:pt x="22" y="357"/>
                        </a:cubicBezTo>
                        <a:cubicBezTo>
                          <a:pt x="22" y="357"/>
                          <a:pt x="20" y="362"/>
                          <a:pt x="19" y="364"/>
                        </a:cubicBezTo>
                        <a:cubicBezTo>
                          <a:pt x="31" y="373"/>
                          <a:pt x="31" y="373"/>
                          <a:pt x="31" y="373"/>
                        </a:cubicBezTo>
                        <a:cubicBezTo>
                          <a:pt x="47" y="378"/>
                          <a:pt x="47" y="378"/>
                          <a:pt x="47" y="378"/>
                        </a:cubicBezTo>
                        <a:cubicBezTo>
                          <a:pt x="53" y="408"/>
                          <a:pt x="53" y="408"/>
                          <a:pt x="53" y="408"/>
                        </a:cubicBezTo>
                        <a:cubicBezTo>
                          <a:pt x="39" y="431"/>
                          <a:pt x="39" y="431"/>
                          <a:pt x="39" y="431"/>
                        </a:cubicBezTo>
                        <a:cubicBezTo>
                          <a:pt x="57" y="437"/>
                          <a:pt x="57" y="437"/>
                          <a:pt x="57" y="437"/>
                        </a:cubicBezTo>
                        <a:cubicBezTo>
                          <a:pt x="66" y="434"/>
                          <a:pt x="66" y="434"/>
                          <a:pt x="66" y="434"/>
                        </a:cubicBezTo>
                        <a:cubicBezTo>
                          <a:pt x="66" y="435"/>
                          <a:pt x="66" y="435"/>
                          <a:pt x="66" y="435"/>
                        </a:cubicBezTo>
                        <a:cubicBezTo>
                          <a:pt x="66" y="435"/>
                          <a:pt x="68" y="434"/>
                          <a:pt x="68" y="434"/>
                        </a:cubicBezTo>
                        <a:cubicBezTo>
                          <a:pt x="91" y="440"/>
                          <a:pt x="91" y="440"/>
                          <a:pt x="91" y="440"/>
                        </a:cubicBezTo>
                        <a:cubicBezTo>
                          <a:pt x="99" y="435"/>
                          <a:pt x="99" y="435"/>
                          <a:pt x="99" y="435"/>
                        </a:cubicBezTo>
                        <a:cubicBezTo>
                          <a:pt x="86" y="409"/>
                          <a:pt x="86" y="409"/>
                          <a:pt x="86" y="409"/>
                        </a:cubicBezTo>
                        <a:cubicBezTo>
                          <a:pt x="91" y="405"/>
                          <a:pt x="91" y="405"/>
                          <a:pt x="91" y="405"/>
                        </a:cubicBezTo>
                        <a:cubicBezTo>
                          <a:pt x="114" y="403"/>
                          <a:pt x="114" y="403"/>
                          <a:pt x="114" y="403"/>
                        </a:cubicBezTo>
                        <a:cubicBezTo>
                          <a:pt x="125" y="414"/>
                          <a:pt x="125" y="414"/>
                          <a:pt x="125" y="414"/>
                        </a:cubicBezTo>
                        <a:cubicBezTo>
                          <a:pt x="132" y="407"/>
                          <a:pt x="132" y="407"/>
                          <a:pt x="132" y="407"/>
                        </a:cubicBezTo>
                        <a:cubicBezTo>
                          <a:pt x="162" y="406"/>
                          <a:pt x="162" y="406"/>
                          <a:pt x="162" y="406"/>
                        </a:cubicBezTo>
                        <a:cubicBezTo>
                          <a:pt x="172" y="396"/>
                          <a:pt x="172" y="396"/>
                          <a:pt x="172" y="396"/>
                        </a:cubicBezTo>
                        <a:cubicBezTo>
                          <a:pt x="169" y="370"/>
                          <a:pt x="169" y="370"/>
                          <a:pt x="169" y="370"/>
                        </a:cubicBezTo>
                        <a:cubicBezTo>
                          <a:pt x="178" y="334"/>
                          <a:pt x="178" y="334"/>
                          <a:pt x="178" y="334"/>
                        </a:cubicBezTo>
                        <a:cubicBezTo>
                          <a:pt x="191" y="337"/>
                          <a:pt x="191" y="337"/>
                          <a:pt x="191" y="337"/>
                        </a:cubicBezTo>
                        <a:cubicBezTo>
                          <a:pt x="218" y="340"/>
                          <a:pt x="218" y="340"/>
                          <a:pt x="218" y="340"/>
                        </a:cubicBezTo>
                        <a:cubicBezTo>
                          <a:pt x="223" y="335"/>
                          <a:pt x="223" y="335"/>
                          <a:pt x="223" y="335"/>
                        </a:cubicBezTo>
                        <a:cubicBezTo>
                          <a:pt x="255" y="339"/>
                          <a:pt x="255" y="339"/>
                          <a:pt x="255" y="339"/>
                        </a:cubicBezTo>
                        <a:cubicBezTo>
                          <a:pt x="284" y="323"/>
                          <a:pt x="284" y="323"/>
                          <a:pt x="284" y="323"/>
                        </a:cubicBezTo>
                        <a:cubicBezTo>
                          <a:pt x="300" y="329"/>
                          <a:pt x="300" y="329"/>
                          <a:pt x="300" y="329"/>
                        </a:cubicBezTo>
                        <a:cubicBezTo>
                          <a:pt x="315" y="314"/>
                          <a:pt x="315" y="314"/>
                          <a:pt x="315" y="314"/>
                        </a:cubicBezTo>
                        <a:cubicBezTo>
                          <a:pt x="321" y="324"/>
                          <a:pt x="321" y="324"/>
                          <a:pt x="321" y="324"/>
                        </a:cubicBezTo>
                        <a:cubicBezTo>
                          <a:pt x="310" y="344"/>
                          <a:pt x="310" y="344"/>
                          <a:pt x="310" y="344"/>
                        </a:cubicBezTo>
                        <a:cubicBezTo>
                          <a:pt x="315" y="356"/>
                          <a:pt x="315" y="356"/>
                          <a:pt x="315" y="356"/>
                        </a:cubicBezTo>
                        <a:cubicBezTo>
                          <a:pt x="328" y="358"/>
                          <a:pt x="328" y="358"/>
                          <a:pt x="328" y="358"/>
                        </a:cubicBezTo>
                        <a:cubicBezTo>
                          <a:pt x="336" y="356"/>
                          <a:pt x="336" y="356"/>
                          <a:pt x="336" y="356"/>
                        </a:cubicBezTo>
                        <a:cubicBezTo>
                          <a:pt x="350" y="364"/>
                          <a:pt x="350" y="364"/>
                          <a:pt x="350" y="364"/>
                        </a:cubicBezTo>
                        <a:cubicBezTo>
                          <a:pt x="360" y="345"/>
                          <a:pt x="360" y="345"/>
                          <a:pt x="360" y="345"/>
                        </a:cubicBezTo>
                        <a:cubicBezTo>
                          <a:pt x="384" y="335"/>
                          <a:pt x="384" y="335"/>
                          <a:pt x="384" y="335"/>
                        </a:cubicBezTo>
                        <a:cubicBezTo>
                          <a:pt x="383" y="323"/>
                          <a:pt x="383" y="323"/>
                          <a:pt x="383" y="323"/>
                        </a:cubicBezTo>
                        <a:cubicBezTo>
                          <a:pt x="383" y="316"/>
                          <a:pt x="383" y="316"/>
                          <a:pt x="383" y="316"/>
                        </a:cubicBezTo>
                        <a:cubicBezTo>
                          <a:pt x="385" y="280"/>
                          <a:pt x="385" y="280"/>
                          <a:pt x="385" y="280"/>
                        </a:cubicBezTo>
                        <a:cubicBezTo>
                          <a:pt x="379" y="256"/>
                          <a:pt x="379" y="256"/>
                          <a:pt x="379" y="256"/>
                        </a:cubicBezTo>
                        <a:cubicBezTo>
                          <a:pt x="386" y="247"/>
                          <a:pt x="386" y="247"/>
                          <a:pt x="386" y="247"/>
                        </a:cubicBezTo>
                        <a:cubicBezTo>
                          <a:pt x="404" y="246"/>
                          <a:pt x="404" y="246"/>
                          <a:pt x="404" y="246"/>
                        </a:cubicBezTo>
                        <a:cubicBezTo>
                          <a:pt x="407" y="241"/>
                          <a:pt x="407" y="241"/>
                          <a:pt x="407" y="241"/>
                        </a:cubicBezTo>
                        <a:cubicBezTo>
                          <a:pt x="407" y="225"/>
                          <a:pt x="407" y="225"/>
                          <a:pt x="407" y="225"/>
                        </a:cubicBezTo>
                        <a:cubicBezTo>
                          <a:pt x="412" y="203"/>
                          <a:pt x="412" y="203"/>
                          <a:pt x="412" y="203"/>
                        </a:cubicBezTo>
                        <a:cubicBezTo>
                          <a:pt x="415" y="187"/>
                          <a:pt x="415" y="187"/>
                          <a:pt x="415" y="187"/>
                        </a:cubicBezTo>
                        <a:cubicBezTo>
                          <a:pt x="434" y="181"/>
                          <a:pt x="434" y="181"/>
                          <a:pt x="434" y="181"/>
                        </a:cubicBezTo>
                        <a:cubicBezTo>
                          <a:pt x="448" y="180"/>
                          <a:pt x="448" y="180"/>
                          <a:pt x="448" y="180"/>
                        </a:cubicBezTo>
                        <a:cubicBezTo>
                          <a:pt x="445" y="164"/>
                          <a:pt x="445" y="164"/>
                          <a:pt x="445" y="164"/>
                        </a:cubicBezTo>
                        <a:cubicBezTo>
                          <a:pt x="429" y="158"/>
                          <a:pt x="429" y="158"/>
                          <a:pt x="429" y="158"/>
                        </a:cubicBezTo>
                        <a:cubicBezTo>
                          <a:pt x="406" y="148"/>
                          <a:pt x="406" y="148"/>
                          <a:pt x="406" y="148"/>
                        </a:cubicBezTo>
                        <a:cubicBezTo>
                          <a:pt x="396" y="135"/>
                          <a:pt x="396" y="135"/>
                          <a:pt x="396" y="135"/>
                        </a:cubicBezTo>
                        <a:cubicBezTo>
                          <a:pt x="379" y="123"/>
                          <a:pt x="379" y="123"/>
                          <a:pt x="379" y="123"/>
                        </a:cubicBezTo>
                        <a:cubicBezTo>
                          <a:pt x="372" y="109"/>
                          <a:pt x="372" y="109"/>
                          <a:pt x="372" y="109"/>
                        </a:cubicBezTo>
                        <a:cubicBezTo>
                          <a:pt x="356" y="107"/>
                          <a:pt x="356" y="107"/>
                          <a:pt x="356" y="107"/>
                        </a:cubicBezTo>
                        <a:cubicBezTo>
                          <a:pt x="356" y="80"/>
                          <a:pt x="356" y="80"/>
                          <a:pt x="356" y="80"/>
                        </a:cubicBezTo>
                        <a:cubicBezTo>
                          <a:pt x="317" y="65"/>
                          <a:pt x="317" y="65"/>
                          <a:pt x="317" y="65"/>
                        </a:cubicBezTo>
                        <a:cubicBezTo>
                          <a:pt x="315" y="75"/>
                          <a:pt x="315" y="75"/>
                          <a:pt x="315" y="75"/>
                        </a:cubicBezTo>
                        <a:cubicBezTo>
                          <a:pt x="302" y="93"/>
                          <a:pt x="302" y="93"/>
                          <a:pt x="302" y="93"/>
                        </a:cubicBezTo>
                        <a:cubicBezTo>
                          <a:pt x="290" y="106"/>
                          <a:pt x="290" y="106"/>
                          <a:pt x="290" y="106"/>
                        </a:cubicBezTo>
                        <a:cubicBezTo>
                          <a:pt x="279" y="102"/>
                          <a:pt x="279" y="102"/>
                          <a:pt x="279" y="102"/>
                        </a:cubicBezTo>
                        <a:cubicBezTo>
                          <a:pt x="261" y="87"/>
                          <a:pt x="261" y="87"/>
                          <a:pt x="261" y="87"/>
                        </a:cubicBezTo>
                        <a:cubicBezTo>
                          <a:pt x="239" y="87"/>
                          <a:pt x="239" y="87"/>
                          <a:pt x="239" y="87"/>
                        </a:cubicBezTo>
                        <a:cubicBezTo>
                          <a:pt x="228" y="79"/>
                          <a:pt x="228" y="79"/>
                          <a:pt x="228" y="79"/>
                        </a:cubicBezTo>
                        <a:cubicBezTo>
                          <a:pt x="217" y="95"/>
                          <a:pt x="217" y="95"/>
                          <a:pt x="217" y="95"/>
                        </a:cubicBezTo>
                        <a:cubicBezTo>
                          <a:pt x="201" y="108"/>
                          <a:pt x="201" y="108"/>
                          <a:pt x="201" y="108"/>
                        </a:cubicBezTo>
                        <a:cubicBezTo>
                          <a:pt x="188" y="113"/>
                          <a:pt x="188" y="113"/>
                          <a:pt x="188" y="113"/>
                        </a:cubicBezTo>
                        <a:cubicBezTo>
                          <a:pt x="183" y="104"/>
                          <a:pt x="183" y="104"/>
                          <a:pt x="183" y="104"/>
                        </a:cubicBezTo>
                        <a:cubicBezTo>
                          <a:pt x="168" y="107"/>
                          <a:pt x="168" y="107"/>
                          <a:pt x="168" y="107"/>
                        </a:cubicBezTo>
                        <a:cubicBezTo>
                          <a:pt x="161" y="95"/>
                          <a:pt x="161" y="95"/>
                          <a:pt x="161" y="95"/>
                        </a:cubicBezTo>
                        <a:cubicBezTo>
                          <a:pt x="146" y="92"/>
                          <a:pt x="146" y="92"/>
                          <a:pt x="146" y="92"/>
                        </a:cubicBezTo>
                        <a:cubicBezTo>
                          <a:pt x="145" y="82"/>
                          <a:pt x="145" y="82"/>
                          <a:pt x="145" y="82"/>
                        </a:cubicBezTo>
                        <a:cubicBezTo>
                          <a:pt x="129" y="82"/>
                          <a:pt x="129" y="82"/>
                          <a:pt x="129" y="82"/>
                        </a:cubicBezTo>
                        <a:cubicBezTo>
                          <a:pt x="113" y="73"/>
                          <a:pt x="113" y="73"/>
                          <a:pt x="113" y="73"/>
                        </a:cubicBezTo>
                        <a:cubicBezTo>
                          <a:pt x="113" y="56"/>
                          <a:pt x="113" y="56"/>
                          <a:pt x="113" y="56"/>
                        </a:cubicBezTo>
                        <a:cubicBezTo>
                          <a:pt x="102" y="42"/>
                          <a:pt x="102" y="42"/>
                          <a:pt x="102" y="42"/>
                        </a:cubicBezTo>
                        <a:cubicBezTo>
                          <a:pt x="89" y="39"/>
                          <a:pt x="89" y="39"/>
                          <a:pt x="89" y="39"/>
                        </a:cubicBezTo>
                        <a:cubicBezTo>
                          <a:pt x="84" y="30"/>
                          <a:pt x="84" y="30"/>
                          <a:pt x="84" y="30"/>
                        </a:cubicBezTo>
                        <a:cubicBezTo>
                          <a:pt x="72" y="21"/>
                          <a:pt x="72" y="21"/>
                          <a:pt x="72" y="21"/>
                        </a:cubicBezTo>
                        <a:lnTo>
                          <a:pt x="34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7" name="Freeform 15"/>
                  <p:cNvSpPr>
                    <a:spLocks/>
                  </p:cNvSpPr>
                  <p:nvPr/>
                </p:nvSpPr>
                <p:spPr bwMode="auto">
                  <a:xfrm>
                    <a:off x="3167014" y="3240904"/>
                    <a:ext cx="1256219" cy="811177"/>
                  </a:xfrm>
                  <a:custGeom>
                    <a:avLst/>
                    <a:gdLst/>
                    <a:ahLst/>
                    <a:cxnLst>
                      <a:cxn ang="0">
                        <a:pos x="350" y="7"/>
                      </a:cxn>
                      <a:cxn ang="0">
                        <a:pos x="345" y="27"/>
                      </a:cxn>
                      <a:cxn ang="0">
                        <a:pos x="319" y="41"/>
                      </a:cxn>
                      <a:cxn ang="0">
                        <a:pos x="297" y="43"/>
                      </a:cxn>
                      <a:cxn ang="0">
                        <a:pos x="261" y="54"/>
                      </a:cxn>
                      <a:cxn ang="0">
                        <a:pos x="229" y="32"/>
                      </a:cxn>
                      <a:cxn ang="0">
                        <a:pos x="111" y="85"/>
                      </a:cxn>
                      <a:cxn ang="0">
                        <a:pos x="82" y="77"/>
                      </a:cxn>
                      <a:cxn ang="0">
                        <a:pos x="56" y="66"/>
                      </a:cxn>
                      <a:cxn ang="0">
                        <a:pos x="22" y="109"/>
                      </a:cxn>
                      <a:cxn ang="0">
                        <a:pos x="10" y="122"/>
                      </a:cxn>
                      <a:cxn ang="0">
                        <a:pos x="32" y="160"/>
                      </a:cxn>
                      <a:cxn ang="0">
                        <a:pos x="69" y="187"/>
                      </a:cxn>
                      <a:cxn ang="0">
                        <a:pos x="128" y="185"/>
                      </a:cxn>
                      <a:cxn ang="0">
                        <a:pos x="112" y="209"/>
                      </a:cxn>
                      <a:cxn ang="0">
                        <a:pos x="93" y="204"/>
                      </a:cxn>
                      <a:cxn ang="0">
                        <a:pos x="72" y="213"/>
                      </a:cxn>
                      <a:cxn ang="0">
                        <a:pos x="46" y="220"/>
                      </a:cxn>
                      <a:cxn ang="0">
                        <a:pos x="11" y="240"/>
                      </a:cxn>
                      <a:cxn ang="0">
                        <a:pos x="36" y="252"/>
                      </a:cxn>
                      <a:cxn ang="0">
                        <a:pos x="50" y="270"/>
                      </a:cxn>
                      <a:cxn ang="0">
                        <a:pos x="66" y="251"/>
                      </a:cxn>
                      <a:cxn ang="0">
                        <a:pos x="61" y="279"/>
                      </a:cxn>
                      <a:cxn ang="0">
                        <a:pos x="56" y="299"/>
                      </a:cxn>
                      <a:cxn ang="0">
                        <a:pos x="52" y="319"/>
                      </a:cxn>
                      <a:cxn ang="0">
                        <a:pos x="102" y="336"/>
                      </a:cxn>
                      <a:cxn ang="0">
                        <a:pos x="136" y="365"/>
                      </a:cxn>
                      <a:cxn ang="0">
                        <a:pos x="161" y="375"/>
                      </a:cxn>
                      <a:cxn ang="0">
                        <a:pos x="195" y="384"/>
                      </a:cxn>
                      <a:cxn ang="0">
                        <a:pos x="266" y="353"/>
                      </a:cxn>
                      <a:cxn ang="0">
                        <a:pos x="305" y="368"/>
                      </a:cxn>
                      <a:cxn ang="0">
                        <a:pos x="373" y="373"/>
                      </a:cxn>
                      <a:cxn ang="0">
                        <a:pos x="433" y="345"/>
                      </a:cxn>
                      <a:cxn ang="0">
                        <a:pos x="455" y="387"/>
                      </a:cxn>
                      <a:cxn ang="0">
                        <a:pos x="483" y="381"/>
                      </a:cxn>
                      <a:cxn ang="0">
                        <a:pos x="516" y="366"/>
                      </a:cxn>
                      <a:cxn ang="0">
                        <a:pos x="540" y="382"/>
                      </a:cxn>
                      <a:cxn ang="0">
                        <a:pos x="550" y="360"/>
                      </a:cxn>
                      <a:cxn ang="0">
                        <a:pos x="521" y="314"/>
                      </a:cxn>
                      <a:cxn ang="0">
                        <a:pos x="532" y="299"/>
                      </a:cxn>
                      <a:cxn ang="0">
                        <a:pos x="540" y="284"/>
                      </a:cxn>
                      <a:cxn ang="0">
                        <a:pos x="576" y="304"/>
                      </a:cxn>
                      <a:cxn ang="0">
                        <a:pos x="595" y="285"/>
                      </a:cxn>
                      <a:cxn ang="0">
                        <a:pos x="605" y="264"/>
                      </a:cxn>
                      <a:cxn ang="0">
                        <a:pos x="583" y="238"/>
                      </a:cxn>
                      <a:cxn ang="0">
                        <a:pos x="560" y="231"/>
                      </a:cxn>
                      <a:cxn ang="0">
                        <a:pos x="560" y="165"/>
                      </a:cxn>
                      <a:cxn ang="0">
                        <a:pos x="557" y="139"/>
                      </a:cxn>
                      <a:cxn ang="0">
                        <a:pos x="548" y="91"/>
                      </a:cxn>
                      <a:cxn ang="0">
                        <a:pos x="524" y="39"/>
                      </a:cxn>
                      <a:cxn ang="0">
                        <a:pos x="482" y="38"/>
                      </a:cxn>
                      <a:cxn ang="0">
                        <a:pos x="439" y="14"/>
                      </a:cxn>
                      <a:cxn ang="0">
                        <a:pos x="390" y="14"/>
                      </a:cxn>
                    </a:cxnLst>
                    <a:rect l="0" t="0" r="r" b="b"/>
                    <a:pathLst>
                      <a:path w="605" h="390">
                        <a:moveTo>
                          <a:pt x="374" y="0"/>
                        </a:moveTo>
                        <a:cubicBezTo>
                          <a:pt x="350" y="7"/>
                          <a:pt x="350" y="7"/>
                          <a:pt x="350" y="7"/>
                        </a:cubicBezTo>
                        <a:cubicBezTo>
                          <a:pt x="340" y="20"/>
                          <a:pt x="340" y="20"/>
                          <a:pt x="340" y="20"/>
                        </a:cubicBezTo>
                        <a:cubicBezTo>
                          <a:pt x="345" y="27"/>
                          <a:pt x="345" y="27"/>
                          <a:pt x="345" y="27"/>
                        </a:cubicBezTo>
                        <a:cubicBezTo>
                          <a:pt x="338" y="39"/>
                          <a:pt x="338" y="39"/>
                          <a:pt x="338" y="39"/>
                        </a:cubicBezTo>
                        <a:cubicBezTo>
                          <a:pt x="319" y="41"/>
                          <a:pt x="319" y="41"/>
                          <a:pt x="319" y="41"/>
                        </a:cubicBezTo>
                        <a:cubicBezTo>
                          <a:pt x="311" y="52"/>
                          <a:pt x="311" y="52"/>
                          <a:pt x="311" y="52"/>
                        </a:cubicBezTo>
                        <a:cubicBezTo>
                          <a:pt x="297" y="43"/>
                          <a:pt x="297" y="43"/>
                          <a:pt x="297" y="43"/>
                        </a:cubicBezTo>
                        <a:cubicBezTo>
                          <a:pt x="285" y="52"/>
                          <a:pt x="285" y="52"/>
                          <a:pt x="285" y="52"/>
                        </a:cubicBezTo>
                        <a:cubicBezTo>
                          <a:pt x="261" y="54"/>
                          <a:pt x="261" y="54"/>
                          <a:pt x="261" y="54"/>
                        </a:cubicBezTo>
                        <a:cubicBezTo>
                          <a:pt x="246" y="37"/>
                          <a:pt x="246" y="37"/>
                          <a:pt x="246" y="37"/>
                        </a:cubicBezTo>
                        <a:cubicBezTo>
                          <a:pt x="246" y="37"/>
                          <a:pt x="234" y="33"/>
                          <a:pt x="229" y="32"/>
                        </a:cubicBezTo>
                        <a:cubicBezTo>
                          <a:pt x="224" y="31"/>
                          <a:pt x="222" y="44"/>
                          <a:pt x="222" y="44"/>
                        </a:cubicBezTo>
                        <a:cubicBezTo>
                          <a:pt x="111" y="85"/>
                          <a:pt x="111" y="85"/>
                          <a:pt x="111" y="85"/>
                        </a:cubicBezTo>
                        <a:cubicBezTo>
                          <a:pt x="110" y="94"/>
                          <a:pt x="110" y="94"/>
                          <a:pt x="110" y="94"/>
                        </a:cubicBezTo>
                        <a:cubicBezTo>
                          <a:pt x="82" y="77"/>
                          <a:pt x="82" y="77"/>
                          <a:pt x="82" y="77"/>
                        </a:cubicBezTo>
                        <a:cubicBezTo>
                          <a:pt x="66" y="76"/>
                          <a:pt x="66" y="76"/>
                          <a:pt x="66" y="76"/>
                        </a:cubicBezTo>
                        <a:cubicBezTo>
                          <a:pt x="56" y="66"/>
                          <a:pt x="56" y="66"/>
                          <a:pt x="56" y="66"/>
                        </a:cubicBezTo>
                        <a:cubicBezTo>
                          <a:pt x="36" y="76"/>
                          <a:pt x="36" y="76"/>
                          <a:pt x="36" y="76"/>
                        </a:cubicBezTo>
                        <a:cubicBezTo>
                          <a:pt x="22" y="109"/>
                          <a:pt x="22" y="109"/>
                          <a:pt x="22" y="109"/>
                        </a:cubicBezTo>
                        <a:cubicBezTo>
                          <a:pt x="13" y="107"/>
                          <a:pt x="13" y="107"/>
                          <a:pt x="13" y="107"/>
                        </a:cubicBezTo>
                        <a:cubicBezTo>
                          <a:pt x="10" y="122"/>
                          <a:pt x="10" y="122"/>
                          <a:pt x="10" y="122"/>
                        </a:cubicBezTo>
                        <a:cubicBezTo>
                          <a:pt x="0" y="144"/>
                          <a:pt x="0" y="144"/>
                          <a:pt x="0" y="144"/>
                        </a:cubicBezTo>
                        <a:cubicBezTo>
                          <a:pt x="32" y="160"/>
                          <a:pt x="32" y="160"/>
                          <a:pt x="32" y="160"/>
                        </a:cubicBezTo>
                        <a:cubicBezTo>
                          <a:pt x="41" y="188"/>
                          <a:pt x="41" y="188"/>
                          <a:pt x="41" y="188"/>
                        </a:cubicBezTo>
                        <a:cubicBezTo>
                          <a:pt x="69" y="187"/>
                          <a:pt x="69" y="187"/>
                          <a:pt x="69" y="187"/>
                        </a:cubicBezTo>
                        <a:cubicBezTo>
                          <a:pt x="101" y="186"/>
                          <a:pt x="101" y="186"/>
                          <a:pt x="101" y="186"/>
                        </a:cubicBezTo>
                        <a:cubicBezTo>
                          <a:pt x="128" y="185"/>
                          <a:pt x="128" y="185"/>
                          <a:pt x="128" y="185"/>
                        </a:cubicBezTo>
                        <a:cubicBezTo>
                          <a:pt x="124" y="191"/>
                          <a:pt x="124" y="191"/>
                          <a:pt x="124" y="191"/>
                        </a:cubicBezTo>
                        <a:cubicBezTo>
                          <a:pt x="112" y="209"/>
                          <a:pt x="112" y="209"/>
                          <a:pt x="112" y="209"/>
                        </a:cubicBezTo>
                        <a:cubicBezTo>
                          <a:pt x="110" y="203"/>
                          <a:pt x="110" y="203"/>
                          <a:pt x="110" y="203"/>
                        </a:cubicBezTo>
                        <a:cubicBezTo>
                          <a:pt x="93" y="204"/>
                          <a:pt x="93" y="204"/>
                          <a:pt x="93" y="204"/>
                        </a:cubicBezTo>
                        <a:cubicBezTo>
                          <a:pt x="83" y="200"/>
                          <a:pt x="83" y="200"/>
                          <a:pt x="83" y="200"/>
                        </a:cubicBezTo>
                        <a:cubicBezTo>
                          <a:pt x="72" y="213"/>
                          <a:pt x="72" y="213"/>
                          <a:pt x="72" y="213"/>
                        </a:cubicBezTo>
                        <a:cubicBezTo>
                          <a:pt x="60" y="213"/>
                          <a:pt x="60" y="213"/>
                          <a:pt x="60" y="213"/>
                        </a:cubicBezTo>
                        <a:cubicBezTo>
                          <a:pt x="46" y="220"/>
                          <a:pt x="46" y="220"/>
                          <a:pt x="46" y="220"/>
                        </a:cubicBezTo>
                        <a:cubicBezTo>
                          <a:pt x="19" y="229"/>
                          <a:pt x="19" y="229"/>
                          <a:pt x="19" y="229"/>
                        </a:cubicBezTo>
                        <a:cubicBezTo>
                          <a:pt x="11" y="240"/>
                          <a:pt x="11" y="240"/>
                          <a:pt x="11" y="240"/>
                        </a:cubicBezTo>
                        <a:cubicBezTo>
                          <a:pt x="17" y="251"/>
                          <a:pt x="17" y="251"/>
                          <a:pt x="17" y="251"/>
                        </a:cubicBezTo>
                        <a:cubicBezTo>
                          <a:pt x="36" y="252"/>
                          <a:pt x="36" y="252"/>
                          <a:pt x="36" y="252"/>
                        </a:cubicBezTo>
                        <a:cubicBezTo>
                          <a:pt x="33" y="274"/>
                          <a:pt x="33" y="274"/>
                          <a:pt x="33" y="274"/>
                        </a:cubicBezTo>
                        <a:cubicBezTo>
                          <a:pt x="50" y="270"/>
                          <a:pt x="50" y="270"/>
                          <a:pt x="50" y="270"/>
                        </a:cubicBezTo>
                        <a:cubicBezTo>
                          <a:pt x="55" y="260"/>
                          <a:pt x="55" y="260"/>
                          <a:pt x="55" y="260"/>
                        </a:cubicBezTo>
                        <a:cubicBezTo>
                          <a:pt x="66" y="251"/>
                          <a:pt x="66" y="251"/>
                          <a:pt x="66" y="251"/>
                        </a:cubicBezTo>
                        <a:cubicBezTo>
                          <a:pt x="68" y="265"/>
                          <a:pt x="68" y="265"/>
                          <a:pt x="68" y="265"/>
                        </a:cubicBezTo>
                        <a:cubicBezTo>
                          <a:pt x="61" y="279"/>
                          <a:pt x="61" y="279"/>
                          <a:pt x="61" y="279"/>
                        </a:cubicBezTo>
                        <a:cubicBezTo>
                          <a:pt x="62" y="290"/>
                          <a:pt x="62" y="290"/>
                          <a:pt x="62" y="290"/>
                        </a:cubicBezTo>
                        <a:cubicBezTo>
                          <a:pt x="56" y="299"/>
                          <a:pt x="56" y="299"/>
                          <a:pt x="56" y="299"/>
                        </a:cubicBezTo>
                        <a:cubicBezTo>
                          <a:pt x="61" y="310"/>
                          <a:pt x="61" y="310"/>
                          <a:pt x="61" y="310"/>
                        </a:cubicBezTo>
                        <a:cubicBezTo>
                          <a:pt x="52" y="319"/>
                          <a:pt x="52" y="319"/>
                          <a:pt x="52" y="319"/>
                        </a:cubicBezTo>
                        <a:cubicBezTo>
                          <a:pt x="78" y="336"/>
                          <a:pt x="78" y="336"/>
                          <a:pt x="78" y="336"/>
                        </a:cubicBezTo>
                        <a:cubicBezTo>
                          <a:pt x="102" y="336"/>
                          <a:pt x="102" y="336"/>
                          <a:pt x="102" y="336"/>
                        </a:cubicBezTo>
                        <a:cubicBezTo>
                          <a:pt x="134" y="355"/>
                          <a:pt x="134" y="355"/>
                          <a:pt x="134" y="355"/>
                        </a:cubicBezTo>
                        <a:cubicBezTo>
                          <a:pt x="136" y="365"/>
                          <a:pt x="136" y="365"/>
                          <a:pt x="136" y="365"/>
                        </a:cubicBezTo>
                        <a:cubicBezTo>
                          <a:pt x="144" y="368"/>
                          <a:pt x="144" y="368"/>
                          <a:pt x="144" y="368"/>
                        </a:cubicBezTo>
                        <a:cubicBezTo>
                          <a:pt x="161" y="375"/>
                          <a:pt x="161" y="375"/>
                          <a:pt x="161" y="375"/>
                        </a:cubicBezTo>
                        <a:cubicBezTo>
                          <a:pt x="177" y="371"/>
                          <a:pt x="177" y="371"/>
                          <a:pt x="177" y="371"/>
                        </a:cubicBezTo>
                        <a:cubicBezTo>
                          <a:pt x="195" y="384"/>
                          <a:pt x="195" y="384"/>
                          <a:pt x="195" y="384"/>
                        </a:cubicBezTo>
                        <a:cubicBezTo>
                          <a:pt x="223" y="360"/>
                          <a:pt x="223" y="360"/>
                          <a:pt x="223" y="360"/>
                        </a:cubicBezTo>
                        <a:cubicBezTo>
                          <a:pt x="266" y="353"/>
                          <a:pt x="266" y="353"/>
                          <a:pt x="266" y="353"/>
                        </a:cubicBezTo>
                        <a:cubicBezTo>
                          <a:pt x="289" y="357"/>
                          <a:pt x="289" y="357"/>
                          <a:pt x="289" y="357"/>
                        </a:cubicBezTo>
                        <a:cubicBezTo>
                          <a:pt x="305" y="368"/>
                          <a:pt x="305" y="368"/>
                          <a:pt x="305" y="368"/>
                        </a:cubicBezTo>
                        <a:cubicBezTo>
                          <a:pt x="330" y="359"/>
                          <a:pt x="330" y="359"/>
                          <a:pt x="330" y="359"/>
                        </a:cubicBezTo>
                        <a:cubicBezTo>
                          <a:pt x="373" y="373"/>
                          <a:pt x="373" y="373"/>
                          <a:pt x="373" y="373"/>
                        </a:cubicBezTo>
                        <a:cubicBezTo>
                          <a:pt x="395" y="355"/>
                          <a:pt x="395" y="355"/>
                          <a:pt x="395" y="355"/>
                        </a:cubicBezTo>
                        <a:cubicBezTo>
                          <a:pt x="433" y="345"/>
                          <a:pt x="433" y="345"/>
                          <a:pt x="433" y="345"/>
                        </a:cubicBezTo>
                        <a:cubicBezTo>
                          <a:pt x="450" y="362"/>
                          <a:pt x="450" y="362"/>
                          <a:pt x="450" y="362"/>
                        </a:cubicBezTo>
                        <a:cubicBezTo>
                          <a:pt x="455" y="387"/>
                          <a:pt x="455" y="387"/>
                          <a:pt x="455" y="387"/>
                        </a:cubicBezTo>
                        <a:cubicBezTo>
                          <a:pt x="468" y="390"/>
                          <a:pt x="468" y="390"/>
                          <a:pt x="468" y="390"/>
                        </a:cubicBezTo>
                        <a:cubicBezTo>
                          <a:pt x="483" y="381"/>
                          <a:pt x="483" y="381"/>
                          <a:pt x="483" y="381"/>
                        </a:cubicBezTo>
                        <a:cubicBezTo>
                          <a:pt x="496" y="366"/>
                          <a:pt x="496" y="366"/>
                          <a:pt x="496" y="366"/>
                        </a:cubicBezTo>
                        <a:cubicBezTo>
                          <a:pt x="516" y="366"/>
                          <a:pt x="516" y="366"/>
                          <a:pt x="516" y="366"/>
                        </a:cubicBezTo>
                        <a:cubicBezTo>
                          <a:pt x="535" y="379"/>
                          <a:pt x="535" y="379"/>
                          <a:pt x="535" y="379"/>
                        </a:cubicBezTo>
                        <a:cubicBezTo>
                          <a:pt x="540" y="382"/>
                          <a:pt x="540" y="382"/>
                          <a:pt x="540" y="382"/>
                        </a:cubicBezTo>
                        <a:cubicBezTo>
                          <a:pt x="541" y="380"/>
                          <a:pt x="543" y="375"/>
                          <a:pt x="543" y="375"/>
                        </a:cubicBezTo>
                        <a:cubicBezTo>
                          <a:pt x="550" y="360"/>
                          <a:pt x="550" y="360"/>
                          <a:pt x="550" y="360"/>
                        </a:cubicBezTo>
                        <a:cubicBezTo>
                          <a:pt x="538" y="327"/>
                          <a:pt x="538" y="327"/>
                          <a:pt x="538" y="327"/>
                        </a:cubicBezTo>
                        <a:cubicBezTo>
                          <a:pt x="521" y="314"/>
                          <a:pt x="521" y="314"/>
                          <a:pt x="521" y="314"/>
                        </a:cubicBezTo>
                        <a:cubicBezTo>
                          <a:pt x="522" y="304"/>
                          <a:pt x="522" y="304"/>
                          <a:pt x="522" y="304"/>
                        </a:cubicBezTo>
                        <a:cubicBezTo>
                          <a:pt x="532" y="299"/>
                          <a:pt x="532" y="299"/>
                          <a:pt x="532" y="299"/>
                        </a:cubicBezTo>
                        <a:cubicBezTo>
                          <a:pt x="529" y="280"/>
                          <a:pt x="529" y="280"/>
                          <a:pt x="529" y="280"/>
                        </a:cubicBezTo>
                        <a:cubicBezTo>
                          <a:pt x="540" y="284"/>
                          <a:pt x="540" y="284"/>
                          <a:pt x="540" y="284"/>
                        </a:cubicBezTo>
                        <a:cubicBezTo>
                          <a:pt x="566" y="292"/>
                          <a:pt x="566" y="292"/>
                          <a:pt x="566" y="292"/>
                        </a:cubicBezTo>
                        <a:cubicBezTo>
                          <a:pt x="576" y="304"/>
                          <a:pt x="576" y="304"/>
                          <a:pt x="576" y="304"/>
                        </a:cubicBezTo>
                        <a:cubicBezTo>
                          <a:pt x="583" y="302"/>
                          <a:pt x="583" y="302"/>
                          <a:pt x="583" y="302"/>
                        </a:cubicBezTo>
                        <a:cubicBezTo>
                          <a:pt x="595" y="285"/>
                          <a:pt x="595" y="285"/>
                          <a:pt x="595" y="285"/>
                        </a:cubicBezTo>
                        <a:cubicBezTo>
                          <a:pt x="598" y="273"/>
                          <a:pt x="598" y="273"/>
                          <a:pt x="598" y="273"/>
                        </a:cubicBezTo>
                        <a:cubicBezTo>
                          <a:pt x="605" y="264"/>
                          <a:pt x="605" y="264"/>
                          <a:pt x="605" y="264"/>
                        </a:cubicBezTo>
                        <a:cubicBezTo>
                          <a:pt x="599" y="244"/>
                          <a:pt x="599" y="244"/>
                          <a:pt x="599" y="244"/>
                        </a:cubicBezTo>
                        <a:cubicBezTo>
                          <a:pt x="583" y="238"/>
                          <a:pt x="583" y="238"/>
                          <a:pt x="583" y="238"/>
                        </a:cubicBezTo>
                        <a:cubicBezTo>
                          <a:pt x="562" y="240"/>
                          <a:pt x="562" y="240"/>
                          <a:pt x="562" y="240"/>
                        </a:cubicBezTo>
                        <a:cubicBezTo>
                          <a:pt x="560" y="231"/>
                          <a:pt x="560" y="231"/>
                          <a:pt x="560" y="231"/>
                        </a:cubicBezTo>
                        <a:cubicBezTo>
                          <a:pt x="570" y="187"/>
                          <a:pt x="570" y="187"/>
                          <a:pt x="570" y="187"/>
                        </a:cubicBezTo>
                        <a:cubicBezTo>
                          <a:pt x="560" y="165"/>
                          <a:pt x="560" y="165"/>
                          <a:pt x="560" y="165"/>
                        </a:cubicBezTo>
                        <a:cubicBezTo>
                          <a:pt x="561" y="158"/>
                          <a:pt x="561" y="158"/>
                          <a:pt x="561" y="158"/>
                        </a:cubicBezTo>
                        <a:cubicBezTo>
                          <a:pt x="557" y="139"/>
                          <a:pt x="557" y="139"/>
                          <a:pt x="557" y="139"/>
                        </a:cubicBezTo>
                        <a:cubicBezTo>
                          <a:pt x="562" y="105"/>
                          <a:pt x="562" y="105"/>
                          <a:pt x="562" y="105"/>
                        </a:cubicBezTo>
                        <a:cubicBezTo>
                          <a:pt x="548" y="91"/>
                          <a:pt x="548" y="91"/>
                          <a:pt x="548" y="91"/>
                        </a:cubicBezTo>
                        <a:cubicBezTo>
                          <a:pt x="528" y="74"/>
                          <a:pt x="528" y="74"/>
                          <a:pt x="528" y="74"/>
                        </a:cubicBezTo>
                        <a:cubicBezTo>
                          <a:pt x="524" y="39"/>
                          <a:pt x="524" y="39"/>
                          <a:pt x="524" y="39"/>
                        </a:cubicBezTo>
                        <a:cubicBezTo>
                          <a:pt x="515" y="33"/>
                          <a:pt x="515" y="33"/>
                          <a:pt x="515" y="33"/>
                        </a:cubicBezTo>
                        <a:cubicBezTo>
                          <a:pt x="482" y="38"/>
                          <a:pt x="482" y="38"/>
                          <a:pt x="482" y="38"/>
                        </a:cubicBezTo>
                        <a:cubicBezTo>
                          <a:pt x="466" y="27"/>
                          <a:pt x="466" y="27"/>
                          <a:pt x="466" y="27"/>
                        </a:cubicBezTo>
                        <a:cubicBezTo>
                          <a:pt x="439" y="14"/>
                          <a:pt x="439" y="14"/>
                          <a:pt x="439" y="14"/>
                        </a:cubicBezTo>
                        <a:cubicBezTo>
                          <a:pt x="411" y="19"/>
                          <a:pt x="411" y="19"/>
                          <a:pt x="411" y="19"/>
                        </a:cubicBezTo>
                        <a:cubicBezTo>
                          <a:pt x="390" y="14"/>
                          <a:pt x="390" y="14"/>
                          <a:pt x="390" y="14"/>
                        </a:cubicBezTo>
                        <a:lnTo>
                          <a:pt x="374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8" name="Freeform 16"/>
                  <p:cNvSpPr>
                    <a:spLocks/>
                  </p:cNvSpPr>
                  <p:nvPr/>
                </p:nvSpPr>
                <p:spPr bwMode="auto">
                  <a:xfrm>
                    <a:off x="3121247" y="3957391"/>
                    <a:ext cx="1442442" cy="1147325"/>
                  </a:xfrm>
                  <a:custGeom>
                    <a:avLst/>
                    <a:gdLst/>
                    <a:ahLst/>
                    <a:cxnLst>
                      <a:cxn ang="0">
                        <a:pos x="548" y="14"/>
                      </a:cxn>
                      <a:cxn ang="0">
                        <a:pos x="463" y="19"/>
                      </a:cxn>
                      <a:cxn ang="0">
                        <a:pos x="409" y="16"/>
                      </a:cxn>
                      <a:cxn ang="0">
                        <a:pos x="322" y="20"/>
                      </a:cxn>
                      <a:cxn ang="0">
                        <a:pos x="262" y="35"/>
                      </a:cxn>
                      <a:cxn ang="0">
                        <a:pos x="218" y="31"/>
                      </a:cxn>
                      <a:cxn ang="0">
                        <a:pos x="210" y="40"/>
                      </a:cxn>
                      <a:cxn ang="0">
                        <a:pos x="125" y="52"/>
                      </a:cxn>
                      <a:cxn ang="0">
                        <a:pos x="93" y="64"/>
                      </a:cxn>
                      <a:cxn ang="0">
                        <a:pos x="50" y="57"/>
                      </a:cxn>
                      <a:cxn ang="0">
                        <a:pos x="16" y="67"/>
                      </a:cxn>
                      <a:cxn ang="0">
                        <a:pos x="31" y="107"/>
                      </a:cxn>
                      <a:cxn ang="0">
                        <a:pos x="1" y="133"/>
                      </a:cxn>
                      <a:cxn ang="0">
                        <a:pos x="39" y="179"/>
                      </a:cxn>
                      <a:cxn ang="0">
                        <a:pos x="91" y="293"/>
                      </a:cxn>
                      <a:cxn ang="0">
                        <a:pos x="109" y="327"/>
                      </a:cxn>
                      <a:cxn ang="0">
                        <a:pos x="154" y="399"/>
                      </a:cxn>
                      <a:cxn ang="0">
                        <a:pos x="168" y="418"/>
                      </a:cxn>
                      <a:cxn ang="0">
                        <a:pos x="130" y="427"/>
                      </a:cxn>
                      <a:cxn ang="0">
                        <a:pos x="141" y="447"/>
                      </a:cxn>
                      <a:cxn ang="0">
                        <a:pos x="177" y="450"/>
                      </a:cxn>
                      <a:cxn ang="0">
                        <a:pos x="179" y="491"/>
                      </a:cxn>
                      <a:cxn ang="0">
                        <a:pos x="188" y="537"/>
                      </a:cxn>
                      <a:cxn ang="0">
                        <a:pos x="227" y="564"/>
                      </a:cxn>
                      <a:cxn ang="0">
                        <a:pos x="313" y="593"/>
                      </a:cxn>
                      <a:cxn ang="0">
                        <a:pos x="342" y="690"/>
                      </a:cxn>
                      <a:cxn ang="0">
                        <a:pos x="430" y="708"/>
                      </a:cxn>
                      <a:cxn ang="0">
                        <a:pos x="466" y="724"/>
                      </a:cxn>
                      <a:cxn ang="0">
                        <a:pos x="488" y="697"/>
                      </a:cxn>
                      <a:cxn ang="0">
                        <a:pos x="534" y="675"/>
                      </a:cxn>
                      <a:cxn ang="0">
                        <a:pos x="560" y="665"/>
                      </a:cxn>
                      <a:cxn ang="0">
                        <a:pos x="577" y="610"/>
                      </a:cxn>
                      <a:cxn ang="0">
                        <a:pos x="600" y="581"/>
                      </a:cxn>
                      <a:cxn ang="0">
                        <a:pos x="608" y="528"/>
                      </a:cxn>
                      <a:cxn ang="0">
                        <a:pos x="626" y="482"/>
                      </a:cxn>
                      <a:cxn ang="0">
                        <a:pos x="622" y="440"/>
                      </a:cxn>
                      <a:cxn ang="0">
                        <a:pos x="600" y="410"/>
                      </a:cxn>
                      <a:cxn ang="0">
                        <a:pos x="655" y="443"/>
                      </a:cxn>
                      <a:cxn ang="0">
                        <a:pos x="716" y="412"/>
                      </a:cxn>
                      <a:cxn ang="0">
                        <a:pos x="789" y="462"/>
                      </a:cxn>
                      <a:cxn ang="0">
                        <a:pos x="855" y="477"/>
                      </a:cxn>
                      <a:cxn ang="0">
                        <a:pos x="870" y="461"/>
                      </a:cxn>
                      <a:cxn ang="0">
                        <a:pos x="885" y="436"/>
                      </a:cxn>
                      <a:cxn ang="0">
                        <a:pos x="914" y="368"/>
                      </a:cxn>
                      <a:cxn ang="0">
                        <a:pos x="889" y="304"/>
                      </a:cxn>
                      <a:cxn ang="0">
                        <a:pos x="852" y="293"/>
                      </a:cxn>
                      <a:cxn ang="0">
                        <a:pos x="888" y="277"/>
                      </a:cxn>
                      <a:cxn ang="0">
                        <a:pos x="877" y="244"/>
                      </a:cxn>
                      <a:cxn ang="0">
                        <a:pos x="845" y="189"/>
                      </a:cxn>
                      <a:cxn ang="0">
                        <a:pos x="801" y="141"/>
                      </a:cxn>
                      <a:cxn ang="0">
                        <a:pos x="766" y="137"/>
                      </a:cxn>
                      <a:cxn ang="0">
                        <a:pos x="776" y="67"/>
                      </a:cxn>
                      <a:cxn ang="0">
                        <a:pos x="733" y="45"/>
                      </a:cxn>
                      <a:cxn ang="0">
                        <a:pos x="681" y="28"/>
                      </a:cxn>
                      <a:cxn ang="0">
                        <a:pos x="645" y="60"/>
                      </a:cxn>
                      <a:cxn ang="0">
                        <a:pos x="621" y="23"/>
                      </a:cxn>
                    </a:cxnLst>
                    <a:rect l="0" t="0" r="r" b="b"/>
                    <a:pathLst>
                      <a:path w="914" h="727">
                        <a:moveTo>
                          <a:pt x="598" y="0"/>
                        </a:moveTo>
                        <a:lnTo>
                          <a:pt x="548" y="14"/>
                        </a:lnTo>
                        <a:lnTo>
                          <a:pt x="520" y="37"/>
                        </a:lnTo>
                        <a:lnTo>
                          <a:pt x="463" y="19"/>
                        </a:lnTo>
                        <a:lnTo>
                          <a:pt x="430" y="31"/>
                        </a:lnTo>
                        <a:lnTo>
                          <a:pt x="409" y="16"/>
                        </a:lnTo>
                        <a:lnTo>
                          <a:pt x="379" y="11"/>
                        </a:lnTo>
                        <a:lnTo>
                          <a:pt x="322" y="20"/>
                        </a:lnTo>
                        <a:lnTo>
                          <a:pt x="285" y="52"/>
                        </a:lnTo>
                        <a:lnTo>
                          <a:pt x="262" y="35"/>
                        </a:lnTo>
                        <a:lnTo>
                          <a:pt x="241" y="40"/>
                        </a:lnTo>
                        <a:lnTo>
                          <a:pt x="218" y="31"/>
                        </a:lnTo>
                        <a:lnTo>
                          <a:pt x="208" y="27"/>
                        </a:lnTo>
                        <a:lnTo>
                          <a:pt x="210" y="40"/>
                        </a:lnTo>
                        <a:lnTo>
                          <a:pt x="167" y="28"/>
                        </a:lnTo>
                        <a:lnTo>
                          <a:pt x="125" y="52"/>
                        </a:lnTo>
                        <a:lnTo>
                          <a:pt x="108" y="46"/>
                        </a:lnTo>
                        <a:lnTo>
                          <a:pt x="93" y="64"/>
                        </a:lnTo>
                        <a:lnTo>
                          <a:pt x="71" y="71"/>
                        </a:lnTo>
                        <a:lnTo>
                          <a:pt x="50" y="57"/>
                        </a:lnTo>
                        <a:lnTo>
                          <a:pt x="18" y="41"/>
                        </a:lnTo>
                        <a:lnTo>
                          <a:pt x="16" y="67"/>
                        </a:lnTo>
                        <a:lnTo>
                          <a:pt x="25" y="85"/>
                        </a:lnTo>
                        <a:lnTo>
                          <a:pt x="31" y="107"/>
                        </a:lnTo>
                        <a:lnTo>
                          <a:pt x="17" y="128"/>
                        </a:lnTo>
                        <a:lnTo>
                          <a:pt x="1" y="133"/>
                        </a:lnTo>
                        <a:lnTo>
                          <a:pt x="0" y="156"/>
                        </a:lnTo>
                        <a:lnTo>
                          <a:pt x="39" y="179"/>
                        </a:lnTo>
                        <a:lnTo>
                          <a:pt x="67" y="218"/>
                        </a:lnTo>
                        <a:lnTo>
                          <a:pt x="91" y="293"/>
                        </a:lnTo>
                        <a:lnTo>
                          <a:pt x="100" y="321"/>
                        </a:lnTo>
                        <a:lnTo>
                          <a:pt x="109" y="327"/>
                        </a:lnTo>
                        <a:lnTo>
                          <a:pt x="123" y="350"/>
                        </a:lnTo>
                        <a:lnTo>
                          <a:pt x="154" y="399"/>
                        </a:lnTo>
                        <a:lnTo>
                          <a:pt x="167" y="410"/>
                        </a:lnTo>
                        <a:lnTo>
                          <a:pt x="168" y="418"/>
                        </a:lnTo>
                        <a:lnTo>
                          <a:pt x="151" y="427"/>
                        </a:lnTo>
                        <a:lnTo>
                          <a:pt x="130" y="427"/>
                        </a:lnTo>
                        <a:lnTo>
                          <a:pt x="108" y="444"/>
                        </a:lnTo>
                        <a:lnTo>
                          <a:pt x="141" y="447"/>
                        </a:lnTo>
                        <a:lnTo>
                          <a:pt x="139" y="461"/>
                        </a:lnTo>
                        <a:lnTo>
                          <a:pt x="177" y="450"/>
                        </a:lnTo>
                        <a:lnTo>
                          <a:pt x="202" y="482"/>
                        </a:lnTo>
                        <a:lnTo>
                          <a:pt x="179" y="491"/>
                        </a:lnTo>
                        <a:lnTo>
                          <a:pt x="156" y="507"/>
                        </a:lnTo>
                        <a:lnTo>
                          <a:pt x="188" y="537"/>
                        </a:lnTo>
                        <a:lnTo>
                          <a:pt x="218" y="548"/>
                        </a:lnTo>
                        <a:lnTo>
                          <a:pt x="227" y="564"/>
                        </a:lnTo>
                        <a:lnTo>
                          <a:pt x="276" y="595"/>
                        </a:lnTo>
                        <a:lnTo>
                          <a:pt x="313" y="593"/>
                        </a:lnTo>
                        <a:lnTo>
                          <a:pt x="329" y="648"/>
                        </a:lnTo>
                        <a:lnTo>
                          <a:pt x="342" y="690"/>
                        </a:lnTo>
                        <a:lnTo>
                          <a:pt x="431" y="689"/>
                        </a:lnTo>
                        <a:lnTo>
                          <a:pt x="430" y="708"/>
                        </a:lnTo>
                        <a:lnTo>
                          <a:pt x="447" y="727"/>
                        </a:lnTo>
                        <a:lnTo>
                          <a:pt x="466" y="724"/>
                        </a:lnTo>
                        <a:lnTo>
                          <a:pt x="480" y="718"/>
                        </a:lnTo>
                        <a:lnTo>
                          <a:pt x="488" y="697"/>
                        </a:lnTo>
                        <a:lnTo>
                          <a:pt x="510" y="681"/>
                        </a:lnTo>
                        <a:lnTo>
                          <a:pt x="534" y="675"/>
                        </a:lnTo>
                        <a:lnTo>
                          <a:pt x="535" y="665"/>
                        </a:lnTo>
                        <a:lnTo>
                          <a:pt x="560" y="665"/>
                        </a:lnTo>
                        <a:lnTo>
                          <a:pt x="562" y="599"/>
                        </a:lnTo>
                        <a:lnTo>
                          <a:pt x="577" y="610"/>
                        </a:lnTo>
                        <a:lnTo>
                          <a:pt x="592" y="602"/>
                        </a:lnTo>
                        <a:lnTo>
                          <a:pt x="600" y="581"/>
                        </a:lnTo>
                        <a:lnTo>
                          <a:pt x="598" y="560"/>
                        </a:lnTo>
                        <a:lnTo>
                          <a:pt x="608" y="528"/>
                        </a:lnTo>
                        <a:lnTo>
                          <a:pt x="629" y="520"/>
                        </a:lnTo>
                        <a:lnTo>
                          <a:pt x="626" y="482"/>
                        </a:lnTo>
                        <a:lnTo>
                          <a:pt x="634" y="464"/>
                        </a:lnTo>
                        <a:lnTo>
                          <a:pt x="622" y="440"/>
                        </a:lnTo>
                        <a:lnTo>
                          <a:pt x="621" y="429"/>
                        </a:lnTo>
                        <a:lnTo>
                          <a:pt x="600" y="410"/>
                        </a:lnTo>
                        <a:lnTo>
                          <a:pt x="609" y="396"/>
                        </a:lnTo>
                        <a:lnTo>
                          <a:pt x="655" y="443"/>
                        </a:lnTo>
                        <a:lnTo>
                          <a:pt x="696" y="429"/>
                        </a:lnTo>
                        <a:lnTo>
                          <a:pt x="716" y="412"/>
                        </a:lnTo>
                        <a:lnTo>
                          <a:pt x="766" y="448"/>
                        </a:lnTo>
                        <a:lnTo>
                          <a:pt x="789" y="462"/>
                        </a:lnTo>
                        <a:lnTo>
                          <a:pt x="830" y="462"/>
                        </a:lnTo>
                        <a:lnTo>
                          <a:pt x="855" y="477"/>
                        </a:lnTo>
                        <a:lnTo>
                          <a:pt x="856" y="477"/>
                        </a:lnTo>
                        <a:lnTo>
                          <a:pt x="870" y="461"/>
                        </a:lnTo>
                        <a:lnTo>
                          <a:pt x="884" y="456"/>
                        </a:lnTo>
                        <a:lnTo>
                          <a:pt x="885" y="436"/>
                        </a:lnTo>
                        <a:lnTo>
                          <a:pt x="912" y="420"/>
                        </a:lnTo>
                        <a:lnTo>
                          <a:pt x="914" y="368"/>
                        </a:lnTo>
                        <a:lnTo>
                          <a:pt x="900" y="333"/>
                        </a:lnTo>
                        <a:lnTo>
                          <a:pt x="889" y="304"/>
                        </a:lnTo>
                        <a:lnTo>
                          <a:pt x="859" y="308"/>
                        </a:lnTo>
                        <a:lnTo>
                          <a:pt x="852" y="293"/>
                        </a:lnTo>
                        <a:lnTo>
                          <a:pt x="877" y="286"/>
                        </a:lnTo>
                        <a:lnTo>
                          <a:pt x="888" y="277"/>
                        </a:lnTo>
                        <a:lnTo>
                          <a:pt x="888" y="275"/>
                        </a:lnTo>
                        <a:lnTo>
                          <a:pt x="877" y="244"/>
                        </a:lnTo>
                        <a:lnTo>
                          <a:pt x="847" y="218"/>
                        </a:lnTo>
                        <a:lnTo>
                          <a:pt x="845" y="189"/>
                        </a:lnTo>
                        <a:lnTo>
                          <a:pt x="809" y="169"/>
                        </a:lnTo>
                        <a:lnTo>
                          <a:pt x="801" y="141"/>
                        </a:lnTo>
                        <a:lnTo>
                          <a:pt x="789" y="145"/>
                        </a:lnTo>
                        <a:lnTo>
                          <a:pt x="766" y="137"/>
                        </a:lnTo>
                        <a:lnTo>
                          <a:pt x="784" y="107"/>
                        </a:lnTo>
                        <a:lnTo>
                          <a:pt x="776" y="67"/>
                        </a:lnTo>
                        <a:lnTo>
                          <a:pt x="755" y="61"/>
                        </a:lnTo>
                        <a:lnTo>
                          <a:pt x="733" y="45"/>
                        </a:lnTo>
                        <a:lnTo>
                          <a:pt x="708" y="28"/>
                        </a:lnTo>
                        <a:lnTo>
                          <a:pt x="681" y="28"/>
                        </a:lnTo>
                        <a:lnTo>
                          <a:pt x="664" y="48"/>
                        </a:lnTo>
                        <a:lnTo>
                          <a:pt x="645" y="60"/>
                        </a:lnTo>
                        <a:lnTo>
                          <a:pt x="627" y="56"/>
                        </a:lnTo>
                        <a:lnTo>
                          <a:pt x="621" y="23"/>
                        </a:lnTo>
                        <a:lnTo>
                          <a:pt x="598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59" name="Freeform 17"/>
                  <p:cNvSpPr>
                    <a:spLocks/>
                  </p:cNvSpPr>
                  <p:nvPr/>
                </p:nvSpPr>
                <p:spPr bwMode="auto">
                  <a:xfrm>
                    <a:off x="2384244" y="3763277"/>
                    <a:ext cx="1068418" cy="656516"/>
                  </a:xfrm>
                  <a:custGeom>
                    <a:avLst/>
                    <a:gdLst/>
                    <a:ahLst/>
                    <a:cxnLst>
                      <a:cxn ang="0">
                        <a:pos x="568" y="12"/>
                      </a:cxn>
                      <a:cxn ang="0">
                        <a:pos x="539" y="30"/>
                      </a:cxn>
                      <a:cxn ang="0">
                        <a:pos x="535" y="31"/>
                      </a:cxn>
                      <a:cxn ang="0">
                        <a:pos x="500" y="38"/>
                      </a:cxn>
                      <a:cxn ang="0">
                        <a:pos x="451" y="67"/>
                      </a:cxn>
                      <a:cxn ang="0">
                        <a:pos x="411" y="73"/>
                      </a:cxn>
                      <a:cxn ang="0">
                        <a:pos x="331" y="55"/>
                      </a:cxn>
                      <a:cxn ang="0">
                        <a:pos x="272" y="52"/>
                      </a:cxn>
                      <a:cxn ang="0">
                        <a:pos x="217" y="40"/>
                      </a:cxn>
                      <a:cxn ang="0">
                        <a:pos x="239" y="113"/>
                      </a:cxn>
                      <a:cxn ang="0">
                        <a:pos x="205" y="155"/>
                      </a:cxn>
                      <a:cxn ang="0">
                        <a:pos x="134" y="169"/>
                      </a:cxn>
                      <a:cxn ang="0">
                        <a:pos x="83" y="234"/>
                      </a:cxn>
                      <a:cxn ang="0">
                        <a:pos x="25" y="263"/>
                      </a:cxn>
                      <a:cxn ang="0">
                        <a:pos x="0" y="316"/>
                      </a:cxn>
                      <a:cxn ang="0">
                        <a:pos x="83" y="296"/>
                      </a:cxn>
                      <a:cxn ang="0">
                        <a:pos x="127" y="267"/>
                      </a:cxn>
                      <a:cxn ang="0">
                        <a:pos x="197" y="271"/>
                      </a:cxn>
                      <a:cxn ang="0">
                        <a:pos x="217" y="314"/>
                      </a:cxn>
                      <a:cxn ang="0">
                        <a:pos x="259" y="346"/>
                      </a:cxn>
                      <a:cxn ang="0">
                        <a:pos x="272" y="369"/>
                      </a:cxn>
                      <a:cxn ang="0">
                        <a:pos x="361" y="416"/>
                      </a:cxn>
                      <a:cxn ang="0">
                        <a:pos x="405" y="381"/>
                      </a:cxn>
                      <a:cxn ang="0">
                        <a:pos x="430" y="387"/>
                      </a:cxn>
                      <a:cxn ang="0">
                        <a:pos x="427" y="334"/>
                      </a:cxn>
                      <a:cxn ang="0">
                        <a:pos x="418" y="306"/>
                      </a:cxn>
                      <a:cxn ang="0">
                        <a:pos x="410" y="260"/>
                      </a:cxn>
                      <a:cxn ang="0">
                        <a:pos x="447" y="252"/>
                      </a:cxn>
                      <a:cxn ang="0">
                        <a:pos x="493" y="238"/>
                      </a:cxn>
                      <a:cxn ang="0">
                        <a:pos x="492" y="208"/>
                      </a:cxn>
                      <a:cxn ang="0">
                        <a:pos x="485" y="164"/>
                      </a:cxn>
                      <a:cxn ang="0">
                        <a:pos x="538" y="194"/>
                      </a:cxn>
                      <a:cxn ang="0">
                        <a:pos x="575" y="169"/>
                      </a:cxn>
                      <a:cxn ang="0">
                        <a:pos x="634" y="151"/>
                      </a:cxn>
                      <a:cxn ang="0">
                        <a:pos x="672" y="137"/>
                      </a:cxn>
                      <a:cxn ang="0">
                        <a:pos x="598" y="112"/>
                      </a:cxn>
                      <a:cxn ang="0">
                        <a:pos x="576" y="77"/>
                      </a:cxn>
                      <a:cxn ang="0">
                        <a:pos x="577" y="51"/>
                      </a:cxn>
                      <a:cxn ang="0">
                        <a:pos x="585" y="18"/>
                      </a:cxn>
                    </a:cxnLst>
                    <a:rect l="0" t="0" r="r" b="b"/>
                    <a:pathLst>
                      <a:path w="677" h="416">
                        <a:moveTo>
                          <a:pt x="583" y="0"/>
                        </a:moveTo>
                        <a:lnTo>
                          <a:pt x="568" y="12"/>
                        </a:lnTo>
                        <a:lnTo>
                          <a:pt x="561" y="25"/>
                        </a:lnTo>
                        <a:lnTo>
                          <a:pt x="539" y="30"/>
                        </a:lnTo>
                        <a:lnTo>
                          <a:pt x="539" y="26"/>
                        </a:lnTo>
                        <a:lnTo>
                          <a:pt x="535" y="31"/>
                        </a:lnTo>
                        <a:lnTo>
                          <a:pt x="517" y="39"/>
                        </a:lnTo>
                        <a:lnTo>
                          <a:pt x="500" y="38"/>
                        </a:lnTo>
                        <a:lnTo>
                          <a:pt x="467" y="67"/>
                        </a:lnTo>
                        <a:lnTo>
                          <a:pt x="451" y="67"/>
                        </a:lnTo>
                        <a:lnTo>
                          <a:pt x="436" y="60"/>
                        </a:lnTo>
                        <a:lnTo>
                          <a:pt x="411" y="73"/>
                        </a:lnTo>
                        <a:lnTo>
                          <a:pt x="383" y="76"/>
                        </a:lnTo>
                        <a:lnTo>
                          <a:pt x="331" y="55"/>
                        </a:lnTo>
                        <a:lnTo>
                          <a:pt x="309" y="43"/>
                        </a:lnTo>
                        <a:lnTo>
                          <a:pt x="272" y="52"/>
                        </a:lnTo>
                        <a:lnTo>
                          <a:pt x="225" y="37"/>
                        </a:lnTo>
                        <a:lnTo>
                          <a:pt x="217" y="40"/>
                        </a:lnTo>
                        <a:lnTo>
                          <a:pt x="230" y="80"/>
                        </a:lnTo>
                        <a:lnTo>
                          <a:pt x="239" y="113"/>
                        </a:lnTo>
                        <a:lnTo>
                          <a:pt x="233" y="143"/>
                        </a:lnTo>
                        <a:lnTo>
                          <a:pt x="205" y="155"/>
                        </a:lnTo>
                        <a:lnTo>
                          <a:pt x="161" y="154"/>
                        </a:lnTo>
                        <a:lnTo>
                          <a:pt x="134" y="169"/>
                        </a:lnTo>
                        <a:lnTo>
                          <a:pt x="96" y="221"/>
                        </a:lnTo>
                        <a:lnTo>
                          <a:pt x="83" y="234"/>
                        </a:lnTo>
                        <a:lnTo>
                          <a:pt x="47" y="251"/>
                        </a:lnTo>
                        <a:lnTo>
                          <a:pt x="25" y="263"/>
                        </a:lnTo>
                        <a:lnTo>
                          <a:pt x="1" y="287"/>
                        </a:lnTo>
                        <a:lnTo>
                          <a:pt x="0" y="316"/>
                        </a:lnTo>
                        <a:lnTo>
                          <a:pt x="25" y="306"/>
                        </a:lnTo>
                        <a:lnTo>
                          <a:pt x="83" y="296"/>
                        </a:lnTo>
                        <a:lnTo>
                          <a:pt x="113" y="281"/>
                        </a:lnTo>
                        <a:lnTo>
                          <a:pt x="127" y="267"/>
                        </a:lnTo>
                        <a:lnTo>
                          <a:pt x="152" y="264"/>
                        </a:lnTo>
                        <a:lnTo>
                          <a:pt x="197" y="271"/>
                        </a:lnTo>
                        <a:lnTo>
                          <a:pt x="217" y="281"/>
                        </a:lnTo>
                        <a:lnTo>
                          <a:pt x="217" y="314"/>
                        </a:lnTo>
                        <a:lnTo>
                          <a:pt x="225" y="343"/>
                        </a:lnTo>
                        <a:lnTo>
                          <a:pt x="259" y="346"/>
                        </a:lnTo>
                        <a:lnTo>
                          <a:pt x="269" y="358"/>
                        </a:lnTo>
                        <a:lnTo>
                          <a:pt x="272" y="369"/>
                        </a:lnTo>
                        <a:lnTo>
                          <a:pt x="286" y="375"/>
                        </a:lnTo>
                        <a:lnTo>
                          <a:pt x="361" y="416"/>
                        </a:lnTo>
                        <a:lnTo>
                          <a:pt x="375" y="392"/>
                        </a:lnTo>
                        <a:lnTo>
                          <a:pt x="405" y="381"/>
                        </a:lnTo>
                        <a:lnTo>
                          <a:pt x="419" y="383"/>
                        </a:lnTo>
                        <a:lnTo>
                          <a:pt x="430" y="387"/>
                        </a:lnTo>
                        <a:lnTo>
                          <a:pt x="440" y="376"/>
                        </a:lnTo>
                        <a:lnTo>
                          <a:pt x="427" y="334"/>
                        </a:lnTo>
                        <a:lnTo>
                          <a:pt x="419" y="323"/>
                        </a:lnTo>
                        <a:lnTo>
                          <a:pt x="418" y="306"/>
                        </a:lnTo>
                        <a:lnTo>
                          <a:pt x="419" y="289"/>
                        </a:lnTo>
                        <a:lnTo>
                          <a:pt x="410" y="260"/>
                        </a:lnTo>
                        <a:lnTo>
                          <a:pt x="419" y="255"/>
                        </a:lnTo>
                        <a:lnTo>
                          <a:pt x="447" y="252"/>
                        </a:lnTo>
                        <a:lnTo>
                          <a:pt x="476" y="242"/>
                        </a:lnTo>
                        <a:lnTo>
                          <a:pt x="493" y="238"/>
                        </a:lnTo>
                        <a:lnTo>
                          <a:pt x="498" y="230"/>
                        </a:lnTo>
                        <a:lnTo>
                          <a:pt x="492" y="208"/>
                        </a:lnTo>
                        <a:lnTo>
                          <a:pt x="483" y="190"/>
                        </a:lnTo>
                        <a:lnTo>
                          <a:pt x="485" y="164"/>
                        </a:lnTo>
                        <a:lnTo>
                          <a:pt x="517" y="180"/>
                        </a:lnTo>
                        <a:lnTo>
                          <a:pt x="538" y="194"/>
                        </a:lnTo>
                        <a:lnTo>
                          <a:pt x="560" y="187"/>
                        </a:lnTo>
                        <a:lnTo>
                          <a:pt x="575" y="169"/>
                        </a:lnTo>
                        <a:lnTo>
                          <a:pt x="592" y="175"/>
                        </a:lnTo>
                        <a:lnTo>
                          <a:pt x="634" y="151"/>
                        </a:lnTo>
                        <a:lnTo>
                          <a:pt x="677" y="163"/>
                        </a:lnTo>
                        <a:lnTo>
                          <a:pt x="672" y="137"/>
                        </a:lnTo>
                        <a:lnTo>
                          <a:pt x="630" y="112"/>
                        </a:lnTo>
                        <a:lnTo>
                          <a:pt x="598" y="112"/>
                        </a:lnTo>
                        <a:lnTo>
                          <a:pt x="564" y="89"/>
                        </a:lnTo>
                        <a:lnTo>
                          <a:pt x="576" y="77"/>
                        </a:lnTo>
                        <a:lnTo>
                          <a:pt x="569" y="63"/>
                        </a:lnTo>
                        <a:lnTo>
                          <a:pt x="577" y="51"/>
                        </a:lnTo>
                        <a:lnTo>
                          <a:pt x="576" y="37"/>
                        </a:lnTo>
                        <a:lnTo>
                          <a:pt x="585" y="18"/>
                        </a:lnTo>
                        <a:lnTo>
                          <a:pt x="583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0" name="Freeform 18"/>
                  <p:cNvSpPr>
                    <a:spLocks/>
                  </p:cNvSpPr>
                  <p:nvPr/>
                </p:nvSpPr>
                <p:spPr bwMode="auto">
                  <a:xfrm>
                    <a:off x="2295867" y="3297718"/>
                    <a:ext cx="1136278" cy="585499"/>
                  </a:xfrm>
                  <a:custGeom>
                    <a:avLst/>
                    <a:gdLst/>
                    <a:ahLst/>
                    <a:cxnLst>
                      <a:cxn ang="0">
                        <a:pos x="47" y="5"/>
                      </a:cxn>
                      <a:cxn ang="0">
                        <a:pos x="9" y="27"/>
                      </a:cxn>
                      <a:cxn ang="0">
                        <a:pos x="26" y="62"/>
                      </a:cxn>
                      <a:cxn ang="0">
                        <a:pos x="64" y="72"/>
                      </a:cxn>
                      <a:cxn ang="0">
                        <a:pos x="60" y="100"/>
                      </a:cxn>
                      <a:cxn ang="0">
                        <a:pos x="42" y="143"/>
                      </a:cxn>
                      <a:cxn ang="0">
                        <a:pos x="80" y="134"/>
                      </a:cxn>
                      <a:cxn ang="0">
                        <a:pos x="121" y="139"/>
                      </a:cxn>
                      <a:cxn ang="0">
                        <a:pos x="148" y="189"/>
                      </a:cxn>
                      <a:cxn ang="0">
                        <a:pos x="154" y="242"/>
                      </a:cxn>
                      <a:cxn ang="0">
                        <a:pos x="161" y="271"/>
                      </a:cxn>
                      <a:cxn ang="0">
                        <a:pos x="208" y="254"/>
                      </a:cxn>
                      <a:cxn ang="0">
                        <a:pos x="213" y="252"/>
                      </a:cxn>
                      <a:cxn ang="0">
                        <a:pos x="277" y="257"/>
                      </a:cxn>
                      <a:cxn ang="0">
                        <a:pos x="333" y="282"/>
                      </a:cxn>
                      <a:cxn ang="0">
                        <a:pos x="374" y="270"/>
                      </a:cxn>
                      <a:cxn ang="0">
                        <a:pos x="397" y="275"/>
                      </a:cxn>
                      <a:cxn ang="0">
                        <a:pos x="435" y="254"/>
                      </a:cxn>
                      <a:cxn ang="0">
                        <a:pos x="452" y="244"/>
                      </a:cxn>
                      <a:cxn ang="0">
                        <a:pos x="436" y="224"/>
                      </a:cxn>
                      <a:cxn ang="0">
                        <a:pos x="438" y="202"/>
                      </a:cxn>
                      <a:cxn ang="0">
                        <a:pos x="479" y="186"/>
                      </a:cxn>
                      <a:cxn ang="0">
                        <a:pos x="502" y="173"/>
                      </a:cxn>
                      <a:cxn ang="0">
                        <a:pos x="529" y="176"/>
                      </a:cxn>
                      <a:cxn ang="0">
                        <a:pos x="543" y="164"/>
                      </a:cxn>
                      <a:cxn ang="0">
                        <a:pos x="520" y="159"/>
                      </a:cxn>
                      <a:cxn ang="0">
                        <a:pos x="460" y="161"/>
                      </a:cxn>
                      <a:cxn ang="0">
                        <a:pos x="420" y="118"/>
                      </a:cxn>
                      <a:cxn ang="0">
                        <a:pos x="383" y="120"/>
                      </a:cxn>
                      <a:cxn ang="0">
                        <a:pos x="349" y="109"/>
                      </a:cxn>
                      <a:cxn ang="0">
                        <a:pos x="307" y="108"/>
                      </a:cxn>
                      <a:cxn ang="0">
                        <a:pos x="266" y="102"/>
                      </a:cxn>
                      <a:cxn ang="0">
                        <a:pos x="221" y="83"/>
                      </a:cxn>
                      <a:cxn ang="0">
                        <a:pos x="176" y="77"/>
                      </a:cxn>
                      <a:cxn ang="0">
                        <a:pos x="160" y="45"/>
                      </a:cxn>
                      <a:cxn ang="0">
                        <a:pos x="120" y="20"/>
                      </a:cxn>
                      <a:cxn ang="0">
                        <a:pos x="99" y="8"/>
                      </a:cxn>
                    </a:cxnLst>
                    <a:rect l="0" t="0" r="r" b="b"/>
                    <a:pathLst>
                      <a:path w="547" h="282">
                        <a:moveTo>
                          <a:pt x="65" y="0"/>
                        </a:moveTo>
                        <a:cubicBezTo>
                          <a:pt x="47" y="5"/>
                          <a:pt x="47" y="5"/>
                          <a:pt x="47" y="5"/>
                        </a:cubicBezTo>
                        <a:cubicBezTo>
                          <a:pt x="27" y="22"/>
                          <a:pt x="27" y="22"/>
                          <a:pt x="27" y="22"/>
                        </a:cubicBezTo>
                        <a:cubicBezTo>
                          <a:pt x="9" y="27"/>
                          <a:pt x="9" y="27"/>
                          <a:pt x="9" y="27"/>
                        </a:cubicBezTo>
                        <a:cubicBezTo>
                          <a:pt x="0" y="43"/>
                          <a:pt x="0" y="43"/>
                          <a:pt x="0" y="43"/>
                        </a:cubicBezTo>
                        <a:cubicBezTo>
                          <a:pt x="26" y="62"/>
                          <a:pt x="26" y="62"/>
                          <a:pt x="26" y="62"/>
                        </a:cubicBezTo>
                        <a:cubicBezTo>
                          <a:pt x="42" y="71"/>
                          <a:pt x="42" y="71"/>
                          <a:pt x="42" y="71"/>
                        </a:cubicBezTo>
                        <a:cubicBezTo>
                          <a:pt x="64" y="72"/>
                          <a:pt x="64" y="72"/>
                          <a:pt x="64" y="72"/>
                        </a:cubicBezTo>
                        <a:cubicBezTo>
                          <a:pt x="65" y="83"/>
                          <a:pt x="65" y="83"/>
                          <a:pt x="65" y="83"/>
                        </a:cubicBezTo>
                        <a:cubicBezTo>
                          <a:pt x="60" y="100"/>
                          <a:pt x="60" y="100"/>
                          <a:pt x="60" y="100"/>
                        </a:cubicBezTo>
                        <a:cubicBezTo>
                          <a:pt x="44" y="130"/>
                          <a:pt x="44" y="130"/>
                          <a:pt x="44" y="130"/>
                        </a:cubicBezTo>
                        <a:cubicBezTo>
                          <a:pt x="42" y="143"/>
                          <a:pt x="42" y="143"/>
                          <a:pt x="42" y="143"/>
                        </a:cubicBezTo>
                        <a:cubicBezTo>
                          <a:pt x="65" y="155"/>
                          <a:pt x="65" y="155"/>
                          <a:pt x="65" y="155"/>
                        </a:cubicBezTo>
                        <a:cubicBezTo>
                          <a:pt x="80" y="134"/>
                          <a:pt x="80" y="134"/>
                          <a:pt x="80" y="134"/>
                        </a:cubicBezTo>
                        <a:cubicBezTo>
                          <a:pt x="92" y="132"/>
                          <a:pt x="92" y="132"/>
                          <a:pt x="92" y="132"/>
                        </a:cubicBezTo>
                        <a:cubicBezTo>
                          <a:pt x="121" y="139"/>
                          <a:pt x="121" y="139"/>
                          <a:pt x="121" y="139"/>
                        </a:cubicBezTo>
                        <a:cubicBezTo>
                          <a:pt x="144" y="167"/>
                          <a:pt x="144" y="167"/>
                          <a:pt x="144" y="167"/>
                        </a:cubicBezTo>
                        <a:cubicBezTo>
                          <a:pt x="148" y="189"/>
                          <a:pt x="148" y="189"/>
                          <a:pt x="148" y="189"/>
                        </a:cubicBezTo>
                        <a:cubicBezTo>
                          <a:pt x="152" y="204"/>
                          <a:pt x="152" y="204"/>
                          <a:pt x="152" y="204"/>
                        </a:cubicBezTo>
                        <a:cubicBezTo>
                          <a:pt x="154" y="242"/>
                          <a:pt x="154" y="242"/>
                          <a:pt x="154" y="242"/>
                        </a:cubicBezTo>
                        <a:cubicBezTo>
                          <a:pt x="150" y="257"/>
                          <a:pt x="150" y="257"/>
                          <a:pt x="150" y="257"/>
                        </a:cubicBezTo>
                        <a:cubicBezTo>
                          <a:pt x="161" y="271"/>
                          <a:pt x="161" y="271"/>
                          <a:pt x="161" y="271"/>
                        </a:cubicBezTo>
                        <a:cubicBezTo>
                          <a:pt x="188" y="265"/>
                          <a:pt x="188" y="265"/>
                          <a:pt x="188" y="265"/>
                        </a:cubicBezTo>
                        <a:cubicBezTo>
                          <a:pt x="208" y="254"/>
                          <a:pt x="208" y="254"/>
                          <a:pt x="208" y="254"/>
                        </a:cubicBezTo>
                        <a:cubicBezTo>
                          <a:pt x="208" y="254"/>
                          <a:pt x="208" y="254"/>
                          <a:pt x="208" y="254"/>
                        </a:cubicBezTo>
                        <a:cubicBezTo>
                          <a:pt x="213" y="252"/>
                          <a:pt x="213" y="252"/>
                          <a:pt x="213" y="252"/>
                        </a:cubicBezTo>
                        <a:cubicBezTo>
                          <a:pt x="249" y="264"/>
                          <a:pt x="249" y="264"/>
                          <a:pt x="249" y="264"/>
                        </a:cubicBezTo>
                        <a:cubicBezTo>
                          <a:pt x="277" y="257"/>
                          <a:pt x="277" y="257"/>
                          <a:pt x="277" y="257"/>
                        </a:cubicBezTo>
                        <a:cubicBezTo>
                          <a:pt x="294" y="266"/>
                          <a:pt x="294" y="266"/>
                          <a:pt x="294" y="266"/>
                        </a:cubicBezTo>
                        <a:cubicBezTo>
                          <a:pt x="333" y="282"/>
                          <a:pt x="333" y="282"/>
                          <a:pt x="333" y="282"/>
                        </a:cubicBezTo>
                        <a:cubicBezTo>
                          <a:pt x="355" y="280"/>
                          <a:pt x="355" y="280"/>
                          <a:pt x="355" y="280"/>
                        </a:cubicBezTo>
                        <a:cubicBezTo>
                          <a:pt x="374" y="270"/>
                          <a:pt x="374" y="270"/>
                          <a:pt x="374" y="270"/>
                        </a:cubicBezTo>
                        <a:cubicBezTo>
                          <a:pt x="385" y="275"/>
                          <a:pt x="385" y="275"/>
                          <a:pt x="385" y="275"/>
                        </a:cubicBezTo>
                        <a:cubicBezTo>
                          <a:pt x="397" y="275"/>
                          <a:pt x="397" y="275"/>
                          <a:pt x="397" y="275"/>
                        </a:cubicBezTo>
                        <a:cubicBezTo>
                          <a:pt x="422" y="253"/>
                          <a:pt x="422" y="253"/>
                          <a:pt x="422" y="253"/>
                        </a:cubicBezTo>
                        <a:cubicBezTo>
                          <a:pt x="435" y="254"/>
                          <a:pt x="435" y="254"/>
                          <a:pt x="435" y="254"/>
                        </a:cubicBezTo>
                        <a:cubicBezTo>
                          <a:pt x="449" y="248"/>
                          <a:pt x="449" y="248"/>
                          <a:pt x="449" y="248"/>
                        </a:cubicBezTo>
                        <a:cubicBezTo>
                          <a:pt x="452" y="244"/>
                          <a:pt x="452" y="244"/>
                          <a:pt x="452" y="244"/>
                        </a:cubicBezTo>
                        <a:cubicBezTo>
                          <a:pt x="455" y="225"/>
                          <a:pt x="455" y="225"/>
                          <a:pt x="455" y="225"/>
                        </a:cubicBezTo>
                        <a:cubicBezTo>
                          <a:pt x="436" y="224"/>
                          <a:pt x="436" y="224"/>
                          <a:pt x="436" y="224"/>
                        </a:cubicBezTo>
                        <a:cubicBezTo>
                          <a:pt x="430" y="213"/>
                          <a:pt x="430" y="213"/>
                          <a:pt x="430" y="213"/>
                        </a:cubicBezTo>
                        <a:cubicBezTo>
                          <a:pt x="438" y="202"/>
                          <a:pt x="438" y="202"/>
                          <a:pt x="438" y="202"/>
                        </a:cubicBezTo>
                        <a:cubicBezTo>
                          <a:pt x="465" y="193"/>
                          <a:pt x="465" y="193"/>
                          <a:pt x="465" y="193"/>
                        </a:cubicBezTo>
                        <a:cubicBezTo>
                          <a:pt x="479" y="186"/>
                          <a:pt x="479" y="186"/>
                          <a:pt x="479" y="186"/>
                        </a:cubicBezTo>
                        <a:cubicBezTo>
                          <a:pt x="491" y="186"/>
                          <a:pt x="491" y="186"/>
                          <a:pt x="491" y="186"/>
                        </a:cubicBezTo>
                        <a:cubicBezTo>
                          <a:pt x="502" y="173"/>
                          <a:pt x="502" y="173"/>
                          <a:pt x="502" y="173"/>
                        </a:cubicBezTo>
                        <a:cubicBezTo>
                          <a:pt x="512" y="177"/>
                          <a:pt x="512" y="177"/>
                          <a:pt x="512" y="177"/>
                        </a:cubicBezTo>
                        <a:cubicBezTo>
                          <a:pt x="529" y="176"/>
                          <a:pt x="529" y="176"/>
                          <a:pt x="529" y="176"/>
                        </a:cubicBezTo>
                        <a:cubicBezTo>
                          <a:pt x="531" y="182"/>
                          <a:pt x="531" y="182"/>
                          <a:pt x="531" y="182"/>
                        </a:cubicBezTo>
                        <a:cubicBezTo>
                          <a:pt x="543" y="164"/>
                          <a:pt x="543" y="164"/>
                          <a:pt x="543" y="164"/>
                        </a:cubicBezTo>
                        <a:cubicBezTo>
                          <a:pt x="547" y="158"/>
                          <a:pt x="547" y="158"/>
                          <a:pt x="547" y="158"/>
                        </a:cubicBezTo>
                        <a:cubicBezTo>
                          <a:pt x="520" y="159"/>
                          <a:pt x="520" y="159"/>
                          <a:pt x="520" y="159"/>
                        </a:cubicBezTo>
                        <a:cubicBezTo>
                          <a:pt x="488" y="160"/>
                          <a:pt x="488" y="160"/>
                          <a:pt x="488" y="160"/>
                        </a:cubicBezTo>
                        <a:cubicBezTo>
                          <a:pt x="460" y="161"/>
                          <a:pt x="460" y="161"/>
                          <a:pt x="460" y="161"/>
                        </a:cubicBezTo>
                        <a:cubicBezTo>
                          <a:pt x="451" y="133"/>
                          <a:pt x="451" y="133"/>
                          <a:pt x="451" y="133"/>
                        </a:cubicBezTo>
                        <a:cubicBezTo>
                          <a:pt x="420" y="118"/>
                          <a:pt x="420" y="118"/>
                          <a:pt x="420" y="118"/>
                        </a:cubicBezTo>
                        <a:cubicBezTo>
                          <a:pt x="417" y="120"/>
                          <a:pt x="411" y="122"/>
                          <a:pt x="411" y="122"/>
                        </a:cubicBezTo>
                        <a:cubicBezTo>
                          <a:pt x="383" y="120"/>
                          <a:pt x="383" y="120"/>
                          <a:pt x="383" y="120"/>
                        </a:cubicBezTo>
                        <a:cubicBezTo>
                          <a:pt x="360" y="106"/>
                          <a:pt x="360" y="106"/>
                          <a:pt x="360" y="106"/>
                        </a:cubicBezTo>
                        <a:cubicBezTo>
                          <a:pt x="349" y="109"/>
                          <a:pt x="349" y="109"/>
                          <a:pt x="349" y="109"/>
                        </a:cubicBezTo>
                        <a:cubicBezTo>
                          <a:pt x="321" y="99"/>
                          <a:pt x="321" y="99"/>
                          <a:pt x="321" y="99"/>
                        </a:cubicBezTo>
                        <a:cubicBezTo>
                          <a:pt x="307" y="108"/>
                          <a:pt x="307" y="108"/>
                          <a:pt x="307" y="108"/>
                        </a:cubicBezTo>
                        <a:cubicBezTo>
                          <a:pt x="274" y="95"/>
                          <a:pt x="274" y="95"/>
                          <a:pt x="274" y="95"/>
                        </a:cubicBezTo>
                        <a:cubicBezTo>
                          <a:pt x="266" y="102"/>
                          <a:pt x="266" y="102"/>
                          <a:pt x="266" y="102"/>
                        </a:cubicBezTo>
                        <a:cubicBezTo>
                          <a:pt x="246" y="87"/>
                          <a:pt x="246" y="87"/>
                          <a:pt x="246" y="87"/>
                        </a:cubicBezTo>
                        <a:cubicBezTo>
                          <a:pt x="221" y="83"/>
                          <a:pt x="221" y="83"/>
                          <a:pt x="221" y="83"/>
                        </a:cubicBezTo>
                        <a:cubicBezTo>
                          <a:pt x="191" y="88"/>
                          <a:pt x="191" y="88"/>
                          <a:pt x="191" y="88"/>
                        </a:cubicBezTo>
                        <a:cubicBezTo>
                          <a:pt x="176" y="77"/>
                          <a:pt x="176" y="77"/>
                          <a:pt x="176" y="77"/>
                        </a:cubicBezTo>
                        <a:cubicBezTo>
                          <a:pt x="175" y="64"/>
                          <a:pt x="175" y="64"/>
                          <a:pt x="175" y="64"/>
                        </a:cubicBezTo>
                        <a:cubicBezTo>
                          <a:pt x="160" y="45"/>
                          <a:pt x="160" y="45"/>
                          <a:pt x="160" y="45"/>
                        </a:cubicBezTo>
                        <a:cubicBezTo>
                          <a:pt x="150" y="44"/>
                          <a:pt x="150" y="44"/>
                          <a:pt x="150" y="44"/>
                        </a:cubicBezTo>
                        <a:cubicBezTo>
                          <a:pt x="120" y="20"/>
                          <a:pt x="120" y="20"/>
                          <a:pt x="120" y="20"/>
                        </a:cubicBezTo>
                        <a:cubicBezTo>
                          <a:pt x="109" y="22"/>
                          <a:pt x="109" y="22"/>
                          <a:pt x="109" y="22"/>
                        </a:cubicBezTo>
                        <a:cubicBezTo>
                          <a:pt x="99" y="8"/>
                          <a:pt x="99" y="8"/>
                          <a:pt x="99" y="8"/>
                        </a:cubicBezTo>
                        <a:lnTo>
                          <a:pt x="65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1" name="Freeform 19"/>
                  <p:cNvSpPr>
                    <a:spLocks/>
                  </p:cNvSpPr>
                  <p:nvPr/>
                </p:nvSpPr>
                <p:spPr bwMode="auto">
                  <a:xfrm>
                    <a:off x="2065455" y="3386095"/>
                    <a:ext cx="695971" cy="760675"/>
                  </a:xfrm>
                  <a:custGeom>
                    <a:avLst/>
                    <a:gdLst/>
                    <a:ahLst/>
                    <a:cxnLst>
                      <a:cxn ang="0">
                        <a:pos x="146" y="0"/>
                      </a:cxn>
                      <a:cxn ang="0">
                        <a:pos x="137" y="16"/>
                      </a:cxn>
                      <a:cxn ang="0">
                        <a:pos x="121" y="37"/>
                      </a:cxn>
                      <a:cxn ang="0">
                        <a:pos x="115" y="57"/>
                      </a:cxn>
                      <a:cxn ang="0">
                        <a:pos x="100" y="66"/>
                      </a:cxn>
                      <a:cxn ang="0">
                        <a:pos x="77" y="66"/>
                      </a:cxn>
                      <a:cxn ang="0">
                        <a:pos x="77" y="78"/>
                      </a:cxn>
                      <a:cxn ang="0">
                        <a:pos x="91" y="118"/>
                      </a:cxn>
                      <a:cxn ang="0">
                        <a:pos x="85" y="140"/>
                      </a:cxn>
                      <a:cxn ang="0">
                        <a:pos x="87" y="174"/>
                      </a:cxn>
                      <a:cxn ang="0">
                        <a:pos x="94" y="228"/>
                      </a:cxn>
                      <a:cxn ang="0">
                        <a:pos x="87" y="257"/>
                      </a:cxn>
                      <a:cxn ang="0">
                        <a:pos x="70" y="276"/>
                      </a:cxn>
                      <a:cxn ang="0">
                        <a:pos x="58" y="304"/>
                      </a:cxn>
                      <a:cxn ang="0">
                        <a:pos x="57" y="323"/>
                      </a:cxn>
                      <a:cxn ang="0">
                        <a:pos x="27" y="364"/>
                      </a:cxn>
                      <a:cxn ang="0">
                        <a:pos x="15" y="390"/>
                      </a:cxn>
                      <a:cxn ang="0">
                        <a:pos x="6" y="402"/>
                      </a:cxn>
                      <a:cxn ang="0">
                        <a:pos x="3" y="437"/>
                      </a:cxn>
                      <a:cxn ang="0">
                        <a:pos x="0" y="468"/>
                      </a:cxn>
                      <a:cxn ang="0">
                        <a:pos x="0" y="477"/>
                      </a:cxn>
                      <a:cxn ang="0">
                        <a:pos x="13" y="477"/>
                      </a:cxn>
                      <a:cxn ang="0">
                        <a:pos x="56" y="482"/>
                      </a:cxn>
                      <a:cxn ang="0">
                        <a:pos x="69" y="473"/>
                      </a:cxn>
                      <a:cxn ang="0">
                        <a:pos x="88" y="476"/>
                      </a:cxn>
                      <a:cxn ang="0">
                        <a:pos x="99" y="482"/>
                      </a:cxn>
                      <a:cxn ang="0">
                        <a:pos x="145" y="468"/>
                      </a:cxn>
                      <a:cxn ang="0">
                        <a:pos x="174" y="444"/>
                      </a:cxn>
                      <a:cxn ang="0">
                        <a:pos x="194" y="441"/>
                      </a:cxn>
                      <a:cxn ang="0">
                        <a:pos x="223" y="452"/>
                      </a:cxn>
                      <a:cxn ang="0">
                        <a:pos x="248" y="462"/>
                      </a:cxn>
                      <a:cxn ang="0">
                        <a:pos x="285" y="462"/>
                      </a:cxn>
                      <a:cxn ang="0">
                        <a:pos x="291" y="466"/>
                      </a:cxn>
                      <a:cxn ang="0">
                        <a:pos x="298" y="460"/>
                      </a:cxn>
                      <a:cxn ang="0">
                        <a:pos x="336" y="408"/>
                      </a:cxn>
                      <a:cxn ang="0">
                        <a:pos x="363" y="393"/>
                      </a:cxn>
                      <a:cxn ang="0">
                        <a:pos x="407" y="394"/>
                      </a:cxn>
                      <a:cxn ang="0">
                        <a:pos x="435" y="382"/>
                      </a:cxn>
                      <a:cxn ang="0">
                        <a:pos x="441" y="352"/>
                      </a:cxn>
                      <a:cxn ang="0">
                        <a:pos x="432" y="319"/>
                      </a:cxn>
                      <a:cxn ang="0">
                        <a:pos x="419" y="279"/>
                      </a:cxn>
                      <a:cxn ang="0">
                        <a:pos x="420" y="278"/>
                      </a:cxn>
                      <a:cxn ang="0">
                        <a:pos x="420" y="278"/>
                      </a:cxn>
                      <a:cxn ang="0">
                        <a:pos x="394" y="293"/>
                      </a:cxn>
                      <a:cxn ang="0">
                        <a:pos x="358" y="301"/>
                      </a:cxn>
                      <a:cxn ang="0">
                        <a:pos x="344" y="282"/>
                      </a:cxn>
                      <a:cxn ang="0">
                        <a:pos x="349" y="262"/>
                      </a:cxn>
                      <a:cxn ang="0">
                        <a:pos x="346" y="212"/>
                      </a:cxn>
                      <a:cxn ang="0">
                        <a:pos x="341" y="193"/>
                      </a:cxn>
                      <a:cxn ang="0">
                        <a:pos x="336" y="164"/>
                      </a:cxn>
                      <a:cxn ang="0">
                        <a:pos x="306" y="127"/>
                      </a:cxn>
                      <a:cxn ang="0">
                        <a:pos x="267" y="118"/>
                      </a:cxn>
                      <a:cxn ang="0">
                        <a:pos x="252" y="120"/>
                      </a:cxn>
                      <a:cxn ang="0">
                        <a:pos x="232" y="148"/>
                      </a:cxn>
                      <a:cxn ang="0">
                        <a:pos x="202" y="132"/>
                      </a:cxn>
                      <a:cxn ang="0">
                        <a:pos x="204" y="115"/>
                      </a:cxn>
                      <a:cxn ang="0">
                        <a:pos x="225" y="75"/>
                      </a:cxn>
                      <a:cxn ang="0">
                        <a:pos x="232" y="53"/>
                      </a:cxn>
                      <a:cxn ang="0">
                        <a:pos x="231" y="39"/>
                      </a:cxn>
                      <a:cxn ang="0">
                        <a:pos x="202" y="37"/>
                      </a:cxn>
                      <a:cxn ang="0">
                        <a:pos x="181" y="25"/>
                      </a:cxn>
                      <a:cxn ang="0">
                        <a:pos x="146" y="0"/>
                      </a:cxn>
                    </a:cxnLst>
                    <a:rect l="0" t="0" r="r" b="b"/>
                    <a:pathLst>
                      <a:path w="441" h="482">
                        <a:moveTo>
                          <a:pt x="146" y="0"/>
                        </a:moveTo>
                        <a:lnTo>
                          <a:pt x="137" y="16"/>
                        </a:lnTo>
                        <a:lnTo>
                          <a:pt x="121" y="37"/>
                        </a:lnTo>
                        <a:lnTo>
                          <a:pt x="115" y="57"/>
                        </a:lnTo>
                        <a:lnTo>
                          <a:pt x="100" y="66"/>
                        </a:lnTo>
                        <a:lnTo>
                          <a:pt x="77" y="66"/>
                        </a:lnTo>
                        <a:lnTo>
                          <a:pt x="77" y="78"/>
                        </a:lnTo>
                        <a:lnTo>
                          <a:pt x="91" y="118"/>
                        </a:lnTo>
                        <a:lnTo>
                          <a:pt x="85" y="140"/>
                        </a:lnTo>
                        <a:lnTo>
                          <a:pt x="87" y="174"/>
                        </a:lnTo>
                        <a:lnTo>
                          <a:pt x="94" y="228"/>
                        </a:lnTo>
                        <a:lnTo>
                          <a:pt x="87" y="257"/>
                        </a:lnTo>
                        <a:lnTo>
                          <a:pt x="70" y="276"/>
                        </a:lnTo>
                        <a:lnTo>
                          <a:pt x="58" y="304"/>
                        </a:lnTo>
                        <a:lnTo>
                          <a:pt x="57" y="323"/>
                        </a:lnTo>
                        <a:lnTo>
                          <a:pt x="27" y="364"/>
                        </a:lnTo>
                        <a:lnTo>
                          <a:pt x="15" y="390"/>
                        </a:lnTo>
                        <a:lnTo>
                          <a:pt x="6" y="402"/>
                        </a:lnTo>
                        <a:lnTo>
                          <a:pt x="3" y="437"/>
                        </a:lnTo>
                        <a:lnTo>
                          <a:pt x="0" y="468"/>
                        </a:lnTo>
                        <a:lnTo>
                          <a:pt x="0" y="477"/>
                        </a:lnTo>
                        <a:lnTo>
                          <a:pt x="13" y="477"/>
                        </a:lnTo>
                        <a:lnTo>
                          <a:pt x="56" y="482"/>
                        </a:lnTo>
                        <a:lnTo>
                          <a:pt x="69" y="473"/>
                        </a:lnTo>
                        <a:lnTo>
                          <a:pt x="88" y="476"/>
                        </a:lnTo>
                        <a:lnTo>
                          <a:pt x="99" y="482"/>
                        </a:lnTo>
                        <a:lnTo>
                          <a:pt x="145" y="468"/>
                        </a:lnTo>
                        <a:lnTo>
                          <a:pt x="174" y="444"/>
                        </a:lnTo>
                        <a:lnTo>
                          <a:pt x="194" y="441"/>
                        </a:lnTo>
                        <a:lnTo>
                          <a:pt x="223" y="452"/>
                        </a:lnTo>
                        <a:lnTo>
                          <a:pt x="248" y="462"/>
                        </a:lnTo>
                        <a:lnTo>
                          <a:pt x="285" y="462"/>
                        </a:lnTo>
                        <a:lnTo>
                          <a:pt x="291" y="466"/>
                        </a:lnTo>
                        <a:lnTo>
                          <a:pt x="298" y="460"/>
                        </a:lnTo>
                        <a:lnTo>
                          <a:pt x="336" y="408"/>
                        </a:lnTo>
                        <a:lnTo>
                          <a:pt x="363" y="393"/>
                        </a:lnTo>
                        <a:lnTo>
                          <a:pt x="407" y="394"/>
                        </a:lnTo>
                        <a:lnTo>
                          <a:pt x="435" y="382"/>
                        </a:lnTo>
                        <a:lnTo>
                          <a:pt x="441" y="352"/>
                        </a:lnTo>
                        <a:lnTo>
                          <a:pt x="432" y="319"/>
                        </a:lnTo>
                        <a:lnTo>
                          <a:pt x="419" y="279"/>
                        </a:lnTo>
                        <a:lnTo>
                          <a:pt x="420" y="278"/>
                        </a:lnTo>
                        <a:lnTo>
                          <a:pt x="420" y="278"/>
                        </a:lnTo>
                        <a:lnTo>
                          <a:pt x="394" y="293"/>
                        </a:lnTo>
                        <a:lnTo>
                          <a:pt x="358" y="301"/>
                        </a:lnTo>
                        <a:lnTo>
                          <a:pt x="344" y="282"/>
                        </a:lnTo>
                        <a:lnTo>
                          <a:pt x="349" y="262"/>
                        </a:lnTo>
                        <a:lnTo>
                          <a:pt x="346" y="212"/>
                        </a:lnTo>
                        <a:lnTo>
                          <a:pt x="341" y="193"/>
                        </a:lnTo>
                        <a:lnTo>
                          <a:pt x="336" y="164"/>
                        </a:lnTo>
                        <a:lnTo>
                          <a:pt x="306" y="127"/>
                        </a:lnTo>
                        <a:lnTo>
                          <a:pt x="267" y="118"/>
                        </a:lnTo>
                        <a:lnTo>
                          <a:pt x="252" y="120"/>
                        </a:lnTo>
                        <a:lnTo>
                          <a:pt x="232" y="148"/>
                        </a:lnTo>
                        <a:lnTo>
                          <a:pt x="202" y="132"/>
                        </a:lnTo>
                        <a:lnTo>
                          <a:pt x="204" y="115"/>
                        </a:lnTo>
                        <a:lnTo>
                          <a:pt x="225" y="75"/>
                        </a:lnTo>
                        <a:lnTo>
                          <a:pt x="232" y="53"/>
                        </a:lnTo>
                        <a:lnTo>
                          <a:pt x="231" y="39"/>
                        </a:lnTo>
                        <a:lnTo>
                          <a:pt x="202" y="37"/>
                        </a:lnTo>
                        <a:lnTo>
                          <a:pt x="181" y="25"/>
                        </a:lnTo>
                        <a:lnTo>
                          <a:pt x="146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2" name="Freeform 20"/>
                  <p:cNvSpPr>
                    <a:spLocks/>
                  </p:cNvSpPr>
                  <p:nvPr/>
                </p:nvSpPr>
                <p:spPr bwMode="auto">
                  <a:xfrm>
                    <a:off x="1680383" y="4082066"/>
                    <a:ext cx="1058949" cy="1002134"/>
                  </a:xfrm>
                  <a:custGeom>
                    <a:avLst/>
                    <a:gdLst/>
                    <a:ahLst/>
                    <a:cxnLst>
                      <a:cxn ang="0">
                        <a:pos x="318" y="2"/>
                      </a:cxn>
                      <a:cxn ang="0">
                        <a:pos x="261" y="31"/>
                      </a:cxn>
                      <a:cxn ang="0">
                        <a:pos x="238" y="24"/>
                      </a:cxn>
                      <a:cxn ang="0">
                        <a:pos x="196" y="27"/>
                      </a:cxn>
                      <a:cxn ang="0">
                        <a:pos x="186" y="52"/>
                      </a:cxn>
                      <a:cxn ang="0">
                        <a:pos x="172" y="100"/>
                      </a:cxn>
                      <a:cxn ang="0">
                        <a:pos x="163" y="137"/>
                      </a:cxn>
                      <a:cxn ang="0">
                        <a:pos x="164" y="166"/>
                      </a:cxn>
                      <a:cxn ang="0">
                        <a:pos x="172" y="198"/>
                      </a:cxn>
                      <a:cxn ang="0">
                        <a:pos x="146" y="243"/>
                      </a:cxn>
                      <a:cxn ang="0">
                        <a:pos x="145" y="293"/>
                      </a:cxn>
                      <a:cxn ang="0">
                        <a:pos x="109" y="345"/>
                      </a:cxn>
                      <a:cxn ang="0">
                        <a:pos x="76" y="360"/>
                      </a:cxn>
                      <a:cxn ang="0">
                        <a:pos x="32" y="401"/>
                      </a:cxn>
                      <a:cxn ang="0">
                        <a:pos x="11" y="471"/>
                      </a:cxn>
                      <a:cxn ang="0">
                        <a:pos x="48" y="478"/>
                      </a:cxn>
                      <a:cxn ang="0">
                        <a:pos x="39" y="456"/>
                      </a:cxn>
                      <a:cxn ang="0">
                        <a:pos x="67" y="454"/>
                      </a:cxn>
                      <a:cxn ang="0">
                        <a:pos x="106" y="429"/>
                      </a:cxn>
                      <a:cxn ang="0">
                        <a:pos x="156" y="408"/>
                      </a:cxn>
                      <a:cxn ang="0">
                        <a:pos x="194" y="392"/>
                      </a:cxn>
                      <a:cxn ang="0">
                        <a:pos x="222" y="376"/>
                      </a:cxn>
                      <a:cxn ang="0">
                        <a:pos x="255" y="393"/>
                      </a:cxn>
                      <a:cxn ang="0">
                        <a:pos x="266" y="380"/>
                      </a:cxn>
                      <a:cxn ang="0">
                        <a:pos x="279" y="377"/>
                      </a:cxn>
                      <a:cxn ang="0">
                        <a:pos x="266" y="359"/>
                      </a:cxn>
                      <a:cxn ang="0">
                        <a:pos x="288" y="337"/>
                      </a:cxn>
                      <a:cxn ang="0">
                        <a:pos x="312" y="357"/>
                      </a:cxn>
                      <a:cxn ang="0">
                        <a:pos x="346" y="413"/>
                      </a:cxn>
                      <a:cxn ang="0">
                        <a:pos x="377" y="398"/>
                      </a:cxn>
                      <a:cxn ang="0">
                        <a:pos x="380" y="365"/>
                      </a:cxn>
                      <a:cxn ang="0">
                        <a:pos x="427" y="381"/>
                      </a:cxn>
                      <a:cxn ang="0">
                        <a:pos x="451" y="351"/>
                      </a:cxn>
                      <a:cxn ang="0">
                        <a:pos x="460" y="329"/>
                      </a:cxn>
                      <a:cxn ang="0">
                        <a:pos x="434" y="292"/>
                      </a:cxn>
                      <a:cxn ang="0">
                        <a:pos x="412" y="266"/>
                      </a:cxn>
                      <a:cxn ang="0">
                        <a:pos x="439" y="262"/>
                      </a:cxn>
                      <a:cxn ang="0">
                        <a:pos x="467" y="269"/>
                      </a:cxn>
                      <a:cxn ang="0">
                        <a:pos x="493" y="245"/>
                      </a:cxn>
                      <a:cxn ang="0">
                        <a:pos x="462" y="206"/>
                      </a:cxn>
                      <a:cxn ang="0">
                        <a:pos x="483" y="175"/>
                      </a:cxn>
                      <a:cxn ang="0">
                        <a:pos x="486" y="144"/>
                      </a:cxn>
                      <a:cxn ang="0">
                        <a:pos x="510" y="107"/>
                      </a:cxn>
                      <a:cxn ang="0">
                        <a:pos x="504" y="85"/>
                      </a:cxn>
                      <a:cxn ang="0">
                        <a:pos x="489" y="52"/>
                      </a:cxn>
                      <a:cxn ang="0">
                        <a:pos x="436" y="49"/>
                      </a:cxn>
                      <a:cxn ang="0">
                        <a:pos x="402" y="71"/>
                      </a:cxn>
                      <a:cxn ang="0">
                        <a:pos x="339" y="86"/>
                      </a:cxn>
                      <a:cxn ang="0">
                        <a:pos x="358" y="46"/>
                      </a:cxn>
                      <a:cxn ang="0">
                        <a:pos x="402" y="24"/>
                      </a:cxn>
                      <a:cxn ang="0">
                        <a:pos x="402" y="16"/>
                      </a:cxn>
                      <a:cxn ang="0">
                        <a:pos x="355" y="8"/>
                      </a:cxn>
                    </a:cxnLst>
                    <a:rect l="0" t="0" r="r" b="b"/>
                    <a:pathLst>
                      <a:path w="510" h="482">
                        <a:moveTo>
                          <a:pt x="333" y="0"/>
                        </a:moveTo>
                        <a:cubicBezTo>
                          <a:pt x="318" y="2"/>
                          <a:pt x="318" y="2"/>
                          <a:pt x="318" y="2"/>
                        </a:cubicBezTo>
                        <a:cubicBezTo>
                          <a:pt x="296" y="20"/>
                          <a:pt x="296" y="20"/>
                          <a:pt x="296" y="20"/>
                        </a:cubicBezTo>
                        <a:cubicBezTo>
                          <a:pt x="261" y="31"/>
                          <a:pt x="261" y="31"/>
                          <a:pt x="261" y="31"/>
                        </a:cubicBezTo>
                        <a:cubicBezTo>
                          <a:pt x="253" y="26"/>
                          <a:pt x="253" y="26"/>
                          <a:pt x="253" y="26"/>
                        </a:cubicBezTo>
                        <a:cubicBezTo>
                          <a:pt x="238" y="24"/>
                          <a:pt x="238" y="24"/>
                          <a:pt x="238" y="24"/>
                        </a:cubicBezTo>
                        <a:cubicBezTo>
                          <a:pt x="228" y="31"/>
                          <a:pt x="228" y="31"/>
                          <a:pt x="228" y="31"/>
                        </a:cubicBezTo>
                        <a:cubicBezTo>
                          <a:pt x="196" y="27"/>
                          <a:pt x="196" y="27"/>
                          <a:pt x="196" y="27"/>
                        </a:cubicBezTo>
                        <a:cubicBezTo>
                          <a:pt x="186" y="27"/>
                          <a:pt x="186" y="27"/>
                          <a:pt x="186" y="27"/>
                        </a:cubicBezTo>
                        <a:cubicBezTo>
                          <a:pt x="186" y="52"/>
                          <a:pt x="186" y="52"/>
                          <a:pt x="186" y="52"/>
                        </a:cubicBezTo>
                        <a:cubicBezTo>
                          <a:pt x="174" y="86"/>
                          <a:pt x="174" y="86"/>
                          <a:pt x="174" y="86"/>
                        </a:cubicBezTo>
                        <a:cubicBezTo>
                          <a:pt x="172" y="100"/>
                          <a:pt x="172" y="100"/>
                          <a:pt x="172" y="100"/>
                        </a:cubicBezTo>
                        <a:cubicBezTo>
                          <a:pt x="159" y="118"/>
                          <a:pt x="159" y="118"/>
                          <a:pt x="159" y="118"/>
                        </a:cubicBezTo>
                        <a:cubicBezTo>
                          <a:pt x="163" y="137"/>
                          <a:pt x="163" y="137"/>
                          <a:pt x="163" y="137"/>
                        </a:cubicBezTo>
                        <a:cubicBezTo>
                          <a:pt x="167" y="160"/>
                          <a:pt x="167" y="160"/>
                          <a:pt x="167" y="160"/>
                        </a:cubicBezTo>
                        <a:cubicBezTo>
                          <a:pt x="164" y="166"/>
                          <a:pt x="164" y="166"/>
                          <a:pt x="164" y="166"/>
                        </a:cubicBezTo>
                        <a:cubicBezTo>
                          <a:pt x="174" y="184"/>
                          <a:pt x="174" y="184"/>
                          <a:pt x="174" y="184"/>
                        </a:cubicBezTo>
                        <a:cubicBezTo>
                          <a:pt x="172" y="198"/>
                          <a:pt x="172" y="198"/>
                          <a:pt x="172" y="198"/>
                        </a:cubicBezTo>
                        <a:cubicBezTo>
                          <a:pt x="157" y="212"/>
                          <a:pt x="157" y="212"/>
                          <a:pt x="157" y="212"/>
                        </a:cubicBezTo>
                        <a:cubicBezTo>
                          <a:pt x="146" y="243"/>
                          <a:pt x="146" y="243"/>
                          <a:pt x="146" y="243"/>
                        </a:cubicBezTo>
                        <a:cubicBezTo>
                          <a:pt x="145" y="266"/>
                          <a:pt x="145" y="266"/>
                          <a:pt x="145" y="266"/>
                        </a:cubicBezTo>
                        <a:cubicBezTo>
                          <a:pt x="145" y="293"/>
                          <a:pt x="145" y="293"/>
                          <a:pt x="145" y="293"/>
                        </a:cubicBezTo>
                        <a:cubicBezTo>
                          <a:pt x="134" y="320"/>
                          <a:pt x="134" y="320"/>
                          <a:pt x="134" y="320"/>
                        </a:cubicBezTo>
                        <a:cubicBezTo>
                          <a:pt x="109" y="345"/>
                          <a:pt x="109" y="345"/>
                          <a:pt x="109" y="345"/>
                        </a:cubicBezTo>
                        <a:cubicBezTo>
                          <a:pt x="89" y="360"/>
                          <a:pt x="89" y="360"/>
                          <a:pt x="89" y="360"/>
                        </a:cubicBezTo>
                        <a:cubicBezTo>
                          <a:pt x="76" y="360"/>
                          <a:pt x="76" y="360"/>
                          <a:pt x="76" y="360"/>
                        </a:cubicBezTo>
                        <a:cubicBezTo>
                          <a:pt x="46" y="380"/>
                          <a:pt x="46" y="380"/>
                          <a:pt x="46" y="380"/>
                        </a:cubicBezTo>
                        <a:cubicBezTo>
                          <a:pt x="32" y="401"/>
                          <a:pt x="32" y="401"/>
                          <a:pt x="32" y="401"/>
                        </a:cubicBezTo>
                        <a:cubicBezTo>
                          <a:pt x="0" y="459"/>
                          <a:pt x="0" y="459"/>
                          <a:pt x="0" y="459"/>
                        </a:cubicBezTo>
                        <a:cubicBezTo>
                          <a:pt x="11" y="471"/>
                          <a:pt x="11" y="471"/>
                          <a:pt x="11" y="471"/>
                        </a:cubicBezTo>
                        <a:cubicBezTo>
                          <a:pt x="20" y="482"/>
                          <a:pt x="20" y="482"/>
                          <a:pt x="20" y="482"/>
                        </a:cubicBezTo>
                        <a:cubicBezTo>
                          <a:pt x="48" y="478"/>
                          <a:pt x="48" y="478"/>
                          <a:pt x="48" y="478"/>
                        </a:cubicBezTo>
                        <a:cubicBezTo>
                          <a:pt x="50" y="462"/>
                          <a:pt x="50" y="462"/>
                          <a:pt x="50" y="462"/>
                        </a:cubicBezTo>
                        <a:cubicBezTo>
                          <a:pt x="39" y="456"/>
                          <a:pt x="39" y="456"/>
                          <a:pt x="39" y="456"/>
                        </a:cubicBezTo>
                        <a:cubicBezTo>
                          <a:pt x="42" y="451"/>
                          <a:pt x="42" y="451"/>
                          <a:pt x="42" y="451"/>
                        </a:cubicBezTo>
                        <a:cubicBezTo>
                          <a:pt x="67" y="454"/>
                          <a:pt x="67" y="454"/>
                          <a:pt x="67" y="454"/>
                        </a:cubicBezTo>
                        <a:cubicBezTo>
                          <a:pt x="97" y="445"/>
                          <a:pt x="97" y="445"/>
                          <a:pt x="97" y="445"/>
                        </a:cubicBezTo>
                        <a:cubicBezTo>
                          <a:pt x="106" y="429"/>
                          <a:pt x="106" y="429"/>
                          <a:pt x="106" y="429"/>
                        </a:cubicBezTo>
                        <a:cubicBezTo>
                          <a:pt x="138" y="418"/>
                          <a:pt x="138" y="418"/>
                          <a:pt x="138" y="418"/>
                        </a:cubicBezTo>
                        <a:cubicBezTo>
                          <a:pt x="156" y="408"/>
                          <a:pt x="156" y="408"/>
                          <a:pt x="156" y="408"/>
                        </a:cubicBezTo>
                        <a:cubicBezTo>
                          <a:pt x="173" y="409"/>
                          <a:pt x="173" y="409"/>
                          <a:pt x="173" y="409"/>
                        </a:cubicBezTo>
                        <a:cubicBezTo>
                          <a:pt x="194" y="392"/>
                          <a:pt x="194" y="392"/>
                          <a:pt x="194" y="392"/>
                        </a:cubicBezTo>
                        <a:cubicBezTo>
                          <a:pt x="198" y="375"/>
                          <a:pt x="198" y="375"/>
                          <a:pt x="198" y="375"/>
                        </a:cubicBezTo>
                        <a:cubicBezTo>
                          <a:pt x="222" y="376"/>
                          <a:pt x="222" y="376"/>
                          <a:pt x="222" y="376"/>
                        </a:cubicBezTo>
                        <a:cubicBezTo>
                          <a:pt x="235" y="391"/>
                          <a:pt x="235" y="391"/>
                          <a:pt x="235" y="391"/>
                        </a:cubicBezTo>
                        <a:cubicBezTo>
                          <a:pt x="255" y="393"/>
                          <a:pt x="255" y="393"/>
                          <a:pt x="255" y="393"/>
                        </a:cubicBezTo>
                        <a:cubicBezTo>
                          <a:pt x="275" y="390"/>
                          <a:pt x="275" y="390"/>
                          <a:pt x="275" y="390"/>
                        </a:cubicBezTo>
                        <a:cubicBezTo>
                          <a:pt x="266" y="380"/>
                          <a:pt x="266" y="380"/>
                          <a:pt x="266" y="380"/>
                        </a:cubicBezTo>
                        <a:cubicBezTo>
                          <a:pt x="267" y="370"/>
                          <a:pt x="267" y="370"/>
                          <a:pt x="267" y="370"/>
                        </a:cubicBezTo>
                        <a:cubicBezTo>
                          <a:pt x="279" y="377"/>
                          <a:pt x="279" y="377"/>
                          <a:pt x="279" y="377"/>
                        </a:cubicBezTo>
                        <a:cubicBezTo>
                          <a:pt x="275" y="363"/>
                          <a:pt x="275" y="363"/>
                          <a:pt x="275" y="363"/>
                        </a:cubicBezTo>
                        <a:cubicBezTo>
                          <a:pt x="266" y="359"/>
                          <a:pt x="266" y="359"/>
                          <a:pt x="266" y="359"/>
                        </a:cubicBezTo>
                        <a:cubicBezTo>
                          <a:pt x="274" y="335"/>
                          <a:pt x="274" y="335"/>
                          <a:pt x="274" y="335"/>
                        </a:cubicBezTo>
                        <a:cubicBezTo>
                          <a:pt x="288" y="337"/>
                          <a:pt x="288" y="337"/>
                          <a:pt x="288" y="337"/>
                        </a:cubicBezTo>
                        <a:cubicBezTo>
                          <a:pt x="303" y="330"/>
                          <a:pt x="303" y="330"/>
                          <a:pt x="303" y="330"/>
                        </a:cubicBezTo>
                        <a:cubicBezTo>
                          <a:pt x="312" y="357"/>
                          <a:pt x="312" y="357"/>
                          <a:pt x="312" y="357"/>
                        </a:cubicBezTo>
                        <a:cubicBezTo>
                          <a:pt x="339" y="390"/>
                          <a:pt x="339" y="390"/>
                          <a:pt x="339" y="390"/>
                        </a:cubicBezTo>
                        <a:cubicBezTo>
                          <a:pt x="346" y="413"/>
                          <a:pt x="346" y="413"/>
                          <a:pt x="346" y="413"/>
                        </a:cubicBezTo>
                        <a:cubicBezTo>
                          <a:pt x="350" y="417"/>
                          <a:pt x="350" y="417"/>
                          <a:pt x="350" y="417"/>
                        </a:cubicBezTo>
                        <a:cubicBezTo>
                          <a:pt x="377" y="398"/>
                          <a:pt x="377" y="398"/>
                          <a:pt x="377" y="398"/>
                        </a:cubicBezTo>
                        <a:cubicBezTo>
                          <a:pt x="377" y="369"/>
                          <a:pt x="377" y="369"/>
                          <a:pt x="377" y="369"/>
                        </a:cubicBezTo>
                        <a:cubicBezTo>
                          <a:pt x="380" y="365"/>
                          <a:pt x="380" y="365"/>
                          <a:pt x="380" y="365"/>
                        </a:cubicBezTo>
                        <a:cubicBezTo>
                          <a:pt x="403" y="391"/>
                          <a:pt x="403" y="391"/>
                          <a:pt x="403" y="391"/>
                        </a:cubicBezTo>
                        <a:cubicBezTo>
                          <a:pt x="403" y="391"/>
                          <a:pt x="422" y="381"/>
                          <a:pt x="427" y="381"/>
                        </a:cubicBezTo>
                        <a:cubicBezTo>
                          <a:pt x="432" y="381"/>
                          <a:pt x="441" y="381"/>
                          <a:pt x="441" y="381"/>
                        </a:cubicBezTo>
                        <a:cubicBezTo>
                          <a:pt x="451" y="351"/>
                          <a:pt x="451" y="351"/>
                          <a:pt x="451" y="351"/>
                        </a:cubicBezTo>
                        <a:cubicBezTo>
                          <a:pt x="462" y="343"/>
                          <a:pt x="462" y="343"/>
                          <a:pt x="462" y="343"/>
                        </a:cubicBezTo>
                        <a:cubicBezTo>
                          <a:pt x="460" y="329"/>
                          <a:pt x="460" y="329"/>
                          <a:pt x="460" y="329"/>
                        </a:cubicBezTo>
                        <a:cubicBezTo>
                          <a:pt x="445" y="316"/>
                          <a:pt x="445" y="316"/>
                          <a:pt x="445" y="316"/>
                        </a:cubicBezTo>
                        <a:cubicBezTo>
                          <a:pt x="434" y="292"/>
                          <a:pt x="434" y="292"/>
                          <a:pt x="434" y="292"/>
                        </a:cubicBezTo>
                        <a:cubicBezTo>
                          <a:pt x="413" y="279"/>
                          <a:pt x="413" y="279"/>
                          <a:pt x="413" y="279"/>
                        </a:cubicBezTo>
                        <a:cubicBezTo>
                          <a:pt x="412" y="266"/>
                          <a:pt x="412" y="266"/>
                          <a:pt x="412" y="266"/>
                        </a:cubicBezTo>
                        <a:cubicBezTo>
                          <a:pt x="422" y="262"/>
                          <a:pt x="422" y="262"/>
                          <a:pt x="422" y="262"/>
                        </a:cubicBezTo>
                        <a:cubicBezTo>
                          <a:pt x="439" y="262"/>
                          <a:pt x="439" y="262"/>
                          <a:pt x="439" y="262"/>
                        </a:cubicBezTo>
                        <a:cubicBezTo>
                          <a:pt x="456" y="275"/>
                          <a:pt x="456" y="275"/>
                          <a:pt x="456" y="275"/>
                        </a:cubicBezTo>
                        <a:cubicBezTo>
                          <a:pt x="467" y="269"/>
                          <a:pt x="467" y="269"/>
                          <a:pt x="467" y="269"/>
                        </a:cubicBezTo>
                        <a:cubicBezTo>
                          <a:pt x="471" y="257"/>
                          <a:pt x="471" y="257"/>
                          <a:pt x="471" y="257"/>
                        </a:cubicBezTo>
                        <a:cubicBezTo>
                          <a:pt x="493" y="245"/>
                          <a:pt x="493" y="245"/>
                          <a:pt x="493" y="245"/>
                        </a:cubicBezTo>
                        <a:cubicBezTo>
                          <a:pt x="491" y="226"/>
                          <a:pt x="491" y="226"/>
                          <a:pt x="491" y="226"/>
                        </a:cubicBezTo>
                        <a:cubicBezTo>
                          <a:pt x="462" y="206"/>
                          <a:pt x="462" y="206"/>
                          <a:pt x="462" y="206"/>
                        </a:cubicBezTo>
                        <a:cubicBezTo>
                          <a:pt x="464" y="195"/>
                          <a:pt x="464" y="195"/>
                          <a:pt x="464" y="195"/>
                        </a:cubicBezTo>
                        <a:cubicBezTo>
                          <a:pt x="483" y="175"/>
                          <a:pt x="483" y="175"/>
                          <a:pt x="483" y="175"/>
                        </a:cubicBezTo>
                        <a:cubicBezTo>
                          <a:pt x="490" y="158"/>
                          <a:pt x="490" y="158"/>
                          <a:pt x="490" y="158"/>
                        </a:cubicBezTo>
                        <a:cubicBezTo>
                          <a:pt x="486" y="144"/>
                          <a:pt x="486" y="144"/>
                          <a:pt x="486" y="144"/>
                        </a:cubicBezTo>
                        <a:cubicBezTo>
                          <a:pt x="485" y="120"/>
                          <a:pt x="485" y="120"/>
                          <a:pt x="485" y="120"/>
                        </a:cubicBezTo>
                        <a:cubicBezTo>
                          <a:pt x="510" y="107"/>
                          <a:pt x="510" y="107"/>
                          <a:pt x="510" y="107"/>
                        </a:cubicBezTo>
                        <a:cubicBezTo>
                          <a:pt x="510" y="107"/>
                          <a:pt x="510" y="107"/>
                          <a:pt x="510" y="107"/>
                        </a:cubicBezTo>
                        <a:cubicBezTo>
                          <a:pt x="504" y="85"/>
                          <a:pt x="504" y="85"/>
                          <a:pt x="504" y="85"/>
                        </a:cubicBezTo>
                        <a:cubicBezTo>
                          <a:pt x="504" y="60"/>
                          <a:pt x="504" y="60"/>
                          <a:pt x="504" y="60"/>
                        </a:cubicBezTo>
                        <a:cubicBezTo>
                          <a:pt x="489" y="52"/>
                          <a:pt x="489" y="52"/>
                          <a:pt x="489" y="52"/>
                        </a:cubicBezTo>
                        <a:cubicBezTo>
                          <a:pt x="455" y="47"/>
                          <a:pt x="455" y="47"/>
                          <a:pt x="455" y="47"/>
                        </a:cubicBezTo>
                        <a:cubicBezTo>
                          <a:pt x="436" y="49"/>
                          <a:pt x="436" y="49"/>
                          <a:pt x="436" y="49"/>
                        </a:cubicBezTo>
                        <a:cubicBezTo>
                          <a:pt x="425" y="60"/>
                          <a:pt x="425" y="60"/>
                          <a:pt x="425" y="60"/>
                        </a:cubicBezTo>
                        <a:cubicBezTo>
                          <a:pt x="402" y="71"/>
                          <a:pt x="402" y="71"/>
                          <a:pt x="402" y="71"/>
                        </a:cubicBezTo>
                        <a:cubicBezTo>
                          <a:pt x="358" y="79"/>
                          <a:pt x="358" y="79"/>
                          <a:pt x="358" y="79"/>
                        </a:cubicBezTo>
                        <a:cubicBezTo>
                          <a:pt x="339" y="86"/>
                          <a:pt x="339" y="86"/>
                          <a:pt x="339" y="86"/>
                        </a:cubicBezTo>
                        <a:cubicBezTo>
                          <a:pt x="340" y="64"/>
                          <a:pt x="340" y="64"/>
                          <a:pt x="340" y="64"/>
                        </a:cubicBezTo>
                        <a:cubicBezTo>
                          <a:pt x="358" y="46"/>
                          <a:pt x="358" y="46"/>
                          <a:pt x="358" y="46"/>
                        </a:cubicBezTo>
                        <a:cubicBezTo>
                          <a:pt x="375" y="37"/>
                          <a:pt x="375" y="37"/>
                          <a:pt x="375" y="37"/>
                        </a:cubicBezTo>
                        <a:cubicBezTo>
                          <a:pt x="402" y="24"/>
                          <a:pt x="402" y="24"/>
                          <a:pt x="402" y="24"/>
                        </a:cubicBezTo>
                        <a:cubicBezTo>
                          <a:pt x="407" y="19"/>
                          <a:pt x="407" y="19"/>
                          <a:pt x="407" y="19"/>
                        </a:cubicBezTo>
                        <a:cubicBezTo>
                          <a:pt x="402" y="16"/>
                          <a:pt x="402" y="16"/>
                          <a:pt x="402" y="16"/>
                        </a:cubicBezTo>
                        <a:cubicBezTo>
                          <a:pt x="374" y="16"/>
                          <a:pt x="374" y="16"/>
                          <a:pt x="374" y="16"/>
                        </a:cubicBezTo>
                        <a:cubicBezTo>
                          <a:pt x="355" y="8"/>
                          <a:pt x="355" y="8"/>
                          <a:pt x="355" y="8"/>
                        </a:cubicBezTo>
                        <a:lnTo>
                          <a:pt x="333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3" name="Freeform 21"/>
                  <p:cNvSpPr>
                    <a:spLocks/>
                  </p:cNvSpPr>
                  <p:nvPr/>
                </p:nvSpPr>
                <p:spPr bwMode="auto">
                  <a:xfrm>
                    <a:off x="2406338" y="4138880"/>
                    <a:ext cx="1240437" cy="1058948"/>
                  </a:xfrm>
                  <a:custGeom>
                    <a:avLst/>
                    <a:gdLst/>
                    <a:ahLst/>
                    <a:cxnLst>
                      <a:cxn ang="0">
                        <a:pos x="351" y="3"/>
                      </a:cxn>
                      <a:cxn ang="0">
                        <a:pos x="308" y="13"/>
                      </a:cxn>
                      <a:cxn ang="0">
                        <a:pos x="308" y="39"/>
                      </a:cxn>
                      <a:cxn ang="0">
                        <a:pos x="308" y="65"/>
                      </a:cxn>
                      <a:cxn ang="0">
                        <a:pos x="324" y="105"/>
                      </a:cxn>
                      <a:cxn ang="0">
                        <a:pos x="308" y="110"/>
                      </a:cxn>
                      <a:cxn ang="0">
                        <a:pos x="274" y="117"/>
                      </a:cxn>
                      <a:cxn ang="0">
                        <a:pos x="207" y="104"/>
                      </a:cxn>
                      <a:cxn ang="0">
                        <a:pos x="194" y="91"/>
                      </a:cxn>
                      <a:cxn ang="0">
                        <a:pos x="160" y="80"/>
                      </a:cxn>
                      <a:cxn ang="0">
                        <a:pos x="136" y="117"/>
                      </a:cxn>
                      <a:cxn ang="0">
                        <a:pos x="133" y="148"/>
                      </a:cxn>
                      <a:cxn ang="0">
                        <a:pos x="112" y="179"/>
                      </a:cxn>
                      <a:cxn ang="0">
                        <a:pos x="143" y="218"/>
                      </a:cxn>
                      <a:cxn ang="0">
                        <a:pos x="117" y="242"/>
                      </a:cxn>
                      <a:cxn ang="0">
                        <a:pos x="89" y="235"/>
                      </a:cxn>
                      <a:cxn ang="0">
                        <a:pos x="62" y="239"/>
                      </a:cxn>
                      <a:cxn ang="0">
                        <a:pos x="84" y="265"/>
                      </a:cxn>
                      <a:cxn ang="0">
                        <a:pos x="110" y="302"/>
                      </a:cxn>
                      <a:cxn ang="0">
                        <a:pos x="101" y="324"/>
                      </a:cxn>
                      <a:cxn ang="0">
                        <a:pos x="77" y="354"/>
                      </a:cxn>
                      <a:cxn ang="0">
                        <a:pos x="30" y="338"/>
                      </a:cxn>
                      <a:cxn ang="0">
                        <a:pos x="27" y="371"/>
                      </a:cxn>
                      <a:cxn ang="0">
                        <a:pos x="7" y="399"/>
                      </a:cxn>
                      <a:cxn ang="0">
                        <a:pos x="24" y="430"/>
                      </a:cxn>
                      <a:cxn ang="0">
                        <a:pos x="52" y="416"/>
                      </a:cxn>
                      <a:cxn ang="0">
                        <a:pos x="93" y="443"/>
                      </a:cxn>
                      <a:cxn ang="0">
                        <a:pos x="154" y="452"/>
                      </a:cxn>
                      <a:cxn ang="0">
                        <a:pos x="192" y="505"/>
                      </a:cxn>
                      <a:cxn ang="0">
                        <a:pos x="240" y="504"/>
                      </a:cxn>
                      <a:cxn ang="0">
                        <a:pos x="262" y="498"/>
                      </a:cxn>
                      <a:cxn ang="0">
                        <a:pos x="292" y="510"/>
                      </a:cxn>
                      <a:cxn ang="0">
                        <a:pos x="296" y="496"/>
                      </a:cxn>
                      <a:cxn ang="0">
                        <a:pos x="328" y="481"/>
                      </a:cxn>
                      <a:cxn ang="0">
                        <a:pos x="334" y="499"/>
                      </a:cxn>
                      <a:cxn ang="0">
                        <a:pos x="333" y="470"/>
                      </a:cxn>
                      <a:cxn ang="0">
                        <a:pos x="328" y="444"/>
                      </a:cxn>
                      <a:cxn ang="0">
                        <a:pos x="339" y="433"/>
                      </a:cxn>
                      <a:cxn ang="0">
                        <a:pos x="380" y="421"/>
                      </a:cxn>
                      <a:cxn ang="0">
                        <a:pos x="398" y="430"/>
                      </a:cxn>
                      <a:cxn ang="0">
                        <a:pos x="428" y="433"/>
                      </a:cxn>
                      <a:cxn ang="0">
                        <a:pos x="455" y="454"/>
                      </a:cxn>
                      <a:cxn ang="0">
                        <a:pos x="468" y="446"/>
                      </a:cxn>
                      <a:cxn ang="0">
                        <a:pos x="506" y="444"/>
                      </a:cxn>
                      <a:cxn ang="0">
                        <a:pos x="537" y="416"/>
                      </a:cxn>
                      <a:cxn ang="0">
                        <a:pos x="557" y="411"/>
                      </a:cxn>
                      <a:cxn ang="0">
                        <a:pos x="597" y="416"/>
                      </a:cxn>
                      <a:cxn ang="0">
                        <a:pos x="582" y="363"/>
                      </a:cxn>
                      <a:cxn ang="0">
                        <a:pos x="517" y="341"/>
                      </a:cxn>
                      <a:cxn ang="0">
                        <a:pos x="487" y="321"/>
                      </a:cxn>
                      <a:cxn ang="0">
                        <a:pos x="480" y="286"/>
                      </a:cxn>
                      <a:cxn ang="0">
                        <a:pos x="479" y="255"/>
                      </a:cxn>
                      <a:cxn ang="0">
                        <a:pos x="451" y="252"/>
                      </a:cxn>
                      <a:cxn ang="0">
                        <a:pos x="443" y="237"/>
                      </a:cxn>
                      <a:cxn ang="0">
                        <a:pos x="472" y="230"/>
                      </a:cxn>
                      <a:cxn ang="0">
                        <a:pos x="461" y="216"/>
                      </a:cxn>
                      <a:cxn ang="0">
                        <a:pos x="427" y="161"/>
                      </a:cxn>
                      <a:cxn ang="0">
                        <a:pos x="413" y="135"/>
                      </a:cxn>
                      <a:cxn ang="0">
                        <a:pos x="374" y="49"/>
                      </a:cxn>
                      <a:cxn ang="0">
                        <a:pos x="345" y="14"/>
                      </a:cxn>
                      <a:cxn ang="0">
                        <a:pos x="364" y="0"/>
                      </a:cxn>
                    </a:cxnLst>
                    <a:rect l="0" t="0" r="r" b="b"/>
                    <a:pathLst>
                      <a:path w="597" h="510">
                        <a:moveTo>
                          <a:pt x="364" y="0"/>
                        </a:moveTo>
                        <a:cubicBezTo>
                          <a:pt x="351" y="3"/>
                          <a:pt x="351" y="3"/>
                          <a:pt x="351" y="3"/>
                        </a:cubicBezTo>
                        <a:cubicBezTo>
                          <a:pt x="329" y="11"/>
                          <a:pt x="329" y="11"/>
                          <a:pt x="329" y="11"/>
                        </a:cubicBezTo>
                        <a:cubicBezTo>
                          <a:pt x="308" y="13"/>
                          <a:pt x="308" y="13"/>
                          <a:pt x="308" y="13"/>
                        </a:cubicBezTo>
                        <a:cubicBezTo>
                          <a:pt x="301" y="17"/>
                          <a:pt x="301" y="17"/>
                          <a:pt x="301" y="17"/>
                        </a:cubicBezTo>
                        <a:cubicBezTo>
                          <a:pt x="308" y="39"/>
                          <a:pt x="308" y="39"/>
                          <a:pt x="308" y="39"/>
                        </a:cubicBezTo>
                        <a:cubicBezTo>
                          <a:pt x="307" y="52"/>
                          <a:pt x="307" y="52"/>
                          <a:pt x="307" y="52"/>
                        </a:cubicBezTo>
                        <a:cubicBezTo>
                          <a:pt x="308" y="65"/>
                          <a:pt x="308" y="65"/>
                          <a:pt x="308" y="65"/>
                        </a:cubicBezTo>
                        <a:cubicBezTo>
                          <a:pt x="314" y="73"/>
                          <a:pt x="314" y="73"/>
                          <a:pt x="314" y="73"/>
                        </a:cubicBezTo>
                        <a:cubicBezTo>
                          <a:pt x="324" y="105"/>
                          <a:pt x="324" y="105"/>
                          <a:pt x="324" y="105"/>
                        </a:cubicBezTo>
                        <a:cubicBezTo>
                          <a:pt x="316" y="113"/>
                          <a:pt x="316" y="113"/>
                          <a:pt x="316" y="113"/>
                        </a:cubicBezTo>
                        <a:cubicBezTo>
                          <a:pt x="308" y="110"/>
                          <a:pt x="308" y="110"/>
                          <a:pt x="308" y="110"/>
                        </a:cubicBezTo>
                        <a:cubicBezTo>
                          <a:pt x="297" y="109"/>
                          <a:pt x="297" y="109"/>
                          <a:pt x="297" y="109"/>
                        </a:cubicBezTo>
                        <a:cubicBezTo>
                          <a:pt x="274" y="117"/>
                          <a:pt x="274" y="117"/>
                          <a:pt x="274" y="117"/>
                        </a:cubicBezTo>
                        <a:cubicBezTo>
                          <a:pt x="264" y="135"/>
                          <a:pt x="264" y="135"/>
                          <a:pt x="264" y="135"/>
                        </a:cubicBezTo>
                        <a:cubicBezTo>
                          <a:pt x="207" y="104"/>
                          <a:pt x="207" y="104"/>
                          <a:pt x="207" y="104"/>
                        </a:cubicBezTo>
                        <a:cubicBezTo>
                          <a:pt x="196" y="100"/>
                          <a:pt x="196" y="100"/>
                          <a:pt x="196" y="100"/>
                        </a:cubicBezTo>
                        <a:cubicBezTo>
                          <a:pt x="194" y="91"/>
                          <a:pt x="194" y="91"/>
                          <a:pt x="194" y="91"/>
                        </a:cubicBezTo>
                        <a:cubicBezTo>
                          <a:pt x="186" y="82"/>
                          <a:pt x="186" y="82"/>
                          <a:pt x="186" y="82"/>
                        </a:cubicBezTo>
                        <a:cubicBezTo>
                          <a:pt x="160" y="80"/>
                          <a:pt x="160" y="80"/>
                          <a:pt x="160" y="80"/>
                        </a:cubicBezTo>
                        <a:cubicBezTo>
                          <a:pt x="135" y="93"/>
                          <a:pt x="135" y="93"/>
                          <a:pt x="135" y="93"/>
                        </a:cubicBezTo>
                        <a:cubicBezTo>
                          <a:pt x="136" y="117"/>
                          <a:pt x="136" y="117"/>
                          <a:pt x="136" y="117"/>
                        </a:cubicBezTo>
                        <a:cubicBezTo>
                          <a:pt x="140" y="131"/>
                          <a:pt x="140" y="131"/>
                          <a:pt x="140" y="131"/>
                        </a:cubicBezTo>
                        <a:cubicBezTo>
                          <a:pt x="133" y="148"/>
                          <a:pt x="133" y="148"/>
                          <a:pt x="133" y="148"/>
                        </a:cubicBezTo>
                        <a:cubicBezTo>
                          <a:pt x="114" y="168"/>
                          <a:pt x="114" y="168"/>
                          <a:pt x="114" y="168"/>
                        </a:cubicBezTo>
                        <a:cubicBezTo>
                          <a:pt x="112" y="179"/>
                          <a:pt x="112" y="179"/>
                          <a:pt x="112" y="179"/>
                        </a:cubicBezTo>
                        <a:cubicBezTo>
                          <a:pt x="141" y="199"/>
                          <a:pt x="141" y="199"/>
                          <a:pt x="141" y="199"/>
                        </a:cubicBezTo>
                        <a:cubicBezTo>
                          <a:pt x="143" y="218"/>
                          <a:pt x="143" y="218"/>
                          <a:pt x="143" y="218"/>
                        </a:cubicBezTo>
                        <a:cubicBezTo>
                          <a:pt x="121" y="230"/>
                          <a:pt x="121" y="230"/>
                          <a:pt x="121" y="230"/>
                        </a:cubicBezTo>
                        <a:cubicBezTo>
                          <a:pt x="117" y="242"/>
                          <a:pt x="117" y="242"/>
                          <a:pt x="117" y="242"/>
                        </a:cubicBezTo>
                        <a:cubicBezTo>
                          <a:pt x="106" y="248"/>
                          <a:pt x="106" y="248"/>
                          <a:pt x="106" y="248"/>
                        </a:cubicBezTo>
                        <a:cubicBezTo>
                          <a:pt x="89" y="235"/>
                          <a:pt x="89" y="235"/>
                          <a:pt x="89" y="235"/>
                        </a:cubicBezTo>
                        <a:cubicBezTo>
                          <a:pt x="72" y="235"/>
                          <a:pt x="72" y="235"/>
                          <a:pt x="72" y="235"/>
                        </a:cubicBezTo>
                        <a:cubicBezTo>
                          <a:pt x="62" y="239"/>
                          <a:pt x="62" y="239"/>
                          <a:pt x="62" y="239"/>
                        </a:cubicBezTo>
                        <a:cubicBezTo>
                          <a:pt x="63" y="252"/>
                          <a:pt x="63" y="252"/>
                          <a:pt x="63" y="252"/>
                        </a:cubicBezTo>
                        <a:cubicBezTo>
                          <a:pt x="84" y="265"/>
                          <a:pt x="84" y="265"/>
                          <a:pt x="84" y="265"/>
                        </a:cubicBezTo>
                        <a:cubicBezTo>
                          <a:pt x="95" y="289"/>
                          <a:pt x="95" y="289"/>
                          <a:pt x="95" y="289"/>
                        </a:cubicBezTo>
                        <a:cubicBezTo>
                          <a:pt x="110" y="302"/>
                          <a:pt x="110" y="302"/>
                          <a:pt x="110" y="302"/>
                        </a:cubicBezTo>
                        <a:cubicBezTo>
                          <a:pt x="112" y="316"/>
                          <a:pt x="112" y="316"/>
                          <a:pt x="112" y="316"/>
                        </a:cubicBezTo>
                        <a:cubicBezTo>
                          <a:pt x="101" y="324"/>
                          <a:pt x="101" y="324"/>
                          <a:pt x="101" y="324"/>
                        </a:cubicBezTo>
                        <a:cubicBezTo>
                          <a:pt x="91" y="354"/>
                          <a:pt x="91" y="354"/>
                          <a:pt x="91" y="354"/>
                        </a:cubicBezTo>
                        <a:cubicBezTo>
                          <a:pt x="91" y="354"/>
                          <a:pt x="82" y="354"/>
                          <a:pt x="77" y="354"/>
                        </a:cubicBezTo>
                        <a:cubicBezTo>
                          <a:pt x="72" y="354"/>
                          <a:pt x="53" y="364"/>
                          <a:pt x="53" y="364"/>
                        </a:cubicBezTo>
                        <a:cubicBezTo>
                          <a:pt x="30" y="338"/>
                          <a:pt x="30" y="338"/>
                          <a:pt x="30" y="338"/>
                        </a:cubicBezTo>
                        <a:cubicBezTo>
                          <a:pt x="27" y="342"/>
                          <a:pt x="27" y="342"/>
                          <a:pt x="27" y="342"/>
                        </a:cubicBezTo>
                        <a:cubicBezTo>
                          <a:pt x="27" y="371"/>
                          <a:pt x="27" y="371"/>
                          <a:pt x="27" y="371"/>
                        </a:cubicBezTo>
                        <a:cubicBezTo>
                          <a:pt x="0" y="390"/>
                          <a:pt x="0" y="390"/>
                          <a:pt x="0" y="390"/>
                        </a:cubicBezTo>
                        <a:cubicBezTo>
                          <a:pt x="7" y="399"/>
                          <a:pt x="7" y="399"/>
                          <a:pt x="7" y="399"/>
                        </a:cubicBezTo>
                        <a:cubicBezTo>
                          <a:pt x="14" y="426"/>
                          <a:pt x="14" y="426"/>
                          <a:pt x="14" y="426"/>
                        </a:cubicBezTo>
                        <a:cubicBezTo>
                          <a:pt x="24" y="430"/>
                          <a:pt x="24" y="430"/>
                          <a:pt x="24" y="430"/>
                        </a:cubicBezTo>
                        <a:cubicBezTo>
                          <a:pt x="39" y="408"/>
                          <a:pt x="39" y="408"/>
                          <a:pt x="39" y="408"/>
                        </a:cubicBezTo>
                        <a:cubicBezTo>
                          <a:pt x="52" y="416"/>
                          <a:pt x="52" y="416"/>
                          <a:pt x="52" y="416"/>
                        </a:cubicBezTo>
                        <a:cubicBezTo>
                          <a:pt x="62" y="447"/>
                          <a:pt x="62" y="447"/>
                          <a:pt x="62" y="447"/>
                        </a:cubicBezTo>
                        <a:cubicBezTo>
                          <a:pt x="93" y="443"/>
                          <a:pt x="93" y="443"/>
                          <a:pt x="93" y="443"/>
                        </a:cubicBezTo>
                        <a:cubicBezTo>
                          <a:pt x="116" y="462"/>
                          <a:pt x="116" y="462"/>
                          <a:pt x="116" y="462"/>
                        </a:cubicBezTo>
                        <a:cubicBezTo>
                          <a:pt x="154" y="452"/>
                          <a:pt x="154" y="452"/>
                          <a:pt x="154" y="452"/>
                        </a:cubicBezTo>
                        <a:cubicBezTo>
                          <a:pt x="189" y="496"/>
                          <a:pt x="189" y="496"/>
                          <a:pt x="189" y="496"/>
                        </a:cubicBezTo>
                        <a:cubicBezTo>
                          <a:pt x="192" y="505"/>
                          <a:pt x="192" y="505"/>
                          <a:pt x="192" y="505"/>
                        </a:cubicBezTo>
                        <a:cubicBezTo>
                          <a:pt x="213" y="509"/>
                          <a:pt x="213" y="509"/>
                          <a:pt x="213" y="509"/>
                        </a:cubicBezTo>
                        <a:cubicBezTo>
                          <a:pt x="240" y="504"/>
                          <a:pt x="240" y="504"/>
                          <a:pt x="240" y="504"/>
                        </a:cubicBezTo>
                        <a:cubicBezTo>
                          <a:pt x="240" y="488"/>
                          <a:pt x="240" y="488"/>
                          <a:pt x="240" y="488"/>
                        </a:cubicBezTo>
                        <a:cubicBezTo>
                          <a:pt x="262" y="498"/>
                          <a:pt x="262" y="498"/>
                          <a:pt x="262" y="498"/>
                        </a:cubicBezTo>
                        <a:cubicBezTo>
                          <a:pt x="274" y="509"/>
                          <a:pt x="274" y="509"/>
                          <a:pt x="274" y="509"/>
                        </a:cubicBezTo>
                        <a:cubicBezTo>
                          <a:pt x="292" y="510"/>
                          <a:pt x="292" y="510"/>
                          <a:pt x="292" y="510"/>
                        </a:cubicBezTo>
                        <a:cubicBezTo>
                          <a:pt x="290" y="508"/>
                          <a:pt x="290" y="508"/>
                          <a:pt x="290" y="508"/>
                        </a:cubicBezTo>
                        <a:cubicBezTo>
                          <a:pt x="296" y="496"/>
                          <a:pt x="296" y="496"/>
                          <a:pt x="296" y="496"/>
                        </a:cubicBezTo>
                        <a:cubicBezTo>
                          <a:pt x="321" y="479"/>
                          <a:pt x="321" y="479"/>
                          <a:pt x="321" y="479"/>
                        </a:cubicBezTo>
                        <a:cubicBezTo>
                          <a:pt x="328" y="481"/>
                          <a:pt x="328" y="481"/>
                          <a:pt x="328" y="481"/>
                        </a:cubicBezTo>
                        <a:cubicBezTo>
                          <a:pt x="327" y="498"/>
                          <a:pt x="327" y="498"/>
                          <a:pt x="327" y="498"/>
                        </a:cubicBezTo>
                        <a:cubicBezTo>
                          <a:pt x="334" y="499"/>
                          <a:pt x="334" y="499"/>
                          <a:pt x="334" y="499"/>
                        </a:cubicBezTo>
                        <a:cubicBezTo>
                          <a:pt x="339" y="495"/>
                          <a:pt x="339" y="495"/>
                          <a:pt x="339" y="495"/>
                        </a:cubicBezTo>
                        <a:cubicBezTo>
                          <a:pt x="333" y="470"/>
                          <a:pt x="333" y="470"/>
                          <a:pt x="333" y="470"/>
                        </a:cubicBezTo>
                        <a:cubicBezTo>
                          <a:pt x="328" y="462"/>
                          <a:pt x="328" y="462"/>
                          <a:pt x="328" y="462"/>
                        </a:cubicBezTo>
                        <a:cubicBezTo>
                          <a:pt x="328" y="444"/>
                          <a:pt x="328" y="444"/>
                          <a:pt x="328" y="444"/>
                        </a:cubicBezTo>
                        <a:cubicBezTo>
                          <a:pt x="322" y="435"/>
                          <a:pt x="322" y="435"/>
                          <a:pt x="322" y="435"/>
                        </a:cubicBezTo>
                        <a:cubicBezTo>
                          <a:pt x="339" y="433"/>
                          <a:pt x="339" y="433"/>
                          <a:pt x="339" y="433"/>
                        </a:cubicBezTo>
                        <a:cubicBezTo>
                          <a:pt x="372" y="442"/>
                          <a:pt x="372" y="442"/>
                          <a:pt x="372" y="442"/>
                        </a:cubicBezTo>
                        <a:cubicBezTo>
                          <a:pt x="380" y="421"/>
                          <a:pt x="380" y="421"/>
                          <a:pt x="380" y="421"/>
                        </a:cubicBezTo>
                        <a:cubicBezTo>
                          <a:pt x="387" y="427"/>
                          <a:pt x="387" y="427"/>
                          <a:pt x="387" y="427"/>
                        </a:cubicBezTo>
                        <a:cubicBezTo>
                          <a:pt x="398" y="430"/>
                          <a:pt x="398" y="430"/>
                          <a:pt x="398" y="430"/>
                        </a:cubicBezTo>
                        <a:cubicBezTo>
                          <a:pt x="415" y="435"/>
                          <a:pt x="415" y="435"/>
                          <a:pt x="415" y="435"/>
                        </a:cubicBezTo>
                        <a:cubicBezTo>
                          <a:pt x="428" y="433"/>
                          <a:pt x="428" y="433"/>
                          <a:pt x="428" y="433"/>
                        </a:cubicBezTo>
                        <a:cubicBezTo>
                          <a:pt x="445" y="438"/>
                          <a:pt x="445" y="438"/>
                          <a:pt x="445" y="438"/>
                        </a:cubicBezTo>
                        <a:cubicBezTo>
                          <a:pt x="455" y="454"/>
                          <a:pt x="455" y="454"/>
                          <a:pt x="455" y="454"/>
                        </a:cubicBezTo>
                        <a:cubicBezTo>
                          <a:pt x="463" y="454"/>
                          <a:pt x="463" y="454"/>
                          <a:pt x="463" y="454"/>
                        </a:cubicBezTo>
                        <a:cubicBezTo>
                          <a:pt x="468" y="446"/>
                          <a:pt x="468" y="446"/>
                          <a:pt x="468" y="446"/>
                        </a:cubicBezTo>
                        <a:cubicBezTo>
                          <a:pt x="482" y="449"/>
                          <a:pt x="482" y="449"/>
                          <a:pt x="482" y="449"/>
                        </a:cubicBezTo>
                        <a:cubicBezTo>
                          <a:pt x="506" y="444"/>
                          <a:pt x="506" y="444"/>
                          <a:pt x="506" y="444"/>
                        </a:cubicBezTo>
                        <a:cubicBezTo>
                          <a:pt x="505" y="425"/>
                          <a:pt x="505" y="425"/>
                          <a:pt x="505" y="425"/>
                        </a:cubicBezTo>
                        <a:cubicBezTo>
                          <a:pt x="537" y="416"/>
                          <a:pt x="537" y="416"/>
                          <a:pt x="537" y="416"/>
                        </a:cubicBezTo>
                        <a:cubicBezTo>
                          <a:pt x="551" y="416"/>
                          <a:pt x="551" y="416"/>
                          <a:pt x="551" y="416"/>
                        </a:cubicBezTo>
                        <a:cubicBezTo>
                          <a:pt x="557" y="411"/>
                          <a:pt x="557" y="411"/>
                          <a:pt x="557" y="411"/>
                        </a:cubicBezTo>
                        <a:cubicBezTo>
                          <a:pt x="568" y="418"/>
                          <a:pt x="568" y="418"/>
                          <a:pt x="568" y="418"/>
                        </a:cubicBezTo>
                        <a:cubicBezTo>
                          <a:pt x="597" y="416"/>
                          <a:pt x="597" y="416"/>
                          <a:pt x="597" y="416"/>
                        </a:cubicBezTo>
                        <a:cubicBezTo>
                          <a:pt x="594" y="405"/>
                          <a:pt x="594" y="405"/>
                          <a:pt x="594" y="405"/>
                        </a:cubicBezTo>
                        <a:cubicBezTo>
                          <a:pt x="582" y="363"/>
                          <a:pt x="582" y="363"/>
                          <a:pt x="582" y="363"/>
                        </a:cubicBezTo>
                        <a:cubicBezTo>
                          <a:pt x="554" y="365"/>
                          <a:pt x="554" y="365"/>
                          <a:pt x="554" y="365"/>
                        </a:cubicBezTo>
                        <a:cubicBezTo>
                          <a:pt x="517" y="341"/>
                          <a:pt x="517" y="341"/>
                          <a:pt x="517" y="341"/>
                        </a:cubicBezTo>
                        <a:cubicBezTo>
                          <a:pt x="510" y="329"/>
                          <a:pt x="510" y="329"/>
                          <a:pt x="510" y="329"/>
                        </a:cubicBezTo>
                        <a:cubicBezTo>
                          <a:pt x="487" y="321"/>
                          <a:pt x="487" y="321"/>
                          <a:pt x="487" y="321"/>
                        </a:cubicBezTo>
                        <a:cubicBezTo>
                          <a:pt x="463" y="298"/>
                          <a:pt x="463" y="298"/>
                          <a:pt x="463" y="298"/>
                        </a:cubicBezTo>
                        <a:cubicBezTo>
                          <a:pt x="480" y="286"/>
                          <a:pt x="480" y="286"/>
                          <a:pt x="480" y="286"/>
                        </a:cubicBezTo>
                        <a:cubicBezTo>
                          <a:pt x="498" y="279"/>
                          <a:pt x="498" y="279"/>
                          <a:pt x="498" y="279"/>
                        </a:cubicBezTo>
                        <a:cubicBezTo>
                          <a:pt x="479" y="255"/>
                          <a:pt x="479" y="255"/>
                          <a:pt x="479" y="255"/>
                        </a:cubicBezTo>
                        <a:cubicBezTo>
                          <a:pt x="450" y="263"/>
                          <a:pt x="450" y="263"/>
                          <a:pt x="450" y="263"/>
                        </a:cubicBezTo>
                        <a:cubicBezTo>
                          <a:pt x="451" y="252"/>
                          <a:pt x="451" y="252"/>
                          <a:pt x="451" y="252"/>
                        </a:cubicBezTo>
                        <a:cubicBezTo>
                          <a:pt x="426" y="250"/>
                          <a:pt x="426" y="250"/>
                          <a:pt x="426" y="250"/>
                        </a:cubicBezTo>
                        <a:cubicBezTo>
                          <a:pt x="443" y="237"/>
                          <a:pt x="443" y="237"/>
                          <a:pt x="443" y="237"/>
                        </a:cubicBezTo>
                        <a:cubicBezTo>
                          <a:pt x="459" y="237"/>
                          <a:pt x="459" y="237"/>
                          <a:pt x="459" y="237"/>
                        </a:cubicBezTo>
                        <a:cubicBezTo>
                          <a:pt x="472" y="230"/>
                          <a:pt x="472" y="230"/>
                          <a:pt x="472" y="230"/>
                        </a:cubicBezTo>
                        <a:cubicBezTo>
                          <a:pt x="471" y="224"/>
                          <a:pt x="471" y="224"/>
                          <a:pt x="471" y="224"/>
                        </a:cubicBezTo>
                        <a:cubicBezTo>
                          <a:pt x="461" y="216"/>
                          <a:pt x="461" y="216"/>
                          <a:pt x="461" y="216"/>
                        </a:cubicBezTo>
                        <a:cubicBezTo>
                          <a:pt x="438" y="179"/>
                          <a:pt x="438" y="179"/>
                          <a:pt x="438" y="179"/>
                        </a:cubicBezTo>
                        <a:cubicBezTo>
                          <a:pt x="427" y="161"/>
                          <a:pt x="427" y="161"/>
                          <a:pt x="427" y="161"/>
                        </a:cubicBezTo>
                        <a:cubicBezTo>
                          <a:pt x="420" y="157"/>
                          <a:pt x="420" y="157"/>
                          <a:pt x="420" y="157"/>
                        </a:cubicBezTo>
                        <a:cubicBezTo>
                          <a:pt x="413" y="135"/>
                          <a:pt x="413" y="135"/>
                          <a:pt x="413" y="135"/>
                        </a:cubicBezTo>
                        <a:cubicBezTo>
                          <a:pt x="395" y="78"/>
                          <a:pt x="395" y="78"/>
                          <a:pt x="395" y="78"/>
                        </a:cubicBezTo>
                        <a:cubicBezTo>
                          <a:pt x="374" y="49"/>
                          <a:pt x="374" y="49"/>
                          <a:pt x="374" y="49"/>
                        </a:cubicBezTo>
                        <a:cubicBezTo>
                          <a:pt x="344" y="31"/>
                          <a:pt x="344" y="31"/>
                          <a:pt x="344" y="31"/>
                        </a:cubicBezTo>
                        <a:cubicBezTo>
                          <a:pt x="345" y="14"/>
                          <a:pt x="345" y="14"/>
                          <a:pt x="345" y="14"/>
                        </a:cubicBezTo>
                        <a:cubicBezTo>
                          <a:pt x="357" y="10"/>
                          <a:pt x="357" y="10"/>
                          <a:pt x="357" y="10"/>
                        </a:cubicBezTo>
                        <a:lnTo>
                          <a:pt x="364" y="0"/>
                        </a:lnTo>
                        <a:close/>
                      </a:path>
                    </a:pathLst>
                  </a:custGeom>
                  <a:solidFill>
                    <a:schemeClr val="accent1">
                      <a:lumMod val="60000"/>
                      <a:lumOff val="40000"/>
                    </a:schemeClr>
                  </a:solidFill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4" name="Freeform 22"/>
                  <p:cNvSpPr>
                    <a:spLocks/>
                  </p:cNvSpPr>
                  <p:nvPr/>
                </p:nvSpPr>
                <p:spPr bwMode="auto">
                  <a:xfrm>
                    <a:off x="3009197" y="4992667"/>
                    <a:ext cx="796974" cy="1019494"/>
                  </a:xfrm>
                  <a:custGeom>
                    <a:avLst/>
                    <a:gdLst/>
                    <a:ahLst/>
                    <a:cxnLst>
                      <a:cxn ang="0">
                        <a:pos x="261" y="5"/>
                      </a:cxn>
                      <a:cxn ang="0">
                        <a:pos x="215" y="14"/>
                      </a:cxn>
                      <a:cxn ang="0">
                        <a:pos x="192" y="38"/>
                      </a:cxn>
                      <a:cxn ang="0">
                        <a:pos x="173" y="43"/>
                      </a:cxn>
                      <a:cxn ang="0">
                        <a:pos x="155" y="27"/>
                      </a:cxn>
                      <a:cxn ang="0">
                        <a:pos x="125" y="24"/>
                      </a:cxn>
                      <a:cxn ang="0">
                        <a:pos x="97" y="16"/>
                      </a:cxn>
                      <a:cxn ang="0">
                        <a:pos x="82" y="31"/>
                      </a:cxn>
                      <a:cxn ang="0">
                        <a:pos x="32" y="24"/>
                      </a:cxn>
                      <a:cxn ang="0">
                        <a:pos x="38" y="51"/>
                      </a:cxn>
                      <a:cxn ang="0">
                        <a:pos x="49" y="84"/>
                      </a:cxn>
                      <a:cxn ang="0">
                        <a:pos x="37" y="87"/>
                      </a:cxn>
                      <a:cxn ang="0">
                        <a:pos x="31" y="68"/>
                      </a:cxn>
                      <a:cxn ang="0">
                        <a:pos x="0" y="97"/>
                      </a:cxn>
                      <a:cxn ang="0">
                        <a:pos x="24" y="123"/>
                      </a:cxn>
                      <a:cxn ang="0">
                        <a:pos x="33" y="160"/>
                      </a:cxn>
                      <a:cxn ang="0">
                        <a:pos x="24" y="185"/>
                      </a:cxn>
                      <a:cxn ang="0">
                        <a:pos x="12" y="207"/>
                      </a:cxn>
                      <a:cxn ang="0">
                        <a:pos x="20" y="236"/>
                      </a:cxn>
                      <a:cxn ang="0">
                        <a:pos x="31" y="257"/>
                      </a:cxn>
                      <a:cxn ang="0">
                        <a:pos x="14" y="273"/>
                      </a:cxn>
                      <a:cxn ang="0">
                        <a:pos x="40" y="282"/>
                      </a:cxn>
                      <a:cxn ang="0">
                        <a:pos x="65" y="291"/>
                      </a:cxn>
                      <a:cxn ang="0">
                        <a:pos x="120" y="332"/>
                      </a:cxn>
                      <a:cxn ang="0">
                        <a:pos x="158" y="358"/>
                      </a:cxn>
                      <a:cxn ang="0">
                        <a:pos x="134" y="373"/>
                      </a:cxn>
                      <a:cxn ang="0">
                        <a:pos x="144" y="409"/>
                      </a:cxn>
                      <a:cxn ang="0">
                        <a:pos x="183" y="425"/>
                      </a:cxn>
                      <a:cxn ang="0">
                        <a:pos x="221" y="436"/>
                      </a:cxn>
                      <a:cxn ang="0">
                        <a:pos x="222" y="471"/>
                      </a:cxn>
                      <a:cxn ang="0">
                        <a:pos x="206" y="474"/>
                      </a:cxn>
                      <a:cxn ang="0">
                        <a:pos x="239" y="487"/>
                      </a:cxn>
                      <a:cxn ang="0">
                        <a:pos x="275" y="484"/>
                      </a:cxn>
                      <a:cxn ang="0">
                        <a:pos x="264" y="443"/>
                      </a:cxn>
                      <a:cxn ang="0">
                        <a:pos x="304" y="448"/>
                      </a:cxn>
                      <a:cxn ang="0">
                        <a:pos x="332" y="436"/>
                      </a:cxn>
                      <a:cxn ang="0">
                        <a:pos x="340" y="404"/>
                      </a:cxn>
                      <a:cxn ang="0">
                        <a:pos x="375" y="374"/>
                      </a:cxn>
                      <a:cxn ang="0">
                        <a:pos x="370" y="324"/>
                      </a:cxn>
                      <a:cxn ang="0">
                        <a:pos x="370" y="273"/>
                      </a:cxn>
                      <a:cxn ang="0">
                        <a:pos x="349" y="207"/>
                      </a:cxn>
                      <a:cxn ang="0">
                        <a:pos x="384" y="134"/>
                      </a:cxn>
                      <a:cxn ang="0">
                        <a:pos x="339" y="79"/>
                      </a:cxn>
                      <a:cxn ang="0">
                        <a:pos x="314" y="26"/>
                      </a:cxn>
                      <a:cxn ang="0">
                        <a:pos x="278" y="7"/>
                      </a:cxn>
                    </a:cxnLst>
                    <a:rect l="0" t="0" r="r" b="b"/>
                    <a:pathLst>
                      <a:path w="384" h="491">
                        <a:moveTo>
                          <a:pt x="267" y="0"/>
                        </a:moveTo>
                        <a:cubicBezTo>
                          <a:pt x="261" y="5"/>
                          <a:pt x="261" y="5"/>
                          <a:pt x="261" y="5"/>
                        </a:cubicBezTo>
                        <a:cubicBezTo>
                          <a:pt x="247" y="5"/>
                          <a:pt x="247" y="5"/>
                          <a:pt x="247" y="5"/>
                        </a:cubicBezTo>
                        <a:cubicBezTo>
                          <a:pt x="215" y="14"/>
                          <a:pt x="215" y="14"/>
                          <a:pt x="215" y="14"/>
                        </a:cubicBezTo>
                        <a:cubicBezTo>
                          <a:pt x="216" y="33"/>
                          <a:pt x="216" y="33"/>
                          <a:pt x="216" y="33"/>
                        </a:cubicBezTo>
                        <a:cubicBezTo>
                          <a:pt x="192" y="38"/>
                          <a:pt x="192" y="38"/>
                          <a:pt x="192" y="38"/>
                        </a:cubicBezTo>
                        <a:cubicBezTo>
                          <a:pt x="178" y="35"/>
                          <a:pt x="178" y="35"/>
                          <a:pt x="178" y="35"/>
                        </a:cubicBezTo>
                        <a:cubicBezTo>
                          <a:pt x="173" y="43"/>
                          <a:pt x="173" y="43"/>
                          <a:pt x="173" y="43"/>
                        </a:cubicBezTo>
                        <a:cubicBezTo>
                          <a:pt x="165" y="43"/>
                          <a:pt x="165" y="43"/>
                          <a:pt x="165" y="43"/>
                        </a:cubicBezTo>
                        <a:cubicBezTo>
                          <a:pt x="155" y="27"/>
                          <a:pt x="155" y="27"/>
                          <a:pt x="155" y="27"/>
                        </a:cubicBezTo>
                        <a:cubicBezTo>
                          <a:pt x="138" y="22"/>
                          <a:pt x="138" y="22"/>
                          <a:pt x="138" y="22"/>
                        </a:cubicBezTo>
                        <a:cubicBezTo>
                          <a:pt x="125" y="24"/>
                          <a:pt x="125" y="24"/>
                          <a:pt x="125" y="24"/>
                        </a:cubicBezTo>
                        <a:cubicBezTo>
                          <a:pt x="108" y="19"/>
                          <a:pt x="108" y="19"/>
                          <a:pt x="108" y="19"/>
                        </a:cubicBezTo>
                        <a:cubicBezTo>
                          <a:pt x="97" y="16"/>
                          <a:pt x="97" y="16"/>
                          <a:pt x="97" y="16"/>
                        </a:cubicBezTo>
                        <a:cubicBezTo>
                          <a:pt x="90" y="10"/>
                          <a:pt x="90" y="10"/>
                          <a:pt x="90" y="10"/>
                        </a:cubicBezTo>
                        <a:cubicBezTo>
                          <a:pt x="82" y="31"/>
                          <a:pt x="82" y="31"/>
                          <a:pt x="82" y="31"/>
                        </a:cubicBezTo>
                        <a:cubicBezTo>
                          <a:pt x="49" y="22"/>
                          <a:pt x="49" y="22"/>
                          <a:pt x="49" y="22"/>
                        </a:cubicBezTo>
                        <a:cubicBezTo>
                          <a:pt x="32" y="24"/>
                          <a:pt x="32" y="24"/>
                          <a:pt x="32" y="24"/>
                        </a:cubicBezTo>
                        <a:cubicBezTo>
                          <a:pt x="38" y="33"/>
                          <a:pt x="38" y="33"/>
                          <a:pt x="38" y="33"/>
                        </a:cubicBezTo>
                        <a:cubicBezTo>
                          <a:pt x="38" y="51"/>
                          <a:pt x="38" y="51"/>
                          <a:pt x="38" y="51"/>
                        </a:cubicBezTo>
                        <a:cubicBezTo>
                          <a:pt x="43" y="59"/>
                          <a:pt x="43" y="59"/>
                          <a:pt x="43" y="59"/>
                        </a:cubicBezTo>
                        <a:cubicBezTo>
                          <a:pt x="49" y="84"/>
                          <a:pt x="49" y="84"/>
                          <a:pt x="49" y="84"/>
                        </a:cubicBezTo>
                        <a:cubicBezTo>
                          <a:pt x="44" y="88"/>
                          <a:pt x="44" y="88"/>
                          <a:pt x="44" y="88"/>
                        </a:cubicBezTo>
                        <a:cubicBezTo>
                          <a:pt x="37" y="87"/>
                          <a:pt x="37" y="87"/>
                          <a:pt x="37" y="87"/>
                        </a:cubicBezTo>
                        <a:cubicBezTo>
                          <a:pt x="38" y="70"/>
                          <a:pt x="38" y="70"/>
                          <a:pt x="38" y="70"/>
                        </a:cubicBezTo>
                        <a:cubicBezTo>
                          <a:pt x="31" y="68"/>
                          <a:pt x="31" y="68"/>
                          <a:pt x="31" y="68"/>
                        </a:cubicBezTo>
                        <a:cubicBezTo>
                          <a:pt x="6" y="85"/>
                          <a:pt x="6" y="85"/>
                          <a:pt x="6" y="85"/>
                        </a:cubicBezTo>
                        <a:cubicBezTo>
                          <a:pt x="0" y="97"/>
                          <a:pt x="0" y="97"/>
                          <a:pt x="0" y="97"/>
                        </a:cubicBezTo>
                        <a:cubicBezTo>
                          <a:pt x="17" y="119"/>
                          <a:pt x="17" y="119"/>
                          <a:pt x="17" y="119"/>
                        </a:cubicBezTo>
                        <a:cubicBezTo>
                          <a:pt x="24" y="123"/>
                          <a:pt x="24" y="123"/>
                          <a:pt x="24" y="123"/>
                        </a:cubicBezTo>
                        <a:cubicBezTo>
                          <a:pt x="34" y="141"/>
                          <a:pt x="34" y="141"/>
                          <a:pt x="34" y="141"/>
                        </a:cubicBezTo>
                        <a:cubicBezTo>
                          <a:pt x="33" y="160"/>
                          <a:pt x="33" y="160"/>
                          <a:pt x="33" y="160"/>
                        </a:cubicBezTo>
                        <a:cubicBezTo>
                          <a:pt x="29" y="180"/>
                          <a:pt x="29" y="180"/>
                          <a:pt x="29" y="180"/>
                        </a:cubicBezTo>
                        <a:cubicBezTo>
                          <a:pt x="24" y="185"/>
                          <a:pt x="24" y="185"/>
                          <a:pt x="24" y="185"/>
                        </a:cubicBezTo>
                        <a:cubicBezTo>
                          <a:pt x="21" y="198"/>
                          <a:pt x="21" y="198"/>
                          <a:pt x="21" y="198"/>
                        </a:cubicBezTo>
                        <a:cubicBezTo>
                          <a:pt x="12" y="207"/>
                          <a:pt x="12" y="207"/>
                          <a:pt x="12" y="207"/>
                        </a:cubicBezTo>
                        <a:cubicBezTo>
                          <a:pt x="6" y="236"/>
                          <a:pt x="6" y="236"/>
                          <a:pt x="6" y="236"/>
                        </a:cubicBezTo>
                        <a:cubicBezTo>
                          <a:pt x="20" y="236"/>
                          <a:pt x="20" y="236"/>
                          <a:pt x="20" y="236"/>
                        </a:cubicBezTo>
                        <a:cubicBezTo>
                          <a:pt x="34" y="243"/>
                          <a:pt x="34" y="243"/>
                          <a:pt x="34" y="243"/>
                        </a:cubicBezTo>
                        <a:cubicBezTo>
                          <a:pt x="31" y="257"/>
                          <a:pt x="31" y="257"/>
                          <a:pt x="31" y="257"/>
                        </a:cubicBezTo>
                        <a:cubicBezTo>
                          <a:pt x="21" y="257"/>
                          <a:pt x="21" y="257"/>
                          <a:pt x="21" y="257"/>
                        </a:cubicBezTo>
                        <a:cubicBezTo>
                          <a:pt x="14" y="273"/>
                          <a:pt x="14" y="273"/>
                          <a:pt x="14" y="273"/>
                        </a:cubicBezTo>
                        <a:cubicBezTo>
                          <a:pt x="22" y="270"/>
                          <a:pt x="22" y="270"/>
                          <a:pt x="22" y="270"/>
                        </a:cubicBezTo>
                        <a:cubicBezTo>
                          <a:pt x="40" y="282"/>
                          <a:pt x="40" y="282"/>
                          <a:pt x="40" y="282"/>
                        </a:cubicBezTo>
                        <a:cubicBezTo>
                          <a:pt x="53" y="279"/>
                          <a:pt x="53" y="279"/>
                          <a:pt x="53" y="279"/>
                        </a:cubicBezTo>
                        <a:cubicBezTo>
                          <a:pt x="65" y="291"/>
                          <a:pt x="65" y="291"/>
                          <a:pt x="65" y="291"/>
                        </a:cubicBezTo>
                        <a:cubicBezTo>
                          <a:pt x="97" y="301"/>
                          <a:pt x="97" y="301"/>
                          <a:pt x="97" y="301"/>
                        </a:cubicBezTo>
                        <a:cubicBezTo>
                          <a:pt x="120" y="332"/>
                          <a:pt x="120" y="332"/>
                          <a:pt x="120" y="332"/>
                        </a:cubicBezTo>
                        <a:cubicBezTo>
                          <a:pt x="150" y="334"/>
                          <a:pt x="150" y="334"/>
                          <a:pt x="150" y="334"/>
                        </a:cubicBezTo>
                        <a:cubicBezTo>
                          <a:pt x="158" y="358"/>
                          <a:pt x="158" y="358"/>
                          <a:pt x="158" y="358"/>
                        </a:cubicBezTo>
                        <a:cubicBezTo>
                          <a:pt x="155" y="368"/>
                          <a:pt x="155" y="368"/>
                          <a:pt x="155" y="368"/>
                        </a:cubicBezTo>
                        <a:cubicBezTo>
                          <a:pt x="134" y="373"/>
                          <a:pt x="134" y="373"/>
                          <a:pt x="134" y="373"/>
                        </a:cubicBezTo>
                        <a:cubicBezTo>
                          <a:pt x="130" y="400"/>
                          <a:pt x="130" y="400"/>
                          <a:pt x="130" y="400"/>
                        </a:cubicBezTo>
                        <a:cubicBezTo>
                          <a:pt x="144" y="409"/>
                          <a:pt x="144" y="409"/>
                          <a:pt x="144" y="409"/>
                        </a:cubicBezTo>
                        <a:cubicBezTo>
                          <a:pt x="161" y="428"/>
                          <a:pt x="161" y="428"/>
                          <a:pt x="161" y="428"/>
                        </a:cubicBezTo>
                        <a:cubicBezTo>
                          <a:pt x="183" y="425"/>
                          <a:pt x="183" y="425"/>
                          <a:pt x="183" y="425"/>
                        </a:cubicBezTo>
                        <a:cubicBezTo>
                          <a:pt x="187" y="429"/>
                          <a:pt x="187" y="429"/>
                          <a:pt x="187" y="429"/>
                        </a:cubicBezTo>
                        <a:cubicBezTo>
                          <a:pt x="221" y="436"/>
                          <a:pt x="221" y="436"/>
                          <a:pt x="221" y="436"/>
                        </a:cubicBezTo>
                        <a:cubicBezTo>
                          <a:pt x="221" y="461"/>
                          <a:pt x="221" y="461"/>
                          <a:pt x="221" y="461"/>
                        </a:cubicBezTo>
                        <a:cubicBezTo>
                          <a:pt x="222" y="471"/>
                          <a:pt x="222" y="471"/>
                          <a:pt x="222" y="471"/>
                        </a:cubicBezTo>
                        <a:cubicBezTo>
                          <a:pt x="206" y="473"/>
                          <a:pt x="206" y="473"/>
                          <a:pt x="206" y="473"/>
                        </a:cubicBezTo>
                        <a:cubicBezTo>
                          <a:pt x="206" y="474"/>
                          <a:pt x="206" y="474"/>
                          <a:pt x="206" y="474"/>
                        </a:cubicBezTo>
                        <a:cubicBezTo>
                          <a:pt x="223" y="490"/>
                          <a:pt x="223" y="490"/>
                          <a:pt x="223" y="490"/>
                        </a:cubicBezTo>
                        <a:cubicBezTo>
                          <a:pt x="239" y="487"/>
                          <a:pt x="239" y="487"/>
                          <a:pt x="239" y="487"/>
                        </a:cubicBezTo>
                        <a:cubicBezTo>
                          <a:pt x="267" y="491"/>
                          <a:pt x="267" y="491"/>
                          <a:pt x="267" y="491"/>
                        </a:cubicBezTo>
                        <a:cubicBezTo>
                          <a:pt x="275" y="484"/>
                          <a:pt x="275" y="484"/>
                          <a:pt x="275" y="484"/>
                        </a:cubicBezTo>
                        <a:cubicBezTo>
                          <a:pt x="256" y="453"/>
                          <a:pt x="256" y="453"/>
                          <a:pt x="256" y="453"/>
                        </a:cubicBezTo>
                        <a:cubicBezTo>
                          <a:pt x="264" y="443"/>
                          <a:pt x="264" y="443"/>
                          <a:pt x="264" y="443"/>
                        </a:cubicBezTo>
                        <a:cubicBezTo>
                          <a:pt x="290" y="441"/>
                          <a:pt x="290" y="441"/>
                          <a:pt x="290" y="441"/>
                        </a:cubicBezTo>
                        <a:cubicBezTo>
                          <a:pt x="304" y="448"/>
                          <a:pt x="304" y="448"/>
                          <a:pt x="304" y="448"/>
                        </a:cubicBezTo>
                        <a:cubicBezTo>
                          <a:pt x="323" y="446"/>
                          <a:pt x="323" y="446"/>
                          <a:pt x="323" y="446"/>
                        </a:cubicBezTo>
                        <a:cubicBezTo>
                          <a:pt x="332" y="436"/>
                          <a:pt x="332" y="436"/>
                          <a:pt x="332" y="436"/>
                        </a:cubicBezTo>
                        <a:cubicBezTo>
                          <a:pt x="328" y="424"/>
                          <a:pt x="328" y="424"/>
                          <a:pt x="328" y="424"/>
                        </a:cubicBezTo>
                        <a:cubicBezTo>
                          <a:pt x="340" y="404"/>
                          <a:pt x="340" y="404"/>
                          <a:pt x="340" y="404"/>
                        </a:cubicBezTo>
                        <a:cubicBezTo>
                          <a:pt x="372" y="376"/>
                          <a:pt x="372" y="376"/>
                          <a:pt x="372" y="376"/>
                        </a:cubicBezTo>
                        <a:cubicBezTo>
                          <a:pt x="372" y="376"/>
                          <a:pt x="374" y="374"/>
                          <a:pt x="375" y="374"/>
                        </a:cubicBezTo>
                        <a:cubicBezTo>
                          <a:pt x="359" y="347"/>
                          <a:pt x="359" y="347"/>
                          <a:pt x="359" y="347"/>
                        </a:cubicBezTo>
                        <a:cubicBezTo>
                          <a:pt x="370" y="324"/>
                          <a:pt x="370" y="324"/>
                          <a:pt x="370" y="324"/>
                        </a:cubicBezTo>
                        <a:cubicBezTo>
                          <a:pt x="376" y="298"/>
                          <a:pt x="376" y="298"/>
                          <a:pt x="376" y="298"/>
                        </a:cubicBezTo>
                        <a:cubicBezTo>
                          <a:pt x="370" y="273"/>
                          <a:pt x="370" y="273"/>
                          <a:pt x="370" y="273"/>
                        </a:cubicBezTo>
                        <a:cubicBezTo>
                          <a:pt x="345" y="243"/>
                          <a:pt x="345" y="243"/>
                          <a:pt x="345" y="243"/>
                        </a:cubicBezTo>
                        <a:cubicBezTo>
                          <a:pt x="349" y="207"/>
                          <a:pt x="349" y="207"/>
                          <a:pt x="349" y="207"/>
                        </a:cubicBezTo>
                        <a:cubicBezTo>
                          <a:pt x="371" y="176"/>
                          <a:pt x="371" y="176"/>
                          <a:pt x="371" y="176"/>
                        </a:cubicBezTo>
                        <a:cubicBezTo>
                          <a:pt x="384" y="134"/>
                          <a:pt x="384" y="134"/>
                          <a:pt x="384" y="134"/>
                        </a:cubicBezTo>
                        <a:cubicBezTo>
                          <a:pt x="384" y="77"/>
                          <a:pt x="384" y="77"/>
                          <a:pt x="384" y="77"/>
                        </a:cubicBezTo>
                        <a:cubicBezTo>
                          <a:pt x="339" y="79"/>
                          <a:pt x="339" y="79"/>
                          <a:pt x="339" y="79"/>
                        </a:cubicBezTo>
                        <a:cubicBezTo>
                          <a:pt x="310" y="26"/>
                          <a:pt x="310" y="26"/>
                          <a:pt x="310" y="26"/>
                        </a:cubicBezTo>
                        <a:cubicBezTo>
                          <a:pt x="314" y="26"/>
                          <a:pt x="314" y="26"/>
                          <a:pt x="314" y="26"/>
                        </a:cubicBezTo>
                        <a:cubicBezTo>
                          <a:pt x="307" y="5"/>
                          <a:pt x="307" y="5"/>
                          <a:pt x="307" y="5"/>
                        </a:cubicBezTo>
                        <a:cubicBezTo>
                          <a:pt x="278" y="7"/>
                          <a:pt x="278" y="7"/>
                          <a:pt x="278" y="7"/>
                        </a:cubicBezTo>
                        <a:lnTo>
                          <a:pt x="267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5" name="Freeform 23"/>
                  <p:cNvSpPr>
                    <a:spLocks/>
                  </p:cNvSpPr>
                  <p:nvPr/>
                </p:nvSpPr>
                <p:spPr bwMode="auto">
                  <a:xfrm>
                    <a:off x="2949227" y="5612886"/>
                    <a:ext cx="520794" cy="939007"/>
                  </a:xfrm>
                  <a:custGeom>
                    <a:avLst/>
                    <a:gdLst/>
                    <a:ahLst/>
                    <a:cxnLst>
                      <a:cxn ang="0">
                        <a:pos x="119" y="19"/>
                      </a:cxn>
                      <a:cxn ang="0">
                        <a:pos x="107" y="52"/>
                      </a:cxn>
                      <a:cxn ang="0">
                        <a:pos x="84" y="70"/>
                      </a:cxn>
                      <a:cxn ang="0">
                        <a:pos x="62" y="91"/>
                      </a:cxn>
                      <a:cxn ang="0">
                        <a:pos x="69" y="115"/>
                      </a:cxn>
                      <a:cxn ang="0">
                        <a:pos x="49" y="109"/>
                      </a:cxn>
                      <a:cxn ang="0">
                        <a:pos x="25" y="114"/>
                      </a:cxn>
                      <a:cxn ang="0">
                        <a:pos x="18" y="147"/>
                      </a:cxn>
                      <a:cxn ang="0">
                        <a:pos x="38" y="165"/>
                      </a:cxn>
                      <a:cxn ang="0">
                        <a:pos x="55" y="196"/>
                      </a:cxn>
                      <a:cxn ang="0">
                        <a:pos x="32" y="205"/>
                      </a:cxn>
                      <a:cxn ang="0">
                        <a:pos x="14" y="249"/>
                      </a:cxn>
                      <a:cxn ang="0">
                        <a:pos x="11" y="290"/>
                      </a:cxn>
                      <a:cxn ang="0">
                        <a:pos x="19" y="313"/>
                      </a:cxn>
                      <a:cxn ang="0">
                        <a:pos x="14" y="355"/>
                      </a:cxn>
                      <a:cxn ang="0">
                        <a:pos x="18" y="374"/>
                      </a:cxn>
                      <a:cxn ang="0">
                        <a:pos x="27" y="392"/>
                      </a:cxn>
                      <a:cxn ang="0">
                        <a:pos x="26" y="420"/>
                      </a:cxn>
                      <a:cxn ang="0">
                        <a:pos x="64" y="440"/>
                      </a:cxn>
                      <a:cxn ang="0">
                        <a:pos x="110" y="431"/>
                      </a:cxn>
                      <a:cxn ang="0">
                        <a:pos x="128" y="446"/>
                      </a:cxn>
                      <a:cxn ang="0">
                        <a:pos x="176" y="445"/>
                      </a:cxn>
                      <a:cxn ang="0">
                        <a:pos x="184" y="388"/>
                      </a:cxn>
                      <a:cxn ang="0">
                        <a:pos x="183" y="338"/>
                      </a:cxn>
                      <a:cxn ang="0">
                        <a:pos x="174" y="314"/>
                      </a:cxn>
                      <a:cxn ang="0">
                        <a:pos x="177" y="275"/>
                      </a:cxn>
                      <a:cxn ang="0">
                        <a:pos x="169" y="251"/>
                      </a:cxn>
                      <a:cxn ang="0">
                        <a:pos x="155" y="224"/>
                      </a:cxn>
                      <a:cxn ang="0">
                        <a:pos x="189" y="190"/>
                      </a:cxn>
                      <a:cxn ang="0">
                        <a:pos x="215" y="188"/>
                      </a:cxn>
                      <a:cxn ang="0">
                        <a:pos x="235" y="174"/>
                      </a:cxn>
                      <a:cxn ang="0">
                        <a:pos x="250" y="162"/>
                      </a:cxn>
                      <a:cxn ang="0">
                        <a:pos x="216" y="130"/>
                      </a:cxn>
                      <a:cxn ang="0">
                        <a:pos x="190" y="129"/>
                      </a:cxn>
                      <a:cxn ang="0">
                        <a:pos x="159" y="101"/>
                      </a:cxn>
                      <a:cxn ang="0">
                        <a:pos x="184" y="69"/>
                      </a:cxn>
                      <a:cxn ang="0">
                        <a:pos x="179" y="35"/>
                      </a:cxn>
                      <a:cxn ang="0">
                        <a:pos x="126" y="2"/>
                      </a:cxn>
                    </a:cxnLst>
                    <a:rect l="0" t="0" r="r" b="b"/>
                    <a:pathLst>
                      <a:path w="251" h="452">
                        <a:moveTo>
                          <a:pt x="119" y="0"/>
                        </a:moveTo>
                        <a:cubicBezTo>
                          <a:pt x="119" y="19"/>
                          <a:pt x="119" y="19"/>
                          <a:pt x="119" y="19"/>
                        </a:cubicBezTo>
                        <a:cubicBezTo>
                          <a:pt x="116" y="42"/>
                          <a:pt x="116" y="42"/>
                          <a:pt x="116" y="42"/>
                        </a:cubicBezTo>
                        <a:cubicBezTo>
                          <a:pt x="107" y="52"/>
                          <a:pt x="107" y="52"/>
                          <a:pt x="107" y="52"/>
                        </a:cubicBezTo>
                        <a:cubicBezTo>
                          <a:pt x="88" y="59"/>
                          <a:pt x="88" y="59"/>
                          <a:pt x="88" y="59"/>
                        </a:cubicBezTo>
                        <a:cubicBezTo>
                          <a:pt x="84" y="70"/>
                          <a:pt x="84" y="70"/>
                          <a:pt x="84" y="70"/>
                        </a:cubicBezTo>
                        <a:cubicBezTo>
                          <a:pt x="77" y="81"/>
                          <a:pt x="77" y="81"/>
                          <a:pt x="77" y="81"/>
                        </a:cubicBezTo>
                        <a:cubicBezTo>
                          <a:pt x="62" y="91"/>
                          <a:pt x="62" y="91"/>
                          <a:pt x="62" y="91"/>
                        </a:cubicBezTo>
                        <a:cubicBezTo>
                          <a:pt x="64" y="104"/>
                          <a:pt x="64" y="104"/>
                          <a:pt x="64" y="104"/>
                        </a:cubicBezTo>
                        <a:cubicBezTo>
                          <a:pt x="69" y="115"/>
                          <a:pt x="69" y="115"/>
                          <a:pt x="69" y="115"/>
                        </a:cubicBezTo>
                        <a:cubicBezTo>
                          <a:pt x="60" y="121"/>
                          <a:pt x="60" y="121"/>
                          <a:pt x="60" y="121"/>
                        </a:cubicBezTo>
                        <a:cubicBezTo>
                          <a:pt x="49" y="109"/>
                          <a:pt x="49" y="109"/>
                          <a:pt x="49" y="109"/>
                        </a:cubicBezTo>
                        <a:cubicBezTo>
                          <a:pt x="39" y="109"/>
                          <a:pt x="39" y="109"/>
                          <a:pt x="39" y="109"/>
                        </a:cubicBezTo>
                        <a:cubicBezTo>
                          <a:pt x="25" y="114"/>
                          <a:pt x="25" y="114"/>
                          <a:pt x="25" y="114"/>
                        </a:cubicBezTo>
                        <a:cubicBezTo>
                          <a:pt x="23" y="130"/>
                          <a:pt x="23" y="130"/>
                          <a:pt x="23" y="130"/>
                        </a:cubicBezTo>
                        <a:cubicBezTo>
                          <a:pt x="18" y="147"/>
                          <a:pt x="18" y="147"/>
                          <a:pt x="18" y="147"/>
                        </a:cubicBezTo>
                        <a:cubicBezTo>
                          <a:pt x="25" y="160"/>
                          <a:pt x="25" y="160"/>
                          <a:pt x="25" y="160"/>
                        </a:cubicBezTo>
                        <a:cubicBezTo>
                          <a:pt x="38" y="165"/>
                          <a:pt x="38" y="165"/>
                          <a:pt x="38" y="165"/>
                        </a:cubicBezTo>
                        <a:cubicBezTo>
                          <a:pt x="55" y="185"/>
                          <a:pt x="55" y="185"/>
                          <a:pt x="55" y="185"/>
                        </a:cubicBezTo>
                        <a:cubicBezTo>
                          <a:pt x="55" y="196"/>
                          <a:pt x="55" y="196"/>
                          <a:pt x="55" y="196"/>
                        </a:cubicBezTo>
                        <a:cubicBezTo>
                          <a:pt x="49" y="204"/>
                          <a:pt x="49" y="204"/>
                          <a:pt x="49" y="204"/>
                        </a:cubicBezTo>
                        <a:cubicBezTo>
                          <a:pt x="32" y="205"/>
                          <a:pt x="32" y="205"/>
                          <a:pt x="32" y="205"/>
                        </a:cubicBezTo>
                        <a:cubicBezTo>
                          <a:pt x="16" y="231"/>
                          <a:pt x="16" y="231"/>
                          <a:pt x="16" y="231"/>
                        </a:cubicBezTo>
                        <a:cubicBezTo>
                          <a:pt x="14" y="249"/>
                          <a:pt x="14" y="249"/>
                          <a:pt x="14" y="249"/>
                        </a:cubicBezTo>
                        <a:cubicBezTo>
                          <a:pt x="7" y="259"/>
                          <a:pt x="7" y="259"/>
                          <a:pt x="7" y="259"/>
                        </a:cubicBezTo>
                        <a:cubicBezTo>
                          <a:pt x="11" y="290"/>
                          <a:pt x="11" y="290"/>
                          <a:pt x="11" y="290"/>
                        </a:cubicBezTo>
                        <a:cubicBezTo>
                          <a:pt x="0" y="296"/>
                          <a:pt x="0" y="296"/>
                          <a:pt x="0" y="296"/>
                        </a:cubicBezTo>
                        <a:cubicBezTo>
                          <a:pt x="19" y="313"/>
                          <a:pt x="19" y="313"/>
                          <a:pt x="19" y="313"/>
                        </a:cubicBezTo>
                        <a:cubicBezTo>
                          <a:pt x="3" y="337"/>
                          <a:pt x="3" y="337"/>
                          <a:pt x="3" y="337"/>
                        </a:cubicBezTo>
                        <a:cubicBezTo>
                          <a:pt x="14" y="355"/>
                          <a:pt x="14" y="355"/>
                          <a:pt x="14" y="355"/>
                        </a:cubicBezTo>
                        <a:cubicBezTo>
                          <a:pt x="18" y="365"/>
                          <a:pt x="18" y="365"/>
                          <a:pt x="18" y="365"/>
                        </a:cubicBezTo>
                        <a:cubicBezTo>
                          <a:pt x="18" y="374"/>
                          <a:pt x="18" y="374"/>
                          <a:pt x="18" y="374"/>
                        </a:cubicBezTo>
                        <a:cubicBezTo>
                          <a:pt x="21" y="374"/>
                          <a:pt x="21" y="374"/>
                          <a:pt x="21" y="374"/>
                        </a:cubicBezTo>
                        <a:cubicBezTo>
                          <a:pt x="27" y="392"/>
                          <a:pt x="27" y="392"/>
                          <a:pt x="27" y="392"/>
                        </a:cubicBezTo>
                        <a:cubicBezTo>
                          <a:pt x="23" y="415"/>
                          <a:pt x="23" y="415"/>
                          <a:pt x="23" y="415"/>
                        </a:cubicBezTo>
                        <a:cubicBezTo>
                          <a:pt x="23" y="415"/>
                          <a:pt x="25" y="418"/>
                          <a:pt x="26" y="420"/>
                        </a:cubicBezTo>
                        <a:cubicBezTo>
                          <a:pt x="44" y="426"/>
                          <a:pt x="44" y="426"/>
                          <a:pt x="44" y="426"/>
                        </a:cubicBezTo>
                        <a:cubicBezTo>
                          <a:pt x="64" y="440"/>
                          <a:pt x="64" y="440"/>
                          <a:pt x="64" y="440"/>
                        </a:cubicBezTo>
                        <a:cubicBezTo>
                          <a:pt x="102" y="443"/>
                          <a:pt x="102" y="443"/>
                          <a:pt x="102" y="443"/>
                        </a:cubicBezTo>
                        <a:cubicBezTo>
                          <a:pt x="110" y="431"/>
                          <a:pt x="110" y="431"/>
                          <a:pt x="110" y="431"/>
                        </a:cubicBezTo>
                        <a:cubicBezTo>
                          <a:pt x="121" y="430"/>
                          <a:pt x="121" y="430"/>
                          <a:pt x="121" y="430"/>
                        </a:cubicBezTo>
                        <a:cubicBezTo>
                          <a:pt x="121" y="430"/>
                          <a:pt x="125" y="441"/>
                          <a:pt x="128" y="446"/>
                        </a:cubicBezTo>
                        <a:cubicBezTo>
                          <a:pt x="131" y="452"/>
                          <a:pt x="161" y="452"/>
                          <a:pt x="161" y="452"/>
                        </a:cubicBezTo>
                        <a:cubicBezTo>
                          <a:pt x="176" y="445"/>
                          <a:pt x="176" y="445"/>
                          <a:pt x="176" y="445"/>
                        </a:cubicBezTo>
                        <a:cubicBezTo>
                          <a:pt x="177" y="426"/>
                          <a:pt x="177" y="426"/>
                          <a:pt x="177" y="426"/>
                        </a:cubicBezTo>
                        <a:cubicBezTo>
                          <a:pt x="184" y="388"/>
                          <a:pt x="184" y="388"/>
                          <a:pt x="184" y="388"/>
                        </a:cubicBezTo>
                        <a:cubicBezTo>
                          <a:pt x="182" y="354"/>
                          <a:pt x="182" y="354"/>
                          <a:pt x="182" y="354"/>
                        </a:cubicBezTo>
                        <a:cubicBezTo>
                          <a:pt x="183" y="338"/>
                          <a:pt x="183" y="338"/>
                          <a:pt x="183" y="338"/>
                        </a:cubicBezTo>
                        <a:cubicBezTo>
                          <a:pt x="190" y="325"/>
                          <a:pt x="190" y="325"/>
                          <a:pt x="190" y="325"/>
                        </a:cubicBezTo>
                        <a:cubicBezTo>
                          <a:pt x="174" y="314"/>
                          <a:pt x="174" y="314"/>
                          <a:pt x="174" y="314"/>
                        </a:cubicBezTo>
                        <a:cubicBezTo>
                          <a:pt x="167" y="281"/>
                          <a:pt x="167" y="281"/>
                          <a:pt x="167" y="281"/>
                        </a:cubicBezTo>
                        <a:cubicBezTo>
                          <a:pt x="177" y="275"/>
                          <a:pt x="177" y="275"/>
                          <a:pt x="177" y="275"/>
                        </a:cubicBezTo>
                        <a:cubicBezTo>
                          <a:pt x="178" y="258"/>
                          <a:pt x="178" y="258"/>
                          <a:pt x="178" y="258"/>
                        </a:cubicBezTo>
                        <a:cubicBezTo>
                          <a:pt x="169" y="251"/>
                          <a:pt x="169" y="251"/>
                          <a:pt x="169" y="251"/>
                        </a:cubicBezTo>
                        <a:cubicBezTo>
                          <a:pt x="178" y="242"/>
                          <a:pt x="178" y="242"/>
                          <a:pt x="178" y="242"/>
                        </a:cubicBezTo>
                        <a:cubicBezTo>
                          <a:pt x="155" y="224"/>
                          <a:pt x="155" y="224"/>
                          <a:pt x="155" y="224"/>
                        </a:cubicBezTo>
                        <a:cubicBezTo>
                          <a:pt x="167" y="191"/>
                          <a:pt x="167" y="191"/>
                          <a:pt x="167" y="191"/>
                        </a:cubicBezTo>
                        <a:cubicBezTo>
                          <a:pt x="189" y="190"/>
                          <a:pt x="189" y="190"/>
                          <a:pt x="189" y="190"/>
                        </a:cubicBezTo>
                        <a:cubicBezTo>
                          <a:pt x="205" y="183"/>
                          <a:pt x="205" y="183"/>
                          <a:pt x="205" y="183"/>
                        </a:cubicBezTo>
                        <a:cubicBezTo>
                          <a:pt x="215" y="188"/>
                          <a:pt x="215" y="188"/>
                          <a:pt x="215" y="188"/>
                        </a:cubicBezTo>
                        <a:cubicBezTo>
                          <a:pt x="232" y="180"/>
                          <a:pt x="232" y="180"/>
                          <a:pt x="232" y="180"/>
                        </a:cubicBezTo>
                        <a:cubicBezTo>
                          <a:pt x="235" y="174"/>
                          <a:pt x="235" y="174"/>
                          <a:pt x="235" y="174"/>
                        </a:cubicBezTo>
                        <a:cubicBezTo>
                          <a:pt x="251" y="172"/>
                          <a:pt x="251" y="172"/>
                          <a:pt x="251" y="172"/>
                        </a:cubicBezTo>
                        <a:cubicBezTo>
                          <a:pt x="250" y="162"/>
                          <a:pt x="250" y="162"/>
                          <a:pt x="250" y="162"/>
                        </a:cubicBezTo>
                        <a:cubicBezTo>
                          <a:pt x="250" y="137"/>
                          <a:pt x="250" y="137"/>
                          <a:pt x="250" y="137"/>
                        </a:cubicBezTo>
                        <a:cubicBezTo>
                          <a:pt x="216" y="130"/>
                          <a:pt x="216" y="130"/>
                          <a:pt x="216" y="130"/>
                        </a:cubicBezTo>
                        <a:cubicBezTo>
                          <a:pt x="212" y="126"/>
                          <a:pt x="212" y="126"/>
                          <a:pt x="212" y="126"/>
                        </a:cubicBezTo>
                        <a:cubicBezTo>
                          <a:pt x="190" y="129"/>
                          <a:pt x="190" y="129"/>
                          <a:pt x="190" y="129"/>
                        </a:cubicBezTo>
                        <a:cubicBezTo>
                          <a:pt x="173" y="110"/>
                          <a:pt x="173" y="110"/>
                          <a:pt x="173" y="110"/>
                        </a:cubicBezTo>
                        <a:cubicBezTo>
                          <a:pt x="159" y="101"/>
                          <a:pt x="159" y="101"/>
                          <a:pt x="159" y="101"/>
                        </a:cubicBezTo>
                        <a:cubicBezTo>
                          <a:pt x="163" y="74"/>
                          <a:pt x="163" y="74"/>
                          <a:pt x="163" y="74"/>
                        </a:cubicBezTo>
                        <a:cubicBezTo>
                          <a:pt x="184" y="69"/>
                          <a:pt x="184" y="69"/>
                          <a:pt x="184" y="69"/>
                        </a:cubicBezTo>
                        <a:cubicBezTo>
                          <a:pt x="187" y="59"/>
                          <a:pt x="187" y="59"/>
                          <a:pt x="187" y="59"/>
                        </a:cubicBezTo>
                        <a:cubicBezTo>
                          <a:pt x="179" y="35"/>
                          <a:pt x="179" y="35"/>
                          <a:pt x="179" y="35"/>
                        </a:cubicBezTo>
                        <a:cubicBezTo>
                          <a:pt x="149" y="33"/>
                          <a:pt x="149" y="33"/>
                          <a:pt x="149" y="33"/>
                        </a:cubicBezTo>
                        <a:cubicBezTo>
                          <a:pt x="126" y="2"/>
                          <a:pt x="126" y="2"/>
                          <a:pt x="126" y="2"/>
                        </a:cubicBezTo>
                        <a:lnTo>
                          <a:pt x="119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6" name="Freeform 24"/>
                  <p:cNvSpPr>
                    <a:spLocks/>
                  </p:cNvSpPr>
                  <p:nvPr/>
                </p:nvSpPr>
                <p:spPr bwMode="auto">
                  <a:xfrm>
                    <a:off x="2469465" y="5152062"/>
                    <a:ext cx="725956" cy="1237281"/>
                  </a:xfrm>
                  <a:custGeom>
                    <a:avLst/>
                    <a:gdLst/>
                    <a:ahLst/>
                    <a:cxnLst>
                      <a:cxn ang="0">
                        <a:pos x="276" y="21"/>
                      </a:cxn>
                      <a:cxn ang="0">
                        <a:pos x="207" y="21"/>
                      </a:cxn>
                      <a:cxn ang="0">
                        <a:pos x="181" y="75"/>
                      </a:cxn>
                      <a:cxn ang="0">
                        <a:pos x="152" y="169"/>
                      </a:cxn>
                      <a:cxn ang="0">
                        <a:pos x="119" y="307"/>
                      </a:cxn>
                      <a:cxn ang="0">
                        <a:pos x="86" y="321"/>
                      </a:cxn>
                      <a:cxn ang="0">
                        <a:pos x="57" y="311"/>
                      </a:cxn>
                      <a:cxn ang="0">
                        <a:pos x="59" y="363"/>
                      </a:cxn>
                      <a:cxn ang="0">
                        <a:pos x="56" y="392"/>
                      </a:cxn>
                      <a:cxn ang="0">
                        <a:pos x="76" y="462"/>
                      </a:cxn>
                      <a:cxn ang="0">
                        <a:pos x="76" y="537"/>
                      </a:cxn>
                      <a:cxn ang="0">
                        <a:pos x="0" y="613"/>
                      </a:cxn>
                      <a:cxn ang="0">
                        <a:pos x="36" y="716"/>
                      </a:cxn>
                      <a:cxn ang="0">
                        <a:pos x="98" y="737"/>
                      </a:cxn>
                      <a:cxn ang="0">
                        <a:pos x="146" y="723"/>
                      </a:cxn>
                      <a:cxn ang="0">
                        <a:pos x="134" y="780"/>
                      </a:cxn>
                      <a:cxn ang="0">
                        <a:pos x="327" y="773"/>
                      </a:cxn>
                      <a:cxn ang="0">
                        <a:pos x="307" y="736"/>
                      </a:cxn>
                      <a:cxn ang="0">
                        <a:pos x="304" y="682"/>
                      </a:cxn>
                      <a:cxn ang="0">
                        <a:pos x="313" y="633"/>
                      </a:cxn>
                      <a:cxn ang="0">
                        <a:pos x="325" y="596"/>
                      </a:cxn>
                      <a:cxn ang="0">
                        <a:pos x="368" y="561"/>
                      </a:cxn>
                      <a:cxn ang="0">
                        <a:pos x="376" y="536"/>
                      </a:cxn>
                      <a:cxn ang="0">
                        <a:pos x="336" y="503"/>
                      </a:cxn>
                      <a:cxn ang="0">
                        <a:pos x="334" y="463"/>
                      </a:cxn>
                      <a:cxn ang="0">
                        <a:pos x="355" y="436"/>
                      </a:cxn>
                      <a:cxn ang="0">
                        <a:pos x="382" y="451"/>
                      </a:cxn>
                      <a:cxn ang="0">
                        <a:pos x="388" y="429"/>
                      </a:cxn>
                      <a:cxn ang="0">
                        <a:pos x="405" y="399"/>
                      </a:cxn>
                      <a:cxn ang="0">
                        <a:pos x="419" y="370"/>
                      </a:cxn>
                      <a:cxn ang="0">
                        <a:pos x="456" y="348"/>
                      </a:cxn>
                      <a:cxn ang="0">
                        <a:pos x="460" y="292"/>
                      </a:cxn>
                      <a:cxn ang="0">
                        <a:pos x="411" y="266"/>
                      </a:cxn>
                      <a:cxn ang="0">
                        <a:pos x="371" y="254"/>
                      </a:cxn>
                      <a:cxn ang="0">
                        <a:pos x="369" y="237"/>
                      </a:cxn>
                      <a:cxn ang="0">
                        <a:pos x="386" y="219"/>
                      </a:cxn>
                      <a:cxn ang="0">
                        <a:pos x="350" y="209"/>
                      </a:cxn>
                      <a:cxn ang="0">
                        <a:pos x="369" y="159"/>
                      </a:cxn>
                      <a:cxn ang="0">
                        <a:pos x="380" y="136"/>
                      </a:cxn>
                      <a:cxn ang="0">
                        <a:pos x="386" y="84"/>
                      </a:cxn>
                      <a:cxn ang="0">
                        <a:pos x="364" y="55"/>
                      </a:cxn>
                      <a:cxn ang="0">
                        <a:pos x="321" y="28"/>
                      </a:cxn>
                      <a:cxn ang="0">
                        <a:pos x="276" y="0"/>
                      </a:cxn>
                    </a:cxnLst>
                    <a:rect l="0" t="0" r="r" b="b"/>
                    <a:pathLst>
                      <a:path w="460" h="784">
                        <a:moveTo>
                          <a:pt x="276" y="0"/>
                        </a:moveTo>
                        <a:lnTo>
                          <a:pt x="276" y="21"/>
                        </a:lnTo>
                        <a:lnTo>
                          <a:pt x="240" y="28"/>
                        </a:lnTo>
                        <a:lnTo>
                          <a:pt x="207" y="21"/>
                        </a:lnTo>
                        <a:lnTo>
                          <a:pt x="197" y="57"/>
                        </a:lnTo>
                        <a:lnTo>
                          <a:pt x="181" y="75"/>
                        </a:lnTo>
                        <a:lnTo>
                          <a:pt x="151" y="149"/>
                        </a:lnTo>
                        <a:lnTo>
                          <a:pt x="152" y="169"/>
                        </a:lnTo>
                        <a:lnTo>
                          <a:pt x="157" y="290"/>
                        </a:lnTo>
                        <a:lnTo>
                          <a:pt x="119" y="307"/>
                        </a:lnTo>
                        <a:lnTo>
                          <a:pt x="101" y="324"/>
                        </a:lnTo>
                        <a:lnTo>
                          <a:pt x="86" y="321"/>
                        </a:lnTo>
                        <a:lnTo>
                          <a:pt x="72" y="311"/>
                        </a:lnTo>
                        <a:lnTo>
                          <a:pt x="57" y="311"/>
                        </a:lnTo>
                        <a:lnTo>
                          <a:pt x="72" y="350"/>
                        </a:lnTo>
                        <a:lnTo>
                          <a:pt x="59" y="363"/>
                        </a:lnTo>
                        <a:lnTo>
                          <a:pt x="63" y="375"/>
                        </a:lnTo>
                        <a:lnTo>
                          <a:pt x="56" y="392"/>
                        </a:lnTo>
                        <a:lnTo>
                          <a:pt x="65" y="421"/>
                        </a:lnTo>
                        <a:lnTo>
                          <a:pt x="76" y="462"/>
                        </a:lnTo>
                        <a:lnTo>
                          <a:pt x="65" y="500"/>
                        </a:lnTo>
                        <a:lnTo>
                          <a:pt x="76" y="537"/>
                        </a:lnTo>
                        <a:lnTo>
                          <a:pt x="50" y="567"/>
                        </a:lnTo>
                        <a:lnTo>
                          <a:pt x="0" y="613"/>
                        </a:lnTo>
                        <a:lnTo>
                          <a:pt x="4" y="684"/>
                        </a:lnTo>
                        <a:lnTo>
                          <a:pt x="36" y="716"/>
                        </a:lnTo>
                        <a:lnTo>
                          <a:pt x="40" y="736"/>
                        </a:lnTo>
                        <a:lnTo>
                          <a:pt x="98" y="737"/>
                        </a:lnTo>
                        <a:lnTo>
                          <a:pt x="100" y="723"/>
                        </a:lnTo>
                        <a:lnTo>
                          <a:pt x="146" y="723"/>
                        </a:lnTo>
                        <a:lnTo>
                          <a:pt x="135" y="758"/>
                        </a:lnTo>
                        <a:lnTo>
                          <a:pt x="134" y="780"/>
                        </a:lnTo>
                        <a:lnTo>
                          <a:pt x="327" y="784"/>
                        </a:lnTo>
                        <a:lnTo>
                          <a:pt x="327" y="773"/>
                        </a:lnTo>
                        <a:lnTo>
                          <a:pt x="322" y="759"/>
                        </a:lnTo>
                        <a:lnTo>
                          <a:pt x="307" y="736"/>
                        </a:lnTo>
                        <a:lnTo>
                          <a:pt x="329" y="704"/>
                        </a:lnTo>
                        <a:lnTo>
                          <a:pt x="304" y="682"/>
                        </a:lnTo>
                        <a:lnTo>
                          <a:pt x="318" y="674"/>
                        </a:lnTo>
                        <a:lnTo>
                          <a:pt x="313" y="633"/>
                        </a:lnTo>
                        <a:lnTo>
                          <a:pt x="322" y="620"/>
                        </a:lnTo>
                        <a:lnTo>
                          <a:pt x="325" y="596"/>
                        </a:lnTo>
                        <a:lnTo>
                          <a:pt x="346" y="562"/>
                        </a:lnTo>
                        <a:lnTo>
                          <a:pt x="368" y="561"/>
                        </a:lnTo>
                        <a:lnTo>
                          <a:pt x="376" y="550"/>
                        </a:lnTo>
                        <a:lnTo>
                          <a:pt x="376" y="536"/>
                        </a:lnTo>
                        <a:lnTo>
                          <a:pt x="354" y="509"/>
                        </a:lnTo>
                        <a:lnTo>
                          <a:pt x="336" y="503"/>
                        </a:lnTo>
                        <a:lnTo>
                          <a:pt x="327" y="486"/>
                        </a:lnTo>
                        <a:lnTo>
                          <a:pt x="334" y="463"/>
                        </a:lnTo>
                        <a:lnTo>
                          <a:pt x="336" y="442"/>
                        </a:lnTo>
                        <a:lnTo>
                          <a:pt x="355" y="436"/>
                        </a:lnTo>
                        <a:lnTo>
                          <a:pt x="368" y="436"/>
                        </a:lnTo>
                        <a:lnTo>
                          <a:pt x="382" y="451"/>
                        </a:lnTo>
                        <a:lnTo>
                          <a:pt x="394" y="444"/>
                        </a:lnTo>
                        <a:lnTo>
                          <a:pt x="388" y="429"/>
                        </a:lnTo>
                        <a:lnTo>
                          <a:pt x="385" y="412"/>
                        </a:lnTo>
                        <a:lnTo>
                          <a:pt x="405" y="399"/>
                        </a:lnTo>
                        <a:lnTo>
                          <a:pt x="414" y="384"/>
                        </a:lnTo>
                        <a:lnTo>
                          <a:pt x="419" y="370"/>
                        </a:lnTo>
                        <a:lnTo>
                          <a:pt x="444" y="361"/>
                        </a:lnTo>
                        <a:lnTo>
                          <a:pt x="456" y="348"/>
                        </a:lnTo>
                        <a:lnTo>
                          <a:pt x="460" y="317"/>
                        </a:lnTo>
                        <a:lnTo>
                          <a:pt x="460" y="292"/>
                        </a:lnTo>
                        <a:lnTo>
                          <a:pt x="427" y="282"/>
                        </a:lnTo>
                        <a:lnTo>
                          <a:pt x="411" y="266"/>
                        </a:lnTo>
                        <a:lnTo>
                          <a:pt x="394" y="270"/>
                        </a:lnTo>
                        <a:lnTo>
                          <a:pt x="371" y="254"/>
                        </a:lnTo>
                        <a:lnTo>
                          <a:pt x="360" y="258"/>
                        </a:lnTo>
                        <a:lnTo>
                          <a:pt x="369" y="237"/>
                        </a:lnTo>
                        <a:lnTo>
                          <a:pt x="382" y="237"/>
                        </a:lnTo>
                        <a:lnTo>
                          <a:pt x="386" y="219"/>
                        </a:lnTo>
                        <a:lnTo>
                          <a:pt x="368" y="209"/>
                        </a:lnTo>
                        <a:lnTo>
                          <a:pt x="350" y="209"/>
                        </a:lnTo>
                        <a:lnTo>
                          <a:pt x="357" y="171"/>
                        </a:lnTo>
                        <a:lnTo>
                          <a:pt x="369" y="159"/>
                        </a:lnTo>
                        <a:lnTo>
                          <a:pt x="373" y="142"/>
                        </a:lnTo>
                        <a:lnTo>
                          <a:pt x="380" y="136"/>
                        </a:lnTo>
                        <a:lnTo>
                          <a:pt x="385" y="109"/>
                        </a:lnTo>
                        <a:lnTo>
                          <a:pt x="386" y="84"/>
                        </a:lnTo>
                        <a:lnTo>
                          <a:pt x="373" y="61"/>
                        </a:lnTo>
                        <a:lnTo>
                          <a:pt x="364" y="55"/>
                        </a:lnTo>
                        <a:lnTo>
                          <a:pt x="344" y="29"/>
                        </a:lnTo>
                        <a:lnTo>
                          <a:pt x="321" y="28"/>
                        </a:lnTo>
                        <a:lnTo>
                          <a:pt x="305" y="13"/>
                        </a:lnTo>
                        <a:lnTo>
                          <a:pt x="276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7" name="Freeform 25"/>
                  <p:cNvSpPr>
                    <a:spLocks/>
                  </p:cNvSpPr>
                  <p:nvPr/>
                </p:nvSpPr>
                <p:spPr bwMode="auto">
                  <a:xfrm>
                    <a:off x="1576224" y="5649183"/>
                    <a:ext cx="956368" cy="946899"/>
                  </a:xfrm>
                  <a:custGeom>
                    <a:avLst/>
                    <a:gdLst/>
                    <a:ahLst/>
                    <a:cxnLst>
                      <a:cxn ang="0">
                        <a:pos x="97" y="9"/>
                      </a:cxn>
                      <a:cxn ang="0">
                        <a:pos x="81" y="33"/>
                      </a:cxn>
                      <a:cxn ang="0">
                        <a:pos x="48" y="76"/>
                      </a:cxn>
                      <a:cxn ang="0">
                        <a:pos x="30" y="152"/>
                      </a:cxn>
                      <a:cxn ang="0">
                        <a:pos x="9" y="193"/>
                      </a:cxn>
                      <a:cxn ang="0">
                        <a:pos x="0" y="230"/>
                      </a:cxn>
                      <a:cxn ang="0">
                        <a:pos x="41" y="242"/>
                      </a:cxn>
                      <a:cxn ang="0">
                        <a:pos x="67" y="242"/>
                      </a:cxn>
                      <a:cxn ang="0">
                        <a:pos x="80" y="275"/>
                      </a:cxn>
                      <a:cxn ang="0">
                        <a:pos x="96" y="325"/>
                      </a:cxn>
                      <a:cxn ang="0">
                        <a:pos x="137" y="410"/>
                      </a:cxn>
                      <a:cxn ang="0">
                        <a:pos x="141" y="462"/>
                      </a:cxn>
                      <a:cxn ang="0">
                        <a:pos x="176" y="502"/>
                      </a:cxn>
                      <a:cxn ang="0">
                        <a:pos x="193" y="535"/>
                      </a:cxn>
                      <a:cxn ang="0">
                        <a:pos x="233" y="600"/>
                      </a:cxn>
                      <a:cxn ang="0">
                        <a:pos x="266" y="596"/>
                      </a:cxn>
                      <a:cxn ang="0">
                        <a:pos x="292" y="594"/>
                      </a:cxn>
                      <a:cxn ang="0">
                        <a:pos x="314" y="583"/>
                      </a:cxn>
                      <a:cxn ang="0">
                        <a:pos x="355" y="581"/>
                      </a:cxn>
                      <a:cxn ang="0">
                        <a:pos x="384" y="579"/>
                      </a:cxn>
                      <a:cxn ang="0">
                        <a:pos x="421" y="568"/>
                      </a:cxn>
                      <a:cxn ang="0">
                        <a:pos x="520" y="580"/>
                      </a:cxn>
                      <a:cxn ang="0">
                        <a:pos x="521" y="531"/>
                      </a:cxn>
                      <a:cxn ang="0">
                        <a:pos x="529" y="512"/>
                      </a:cxn>
                      <a:cxn ang="0">
                        <a:pos x="537" y="451"/>
                      </a:cxn>
                      <a:cxn ang="0">
                        <a:pos x="542" y="421"/>
                      </a:cxn>
                      <a:cxn ang="0">
                        <a:pos x="602" y="401"/>
                      </a:cxn>
                      <a:cxn ang="0">
                        <a:pos x="567" y="327"/>
                      </a:cxn>
                      <a:cxn ang="0">
                        <a:pos x="533" y="334"/>
                      </a:cxn>
                      <a:cxn ang="0">
                        <a:pos x="513" y="319"/>
                      </a:cxn>
                      <a:cxn ang="0">
                        <a:pos x="498" y="301"/>
                      </a:cxn>
                      <a:cxn ang="0">
                        <a:pos x="445" y="325"/>
                      </a:cxn>
                      <a:cxn ang="0">
                        <a:pos x="409" y="288"/>
                      </a:cxn>
                      <a:cxn ang="0">
                        <a:pos x="381" y="256"/>
                      </a:cxn>
                      <a:cxn ang="0">
                        <a:pos x="318" y="254"/>
                      </a:cxn>
                      <a:cxn ang="0">
                        <a:pos x="306" y="233"/>
                      </a:cxn>
                      <a:cxn ang="0">
                        <a:pos x="252" y="235"/>
                      </a:cxn>
                      <a:cxn ang="0">
                        <a:pos x="214" y="192"/>
                      </a:cxn>
                      <a:cxn ang="0">
                        <a:pos x="214" y="148"/>
                      </a:cxn>
                      <a:cxn ang="0">
                        <a:pos x="227" y="86"/>
                      </a:cxn>
                      <a:cxn ang="0">
                        <a:pos x="242" y="61"/>
                      </a:cxn>
                      <a:cxn ang="0">
                        <a:pos x="237" y="4"/>
                      </a:cxn>
                      <a:cxn ang="0">
                        <a:pos x="185" y="39"/>
                      </a:cxn>
                      <a:cxn ang="0">
                        <a:pos x="164" y="48"/>
                      </a:cxn>
                      <a:cxn ang="0">
                        <a:pos x="151" y="17"/>
                      </a:cxn>
                    </a:cxnLst>
                    <a:rect l="0" t="0" r="r" b="b"/>
                    <a:pathLst>
                      <a:path w="606" h="600">
                        <a:moveTo>
                          <a:pt x="120" y="0"/>
                        </a:moveTo>
                        <a:lnTo>
                          <a:pt x="97" y="9"/>
                        </a:lnTo>
                        <a:lnTo>
                          <a:pt x="79" y="14"/>
                        </a:lnTo>
                        <a:lnTo>
                          <a:pt x="81" y="33"/>
                        </a:lnTo>
                        <a:lnTo>
                          <a:pt x="71" y="35"/>
                        </a:lnTo>
                        <a:lnTo>
                          <a:pt x="48" y="76"/>
                        </a:lnTo>
                        <a:lnTo>
                          <a:pt x="47" y="98"/>
                        </a:lnTo>
                        <a:lnTo>
                          <a:pt x="30" y="152"/>
                        </a:lnTo>
                        <a:lnTo>
                          <a:pt x="18" y="156"/>
                        </a:lnTo>
                        <a:lnTo>
                          <a:pt x="9" y="193"/>
                        </a:lnTo>
                        <a:lnTo>
                          <a:pt x="8" y="217"/>
                        </a:lnTo>
                        <a:lnTo>
                          <a:pt x="0" y="230"/>
                        </a:lnTo>
                        <a:lnTo>
                          <a:pt x="0" y="242"/>
                        </a:lnTo>
                        <a:lnTo>
                          <a:pt x="41" y="242"/>
                        </a:lnTo>
                        <a:lnTo>
                          <a:pt x="54" y="250"/>
                        </a:lnTo>
                        <a:lnTo>
                          <a:pt x="67" y="242"/>
                        </a:lnTo>
                        <a:lnTo>
                          <a:pt x="77" y="252"/>
                        </a:lnTo>
                        <a:lnTo>
                          <a:pt x="80" y="275"/>
                        </a:lnTo>
                        <a:lnTo>
                          <a:pt x="98" y="290"/>
                        </a:lnTo>
                        <a:lnTo>
                          <a:pt x="96" y="325"/>
                        </a:lnTo>
                        <a:lnTo>
                          <a:pt x="121" y="389"/>
                        </a:lnTo>
                        <a:lnTo>
                          <a:pt x="137" y="410"/>
                        </a:lnTo>
                        <a:lnTo>
                          <a:pt x="134" y="435"/>
                        </a:lnTo>
                        <a:lnTo>
                          <a:pt x="141" y="462"/>
                        </a:lnTo>
                        <a:lnTo>
                          <a:pt x="160" y="480"/>
                        </a:lnTo>
                        <a:lnTo>
                          <a:pt x="176" y="502"/>
                        </a:lnTo>
                        <a:lnTo>
                          <a:pt x="189" y="521"/>
                        </a:lnTo>
                        <a:lnTo>
                          <a:pt x="193" y="535"/>
                        </a:lnTo>
                        <a:lnTo>
                          <a:pt x="222" y="583"/>
                        </a:lnTo>
                        <a:lnTo>
                          <a:pt x="233" y="600"/>
                        </a:lnTo>
                        <a:lnTo>
                          <a:pt x="247" y="593"/>
                        </a:lnTo>
                        <a:lnTo>
                          <a:pt x="266" y="596"/>
                        </a:lnTo>
                        <a:lnTo>
                          <a:pt x="279" y="592"/>
                        </a:lnTo>
                        <a:lnTo>
                          <a:pt x="292" y="594"/>
                        </a:lnTo>
                        <a:lnTo>
                          <a:pt x="318" y="596"/>
                        </a:lnTo>
                        <a:lnTo>
                          <a:pt x="314" y="583"/>
                        </a:lnTo>
                        <a:lnTo>
                          <a:pt x="346" y="577"/>
                        </a:lnTo>
                        <a:lnTo>
                          <a:pt x="355" y="581"/>
                        </a:lnTo>
                        <a:lnTo>
                          <a:pt x="360" y="577"/>
                        </a:lnTo>
                        <a:lnTo>
                          <a:pt x="384" y="579"/>
                        </a:lnTo>
                        <a:lnTo>
                          <a:pt x="380" y="567"/>
                        </a:lnTo>
                        <a:lnTo>
                          <a:pt x="421" y="568"/>
                        </a:lnTo>
                        <a:lnTo>
                          <a:pt x="426" y="580"/>
                        </a:lnTo>
                        <a:lnTo>
                          <a:pt x="520" y="580"/>
                        </a:lnTo>
                        <a:lnTo>
                          <a:pt x="513" y="572"/>
                        </a:lnTo>
                        <a:lnTo>
                          <a:pt x="521" y="531"/>
                        </a:lnTo>
                        <a:lnTo>
                          <a:pt x="514" y="513"/>
                        </a:lnTo>
                        <a:lnTo>
                          <a:pt x="529" y="512"/>
                        </a:lnTo>
                        <a:lnTo>
                          <a:pt x="541" y="500"/>
                        </a:lnTo>
                        <a:lnTo>
                          <a:pt x="537" y="451"/>
                        </a:lnTo>
                        <a:lnTo>
                          <a:pt x="547" y="434"/>
                        </a:lnTo>
                        <a:lnTo>
                          <a:pt x="542" y="421"/>
                        </a:lnTo>
                        <a:lnTo>
                          <a:pt x="606" y="419"/>
                        </a:lnTo>
                        <a:lnTo>
                          <a:pt x="602" y="401"/>
                        </a:lnTo>
                        <a:lnTo>
                          <a:pt x="570" y="369"/>
                        </a:lnTo>
                        <a:lnTo>
                          <a:pt x="567" y="327"/>
                        </a:lnTo>
                        <a:lnTo>
                          <a:pt x="552" y="333"/>
                        </a:lnTo>
                        <a:lnTo>
                          <a:pt x="533" y="334"/>
                        </a:lnTo>
                        <a:lnTo>
                          <a:pt x="530" y="313"/>
                        </a:lnTo>
                        <a:lnTo>
                          <a:pt x="513" y="319"/>
                        </a:lnTo>
                        <a:lnTo>
                          <a:pt x="496" y="312"/>
                        </a:lnTo>
                        <a:lnTo>
                          <a:pt x="498" y="301"/>
                        </a:lnTo>
                        <a:lnTo>
                          <a:pt x="470" y="305"/>
                        </a:lnTo>
                        <a:lnTo>
                          <a:pt x="445" y="325"/>
                        </a:lnTo>
                        <a:lnTo>
                          <a:pt x="421" y="310"/>
                        </a:lnTo>
                        <a:lnTo>
                          <a:pt x="409" y="288"/>
                        </a:lnTo>
                        <a:lnTo>
                          <a:pt x="389" y="283"/>
                        </a:lnTo>
                        <a:lnTo>
                          <a:pt x="381" y="256"/>
                        </a:lnTo>
                        <a:lnTo>
                          <a:pt x="343" y="246"/>
                        </a:lnTo>
                        <a:lnTo>
                          <a:pt x="318" y="254"/>
                        </a:lnTo>
                        <a:lnTo>
                          <a:pt x="309" y="256"/>
                        </a:lnTo>
                        <a:lnTo>
                          <a:pt x="306" y="233"/>
                        </a:lnTo>
                        <a:lnTo>
                          <a:pt x="273" y="227"/>
                        </a:lnTo>
                        <a:lnTo>
                          <a:pt x="252" y="235"/>
                        </a:lnTo>
                        <a:lnTo>
                          <a:pt x="220" y="221"/>
                        </a:lnTo>
                        <a:lnTo>
                          <a:pt x="214" y="192"/>
                        </a:lnTo>
                        <a:lnTo>
                          <a:pt x="223" y="169"/>
                        </a:lnTo>
                        <a:lnTo>
                          <a:pt x="214" y="148"/>
                        </a:lnTo>
                        <a:lnTo>
                          <a:pt x="227" y="122"/>
                        </a:lnTo>
                        <a:lnTo>
                          <a:pt x="227" y="86"/>
                        </a:lnTo>
                        <a:lnTo>
                          <a:pt x="223" y="67"/>
                        </a:lnTo>
                        <a:lnTo>
                          <a:pt x="242" y="61"/>
                        </a:lnTo>
                        <a:lnTo>
                          <a:pt x="242" y="31"/>
                        </a:lnTo>
                        <a:lnTo>
                          <a:pt x="237" y="4"/>
                        </a:lnTo>
                        <a:lnTo>
                          <a:pt x="216" y="25"/>
                        </a:lnTo>
                        <a:lnTo>
                          <a:pt x="185" y="39"/>
                        </a:lnTo>
                        <a:lnTo>
                          <a:pt x="179" y="47"/>
                        </a:lnTo>
                        <a:lnTo>
                          <a:pt x="164" y="48"/>
                        </a:lnTo>
                        <a:lnTo>
                          <a:pt x="151" y="29"/>
                        </a:lnTo>
                        <a:lnTo>
                          <a:pt x="151" y="17"/>
                        </a:lnTo>
                        <a:lnTo>
                          <a:pt x="120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8" name="Freeform 26"/>
                  <p:cNvSpPr>
                    <a:spLocks/>
                  </p:cNvSpPr>
                  <p:nvPr/>
                </p:nvSpPr>
                <p:spPr bwMode="auto">
                  <a:xfrm>
                    <a:off x="1685118" y="5382474"/>
                    <a:ext cx="904289" cy="793816"/>
                  </a:xfrm>
                  <a:custGeom>
                    <a:avLst/>
                    <a:gdLst/>
                    <a:ahLst/>
                    <a:cxnLst>
                      <a:cxn ang="0">
                        <a:pos x="92" y="11"/>
                      </a:cxn>
                      <a:cxn ang="0">
                        <a:pos x="91" y="63"/>
                      </a:cxn>
                      <a:cxn ang="0">
                        <a:pos x="48" y="96"/>
                      </a:cxn>
                      <a:cxn ang="0">
                        <a:pos x="0" y="120"/>
                      </a:cxn>
                      <a:cxn ang="0">
                        <a:pos x="7" y="139"/>
                      </a:cxn>
                      <a:cxn ang="0">
                        <a:pos x="38" y="128"/>
                      </a:cxn>
                      <a:cxn ang="0">
                        <a:pos x="62" y="150"/>
                      </a:cxn>
                      <a:cxn ang="0">
                        <a:pos x="83" y="164"/>
                      </a:cxn>
                      <a:cxn ang="0">
                        <a:pos x="111" y="147"/>
                      </a:cxn>
                      <a:cxn ang="0">
                        <a:pos x="131" y="152"/>
                      </a:cxn>
                      <a:cxn ang="0">
                        <a:pos x="117" y="179"/>
                      </a:cxn>
                      <a:cxn ang="0">
                        <a:pos x="120" y="221"/>
                      </a:cxn>
                      <a:cxn ang="0">
                        <a:pos x="117" y="257"/>
                      </a:cxn>
                      <a:cxn ang="0">
                        <a:pos x="114" y="296"/>
                      </a:cxn>
                      <a:cxn ang="0">
                        <a:pos x="155" y="301"/>
                      </a:cxn>
                      <a:cxn ang="0">
                        <a:pos x="182" y="323"/>
                      </a:cxn>
                      <a:cxn ang="0">
                        <a:pos x="208" y="315"/>
                      </a:cxn>
                      <a:cxn ang="0">
                        <a:pos x="243" y="343"/>
                      </a:cxn>
                      <a:cxn ang="0">
                        <a:pos x="267" y="364"/>
                      </a:cxn>
                      <a:cxn ang="0">
                        <a:pos x="304" y="360"/>
                      </a:cxn>
                      <a:cxn ang="0">
                        <a:pos x="324" y="365"/>
                      </a:cxn>
                      <a:cxn ang="0">
                        <a:pos x="350" y="366"/>
                      </a:cxn>
                      <a:cxn ang="0">
                        <a:pos x="367" y="381"/>
                      </a:cxn>
                      <a:cxn ang="0">
                        <a:pos x="377" y="355"/>
                      </a:cxn>
                      <a:cxn ang="0">
                        <a:pos x="435" y="297"/>
                      </a:cxn>
                      <a:cxn ang="0">
                        <a:pos x="435" y="240"/>
                      </a:cxn>
                      <a:cxn ang="0">
                        <a:pos x="420" y="187"/>
                      </a:cxn>
                      <a:cxn ang="0">
                        <a:pos x="422" y="165"/>
                      </a:cxn>
                      <a:cxn ang="0">
                        <a:pos x="421" y="125"/>
                      </a:cxn>
                      <a:cxn ang="0">
                        <a:pos x="405" y="111"/>
                      </a:cxn>
                      <a:cxn ang="0">
                        <a:pos x="280" y="50"/>
                      </a:cxn>
                      <a:cxn ang="0">
                        <a:pos x="189" y="21"/>
                      </a:cxn>
                      <a:cxn ang="0">
                        <a:pos x="102" y="0"/>
                      </a:cxn>
                    </a:cxnLst>
                    <a:rect l="0" t="0" r="r" b="b"/>
                    <a:pathLst>
                      <a:path w="435" h="382">
                        <a:moveTo>
                          <a:pt x="102" y="0"/>
                        </a:moveTo>
                        <a:cubicBezTo>
                          <a:pt x="92" y="11"/>
                          <a:pt x="92" y="11"/>
                          <a:pt x="92" y="11"/>
                        </a:cubicBezTo>
                        <a:cubicBezTo>
                          <a:pt x="97" y="46"/>
                          <a:pt x="97" y="46"/>
                          <a:pt x="97" y="46"/>
                        </a:cubicBezTo>
                        <a:cubicBezTo>
                          <a:pt x="91" y="63"/>
                          <a:pt x="91" y="63"/>
                          <a:pt x="91" y="63"/>
                        </a:cubicBezTo>
                        <a:cubicBezTo>
                          <a:pt x="73" y="88"/>
                          <a:pt x="73" y="88"/>
                          <a:pt x="73" y="88"/>
                        </a:cubicBezTo>
                        <a:cubicBezTo>
                          <a:pt x="48" y="96"/>
                          <a:pt x="48" y="96"/>
                          <a:pt x="48" y="96"/>
                        </a:cubicBezTo>
                        <a:cubicBezTo>
                          <a:pt x="14" y="115"/>
                          <a:pt x="14" y="115"/>
                          <a:pt x="14" y="115"/>
                        </a:cubicBezTo>
                        <a:cubicBezTo>
                          <a:pt x="14" y="115"/>
                          <a:pt x="7" y="118"/>
                          <a:pt x="0" y="120"/>
                        </a:cubicBezTo>
                        <a:cubicBezTo>
                          <a:pt x="5" y="131"/>
                          <a:pt x="5" y="131"/>
                          <a:pt x="5" y="131"/>
                        </a:cubicBezTo>
                        <a:cubicBezTo>
                          <a:pt x="7" y="139"/>
                          <a:pt x="7" y="139"/>
                          <a:pt x="7" y="139"/>
                        </a:cubicBezTo>
                        <a:cubicBezTo>
                          <a:pt x="21" y="135"/>
                          <a:pt x="21" y="135"/>
                          <a:pt x="21" y="135"/>
                        </a:cubicBezTo>
                        <a:cubicBezTo>
                          <a:pt x="38" y="128"/>
                          <a:pt x="38" y="128"/>
                          <a:pt x="38" y="128"/>
                        </a:cubicBezTo>
                        <a:cubicBezTo>
                          <a:pt x="62" y="141"/>
                          <a:pt x="62" y="141"/>
                          <a:pt x="62" y="141"/>
                        </a:cubicBezTo>
                        <a:cubicBezTo>
                          <a:pt x="62" y="150"/>
                          <a:pt x="62" y="150"/>
                          <a:pt x="62" y="150"/>
                        </a:cubicBezTo>
                        <a:cubicBezTo>
                          <a:pt x="72" y="165"/>
                          <a:pt x="72" y="165"/>
                          <a:pt x="72" y="165"/>
                        </a:cubicBezTo>
                        <a:cubicBezTo>
                          <a:pt x="83" y="164"/>
                          <a:pt x="83" y="164"/>
                          <a:pt x="83" y="164"/>
                        </a:cubicBezTo>
                        <a:cubicBezTo>
                          <a:pt x="88" y="158"/>
                          <a:pt x="88" y="158"/>
                          <a:pt x="88" y="158"/>
                        </a:cubicBezTo>
                        <a:cubicBezTo>
                          <a:pt x="111" y="147"/>
                          <a:pt x="111" y="147"/>
                          <a:pt x="111" y="147"/>
                        </a:cubicBezTo>
                        <a:cubicBezTo>
                          <a:pt x="127" y="131"/>
                          <a:pt x="127" y="131"/>
                          <a:pt x="127" y="131"/>
                        </a:cubicBezTo>
                        <a:cubicBezTo>
                          <a:pt x="131" y="152"/>
                          <a:pt x="131" y="152"/>
                          <a:pt x="131" y="152"/>
                        </a:cubicBezTo>
                        <a:cubicBezTo>
                          <a:pt x="131" y="175"/>
                          <a:pt x="131" y="175"/>
                          <a:pt x="131" y="175"/>
                        </a:cubicBezTo>
                        <a:cubicBezTo>
                          <a:pt x="117" y="179"/>
                          <a:pt x="117" y="179"/>
                          <a:pt x="117" y="179"/>
                        </a:cubicBezTo>
                        <a:cubicBezTo>
                          <a:pt x="120" y="194"/>
                          <a:pt x="120" y="194"/>
                          <a:pt x="120" y="194"/>
                        </a:cubicBezTo>
                        <a:cubicBezTo>
                          <a:pt x="120" y="221"/>
                          <a:pt x="120" y="221"/>
                          <a:pt x="120" y="221"/>
                        </a:cubicBezTo>
                        <a:cubicBezTo>
                          <a:pt x="110" y="241"/>
                          <a:pt x="110" y="241"/>
                          <a:pt x="110" y="241"/>
                        </a:cubicBezTo>
                        <a:cubicBezTo>
                          <a:pt x="117" y="257"/>
                          <a:pt x="117" y="257"/>
                          <a:pt x="117" y="257"/>
                        </a:cubicBezTo>
                        <a:cubicBezTo>
                          <a:pt x="110" y="274"/>
                          <a:pt x="110" y="274"/>
                          <a:pt x="110" y="274"/>
                        </a:cubicBezTo>
                        <a:cubicBezTo>
                          <a:pt x="114" y="296"/>
                          <a:pt x="114" y="296"/>
                          <a:pt x="114" y="296"/>
                        </a:cubicBezTo>
                        <a:cubicBezTo>
                          <a:pt x="139" y="307"/>
                          <a:pt x="139" y="307"/>
                          <a:pt x="139" y="307"/>
                        </a:cubicBezTo>
                        <a:cubicBezTo>
                          <a:pt x="155" y="301"/>
                          <a:pt x="155" y="301"/>
                          <a:pt x="155" y="301"/>
                        </a:cubicBezTo>
                        <a:cubicBezTo>
                          <a:pt x="180" y="305"/>
                          <a:pt x="180" y="305"/>
                          <a:pt x="180" y="305"/>
                        </a:cubicBezTo>
                        <a:cubicBezTo>
                          <a:pt x="182" y="323"/>
                          <a:pt x="182" y="323"/>
                          <a:pt x="182" y="323"/>
                        </a:cubicBezTo>
                        <a:cubicBezTo>
                          <a:pt x="189" y="321"/>
                          <a:pt x="189" y="321"/>
                          <a:pt x="189" y="321"/>
                        </a:cubicBezTo>
                        <a:cubicBezTo>
                          <a:pt x="208" y="315"/>
                          <a:pt x="208" y="315"/>
                          <a:pt x="208" y="315"/>
                        </a:cubicBezTo>
                        <a:cubicBezTo>
                          <a:pt x="237" y="323"/>
                          <a:pt x="237" y="323"/>
                          <a:pt x="237" y="323"/>
                        </a:cubicBezTo>
                        <a:cubicBezTo>
                          <a:pt x="243" y="343"/>
                          <a:pt x="243" y="343"/>
                          <a:pt x="243" y="343"/>
                        </a:cubicBezTo>
                        <a:cubicBezTo>
                          <a:pt x="258" y="347"/>
                          <a:pt x="258" y="347"/>
                          <a:pt x="258" y="347"/>
                        </a:cubicBezTo>
                        <a:cubicBezTo>
                          <a:pt x="267" y="364"/>
                          <a:pt x="267" y="364"/>
                          <a:pt x="267" y="364"/>
                        </a:cubicBezTo>
                        <a:cubicBezTo>
                          <a:pt x="285" y="375"/>
                          <a:pt x="285" y="375"/>
                          <a:pt x="285" y="375"/>
                        </a:cubicBezTo>
                        <a:cubicBezTo>
                          <a:pt x="304" y="360"/>
                          <a:pt x="304" y="360"/>
                          <a:pt x="304" y="360"/>
                        </a:cubicBezTo>
                        <a:cubicBezTo>
                          <a:pt x="326" y="357"/>
                          <a:pt x="326" y="357"/>
                          <a:pt x="326" y="357"/>
                        </a:cubicBezTo>
                        <a:cubicBezTo>
                          <a:pt x="324" y="365"/>
                          <a:pt x="324" y="365"/>
                          <a:pt x="324" y="365"/>
                        </a:cubicBezTo>
                        <a:cubicBezTo>
                          <a:pt x="337" y="371"/>
                          <a:pt x="337" y="371"/>
                          <a:pt x="337" y="371"/>
                        </a:cubicBezTo>
                        <a:cubicBezTo>
                          <a:pt x="350" y="366"/>
                          <a:pt x="350" y="366"/>
                          <a:pt x="350" y="366"/>
                        </a:cubicBezTo>
                        <a:cubicBezTo>
                          <a:pt x="352" y="382"/>
                          <a:pt x="352" y="382"/>
                          <a:pt x="352" y="382"/>
                        </a:cubicBezTo>
                        <a:cubicBezTo>
                          <a:pt x="367" y="381"/>
                          <a:pt x="367" y="381"/>
                          <a:pt x="367" y="381"/>
                        </a:cubicBezTo>
                        <a:cubicBezTo>
                          <a:pt x="378" y="377"/>
                          <a:pt x="378" y="377"/>
                          <a:pt x="378" y="377"/>
                        </a:cubicBezTo>
                        <a:cubicBezTo>
                          <a:pt x="377" y="355"/>
                          <a:pt x="377" y="355"/>
                          <a:pt x="377" y="355"/>
                        </a:cubicBezTo>
                        <a:cubicBezTo>
                          <a:pt x="415" y="320"/>
                          <a:pt x="415" y="320"/>
                          <a:pt x="415" y="320"/>
                        </a:cubicBezTo>
                        <a:cubicBezTo>
                          <a:pt x="435" y="297"/>
                          <a:pt x="435" y="297"/>
                          <a:pt x="435" y="297"/>
                        </a:cubicBezTo>
                        <a:cubicBezTo>
                          <a:pt x="427" y="269"/>
                          <a:pt x="427" y="269"/>
                          <a:pt x="427" y="269"/>
                        </a:cubicBezTo>
                        <a:cubicBezTo>
                          <a:pt x="435" y="240"/>
                          <a:pt x="435" y="240"/>
                          <a:pt x="435" y="240"/>
                        </a:cubicBezTo>
                        <a:cubicBezTo>
                          <a:pt x="427" y="209"/>
                          <a:pt x="427" y="209"/>
                          <a:pt x="427" y="209"/>
                        </a:cubicBezTo>
                        <a:cubicBezTo>
                          <a:pt x="420" y="187"/>
                          <a:pt x="420" y="187"/>
                          <a:pt x="420" y="187"/>
                        </a:cubicBezTo>
                        <a:cubicBezTo>
                          <a:pt x="425" y="174"/>
                          <a:pt x="425" y="174"/>
                          <a:pt x="425" y="174"/>
                        </a:cubicBezTo>
                        <a:cubicBezTo>
                          <a:pt x="422" y="165"/>
                          <a:pt x="422" y="165"/>
                          <a:pt x="422" y="165"/>
                        </a:cubicBezTo>
                        <a:cubicBezTo>
                          <a:pt x="432" y="155"/>
                          <a:pt x="432" y="155"/>
                          <a:pt x="432" y="155"/>
                        </a:cubicBezTo>
                        <a:cubicBezTo>
                          <a:pt x="421" y="125"/>
                          <a:pt x="421" y="125"/>
                          <a:pt x="421" y="125"/>
                        </a:cubicBezTo>
                        <a:cubicBezTo>
                          <a:pt x="423" y="125"/>
                          <a:pt x="423" y="125"/>
                          <a:pt x="423" y="125"/>
                        </a:cubicBezTo>
                        <a:cubicBezTo>
                          <a:pt x="405" y="111"/>
                          <a:pt x="405" y="111"/>
                          <a:pt x="405" y="111"/>
                        </a:cubicBezTo>
                        <a:cubicBezTo>
                          <a:pt x="353" y="87"/>
                          <a:pt x="353" y="87"/>
                          <a:pt x="353" y="87"/>
                        </a:cubicBezTo>
                        <a:cubicBezTo>
                          <a:pt x="280" y="50"/>
                          <a:pt x="280" y="50"/>
                          <a:pt x="280" y="50"/>
                        </a:cubicBezTo>
                        <a:cubicBezTo>
                          <a:pt x="224" y="36"/>
                          <a:pt x="224" y="36"/>
                          <a:pt x="224" y="36"/>
                        </a:cubicBezTo>
                        <a:cubicBezTo>
                          <a:pt x="189" y="21"/>
                          <a:pt x="189" y="21"/>
                          <a:pt x="189" y="21"/>
                        </a:cubicBezTo>
                        <a:cubicBezTo>
                          <a:pt x="156" y="20"/>
                          <a:pt x="156" y="20"/>
                          <a:pt x="156" y="20"/>
                        </a:cubicBezTo>
                        <a:lnTo>
                          <a:pt x="102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69" name="Freeform 27"/>
                  <p:cNvSpPr>
                    <a:spLocks/>
                  </p:cNvSpPr>
                  <p:nvPr/>
                </p:nvSpPr>
                <p:spPr bwMode="auto">
                  <a:xfrm>
                    <a:off x="1533614" y="4768567"/>
                    <a:ext cx="1272001" cy="894819"/>
                  </a:xfrm>
                  <a:custGeom>
                    <a:avLst/>
                    <a:gdLst/>
                    <a:ahLst/>
                    <a:cxnLst>
                      <a:cxn ang="0">
                        <a:pos x="358" y="7"/>
                      </a:cxn>
                      <a:cxn ang="0">
                        <a:pos x="336" y="29"/>
                      </a:cxn>
                      <a:cxn ang="0">
                        <a:pos x="349" y="47"/>
                      </a:cxn>
                      <a:cxn ang="0">
                        <a:pos x="336" y="50"/>
                      </a:cxn>
                      <a:cxn ang="0">
                        <a:pos x="325" y="63"/>
                      </a:cxn>
                      <a:cxn ang="0">
                        <a:pos x="292" y="46"/>
                      </a:cxn>
                      <a:cxn ang="0">
                        <a:pos x="264" y="62"/>
                      </a:cxn>
                      <a:cxn ang="0">
                        <a:pos x="226" y="78"/>
                      </a:cxn>
                      <a:cxn ang="0">
                        <a:pos x="176" y="99"/>
                      </a:cxn>
                      <a:cxn ang="0">
                        <a:pos x="137" y="124"/>
                      </a:cxn>
                      <a:cxn ang="0">
                        <a:pos x="109" y="126"/>
                      </a:cxn>
                      <a:cxn ang="0">
                        <a:pos x="118" y="148"/>
                      </a:cxn>
                      <a:cxn ang="0">
                        <a:pos x="81" y="141"/>
                      </a:cxn>
                      <a:cxn ang="0">
                        <a:pos x="45" y="156"/>
                      </a:cxn>
                      <a:cxn ang="0">
                        <a:pos x="32" y="199"/>
                      </a:cxn>
                      <a:cxn ang="0">
                        <a:pos x="33" y="240"/>
                      </a:cxn>
                      <a:cxn ang="0">
                        <a:pos x="31" y="294"/>
                      </a:cxn>
                      <a:cxn ang="0">
                        <a:pos x="27" y="316"/>
                      </a:cxn>
                      <a:cxn ang="0">
                        <a:pos x="22" y="389"/>
                      </a:cxn>
                      <a:cxn ang="0">
                        <a:pos x="65" y="413"/>
                      </a:cxn>
                      <a:cxn ang="0">
                        <a:pos x="73" y="416"/>
                      </a:cxn>
                      <a:cxn ang="0">
                        <a:pos x="121" y="392"/>
                      </a:cxn>
                      <a:cxn ang="0">
                        <a:pos x="164" y="359"/>
                      </a:cxn>
                      <a:cxn ang="0">
                        <a:pos x="165" y="307"/>
                      </a:cxn>
                      <a:cxn ang="0">
                        <a:pos x="229" y="316"/>
                      </a:cxn>
                      <a:cxn ang="0">
                        <a:pos x="297" y="332"/>
                      </a:cxn>
                      <a:cxn ang="0">
                        <a:pos x="426" y="383"/>
                      </a:cxn>
                      <a:cxn ang="0">
                        <a:pos x="496" y="421"/>
                      </a:cxn>
                      <a:cxn ang="0">
                        <a:pos x="516" y="429"/>
                      </a:cxn>
                      <a:cxn ang="0">
                        <a:pos x="541" y="418"/>
                      </a:cxn>
                      <a:cxn ang="0">
                        <a:pos x="566" y="313"/>
                      </a:cxn>
                      <a:cxn ang="0">
                        <a:pos x="588" y="242"/>
                      </a:cxn>
                      <a:cxn ang="0">
                        <a:pos x="608" y="201"/>
                      </a:cxn>
                      <a:cxn ang="0">
                        <a:pos x="609" y="193"/>
                      </a:cxn>
                      <a:cxn ang="0">
                        <a:pos x="536" y="159"/>
                      </a:cxn>
                      <a:cxn ang="0">
                        <a:pos x="482" y="144"/>
                      </a:cxn>
                      <a:cxn ang="0">
                        <a:pos x="459" y="105"/>
                      </a:cxn>
                      <a:cxn ang="0">
                        <a:pos x="434" y="123"/>
                      </a:cxn>
                      <a:cxn ang="0">
                        <a:pos x="416" y="83"/>
                      </a:cxn>
                      <a:cxn ang="0">
                        <a:pos x="382" y="27"/>
                      </a:cxn>
                    </a:cxnLst>
                    <a:rect l="0" t="0" r="r" b="b"/>
                    <a:pathLst>
                      <a:path w="612" h="431">
                        <a:moveTo>
                          <a:pt x="373" y="0"/>
                        </a:moveTo>
                        <a:cubicBezTo>
                          <a:pt x="358" y="7"/>
                          <a:pt x="358" y="7"/>
                          <a:pt x="358" y="7"/>
                        </a:cubicBezTo>
                        <a:cubicBezTo>
                          <a:pt x="344" y="5"/>
                          <a:pt x="344" y="5"/>
                          <a:pt x="344" y="5"/>
                        </a:cubicBezTo>
                        <a:cubicBezTo>
                          <a:pt x="336" y="29"/>
                          <a:pt x="336" y="29"/>
                          <a:pt x="336" y="29"/>
                        </a:cubicBezTo>
                        <a:cubicBezTo>
                          <a:pt x="345" y="33"/>
                          <a:pt x="345" y="33"/>
                          <a:pt x="345" y="33"/>
                        </a:cubicBezTo>
                        <a:cubicBezTo>
                          <a:pt x="349" y="47"/>
                          <a:pt x="349" y="47"/>
                          <a:pt x="349" y="47"/>
                        </a:cubicBezTo>
                        <a:cubicBezTo>
                          <a:pt x="337" y="40"/>
                          <a:pt x="337" y="40"/>
                          <a:pt x="337" y="40"/>
                        </a:cubicBezTo>
                        <a:cubicBezTo>
                          <a:pt x="336" y="50"/>
                          <a:pt x="336" y="50"/>
                          <a:pt x="336" y="50"/>
                        </a:cubicBezTo>
                        <a:cubicBezTo>
                          <a:pt x="345" y="60"/>
                          <a:pt x="345" y="60"/>
                          <a:pt x="345" y="60"/>
                        </a:cubicBezTo>
                        <a:cubicBezTo>
                          <a:pt x="325" y="63"/>
                          <a:pt x="325" y="63"/>
                          <a:pt x="325" y="63"/>
                        </a:cubicBezTo>
                        <a:cubicBezTo>
                          <a:pt x="305" y="61"/>
                          <a:pt x="305" y="61"/>
                          <a:pt x="305" y="61"/>
                        </a:cubicBezTo>
                        <a:cubicBezTo>
                          <a:pt x="292" y="46"/>
                          <a:pt x="292" y="46"/>
                          <a:pt x="292" y="46"/>
                        </a:cubicBezTo>
                        <a:cubicBezTo>
                          <a:pt x="268" y="45"/>
                          <a:pt x="268" y="45"/>
                          <a:pt x="268" y="45"/>
                        </a:cubicBezTo>
                        <a:cubicBezTo>
                          <a:pt x="264" y="62"/>
                          <a:pt x="264" y="62"/>
                          <a:pt x="264" y="62"/>
                        </a:cubicBezTo>
                        <a:cubicBezTo>
                          <a:pt x="243" y="79"/>
                          <a:pt x="243" y="79"/>
                          <a:pt x="243" y="79"/>
                        </a:cubicBezTo>
                        <a:cubicBezTo>
                          <a:pt x="226" y="78"/>
                          <a:pt x="226" y="78"/>
                          <a:pt x="226" y="78"/>
                        </a:cubicBezTo>
                        <a:cubicBezTo>
                          <a:pt x="208" y="88"/>
                          <a:pt x="208" y="88"/>
                          <a:pt x="208" y="88"/>
                        </a:cubicBezTo>
                        <a:cubicBezTo>
                          <a:pt x="176" y="99"/>
                          <a:pt x="176" y="99"/>
                          <a:pt x="176" y="99"/>
                        </a:cubicBezTo>
                        <a:cubicBezTo>
                          <a:pt x="167" y="115"/>
                          <a:pt x="167" y="115"/>
                          <a:pt x="167" y="115"/>
                        </a:cubicBezTo>
                        <a:cubicBezTo>
                          <a:pt x="137" y="124"/>
                          <a:pt x="137" y="124"/>
                          <a:pt x="137" y="124"/>
                        </a:cubicBezTo>
                        <a:cubicBezTo>
                          <a:pt x="112" y="121"/>
                          <a:pt x="112" y="121"/>
                          <a:pt x="112" y="121"/>
                        </a:cubicBezTo>
                        <a:cubicBezTo>
                          <a:pt x="109" y="126"/>
                          <a:pt x="109" y="126"/>
                          <a:pt x="109" y="126"/>
                        </a:cubicBezTo>
                        <a:cubicBezTo>
                          <a:pt x="120" y="132"/>
                          <a:pt x="120" y="132"/>
                          <a:pt x="120" y="132"/>
                        </a:cubicBezTo>
                        <a:cubicBezTo>
                          <a:pt x="118" y="148"/>
                          <a:pt x="118" y="148"/>
                          <a:pt x="118" y="148"/>
                        </a:cubicBezTo>
                        <a:cubicBezTo>
                          <a:pt x="90" y="152"/>
                          <a:pt x="90" y="152"/>
                          <a:pt x="90" y="152"/>
                        </a:cubicBezTo>
                        <a:cubicBezTo>
                          <a:pt x="81" y="141"/>
                          <a:pt x="81" y="141"/>
                          <a:pt x="81" y="141"/>
                        </a:cubicBezTo>
                        <a:cubicBezTo>
                          <a:pt x="72" y="132"/>
                          <a:pt x="72" y="132"/>
                          <a:pt x="72" y="132"/>
                        </a:cubicBezTo>
                        <a:cubicBezTo>
                          <a:pt x="45" y="156"/>
                          <a:pt x="45" y="156"/>
                          <a:pt x="45" y="156"/>
                        </a:cubicBezTo>
                        <a:cubicBezTo>
                          <a:pt x="33" y="168"/>
                          <a:pt x="33" y="168"/>
                          <a:pt x="33" y="168"/>
                        </a:cubicBezTo>
                        <a:cubicBezTo>
                          <a:pt x="32" y="199"/>
                          <a:pt x="32" y="199"/>
                          <a:pt x="32" y="199"/>
                        </a:cubicBezTo>
                        <a:cubicBezTo>
                          <a:pt x="38" y="220"/>
                          <a:pt x="38" y="220"/>
                          <a:pt x="38" y="220"/>
                        </a:cubicBezTo>
                        <a:cubicBezTo>
                          <a:pt x="33" y="240"/>
                          <a:pt x="33" y="240"/>
                          <a:pt x="33" y="240"/>
                        </a:cubicBezTo>
                        <a:cubicBezTo>
                          <a:pt x="31" y="277"/>
                          <a:pt x="31" y="277"/>
                          <a:pt x="31" y="277"/>
                        </a:cubicBezTo>
                        <a:cubicBezTo>
                          <a:pt x="31" y="294"/>
                          <a:pt x="31" y="294"/>
                          <a:pt x="31" y="294"/>
                        </a:cubicBezTo>
                        <a:cubicBezTo>
                          <a:pt x="37" y="300"/>
                          <a:pt x="37" y="300"/>
                          <a:pt x="37" y="300"/>
                        </a:cubicBezTo>
                        <a:cubicBezTo>
                          <a:pt x="27" y="316"/>
                          <a:pt x="27" y="316"/>
                          <a:pt x="27" y="316"/>
                        </a:cubicBezTo>
                        <a:cubicBezTo>
                          <a:pt x="0" y="377"/>
                          <a:pt x="0" y="377"/>
                          <a:pt x="0" y="377"/>
                        </a:cubicBezTo>
                        <a:cubicBezTo>
                          <a:pt x="22" y="389"/>
                          <a:pt x="22" y="389"/>
                          <a:pt x="22" y="389"/>
                        </a:cubicBezTo>
                        <a:cubicBezTo>
                          <a:pt x="60" y="400"/>
                          <a:pt x="60" y="400"/>
                          <a:pt x="60" y="400"/>
                        </a:cubicBezTo>
                        <a:cubicBezTo>
                          <a:pt x="65" y="413"/>
                          <a:pt x="65" y="413"/>
                          <a:pt x="65" y="413"/>
                        </a:cubicBezTo>
                        <a:cubicBezTo>
                          <a:pt x="73" y="416"/>
                          <a:pt x="73" y="416"/>
                          <a:pt x="73" y="416"/>
                        </a:cubicBezTo>
                        <a:cubicBezTo>
                          <a:pt x="73" y="416"/>
                          <a:pt x="73" y="416"/>
                          <a:pt x="73" y="416"/>
                        </a:cubicBezTo>
                        <a:cubicBezTo>
                          <a:pt x="80" y="414"/>
                          <a:pt x="87" y="411"/>
                          <a:pt x="87" y="411"/>
                        </a:cubicBezTo>
                        <a:cubicBezTo>
                          <a:pt x="121" y="392"/>
                          <a:pt x="121" y="392"/>
                          <a:pt x="121" y="392"/>
                        </a:cubicBezTo>
                        <a:cubicBezTo>
                          <a:pt x="146" y="384"/>
                          <a:pt x="146" y="384"/>
                          <a:pt x="146" y="384"/>
                        </a:cubicBezTo>
                        <a:cubicBezTo>
                          <a:pt x="164" y="359"/>
                          <a:pt x="164" y="359"/>
                          <a:pt x="164" y="359"/>
                        </a:cubicBezTo>
                        <a:cubicBezTo>
                          <a:pt x="170" y="342"/>
                          <a:pt x="170" y="342"/>
                          <a:pt x="170" y="342"/>
                        </a:cubicBezTo>
                        <a:cubicBezTo>
                          <a:pt x="165" y="307"/>
                          <a:pt x="165" y="307"/>
                          <a:pt x="165" y="307"/>
                        </a:cubicBezTo>
                        <a:cubicBezTo>
                          <a:pt x="175" y="296"/>
                          <a:pt x="175" y="296"/>
                          <a:pt x="175" y="296"/>
                        </a:cubicBezTo>
                        <a:cubicBezTo>
                          <a:pt x="229" y="316"/>
                          <a:pt x="229" y="316"/>
                          <a:pt x="229" y="316"/>
                        </a:cubicBezTo>
                        <a:cubicBezTo>
                          <a:pt x="262" y="317"/>
                          <a:pt x="262" y="317"/>
                          <a:pt x="262" y="317"/>
                        </a:cubicBezTo>
                        <a:cubicBezTo>
                          <a:pt x="297" y="332"/>
                          <a:pt x="297" y="332"/>
                          <a:pt x="297" y="332"/>
                        </a:cubicBezTo>
                        <a:cubicBezTo>
                          <a:pt x="353" y="346"/>
                          <a:pt x="353" y="346"/>
                          <a:pt x="353" y="346"/>
                        </a:cubicBezTo>
                        <a:cubicBezTo>
                          <a:pt x="426" y="383"/>
                          <a:pt x="426" y="383"/>
                          <a:pt x="426" y="383"/>
                        </a:cubicBezTo>
                        <a:cubicBezTo>
                          <a:pt x="478" y="407"/>
                          <a:pt x="478" y="407"/>
                          <a:pt x="478" y="407"/>
                        </a:cubicBezTo>
                        <a:cubicBezTo>
                          <a:pt x="496" y="421"/>
                          <a:pt x="496" y="421"/>
                          <a:pt x="496" y="421"/>
                        </a:cubicBezTo>
                        <a:cubicBezTo>
                          <a:pt x="505" y="421"/>
                          <a:pt x="505" y="421"/>
                          <a:pt x="505" y="421"/>
                        </a:cubicBezTo>
                        <a:cubicBezTo>
                          <a:pt x="516" y="429"/>
                          <a:pt x="516" y="429"/>
                          <a:pt x="516" y="429"/>
                        </a:cubicBezTo>
                        <a:cubicBezTo>
                          <a:pt x="527" y="431"/>
                          <a:pt x="527" y="431"/>
                          <a:pt x="527" y="431"/>
                        </a:cubicBezTo>
                        <a:cubicBezTo>
                          <a:pt x="541" y="418"/>
                          <a:pt x="541" y="418"/>
                          <a:pt x="541" y="418"/>
                        </a:cubicBezTo>
                        <a:cubicBezTo>
                          <a:pt x="570" y="405"/>
                          <a:pt x="570" y="405"/>
                          <a:pt x="570" y="405"/>
                        </a:cubicBezTo>
                        <a:cubicBezTo>
                          <a:pt x="566" y="313"/>
                          <a:pt x="566" y="313"/>
                          <a:pt x="566" y="313"/>
                        </a:cubicBezTo>
                        <a:cubicBezTo>
                          <a:pt x="565" y="298"/>
                          <a:pt x="565" y="298"/>
                          <a:pt x="565" y="298"/>
                        </a:cubicBezTo>
                        <a:cubicBezTo>
                          <a:pt x="588" y="242"/>
                          <a:pt x="588" y="242"/>
                          <a:pt x="588" y="242"/>
                        </a:cubicBezTo>
                        <a:cubicBezTo>
                          <a:pt x="600" y="228"/>
                          <a:pt x="600" y="228"/>
                          <a:pt x="600" y="228"/>
                        </a:cubicBezTo>
                        <a:cubicBezTo>
                          <a:pt x="608" y="201"/>
                          <a:pt x="608" y="201"/>
                          <a:pt x="608" y="201"/>
                        </a:cubicBezTo>
                        <a:cubicBezTo>
                          <a:pt x="612" y="202"/>
                          <a:pt x="612" y="202"/>
                          <a:pt x="612" y="202"/>
                        </a:cubicBezTo>
                        <a:cubicBezTo>
                          <a:pt x="609" y="193"/>
                          <a:pt x="609" y="193"/>
                          <a:pt x="609" y="193"/>
                        </a:cubicBezTo>
                        <a:cubicBezTo>
                          <a:pt x="574" y="149"/>
                          <a:pt x="574" y="149"/>
                          <a:pt x="574" y="149"/>
                        </a:cubicBezTo>
                        <a:cubicBezTo>
                          <a:pt x="536" y="159"/>
                          <a:pt x="536" y="159"/>
                          <a:pt x="536" y="159"/>
                        </a:cubicBezTo>
                        <a:cubicBezTo>
                          <a:pt x="513" y="140"/>
                          <a:pt x="513" y="140"/>
                          <a:pt x="513" y="140"/>
                        </a:cubicBezTo>
                        <a:cubicBezTo>
                          <a:pt x="482" y="144"/>
                          <a:pt x="482" y="144"/>
                          <a:pt x="482" y="144"/>
                        </a:cubicBezTo>
                        <a:cubicBezTo>
                          <a:pt x="472" y="113"/>
                          <a:pt x="472" y="113"/>
                          <a:pt x="472" y="113"/>
                        </a:cubicBezTo>
                        <a:cubicBezTo>
                          <a:pt x="459" y="105"/>
                          <a:pt x="459" y="105"/>
                          <a:pt x="459" y="105"/>
                        </a:cubicBezTo>
                        <a:cubicBezTo>
                          <a:pt x="444" y="127"/>
                          <a:pt x="444" y="127"/>
                          <a:pt x="444" y="127"/>
                        </a:cubicBezTo>
                        <a:cubicBezTo>
                          <a:pt x="434" y="123"/>
                          <a:pt x="434" y="123"/>
                          <a:pt x="434" y="123"/>
                        </a:cubicBezTo>
                        <a:cubicBezTo>
                          <a:pt x="427" y="96"/>
                          <a:pt x="427" y="96"/>
                          <a:pt x="427" y="96"/>
                        </a:cubicBezTo>
                        <a:cubicBezTo>
                          <a:pt x="416" y="83"/>
                          <a:pt x="416" y="83"/>
                          <a:pt x="416" y="83"/>
                        </a:cubicBezTo>
                        <a:cubicBezTo>
                          <a:pt x="409" y="60"/>
                          <a:pt x="409" y="60"/>
                          <a:pt x="409" y="60"/>
                        </a:cubicBezTo>
                        <a:cubicBezTo>
                          <a:pt x="382" y="27"/>
                          <a:pt x="382" y="27"/>
                          <a:pt x="382" y="27"/>
                        </a:cubicBezTo>
                        <a:lnTo>
                          <a:pt x="373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70" name="Freeform 28"/>
                  <p:cNvSpPr>
                    <a:spLocks/>
                  </p:cNvSpPr>
                  <p:nvPr/>
                </p:nvSpPr>
                <p:spPr bwMode="auto">
                  <a:xfrm>
                    <a:off x="1358437" y="5551337"/>
                    <a:ext cx="345619" cy="271444"/>
                  </a:xfrm>
                  <a:custGeom>
                    <a:avLst/>
                    <a:gdLst/>
                    <a:ahLst/>
                    <a:cxnLst>
                      <a:cxn ang="0">
                        <a:pos x="111" y="0"/>
                      </a:cxn>
                      <a:cxn ang="0">
                        <a:pos x="101" y="8"/>
                      </a:cxn>
                      <a:cxn ang="0">
                        <a:pos x="76" y="9"/>
                      </a:cxn>
                      <a:cxn ang="0">
                        <a:pos x="51" y="22"/>
                      </a:cxn>
                      <a:cxn ang="0">
                        <a:pos x="46" y="39"/>
                      </a:cxn>
                      <a:cxn ang="0">
                        <a:pos x="39" y="52"/>
                      </a:cxn>
                      <a:cxn ang="0">
                        <a:pos x="26" y="56"/>
                      </a:cxn>
                      <a:cxn ang="0">
                        <a:pos x="2" y="54"/>
                      </a:cxn>
                      <a:cxn ang="0">
                        <a:pos x="0" y="66"/>
                      </a:cxn>
                      <a:cxn ang="0">
                        <a:pos x="9" y="83"/>
                      </a:cxn>
                      <a:cxn ang="0">
                        <a:pos x="23" y="104"/>
                      </a:cxn>
                      <a:cxn ang="0">
                        <a:pos x="39" y="112"/>
                      </a:cxn>
                      <a:cxn ang="0">
                        <a:pos x="48" y="95"/>
                      </a:cxn>
                      <a:cxn ang="0">
                        <a:pos x="60" y="100"/>
                      </a:cxn>
                      <a:cxn ang="0">
                        <a:pos x="72" y="100"/>
                      </a:cxn>
                      <a:cxn ang="0">
                        <a:pos x="88" y="109"/>
                      </a:cxn>
                      <a:cxn ang="0">
                        <a:pos x="102" y="117"/>
                      </a:cxn>
                      <a:cxn ang="0">
                        <a:pos x="96" y="145"/>
                      </a:cxn>
                      <a:cxn ang="0">
                        <a:pos x="81" y="148"/>
                      </a:cxn>
                      <a:cxn ang="0">
                        <a:pos x="88" y="158"/>
                      </a:cxn>
                      <a:cxn ang="0">
                        <a:pos x="106" y="170"/>
                      </a:cxn>
                      <a:cxn ang="0">
                        <a:pos x="126" y="172"/>
                      </a:cxn>
                      <a:cxn ang="0">
                        <a:pos x="125" y="151"/>
                      </a:cxn>
                      <a:cxn ang="0">
                        <a:pos x="134" y="163"/>
                      </a:cxn>
                      <a:cxn ang="0">
                        <a:pos x="171" y="172"/>
                      </a:cxn>
                      <a:cxn ang="0">
                        <a:pos x="182" y="171"/>
                      </a:cxn>
                      <a:cxn ang="0">
                        <a:pos x="185" y="160"/>
                      </a:cxn>
                      <a:cxn ang="0">
                        <a:pos x="186" y="138"/>
                      </a:cxn>
                      <a:cxn ang="0">
                        <a:pos x="209" y="97"/>
                      </a:cxn>
                      <a:cxn ang="0">
                        <a:pos x="219" y="95"/>
                      </a:cxn>
                      <a:cxn ang="0">
                        <a:pos x="214" y="66"/>
                      </a:cxn>
                      <a:cxn ang="0">
                        <a:pos x="207" y="51"/>
                      </a:cxn>
                      <a:cxn ang="0">
                        <a:pos x="197" y="47"/>
                      </a:cxn>
                      <a:cxn ang="0">
                        <a:pos x="190" y="30"/>
                      </a:cxn>
                      <a:cxn ang="0">
                        <a:pos x="140" y="16"/>
                      </a:cxn>
                      <a:cxn ang="0">
                        <a:pos x="111" y="0"/>
                      </a:cxn>
                    </a:cxnLst>
                    <a:rect l="0" t="0" r="r" b="b"/>
                    <a:pathLst>
                      <a:path w="219" h="172">
                        <a:moveTo>
                          <a:pt x="111" y="0"/>
                        </a:moveTo>
                        <a:lnTo>
                          <a:pt x="101" y="8"/>
                        </a:lnTo>
                        <a:lnTo>
                          <a:pt x="76" y="9"/>
                        </a:lnTo>
                        <a:lnTo>
                          <a:pt x="51" y="22"/>
                        </a:lnTo>
                        <a:lnTo>
                          <a:pt x="46" y="39"/>
                        </a:lnTo>
                        <a:lnTo>
                          <a:pt x="39" y="52"/>
                        </a:lnTo>
                        <a:lnTo>
                          <a:pt x="26" y="56"/>
                        </a:lnTo>
                        <a:lnTo>
                          <a:pt x="2" y="54"/>
                        </a:lnTo>
                        <a:lnTo>
                          <a:pt x="0" y="66"/>
                        </a:lnTo>
                        <a:lnTo>
                          <a:pt x="9" y="83"/>
                        </a:lnTo>
                        <a:lnTo>
                          <a:pt x="23" y="104"/>
                        </a:lnTo>
                        <a:lnTo>
                          <a:pt x="39" y="112"/>
                        </a:lnTo>
                        <a:lnTo>
                          <a:pt x="48" y="95"/>
                        </a:lnTo>
                        <a:lnTo>
                          <a:pt x="60" y="100"/>
                        </a:lnTo>
                        <a:lnTo>
                          <a:pt x="72" y="100"/>
                        </a:lnTo>
                        <a:lnTo>
                          <a:pt x="88" y="109"/>
                        </a:lnTo>
                        <a:lnTo>
                          <a:pt x="102" y="117"/>
                        </a:lnTo>
                        <a:lnTo>
                          <a:pt x="96" y="145"/>
                        </a:lnTo>
                        <a:lnTo>
                          <a:pt x="81" y="148"/>
                        </a:lnTo>
                        <a:lnTo>
                          <a:pt x="88" y="158"/>
                        </a:lnTo>
                        <a:lnTo>
                          <a:pt x="106" y="170"/>
                        </a:lnTo>
                        <a:lnTo>
                          <a:pt x="126" y="172"/>
                        </a:lnTo>
                        <a:lnTo>
                          <a:pt x="125" y="151"/>
                        </a:lnTo>
                        <a:lnTo>
                          <a:pt x="134" y="163"/>
                        </a:lnTo>
                        <a:lnTo>
                          <a:pt x="171" y="172"/>
                        </a:lnTo>
                        <a:lnTo>
                          <a:pt x="182" y="171"/>
                        </a:lnTo>
                        <a:lnTo>
                          <a:pt x="185" y="160"/>
                        </a:lnTo>
                        <a:lnTo>
                          <a:pt x="186" y="138"/>
                        </a:lnTo>
                        <a:lnTo>
                          <a:pt x="209" y="97"/>
                        </a:lnTo>
                        <a:lnTo>
                          <a:pt x="219" y="95"/>
                        </a:lnTo>
                        <a:lnTo>
                          <a:pt x="214" y="66"/>
                        </a:lnTo>
                        <a:lnTo>
                          <a:pt x="207" y="51"/>
                        </a:lnTo>
                        <a:lnTo>
                          <a:pt x="197" y="47"/>
                        </a:lnTo>
                        <a:lnTo>
                          <a:pt x="190" y="30"/>
                        </a:lnTo>
                        <a:lnTo>
                          <a:pt x="140" y="16"/>
                        </a:lnTo>
                        <a:lnTo>
                          <a:pt x="111" y="0"/>
                        </a:lnTo>
                        <a:close/>
                      </a:path>
                    </a:pathLst>
                  </a:custGeom>
                  <a:solidFill>
                    <a:schemeClr val="accent1">
                      <a:lumMod val="60000"/>
                      <a:lumOff val="40000"/>
                    </a:schemeClr>
                  </a:solidFill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endParaRPr lang="zh-CN" altLang="en-US" sz="900" b="1" kern="0">
                      <a:solidFill>
                        <a:srgbClr val="000000"/>
                      </a:solidFill>
                      <a:latin typeface="Arial" charset="0"/>
                    </a:endParaRPr>
                  </a:p>
                </p:txBody>
              </p:sp>
              <p:sp>
                <p:nvSpPr>
                  <p:cNvPr id="71" name="Freeform 29"/>
                  <p:cNvSpPr>
                    <a:spLocks/>
                  </p:cNvSpPr>
                  <p:nvPr/>
                </p:nvSpPr>
                <p:spPr bwMode="auto">
                  <a:xfrm>
                    <a:off x="610387" y="5631824"/>
                    <a:ext cx="1035276" cy="441886"/>
                  </a:xfrm>
                  <a:custGeom>
                    <a:avLst/>
                    <a:gdLst/>
                    <a:ahLst/>
                    <a:cxnLst>
                      <a:cxn ang="0">
                        <a:pos x="325" y="15"/>
                      </a:cxn>
                      <a:cxn ang="0">
                        <a:pos x="278" y="40"/>
                      </a:cxn>
                      <a:cxn ang="0">
                        <a:pos x="255" y="22"/>
                      </a:cxn>
                      <a:cxn ang="0">
                        <a:pos x="243" y="49"/>
                      </a:cxn>
                      <a:cxn ang="0">
                        <a:pos x="222" y="80"/>
                      </a:cxn>
                      <a:cxn ang="0">
                        <a:pos x="185" y="86"/>
                      </a:cxn>
                      <a:cxn ang="0">
                        <a:pos x="167" y="66"/>
                      </a:cxn>
                      <a:cxn ang="0">
                        <a:pos x="142" y="66"/>
                      </a:cxn>
                      <a:cxn ang="0">
                        <a:pos x="84" y="100"/>
                      </a:cxn>
                      <a:cxn ang="0">
                        <a:pos x="54" y="140"/>
                      </a:cxn>
                      <a:cxn ang="0">
                        <a:pos x="0" y="238"/>
                      </a:cxn>
                      <a:cxn ang="0">
                        <a:pos x="31" y="280"/>
                      </a:cxn>
                      <a:cxn ang="0">
                        <a:pos x="87" y="272"/>
                      </a:cxn>
                      <a:cxn ang="0">
                        <a:pos x="141" y="255"/>
                      </a:cxn>
                      <a:cxn ang="0">
                        <a:pos x="170" y="254"/>
                      </a:cxn>
                      <a:cxn ang="0">
                        <a:pos x="192" y="253"/>
                      </a:cxn>
                      <a:cxn ang="0">
                        <a:pos x="279" y="250"/>
                      </a:cxn>
                      <a:cxn ang="0">
                        <a:pos x="300" y="250"/>
                      </a:cxn>
                      <a:cxn ang="0">
                        <a:pos x="391" y="254"/>
                      </a:cxn>
                      <a:cxn ang="0">
                        <a:pos x="612" y="241"/>
                      </a:cxn>
                      <a:cxn ang="0">
                        <a:pos x="621" y="204"/>
                      </a:cxn>
                      <a:cxn ang="0">
                        <a:pos x="642" y="163"/>
                      </a:cxn>
                      <a:cxn ang="0">
                        <a:pos x="645" y="121"/>
                      </a:cxn>
                      <a:cxn ang="0">
                        <a:pos x="599" y="100"/>
                      </a:cxn>
                      <a:cxn ang="0">
                        <a:pos x="580" y="119"/>
                      </a:cxn>
                      <a:cxn ang="0">
                        <a:pos x="555" y="97"/>
                      </a:cxn>
                      <a:cxn ang="0">
                        <a:pos x="576" y="66"/>
                      </a:cxn>
                      <a:cxn ang="0">
                        <a:pos x="546" y="49"/>
                      </a:cxn>
                      <a:cxn ang="0">
                        <a:pos x="522" y="44"/>
                      </a:cxn>
                      <a:cxn ang="0">
                        <a:pos x="497" y="53"/>
                      </a:cxn>
                      <a:cxn ang="0">
                        <a:pos x="474" y="15"/>
                      </a:cxn>
                      <a:cxn ang="0">
                        <a:pos x="474" y="8"/>
                      </a:cxn>
                      <a:cxn ang="0">
                        <a:pos x="424" y="72"/>
                      </a:cxn>
                      <a:cxn ang="0">
                        <a:pos x="391" y="103"/>
                      </a:cxn>
                      <a:cxn ang="0">
                        <a:pos x="346" y="97"/>
                      </a:cxn>
                      <a:cxn ang="0">
                        <a:pos x="338" y="44"/>
                      </a:cxn>
                      <a:cxn ang="0">
                        <a:pos x="346" y="16"/>
                      </a:cxn>
                    </a:cxnLst>
                    <a:rect l="0" t="0" r="r" b="b"/>
                    <a:pathLst>
                      <a:path w="656" h="280">
                        <a:moveTo>
                          <a:pt x="351" y="0"/>
                        </a:moveTo>
                        <a:lnTo>
                          <a:pt x="325" y="15"/>
                        </a:lnTo>
                        <a:lnTo>
                          <a:pt x="291" y="24"/>
                        </a:lnTo>
                        <a:lnTo>
                          <a:pt x="278" y="40"/>
                        </a:lnTo>
                        <a:lnTo>
                          <a:pt x="263" y="32"/>
                        </a:lnTo>
                        <a:lnTo>
                          <a:pt x="255" y="22"/>
                        </a:lnTo>
                        <a:lnTo>
                          <a:pt x="241" y="29"/>
                        </a:lnTo>
                        <a:lnTo>
                          <a:pt x="243" y="49"/>
                        </a:lnTo>
                        <a:lnTo>
                          <a:pt x="238" y="66"/>
                        </a:lnTo>
                        <a:lnTo>
                          <a:pt x="222" y="80"/>
                        </a:lnTo>
                        <a:lnTo>
                          <a:pt x="192" y="101"/>
                        </a:lnTo>
                        <a:lnTo>
                          <a:pt x="185" y="86"/>
                        </a:lnTo>
                        <a:lnTo>
                          <a:pt x="168" y="78"/>
                        </a:lnTo>
                        <a:lnTo>
                          <a:pt x="167" y="66"/>
                        </a:lnTo>
                        <a:lnTo>
                          <a:pt x="145" y="50"/>
                        </a:lnTo>
                        <a:lnTo>
                          <a:pt x="142" y="66"/>
                        </a:lnTo>
                        <a:lnTo>
                          <a:pt x="106" y="78"/>
                        </a:lnTo>
                        <a:lnTo>
                          <a:pt x="84" y="100"/>
                        </a:lnTo>
                        <a:lnTo>
                          <a:pt x="46" y="132"/>
                        </a:lnTo>
                        <a:lnTo>
                          <a:pt x="54" y="140"/>
                        </a:lnTo>
                        <a:lnTo>
                          <a:pt x="51" y="233"/>
                        </a:lnTo>
                        <a:lnTo>
                          <a:pt x="0" y="238"/>
                        </a:lnTo>
                        <a:lnTo>
                          <a:pt x="25" y="278"/>
                        </a:lnTo>
                        <a:lnTo>
                          <a:pt x="31" y="280"/>
                        </a:lnTo>
                        <a:lnTo>
                          <a:pt x="47" y="279"/>
                        </a:lnTo>
                        <a:lnTo>
                          <a:pt x="87" y="272"/>
                        </a:lnTo>
                        <a:lnTo>
                          <a:pt x="116" y="258"/>
                        </a:lnTo>
                        <a:lnTo>
                          <a:pt x="141" y="255"/>
                        </a:lnTo>
                        <a:lnTo>
                          <a:pt x="154" y="258"/>
                        </a:lnTo>
                        <a:lnTo>
                          <a:pt x="170" y="254"/>
                        </a:lnTo>
                        <a:lnTo>
                          <a:pt x="184" y="258"/>
                        </a:lnTo>
                        <a:lnTo>
                          <a:pt x="192" y="253"/>
                        </a:lnTo>
                        <a:lnTo>
                          <a:pt x="263" y="255"/>
                        </a:lnTo>
                        <a:lnTo>
                          <a:pt x="279" y="250"/>
                        </a:lnTo>
                        <a:lnTo>
                          <a:pt x="291" y="255"/>
                        </a:lnTo>
                        <a:lnTo>
                          <a:pt x="300" y="250"/>
                        </a:lnTo>
                        <a:lnTo>
                          <a:pt x="376" y="262"/>
                        </a:lnTo>
                        <a:lnTo>
                          <a:pt x="391" y="254"/>
                        </a:lnTo>
                        <a:lnTo>
                          <a:pt x="612" y="253"/>
                        </a:lnTo>
                        <a:lnTo>
                          <a:pt x="612" y="241"/>
                        </a:lnTo>
                        <a:lnTo>
                          <a:pt x="620" y="228"/>
                        </a:lnTo>
                        <a:lnTo>
                          <a:pt x="621" y="204"/>
                        </a:lnTo>
                        <a:lnTo>
                          <a:pt x="630" y="167"/>
                        </a:lnTo>
                        <a:lnTo>
                          <a:pt x="642" y="163"/>
                        </a:lnTo>
                        <a:lnTo>
                          <a:pt x="656" y="120"/>
                        </a:lnTo>
                        <a:lnTo>
                          <a:pt x="645" y="121"/>
                        </a:lnTo>
                        <a:lnTo>
                          <a:pt x="608" y="112"/>
                        </a:lnTo>
                        <a:lnTo>
                          <a:pt x="599" y="100"/>
                        </a:lnTo>
                        <a:lnTo>
                          <a:pt x="600" y="121"/>
                        </a:lnTo>
                        <a:lnTo>
                          <a:pt x="580" y="119"/>
                        </a:lnTo>
                        <a:lnTo>
                          <a:pt x="562" y="107"/>
                        </a:lnTo>
                        <a:lnTo>
                          <a:pt x="555" y="97"/>
                        </a:lnTo>
                        <a:lnTo>
                          <a:pt x="570" y="94"/>
                        </a:lnTo>
                        <a:lnTo>
                          <a:pt x="576" y="66"/>
                        </a:lnTo>
                        <a:lnTo>
                          <a:pt x="562" y="58"/>
                        </a:lnTo>
                        <a:lnTo>
                          <a:pt x="546" y="49"/>
                        </a:lnTo>
                        <a:lnTo>
                          <a:pt x="534" y="49"/>
                        </a:lnTo>
                        <a:lnTo>
                          <a:pt x="522" y="44"/>
                        </a:lnTo>
                        <a:lnTo>
                          <a:pt x="513" y="61"/>
                        </a:lnTo>
                        <a:lnTo>
                          <a:pt x="497" y="53"/>
                        </a:lnTo>
                        <a:lnTo>
                          <a:pt x="483" y="32"/>
                        </a:lnTo>
                        <a:lnTo>
                          <a:pt x="474" y="15"/>
                        </a:lnTo>
                        <a:lnTo>
                          <a:pt x="475" y="9"/>
                        </a:lnTo>
                        <a:lnTo>
                          <a:pt x="474" y="8"/>
                        </a:lnTo>
                        <a:lnTo>
                          <a:pt x="449" y="44"/>
                        </a:lnTo>
                        <a:lnTo>
                          <a:pt x="424" y="72"/>
                        </a:lnTo>
                        <a:lnTo>
                          <a:pt x="416" y="88"/>
                        </a:lnTo>
                        <a:lnTo>
                          <a:pt x="391" y="103"/>
                        </a:lnTo>
                        <a:lnTo>
                          <a:pt x="362" y="94"/>
                        </a:lnTo>
                        <a:lnTo>
                          <a:pt x="346" y="97"/>
                        </a:lnTo>
                        <a:lnTo>
                          <a:pt x="346" y="61"/>
                        </a:lnTo>
                        <a:lnTo>
                          <a:pt x="338" y="44"/>
                        </a:lnTo>
                        <a:lnTo>
                          <a:pt x="356" y="28"/>
                        </a:lnTo>
                        <a:lnTo>
                          <a:pt x="346" y="16"/>
                        </a:lnTo>
                        <a:lnTo>
                          <a:pt x="351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72" name="Freeform 30"/>
                  <p:cNvSpPr>
                    <a:spLocks noEditPoints="1"/>
                  </p:cNvSpPr>
                  <p:nvPr/>
                </p:nvSpPr>
                <p:spPr bwMode="auto">
                  <a:xfrm>
                    <a:off x="3924533" y="6487189"/>
                    <a:ext cx="1063683" cy="1429817"/>
                  </a:xfrm>
                  <a:custGeom>
                    <a:avLst/>
                    <a:gdLst/>
                    <a:ahLst/>
                    <a:cxnLst>
                      <a:cxn ang="0">
                        <a:pos x="464" y="29"/>
                      </a:cxn>
                      <a:cxn ang="0">
                        <a:pos x="447" y="94"/>
                      </a:cxn>
                      <a:cxn ang="0">
                        <a:pos x="404" y="121"/>
                      </a:cxn>
                      <a:cxn ang="0">
                        <a:pos x="351" y="78"/>
                      </a:cxn>
                      <a:cxn ang="0">
                        <a:pos x="233" y="158"/>
                      </a:cxn>
                      <a:cxn ang="0">
                        <a:pos x="191" y="173"/>
                      </a:cxn>
                      <a:cxn ang="0">
                        <a:pos x="163" y="261"/>
                      </a:cxn>
                      <a:cxn ang="0">
                        <a:pos x="134" y="341"/>
                      </a:cxn>
                      <a:cxn ang="0">
                        <a:pos x="233" y="346"/>
                      </a:cxn>
                      <a:cxn ang="0">
                        <a:pos x="262" y="439"/>
                      </a:cxn>
                      <a:cxn ang="0">
                        <a:pos x="220" y="448"/>
                      </a:cxn>
                      <a:cxn ang="0">
                        <a:pos x="175" y="491"/>
                      </a:cxn>
                      <a:cxn ang="0">
                        <a:pos x="136" y="557"/>
                      </a:cxn>
                      <a:cxn ang="0">
                        <a:pos x="100" y="516"/>
                      </a:cxn>
                      <a:cxn ang="0">
                        <a:pos x="59" y="581"/>
                      </a:cxn>
                      <a:cxn ang="0">
                        <a:pos x="36" y="650"/>
                      </a:cxn>
                      <a:cxn ang="0">
                        <a:pos x="74" y="669"/>
                      </a:cxn>
                      <a:cxn ang="0">
                        <a:pos x="184" y="679"/>
                      </a:cxn>
                      <a:cxn ang="0">
                        <a:pos x="224" y="665"/>
                      </a:cxn>
                      <a:cxn ang="0">
                        <a:pos x="268" y="615"/>
                      </a:cxn>
                      <a:cxn ang="0">
                        <a:pos x="307" y="686"/>
                      </a:cxn>
                      <a:cxn ang="0">
                        <a:pos x="355" y="721"/>
                      </a:cxn>
                      <a:cxn ang="0">
                        <a:pos x="401" y="736"/>
                      </a:cxn>
                      <a:cxn ang="0">
                        <a:pos x="441" y="748"/>
                      </a:cxn>
                      <a:cxn ang="0">
                        <a:pos x="479" y="818"/>
                      </a:cxn>
                      <a:cxn ang="0">
                        <a:pos x="522" y="850"/>
                      </a:cxn>
                      <a:cxn ang="0">
                        <a:pos x="567" y="893"/>
                      </a:cxn>
                      <a:cxn ang="0">
                        <a:pos x="636" y="869"/>
                      </a:cxn>
                      <a:cxn ang="0">
                        <a:pos x="657" y="906"/>
                      </a:cxn>
                      <a:cxn ang="0">
                        <a:pos x="664" y="704"/>
                      </a:cxn>
                      <a:cxn ang="0">
                        <a:pos x="622" y="716"/>
                      </a:cxn>
                      <a:cxn ang="0">
                        <a:pos x="632" y="745"/>
                      </a:cxn>
                      <a:cxn ang="0">
                        <a:pos x="593" y="744"/>
                      </a:cxn>
                      <a:cxn ang="0">
                        <a:pos x="546" y="727"/>
                      </a:cxn>
                      <a:cxn ang="0">
                        <a:pos x="507" y="674"/>
                      </a:cxn>
                      <a:cxn ang="0">
                        <a:pos x="467" y="658"/>
                      </a:cxn>
                      <a:cxn ang="0">
                        <a:pos x="455" y="623"/>
                      </a:cxn>
                      <a:cxn ang="0">
                        <a:pos x="467" y="548"/>
                      </a:cxn>
                      <a:cxn ang="0">
                        <a:pos x="497" y="469"/>
                      </a:cxn>
                      <a:cxn ang="0">
                        <a:pos x="480" y="400"/>
                      </a:cxn>
                      <a:cxn ang="0">
                        <a:pos x="496" y="333"/>
                      </a:cxn>
                      <a:cxn ang="0">
                        <a:pos x="472" y="275"/>
                      </a:cxn>
                      <a:cxn ang="0">
                        <a:pos x="471" y="262"/>
                      </a:cxn>
                      <a:cxn ang="0">
                        <a:pos x="449" y="263"/>
                      </a:cxn>
                      <a:cxn ang="0">
                        <a:pos x="482" y="171"/>
                      </a:cxn>
                      <a:cxn ang="0">
                        <a:pos x="532" y="124"/>
                      </a:cxn>
                      <a:cxn ang="0">
                        <a:pos x="651" y="86"/>
                      </a:cxn>
                      <a:cxn ang="0">
                        <a:pos x="636" y="37"/>
                      </a:cxn>
                      <a:cxn ang="0">
                        <a:pos x="557" y="32"/>
                      </a:cxn>
                      <a:cxn ang="0">
                        <a:pos x="520" y="46"/>
                      </a:cxn>
                      <a:cxn ang="0">
                        <a:pos x="461" y="0"/>
                      </a:cxn>
                      <a:cxn ang="0">
                        <a:pos x="3" y="338"/>
                      </a:cxn>
                    </a:cxnLst>
                    <a:rect l="0" t="0" r="r" b="b"/>
                    <a:pathLst>
                      <a:path w="674" h="906">
                        <a:moveTo>
                          <a:pt x="461" y="0"/>
                        </a:moveTo>
                        <a:lnTo>
                          <a:pt x="450" y="11"/>
                        </a:lnTo>
                        <a:lnTo>
                          <a:pt x="464" y="29"/>
                        </a:lnTo>
                        <a:lnTo>
                          <a:pt x="463" y="91"/>
                        </a:lnTo>
                        <a:lnTo>
                          <a:pt x="461" y="100"/>
                        </a:lnTo>
                        <a:lnTo>
                          <a:pt x="447" y="94"/>
                        </a:lnTo>
                        <a:lnTo>
                          <a:pt x="432" y="94"/>
                        </a:lnTo>
                        <a:lnTo>
                          <a:pt x="413" y="123"/>
                        </a:lnTo>
                        <a:lnTo>
                          <a:pt x="404" y="121"/>
                        </a:lnTo>
                        <a:lnTo>
                          <a:pt x="391" y="99"/>
                        </a:lnTo>
                        <a:lnTo>
                          <a:pt x="368" y="83"/>
                        </a:lnTo>
                        <a:lnTo>
                          <a:pt x="351" y="78"/>
                        </a:lnTo>
                        <a:lnTo>
                          <a:pt x="322" y="71"/>
                        </a:lnTo>
                        <a:lnTo>
                          <a:pt x="259" y="103"/>
                        </a:lnTo>
                        <a:lnTo>
                          <a:pt x="233" y="158"/>
                        </a:lnTo>
                        <a:lnTo>
                          <a:pt x="214" y="167"/>
                        </a:lnTo>
                        <a:lnTo>
                          <a:pt x="199" y="165"/>
                        </a:lnTo>
                        <a:lnTo>
                          <a:pt x="191" y="173"/>
                        </a:lnTo>
                        <a:lnTo>
                          <a:pt x="186" y="215"/>
                        </a:lnTo>
                        <a:lnTo>
                          <a:pt x="171" y="227"/>
                        </a:lnTo>
                        <a:lnTo>
                          <a:pt x="163" y="261"/>
                        </a:lnTo>
                        <a:lnTo>
                          <a:pt x="133" y="316"/>
                        </a:lnTo>
                        <a:lnTo>
                          <a:pt x="136" y="313"/>
                        </a:lnTo>
                        <a:lnTo>
                          <a:pt x="134" y="341"/>
                        </a:lnTo>
                        <a:lnTo>
                          <a:pt x="178" y="342"/>
                        </a:lnTo>
                        <a:lnTo>
                          <a:pt x="192" y="350"/>
                        </a:lnTo>
                        <a:lnTo>
                          <a:pt x="233" y="346"/>
                        </a:lnTo>
                        <a:lnTo>
                          <a:pt x="243" y="362"/>
                        </a:lnTo>
                        <a:lnTo>
                          <a:pt x="241" y="408"/>
                        </a:lnTo>
                        <a:lnTo>
                          <a:pt x="262" y="439"/>
                        </a:lnTo>
                        <a:lnTo>
                          <a:pt x="247" y="474"/>
                        </a:lnTo>
                        <a:lnTo>
                          <a:pt x="237" y="471"/>
                        </a:lnTo>
                        <a:lnTo>
                          <a:pt x="220" y="448"/>
                        </a:lnTo>
                        <a:lnTo>
                          <a:pt x="186" y="448"/>
                        </a:lnTo>
                        <a:lnTo>
                          <a:pt x="167" y="448"/>
                        </a:lnTo>
                        <a:lnTo>
                          <a:pt x="175" y="491"/>
                        </a:lnTo>
                        <a:lnTo>
                          <a:pt x="162" y="524"/>
                        </a:lnTo>
                        <a:lnTo>
                          <a:pt x="146" y="558"/>
                        </a:lnTo>
                        <a:lnTo>
                          <a:pt x="136" y="557"/>
                        </a:lnTo>
                        <a:lnTo>
                          <a:pt x="136" y="514"/>
                        </a:lnTo>
                        <a:lnTo>
                          <a:pt x="121" y="504"/>
                        </a:lnTo>
                        <a:lnTo>
                          <a:pt x="100" y="516"/>
                        </a:lnTo>
                        <a:lnTo>
                          <a:pt x="80" y="521"/>
                        </a:lnTo>
                        <a:lnTo>
                          <a:pt x="67" y="533"/>
                        </a:lnTo>
                        <a:lnTo>
                          <a:pt x="59" y="581"/>
                        </a:lnTo>
                        <a:lnTo>
                          <a:pt x="32" y="628"/>
                        </a:lnTo>
                        <a:lnTo>
                          <a:pt x="32" y="648"/>
                        </a:lnTo>
                        <a:lnTo>
                          <a:pt x="36" y="650"/>
                        </a:lnTo>
                        <a:lnTo>
                          <a:pt x="58" y="649"/>
                        </a:lnTo>
                        <a:lnTo>
                          <a:pt x="72" y="662"/>
                        </a:lnTo>
                        <a:lnTo>
                          <a:pt x="74" y="669"/>
                        </a:lnTo>
                        <a:lnTo>
                          <a:pt x="120" y="669"/>
                        </a:lnTo>
                        <a:lnTo>
                          <a:pt x="150" y="665"/>
                        </a:lnTo>
                        <a:lnTo>
                          <a:pt x="184" y="679"/>
                        </a:lnTo>
                        <a:lnTo>
                          <a:pt x="196" y="671"/>
                        </a:lnTo>
                        <a:lnTo>
                          <a:pt x="208" y="674"/>
                        </a:lnTo>
                        <a:lnTo>
                          <a:pt x="224" y="665"/>
                        </a:lnTo>
                        <a:lnTo>
                          <a:pt x="241" y="631"/>
                        </a:lnTo>
                        <a:lnTo>
                          <a:pt x="238" y="615"/>
                        </a:lnTo>
                        <a:lnTo>
                          <a:pt x="268" y="615"/>
                        </a:lnTo>
                        <a:lnTo>
                          <a:pt x="263" y="644"/>
                        </a:lnTo>
                        <a:lnTo>
                          <a:pt x="296" y="660"/>
                        </a:lnTo>
                        <a:lnTo>
                          <a:pt x="307" y="686"/>
                        </a:lnTo>
                        <a:lnTo>
                          <a:pt x="321" y="711"/>
                        </a:lnTo>
                        <a:lnTo>
                          <a:pt x="338" y="723"/>
                        </a:lnTo>
                        <a:lnTo>
                          <a:pt x="355" y="721"/>
                        </a:lnTo>
                        <a:lnTo>
                          <a:pt x="378" y="716"/>
                        </a:lnTo>
                        <a:lnTo>
                          <a:pt x="383" y="732"/>
                        </a:lnTo>
                        <a:lnTo>
                          <a:pt x="401" y="736"/>
                        </a:lnTo>
                        <a:lnTo>
                          <a:pt x="409" y="746"/>
                        </a:lnTo>
                        <a:lnTo>
                          <a:pt x="418" y="736"/>
                        </a:lnTo>
                        <a:lnTo>
                          <a:pt x="441" y="748"/>
                        </a:lnTo>
                        <a:lnTo>
                          <a:pt x="468" y="778"/>
                        </a:lnTo>
                        <a:lnTo>
                          <a:pt x="461" y="791"/>
                        </a:lnTo>
                        <a:lnTo>
                          <a:pt x="479" y="818"/>
                        </a:lnTo>
                        <a:lnTo>
                          <a:pt x="491" y="807"/>
                        </a:lnTo>
                        <a:lnTo>
                          <a:pt x="514" y="832"/>
                        </a:lnTo>
                        <a:lnTo>
                          <a:pt x="522" y="850"/>
                        </a:lnTo>
                        <a:lnTo>
                          <a:pt x="533" y="866"/>
                        </a:lnTo>
                        <a:lnTo>
                          <a:pt x="549" y="899"/>
                        </a:lnTo>
                        <a:lnTo>
                          <a:pt x="567" y="893"/>
                        </a:lnTo>
                        <a:lnTo>
                          <a:pt x="575" y="903"/>
                        </a:lnTo>
                        <a:lnTo>
                          <a:pt x="597" y="890"/>
                        </a:lnTo>
                        <a:lnTo>
                          <a:pt x="636" y="869"/>
                        </a:lnTo>
                        <a:lnTo>
                          <a:pt x="653" y="873"/>
                        </a:lnTo>
                        <a:lnTo>
                          <a:pt x="641" y="899"/>
                        </a:lnTo>
                        <a:lnTo>
                          <a:pt x="657" y="906"/>
                        </a:lnTo>
                        <a:lnTo>
                          <a:pt x="674" y="906"/>
                        </a:lnTo>
                        <a:lnTo>
                          <a:pt x="672" y="703"/>
                        </a:lnTo>
                        <a:lnTo>
                          <a:pt x="664" y="704"/>
                        </a:lnTo>
                        <a:lnTo>
                          <a:pt x="654" y="711"/>
                        </a:lnTo>
                        <a:lnTo>
                          <a:pt x="638" y="708"/>
                        </a:lnTo>
                        <a:lnTo>
                          <a:pt x="622" y="716"/>
                        </a:lnTo>
                        <a:lnTo>
                          <a:pt x="617" y="732"/>
                        </a:lnTo>
                        <a:lnTo>
                          <a:pt x="628" y="741"/>
                        </a:lnTo>
                        <a:lnTo>
                          <a:pt x="632" y="745"/>
                        </a:lnTo>
                        <a:lnTo>
                          <a:pt x="622" y="754"/>
                        </a:lnTo>
                        <a:lnTo>
                          <a:pt x="605" y="744"/>
                        </a:lnTo>
                        <a:lnTo>
                          <a:pt x="593" y="744"/>
                        </a:lnTo>
                        <a:lnTo>
                          <a:pt x="588" y="735"/>
                        </a:lnTo>
                        <a:lnTo>
                          <a:pt x="555" y="740"/>
                        </a:lnTo>
                        <a:lnTo>
                          <a:pt x="546" y="727"/>
                        </a:lnTo>
                        <a:lnTo>
                          <a:pt x="534" y="708"/>
                        </a:lnTo>
                        <a:lnTo>
                          <a:pt x="512" y="686"/>
                        </a:lnTo>
                        <a:lnTo>
                          <a:pt x="507" y="674"/>
                        </a:lnTo>
                        <a:lnTo>
                          <a:pt x="499" y="677"/>
                        </a:lnTo>
                        <a:lnTo>
                          <a:pt x="484" y="665"/>
                        </a:lnTo>
                        <a:lnTo>
                          <a:pt x="467" y="658"/>
                        </a:lnTo>
                        <a:lnTo>
                          <a:pt x="463" y="649"/>
                        </a:lnTo>
                        <a:lnTo>
                          <a:pt x="457" y="649"/>
                        </a:lnTo>
                        <a:lnTo>
                          <a:pt x="455" y="623"/>
                        </a:lnTo>
                        <a:lnTo>
                          <a:pt x="449" y="614"/>
                        </a:lnTo>
                        <a:lnTo>
                          <a:pt x="457" y="581"/>
                        </a:lnTo>
                        <a:lnTo>
                          <a:pt x="467" y="548"/>
                        </a:lnTo>
                        <a:lnTo>
                          <a:pt x="464" y="537"/>
                        </a:lnTo>
                        <a:lnTo>
                          <a:pt x="486" y="478"/>
                        </a:lnTo>
                        <a:lnTo>
                          <a:pt x="497" y="469"/>
                        </a:lnTo>
                        <a:lnTo>
                          <a:pt x="489" y="441"/>
                        </a:lnTo>
                        <a:lnTo>
                          <a:pt x="489" y="412"/>
                        </a:lnTo>
                        <a:lnTo>
                          <a:pt x="480" y="400"/>
                        </a:lnTo>
                        <a:lnTo>
                          <a:pt x="489" y="377"/>
                        </a:lnTo>
                        <a:lnTo>
                          <a:pt x="487" y="357"/>
                        </a:lnTo>
                        <a:lnTo>
                          <a:pt x="496" y="333"/>
                        </a:lnTo>
                        <a:lnTo>
                          <a:pt x="488" y="321"/>
                        </a:lnTo>
                        <a:lnTo>
                          <a:pt x="484" y="295"/>
                        </a:lnTo>
                        <a:lnTo>
                          <a:pt x="472" y="275"/>
                        </a:lnTo>
                        <a:lnTo>
                          <a:pt x="472" y="270"/>
                        </a:lnTo>
                        <a:lnTo>
                          <a:pt x="470" y="270"/>
                        </a:lnTo>
                        <a:lnTo>
                          <a:pt x="471" y="262"/>
                        </a:lnTo>
                        <a:lnTo>
                          <a:pt x="459" y="269"/>
                        </a:lnTo>
                        <a:lnTo>
                          <a:pt x="447" y="266"/>
                        </a:lnTo>
                        <a:lnTo>
                          <a:pt x="449" y="263"/>
                        </a:lnTo>
                        <a:lnTo>
                          <a:pt x="439" y="261"/>
                        </a:lnTo>
                        <a:lnTo>
                          <a:pt x="438" y="233"/>
                        </a:lnTo>
                        <a:lnTo>
                          <a:pt x="482" y="171"/>
                        </a:lnTo>
                        <a:lnTo>
                          <a:pt x="514" y="135"/>
                        </a:lnTo>
                        <a:lnTo>
                          <a:pt x="539" y="141"/>
                        </a:lnTo>
                        <a:lnTo>
                          <a:pt x="532" y="124"/>
                        </a:lnTo>
                        <a:lnTo>
                          <a:pt x="643" y="110"/>
                        </a:lnTo>
                        <a:lnTo>
                          <a:pt x="643" y="106"/>
                        </a:lnTo>
                        <a:lnTo>
                          <a:pt x="651" y="86"/>
                        </a:lnTo>
                        <a:lnTo>
                          <a:pt x="666" y="63"/>
                        </a:lnTo>
                        <a:lnTo>
                          <a:pt x="659" y="40"/>
                        </a:lnTo>
                        <a:lnTo>
                          <a:pt x="636" y="37"/>
                        </a:lnTo>
                        <a:lnTo>
                          <a:pt x="620" y="19"/>
                        </a:lnTo>
                        <a:lnTo>
                          <a:pt x="586" y="21"/>
                        </a:lnTo>
                        <a:lnTo>
                          <a:pt x="557" y="32"/>
                        </a:lnTo>
                        <a:lnTo>
                          <a:pt x="545" y="33"/>
                        </a:lnTo>
                        <a:lnTo>
                          <a:pt x="529" y="50"/>
                        </a:lnTo>
                        <a:lnTo>
                          <a:pt x="520" y="46"/>
                        </a:lnTo>
                        <a:lnTo>
                          <a:pt x="497" y="7"/>
                        </a:lnTo>
                        <a:lnTo>
                          <a:pt x="478" y="0"/>
                        </a:lnTo>
                        <a:lnTo>
                          <a:pt x="461" y="0"/>
                        </a:lnTo>
                        <a:close/>
                        <a:moveTo>
                          <a:pt x="0" y="312"/>
                        </a:moveTo>
                        <a:lnTo>
                          <a:pt x="3" y="338"/>
                        </a:lnTo>
                        <a:lnTo>
                          <a:pt x="3" y="338"/>
                        </a:lnTo>
                        <a:lnTo>
                          <a:pt x="0" y="312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  <p:sp>
                <p:nvSpPr>
                  <p:cNvPr id="73" name="Freeform 31"/>
                  <p:cNvSpPr>
                    <a:spLocks/>
                  </p:cNvSpPr>
                  <p:nvPr/>
                </p:nvSpPr>
                <p:spPr bwMode="auto">
                  <a:xfrm>
                    <a:off x="2991838" y="6484033"/>
                    <a:ext cx="1346175" cy="1025807"/>
                  </a:xfrm>
                  <a:custGeom>
                    <a:avLst/>
                    <a:gdLst/>
                    <a:ahLst/>
                    <a:cxnLst>
                      <a:cxn ang="0">
                        <a:pos x="0" y="34"/>
                      </a:cxn>
                      <a:cxn ang="0">
                        <a:pos x="10" y="164"/>
                      </a:cxn>
                      <a:cxn ang="0">
                        <a:pos x="3" y="206"/>
                      </a:cxn>
                      <a:cxn ang="0">
                        <a:pos x="36" y="258"/>
                      </a:cxn>
                      <a:cxn ang="0">
                        <a:pos x="56" y="301"/>
                      </a:cxn>
                      <a:cxn ang="0">
                        <a:pos x="69" y="361"/>
                      </a:cxn>
                      <a:cxn ang="0">
                        <a:pos x="51" y="382"/>
                      </a:cxn>
                      <a:cxn ang="0">
                        <a:pos x="80" y="422"/>
                      </a:cxn>
                      <a:cxn ang="0">
                        <a:pos x="95" y="404"/>
                      </a:cxn>
                      <a:cxn ang="0">
                        <a:pos x="137" y="405"/>
                      </a:cxn>
                      <a:cxn ang="0">
                        <a:pos x="199" y="390"/>
                      </a:cxn>
                      <a:cxn ang="0">
                        <a:pos x="273" y="383"/>
                      </a:cxn>
                      <a:cxn ang="0">
                        <a:pos x="285" y="401"/>
                      </a:cxn>
                      <a:cxn ang="0">
                        <a:pos x="310" y="407"/>
                      </a:cxn>
                      <a:cxn ang="0">
                        <a:pos x="310" y="441"/>
                      </a:cxn>
                      <a:cxn ang="0">
                        <a:pos x="337" y="450"/>
                      </a:cxn>
                      <a:cxn ang="0">
                        <a:pos x="427" y="421"/>
                      </a:cxn>
                      <a:cxn ang="0">
                        <a:pos x="424" y="467"/>
                      </a:cxn>
                      <a:cxn ang="0">
                        <a:pos x="446" y="482"/>
                      </a:cxn>
                      <a:cxn ang="0">
                        <a:pos x="465" y="486"/>
                      </a:cxn>
                      <a:cxn ang="0">
                        <a:pos x="473" y="479"/>
                      </a:cxn>
                      <a:cxn ang="0">
                        <a:pos x="500" y="407"/>
                      </a:cxn>
                      <a:cxn ang="0">
                        <a:pos x="525" y="394"/>
                      </a:cxn>
                      <a:cxn ang="0">
                        <a:pos x="552" y="392"/>
                      </a:cxn>
                      <a:cxn ang="0">
                        <a:pos x="560" y="426"/>
                      </a:cxn>
                      <a:cxn ang="0">
                        <a:pos x="582" y="375"/>
                      </a:cxn>
                      <a:cxn ang="0">
                        <a:pos x="590" y="342"/>
                      </a:cxn>
                      <a:cxn ang="0">
                        <a:pos x="629" y="360"/>
                      </a:cxn>
                      <a:cxn ang="0">
                        <a:pos x="648" y="335"/>
                      </a:cxn>
                      <a:cxn ang="0">
                        <a:pos x="634" y="277"/>
                      </a:cxn>
                      <a:cxn ang="0">
                        <a:pos x="595" y="268"/>
                      </a:cxn>
                      <a:cxn ang="0">
                        <a:pos x="551" y="261"/>
                      </a:cxn>
                      <a:cxn ang="0">
                        <a:pos x="536" y="248"/>
                      </a:cxn>
                      <a:cxn ang="0">
                        <a:pos x="475" y="226"/>
                      </a:cxn>
                      <a:cxn ang="0">
                        <a:pos x="446" y="218"/>
                      </a:cxn>
                      <a:cxn ang="0">
                        <a:pos x="451" y="259"/>
                      </a:cxn>
                      <a:cxn ang="0">
                        <a:pos x="411" y="282"/>
                      </a:cxn>
                      <a:cxn ang="0">
                        <a:pos x="386" y="294"/>
                      </a:cxn>
                      <a:cxn ang="0">
                        <a:pos x="360" y="289"/>
                      </a:cxn>
                      <a:cxn ang="0">
                        <a:pos x="323" y="284"/>
                      </a:cxn>
                      <a:cxn ang="0">
                        <a:pos x="284" y="284"/>
                      </a:cxn>
                      <a:cxn ang="0">
                        <a:pos x="279" y="254"/>
                      </a:cxn>
                      <a:cxn ang="0">
                        <a:pos x="288" y="207"/>
                      </a:cxn>
                      <a:cxn ang="0">
                        <a:pos x="305" y="189"/>
                      </a:cxn>
                      <a:cxn ang="0">
                        <a:pos x="256" y="139"/>
                      </a:cxn>
                      <a:cxn ang="0">
                        <a:pos x="220" y="87"/>
                      </a:cxn>
                      <a:cxn ang="0">
                        <a:pos x="216" y="34"/>
                      </a:cxn>
                      <a:cxn ang="0">
                        <a:pos x="162" y="23"/>
                      </a:cxn>
                      <a:cxn ang="0">
                        <a:pos x="107" y="28"/>
                      </a:cxn>
                      <a:cxn ang="0">
                        <a:pos x="89" y="12"/>
                      </a:cxn>
                      <a:cxn ang="0">
                        <a:pos x="43" y="21"/>
                      </a:cxn>
                      <a:cxn ang="0">
                        <a:pos x="4" y="0"/>
                      </a:cxn>
                    </a:cxnLst>
                    <a:rect l="0" t="0" r="r" b="b"/>
                    <a:pathLst>
                      <a:path w="648" h="494">
                        <a:moveTo>
                          <a:pt x="4" y="0"/>
                        </a:moveTo>
                        <a:cubicBezTo>
                          <a:pt x="0" y="34"/>
                          <a:pt x="0" y="34"/>
                          <a:pt x="0" y="34"/>
                        </a:cubicBezTo>
                        <a:cubicBezTo>
                          <a:pt x="21" y="87"/>
                          <a:pt x="21" y="87"/>
                          <a:pt x="21" y="87"/>
                        </a:cubicBezTo>
                        <a:cubicBezTo>
                          <a:pt x="10" y="164"/>
                          <a:pt x="10" y="164"/>
                          <a:pt x="10" y="164"/>
                        </a:cubicBezTo>
                        <a:cubicBezTo>
                          <a:pt x="11" y="188"/>
                          <a:pt x="11" y="188"/>
                          <a:pt x="11" y="188"/>
                        </a:cubicBezTo>
                        <a:cubicBezTo>
                          <a:pt x="3" y="206"/>
                          <a:pt x="3" y="206"/>
                          <a:pt x="3" y="206"/>
                        </a:cubicBezTo>
                        <a:cubicBezTo>
                          <a:pt x="14" y="234"/>
                          <a:pt x="14" y="234"/>
                          <a:pt x="14" y="234"/>
                        </a:cubicBezTo>
                        <a:cubicBezTo>
                          <a:pt x="36" y="258"/>
                          <a:pt x="36" y="258"/>
                          <a:pt x="36" y="258"/>
                        </a:cubicBezTo>
                        <a:cubicBezTo>
                          <a:pt x="51" y="267"/>
                          <a:pt x="51" y="267"/>
                          <a:pt x="51" y="267"/>
                        </a:cubicBezTo>
                        <a:cubicBezTo>
                          <a:pt x="56" y="301"/>
                          <a:pt x="56" y="301"/>
                          <a:pt x="56" y="301"/>
                        </a:cubicBezTo>
                        <a:cubicBezTo>
                          <a:pt x="67" y="331"/>
                          <a:pt x="67" y="331"/>
                          <a:pt x="67" y="331"/>
                        </a:cubicBezTo>
                        <a:cubicBezTo>
                          <a:pt x="69" y="361"/>
                          <a:pt x="69" y="361"/>
                          <a:pt x="69" y="361"/>
                        </a:cubicBezTo>
                        <a:cubicBezTo>
                          <a:pt x="68" y="373"/>
                          <a:pt x="68" y="373"/>
                          <a:pt x="68" y="373"/>
                        </a:cubicBezTo>
                        <a:cubicBezTo>
                          <a:pt x="51" y="382"/>
                          <a:pt x="51" y="382"/>
                          <a:pt x="51" y="382"/>
                        </a:cubicBezTo>
                        <a:cubicBezTo>
                          <a:pt x="62" y="420"/>
                          <a:pt x="62" y="420"/>
                          <a:pt x="62" y="420"/>
                        </a:cubicBezTo>
                        <a:cubicBezTo>
                          <a:pt x="80" y="422"/>
                          <a:pt x="80" y="422"/>
                          <a:pt x="80" y="422"/>
                        </a:cubicBezTo>
                        <a:cubicBezTo>
                          <a:pt x="91" y="410"/>
                          <a:pt x="91" y="410"/>
                          <a:pt x="91" y="410"/>
                        </a:cubicBezTo>
                        <a:cubicBezTo>
                          <a:pt x="95" y="404"/>
                          <a:pt x="95" y="404"/>
                          <a:pt x="95" y="404"/>
                        </a:cubicBezTo>
                        <a:cubicBezTo>
                          <a:pt x="129" y="412"/>
                          <a:pt x="129" y="412"/>
                          <a:pt x="129" y="412"/>
                        </a:cubicBezTo>
                        <a:cubicBezTo>
                          <a:pt x="137" y="405"/>
                          <a:pt x="137" y="405"/>
                          <a:pt x="137" y="405"/>
                        </a:cubicBezTo>
                        <a:cubicBezTo>
                          <a:pt x="167" y="410"/>
                          <a:pt x="167" y="410"/>
                          <a:pt x="167" y="410"/>
                        </a:cubicBezTo>
                        <a:cubicBezTo>
                          <a:pt x="199" y="390"/>
                          <a:pt x="199" y="390"/>
                          <a:pt x="199" y="390"/>
                        </a:cubicBezTo>
                        <a:cubicBezTo>
                          <a:pt x="252" y="401"/>
                          <a:pt x="252" y="401"/>
                          <a:pt x="252" y="401"/>
                        </a:cubicBezTo>
                        <a:cubicBezTo>
                          <a:pt x="273" y="383"/>
                          <a:pt x="273" y="383"/>
                          <a:pt x="273" y="383"/>
                        </a:cubicBezTo>
                        <a:cubicBezTo>
                          <a:pt x="284" y="388"/>
                          <a:pt x="284" y="388"/>
                          <a:pt x="284" y="388"/>
                        </a:cubicBezTo>
                        <a:cubicBezTo>
                          <a:pt x="285" y="401"/>
                          <a:pt x="285" y="401"/>
                          <a:pt x="285" y="401"/>
                        </a:cubicBezTo>
                        <a:cubicBezTo>
                          <a:pt x="301" y="405"/>
                          <a:pt x="301" y="405"/>
                          <a:pt x="301" y="405"/>
                        </a:cubicBezTo>
                        <a:cubicBezTo>
                          <a:pt x="310" y="407"/>
                          <a:pt x="310" y="407"/>
                          <a:pt x="310" y="407"/>
                        </a:cubicBezTo>
                        <a:cubicBezTo>
                          <a:pt x="315" y="423"/>
                          <a:pt x="315" y="423"/>
                          <a:pt x="315" y="423"/>
                        </a:cubicBezTo>
                        <a:cubicBezTo>
                          <a:pt x="310" y="441"/>
                          <a:pt x="310" y="441"/>
                          <a:pt x="310" y="441"/>
                        </a:cubicBezTo>
                        <a:cubicBezTo>
                          <a:pt x="318" y="451"/>
                          <a:pt x="318" y="451"/>
                          <a:pt x="318" y="451"/>
                        </a:cubicBezTo>
                        <a:cubicBezTo>
                          <a:pt x="337" y="450"/>
                          <a:pt x="337" y="450"/>
                          <a:pt x="337" y="450"/>
                        </a:cubicBezTo>
                        <a:cubicBezTo>
                          <a:pt x="367" y="430"/>
                          <a:pt x="367" y="430"/>
                          <a:pt x="367" y="430"/>
                        </a:cubicBezTo>
                        <a:cubicBezTo>
                          <a:pt x="427" y="421"/>
                          <a:pt x="427" y="421"/>
                          <a:pt x="427" y="421"/>
                        </a:cubicBezTo>
                        <a:cubicBezTo>
                          <a:pt x="422" y="448"/>
                          <a:pt x="422" y="448"/>
                          <a:pt x="422" y="448"/>
                        </a:cubicBezTo>
                        <a:cubicBezTo>
                          <a:pt x="424" y="467"/>
                          <a:pt x="424" y="467"/>
                          <a:pt x="424" y="467"/>
                        </a:cubicBezTo>
                        <a:cubicBezTo>
                          <a:pt x="435" y="477"/>
                          <a:pt x="435" y="477"/>
                          <a:pt x="435" y="477"/>
                        </a:cubicBezTo>
                        <a:cubicBezTo>
                          <a:pt x="446" y="482"/>
                          <a:pt x="446" y="482"/>
                          <a:pt x="446" y="482"/>
                        </a:cubicBezTo>
                        <a:cubicBezTo>
                          <a:pt x="446" y="482"/>
                          <a:pt x="444" y="490"/>
                          <a:pt x="446" y="490"/>
                        </a:cubicBezTo>
                        <a:cubicBezTo>
                          <a:pt x="448" y="491"/>
                          <a:pt x="465" y="486"/>
                          <a:pt x="465" y="486"/>
                        </a:cubicBezTo>
                        <a:cubicBezTo>
                          <a:pt x="473" y="494"/>
                          <a:pt x="473" y="494"/>
                          <a:pt x="473" y="494"/>
                        </a:cubicBezTo>
                        <a:cubicBezTo>
                          <a:pt x="473" y="479"/>
                          <a:pt x="473" y="479"/>
                          <a:pt x="473" y="479"/>
                        </a:cubicBezTo>
                        <a:cubicBezTo>
                          <a:pt x="494" y="443"/>
                          <a:pt x="494" y="443"/>
                          <a:pt x="494" y="443"/>
                        </a:cubicBezTo>
                        <a:cubicBezTo>
                          <a:pt x="500" y="407"/>
                          <a:pt x="500" y="407"/>
                          <a:pt x="500" y="407"/>
                        </a:cubicBezTo>
                        <a:cubicBezTo>
                          <a:pt x="510" y="398"/>
                          <a:pt x="510" y="398"/>
                          <a:pt x="510" y="398"/>
                        </a:cubicBezTo>
                        <a:cubicBezTo>
                          <a:pt x="525" y="394"/>
                          <a:pt x="525" y="394"/>
                          <a:pt x="525" y="394"/>
                        </a:cubicBezTo>
                        <a:cubicBezTo>
                          <a:pt x="541" y="385"/>
                          <a:pt x="541" y="385"/>
                          <a:pt x="541" y="385"/>
                        </a:cubicBezTo>
                        <a:cubicBezTo>
                          <a:pt x="552" y="392"/>
                          <a:pt x="552" y="392"/>
                          <a:pt x="552" y="392"/>
                        </a:cubicBezTo>
                        <a:cubicBezTo>
                          <a:pt x="552" y="425"/>
                          <a:pt x="552" y="425"/>
                          <a:pt x="552" y="425"/>
                        </a:cubicBezTo>
                        <a:cubicBezTo>
                          <a:pt x="560" y="426"/>
                          <a:pt x="560" y="426"/>
                          <a:pt x="560" y="426"/>
                        </a:cubicBezTo>
                        <a:cubicBezTo>
                          <a:pt x="572" y="400"/>
                          <a:pt x="572" y="400"/>
                          <a:pt x="572" y="400"/>
                        </a:cubicBezTo>
                        <a:cubicBezTo>
                          <a:pt x="582" y="375"/>
                          <a:pt x="582" y="375"/>
                          <a:pt x="582" y="375"/>
                        </a:cubicBezTo>
                        <a:cubicBezTo>
                          <a:pt x="576" y="342"/>
                          <a:pt x="576" y="342"/>
                          <a:pt x="576" y="342"/>
                        </a:cubicBezTo>
                        <a:cubicBezTo>
                          <a:pt x="590" y="342"/>
                          <a:pt x="590" y="342"/>
                          <a:pt x="590" y="342"/>
                        </a:cubicBezTo>
                        <a:cubicBezTo>
                          <a:pt x="616" y="342"/>
                          <a:pt x="616" y="342"/>
                          <a:pt x="616" y="342"/>
                        </a:cubicBezTo>
                        <a:cubicBezTo>
                          <a:pt x="629" y="360"/>
                          <a:pt x="629" y="360"/>
                          <a:pt x="629" y="360"/>
                        </a:cubicBezTo>
                        <a:cubicBezTo>
                          <a:pt x="637" y="362"/>
                          <a:pt x="637" y="362"/>
                          <a:pt x="637" y="362"/>
                        </a:cubicBezTo>
                        <a:cubicBezTo>
                          <a:pt x="648" y="335"/>
                          <a:pt x="648" y="335"/>
                          <a:pt x="648" y="335"/>
                        </a:cubicBezTo>
                        <a:cubicBezTo>
                          <a:pt x="632" y="312"/>
                          <a:pt x="632" y="312"/>
                          <a:pt x="632" y="312"/>
                        </a:cubicBezTo>
                        <a:cubicBezTo>
                          <a:pt x="634" y="277"/>
                          <a:pt x="634" y="277"/>
                          <a:pt x="634" y="277"/>
                        </a:cubicBezTo>
                        <a:cubicBezTo>
                          <a:pt x="626" y="265"/>
                          <a:pt x="626" y="265"/>
                          <a:pt x="626" y="265"/>
                        </a:cubicBezTo>
                        <a:cubicBezTo>
                          <a:pt x="595" y="268"/>
                          <a:pt x="595" y="268"/>
                          <a:pt x="595" y="268"/>
                        </a:cubicBezTo>
                        <a:cubicBezTo>
                          <a:pt x="584" y="262"/>
                          <a:pt x="584" y="262"/>
                          <a:pt x="584" y="262"/>
                        </a:cubicBezTo>
                        <a:cubicBezTo>
                          <a:pt x="551" y="261"/>
                          <a:pt x="551" y="261"/>
                          <a:pt x="551" y="261"/>
                        </a:cubicBezTo>
                        <a:cubicBezTo>
                          <a:pt x="552" y="240"/>
                          <a:pt x="552" y="240"/>
                          <a:pt x="552" y="240"/>
                        </a:cubicBezTo>
                        <a:cubicBezTo>
                          <a:pt x="536" y="248"/>
                          <a:pt x="536" y="248"/>
                          <a:pt x="536" y="248"/>
                        </a:cubicBezTo>
                        <a:cubicBezTo>
                          <a:pt x="516" y="243"/>
                          <a:pt x="516" y="243"/>
                          <a:pt x="516" y="243"/>
                        </a:cubicBezTo>
                        <a:cubicBezTo>
                          <a:pt x="475" y="226"/>
                          <a:pt x="475" y="226"/>
                          <a:pt x="475" y="226"/>
                        </a:cubicBezTo>
                        <a:cubicBezTo>
                          <a:pt x="454" y="214"/>
                          <a:pt x="454" y="214"/>
                          <a:pt x="454" y="214"/>
                        </a:cubicBezTo>
                        <a:cubicBezTo>
                          <a:pt x="446" y="218"/>
                          <a:pt x="446" y="218"/>
                          <a:pt x="446" y="218"/>
                        </a:cubicBezTo>
                        <a:cubicBezTo>
                          <a:pt x="449" y="239"/>
                          <a:pt x="449" y="239"/>
                          <a:pt x="449" y="239"/>
                        </a:cubicBezTo>
                        <a:cubicBezTo>
                          <a:pt x="451" y="259"/>
                          <a:pt x="451" y="259"/>
                          <a:pt x="451" y="259"/>
                        </a:cubicBezTo>
                        <a:cubicBezTo>
                          <a:pt x="435" y="270"/>
                          <a:pt x="435" y="270"/>
                          <a:pt x="435" y="270"/>
                        </a:cubicBezTo>
                        <a:cubicBezTo>
                          <a:pt x="411" y="282"/>
                          <a:pt x="411" y="282"/>
                          <a:pt x="411" y="282"/>
                        </a:cubicBezTo>
                        <a:cubicBezTo>
                          <a:pt x="397" y="285"/>
                          <a:pt x="397" y="285"/>
                          <a:pt x="397" y="285"/>
                        </a:cubicBezTo>
                        <a:cubicBezTo>
                          <a:pt x="386" y="294"/>
                          <a:pt x="386" y="294"/>
                          <a:pt x="386" y="294"/>
                        </a:cubicBezTo>
                        <a:cubicBezTo>
                          <a:pt x="367" y="289"/>
                          <a:pt x="367" y="289"/>
                          <a:pt x="367" y="289"/>
                        </a:cubicBezTo>
                        <a:cubicBezTo>
                          <a:pt x="360" y="289"/>
                          <a:pt x="360" y="289"/>
                          <a:pt x="360" y="289"/>
                        </a:cubicBezTo>
                        <a:cubicBezTo>
                          <a:pt x="339" y="281"/>
                          <a:pt x="339" y="281"/>
                          <a:pt x="339" y="281"/>
                        </a:cubicBezTo>
                        <a:cubicBezTo>
                          <a:pt x="323" y="284"/>
                          <a:pt x="323" y="284"/>
                          <a:pt x="323" y="284"/>
                        </a:cubicBezTo>
                        <a:cubicBezTo>
                          <a:pt x="299" y="277"/>
                          <a:pt x="299" y="277"/>
                          <a:pt x="299" y="277"/>
                        </a:cubicBezTo>
                        <a:cubicBezTo>
                          <a:pt x="284" y="284"/>
                          <a:pt x="284" y="284"/>
                          <a:pt x="284" y="284"/>
                        </a:cubicBezTo>
                        <a:cubicBezTo>
                          <a:pt x="282" y="283"/>
                          <a:pt x="282" y="283"/>
                          <a:pt x="282" y="283"/>
                        </a:cubicBezTo>
                        <a:cubicBezTo>
                          <a:pt x="279" y="254"/>
                          <a:pt x="279" y="254"/>
                          <a:pt x="279" y="254"/>
                        </a:cubicBezTo>
                        <a:cubicBezTo>
                          <a:pt x="284" y="238"/>
                          <a:pt x="284" y="238"/>
                          <a:pt x="284" y="238"/>
                        </a:cubicBezTo>
                        <a:cubicBezTo>
                          <a:pt x="288" y="207"/>
                          <a:pt x="288" y="207"/>
                          <a:pt x="288" y="207"/>
                        </a:cubicBezTo>
                        <a:cubicBezTo>
                          <a:pt x="296" y="194"/>
                          <a:pt x="296" y="194"/>
                          <a:pt x="296" y="194"/>
                        </a:cubicBezTo>
                        <a:cubicBezTo>
                          <a:pt x="305" y="189"/>
                          <a:pt x="305" y="189"/>
                          <a:pt x="305" y="189"/>
                        </a:cubicBezTo>
                        <a:cubicBezTo>
                          <a:pt x="297" y="157"/>
                          <a:pt x="297" y="157"/>
                          <a:pt x="297" y="157"/>
                        </a:cubicBezTo>
                        <a:cubicBezTo>
                          <a:pt x="256" y="139"/>
                          <a:pt x="256" y="139"/>
                          <a:pt x="256" y="139"/>
                        </a:cubicBezTo>
                        <a:cubicBezTo>
                          <a:pt x="223" y="129"/>
                          <a:pt x="223" y="129"/>
                          <a:pt x="223" y="129"/>
                        </a:cubicBezTo>
                        <a:cubicBezTo>
                          <a:pt x="220" y="87"/>
                          <a:pt x="220" y="87"/>
                          <a:pt x="220" y="87"/>
                        </a:cubicBezTo>
                        <a:cubicBezTo>
                          <a:pt x="227" y="60"/>
                          <a:pt x="227" y="60"/>
                          <a:pt x="227" y="60"/>
                        </a:cubicBezTo>
                        <a:cubicBezTo>
                          <a:pt x="216" y="34"/>
                          <a:pt x="216" y="34"/>
                          <a:pt x="216" y="34"/>
                        </a:cubicBezTo>
                        <a:cubicBezTo>
                          <a:pt x="168" y="34"/>
                          <a:pt x="168" y="34"/>
                          <a:pt x="168" y="34"/>
                        </a:cubicBezTo>
                        <a:cubicBezTo>
                          <a:pt x="162" y="23"/>
                          <a:pt x="162" y="23"/>
                          <a:pt x="162" y="23"/>
                        </a:cubicBezTo>
                        <a:cubicBezTo>
                          <a:pt x="140" y="33"/>
                          <a:pt x="140" y="33"/>
                          <a:pt x="140" y="33"/>
                        </a:cubicBezTo>
                        <a:cubicBezTo>
                          <a:pt x="140" y="33"/>
                          <a:pt x="110" y="33"/>
                          <a:pt x="107" y="28"/>
                        </a:cubicBezTo>
                        <a:cubicBezTo>
                          <a:pt x="104" y="22"/>
                          <a:pt x="101" y="11"/>
                          <a:pt x="101" y="11"/>
                        </a:cubicBezTo>
                        <a:cubicBezTo>
                          <a:pt x="89" y="12"/>
                          <a:pt x="89" y="12"/>
                          <a:pt x="89" y="12"/>
                        </a:cubicBezTo>
                        <a:cubicBezTo>
                          <a:pt x="81" y="24"/>
                          <a:pt x="81" y="24"/>
                          <a:pt x="81" y="24"/>
                        </a:cubicBezTo>
                        <a:cubicBezTo>
                          <a:pt x="43" y="21"/>
                          <a:pt x="43" y="21"/>
                          <a:pt x="43" y="21"/>
                        </a:cubicBezTo>
                        <a:cubicBezTo>
                          <a:pt x="23" y="7"/>
                          <a:pt x="23" y="7"/>
                          <a:pt x="23" y="7"/>
                        </a:cubicBezTo>
                        <a:lnTo>
                          <a:pt x="4" y="0"/>
                        </a:lnTo>
                        <a:close/>
                      </a:path>
                    </a:pathLst>
                  </a:custGeom>
                  <a:noFill/>
                  <a:ln w="3175" cmpd="sng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  <a:effectLst>
                    <a:outerShdw dist="28398" dir="6993903" algn="ctr" rotWithShape="0">
                      <a:srgbClr val="B2B2B2">
                        <a:alpha val="50000"/>
                      </a:srgbClr>
                    </a:outerShdw>
                  </a:effectLst>
                </p:spPr>
                <p:txBody>
                  <a:bodyPr/>
                  <a:lstStyle/>
                  <a:p>
                    <a:endParaRPr lang="zh-CN" altLang="en-US" sz="900" kern="0">
                      <a:solidFill>
                        <a:sysClr val="windowText" lastClr="000000"/>
                      </a:solidFill>
                    </a:endParaRPr>
                  </a:p>
                </p:txBody>
              </p:sp>
            </p:grpSp>
            <p:sp>
              <p:nvSpPr>
                <p:cNvPr id="88" name="TextBox 87"/>
                <p:cNvSpPr txBox="1"/>
                <p:nvPr/>
              </p:nvSpPr>
              <p:spPr>
                <a:xfrm>
                  <a:off x="3448405" y="2491153"/>
                  <a:ext cx="1130847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shuapa province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TextBox 92"/>
                <p:cNvSpPr txBox="1"/>
                <p:nvPr/>
              </p:nvSpPr>
              <p:spPr>
                <a:xfrm>
                  <a:off x="1879093" y="5616731"/>
                  <a:ext cx="936265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inshasa province</a:t>
                  </a:r>
                  <a:endParaRPr 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8" name="Rectangle 97"/>
              <p:cNvSpPr/>
              <p:nvPr/>
            </p:nvSpPr>
            <p:spPr>
              <a:xfrm>
                <a:off x="971945" y="2467841"/>
                <a:ext cx="4329545" cy="4094018"/>
              </a:xfrm>
              <a:prstGeom prst="rect">
                <a:avLst/>
              </a:prstGeom>
              <a:noFill/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3" name="Straight Connector 2"/>
            <p:cNvCxnSpPr/>
            <p:nvPr/>
          </p:nvCxnSpPr>
          <p:spPr>
            <a:xfrm>
              <a:off x="1499719" y="3160861"/>
              <a:ext cx="573567" cy="1997700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>
              <a:endCxn id="56" idx="38"/>
            </p:cNvCxnSpPr>
            <p:nvPr/>
          </p:nvCxnSpPr>
          <p:spPr>
            <a:xfrm>
              <a:off x="1703550" y="2994864"/>
              <a:ext cx="2859776" cy="296925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 flipH="1">
              <a:off x="3675764" y="3055369"/>
              <a:ext cx="312715" cy="1177601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/>
            <p:nvPr/>
          </p:nvCxnSpPr>
          <p:spPr>
            <a:xfrm flipV="1">
              <a:off x="2481750" y="4919513"/>
              <a:ext cx="229534" cy="82004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Rectangle 3"/>
          <p:cNvSpPr/>
          <p:nvPr/>
        </p:nvSpPr>
        <p:spPr>
          <a:xfrm>
            <a:off x="836024" y="7234772"/>
            <a:ext cx="504226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627063" indent="-627063" algn="just">
              <a:spcBef>
                <a:spcPts val="1200"/>
              </a:spcBef>
            </a:pPr>
            <a:r>
              <a:rPr lang="en-US" sz="10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sampling location in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Democratic Republic of the Congo (DRC).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 shaded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gion indicates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ing province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the DR Congo.</a:t>
            </a:r>
          </a:p>
        </p:txBody>
      </p:sp>
    </p:spTree>
    <p:extLst>
      <p:ext uri="{BB962C8B-B14F-4D97-AF65-F5344CB8AC3E}">
        <p14:creationId xmlns:p14="http://schemas.microsoft.com/office/powerpoint/2010/main" val="3901815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85433" y="122858"/>
            <a:ext cx="6260147" cy="9112580"/>
            <a:chOff x="285433" y="162046"/>
            <a:chExt cx="6835775" cy="9387067"/>
          </a:xfrm>
        </p:grpSpPr>
        <p:grpSp>
          <p:nvGrpSpPr>
            <p:cNvPr id="260" name="Group 259"/>
            <p:cNvGrpSpPr>
              <a:grpSpLocks noChangeAspect="1"/>
            </p:cNvGrpSpPr>
            <p:nvPr/>
          </p:nvGrpSpPr>
          <p:grpSpPr>
            <a:xfrm>
              <a:off x="285433" y="162046"/>
              <a:ext cx="6835775" cy="9387067"/>
              <a:chOff x="468313" y="957263"/>
              <a:chExt cx="6835775" cy="8069163"/>
            </a:xfrm>
          </p:grpSpPr>
          <p:sp>
            <p:nvSpPr>
              <p:cNvPr id="4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468313" y="957263"/>
                <a:ext cx="6835775" cy="7991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" name="Group 205"/>
              <p:cNvGrpSpPr>
                <a:grpSpLocks/>
              </p:cNvGrpSpPr>
              <p:nvPr/>
            </p:nvGrpSpPr>
            <p:grpSpPr bwMode="auto">
              <a:xfrm>
                <a:off x="519113" y="1027113"/>
                <a:ext cx="5268914" cy="7750176"/>
                <a:chOff x="327" y="647"/>
                <a:chExt cx="3319" cy="4882"/>
              </a:xfrm>
            </p:grpSpPr>
            <p:sp>
              <p:nvSpPr>
                <p:cNvPr id="60" name="Rectangle 5"/>
                <p:cNvSpPr>
                  <a:spLocks noChangeArrowheads="1"/>
                </p:cNvSpPr>
                <p:nvPr/>
              </p:nvSpPr>
              <p:spPr bwMode="auto">
                <a:xfrm>
                  <a:off x="1490" y="647"/>
                  <a:ext cx="1315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F966385 NDV/  2008 Mali ML007 0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Freeform 6"/>
                <p:cNvSpPr>
                  <a:spLocks/>
                </p:cNvSpPr>
                <p:nvPr/>
              </p:nvSpPr>
              <p:spPr bwMode="auto">
                <a:xfrm>
                  <a:off x="1362" y="673"/>
                  <a:ext cx="106" cy="37"/>
                </a:xfrm>
                <a:custGeom>
                  <a:avLst/>
                  <a:gdLst>
                    <a:gd name="T0" fmla="*/ 0 w 106"/>
                    <a:gd name="T1" fmla="*/ 37 h 37"/>
                    <a:gd name="T2" fmla="*/ 0 w 106"/>
                    <a:gd name="T3" fmla="*/ 0 h 37"/>
                    <a:gd name="T4" fmla="*/ 106 w 106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10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Rectangle 7"/>
                <p:cNvSpPr>
                  <a:spLocks noChangeArrowheads="1"/>
                </p:cNvSpPr>
                <p:nvPr/>
              </p:nvSpPr>
              <p:spPr bwMode="auto">
                <a:xfrm>
                  <a:off x="1442" y="723"/>
                  <a:ext cx="2123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171995 NDV/chicken/Nigeria/VRD124/06/N11/867/2006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Freeform 8"/>
                <p:cNvSpPr>
                  <a:spLocks/>
                </p:cNvSpPr>
                <p:nvPr/>
              </p:nvSpPr>
              <p:spPr bwMode="auto">
                <a:xfrm>
                  <a:off x="1362" y="713"/>
                  <a:ext cx="57" cy="36"/>
                </a:xfrm>
                <a:custGeom>
                  <a:avLst/>
                  <a:gdLst>
                    <a:gd name="T0" fmla="*/ 0 w 57"/>
                    <a:gd name="T1" fmla="*/ 0 h 36"/>
                    <a:gd name="T2" fmla="*/ 0 w 57"/>
                    <a:gd name="T3" fmla="*/ 36 h 36"/>
                    <a:gd name="T4" fmla="*/ 57 w 57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7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57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Freeform 9"/>
                <p:cNvSpPr>
                  <a:spLocks/>
                </p:cNvSpPr>
                <p:nvPr/>
              </p:nvSpPr>
              <p:spPr bwMode="auto">
                <a:xfrm>
                  <a:off x="1352" y="711"/>
                  <a:ext cx="10" cy="56"/>
                </a:xfrm>
                <a:custGeom>
                  <a:avLst/>
                  <a:gdLst>
                    <a:gd name="T0" fmla="*/ 0 w 10"/>
                    <a:gd name="T1" fmla="*/ 56 h 56"/>
                    <a:gd name="T2" fmla="*/ 0 w 10"/>
                    <a:gd name="T3" fmla="*/ 0 h 56"/>
                    <a:gd name="T4" fmla="*/ 10 w 10"/>
                    <a:gd name="T5" fmla="*/ 0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1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Rectangle 10"/>
                <p:cNvSpPr>
                  <a:spLocks noChangeArrowheads="1"/>
                </p:cNvSpPr>
                <p:nvPr/>
              </p:nvSpPr>
              <p:spPr bwMode="auto">
                <a:xfrm>
                  <a:off x="1499" y="799"/>
                  <a:ext cx="1921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171992  NDV/chicken/Nigeria/JN/469/N44/892/200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Freeform 11"/>
                <p:cNvSpPr>
                  <a:spLocks/>
                </p:cNvSpPr>
                <p:nvPr/>
              </p:nvSpPr>
              <p:spPr bwMode="auto">
                <a:xfrm>
                  <a:off x="1352" y="770"/>
                  <a:ext cx="125" cy="55"/>
                </a:xfrm>
                <a:custGeom>
                  <a:avLst/>
                  <a:gdLst>
                    <a:gd name="T0" fmla="*/ 0 w 125"/>
                    <a:gd name="T1" fmla="*/ 0 h 55"/>
                    <a:gd name="T2" fmla="*/ 0 w 125"/>
                    <a:gd name="T3" fmla="*/ 55 h 55"/>
                    <a:gd name="T4" fmla="*/ 125 w 125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5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125" y="5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Freeform 12"/>
                <p:cNvSpPr>
                  <a:spLocks/>
                </p:cNvSpPr>
                <p:nvPr/>
              </p:nvSpPr>
              <p:spPr bwMode="auto">
                <a:xfrm>
                  <a:off x="979" y="768"/>
                  <a:ext cx="373" cy="84"/>
                </a:xfrm>
                <a:custGeom>
                  <a:avLst/>
                  <a:gdLst>
                    <a:gd name="T0" fmla="*/ 0 w 373"/>
                    <a:gd name="T1" fmla="*/ 84 h 84"/>
                    <a:gd name="T2" fmla="*/ 0 w 373"/>
                    <a:gd name="T3" fmla="*/ 0 h 84"/>
                    <a:gd name="T4" fmla="*/ 373 w 373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3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373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Rectangle 13"/>
                <p:cNvSpPr>
                  <a:spLocks noChangeArrowheads="1"/>
                </p:cNvSpPr>
                <p:nvPr/>
              </p:nvSpPr>
              <p:spPr bwMode="auto">
                <a:xfrm>
                  <a:off x="1546" y="875"/>
                  <a:ext cx="204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171994 NDV/chicken/Nigeria/VRD09/001/N19/714/200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Freeform 14"/>
                <p:cNvSpPr>
                  <a:spLocks/>
                </p:cNvSpPr>
                <p:nvPr/>
              </p:nvSpPr>
              <p:spPr bwMode="auto">
                <a:xfrm>
                  <a:off x="1524" y="901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Rectangle 15"/>
                <p:cNvSpPr>
                  <a:spLocks noChangeArrowheads="1"/>
                </p:cNvSpPr>
                <p:nvPr/>
              </p:nvSpPr>
              <p:spPr bwMode="auto">
                <a:xfrm>
                  <a:off x="1546" y="951"/>
                  <a:ext cx="204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171994  NDV/chicken/Nigeria/VRD09/001/N19/714/200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Freeform 16"/>
                <p:cNvSpPr>
                  <a:spLocks/>
                </p:cNvSpPr>
                <p:nvPr/>
              </p:nvSpPr>
              <p:spPr bwMode="auto">
                <a:xfrm>
                  <a:off x="1524" y="941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Freeform 17"/>
                <p:cNvSpPr>
                  <a:spLocks/>
                </p:cNvSpPr>
                <p:nvPr/>
              </p:nvSpPr>
              <p:spPr bwMode="auto">
                <a:xfrm>
                  <a:off x="979" y="855"/>
                  <a:ext cx="545" cy="84"/>
                </a:xfrm>
                <a:custGeom>
                  <a:avLst/>
                  <a:gdLst>
                    <a:gd name="T0" fmla="*/ 0 w 545"/>
                    <a:gd name="T1" fmla="*/ 0 h 84"/>
                    <a:gd name="T2" fmla="*/ 0 w 545"/>
                    <a:gd name="T3" fmla="*/ 84 h 84"/>
                    <a:gd name="T4" fmla="*/ 545 w 545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45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545" y="8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Rectangle 18"/>
                <p:cNvSpPr>
                  <a:spLocks noChangeArrowheads="1"/>
                </p:cNvSpPr>
                <p:nvPr/>
              </p:nvSpPr>
              <p:spPr bwMode="auto">
                <a:xfrm>
                  <a:off x="1516" y="1027"/>
                  <a:ext cx="1194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F966387  NDV/2009 Mali ML00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Freeform 19"/>
                <p:cNvSpPr>
                  <a:spLocks/>
                </p:cNvSpPr>
                <p:nvPr/>
              </p:nvSpPr>
              <p:spPr bwMode="auto">
                <a:xfrm>
                  <a:off x="1494" y="1053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Rectangle 20"/>
                <p:cNvSpPr>
                  <a:spLocks noChangeArrowheads="1"/>
                </p:cNvSpPr>
                <p:nvPr/>
              </p:nvSpPr>
              <p:spPr bwMode="auto">
                <a:xfrm>
                  <a:off x="1516" y="1103"/>
                  <a:ext cx="1221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F966387   NDV/2009 Mali ML008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Freeform 21"/>
                <p:cNvSpPr>
                  <a:spLocks/>
                </p:cNvSpPr>
                <p:nvPr/>
              </p:nvSpPr>
              <p:spPr bwMode="auto">
                <a:xfrm>
                  <a:off x="1494" y="1093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Freeform 22"/>
                <p:cNvSpPr>
                  <a:spLocks/>
                </p:cNvSpPr>
                <p:nvPr/>
              </p:nvSpPr>
              <p:spPr bwMode="auto">
                <a:xfrm>
                  <a:off x="1188" y="1091"/>
                  <a:ext cx="306" cy="75"/>
                </a:xfrm>
                <a:custGeom>
                  <a:avLst/>
                  <a:gdLst>
                    <a:gd name="T0" fmla="*/ 0 w 306"/>
                    <a:gd name="T1" fmla="*/ 75 h 75"/>
                    <a:gd name="T2" fmla="*/ 0 w 306"/>
                    <a:gd name="T3" fmla="*/ 0 h 75"/>
                    <a:gd name="T4" fmla="*/ 306 w 306"/>
                    <a:gd name="T5" fmla="*/ 0 h 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6" h="75">
                      <a:moveTo>
                        <a:pt x="0" y="75"/>
                      </a:moveTo>
                      <a:lnTo>
                        <a:pt x="0" y="0"/>
                      </a:lnTo>
                      <a:lnTo>
                        <a:pt x="30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Rectangle 23"/>
                <p:cNvSpPr>
                  <a:spLocks noChangeArrowheads="1"/>
                </p:cNvSpPr>
                <p:nvPr/>
              </p:nvSpPr>
              <p:spPr bwMode="auto">
                <a:xfrm>
                  <a:off x="1482" y="1179"/>
                  <a:ext cx="1757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X390609    NDV/NDV/chicken/Togo/AKO18/200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Freeform 24"/>
                <p:cNvSpPr>
                  <a:spLocks/>
                </p:cNvSpPr>
                <p:nvPr/>
              </p:nvSpPr>
              <p:spPr bwMode="auto">
                <a:xfrm>
                  <a:off x="1328" y="1205"/>
                  <a:ext cx="132" cy="36"/>
                </a:xfrm>
                <a:custGeom>
                  <a:avLst/>
                  <a:gdLst>
                    <a:gd name="T0" fmla="*/ 0 w 132"/>
                    <a:gd name="T1" fmla="*/ 36 h 36"/>
                    <a:gd name="T2" fmla="*/ 0 w 132"/>
                    <a:gd name="T3" fmla="*/ 0 h 36"/>
                    <a:gd name="T4" fmla="*/ 132 w 132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2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3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Rectangle 25"/>
                <p:cNvSpPr>
                  <a:spLocks noChangeArrowheads="1"/>
                </p:cNvSpPr>
                <p:nvPr/>
              </p:nvSpPr>
              <p:spPr bwMode="auto">
                <a:xfrm>
                  <a:off x="1484" y="1255"/>
                  <a:ext cx="199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H392227  NDV/chicken/Nigeria/OOT/4/1/N69/914/200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Freeform 26"/>
                <p:cNvSpPr>
                  <a:spLocks/>
                </p:cNvSpPr>
                <p:nvPr/>
              </p:nvSpPr>
              <p:spPr bwMode="auto">
                <a:xfrm>
                  <a:off x="1328" y="1245"/>
                  <a:ext cx="134" cy="36"/>
                </a:xfrm>
                <a:custGeom>
                  <a:avLst/>
                  <a:gdLst>
                    <a:gd name="T0" fmla="*/ 0 w 134"/>
                    <a:gd name="T1" fmla="*/ 0 h 36"/>
                    <a:gd name="T2" fmla="*/ 0 w 134"/>
                    <a:gd name="T3" fmla="*/ 36 h 36"/>
                    <a:gd name="T4" fmla="*/ 134 w 134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4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134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Freeform 27"/>
                <p:cNvSpPr>
                  <a:spLocks/>
                </p:cNvSpPr>
                <p:nvPr/>
              </p:nvSpPr>
              <p:spPr bwMode="auto">
                <a:xfrm>
                  <a:off x="1188" y="1169"/>
                  <a:ext cx="140" cy="74"/>
                </a:xfrm>
                <a:custGeom>
                  <a:avLst/>
                  <a:gdLst>
                    <a:gd name="T0" fmla="*/ 0 w 140"/>
                    <a:gd name="T1" fmla="*/ 0 h 74"/>
                    <a:gd name="T2" fmla="*/ 0 w 140"/>
                    <a:gd name="T3" fmla="*/ 74 h 74"/>
                    <a:gd name="T4" fmla="*/ 140 w 140"/>
                    <a:gd name="T5" fmla="*/ 74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0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140" y="7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Freeform 28"/>
                <p:cNvSpPr>
                  <a:spLocks/>
                </p:cNvSpPr>
                <p:nvPr/>
              </p:nvSpPr>
              <p:spPr bwMode="auto">
                <a:xfrm>
                  <a:off x="979" y="969"/>
                  <a:ext cx="209" cy="198"/>
                </a:xfrm>
                <a:custGeom>
                  <a:avLst/>
                  <a:gdLst>
                    <a:gd name="T0" fmla="*/ 0 w 209"/>
                    <a:gd name="T1" fmla="*/ 0 h 198"/>
                    <a:gd name="T2" fmla="*/ 0 w 209"/>
                    <a:gd name="T3" fmla="*/ 198 h 198"/>
                    <a:gd name="T4" fmla="*/ 209 w 209"/>
                    <a:gd name="T5" fmla="*/ 198 h 19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" h="198">
                      <a:moveTo>
                        <a:pt x="0" y="0"/>
                      </a:moveTo>
                      <a:lnTo>
                        <a:pt x="0" y="198"/>
                      </a:lnTo>
                      <a:lnTo>
                        <a:pt x="209" y="198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Line 29"/>
                <p:cNvSpPr>
                  <a:spLocks noChangeShapeType="1"/>
                </p:cNvSpPr>
                <p:nvPr/>
              </p:nvSpPr>
              <p:spPr bwMode="auto">
                <a:xfrm>
                  <a:off x="979" y="768"/>
                  <a:ext cx="0" cy="198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Freeform 30"/>
                <p:cNvSpPr>
                  <a:spLocks/>
                </p:cNvSpPr>
                <p:nvPr/>
              </p:nvSpPr>
              <p:spPr bwMode="auto">
                <a:xfrm>
                  <a:off x="923" y="968"/>
                  <a:ext cx="56" cy="288"/>
                </a:xfrm>
                <a:custGeom>
                  <a:avLst/>
                  <a:gdLst>
                    <a:gd name="T0" fmla="*/ 0 w 56"/>
                    <a:gd name="T1" fmla="*/ 288 h 288"/>
                    <a:gd name="T2" fmla="*/ 0 w 56"/>
                    <a:gd name="T3" fmla="*/ 0 h 288"/>
                    <a:gd name="T4" fmla="*/ 56 w 56"/>
                    <a:gd name="T5" fmla="*/ 0 h 2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6" h="288">
                      <a:moveTo>
                        <a:pt x="0" y="288"/>
                      </a:moveTo>
                      <a:lnTo>
                        <a:pt x="0" y="0"/>
                      </a:lnTo>
                      <a:lnTo>
                        <a:pt x="5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Rectangle 31"/>
                <p:cNvSpPr>
                  <a:spLocks noChangeArrowheads="1"/>
                </p:cNvSpPr>
                <p:nvPr/>
              </p:nvSpPr>
              <p:spPr bwMode="auto">
                <a:xfrm>
                  <a:off x="1505" y="1331"/>
                  <a:ext cx="1035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152048 NDV/GD450/201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Freeform 32"/>
                <p:cNvSpPr>
                  <a:spLocks/>
                </p:cNvSpPr>
                <p:nvPr/>
              </p:nvSpPr>
              <p:spPr bwMode="auto">
                <a:xfrm>
                  <a:off x="1483" y="1357"/>
                  <a:ext cx="0" cy="36"/>
                </a:xfrm>
                <a:custGeom>
                  <a:avLst/>
                  <a:gdLst>
                    <a:gd name="T0" fmla="*/ 36 h 36"/>
                    <a:gd name="T1" fmla="*/ 0 h 36"/>
                    <a:gd name="T2" fmla="*/ 0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Rectangle 33"/>
                <p:cNvSpPr>
                  <a:spLocks noChangeArrowheads="1"/>
                </p:cNvSpPr>
                <p:nvPr/>
              </p:nvSpPr>
              <p:spPr bwMode="auto">
                <a:xfrm>
                  <a:off x="1505" y="1406"/>
                  <a:ext cx="106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152048 NDV/GD450/201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Freeform 34"/>
                <p:cNvSpPr>
                  <a:spLocks/>
                </p:cNvSpPr>
                <p:nvPr/>
              </p:nvSpPr>
              <p:spPr bwMode="auto">
                <a:xfrm>
                  <a:off x="1483" y="1397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Freeform 35"/>
                <p:cNvSpPr>
                  <a:spLocks/>
                </p:cNvSpPr>
                <p:nvPr/>
              </p:nvSpPr>
              <p:spPr bwMode="auto">
                <a:xfrm>
                  <a:off x="1075" y="1395"/>
                  <a:ext cx="408" cy="55"/>
                </a:xfrm>
                <a:custGeom>
                  <a:avLst/>
                  <a:gdLst>
                    <a:gd name="T0" fmla="*/ 0 w 408"/>
                    <a:gd name="T1" fmla="*/ 55 h 55"/>
                    <a:gd name="T2" fmla="*/ 0 w 408"/>
                    <a:gd name="T3" fmla="*/ 0 h 55"/>
                    <a:gd name="T4" fmla="*/ 408 w 408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08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40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Rectangle 36"/>
                <p:cNvSpPr>
                  <a:spLocks noChangeArrowheads="1"/>
                </p:cNvSpPr>
                <p:nvPr/>
              </p:nvSpPr>
              <p:spPr bwMode="auto">
                <a:xfrm>
                  <a:off x="1504" y="1482"/>
                  <a:ext cx="130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N800306.2(XII-1) Avian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vulavirus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Freeform 37"/>
                <p:cNvSpPr>
                  <a:spLocks/>
                </p:cNvSpPr>
                <p:nvPr/>
              </p:nvSpPr>
              <p:spPr bwMode="auto">
                <a:xfrm>
                  <a:off x="1075" y="1453"/>
                  <a:ext cx="407" cy="56"/>
                </a:xfrm>
                <a:custGeom>
                  <a:avLst/>
                  <a:gdLst>
                    <a:gd name="T0" fmla="*/ 0 w 407"/>
                    <a:gd name="T1" fmla="*/ 0 h 56"/>
                    <a:gd name="T2" fmla="*/ 0 w 407"/>
                    <a:gd name="T3" fmla="*/ 56 h 56"/>
                    <a:gd name="T4" fmla="*/ 407 w 407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07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407" y="5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Freeform 38"/>
                <p:cNvSpPr>
                  <a:spLocks/>
                </p:cNvSpPr>
                <p:nvPr/>
              </p:nvSpPr>
              <p:spPr bwMode="auto">
                <a:xfrm>
                  <a:off x="932" y="1452"/>
                  <a:ext cx="143" cy="93"/>
                </a:xfrm>
                <a:custGeom>
                  <a:avLst/>
                  <a:gdLst>
                    <a:gd name="T0" fmla="*/ 0 w 143"/>
                    <a:gd name="T1" fmla="*/ 93 h 93"/>
                    <a:gd name="T2" fmla="*/ 0 w 143"/>
                    <a:gd name="T3" fmla="*/ 0 h 93"/>
                    <a:gd name="T4" fmla="*/ 143 w 143"/>
                    <a:gd name="T5" fmla="*/ 0 h 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3" h="93">
                      <a:moveTo>
                        <a:pt x="0" y="93"/>
                      </a:moveTo>
                      <a:lnTo>
                        <a:pt x="0" y="0"/>
                      </a:lnTo>
                      <a:lnTo>
                        <a:pt x="143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Rectangle 39"/>
                <p:cNvSpPr>
                  <a:spLocks noChangeArrowheads="1"/>
                </p:cNvSpPr>
                <p:nvPr/>
              </p:nvSpPr>
              <p:spPr bwMode="auto">
                <a:xfrm>
                  <a:off x="1610" y="1558"/>
                  <a:ext cx="1581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M056349  NDV/NDV/42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opalpura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04/2013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Freeform 40"/>
                <p:cNvSpPr>
                  <a:spLocks/>
                </p:cNvSpPr>
                <p:nvPr/>
              </p:nvSpPr>
              <p:spPr bwMode="auto">
                <a:xfrm>
                  <a:off x="1006" y="1585"/>
                  <a:ext cx="582" cy="55"/>
                </a:xfrm>
                <a:custGeom>
                  <a:avLst/>
                  <a:gdLst>
                    <a:gd name="T0" fmla="*/ 0 w 582"/>
                    <a:gd name="T1" fmla="*/ 55 h 55"/>
                    <a:gd name="T2" fmla="*/ 0 w 582"/>
                    <a:gd name="T3" fmla="*/ 0 h 55"/>
                    <a:gd name="T4" fmla="*/ 582 w 582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2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58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Rectangle 41"/>
                <p:cNvSpPr>
                  <a:spLocks noChangeArrowheads="1"/>
                </p:cNvSpPr>
                <p:nvPr/>
              </p:nvSpPr>
              <p:spPr bwMode="auto">
                <a:xfrm>
                  <a:off x="1304" y="1634"/>
                  <a:ext cx="1450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J577585  NDV/Chicken/Bareilly/01/2010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Freeform 42"/>
                <p:cNvSpPr>
                  <a:spLocks/>
                </p:cNvSpPr>
                <p:nvPr/>
              </p:nvSpPr>
              <p:spPr bwMode="auto">
                <a:xfrm>
                  <a:off x="1198" y="1661"/>
                  <a:ext cx="83" cy="36"/>
                </a:xfrm>
                <a:custGeom>
                  <a:avLst/>
                  <a:gdLst>
                    <a:gd name="T0" fmla="*/ 0 w 83"/>
                    <a:gd name="T1" fmla="*/ 36 h 36"/>
                    <a:gd name="T2" fmla="*/ 0 w 83"/>
                    <a:gd name="T3" fmla="*/ 0 h 36"/>
                    <a:gd name="T4" fmla="*/ 83 w 83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3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83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Rectangle 43"/>
                <p:cNvSpPr>
                  <a:spLocks noChangeArrowheads="1"/>
                </p:cNvSpPr>
                <p:nvPr/>
              </p:nvSpPr>
              <p:spPr bwMode="auto">
                <a:xfrm>
                  <a:off x="1587" y="1710"/>
                  <a:ext cx="1681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F409241   </a:t>
                  </a:r>
                  <a:r>
                    <a:rPr lang="en-US" altLang="en-US" sz="10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icken/Zambia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iwoko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201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Freeform 44"/>
                <p:cNvSpPr>
                  <a:spLocks/>
                </p:cNvSpPr>
                <p:nvPr/>
              </p:nvSpPr>
              <p:spPr bwMode="auto">
                <a:xfrm>
                  <a:off x="1198" y="1700"/>
                  <a:ext cx="367" cy="37"/>
                </a:xfrm>
                <a:custGeom>
                  <a:avLst/>
                  <a:gdLst>
                    <a:gd name="T0" fmla="*/ 0 w 367"/>
                    <a:gd name="T1" fmla="*/ 0 h 37"/>
                    <a:gd name="T2" fmla="*/ 0 w 367"/>
                    <a:gd name="T3" fmla="*/ 37 h 37"/>
                    <a:gd name="T4" fmla="*/ 367 w 367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67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367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Freeform 45"/>
                <p:cNvSpPr>
                  <a:spLocks/>
                </p:cNvSpPr>
                <p:nvPr/>
              </p:nvSpPr>
              <p:spPr bwMode="auto">
                <a:xfrm>
                  <a:off x="1006" y="1643"/>
                  <a:ext cx="192" cy="56"/>
                </a:xfrm>
                <a:custGeom>
                  <a:avLst/>
                  <a:gdLst>
                    <a:gd name="T0" fmla="*/ 0 w 192"/>
                    <a:gd name="T1" fmla="*/ 0 h 56"/>
                    <a:gd name="T2" fmla="*/ 0 w 192"/>
                    <a:gd name="T3" fmla="*/ 56 h 56"/>
                    <a:gd name="T4" fmla="*/ 192 w 192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2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192" y="5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Freeform 46"/>
                <p:cNvSpPr>
                  <a:spLocks/>
                </p:cNvSpPr>
                <p:nvPr/>
              </p:nvSpPr>
              <p:spPr bwMode="auto">
                <a:xfrm>
                  <a:off x="932" y="1548"/>
                  <a:ext cx="74" cy="94"/>
                </a:xfrm>
                <a:custGeom>
                  <a:avLst/>
                  <a:gdLst>
                    <a:gd name="T0" fmla="*/ 0 w 74"/>
                    <a:gd name="T1" fmla="*/ 0 h 94"/>
                    <a:gd name="T2" fmla="*/ 0 w 74"/>
                    <a:gd name="T3" fmla="*/ 94 h 94"/>
                    <a:gd name="T4" fmla="*/ 74 w 74"/>
                    <a:gd name="T5" fmla="*/ 94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4" h="94">
                      <a:moveTo>
                        <a:pt x="0" y="0"/>
                      </a:moveTo>
                      <a:lnTo>
                        <a:pt x="0" y="94"/>
                      </a:lnTo>
                      <a:lnTo>
                        <a:pt x="74" y="9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Freeform 47"/>
                <p:cNvSpPr>
                  <a:spLocks/>
                </p:cNvSpPr>
                <p:nvPr/>
              </p:nvSpPr>
              <p:spPr bwMode="auto">
                <a:xfrm>
                  <a:off x="923" y="1259"/>
                  <a:ext cx="9" cy="288"/>
                </a:xfrm>
                <a:custGeom>
                  <a:avLst/>
                  <a:gdLst>
                    <a:gd name="T0" fmla="*/ 0 w 9"/>
                    <a:gd name="T1" fmla="*/ 0 h 288"/>
                    <a:gd name="T2" fmla="*/ 0 w 9"/>
                    <a:gd name="T3" fmla="*/ 288 h 288"/>
                    <a:gd name="T4" fmla="*/ 9 w 9"/>
                    <a:gd name="T5" fmla="*/ 288 h 2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" h="288">
                      <a:moveTo>
                        <a:pt x="0" y="0"/>
                      </a:moveTo>
                      <a:lnTo>
                        <a:pt x="0" y="288"/>
                      </a:lnTo>
                      <a:lnTo>
                        <a:pt x="9" y="288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Freeform 48"/>
                <p:cNvSpPr>
                  <a:spLocks/>
                </p:cNvSpPr>
                <p:nvPr/>
              </p:nvSpPr>
              <p:spPr bwMode="auto">
                <a:xfrm>
                  <a:off x="872" y="1257"/>
                  <a:ext cx="51" cy="333"/>
                </a:xfrm>
                <a:custGeom>
                  <a:avLst/>
                  <a:gdLst>
                    <a:gd name="T0" fmla="*/ 0 w 51"/>
                    <a:gd name="T1" fmla="*/ 333 h 333"/>
                    <a:gd name="T2" fmla="*/ 0 w 51"/>
                    <a:gd name="T3" fmla="*/ 0 h 333"/>
                    <a:gd name="T4" fmla="*/ 51 w 51"/>
                    <a:gd name="T5" fmla="*/ 0 h 3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" h="333">
                      <a:moveTo>
                        <a:pt x="0" y="333"/>
                      </a:moveTo>
                      <a:lnTo>
                        <a:pt x="0" y="0"/>
                      </a:lnTo>
                      <a:lnTo>
                        <a:pt x="51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4" name="Rectangle 49"/>
                <p:cNvSpPr>
                  <a:spLocks noChangeArrowheads="1"/>
                </p:cNvSpPr>
                <p:nvPr/>
              </p:nvSpPr>
              <p:spPr bwMode="auto">
                <a:xfrm>
                  <a:off x="1546" y="1787"/>
                  <a:ext cx="1826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ctr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W363931 </a:t>
                  </a:r>
                  <a:r>
                    <a:rPr lang="en-US" altLang="en-US" sz="10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chicken/DR Congo/</a:t>
                  </a:r>
                  <a:r>
                    <a:rPr kumimoji="0" lang="en-US" altLang="en-US" sz="1000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219/2019</a:t>
                  </a:r>
                </a:p>
              </p:txBody>
            </p:sp>
            <p:sp>
              <p:nvSpPr>
                <p:cNvPr id="105" name="Freeform 50"/>
                <p:cNvSpPr>
                  <a:spLocks/>
                </p:cNvSpPr>
                <p:nvPr/>
              </p:nvSpPr>
              <p:spPr bwMode="auto">
                <a:xfrm>
                  <a:off x="1019" y="1813"/>
                  <a:ext cx="505" cy="112"/>
                </a:xfrm>
                <a:custGeom>
                  <a:avLst/>
                  <a:gdLst>
                    <a:gd name="T0" fmla="*/ 0 w 505"/>
                    <a:gd name="T1" fmla="*/ 112 h 112"/>
                    <a:gd name="T2" fmla="*/ 0 w 505"/>
                    <a:gd name="T3" fmla="*/ 0 h 112"/>
                    <a:gd name="T4" fmla="*/ 505 w 505"/>
                    <a:gd name="T5" fmla="*/ 0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5" h="112">
                      <a:moveTo>
                        <a:pt x="0" y="112"/>
                      </a:moveTo>
                      <a:lnTo>
                        <a:pt x="0" y="0"/>
                      </a:lnTo>
                      <a:lnTo>
                        <a:pt x="505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6" name="Rectangle 51"/>
                <p:cNvSpPr>
                  <a:spLocks noChangeArrowheads="1"/>
                </p:cNvSpPr>
                <p:nvPr/>
              </p:nvSpPr>
              <p:spPr bwMode="auto">
                <a:xfrm>
                  <a:off x="1298" y="1862"/>
                  <a:ext cx="130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Q338309.1(VII-f) NDV/ND/03/01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Freeform 52"/>
                <p:cNvSpPr>
                  <a:spLocks/>
                </p:cNvSpPr>
                <p:nvPr/>
              </p:nvSpPr>
              <p:spPr bwMode="auto">
                <a:xfrm>
                  <a:off x="1276" y="1889"/>
                  <a:ext cx="0" cy="36"/>
                </a:xfrm>
                <a:custGeom>
                  <a:avLst/>
                  <a:gdLst>
                    <a:gd name="T0" fmla="*/ 36 h 36"/>
                    <a:gd name="T1" fmla="*/ 0 h 36"/>
                    <a:gd name="T2" fmla="*/ 0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Rectangle 53"/>
                <p:cNvSpPr>
                  <a:spLocks noChangeArrowheads="1"/>
                </p:cNvSpPr>
                <p:nvPr/>
              </p:nvSpPr>
              <p:spPr bwMode="auto">
                <a:xfrm>
                  <a:off x="1298" y="1938"/>
                  <a:ext cx="126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F343538.1(VII-f) NDV/ND/03/01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Freeform 54"/>
                <p:cNvSpPr>
                  <a:spLocks/>
                </p:cNvSpPr>
                <p:nvPr/>
              </p:nvSpPr>
              <p:spPr bwMode="auto">
                <a:xfrm>
                  <a:off x="1276" y="1928"/>
                  <a:ext cx="0" cy="37"/>
                </a:xfrm>
                <a:custGeom>
                  <a:avLst/>
                  <a:gdLst>
                    <a:gd name="T0" fmla="*/ 0 h 37"/>
                    <a:gd name="T1" fmla="*/ 37 h 37"/>
                    <a:gd name="T2" fmla="*/ 37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0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Freeform 55"/>
                <p:cNvSpPr>
                  <a:spLocks/>
                </p:cNvSpPr>
                <p:nvPr/>
              </p:nvSpPr>
              <p:spPr bwMode="auto">
                <a:xfrm>
                  <a:off x="1106" y="1927"/>
                  <a:ext cx="170" cy="112"/>
                </a:xfrm>
                <a:custGeom>
                  <a:avLst/>
                  <a:gdLst>
                    <a:gd name="T0" fmla="*/ 0 w 170"/>
                    <a:gd name="T1" fmla="*/ 112 h 112"/>
                    <a:gd name="T2" fmla="*/ 0 w 170"/>
                    <a:gd name="T3" fmla="*/ 0 h 112"/>
                    <a:gd name="T4" fmla="*/ 170 w 170"/>
                    <a:gd name="T5" fmla="*/ 0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0" h="112">
                      <a:moveTo>
                        <a:pt x="0" y="112"/>
                      </a:moveTo>
                      <a:lnTo>
                        <a:pt x="0" y="0"/>
                      </a:lnTo>
                      <a:lnTo>
                        <a:pt x="17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Rectangle 56"/>
                <p:cNvSpPr>
                  <a:spLocks noChangeArrowheads="1"/>
                </p:cNvSpPr>
                <p:nvPr/>
              </p:nvSpPr>
              <p:spPr bwMode="auto">
                <a:xfrm>
                  <a:off x="1292" y="2014"/>
                  <a:ext cx="125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X765179.1(VII) NDV/DU-FJ-24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Freeform 57"/>
                <p:cNvSpPr>
                  <a:spLocks/>
                </p:cNvSpPr>
                <p:nvPr/>
              </p:nvSpPr>
              <p:spPr bwMode="auto">
                <a:xfrm>
                  <a:off x="1255" y="2040"/>
                  <a:ext cx="15" cy="37"/>
                </a:xfrm>
                <a:custGeom>
                  <a:avLst/>
                  <a:gdLst>
                    <a:gd name="T0" fmla="*/ 0 w 15"/>
                    <a:gd name="T1" fmla="*/ 37 h 37"/>
                    <a:gd name="T2" fmla="*/ 0 w 15"/>
                    <a:gd name="T3" fmla="*/ 0 h 37"/>
                    <a:gd name="T4" fmla="*/ 15 w 15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15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Rectangle 58"/>
                <p:cNvSpPr>
                  <a:spLocks noChangeArrowheads="1"/>
                </p:cNvSpPr>
                <p:nvPr/>
              </p:nvSpPr>
              <p:spPr bwMode="auto">
                <a:xfrm>
                  <a:off x="1293" y="2090"/>
                  <a:ext cx="131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X765178.1(VII) NDV/DU-JXNC3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Freeform 59"/>
                <p:cNvSpPr>
                  <a:spLocks/>
                </p:cNvSpPr>
                <p:nvPr/>
              </p:nvSpPr>
              <p:spPr bwMode="auto">
                <a:xfrm>
                  <a:off x="1255" y="2080"/>
                  <a:ext cx="16" cy="36"/>
                </a:xfrm>
                <a:custGeom>
                  <a:avLst/>
                  <a:gdLst>
                    <a:gd name="T0" fmla="*/ 0 w 16"/>
                    <a:gd name="T1" fmla="*/ 0 h 36"/>
                    <a:gd name="T2" fmla="*/ 0 w 16"/>
                    <a:gd name="T3" fmla="*/ 36 h 36"/>
                    <a:gd name="T4" fmla="*/ 16 w 16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16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Freeform 60"/>
                <p:cNvSpPr>
                  <a:spLocks/>
                </p:cNvSpPr>
                <p:nvPr/>
              </p:nvSpPr>
              <p:spPr bwMode="auto">
                <a:xfrm>
                  <a:off x="1175" y="2078"/>
                  <a:ext cx="80" cy="75"/>
                </a:xfrm>
                <a:custGeom>
                  <a:avLst/>
                  <a:gdLst>
                    <a:gd name="T0" fmla="*/ 0 w 80"/>
                    <a:gd name="T1" fmla="*/ 75 h 75"/>
                    <a:gd name="T2" fmla="*/ 0 w 80"/>
                    <a:gd name="T3" fmla="*/ 0 h 75"/>
                    <a:gd name="T4" fmla="*/ 80 w 80"/>
                    <a:gd name="T5" fmla="*/ 0 h 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0" h="75">
                      <a:moveTo>
                        <a:pt x="0" y="75"/>
                      </a:moveTo>
                      <a:lnTo>
                        <a:pt x="0" y="0"/>
                      </a:lnTo>
                      <a:lnTo>
                        <a:pt x="8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Rectangle 61"/>
                <p:cNvSpPr>
                  <a:spLocks noChangeArrowheads="1"/>
                </p:cNvSpPr>
                <p:nvPr/>
              </p:nvSpPr>
              <p:spPr bwMode="auto">
                <a:xfrm>
                  <a:off x="1330" y="2166"/>
                  <a:ext cx="206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B853927.2(VII-e) NDV/chicken/Japan/Ibaraki/SG106/1999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Freeform 62"/>
                <p:cNvSpPr>
                  <a:spLocks/>
                </p:cNvSpPr>
                <p:nvPr/>
              </p:nvSpPr>
              <p:spPr bwMode="auto">
                <a:xfrm>
                  <a:off x="1240" y="2192"/>
                  <a:ext cx="68" cy="37"/>
                </a:xfrm>
                <a:custGeom>
                  <a:avLst/>
                  <a:gdLst>
                    <a:gd name="T0" fmla="*/ 0 w 68"/>
                    <a:gd name="T1" fmla="*/ 37 h 37"/>
                    <a:gd name="T2" fmla="*/ 0 w 68"/>
                    <a:gd name="T3" fmla="*/ 0 h 37"/>
                    <a:gd name="T4" fmla="*/ 68 w 68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8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6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" name="Rectangle 63"/>
                <p:cNvSpPr>
                  <a:spLocks noChangeArrowheads="1"/>
                </p:cNvSpPr>
                <p:nvPr/>
              </p:nvSpPr>
              <p:spPr bwMode="auto">
                <a:xfrm>
                  <a:off x="1296" y="2242"/>
                  <a:ext cx="169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J782375.1(VII-e) NDV/goose/CH/GD-QY/1997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" name="Freeform 64"/>
                <p:cNvSpPr>
                  <a:spLocks/>
                </p:cNvSpPr>
                <p:nvPr/>
              </p:nvSpPr>
              <p:spPr bwMode="auto">
                <a:xfrm>
                  <a:off x="1240" y="2232"/>
                  <a:ext cx="34" cy="36"/>
                </a:xfrm>
                <a:custGeom>
                  <a:avLst/>
                  <a:gdLst>
                    <a:gd name="T0" fmla="*/ 0 w 34"/>
                    <a:gd name="T1" fmla="*/ 0 h 36"/>
                    <a:gd name="T2" fmla="*/ 0 w 34"/>
                    <a:gd name="T3" fmla="*/ 36 h 36"/>
                    <a:gd name="T4" fmla="*/ 34 w 34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4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34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Freeform 65"/>
                <p:cNvSpPr>
                  <a:spLocks/>
                </p:cNvSpPr>
                <p:nvPr/>
              </p:nvSpPr>
              <p:spPr bwMode="auto">
                <a:xfrm>
                  <a:off x="1175" y="2156"/>
                  <a:ext cx="65" cy="74"/>
                </a:xfrm>
                <a:custGeom>
                  <a:avLst/>
                  <a:gdLst>
                    <a:gd name="T0" fmla="*/ 0 w 65"/>
                    <a:gd name="T1" fmla="*/ 0 h 74"/>
                    <a:gd name="T2" fmla="*/ 0 w 65"/>
                    <a:gd name="T3" fmla="*/ 74 h 74"/>
                    <a:gd name="T4" fmla="*/ 65 w 65"/>
                    <a:gd name="T5" fmla="*/ 74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65" y="7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Freeform 66"/>
                <p:cNvSpPr>
                  <a:spLocks/>
                </p:cNvSpPr>
                <p:nvPr/>
              </p:nvSpPr>
              <p:spPr bwMode="auto">
                <a:xfrm>
                  <a:off x="1106" y="2042"/>
                  <a:ext cx="69" cy="112"/>
                </a:xfrm>
                <a:custGeom>
                  <a:avLst/>
                  <a:gdLst>
                    <a:gd name="T0" fmla="*/ 0 w 69"/>
                    <a:gd name="T1" fmla="*/ 0 h 112"/>
                    <a:gd name="T2" fmla="*/ 0 w 69"/>
                    <a:gd name="T3" fmla="*/ 112 h 112"/>
                    <a:gd name="T4" fmla="*/ 69 w 69"/>
                    <a:gd name="T5" fmla="*/ 112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9" h="112">
                      <a:moveTo>
                        <a:pt x="0" y="0"/>
                      </a:moveTo>
                      <a:lnTo>
                        <a:pt x="0" y="112"/>
                      </a:lnTo>
                      <a:lnTo>
                        <a:pt x="69" y="112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Freeform 67"/>
                <p:cNvSpPr>
                  <a:spLocks/>
                </p:cNvSpPr>
                <p:nvPr/>
              </p:nvSpPr>
              <p:spPr bwMode="auto">
                <a:xfrm>
                  <a:off x="1019" y="1928"/>
                  <a:ext cx="87" cy="112"/>
                </a:xfrm>
                <a:custGeom>
                  <a:avLst/>
                  <a:gdLst>
                    <a:gd name="T0" fmla="*/ 0 w 87"/>
                    <a:gd name="T1" fmla="*/ 0 h 112"/>
                    <a:gd name="T2" fmla="*/ 0 w 87"/>
                    <a:gd name="T3" fmla="*/ 112 h 112"/>
                    <a:gd name="T4" fmla="*/ 87 w 87"/>
                    <a:gd name="T5" fmla="*/ 112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7" h="112">
                      <a:moveTo>
                        <a:pt x="0" y="0"/>
                      </a:moveTo>
                      <a:lnTo>
                        <a:pt x="0" y="112"/>
                      </a:lnTo>
                      <a:lnTo>
                        <a:pt x="87" y="112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Freeform 68"/>
                <p:cNvSpPr>
                  <a:spLocks/>
                </p:cNvSpPr>
                <p:nvPr/>
              </p:nvSpPr>
              <p:spPr bwMode="auto">
                <a:xfrm>
                  <a:off x="872" y="1593"/>
                  <a:ext cx="147" cy="334"/>
                </a:xfrm>
                <a:custGeom>
                  <a:avLst/>
                  <a:gdLst>
                    <a:gd name="T0" fmla="*/ 0 w 147"/>
                    <a:gd name="T1" fmla="*/ 0 h 334"/>
                    <a:gd name="T2" fmla="*/ 0 w 147"/>
                    <a:gd name="T3" fmla="*/ 334 h 334"/>
                    <a:gd name="T4" fmla="*/ 147 w 147"/>
                    <a:gd name="T5" fmla="*/ 334 h 3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7" h="334">
                      <a:moveTo>
                        <a:pt x="0" y="0"/>
                      </a:moveTo>
                      <a:lnTo>
                        <a:pt x="0" y="334"/>
                      </a:lnTo>
                      <a:lnTo>
                        <a:pt x="147" y="33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4" name="Freeform 69"/>
                <p:cNvSpPr>
                  <a:spLocks/>
                </p:cNvSpPr>
                <p:nvPr/>
              </p:nvSpPr>
              <p:spPr bwMode="auto">
                <a:xfrm>
                  <a:off x="824" y="1592"/>
                  <a:ext cx="48" cy="393"/>
                </a:xfrm>
                <a:custGeom>
                  <a:avLst/>
                  <a:gdLst>
                    <a:gd name="T0" fmla="*/ 0 w 48"/>
                    <a:gd name="T1" fmla="*/ 393 h 393"/>
                    <a:gd name="T2" fmla="*/ 0 w 48"/>
                    <a:gd name="T3" fmla="*/ 0 h 393"/>
                    <a:gd name="T4" fmla="*/ 48 w 48"/>
                    <a:gd name="T5" fmla="*/ 0 h 3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393">
                      <a:moveTo>
                        <a:pt x="0" y="393"/>
                      </a:moveTo>
                      <a:lnTo>
                        <a:pt x="0" y="0"/>
                      </a:lnTo>
                      <a:lnTo>
                        <a:pt x="4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5" name="Rectangle 70"/>
                <p:cNvSpPr>
                  <a:spLocks noChangeArrowheads="1"/>
                </p:cNvSpPr>
                <p:nvPr/>
              </p:nvSpPr>
              <p:spPr bwMode="auto">
                <a:xfrm>
                  <a:off x="1565" y="2320"/>
                  <a:ext cx="178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lang="en-US" altLang="en-US" sz="1000" dirty="0" smtClean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W363930 NDV/chicken/</a:t>
                  </a:r>
                  <a:r>
                    <a:rPr kumimoji="0" lang="en-US" altLang="en-US" sz="1000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R Congo/PL33/2018</a:t>
                  </a:r>
                </a:p>
              </p:txBody>
            </p:sp>
            <p:sp>
              <p:nvSpPr>
                <p:cNvPr id="126" name="Freeform 71"/>
                <p:cNvSpPr>
                  <a:spLocks/>
                </p:cNvSpPr>
                <p:nvPr/>
              </p:nvSpPr>
              <p:spPr bwMode="auto">
                <a:xfrm>
                  <a:off x="1550" y="2344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7" name="Rectangle 72"/>
                <p:cNvSpPr>
                  <a:spLocks noChangeArrowheads="1"/>
                </p:cNvSpPr>
                <p:nvPr/>
              </p:nvSpPr>
              <p:spPr bwMode="auto">
                <a:xfrm>
                  <a:off x="1586" y="2398"/>
                  <a:ext cx="2060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i="0" u="none" strike="noStrike" cap="none" normalizeH="0" baseline="0" dirty="0" smtClean="0">
                      <a:ln>
                        <a:noFill/>
                      </a:ln>
                      <a:solidFill>
                        <a:srgbClr val="C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W363929 NDV/chicken/DR Congo/18VRI3696/2018</a:t>
                  </a:r>
                </a:p>
              </p:txBody>
            </p:sp>
            <p:sp>
              <p:nvSpPr>
                <p:cNvPr id="128" name="Freeform 73"/>
                <p:cNvSpPr>
                  <a:spLocks/>
                </p:cNvSpPr>
                <p:nvPr/>
              </p:nvSpPr>
              <p:spPr bwMode="auto">
                <a:xfrm>
                  <a:off x="1550" y="2384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9" name="Freeform 74"/>
                <p:cNvSpPr>
                  <a:spLocks/>
                </p:cNvSpPr>
                <p:nvPr/>
              </p:nvSpPr>
              <p:spPr bwMode="auto">
                <a:xfrm>
                  <a:off x="824" y="1988"/>
                  <a:ext cx="726" cy="394"/>
                </a:xfrm>
                <a:custGeom>
                  <a:avLst/>
                  <a:gdLst>
                    <a:gd name="T0" fmla="*/ 0 w 726"/>
                    <a:gd name="T1" fmla="*/ 0 h 394"/>
                    <a:gd name="T2" fmla="*/ 0 w 726"/>
                    <a:gd name="T3" fmla="*/ 394 h 394"/>
                    <a:gd name="T4" fmla="*/ 726 w 726"/>
                    <a:gd name="T5" fmla="*/ 394 h 3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26" h="394">
                      <a:moveTo>
                        <a:pt x="0" y="0"/>
                      </a:moveTo>
                      <a:lnTo>
                        <a:pt x="0" y="394"/>
                      </a:lnTo>
                      <a:lnTo>
                        <a:pt x="726" y="39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0" name="Freeform 75"/>
                <p:cNvSpPr>
                  <a:spLocks/>
                </p:cNvSpPr>
                <p:nvPr/>
              </p:nvSpPr>
              <p:spPr bwMode="auto">
                <a:xfrm>
                  <a:off x="686" y="1987"/>
                  <a:ext cx="138" cy="367"/>
                </a:xfrm>
                <a:custGeom>
                  <a:avLst/>
                  <a:gdLst>
                    <a:gd name="T0" fmla="*/ 0 w 138"/>
                    <a:gd name="T1" fmla="*/ 367 h 367"/>
                    <a:gd name="T2" fmla="*/ 0 w 138"/>
                    <a:gd name="T3" fmla="*/ 0 h 367"/>
                    <a:gd name="T4" fmla="*/ 138 w 138"/>
                    <a:gd name="T5" fmla="*/ 0 h 3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8" h="367">
                      <a:moveTo>
                        <a:pt x="0" y="367"/>
                      </a:moveTo>
                      <a:lnTo>
                        <a:pt x="0" y="0"/>
                      </a:lnTo>
                      <a:lnTo>
                        <a:pt x="13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Rectangle 76"/>
                <p:cNvSpPr>
                  <a:spLocks noChangeArrowheads="1"/>
                </p:cNvSpPr>
                <p:nvPr/>
              </p:nvSpPr>
              <p:spPr bwMode="auto">
                <a:xfrm>
                  <a:off x="1035" y="2470"/>
                  <a:ext cx="936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FJ766529 NDV/  ZhJ-3/97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Freeform 77"/>
                <p:cNvSpPr>
                  <a:spLocks/>
                </p:cNvSpPr>
                <p:nvPr/>
              </p:nvSpPr>
              <p:spPr bwMode="auto">
                <a:xfrm>
                  <a:off x="1013" y="2496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3" name="Rectangle 78"/>
                <p:cNvSpPr>
                  <a:spLocks noChangeArrowheads="1"/>
                </p:cNvSpPr>
                <p:nvPr/>
              </p:nvSpPr>
              <p:spPr bwMode="auto">
                <a:xfrm>
                  <a:off x="1035" y="2546"/>
                  <a:ext cx="909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FJ766529 NDV/  ZhJ-3/97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Freeform 79"/>
                <p:cNvSpPr>
                  <a:spLocks/>
                </p:cNvSpPr>
                <p:nvPr/>
              </p:nvSpPr>
              <p:spPr bwMode="auto">
                <a:xfrm>
                  <a:off x="1013" y="2536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Freeform 80"/>
                <p:cNvSpPr>
                  <a:spLocks/>
                </p:cNvSpPr>
                <p:nvPr/>
              </p:nvSpPr>
              <p:spPr bwMode="auto">
                <a:xfrm>
                  <a:off x="787" y="2534"/>
                  <a:ext cx="226" cy="188"/>
                </a:xfrm>
                <a:custGeom>
                  <a:avLst/>
                  <a:gdLst>
                    <a:gd name="T0" fmla="*/ 0 w 226"/>
                    <a:gd name="T1" fmla="*/ 188 h 188"/>
                    <a:gd name="T2" fmla="*/ 0 w 226"/>
                    <a:gd name="T3" fmla="*/ 0 h 188"/>
                    <a:gd name="T4" fmla="*/ 226 w 226"/>
                    <a:gd name="T5" fmla="*/ 0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6" h="188">
                      <a:moveTo>
                        <a:pt x="0" y="188"/>
                      </a:moveTo>
                      <a:lnTo>
                        <a:pt x="0" y="0"/>
                      </a:lnTo>
                      <a:lnTo>
                        <a:pt x="22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6" name="Rectangle 81"/>
                <p:cNvSpPr>
                  <a:spLocks noChangeArrowheads="1"/>
                </p:cNvSpPr>
                <p:nvPr/>
              </p:nvSpPr>
              <p:spPr bwMode="auto">
                <a:xfrm>
                  <a:off x="1338" y="2622"/>
                  <a:ext cx="1534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013038</a:t>
                  </a:r>
                  <a:r>
                    <a:rPr kumimoji="0" lang="en-US" altLang="en-US" sz="1000" b="0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Pigeon/PA/USA/0810/200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7" name="Freeform 82"/>
                <p:cNvSpPr>
                  <a:spLocks/>
                </p:cNvSpPr>
                <p:nvPr/>
              </p:nvSpPr>
              <p:spPr bwMode="auto">
                <a:xfrm>
                  <a:off x="1060" y="2648"/>
                  <a:ext cx="256" cy="36"/>
                </a:xfrm>
                <a:custGeom>
                  <a:avLst/>
                  <a:gdLst>
                    <a:gd name="T0" fmla="*/ 0 w 256"/>
                    <a:gd name="T1" fmla="*/ 36 h 36"/>
                    <a:gd name="T2" fmla="*/ 0 w 256"/>
                    <a:gd name="T3" fmla="*/ 0 h 36"/>
                    <a:gd name="T4" fmla="*/ 256 w 256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6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25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Rectangle 83"/>
                <p:cNvSpPr>
                  <a:spLocks noChangeArrowheads="1"/>
                </p:cNvSpPr>
                <p:nvPr/>
              </p:nvSpPr>
              <p:spPr bwMode="auto">
                <a:xfrm>
                  <a:off x="1375" y="2698"/>
                  <a:ext cx="152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M374060 NDV/ pigeon/Shanghai/215/201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Freeform 84"/>
                <p:cNvSpPr>
                  <a:spLocks/>
                </p:cNvSpPr>
                <p:nvPr/>
              </p:nvSpPr>
              <p:spPr bwMode="auto">
                <a:xfrm>
                  <a:off x="1060" y="2688"/>
                  <a:ext cx="293" cy="36"/>
                </a:xfrm>
                <a:custGeom>
                  <a:avLst/>
                  <a:gdLst>
                    <a:gd name="T0" fmla="*/ 0 w 293"/>
                    <a:gd name="T1" fmla="*/ 0 h 36"/>
                    <a:gd name="T2" fmla="*/ 0 w 293"/>
                    <a:gd name="T3" fmla="*/ 36 h 36"/>
                    <a:gd name="T4" fmla="*/ 293 w 293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3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293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0" name="Freeform 85"/>
                <p:cNvSpPr>
                  <a:spLocks/>
                </p:cNvSpPr>
                <p:nvPr/>
              </p:nvSpPr>
              <p:spPr bwMode="auto">
                <a:xfrm>
                  <a:off x="938" y="2686"/>
                  <a:ext cx="122" cy="74"/>
                </a:xfrm>
                <a:custGeom>
                  <a:avLst/>
                  <a:gdLst>
                    <a:gd name="T0" fmla="*/ 0 w 122"/>
                    <a:gd name="T1" fmla="*/ 74 h 74"/>
                    <a:gd name="T2" fmla="*/ 0 w 122"/>
                    <a:gd name="T3" fmla="*/ 0 h 74"/>
                    <a:gd name="T4" fmla="*/ 122 w 122"/>
                    <a:gd name="T5" fmla="*/ 0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2" h="74">
                      <a:moveTo>
                        <a:pt x="0" y="74"/>
                      </a:moveTo>
                      <a:lnTo>
                        <a:pt x="0" y="0"/>
                      </a:lnTo>
                      <a:lnTo>
                        <a:pt x="12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Rectangle 86"/>
                <p:cNvSpPr>
                  <a:spLocks noChangeArrowheads="1"/>
                </p:cNvSpPr>
                <p:nvPr/>
              </p:nvSpPr>
              <p:spPr bwMode="auto">
                <a:xfrm>
                  <a:off x="1348" y="2774"/>
                  <a:ext cx="1541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013040   </a:t>
                  </a:r>
                  <a:r>
                    <a:rPr lang="en-US" altLang="en-US" sz="10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geon/PA/USA/0712/2007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Freeform 87"/>
                <p:cNvSpPr>
                  <a:spLocks/>
                </p:cNvSpPr>
                <p:nvPr/>
              </p:nvSpPr>
              <p:spPr bwMode="auto">
                <a:xfrm>
                  <a:off x="1157" y="2800"/>
                  <a:ext cx="169" cy="36"/>
                </a:xfrm>
                <a:custGeom>
                  <a:avLst/>
                  <a:gdLst>
                    <a:gd name="T0" fmla="*/ 0 w 169"/>
                    <a:gd name="T1" fmla="*/ 36 h 36"/>
                    <a:gd name="T2" fmla="*/ 0 w 169"/>
                    <a:gd name="T3" fmla="*/ 0 h 36"/>
                    <a:gd name="T4" fmla="*/ 169 w 169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9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169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Rectangle 88"/>
                <p:cNvSpPr>
                  <a:spLocks noChangeArrowheads="1"/>
                </p:cNvSpPr>
                <p:nvPr/>
              </p:nvSpPr>
              <p:spPr bwMode="auto">
                <a:xfrm>
                  <a:off x="1270" y="2849"/>
                  <a:ext cx="158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013031.1(VI)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geon/USA/0101/200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Freeform 89"/>
                <p:cNvSpPr>
                  <a:spLocks/>
                </p:cNvSpPr>
                <p:nvPr/>
              </p:nvSpPr>
              <p:spPr bwMode="auto">
                <a:xfrm>
                  <a:off x="1157" y="2839"/>
                  <a:ext cx="91" cy="37"/>
                </a:xfrm>
                <a:custGeom>
                  <a:avLst/>
                  <a:gdLst>
                    <a:gd name="T0" fmla="*/ 0 w 91"/>
                    <a:gd name="T1" fmla="*/ 0 h 37"/>
                    <a:gd name="T2" fmla="*/ 0 w 91"/>
                    <a:gd name="T3" fmla="*/ 37 h 37"/>
                    <a:gd name="T4" fmla="*/ 91 w 91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1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91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5" name="Freeform 90"/>
                <p:cNvSpPr>
                  <a:spLocks/>
                </p:cNvSpPr>
                <p:nvPr/>
              </p:nvSpPr>
              <p:spPr bwMode="auto">
                <a:xfrm>
                  <a:off x="938" y="2764"/>
                  <a:ext cx="219" cy="74"/>
                </a:xfrm>
                <a:custGeom>
                  <a:avLst/>
                  <a:gdLst>
                    <a:gd name="T0" fmla="*/ 0 w 219"/>
                    <a:gd name="T1" fmla="*/ 0 h 74"/>
                    <a:gd name="T2" fmla="*/ 0 w 219"/>
                    <a:gd name="T3" fmla="*/ 74 h 74"/>
                    <a:gd name="T4" fmla="*/ 219 w 219"/>
                    <a:gd name="T5" fmla="*/ 74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9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219" y="7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6" name="Freeform 91"/>
                <p:cNvSpPr>
                  <a:spLocks/>
                </p:cNvSpPr>
                <p:nvPr/>
              </p:nvSpPr>
              <p:spPr bwMode="auto">
                <a:xfrm>
                  <a:off x="852" y="2762"/>
                  <a:ext cx="86" cy="150"/>
                </a:xfrm>
                <a:custGeom>
                  <a:avLst/>
                  <a:gdLst>
                    <a:gd name="T0" fmla="*/ 0 w 86"/>
                    <a:gd name="T1" fmla="*/ 150 h 150"/>
                    <a:gd name="T2" fmla="*/ 0 w 86"/>
                    <a:gd name="T3" fmla="*/ 0 h 150"/>
                    <a:gd name="T4" fmla="*/ 86 w 86"/>
                    <a:gd name="T5" fmla="*/ 0 h 1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6" h="150">
                      <a:moveTo>
                        <a:pt x="0" y="150"/>
                      </a:moveTo>
                      <a:lnTo>
                        <a:pt x="0" y="0"/>
                      </a:lnTo>
                      <a:lnTo>
                        <a:pt x="8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7" name="Rectangle 92"/>
                <p:cNvSpPr>
                  <a:spLocks noChangeArrowheads="1"/>
                </p:cNvSpPr>
                <p:nvPr/>
              </p:nvSpPr>
              <p:spPr bwMode="auto">
                <a:xfrm>
                  <a:off x="1548" y="2925"/>
                  <a:ext cx="1468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G456676.1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llared dove/Iran/2014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Freeform 93"/>
                <p:cNvSpPr>
                  <a:spLocks/>
                </p:cNvSpPr>
                <p:nvPr/>
              </p:nvSpPr>
              <p:spPr bwMode="auto">
                <a:xfrm>
                  <a:off x="1032" y="2952"/>
                  <a:ext cx="494" cy="36"/>
                </a:xfrm>
                <a:custGeom>
                  <a:avLst/>
                  <a:gdLst>
                    <a:gd name="T0" fmla="*/ 0 w 494"/>
                    <a:gd name="T1" fmla="*/ 36 h 36"/>
                    <a:gd name="T2" fmla="*/ 0 w 494"/>
                    <a:gd name="T3" fmla="*/ 0 h 36"/>
                    <a:gd name="T4" fmla="*/ 494 w 494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94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494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9" name="Rectangle 94"/>
                <p:cNvSpPr>
                  <a:spLocks noChangeArrowheads="1"/>
                </p:cNvSpPr>
                <p:nvPr/>
              </p:nvSpPr>
              <p:spPr bwMode="auto">
                <a:xfrm>
                  <a:off x="1477" y="3001"/>
                  <a:ext cx="179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X236100.2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geon/Pakistan/Lahore/21A/201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0" name="Freeform 95"/>
                <p:cNvSpPr>
                  <a:spLocks/>
                </p:cNvSpPr>
                <p:nvPr/>
              </p:nvSpPr>
              <p:spPr bwMode="auto">
                <a:xfrm>
                  <a:off x="1032" y="2991"/>
                  <a:ext cx="423" cy="37"/>
                </a:xfrm>
                <a:custGeom>
                  <a:avLst/>
                  <a:gdLst>
                    <a:gd name="T0" fmla="*/ 0 w 423"/>
                    <a:gd name="T1" fmla="*/ 0 h 37"/>
                    <a:gd name="T2" fmla="*/ 0 w 423"/>
                    <a:gd name="T3" fmla="*/ 37 h 37"/>
                    <a:gd name="T4" fmla="*/ 423 w 423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23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423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Freeform 96"/>
                <p:cNvSpPr>
                  <a:spLocks/>
                </p:cNvSpPr>
                <p:nvPr/>
              </p:nvSpPr>
              <p:spPr bwMode="auto">
                <a:xfrm>
                  <a:off x="1010" y="2990"/>
                  <a:ext cx="22" cy="74"/>
                </a:xfrm>
                <a:custGeom>
                  <a:avLst/>
                  <a:gdLst>
                    <a:gd name="T0" fmla="*/ 0 w 22"/>
                    <a:gd name="T1" fmla="*/ 74 h 74"/>
                    <a:gd name="T2" fmla="*/ 0 w 22"/>
                    <a:gd name="T3" fmla="*/ 0 h 74"/>
                    <a:gd name="T4" fmla="*/ 22 w 22"/>
                    <a:gd name="T5" fmla="*/ 0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" h="74">
                      <a:moveTo>
                        <a:pt x="0" y="74"/>
                      </a:moveTo>
                      <a:lnTo>
                        <a:pt x="0" y="0"/>
                      </a:lnTo>
                      <a:lnTo>
                        <a:pt x="2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2" name="Rectangle 97"/>
                <p:cNvSpPr>
                  <a:spLocks noChangeArrowheads="1"/>
                </p:cNvSpPr>
                <p:nvPr/>
              </p:nvSpPr>
              <p:spPr bwMode="auto">
                <a:xfrm>
                  <a:off x="1344" y="3077"/>
                  <a:ext cx="1412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F827026.1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us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Vladimir/687/0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3" name="Freeform 98"/>
                <p:cNvSpPr>
                  <a:spLocks/>
                </p:cNvSpPr>
                <p:nvPr/>
              </p:nvSpPr>
              <p:spPr bwMode="auto">
                <a:xfrm>
                  <a:off x="1267" y="3104"/>
                  <a:ext cx="55" cy="36"/>
                </a:xfrm>
                <a:custGeom>
                  <a:avLst/>
                  <a:gdLst>
                    <a:gd name="T0" fmla="*/ 0 w 55"/>
                    <a:gd name="T1" fmla="*/ 36 h 36"/>
                    <a:gd name="T2" fmla="*/ 0 w 55"/>
                    <a:gd name="T3" fmla="*/ 0 h 36"/>
                    <a:gd name="T4" fmla="*/ 55 w 55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5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55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4" name="Rectangle 99"/>
                <p:cNvSpPr>
                  <a:spLocks noChangeArrowheads="1"/>
                </p:cNvSpPr>
                <p:nvPr/>
              </p:nvSpPr>
              <p:spPr bwMode="auto">
                <a:xfrm>
                  <a:off x="1382" y="3153"/>
                  <a:ext cx="1766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042128 </a:t>
                  </a:r>
                  <a:r>
                    <a:rPr lang="en-US" altLang="en-US" sz="10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geon/Ukraine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oneck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3/968/2007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5" name="Freeform 100"/>
                <p:cNvSpPr>
                  <a:spLocks/>
                </p:cNvSpPr>
                <p:nvPr/>
              </p:nvSpPr>
              <p:spPr bwMode="auto">
                <a:xfrm>
                  <a:off x="1267" y="3143"/>
                  <a:ext cx="93" cy="37"/>
                </a:xfrm>
                <a:custGeom>
                  <a:avLst/>
                  <a:gdLst>
                    <a:gd name="T0" fmla="*/ 0 w 93"/>
                    <a:gd name="T1" fmla="*/ 0 h 37"/>
                    <a:gd name="T2" fmla="*/ 0 w 93"/>
                    <a:gd name="T3" fmla="*/ 37 h 37"/>
                    <a:gd name="T4" fmla="*/ 93 w 93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3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93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Freeform 101"/>
                <p:cNvSpPr>
                  <a:spLocks/>
                </p:cNvSpPr>
                <p:nvPr/>
              </p:nvSpPr>
              <p:spPr bwMode="auto">
                <a:xfrm>
                  <a:off x="1010" y="3067"/>
                  <a:ext cx="257" cy="75"/>
                </a:xfrm>
                <a:custGeom>
                  <a:avLst/>
                  <a:gdLst>
                    <a:gd name="T0" fmla="*/ 0 w 257"/>
                    <a:gd name="T1" fmla="*/ 0 h 75"/>
                    <a:gd name="T2" fmla="*/ 0 w 257"/>
                    <a:gd name="T3" fmla="*/ 75 h 75"/>
                    <a:gd name="T4" fmla="*/ 257 w 257"/>
                    <a:gd name="T5" fmla="*/ 75 h 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7" h="75">
                      <a:moveTo>
                        <a:pt x="0" y="0"/>
                      </a:moveTo>
                      <a:lnTo>
                        <a:pt x="0" y="75"/>
                      </a:lnTo>
                      <a:lnTo>
                        <a:pt x="257" y="7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7" name="Freeform 102"/>
                <p:cNvSpPr>
                  <a:spLocks/>
                </p:cNvSpPr>
                <p:nvPr/>
              </p:nvSpPr>
              <p:spPr bwMode="auto">
                <a:xfrm>
                  <a:off x="852" y="2915"/>
                  <a:ext cx="158" cy="151"/>
                </a:xfrm>
                <a:custGeom>
                  <a:avLst/>
                  <a:gdLst>
                    <a:gd name="T0" fmla="*/ 0 w 158"/>
                    <a:gd name="T1" fmla="*/ 0 h 151"/>
                    <a:gd name="T2" fmla="*/ 0 w 158"/>
                    <a:gd name="T3" fmla="*/ 151 h 151"/>
                    <a:gd name="T4" fmla="*/ 158 w 158"/>
                    <a:gd name="T5" fmla="*/ 151 h 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8" h="151">
                      <a:moveTo>
                        <a:pt x="0" y="0"/>
                      </a:moveTo>
                      <a:lnTo>
                        <a:pt x="0" y="151"/>
                      </a:lnTo>
                      <a:lnTo>
                        <a:pt x="158" y="151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Freeform 103"/>
                <p:cNvSpPr>
                  <a:spLocks/>
                </p:cNvSpPr>
                <p:nvPr/>
              </p:nvSpPr>
              <p:spPr bwMode="auto">
                <a:xfrm>
                  <a:off x="787" y="2726"/>
                  <a:ext cx="65" cy="188"/>
                </a:xfrm>
                <a:custGeom>
                  <a:avLst/>
                  <a:gdLst>
                    <a:gd name="T0" fmla="*/ 0 w 65"/>
                    <a:gd name="T1" fmla="*/ 0 h 188"/>
                    <a:gd name="T2" fmla="*/ 0 w 65"/>
                    <a:gd name="T3" fmla="*/ 188 h 188"/>
                    <a:gd name="T4" fmla="*/ 65 w 65"/>
                    <a:gd name="T5" fmla="*/ 188 h 1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" h="188">
                      <a:moveTo>
                        <a:pt x="0" y="0"/>
                      </a:moveTo>
                      <a:lnTo>
                        <a:pt x="0" y="188"/>
                      </a:lnTo>
                      <a:lnTo>
                        <a:pt x="65" y="188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Freeform 104"/>
                <p:cNvSpPr>
                  <a:spLocks/>
                </p:cNvSpPr>
                <p:nvPr/>
              </p:nvSpPr>
              <p:spPr bwMode="auto">
                <a:xfrm>
                  <a:off x="686" y="2357"/>
                  <a:ext cx="101" cy="367"/>
                </a:xfrm>
                <a:custGeom>
                  <a:avLst/>
                  <a:gdLst>
                    <a:gd name="T0" fmla="*/ 0 w 101"/>
                    <a:gd name="T1" fmla="*/ 0 h 367"/>
                    <a:gd name="T2" fmla="*/ 0 w 101"/>
                    <a:gd name="T3" fmla="*/ 367 h 367"/>
                    <a:gd name="T4" fmla="*/ 101 w 101"/>
                    <a:gd name="T5" fmla="*/ 367 h 3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1" h="367">
                      <a:moveTo>
                        <a:pt x="0" y="0"/>
                      </a:moveTo>
                      <a:lnTo>
                        <a:pt x="0" y="367"/>
                      </a:lnTo>
                      <a:lnTo>
                        <a:pt x="101" y="36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" name="Freeform 105"/>
                <p:cNvSpPr>
                  <a:spLocks/>
                </p:cNvSpPr>
                <p:nvPr/>
              </p:nvSpPr>
              <p:spPr bwMode="auto">
                <a:xfrm>
                  <a:off x="536" y="2355"/>
                  <a:ext cx="150" cy="513"/>
                </a:xfrm>
                <a:custGeom>
                  <a:avLst/>
                  <a:gdLst>
                    <a:gd name="T0" fmla="*/ 0 w 150"/>
                    <a:gd name="T1" fmla="*/ 513 h 513"/>
                    <a:gd name="T2" fmla="*/ 0 w 150"/>
                    <a:gd name="T3" fmla="*/ 0 h 513"/>
                    <a:gd name="T4" fmla="*/ 150 w 150"/>
                    <a:gd name="T5" fmla="*/ 0 h 5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0" h="513">
                      <a:moveTo>
                        <a:pt x="0" y="513"/>
                      </a:moveTo>
                      <a:lnTo>
                        <a:pt x="0" y="0"/>
                      </a:lnTo>
                      <a:lnTo>
                        <a:pt x="15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1" name="Rectangle 106"/>
                <p:cNvSpPr>
                  <a:spLocks noChangeArrowheads="1"/>
                </p:cNvSpPr>
                <p:nvPr/>
              </p:nvSpPr>
              <p:spPr bwMode="auto">
                <a:xfrm>
                  <a:off x="1298" y="3229"/>
                  <a:ext cx="116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EF065682.1(XIX)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nhinga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Freeform 107"/>
                <p:cNvSpPr>
                  <a:spLocks/>
                </p:cNvSpPr>
                <p:nvPr/>
              </p:nvSpPr>
              <p:spPr bwMode="auto">
                <a:xfrm>
                  <a:off x="1276" y="3256"/>
                  <a:ext cx="0" cy="36"/>
                </a:xfrm>
                <a:custGeom>
                  <a:avLst/>
                  <a:gdLst>
                    <a:gd name="T0" fmla="*/ 36 h 36"/>
                    <a:gd name="T1" fmla="*/ 0 h 36"/>
                    <a:gd name="T2" fmla="*/ 0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3" name="Rectangle 108"/>
                <p:cNvSpPr>
                  <a:spLocks noChangeArrowheads="1"/>
                </p:cNvSpPr>
                <p:nvPr/>
              </p:nvSpPr>
              <p:spPr bwMode="auto">
                <a:xfrm>
                  <a:off x="1298" y="3305"/>
                  <a:ext cx="114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EF065682.1(XIX) </a:t>
                  </a:r>
                  <a:r>
                    <a:rPr lang="en-US" altLang="en-US" sz="10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Anhinga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4" name="Freeform 109"/>
                <p:cNvSpPr>
                  <a:spLocks/>
                </p:cNvSpPr>
                <p:nvPr/>
              </p:nvSpPr>
              <p:spPr bwMode="auto">
                <a:xfrm>
                  <a:off x="1276" y="3295"/>
                  <a:ext cx="0" cy="37"/>
                </a:xfrm>
                <a:custGeom>
                  <a:avLst/>
                  <a:gdLst>
                    <a:gd name="T0" fmla="*/ 0 h 37"/>
                    <a:gd name="T1" fmla="*/ 37 h 37"/>
                    <a:gd name="T2" fmla="*/ 37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0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5" name="Freeform 110"/>
                <p:cNvSpPr>
                  <a:spLocks/>
                </p:cNvSpPr>
                <p:nvPr/>
              </p:nvSpPr>
              <p:spPr bwMode="auto">
                <a:xfrm>
                  <a:off x="861" y="3294"/>
                  <a:ext cx="415" cy="88"/>
                </a:xfrm>
                <a:custGeom>
                  <a:avLst/>
                  <a:gdLst>
                    <a:gd name="T0" fmla="*/ 0 w 415"/>
                    <a:gd name="T1" fmla="*/ 88 h 88"/>
                    <a:gd name="T2" fmla="*/ 0 w 415"/>
                    <a:gd name="T3" fmla="*/ 0 h 88"/>
                    <a:gd name="T4" fmla="*/ 415 w 415"/>
                    <a:gd name="T5" fmla="*/ 0 h 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15" h="88">
                      <a:moveTo>
                        <a:pt x="0" y="88"/>
                      </a:moveTo>
                      <a:lnTo>
                        <a:pt x="0" y="0"/>
                      </a:lnTo>
                      <a:lnTo>
                        <a:pt x="415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6" name="Rectangle 111"/>
                <p:cNvSpPr>
                  <a:spLocks noChangeArrowheads="1"/>
                </p:cNvSpPr>
                <p:nvPr/>
              </p:nvSpPr>
              <p:spPr bwMode="auto">
                <a:xfrm>
                  <a:off x="942" y="3381"/>
                  <a:ext cx="145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lvl="0"/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Q247691.1(V) </a:t>
                  </a:r>
                  <a:r>
                    <a:rPr lang="en-US" altLang="en-US" sz="1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icken/Ca/2098/7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7" name="Freeform 112"/>
                <p:cNvSpPr>
                  <a:spLocks/>
                </p:cNvSpPr>
                <p:nvPr/>
              </p:nvSpPr>
              <p:spPr bwMode="auto">
                <a:xfrm>
                  <a:off x="879" y="3408"/>
                  <a:ext cx="41" cy="64"/>
                </a:xfrm>
                <a:custGeom>
                  <a:avLst/>
                  <a:gdLst>
                    <a:gd name="T0" fmla="*/ 0 w 41"/>
                    <a:gd name="T1" fmla="*/ 64 h 64"/>
                    <a:gd name="T2" fmla="*/ 0 w 41"/>
                    <a:gd name="T3" fmla="*/ 0 h 64"/>
                    <a:gd name="T4" fmla="*/ 41 w 41"/>
                    <a:gd name="T5" fmla="*/ 0 h 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1" h="64">
                      <a:moveTo>
                        <a:pt x="0" y="64"/>
                      </a:moveTo>
                      <a:lnTo>
                        <a:pt x="0" y="0"/>
                      </a:lnTo>
                      <a:lnTo>
                        <a:pt x="41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Rectangle 113"/>
                <p:cNvSpPr>
                  <a:spLocks noChangeArrowheads="1"/>
                </p:cNvSpPr>
                <p:nvPr/>
              </p:nvSpPr>
              <p:spPr bwMode="auto">
                <a:xfrm>
                  <a:off x="1059" y="3457"/>
                  <a:ext cx="93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M117720.1(V) NDV-P0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9" name="Freeform 114"/>
                <p:cNvSpPr>
                  <a:spLocks/>
                </p:cNvSpPr>
                <p:nvPr/>
              </p:nvSpPr>
              <p:spPr bwMode="auto">
                <a:xfrm>
                  <a:off x="937" y="3483"/>
                  <a:ext cx="100" cy="56"/>
                </a:xfrm>
                <a:custGeom>
                  <a:avLst/>
                  <a:gdLst>
                    <a:gd name="T0" fmla="*/ 0 w 100"/>
                    <a:gd name="T1" fmla="*/ 56 h 56"/>
                    <a:gd name="T2" fmla="*/ 0 w 100"/>
                    <a:gd name="T3" fmla="*/ 0 h 56"/>
                    <a:gd name="T4" fmla="*/ 100 w 100"/>
                    <a:gd name="T5" fmla="*/ 0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0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0" name="Rectangle 115"/>
                <p:cNvSpPr>
                  <a:spLocks noChangeArrowheads="1"/>
                </p:cNvSpPr>
                <p:nvPr/>
              </p:nvSpPr>
              <p:spPr bwMode="auto">
                <a:xfrm>
                  <a:off x="969" y="3533"/>
                  <a:ext cx="127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J577136.1(V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imalhuacan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1" name="Freeform 116"/>
                <p:cNvSpPr>
                  <a:spLocks/>
                </p:cNvSpPr>
                <p:nvPr/>
              </p:nvSpPr>
              <p:spPr bwMode="auto">
                <a:xfrm>
                  <a:off x="947" y="3559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2" name="Rectangle 117"/>
                <p:cNvSpPr>
                  <a:spLocks noChangeArrowheads="1"/>
                </p:cNvSpPr>
                <p:nvPr/>
              </p:nvSpPr>
              <p:spPr bwMode="auto">
                <a:xfrm>
                  <a:off x="969" y="3609"/>
                  <a:ext cx="1340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J577136.1(V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imalhuacan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)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Freeform 118"/>
                <p:cNvSpPr>
                  <a:spLocks/>
                </p:cNvSpPr>
                <p:nvPr/>
              </p:nvSpPr>
              <p:spPr bwMode="auto">
                <a:xfrm>
                  <a:off x="947" y="3599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4" name="Freeform 119"/>
                <p:cNvSpPr>
                  <a:spLocks/>
                </p:cNvSpPr>
                <p:nvPr/>
              </p:nvSpPr>
              <p:spPr bwMode="auto">
                <a:xfrm>
                  <a:off x="937" y="3542"/>
                  <a:ext cx="10" cy="55"/>
                </a:xfrm>
                <a:custGeom>
                  <a:avLst/>
                  <a:gdLst>
                    <a:gd name="T0" fmla="*/ 0 w 10"/>
                    <a:gd name="T1" fmla="*/ 0 h 55"/>
                    <a:gd name="T2" fmla="*/ 0 w 10"/>
                    <a:gd name="T3" fmla="*/ 55 h 55"/>
                    <a:gd name="T4" fmla="*/ 10 w 10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10" y="5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5" name="Freeform 120"/>
                <p:cNvSpPr>
                  <a:spLocks/>
                </p:cNvSpPr>
                <p:nvPr/>
              </p:nvSpPr>
              <p:spPr bwMode="auto">
                <a:xfrm>
                  <a:off x="879" y="3476"/>
                  <a:ext cx="58" cy="64"/>
                </a:xfrm>
                <a:custGeom>
                  <a:avLst/>
                  <a:gdLst>
                    <a:gd name="T0" fmla="*/ 0 w 58"/>
                    <a:gd name="T1" fmla="*/ 0 h 64"/>
                    <a:gd name="T2" fmla="*/ 0 w 58"/>
                    <a:gd name="T3" fmla="*/ 64 h 64"/>
                    <a:gd name="T4" fmla="*/ 58 w 58"/>
                    <a:gd name="T5" fmla="*/ 64 h 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" h="64">
                      <a:moveTo>
                        <a:pt x="0" y="0"/>
                      </a:moveTo>
                      <a:lnTo>
                        <a:pt x="0" y="64"/>
                      </a:lnTo>
                      <a:lnTo>
                        <a:pt x="58" y="6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6" name="Freeform 121"/>
                <p:cNvSpPr>
                  <a:spLocks/>
                </p:cNvSpPr>
                <p:nvPr/>
              </p:nvSpPr>
              <p:spPr bwMode="auto">
                <a:xfrm>
                  <a:off x="861" y="3385"/>
                  <a:ext cx="18" cy="89"/>
                </a:xfrm>
                <a:custGeom>
                  <a:avLst/>
                  <a:gdLst>
                    <a:gd name="T0" fmla="*/ 0 w 18"/>
                    <a:gd name="T1" fmla="*/ 0 h 89"/>
                    <a:gd name="T2" fmla="*/ 0 w 18"/>
                    <a:gd name="T3" fmla="*/ 89 h 89"/>
                    <a:gd name="T4" fmla="*/ 18 w 18"/>
                    <a:gd name="T5" fmla="*/ 89 h 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" h="89">
                      <a:moveTo>
                        <a:pt x="0" y="0"/>
                      </a:moveTo>
                      <a:lnTo>
                        <a:pt x="0" y="89"/>
                      </a:lnTo>
                      <a:lnTo>
                        <a:pt x="18" y="89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Freeform 122"/>
                <p:cNvSpPr>
                  <a:spLocks/>
                </p:cNvSpPr>
                <p:nvPr/>
              </p:nvSpPr>
              <p:spPr bwMode="auto">
                <a:xfrm>
                  <a:off x="536" y="2871"/>
                  <a:ext cx="325" cy="513"/>
                </a:xfrm>
                <a:custGeom>
                  <a:avLst/>
                  <a:gdLst>
                    <a:gd name="T0" fmla="*/ 0 w 325"/>
                    <a:gd name="T1" fmla="*/ 0 h 513"/>
                    <a:gd name="T2" fmla="*/ 0 w 325"/>
                    <a:gd name="T3" fmla="*/ 513 h 513"/>
                    <a:gd name="T4" fmla="*/ 325 w 325"/>
                    <a:gd name="T5" fmla="*/ 513 h 5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25" h="513">
                      <a:moveTo>
                        <a:pt x="0" y="0"/>
                      </a:moveTo>
                      <a:lnTo>
                        <a:pt x="0" y="513"/>
                      </a:lnTo>
                      <a:lnTo>
                        <a:pt x="325" y="513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8" name="Freeform 123"/>
                <p:cNvSpPr>
                  <a:spLocks/>
                </p:cNvSpPr>
                <p:nvPr/>
              </p:nvSpPr>
              <p:spPr bwMode="auto">
                <a:xfrm>
                  <a:off x="510" y="2870"/>
                  <a:ext cx="26" cy="419"/>
                </a:xfrm>
                <a:custGeom>
                  <a:avLst/>
                  <a:gdLst>
                    <a:gd name="T0" fmla="*/ 0 w 26"/>
                    <a:gd name="T1" fmla="*/ 419 h 419"/>
                    <a:gd name="T2" fmla="*/ 0 w 26"/>
                    <a:gd name="T3" fmla="*/ 0 h 419"/>
                    <a:gd name="T4" fmla="*/ 26 w 26"/>
                    <a:gd name="T5" fmla="*/ 0 h 4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6" h="419">
                      <a:moveTo>
                        <a:pt x="0" y="419"/>
                      </a:moveTo>
                      <a:lnTo>
                        <a:pt x="0" y="0"/>
                      </a:lnTo>
                      <a:lnTo>
                        <a:pt x="2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Rectangle 124"/>
                <p:cNvSpPr>
                  <a:spLocks noChangeArrowheads="1"/>
                </p:cNvSpPr>
                <p:nvPr/>
              </p:nvSpPr>
              <p:spPr bwMode="auto">
                <a:xfrm>
                  <a:off x="808" y="3685"/>
                  <a:ext cx="120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X012096.2(VIII) NDV/  AF2240-I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Freeform 125"/>
                <p:cNvSpPr>
                  <a:spLocks/>
                </p:cNvSpPr>
                <p:nvPr/>
              </p:nvSpPr>
              <p:spPr bwMode="auto">
                <a:xfrm>
                  <a:off x="510" y="3292"/>
                  <a:ext cx="276" cy="419"/>
                </a:xfrm>
                <a:custGeom>
                  <a:avLst/>
                  <a:gdLst>
                    <a:gd name="T0" fmla="*/ 0 w 276"/>
                    <a:gd name="T1" fmla="*/ 0 h 419"/>
                    <a:gd name="T2" fmla="*/ 0 w 276"/>
                    <a:gd name="T3" fmla="*/ 419 h 419"/>
                    <a:gd name="T4" fmla="*/ 276 w 276"/>
                    <a:gd name="T5" fmla="*/ 419 h 4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6" h="419">
                      <a:moveTo>
                        <a:pt x="0" y="0"/>
                      </a:moveTo>
                      <a:lnTo>
                        <a:pt x="0" y="419"/>
                      </a:lnTo>
                      <a:lnTo>
                        <a:pt x="276" y="419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Freeform 126"/>
                <p:cNvSpPr>
                  <a:spLocks/>
                </p:cNvSpPr>
                <p:nvPr/>
              </p:nvSpPr>
              <p:spPr bwMode="auto">
                <a:xfrm>
                  <a:off x="433" y="3290"/>
                  <a:ext cx="77" cy="266"/>
                </a:xfrm>
                <a:custGeom>
                  <a:avLst/>
                  <a:gdLst>
                    <a:gd name="T0" fmla="*/ 0 w 77"/>
                    <a:gd name="T1" fmla="*/ 266 h 266"/>
                    <a:gd name="T2" fmla="*/ 0 w 77"/>
                    <a:gd name="T3" fmla="*/ 0 h 266"/>
                    <a:gd name="T4" fmla="*/ 77 w 77"/>
                    <a:gd name="T5" fmla="*/ 0 h 2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7" h="266">
                      <a:moveTo>
                        <a:pt x="0" y="266"/>
                      </a:moveTo>
                      <a:lnTo>
                        <a:pt x="0" y="0"/>
                      </a:lnTo>
                      <a:lnTo>
                        <a:pt x="77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2" name="Rectangle 127"/>
                <p:cNvSpPr>
                  <a:spLocks noChangeArrowheads="1"/>
                </p:cNvSpPr>
                <p:nvPr/>
              </p:nvSpPr>
              <p:spPr bwMode="auto">
                <a:xfrm>
                  <a:off x="1507" y="3761"/>
                  <a:ext cx="1794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X119193.1</a:t>
                  </a:r>
                  <a:r>
                    <a:rPr kumimoji="0" lang="en-US" altLang="en-US" sz="1000" b="0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chicken/Dom.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pub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499-31/200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3" name="Freeform 128"/>
                <p:cNvSpPr>
                  <a:spLocks/>
                </p:cNvSpPr>
                <p:nvPr/>
              </p:nvSpPr>
              <p:spPr bwMode="auto">
                <a:xfrm>
                  <a:off x="1485" y="3787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Rectangle 129"/>
                <p:cNvSpPr>
                  <a:spLocks noChangeArrowheads="1"/>
                </p:cNvSpPr>
                <p:nvPr/>
              </p:nvSpPr>
              <p:spPr bwMode="auto">
                <a:xfrm>
                  <a:off x="1507" y="3837"/>
                  <a:ext cx="1754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X119193.</a:t>
                  </a:r>
                  <a:r>
                    <a:rPr kumimoji="0" lang="en-US" altLang="en-US" sz="1000" b="0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V/chicken/Dom.</a:t>
                  </a:r>
                  <a:r>
                    <a:rPr kumimoji="0" lang="en-US" altLang="en-US" sz="1000" b="0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pub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499-31/2008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5" name="Freeform 130"/>
                <p:cNvSpPr>
                  <a:spLocks/>
                </p:cNvSpPr>
                <p:nvPr/>
              </p:nvSpPr>
              <p:spPr bwMode="auto">
                <a:xfrm>
                  <a:off x="1485" y="3827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Freeform 131"/>
                <p:cNvSpPr>
                  <a:spLocks/>
                </p:cNvSpPr>
                <p:nvPr/>
              </p:nvSpPr>
              <p:spPr bwMode="auto">
                <a:xfrm>
                  <a:off x="433" y="3559"/>
                  <a:ext cx="1052" cy="266"/>
                </a:xfrm>
                <a:custGeom>
                  <a:avLst/>
                  <a:gdLst>
                    <a:gd name="T0" fmla="*/ 0 w 1052"/>
                    <a:gd name="T1" fmla="*/ 0 h 266"/>
                    <a:gd name="T2" fmla="*/ 0 w 1052"/>
                    <a:gd name="T3" fmla="*/ 266 h 266"/>
                    <a:gd name="T4" fmla="*/ 1052 w 1052"/>
                    <a:gd name="T5" fmla="*/ 266 h 26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52" h="266">
                      <a:moveTo>
                        <a:pt x="0" y="0"/>
                      </a:moveTo>
                      <a:lnTo>
                        <a:pt x="0" y="266"/>
                      </a:lnTo>
                      <a:lnTo>
                        <a:pt x="1052" y="26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Freeform 132"/>
                <p:cNvSpPr>
                  <a:spLocks/>
                </p:cNvSpPr>
                <p:nvPr/>
              </p:nvSpPr>
              <p:spPr bwMode="auto">
                <a:xfrm>
                  <a:off x="327" y="3558"/>
                  <a:ext cx="106" cy="439"/>
                </a:xfrm>
                <a:custGeom>
                  <a:avLst/>
                  <a:gdLst>
                    <a:gd name="T0" fmla="*/ 0 w 106"/>
                    <a:gd name="T1" fmla="*/ 439 h 439"/>
                    <a:gd name="T2" fmla="*/ 0 w 106"/>
                    <a:gd name="T3" fmla="*/ 0 h 439"/>
                    <a:gd name="T4" fmla="*/ 106 w 106"/>
                    <a:gd name="T5" fmla="*/ 0 h 4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439">
                      <a:moveTo>
                        <a:pt x="0" y="439"/>
                      </a:moveTo>
                      <a:lnTo>
                        <a:pt x="0" y="0"/>
                      </a:lnTo>
                      <a:lnTo>
                        <a:pt x="10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Rectangle 133"/>
                <p:cNvSpPr>
                  <a:spLocks noChangeArrowheads="1"/>
                </p:cNvSpPr>
                <p:nvPr/>
              </p:nvSpPr>
              <p:spPr bwMode="auto">
                <a:xfrm>
                  <a:off x="651" y="3913"/>
                  <a:ext cx="105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EU293914.1(IV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talien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9" name="Freeform 134"/>
                <p:cNvSpPr>
                  <a:spLocks/>
                </p:cNvSpPr>
                <p:nvPr/>
              </p:nvSpPr>
              <p:spPr bwMode="auto">
                <a:xfrm>
                  <a:off x="629" y="3939"/>
                  <a:ext cx="0" cy="37"/>
                </a:xfrm>
                <a:custGeom>
                  <a:avLst/>
                  <a:gdLst>
                    <a:gd name="T0" fmla="*/ 37 h 37"/>
                    <a:gd name="T1" fmla="*/ 0 h 37"/>
                    <a:gd name="T2" fmla="*/ 0 h 3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Rectangle 135"/>
                <p:cNvSpPr>
                  <a:spLocks noChangeArrowheads="1"/>
                </p:cNvSpPr>
                <p:nvPr/>
              </p:nvSpPr>
              <p:spPr bwMode="auto">
                <a:xfrm>
                  <a:off x="651" y="3989"/>
                  <a:ext cx="1057" cy="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EU293914.1(IV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talien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1" name="Freeform 136"/>
                <p:cNvSpPr>
                  <a:spLocks/>
                </p:cNvSpPr>
                <p:nvPr/>
              </p:nvSpPr>
              <p:spPr bwMode="auto">
                <a:xfrm>
                  <a:off x="629" y="3979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Freeform 137"/>
                <p:cNvSpPr>
                  <a:spLocks/>
                </p:cNvSpPr>
                <p:nvPr/>
              </p:nvSpPr>
              <p:spPr bwMode="auto">
                <a:xfrm>
                  <a:off x="581" y="3977"/>
                  <a:ext cx="48" cy="55"/>
                </a:xfrm>
                <a:custGeom>
                  <a:avLst/>
                  <a:gdLst>
                    <a:gd name="T0" fmla="*/ 0 w 48"/>
                    <a:gd name="T1" fmla="*/ 55 h 55"/>
                    <a:gd name="T2" fmla="*/ 0 w 48"/>
                    <a:gd name="T3" fmla="*/ 0 h 55"/>
                    <a:gd name="T4" fmla="*/ 48 w 48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8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4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Rectangle 138"/>
                <p:cNvSpPr>
                  <a:spLocks noChangeArrowheads="1"/>
                </p:cNvSpPr>
                <p:nvPr/>
              </p:nvSpPr>
              <p:spPr bwMode="auto">
                <a:xfrm>
                  <a:off x="703" y="4065"/>
                  <a:ext cx="113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Y741404.1(IV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erts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33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Freeform 139"/>
                <p:cNvSpPr>
                  <a:spLocks/>
                </p:cNvSpPr>
                <p:nvPr/>
              </p:nvSpPr>
              <p:spPr bwMode="auto">
                <a:xfrm>
                  <a:off x="581" y="4036"/>
                  <a:ext cx="100" cy="55"/>
                </a:xfrm>
                <a:custGeom>
                  <a:avLst/>
                  <a:gdLst>
                    <a:gd name="T0" fmla="*/ 0 w 100"/>
                    <a:gd name="T1" fmla="*/ 0 h 55"/>
                    <a:gd name="T2" fmla="*/ 0 w 100"/>
                    <a:gd name="T3" fmla="*/ 55 h 55"/>
                    <a:gd name="T4" fmla="*/ 100 w 100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0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100" y="5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5" name="Freeform 140"/>
                <p:cNvSpPr>
                  <a:spLocks/>
                </p:cNvSpPr>
                <p:nvPr/>
              </p:nvSpPr>
              <p:spPr bwMode="auto">
                <a:xfrm>
                  <a:off x="569" y="4034"/>
                  <a:ext cx="12" cy="84"/>
                </a:xfrm>
                <a:custGeom>
                  <a:avLst/>
                  <a:gdLst>
                    <a:gd name="T0" fmla="*/ 0 w 12"/>
                    <a:gd name="T1" fmla="*/ 84 h 84"/>
                    <a:gd name="T2" fmla="*/ 0 w 12"/>
                    <a:gd name="T3" fmla="*/ 0 h 84"/>
                    <a:gd name="T4" fmla="*/ 12 w 12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1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6" name="Rectangle 141"/>
                <p:cNvSpPr>
                  <a:spLocks noChangeArrowheads="1"/>
                </p:cNvSpPr>
                <p:nvPr/>
              </p:nvSpPr>
              <p:spPr bwMode="auto">
                <a:xfrm>
                  <a:off x="1610" y="4141"/>
                  <a:ext cx="119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Q266602.1(XI) NDV/MG 725 08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7" name="Freeform 142"/>
                <p:cNvSpPr>
                  <a:spLocks/>
                </p:cNvSpPr>
                <p:nvPr/>
              </p:nvSpPr>
              <p:spPr bwMode="auto">
                <a:xfrm>
                  <a:off x="1587" y="4167"/>
                  <a:ext cx="0" cy="36"/>
                </a:xfrm>
                <a:custGeom>
                  <a:avLst/>
                  <a:gdLst>
                    <a:gd name="T0" fmla="*/ 36 h 36"/>
                    <a:gd name="T1" fmla="*/ 0 h 36"/>
                    <a:gd name="T2" fmla="*/ 0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Rectangle 143"/>
                <p:cNvSpPr>
                  <a:spLocks noChangeArrowheads="1"/>
                </p:cNvSpPr>
                <p:nvPr/>
              </p:nvSpPr>
              <p:spPr bwMode="auto">
                <a:xfrm>
                  <a:off x="1610" y="4216"/>
                  <a:ext cx="132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HQ266602.1(XI) NDV/  MG 725 08 (2)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Freeform 144"/>
                <p:cNvSpPr>
                  <a:spLocks/>
                </p:cNvSpPr>
                <p:nvPr/>
              </p:nvSpPr>
              <p:spPr bwMode="auto">
                <a:xfrm>
                  <a:off x="1587" y="4207"/>
                  <a:ext cx="0" cy="36"/>
                </a:xfrm>
                <a:custGeom>
                  <a:avLst/>
                  <a:gdLst>
                    <a:gd name="T0" fmla="*/ 0 h 36"/>
                    <a:gd name="T1" fmla="*/ 36 h 36"/>
                    <a:gd name="T2" fmla="*/ 36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0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Freeform 145"/>
                <p:cNvSpPr>
                  <a:spLocks/>
                </p:cNvSpPr>
                <p:nvPr/>
              </p:nvSpPr>
              <p:spPr bwMode="auto">
                <a:xfrm>
                  <a:off x="569" y="4121"/>
                  <a:ext cx="1018" cy="84"/>
                </a:xfrm>
                <a:custGeom>
                  <a:avLst/>
                  <a:gdLst>
                    <a:gd name="T0" fmla="*/ 0 w 1018"/>
                    <a:gd name="T1" fmla="*/ 0 h 84"/>
                    <a:gd name="T2" fmla="*/ 0 w 1018"/>
                    <a:gd name="T3" fmla="*/ 84 h 84"/>
                    <a:gd name="T4" fmla="*/ 1018 w 1018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18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1018" y="8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Freeform 146"/>
                <p:cNvSpPr>
                  <a:spLocks/>
                </p:cNvSpPr>
                <p:nvPr/>
              </p:nvSpPr>
              <p:spPr bwMode="auto">
                <a:xfrm>
                  <a:off x="431" y="4120"/>
                  <a:ext cx="138" cy="318"/>
                </a:xfrm>
                <a:custGeom>
                  <a:avLst/>
                  <a:gdLst>
                    <a:gd name="T0" fmla="*/ 0 w 138"/>
                    <a:gd name="T1" fmla="*/ 318 h 318"/>
                    <a:gd name="T2" fmla="*/ 0 w 138"/>
                    <a:gd name="T3" fmla="*/ 0 h 318"/>
                    <a:gd name="T4" fmla="*/ 138 w 138"/>
                    <a:gd name="T5" fmla="*/ 0 h 3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8" h="318">
                      <a:moveTo>
                        <a:pt x="0" y="318"/>
                      </a:moveTo>
                      <a:lnTo>
                        <a:pt x="0" y="0"/>
                      </a:lnTo>
                      <a:lnTo>
                        <a:pt x="13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Rectangle 147"/>
                <p:cNvSpPr>
                  <a:spLocks noChangeArrowheads="1"/>
                </p:cNvSpPr>
                <p:nvPr/>
              </p:nvSpPr>
              <p:spPr bwMode="auto">
                <a:xfrm>
                  <a:off x="972" y="4292"/>
                  <a:ext cx="205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776604.1(III) Avian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vulavirus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  Mallard/CH/HLJ383/06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Freeform 148"/>
                <p:cNvSpPr>
                  <a:spLocks/>
                </p:cNvSpPr>
                <p:nvPr/>
              </p:nvSpPr>
              <p:spPr bwMode="auto">
                <a:xfrm>
                  <a:off x="942" y="4319"/>
                  <a:ext cx="8" cy="36"/>
                </a:xfrm>
                <a:custGeom>
                  <a:avLst/>
                  <a:gdLst>
                    <a:gd name="T0" fmla="*/ 0 w 8"/>
                    <a:gd name="T1" fmla="*/ 36 h 36"/>
                    <a:gd name="T2" fmla="*/ 0 w 8"/>
                    <a:gd name="T3" fmla="*/ 0 h 36"/>
                    <a:gd name="T4" fmla="*/ 8 w 8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Rectangle 149"/>
                <p:cNvSpPr>
                  <a:spLocks noChangeArrowheads="1"/>
                </p:cNvSpPr>
                <p:nvPr/>
              </p:nvSpPr>
              <p:spPr bwMode="auto">
                <a:xfrm>
                  <a:off x="967" y="4368"/>
                  <a:ext cx="145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Y247177.1(III) Avian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vulavirus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  SH1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Freeform 150"/>
                <p:cNvSpPr>
                  <a:spLocks/>
                </p:cNvSpPr>
                <p:nvPr/>
              </p:nvSpPr>
              <p:spPr bwMode="auto">
                <a:xfrm>
                  <a:off x="942" y="4358"/>
                  <a:ext cx="3" cy="37"/>
                </a:xfrm>
                <a:custGeom>
                  <a:avLst/>
                  <a:gdLst>
                    <a:gd name="T0" fmla="*/ 0 w 3"/>
                    <a:gd name="T1" fmla="*/ 0 h 37"/>
                    <a:gd name="T2" fmla="*/ 0 w 3"/>
                    <a:gd name="T3" fmla="*/ 37 h 37"/>
                    <a:gd name="T4" fmla="*/ 3 w 3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3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Freeform 151"/>
                <p:cNvSpPr>
                  <a:spLocks/>
                </p:cNvSpPr>
                <p:nvPr/>
              </p:nvSpPr>
              <p:spPr bwMode="auto">
                <a:xfrm>
                  <a:off x="938" y="4357"/>
                  <a:ext cx="4" cy="55"/>
                </a:xfrm>
                <a:custGeom>
                  <a:avLst/>
                  <a:gdLst>
                    <a:gd name="T0" fmla="*/ 0 w 4"/>
                    <a:gd name="T1" fmla="*/ 55 h 55"/>
                    <a:gd name="T2" fmla="*/ 0 w 4"/>
                    <a:gd name="T3" fmla="*/ 0 h 55"/>
                    <a:gd name="T4" fmla="*/ 4 w 4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4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Rectangle 152"/>
                <p:cNvSpPr>
                  <a:spLocks noChangeArrowheads="1"/>
                </p:cNvSpPr>
                <p:nvPr/>
              </p:nvSpPr>
              <p:spPr bwMode="auto">
                <a:xfrm>
                  <a:off x="967" y="4444"/>
                  <a:ext cx="115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U865562.1(III) NDV/  NDVH-2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8" name="Freeform 153"/>
                <p:cNvSpPr>
                  <a:spLocks/>
                </p:cNvSpPr>
                <p:nvPr/>
              </p:nvSpPr>
              <p:spPr bwMode="auto">
                <a:xfrm>
                  <a:off x="938" y="4415"/>
                  <a:ext cx="7" cy="56"/>
                </a:xfrm>
                <a:custGeom>
                  <a:avLst/>
                  <a:gdLst>
                    <a:gd name="T0" fmla="*/ 0 w 7"/>
                    <a:gd name="T1" fmla="*/ 0 h 56"/>
                    <a:gd name="T2" fmla="*/ 0 w 7"/>
                    <a:gd name="T3" fmla="*/ 56 h 56"/>
                    <a:gd name="T4" fmla="*/ 7 w 7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7" y="5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Freeform 154"/>
                <p:cNvSpPr>
                  <a:spLocks/>
                </p:cNvSpPr>
                <p:nvPr/>
              </p:nvSpPr>
              <p:spPr bwMode="auto">
                <a:xfrm>
                  <a:off x="597" y="4414"/>
                  <a:ext cx="341" cy="93"/>
                </a:xfrm>
                <a:custGeom>
                  <a:avLst/>
                  <a:gdLst>
                    <a:gd name="T0" fmla="*/ 0 w 341"/>
                    <a:gd name="T1" fmla="*/ 93 h 93"/>
                    <a:gd name="T2" fmla="*/ 0 w 341"/>
                    <a:gd name="T3" fmla="*/ 0 h 93"/>
                    <a:gd name="T4" fmla="*/ 341 w 341"/>
                    <a:gd name="T5" fmla="*/ 0 h 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41" h="93">
                      <a:moveTo>
                        <a:pt x="0" y="93"/>
                      </a:moveTo>
                      <a:lnTo>
                        <a:pt x="0" y="0"/>
                      </a:lnTo>
                      <a:lnTo>
                        <a:pt x="341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0" name="Rectangle 155"/>
                <p:cNvSpPr>
                  <a:spLocks noChangeArrowheads="1"/>
                </p:cNvSpPr>
                <p:nvPr/>
              </p:nvSpPr>
              <p:spPr bwMode="auto">
                <a:xfrm>
                  <a:off x="1020" y="4520"/>
                  <a:ext cx="155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P027403.1(IX) NDV/  Layer/China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Yulin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10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Freeform 156"/>
                <p:cNvSpPr>
                  <a:spLocks/>
                </p:cNvSpPr>
                <p:nvPr/>
              </p:nvSpPr>
              <p:spPr bwMode="auto">
                <a:xfrm>
                  <a:off x="994" y="4547"/>
                  <a:ext cx="4" cy="55"/>
                </a:xfrm>
                <a:custGeom>
                  <a:avLst/>
                  <a:gdLst>
                    <a:gd name="T0" fmla="*/ 0 w 4"/>
                    <a:gd name="T1" fmla="*/ 55 h 55"/>
                    <a:gd name="T2" fmla="*/ 0 w 4"/>
                    <a:gd name="T3" fmla="*/ 0 h 55"/>
                    <a:gd name="T4" fmla="*/ 4 w 4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4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Rectangle 157"/>
                <p:cNvSpPr>
                  <a:spLocks noChangeArrowheads="1"/>
                </p:cNvSpPr>
                <p:nvPr/>
              </p:nvSpPr>
              <p:spPr bwMode="auto">
                <a:xfrm>
                  <a:off x="1028" y="4596"/>
                  <a:ext cx="118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FJ436303.1(IX) NDV/  ZJ/1/86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h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Freeform 158"/>
                <p:cNvSpPr>
                  <a:spLocks/>
                </p:cNvSpPr>
                <p:nvPr/>
              </p:nvSpPr>
              <p:spPr bwMode="auto">
                <a:xfrm>
                  <a:off x="997" y="4623"/>
                  <a:ext cx="9" cy="36"/>
                </a:xfrm>
                <a:custGeom>
                  <a:avLst/>
                  <a:gdLst>
                    <a:gd name="T0" fmla="*/ 0 w 9"/>
                    <a:gd name="T1" fmla="*/ 36 h 36"/>
                    <a:gd name="T2" fmla="*/ 0 w 9"/>
                    <a:gd name="T3" fmla="*/ 0 h 36"/>
                    <a:gd name="T4" fmla="*/ 9 w 9"/>
                    <a:gd name="T5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"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Rectangle 159"/>
                <p:cNvSpPr>
                  <a:spLocks noChangeArrowheads="1"/>
                </p:cNvSpPr>
                <p:nvPr/>
              </p:nvSpPr>
              <p:spPr bwMode="auto">
                <a:xfrm>
                  <a:off x="1020" y="4672"/>
                  <a:ext cx="141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C246549.1(IX) NDV/  HBNU/LSRC/F3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Freeform 160"/>
                <p:cNvSpPr>
                  <a:spLocks/>
                </p:cNvSpPr>
                <p:nvPr/>
              </p:nvSpPr>
              <p:spPr bwMode="auto">
                <a:xfrm>
                  <a:off x="997" y="4662"/>
                  <a:ext cx="1" cy="37"/>
                </a:xfrm>
                <a:custGeom>
                  <a:avLst/>
                  <a:gdLst>
                    <a:gd name="T0" fmla="*/ 0 w 1"/>
                    <a:gd name="T1" fmla="*/ 0 h 37"/>
                    <a:gd name="T2" fmla="*/ 0 w 1"/>
                    <a:gd name="T3" fmla="*/ 37 h 37"/>
                    <a:gd name="T4" fmla="*/ 1 w 1"/>
                    <a:gd name="T5" fmla="*/ 37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" h="37">
                      <a:moveTo>
                        <a:pt x="0" y="0"/>
                      </a:moveTo>
                      <a:lnTo>
                        <a:pt x="0" y="37"/>
                      </a:lnTo>
                      <a:lnTo>
                        <a:pt x="1" y="3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Freeform 161"/>
                <p:cNvSpPr>
                  <a:spLocks/>
                </p:cNvSpPr>
                <p:nvPr/>
              </p:nvSpPr>
              <p:spPr bwMode="auto">
                <a:xfrm>
                  <a:off x="994" y="4605"/>
                  <a:ext cx="3" cy="56"/>
                </a:xfrm>
                <a:custGeom>
                  <a:avLst/>
                  <a:gdLst>
                    <a:gd name="T0" fmla="*/ 0 w 3"/>
                    <a:gd name="T1" fmla="*/ 0 h 56"/>
                    <a:gd name="T2" fmla="*/ 0 w 3"/>
                    <a:gd name="T3" fmla="*/ 56 h 56"/>
                    <a:gd name="T4" fmla="*/ 3 w 3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3" y="5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7" name="Freeform 162"/>
                <p:cNvSpPr>
                  <a:spLocks/>
                </p:cNvSpPr>
                <p:nvPr/>
              </p:nvSpPr>
              <p:spPr bwMode="auto">
                <a:xfrm>
                  <a:off x="597" y="4510"/>
                  <a:ext cx="397" cy="94"/>
                </a:xfrm>
                <a:custGeom>
                  <a:avLst/>
                  <a:gdLst>
                    <a:gd name="T0" fmla="*/ 0 w 397"/>
                    <a:gd name="T1" fmla="*/ 0 h 94"/>
                    <a:gd name="T2" fmla="*/ 0 w 397"/>
                    <a:gd name="T3" fmla="*/ 94 h 94"/>
                    <a:gd name="T4" fmla="*/ 397 w 397"/>
                    <a:gd name="T5" fmla="*/ 94 h 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97" h="94">
                      <a:moveTo>
                        <a:pt x="0" y="0"/>
                      </a:moveTo>
                      <a:lnTo>
                        <a:pt x="0" y="94"/>
                      </a:lnTo>
                      <a:lnTo>
                        <a:pt x="397" y="9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Freeform 163"/>
                <p:cNvSpPr>
                  <a:spLocks/>
                </p:cNvSpPr>
                <p:nvPr/>
              </p:nvSpPr>
              <p:spPr bwMode="auto">
                <a:xfrm>
                  <a:off x="579" y="4509"/>
                  <a:ext cx="18" cy="251"/>
                </a:xfrm>
                <a:custGeom>
                  <a:avLst/>
                  <a:gdLst>
                    <a:gd name="T0" fmla="*/ 0 w 18"/>
                    <a:gd name="T1" fmla="*/ 251 h 251"/>
                    <a:gd name="T2" fmla="*/ 0 w 18"/>
                    <a:gd name="T3" fmla="*/ 0 h 251"/>
                    <a:gd name="T4" fmla="*/ 18 w 18"/>
                    <a:gd name="T5" fmla="*/ 0 h 2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" h="251">
                      <a:moveTo>
                        <a:pt x="0" y="251"/>
                      </a:moveTo>
                      <a:lnTo>
                        <a:pt x="0" y="0"/>
                      </a:lnTo>
                      <a:lnTo>
                        <a:pt x="18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Rectangle 164"/>
                <p:cNvSpPr>
                  <a:spLocks noChangeArrowheads="1"/>
                </p:cNvSpPr>
                <p:nvPr/>
              </p:nvSpPr>
              <p:spPr bwMode="auto">
                <a:xfrm>
                  <a:off x="1140" y="4748"/>
                  <a:ext cx="129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M056356.1(I) NDV/  ndv60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vinew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0" name="Freeform 165"/>
                <p:cNvSpPr>
                  <a:spLocks/>
                </p:cNvSpPr>
                <p:nvPr/>
              </p:nvSpPr>
              <p:spPr bwMode="auto">
                <a:xfrm>
                  <a:off x="1117" y="4775"/>
                  <a:ext cx="0" cy="36"/>
                </a:xfrm>
                <a:custGeom>
                  <a:avLst/>
                  <a:gdLst>
                    <a:gd name="T0" fmla="*/ 36 h 36"/>
                    <a:gd name="T1" fmla="*/ 0 h 36"/>
                    <a:gd name="T2" fmla="*/ 0 h 3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36">
                      <a:moveTo>
                        <a:pt x="0" y="36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Rectangle 166"/>
                <p:cNvSpPr>
                  <a:spLocks noChangeArrowheads="1"/>
                </p:cNvSpPr>
                <p:nvPr/>
              </p:nvSpPr>
              <p:spPr bwMode="auto">
                <a:xfrm>
                  <a:off x="1142" y="4824"/>
                  <a:ext cx="163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JQ029740.1(I) NDV/  Duck/China/SDFC07/2011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2" name="Freeform 167"/>
                <p:cNvSpPr>
                  <a:spLocks/>
                </p:cNvSpPr>
                <p:nvPr/>
              </p:nvSpPr>
              <p:spPr bwMode="auto">
                <a:xfrm>
                  <a:off x="1117" y="4814"/>
                  <a:ext cx="3" cy="36"/>
                </a:xfrm>
                <a:custGeom>
                  <a:avLst/>
                  <a:gdLst>
                    <a:gd name="T0" fmla="*/ 0 w 3"/>
                    <a:gd name="T1" fmla="*/ 0 h 36"/>
                    <a:gd name="T2" fmla="*/ 0 w 3"/>
                    <a:gd name="T3" fmla="*/ 36 h 36"/>
                    <a:gd name="T4" fmla="*/ 3 w 3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3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Freeform 168"/>
                <p:cNvSpPr>
                  <a:spLocks/>
                </p:cNvSpPr>
                <p:nvPr/>
              </p:nvSpPr>
              <p:spPr bwMode="auto">
                <a:xfrm>
                  <a:off x="887" y="4813"/>
                  <a:ext cx="230" cy="55"/>
                </a:xfrm>
                <a:custGeom>
                  <a:avLst/>
                  <a:gdLst>
                    <a:gd name="T0" fmla="*/ 0 w 230"/>
                    <a:gd name="T1" fmla="*/ 55 h 55"/>
                    <a:gd name="T2" fmla="*/ 0 w 230"/>
                    <a:gd name="T3" fmla="*/ 0 h 55"/>
                    <a:gd name="T4" fmla="*/ 230 w 230"/>
                    <a:gd name="T5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0" h="55">
                      <a:moveTo>
                        <a:pt x="0" y="55"/>
                      </a:moveTo>
                      <a:lnTo>
                        <a:pt x="0" y="0"/>
                      </a:lnTo>
                      <a:lnTo>
                        <a:pt x="230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4" name="Rectangle 169"/>
                <p:cNvSpPr>
                  <a:spLocks noChangeArrowheads="1"/>
                </p:cNvSpPr>
                <p:nvPr/>
              </p:nvSpPr>
              <p:spPr bwMode="auto">
                <a:xfrm>
                  <a:off x="1286" y="4900"/>
                  <a:ext cx="223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U601398(I).1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ria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alge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Russia/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yuleniy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Island/109/201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5" name="Freeform 170"/>
                <p:cNvSpPr>
                  <a:spLocks/>
                </p:cNvSpPr>
                <p:nvPr/>
              </p:nvSpPr>
              <p:spPr bwMode="auto">
                <a:xfrm>
                  <a:off x="887" y="4871"/>
                  <a:ext cx="377" cy="55"/>
                </a:xfrm>
                <a:custGeom>
                  <a:avLst/>
                  <a:gdLst>
                    <a:gd name="T0" fmla="*/ 0 w 377"/>
                    <a:gd name="T1" fmla="*/ 0 h 55"/>
                    <a:gd name="T2" fmla="*/ 0 w 377"/>
                    <a:gd name="T3" fmla="*/ 55 h 55"/>
                    <a:gd name="T4" fmla="*/ 377 w 377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7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377" y="5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6" name="Freeform 171"/>
                <p:cNvSpPr>
                  <a:spLocks/>
                </p:cNvSpPr>
                <p:nvPr/>
              </p:nvSpPr>
              <p:spPr bwMode="auto">
                <a:xfrm>
                  <a:off x="781" y="4869"/>
                  <a:ext cx="106" cy="144"/>
                </a:xfrm>
                <a:custGeom>
                  <a:avLst/>
                  <a:gdLst>
                    <a:gd name="T0" fmla="*/ 0 w 106"/>
                    <a:gd name="T1" fmla="*/ 144 h 144"/>
                    <a:gd name="T2" fmla="*/ 0 w 106"/>
                    <a:gd name="T3" fmla="*/ 0 h 144"/>
                    <a:gd name="T4" fmla="*/ 106 w 106"/>
                    <a:gd name="T5" fmla="*/ 0 h 1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6" h="144">
                      <a:moveTo>
                        <a:pt x="0" y="144"/>
                      </a:moveTo>
                      <a:lnTo>
                        <a:pt x="0" y="0"/>
                      </a:lnTo>
                      <a:lnTo>
                        <a:pt x="106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7" name="Rectangle 172"/>
                <p:cNvSpPr>
                  <a:spLocks noChangeArrowheads="1"/>
                </p:cNvSpPr>
                <p:nvPr/>
              </p:nvSpPr>
              <p:spPr bwMode="auto">
                <a:xfrm>
                  <a:off x="1434" y="4976"/>
                  <a:ext cx="2043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Q288391.1(X-a) NDV/  mottled duck/US(TX)/01-130/2001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Freeform 173"/>
                <p:cNvSpPr>
                  <a:spLocks/>
                </p:cNvSpPr>
                <p:nvPr/>
              </p:nvSpPr>
              <p:spPr bwMode="auto">
                <a:xfrm>
                  <a:off x="1181" y="5002"/>
                  <a:ext cx="231" cy="37"/>
                </a:xfrm>
                <a:custGeom>
                  <a:avLst/>
                  <a:gdLst>
                    <a:gd name="T0" fmla="*/ 0 w 231"/>
                    <a:gd name="T1" fmla="*/ 37 h 37"/>
                    <a:gd name="T2" fmla="*/ 0 w 231"/>
                    <a:gd name="T3" fmla="*/ 0 h 37"/>
                    <a:gd name="T4" fmla="*/ 231 w 231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1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231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Rectangle 174"/>
                <p:cNvSpPr>
                  <a:spLocks noChangeArrowheads="1"/>
                </p:cNvSpPr>
                <p:nvPr/>
              </p:nvSpPr>
              <p:spPr bwMode="auto">
                <a:xfrm>
                  <a:off x="1415" y="5052"/>
                  <a:ext cx="189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GQ288389.1(X-b) NDV/  mallard/US(MN)/99-376/1999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0" name="Freeform 175"/>
                <p:cNvSpPr>
                  <a:spLocks/>
                </p:cNvSpPr>
                <p:nvPr/>
              </p:nvSpPr>
              <p:spPr bwMode="auto">
                <a:xfrm>
                  <a:off x="1181" y="5042"/>
                  <a:ext cx="212" cy="36"/>
                </a:xfrm>
                <a:custGeom>
                  <a:avLst/>
                  <a:gdLst>
                    <a:gd name="T0" fmla="*/ 0 w 212"/>
                    <a:gd name="T1" fmla="*/ 0 h 36"/>
                    <a:gd name="T2" fmla="*/ 0 w 212"/>
                    <a:gd name="T3" fmla="*/ 36 h 36"/>
                    <a:gd name="T4" fmla="*/ 212 w 212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212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1" name="Freeform 176"/>
                <p:cNvSpPr>
                  <a:spLocks/>
                </p:cNvSpPr>
                <p:nvPr/>
              </p:nvSpPr>
              <p:spPr bwMode="auto">
                <a:xfrm>
                  <a:off x="908" y="5040"/>
                  <a:ext cx="273" cy="117"/>
                </a:xfrm>
                <a:custGeom>
                  <a:avLst/>
                  <a:gdLst>
                    <a:gd name="T0" fmla="*/ 0 w 273"/>
                    <a:gd name="T1" fmla="*/ 117 h 117"/>
                    <a:gd name="T2" fmla="*/ 0 w 273"/>
                    <a:gd name="T3" fmla="*/ 0 h 117"/>
                    <a:gd name="T4" fmla="*/ 273 w 273"/>
                    <a:gd name="T5" fmla="*/ 0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3" h="117">
                      <a:moveTo>
                        <a:pt x="0" y="117"/>
                      </a:moveTo>
                      <a:lnTo>
                        <a:pt x="0" y="0"/>
                      </a:lnTo>
                      <a:lnTo>
                        <a:pt x="273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2" name="Rectangle 177"/>
                <p:cNvSpPr>
                  <a:spLocks noChangeArrowheads="1"/>
                </p:cNvSpPr>
                <p:nvPr/>
              </p:nvSpPr>
              <p:spPr bwMode="auto">
                <a:xfrm>
                  <a:off x="1522" y="5128"/>
                  <a:ext cx="101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F077761.1(I) NDV/  </a:t>
                  </a:r>
                  <a:r>
                    <a:rPr kumimoji="0" lang="en-US" altLang="en-US" sz="1000" b="0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aSota</a:t>
                  </a: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3" name="Freeform 178"/>
                <p:cNvSpPr>
                  <a:spLocks/>
                </p:cNvSpPr>
                <p:nvPr/>
              </p:nvSpPr>
              <p:spPr bwMode="auto">
                <a:xfrm>
                  <a:off x="1493" y="5154"/>
                  <a:ext cx="7" cy="37"/>
                </a:xfrm>
                <a:custGeom>
                  <a:avLst/>
                  <a:gdLst>
                    <a:gd name="T0" fmla="*/ 0 w 7"/>
                    <a:gd name="T1" fmla="*/ 37 h 37"/>
                    <a:gd name="T2" fmla="*/ 0 w 7"/>
                    <a:gd name="T3" fmla="*/ 0 h 37"/>
                    <a:gd name="T4" fmla="*/ 7 w 7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7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Rectangle 179"/>
                <p:cNvSpPr>
                  <a:spLocks noChangeArrowheads="1"/>
                </p:cNvSpPr>
                <p:nvPr/>
              </p:nvSpPr>
              <p:spPr bwMode="auto">
                <a:xfrm>
                  <a:off x="1522" y="5204"/>
                  <a:ext cx="167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MH289850.1(I) NDV/Chicken/CN/JX/38A2/2016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5" name="Freeform 180"/>
                <p:cNvSpPr>
                  <a:spLocks/>
                </p:cNvSpPr>
                <p:nvPr/>
              </p:nvSpPr>
              <p:spPr bwMode="auto">
                <a:xfrm>
                  <a:off x="1493" y="5194"/>
                  <a:ext cx="7" cy="36"/>
                </a:xfrm>
                <a:custGeom>
                  <a:avLst/>
                  <a:gdLst>
                    <a:gd name="T0" fmla="*/ 0 w 7"/>
                    <a:gd name="T1" fmla="*/ 0 h 36"/>
                    <a:gd name="T2" fmla="*/ 0 w 7"/>
                    <a:gd name="T3" fmla="*/ 36 h 36"/>
                    <a:gd name="T4" fmla="*/ 7 w 7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7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Freeform 181"/>
                <p:cNvSpPr>
                  <a:spLocks/>
                </p:cNvSpPr>
                <p:nvPr/>
              </p:nvSpPr>
              <p:spPr bwMode="auto">
                <a:xfrm>
                  <a:off x="1456" y="5192"/>
                  <a:ext cx="37" cy="84"/>
                </a:xfrm>
                <a:custGeom>
                  <a:avLst/>
                  <a:gdLst>
                    <a:gd name="T0" fmla="*/ 0 w 37"/>
                    <a:gd name="T1" fmla="*/ 84 h 84"/>
                    <a:gd name="T2" fmla="*/ 0 w 37"/>
                    <a:gd name="T3" fmla="*/ 0 h 84"/>
                    <a:gd name="T4" fmla="*/ 37 w 37"/>
                    <a:gd name="T5" fmla="*/ 0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" h="84">
                      <a:moveTo>
                        <a:pt x="0" y="84"/>
                      </a:moveTo>
                      <a:lnTo>
                        <a:pt x="0" y="0"/>
                      </a:lnTo>
                      <a:lnTo>
                        <a:pt x="37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Rectangle 182"/>
                <p:cNvSpPr>
                  <a:spLocks noChangeArrowheads="1"/>
                </p:cNvSpPr>
                <p:nvPr/>
              </p:nvSpPr>
              <p:spPr bwMode="auto">
                <a:xfrm>
                  <a:off x="1500" y="5280"/>
                  <a:ext cx="118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M056358.1(II) NDV/  ndv64/VH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Freeform 183"/>
                <p:cNvSpPr>
                  <a:spLocks/>
                </p:cNvSpPr>
                <p:nvPr/>
              </p:nvSpPr>
              <p:spPr bwMode="auto">
                <a:xfrm>
                  <a:off x="1476" y="5306"/>
                  <a:ext cx="2" cy="56"/>
                </a:xfrm>
                <a:custGeom>
                  <a:avLst/>
                  <a:gdLst>
                    <a:gd name="T0" fmla="*/ 0 w 2"/>
                    <a:gd name="T1" fmla="*/ 56 h 56"/>
                    <a:gd name="T2" fmla="*/ 0 w 2"/>
                    <a:gd name="T3" fmla="*/ 0 h 56"/>
                    <a:gd name="T4" fmla="*/ 2 w 2"/>
                    <a:gd name="T5" fmla="*/ 0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2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9" name="Rectangle 184"/>
                <p:cNvSpPr>
                  <a:spLocks noChangeArrowheads="1"/>
                </p:cNvSpPr>
                <p:nvPr/>
              </p:nvSpPr>
              <p:spPr bwMode="auto">
                <a:xfrm>
                  <a:off x="1511" y="5356"/>
                  <a:ext cx="1332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EU289029.1(II) NDV/  VG/GA clone 5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Freeform 185"/>
                <p:cNvSpPr>
                  <a:spLocks/>
                </p:cNvSpPr>
                <p:nvPr/>
              </p:nvSpPr>
              <p:spPr bwMode="auto">
                <a:xfrm>
                  <a:off x="1480" y="5382"/>
                  <a:ext cx="9" cy="37"/>
                </a:xfrm>
                <a:custGeom>
                  <a:avLst/>
                  <a:gdLst>
                    <a:gd name="T0" fmla="*/ 0 w 9"/>
                    <a:gd name="T1" fmla="*/ 37 h 37"/>
                    <a:gd name="T2" fmla="*/ 0 w 9"/>
                    <a:gd name="T3" fmla="*/ 0 h 37"/>
                    <a:gd name="T4" fmla="*/ 9 w 9"/>
                    <a:gd name="T5" fmla="*/ 0 h 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" h="37">
                      <a:moveTo>
                        <a:pt x="0" y="37"/>
                      </a:moveTo>
                      <a:lnTo>
                        <a:pt x="0" y="0"/>
                      </a:lnTo>
                      <a:lnTo>
                        <a:pt x="9" y="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1" name="Rectangle 186"/>
                <p:cNvSpPr>
                  <a:spLocks noChangeArrowheads="1"/>
                </p:cNvSpPr>
                <p:nvPr/>
              </p:nvSpPr>
              <p:spPr bwMode="auto">
                <a:xfrm>
                  <a:off x="1508" y="5432"/>
                  <a:ext cx="103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KX822746.1(II) NDV/  22516 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2" name="Freeform 187"/>
                <p:cNvSpPr>
                  <a:spLocks/>
                </p:cNvSpPr>
                <p:nvPr/>
              </p:nvSpPr>
              <p:spPr bwMode="auto">
                <a:xfrm>
                  <a:off x="1480" y="5422"/>
                  <a:ext cx="6" cy="36"/>
                </a:xfrm>
                <a:custGeom>
                  <a:avLst/>
                  <a:gdLst>
                    <a:gd name="T0" fmla="*/ 0 w 6"/>
                    <a:gd name="T1" fmla="*/ 0 h 36"/>
                    <a:gd name="T2" fmla="*/ 0 w 6"/>
                    <a:gd name="T3" fmla="*/ 36 h 36"/>
                    <a:gd name="T4" fmla="*/ 6 w 6"/>
                    <a:gd name="T5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" h="36">
                      <a:moveTo>
                        <a:pt x="0" y="0"/>
                      </a:moveTo>
                      <a:lnTo>
                        <a:pt x="0" y="36"/>
                      </a:lnTo>
                      <a:lnTo>
                        <a:pt x="6" y="36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Freeform 188"/>
                <p:cNvSpPr>
                  <a:spLocks/>
                </p:cNvSpPr>
                <p:nvPr/>
              </p:nvSpPr>
              <p:spPr bwMode="auto">
                <a:xfrm>
                  <a:off x="1476" y="5365"/>
                  <a:ext cx="4" cy="55"/>
                </a:xfrm>
                <a:custGeom>
                  <a:avLst/>
                  <a:gdLst>
                    <a:gd name="T0" fmla="*/ 0 w 4"/>
                    <a:gd name="T1" fmla="*/ 0 h 55"/>
                    <a:gd name="T2" fmla="*/ 0 w 4"/>
                    <a:gd name="T3" fmla="*/ 55 h 55"/>
                    <a:gd name="T4" fmla="*/ 4 w 4"/>
                    <a:gd name="T5" fmla="*/ 55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" h="55">
                      <a:moveTo>
                        <a:pt x="0" y="0"/>
                      </a:moveTo>
                      <a:lnTo>
                        <a:pt x="0" y="55"/>
                      </a:lnTo>
                      <a:lnTo>
                        <a:pt x="4" y="55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Freeform 189"/>
                <p:cNvSpPr>
                  <a:spLocks/>
                </p:cNvSpPr>
                <p:nvPr/>
              </p:nvSpPr>
              <p:spPr bwMode="auto">
                <a:xfrm>
                  <a:off x="1456" y="5279"/>
                  <a:ext cx="20" cy="84"/>
                </a:xfrm>
                <a:custGeom>
                  <a:avLst/>
                  <a:gdLst>
                    <a:gd name="T0" fmla="*/ 0 w 20"/>
                    <a:gd name="T1" fmla="*/ 0 h 84"/>
                    <a:gd name="T2" fmla="*/ 0 w 20"/>
                    <a:gd name="T3" fmla="*/ 84 h 84"/>
                    <a:gd name="T4" fmla="*/ 20 w 20"/>
                    <a:gd name="T5" fmla="*/ 84 h 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" h="84">
                      <a:moveTo>
                        <a:pt x="0" y="0"/>
                      </a:moveTo>
                      <a:lnTo>
                        <a:pt x="0" y="84"/>
                      </a:lnTo>
                      <a:lnTo>
                        <a:pt x="20" y="84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5" name="Freeform 190"/>
                <p:cNvSpPr>
                  <a:spLocks/>
                </p:cNvSpPr>
                <p:nvPr/>
              </p:nvSpPr>
              <p:spPr bwMode="auto">
                <a:xfrm>
                  <a:off x="908" y="5161"/>
                  <a:ext cx="548" cy="117"/>
                </a:xfrm>
                <a:custGeom>
                  <a:avLst/>
                  <a:gdLst>
                    <a:gd name="T0" fmla="*/ 0 w 548"/>
                    <a:gd name="T1" fmla="*/ 0 h 117"/>
                    <a:gd name="T2" fmla="*/ 0 w 548"/>
                    <a:gd name="T3" fmla="*/ 117 h 117"/>
                    <a:gd name="T4" fmla="*/ 548 w 548"/>
                    <a:gd name="T5" fmla="*/ 117 h 1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48" h="117">
                      <a:moveTo>
                        <a:pt x="0" y="0"/>
                      </a:moveTo>
                      <a:lnTo>
                        <a:pt x="0" y="117"/>
                      </a:lnTo>
                      <a:lnTo>
                        <a:pt x="548" y="117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Freeform 191"/>
                <p:cNvSpPr>
                  <a:spLocks/>
                </p:cNvSpPr>
                <p:nvPr/>
              </p:nvSpPr>
              <p:spPr bwMode="auto">
                <a:xfrm>
                  <a:off x="781" y="5016"/>
                  <a:ext cx="127" cy="143"/>
                </a:xfrm>
                <a:custGeom>
                  <a:avLst/>
                  <a:gdLst>
                    <a:gd name="T0" fmla="*/ 0 w 127"/>
                    <a:gd name="T1" fmla="*/ 0 h 143"/>
                    <a:gd name="T2" fmla="*/ 0 w 127"/>
                    <a:gd name="T3" fmla="*/ 143 h 143"/>
                    <a:gd name="T4" fmla="*/ 127 w 127"/>
                    <a:gd name="T5" fmla="*/ 143 h 1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7" h="143">
                      <a:moveTo>
                        <a:pt x="0" y="0"/>
                      </a:moveTo>
                      <a:lnTo>
                        <a:pt x="0" y="143"/>
                      </a:lnTo>
                      <a:lnTo>
                        <a:pt x="127" y="143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Freeform 192"/>
                <p:cNvSpPr>
                  <a:spLocks/>
                </p:cNvSpPr>
                <p:nvPr/>
              </p:nvSpPr>
              <p:spPr bwMode="auto">
                <a:xfrm>
                  <a:off x="579" y="4763"/>
                  <a:ext cx="202" cy="251"/>
                </a:xfrm>
                <a:custGeom>
                  <a:avLst/>
                  <a:gdLst>
                    <a:gd name="T0" fmla="*/ 0 w 202"/>
                    <a:gd name="T1" fmla="*/ 0 h 251"/>
                    <a:gd name="T2" fmla="*/ 0 w 202"/>
                    <a:gd name="T3" fmla="*/ 251 h 251"/>
                    <a:gd name="T4" fmla="*/ 202 w 202"/>
                    <a:gd name="T5" fmla="*/ 251 h 2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2" h="251">
                      <a:moveTo>
                        <a:pt x="0" y="0"/>
                      </a:moveTo>
                      <a:lnTo>
                        <a:pt x="0" y="251"/>
                      </a:lnTo>
                      <a:lnTo>
                        <a:pt x="202" y="251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8" name="Freeform 193"/>
                <p:cNvSpPr>
                  <a:spLocks/>
                </p:cNvSpPr>
                <p:nvPr/>
              </p:nvSpPr>
              <p:spPr bwMode="auto">
                <a:xfrm>
                  <a:off x="431" y="4441"/>
                  <a:ext cx="148" cy="320"/>
                </a:xfrm>
                <a:custGeom>
                  <a:avLst/>
                  <a:gdLst>
                    <a:gd name="T0" fmla="*/ 0 w 148"/>
                    <a:gd name="T1" fmla="*/ 0 h 320"/>
                    <a:gd name="T2" fmla="*/ 0 w 148"/>
                    <a:gd name="T3" fmla="*/ 320 h 320"/>
                    <a:gd name="T4" fmla="*/ 148 w 148"/>
                    <a:gd name="T5" fmla="*/ 320 h 3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8" h="320">
                      <a:moveTo>
                        <a:pt x="0" y="0"/>
                      </a:moveTo>
                      <a:lnTo>
                        <a:pt x="0" y="320"/>
                      </a:lnTo>
                      <a:lnTo>
                        <a:pt x="148" y="32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Freeform 194"/>
                <p:cNvSpPr>
                  <a:spLocks/>
                </p:cNvSpPr>
                <p:nvPr/>
              </p:nvSpPr>
              <p:spPr bwMode="auto">
                <a:xfrm>
                  <a:off x="327" y="4000"/>
                  <a:ext cx="104" cy="440"/>
                </a:xfrm>
                <a:custGeom>
                  <a:avLst/>
                  <a:gdLst>
                    <a:gd name="T0" fmla="*/ 0 w 104"/>
                    <a:gd name="T1" fmla="*/ 0 h 440"/>
                    <a:gd name="T2" fmla="*/ 0 w 104"/>
                    <a:gd name="T3" fmla="*/ 440 h 440"/>
                    <a:gd name="T4" fmla="*/ 104 w 104"/>
                    <a:gd name="T5" fmla="*/ 440 h 4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4" h="440">
                      <a:moveTo>
                        <a:pt x="0" y="0"/>
                      </a:moveTo>
                      <a:lnTo>
                        <a:pt x="0" y="440"/>
                      </a:lnTo>
                      <a:lnTo>
                        <a:pt x="104" y="440"/>
                      </a:lnTo>
                    </a:path>
                  </a:pathLst>
                </a:cu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Rectangle 195"/>
                <p:cNvSpPr>
                  <a:spLocks noChangeArrowheads="1"/>
                </p:cNvSpPr>
                <p:nvPr/>
              </p:nvSpPr>
              <p:spPr bwMode="auto">
                <a:xfrm>
                  <a:off x="1410" y="2365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Rectangle 197"/>
                <p:cNvSpPr>
                  <a:spLocks noChangeArrowheads="1"/>
                </p:cNvSpPr>
                <p:nvPr/>
              </p:nvSpPr>
              <p:spPr bwMode="auto">
                <a:xfrm>
                  <a:off x="746" y="4791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Rectangle 201"/>
                <p:cNvSpPr>
                  <a:spLocks noChangeArrowheads="1"/>
                </p:cNvSpPr>
                <p:nvPr/>
              </p:nvSpPr>
              <p:spPr bwMode="auto">
                <a:xfrm>
                  <a:off x="1317" y="5274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Rectangle 203"/>
                <p:cNvSpPr>
                  <a:spLocks noChangeArrowheads="1"/>
                </p:cNvSpPr>
                <p:nvPr/>
              </p:nvSpPr>
              <p:spPr bwMode="auto">
                <a:xfrm>
                  <a:off x="784" y="4336"/>
                  <a:ext cx="12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Rectangle 206"/>
              <p:cNvSpPr>
                <a:spLocks noChangeArrowheads="1"/>
              </p:cNvSpPr>
              <p:nvPr/>
            </p:nvSpPr>
            <p:spPr bwMode="auto">
              <a:xfrm>
                <a:off x="688862" y="6292313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ectangle 208"/>
              <p:cNvSpPr>
                <a:spLocks noChangeArrowheads="1"/>
              </p:cNvSpPr>
              <p:nvPr/>
            </p:nvSpPr>
            <p:spPr bwMode="auto">
              <a:xfrm>
                <a:off x="1257038" y="5602277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Rectangle 211"/>
              <p:cNvSpPr>
                <a:spLocks noChangeArrowheads="1"/>
              </p:cNvSpPr>
              <p:nvPr/>
            </p:nvSpPr>
            <p:spPr bwMode="auto">
              <a:xfrm>
                <a:off x="1622463" y="4483487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Rectangle 212"/>
              <p:cNvSpPr>
                <a:spLocks noChangeArrowheads="1"/>
              </p:cNvSpPr>
              <p:nvPr/>
            </p:nvSpPr>
            <p:spPr bwMode="auto">
              <a:xfrm>
                <a:off x="1271091" y="4262562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Rectangle 213"/>
              <p:cNvSpPr>
                <a:spLocks noChangeArrowheads="1"/>
              </p:cNvSpPr>
              <p:nvPr/>
            </p:nvSpPr>
            <p:spPr bwMode="auto">
              <a:xfrm>
                <a:off x="1772545" y="4970453"/>
                <a:ext cx="216436" cy="1362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Rectangle 214"/>
              <p:cNvSpPr>
                <a:spLocks noChangeArrowheads="1"/>
              </p:cNvSpPr>
              <p:nvPr/>
            </p:nvSpPr>
            <p:spPr bwMode="auto">
              <a:xfrm>
                <a:off x="1775264" y="3171549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ctangle 215"/>
              <p:cNvSpPr>
                <a:spLocks noChangeArrowheads="1"/>
              </p:cNvSpPr>
              <p:nvPr/>
            </p:nvSpPr>
            <p:spPr bwMode="auto">
              <a:xfrm>
                <a:off x="1741478" y="3522655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ctangle 216"/>
              <p:cNvSpPr>
                <a:spLocks noChangeArrowheads="1"/>
              </p:cNvSpPr>
              <p:nvPr/>
            </p:nvSpPr>
            <p:spPr bwMode="auto">
              <a:xfrm>
                <a:off x="1643184" y="339975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Rectangle 217"/>
              <p:cNvSpPr>
                <a:spLocks noChangeArrowheads="1"/>
              </p:cNvSpPr>
              <p:nvPr/>
            </p:nvSpPr>
            <p:spPr bwMode="auto">
              <a:xfrm>
                <a:off x="1800281" y="2932498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218"/>
              <p:cNvSpPr>
                <a:spLocks noChangeArrowheads="1"/>
              </p:cNvSpPr>
              <p:nvPr/>
            </p:nvSpPr>
            <p:spPr bwMode="auto">
              <a:xfrm>
                <a:off x="1536419" y="322076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Rectangle 220"/>
              <p:cNvSpPr>
                <a:spLocks noChangeArrowheads="1"/>
              </p:cNvSpPr>
              <p:nvPr/>
            </p:nvSpPr>
            <p:spPr bwMode="auto">
              <a:xfrm>
                <a:off x="1347274" y="7299849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Rectangle 222"/>
              <p:cNvSpPr>
                <a:spLocks noChangeArrowheads="1"/>
              </p:cNvSpPr>
              <p:nvPr/>
            </p:nvSpPr>
            <p:spPr bwMode="auto">
              <a:xfrm>
                <a:off x="1652271" y="7873859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Rectangle 223"/>
              <p:cNvSpPr>
                <a:spLocks noChangeArrowheads="1"/>
              </p:cNvSpPr>
              <p:nvPr/>
            </p:nvSpPr>
            <p:spPr bwMode="auto">
              <a:xfrm>
                <a:off x="1202680" y="8176676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Rectangle 224"/>
              <p:cNvSpPr>
                <a:spLocks noChangeArrowheads="1"/>
              </p:cNvSpPr>
              <p:nvPr/>
            </p:nvSpPr>
            <p:spPr bwMode="auto">
              <a:xfrm>
                <a:off x="1009388" y="794860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Rectangle 225"/>
              <p:cNvSpPr>
                <a:spLocks noChangeArrowheads="1"/>
              </p:cNvSpPr>
              <p:nvPr/>
            </p:nvSpPr>
            <p:spPr bwMode="auto">
              <a:xfrm>
                <a:off x="691954" y="7540615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Rectangle 227"/>
              <p:cNvSpPr>
                <a:spLocks noChangeArrowheads="1"/>
              </p:cNvSpPr>
              <p:nvPr/>
            </p:nvSpPr>
            <p:spPr bwMode="auto">
              <a:xfrm>
                <a:off x="757975" y="6526215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Rectangle 228"/>
              <p:cNvSpPr>
                <a:spLocks noChangeArrowheads="1"/>
              </p:cNvSpPr>
              <p:nvPr/>
            </p:nvSpPr>
            <p:spPr bwMode="auto">
              <a:xfrm>
                <a:off x="1383973" y="3046009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Rectangle 229"/>
              <p:cNvSpPr>
                <a:spLocks noChangeArrowheads="1"/>
              </p:cNvSpPr>
              <p:nvPr/>
            </p:nvSpPr>
            <p:spPr bwMode="auto">
              <a:xfrm>
                <a:off x="2132601" y="2090198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Rectangle 230"/>
              <p:cNvSpPr>
                <a:spLocks noChangeArrowheads="1"/>
              </p:cNvSpPr>
              <p:nvPr/>
            </p:nvSpPr>
            <p:spPr bwMode="auto">
              <a:xfrm>
                <a:off x="1487675" y="2185053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Rectangle 231"/>
              <p:cNvSpPr>
                <a:spLocks noChangeArrowheads="1"/>
              </p:cNvSpPr>
              <p:nvPr/>
            </p:nvSpPr>
            <p:spPr bwMode="auto">
              <a:xfrm>
                <a:off x="1673215" y="2679691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Rectangle 232"/>
              <p:cNvSpPr>
                <a:spLocks noChangeArrowheads="1"/>
              </p:cNvSpPr>
              <p:nvPr/>
            </p:nvSpPr>
            <p:spPr bwMode="auto">
              <a:xfrm>
                <a:off x="1433418" y="2586823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ectangle 234"/>
              <p:cNvSpPr>
                <a:spLocks noChangeArrowheads="1"/>
              </p:cNvSpPr>
              <p:nvPr/>
            </p:nvSpPr>
            <p:spPr bwMode="auto">
              <a:xfrm>
                <a:off x="2196970" y="1367216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Rectangle 235"/>
              <p:cNvSpPr>
                <a:spLocks noChangeArrowheads="1"/>
              </p:cNvSpPr>
              <p:nvPr/>
            </p:nvSpPr>
            <p:spPr bwMode="auto">
              <a:xfrm>
                <a:off x="2126522" y="6057097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Rectangle 236"/>
              <p:cNvSpPr>
                <a:spLocks noChangeArrowheads="1"/>
              </p:cNvSpPr>
              <p:nvPr/>
            </p:nvSpPr>
            <p:spPr bwMode="auto">
              <a:xfrm>
                <a:off x="518514" y="5526080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237"/>
              <p:cNvSpPr>
                <a:spLocks noChangeArrowheads="1"/>
              </p:cNvSpPr>
              <p:nvPr/>
            </p:nvSpPr>
            <p:spPr bwMode="auto">
              <a:xfrm>
                <a:off x="641658" y="5095865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239"/>
              <p:cNvSpPr>
                <a:spLocks noChangeArrowheads="1"/>
              </p:cNvSpPr>
              <p:nvPr/>
            </p:nvSpPr>
            <p:spPr bwMode="auto">
              <a:xfrm>
                <a:off x="1925544" y="109179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Rectangle 240"/>
              <p:cNvSpPr>
                <a:spLocks noChangeArrowheads="1"/>
              </p:cNvSpPr>
              <p:nvPr/>
            </p:nvSpPr>
            <p:spPr bwMode="auto">
              <a:xfrm>
                <a:off x="2149128" y="1606936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Rectangle 241"/>
              <p:cNvSpPr>
                <a:spLocks noChangeArrowheads="1"/>
              </p:cNvSpPr>
              <p:nvPr/>
            </p:nvSpPr>
            <p:spPr bwMode="auto">
              <a:xfrm>
                <a:off x="1880551" y="1960158"/>
                <a:ext cx="241936" cy="1362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Rectangle 242"/>
              <p:cNvSpPr>
                <a:spLocks noChangeArrowheads="1"/>
              </p:cNvSpPr>
              <p:nvPr/>
            </p:nvSpPr>
            <p:spPr bwMode="auto">
              <a:xfrm>
                <a:off x="1655500" y="1835142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Rectangle 243"/>
              <p:cNvSpPr>
                <a:spLocks noChangeArrowheads="1"/>
              </p:cNvSpPr>
              <p:nvPr/>
            </p:nvSpPr>
            <p:spPr bwMode="auto">
              <a:xfrm>
                <a:off x="1389184" y="1412468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Rectangle 244"/>
              <p:cNvSpPr>
                <a:spLocks noChangeArrowheads="1"/>
              </p:cNvSpPr>
              <p:nvPr/>
            </p:nvSpPr>
            <p:spPr bwMode="auto">
              <a:xfrm>
                <a:off x="1310444" y="1877209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Rectangle 245"/>
              <p:cNvSpPr>
                <a:spLocks noChangeArrowheads="1"/>
              </p:cNvSpPr>
              <p:nvPr/>
            </p:nvSpPr>
            <p:spPr bwMode="auto">
              <a:xfrm>
                <a:off x="1216985" y="2409815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Rectangle 246"/>
              <p:cNvSpPr>
                <a:spLocks noChangeArrowheads="1"/>
              </p:cNvSpPr>
              <p:nvPr/>
            </p:nvSpPr>
            <p:spPr bwMode="auto">
              <a:xfrm>
                <a:off x="1078772" y="3023251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Rectangle 247"/>
              <p:cNvSpPr>
                <a:spLocks noChangeArrowheads="1"/>
              </p:cNvSpPr>
              <p:nvPr/>
            </p:nvSpPr>
            <p:spPr bwMode="auto">
              <a:xfrm>
                <a:off x="1803054" y="5109361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Rectangle 248"/>
              <p:cNvSpPr>
                <a:spLocks noChangeArrowheads="1"/>
              </p:cNvSpPr>
              <p:nvPr/>
            </p:nvSpPr>
            <p:spPr bwMode="auto">
              <a:xfrm>
                <a:off x="1135201" y="5358995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Rectangle 249"/>
              <p:cNvSpPr>
                <a:spLocks noChangeArrowheads="1"/>
              </p:cNvSpPr>
              <p:nvPr/>
            </p:nvSpPr>
            <p:spPr bwMode="auto">
              <a:xfrm>
                <a:off x="687293" y="4436261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7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Rectangle 250"/>
              <p:cNvSpPr>
                <a:spLocks noChangeArrowheads="1"/>
              </p:cNvSpPr>
              <p:nvPr/>
            </p:nvSpPr>
            <p:spPr bwMode="auto">
              <a:xfrm>
                <a:off x="865710" y="3620287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Rectangle 251"/>
              <p:cNvSpPr>
                <a:spLocks noChangeArrowheads="1"/>
              </p:cNvSpPr>
              <p:nvPr/>
            </p:nvSpPr>
            <p:spPr bwMode="auto">
              <a:xfrm>
                <a:off x="1384637" y="3902067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Rectangle 252"/>
              <p:cNvSpPr>
                <a:spLocks noChangeArrowheads="1"/>
              </p:cNvSpPr>
              <p:nvPr/>
            </p:nvSpPr>
            <p:spPr bwMode="auto">
              <a:xfrm>
                <a:off x="1022807" y="431124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Rectangle 253"/>
              <p:cNvSpPr>
                <a:spLocks noChangeArrowheads="1"/>
              </p:cNvSpPr>
              <p:nvPr/>
            </p:nvSpPr>
            <p:spPr bwMode="auto">
              <a:xfrm>
                <a:off x="1485788" y="4631259"/>
                <a:ext cx="12824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</a:t>
                </a:r>
                <a:endPara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Rectangle 254"/>
              <p:cNvSpPr>
                <a:spLocks noChangeArrowheads="1"/>
              </p:cNvSpPr>
              <p:nvPr/>
            </p:nvSpPr>
            <p:spPr bwMode="auto">
              <a:xfrm>
                <a:off x="1127647" y="461697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Rectangle 255"/>
              <p:cNvSpPr>
                <a:spLocks noChangeArrowheads="1"/>
              </p:cNvSpPr>
              <p:nvPr/>
            </p:nvSpPr>
            <p:spPr bwMode="auto">
              <a:xfrm>
                <a:off x="1374046" y="4852184"/>
                <a:ext cx="19236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Line 256"/>
              <p:cNvSpPr>
                <a:spLocks noChangeShapeType="1"/>
              </p:cNvSpPr>
              <p:nvPr/>
            </p:nvSpPr>
            <p:spPr bwMode="auto">
              <a:xfrm>
                <a:off x="768351" y="8843963"/>
                <a:ext cx="250825" cy="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Line 257"/>
              <p:cNvSpPr>
                <a:spLocks noChangeShapeType="1"/>
              </p:cNvSpPr>
              <p:nvPr/>
            </p:nvSpPr>
            <p:spPr bwMode="auto">
              <a:xfrm>
                <a:off x="768351" y="8824913"/>
                <a:ext cx="0" cy="3968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Line 258"/>
              <p:cNvSpPr>
                <a:spLocks noChangeShapeType="1"/>
              </p:cNvSpPr>
              <p:nvPr/>
            </p:nvSpPr>
            <p:spPr bwMode="auto">
              <a:xfrm>
                <a:off x="1019176" y="8824913"/>
                <a:ext cx="0" cy="39688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Rectangle 259"/>
              <p:cNvSpPr>
                <a:spLocks noChangeArrowheads="1"/>
              </p:cNvSpPr>
              <p:nvPr/>
            </p:nvSpPr>
            <p:spPr bwMode="auto">
              <a:xfrm>
                <a:off x="827088" y="8872538"/>
                <a:ext cx="28854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20</a:t>
                </a:r>
                <a:endParaRPr kumimoji="0" lang="en-US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263" name="Straight Connector 262"/>
            <p:cNvCxnSpPr/>
            <p:nvPr/>
          </p:nvCxnSpPr>
          <p:spPr>
            <a:xfrm>
              <a:off x="5791784" y="8565812"/>
              <a:ext cx="0" cy="66207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4" name="TextBox 263"/>
            <p:cNvSpPr txBox="1"/>
            <p:nvPr/>
          </p:nvSpPr>
          <p:spPr>
            <a:xfrm>
              <a:off x="5817931" y="8747716"/>
              <a:ext cx="5398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5" name="Straight Connector 264"/>
            <p:cNvCxnSpPr/>
            <p:nvPr/>
          </p:nvCxnSpPr>
          <p:spPr>
            <a:xfrm>
              <a:off x="5791784" y="7409859"/>
              <a:ext cx="0" cy="3737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6" name="TextBox 265"/>
            <p:cNvSpPr txBox="1"/>
            <p:nvPr/>
          </p:nvSpPr>
          <p:spPr>
            <a:xfrm>
              <a:off x="5817931" y="7442506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X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7" name="Straight Connector 266"/>
            <p:cNvCxnSpPr/>
            <p:nvPr/>
          </p:nvCxnSpPr>
          <p:spPr>
            <a:xfrm>
              <a:off x="5791784" y="7821704"/>
              <a:ext cx="0" cy="3737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TextBox 267"/>
            <p:cNvSpPr txBox="1"/>
            <p:nvPr/>
          </p:nvSpPr>
          <p:spPr>
            <a:xfrm>
              <a:off x="5817931" y="7854351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9" name="Straight Connector 268"/>
            <p:cNvCxnSpPr/>
            <p:nvPr/>
          </p:nvCxnSpPr>
          <p:spPr>
            <a:xfrm>
              <a:off x="5791784" y="7085489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TextBox 269"/>
            <p:cNvSpPr txBox="1"/>
            <p:nvPr/>
          </p:nvSpPr>
          <p:spPr>
            <a:xfrm>
              <a:off x="5817931" y="7071666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X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1" name="Straight Connector 270"/>
            <p:cNvCxnSpPr/>
            <p:nvPr/>
          </p:nvCxnSpPr>
          <p:spPr>
            <a:xfrm>
              <a:off x="5791784" y="6714921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TextBox 271"/>
            <p:cNvSpPr txBox="1"/>
            <p:nvPr/>
          </p:nvSpPr>
          <p:spPr>
            <a:xfrm>
              <a:off x="5817931" y="6701098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3" name="Straight Connector 272"/>
            <p:cNvCxnSpPr/>
            <p:nvPr/>
          </p:nvCxnSpPr>
          <p:spPr>
            <a:xfrm>
              <a:off x="5791784" y="6406246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TextBox 273"/>
            <p:cNvSpPr txBox="1"/>
            <p:nvPr/>
          </p:nvSpPr>
          <p:spPr>
            <a:xfrm>
              <a:off x="5817931" y="6392423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5" name="Straight Connector 274"/>
            <p:cNvCxnSpPr/>
            <p:nvPr/>
          </p:nvCxnSpPr>
          <p:spPr>
            <a:xfrm>
              <a:off x="5791784" y="6023937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6" name="TextBox 275"/>
            <p:cNvSpPr txBox="1"/>
            <p:nvPr/>
          </p:nvSpPr>
          <p:spPr>
            <a:xfrm>
              <a:off x="5817931" y="6010114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V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7" name="Straight Connector 276"/>
            <p:cNvCxnSpPr/>
            <p:nvPr/>
          </p:nvCxnSpPr>
          <p:spPr>
            <a:xfrm>
              <a:off x="5791784" y="5632279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TextBox 277"/>
            <p:cNvSpPr txBox="1"/>
            <p:nvPr/>
          </p:nvSpPr>
          <p:spPr>
            <a:xfrm>
              <a:off x="5817931" y="5618456"/>
              <a:ext cx="64178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9" name="Straight Connector 278"/>
            <p:cNvCxnSpPr/>
            <p:nvPr/>
          </p:nvCxnSpPr>
          <p:spPr>
            <a:xfrm>
              <a:off x="5791784" y="5230410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0" name="TextBox 279"/>
            <p:cNvSpPr txBox="1"/>
            <p:nvPr/>
          </p:nvSpPr>
          <p:spPr>
            <a:xfrm>
              <a:off x="5817933" y="5216587"/>
              <a:ext cx="77656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IX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1" name="Straight Connector 280"/>
            <p:cNvCxnSpPr/>
            <p:nvPr/>
          </p:nvCxnSpPr>
          <p:spPr>
            <a:xfrm>
              <a:off x="5791784" y="4484294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2" name="TextBox 281"/>
            <p:cNvSpPr txBox="1"/>
            <p:nvPr/>
          </p:nvSpPr>
          <p:spPr>
            <a:xfrm>
              <a:off x="5817933" y="4470471"/>
              <a:ext cx="77656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3" name="Straight Connector 282"/>
            <p:cNvCxnSpPr/>
            <p:nvPr/>
          </p:nvCxnSpPr>
          <p:spPr>
            <a:xfrm>
              <a:off x="5791784" y="4853833"/>
              <a:ext cx="0" cy="13098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4" name="TextBox 283"/>
            <p:cNvSpPr txBox="1"/>
            <p:nvPr/>
          </p:nvSpPr>
          <p:spPr>
            <a:xfrm>
              <a:off x="5817933" y="4760031"/>
              <a:ext cx="59615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5" name="Straight Connector 284"/>
            <p:cNvCxnSpPr/>
            <p:nvPr/>
          </p:nvCxnSpPr>
          <p:spPr>
            <a:xfrm>
              <a:off x="5791784" y="3956951"/>
              <a:ext cx="0" cy="4522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6" name="TextBox 285"/>
            <p:cNvSpPr txBox="1"/>
            <p:nvPr/>
          </p:nvSpPr>
          <p:spPr>
            <a:xfrm>
              <a:off x="5817933" y="3947560"/>
              <a:ext cx="77656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7" name="Straight Connector 286"/>
            <p:cNvCxnSpPr/>
            <p:nvPr/>
          </p:nvCxnSpPr>
          <p:spPr>
            <a:xfrm>
              <a:off x="5791784" y="3625663"/>
              <a:ext cx="0" cy="2807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TextBox 287"/>
            <p:cNvSpPr txBox="1"/>
            <p:nvPr/>
          </p:nvSpPr>
          <p:spPr>
            <a:xfrm>
              <a:off x="5817933" y="3611840"/>
              <a:ext cx="77656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9" name="Straight Connector 288"/>
            <p:cNvCxnSpPr/>
            <p:nvPr/>
          </p:nvCxnSpPr>
          <p:spPr>
            <a:xfrm>
              <a:off x="5791784" y="2396776"/>
              <a:ext cx="0" cy="9693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Box 289"/>
            <p:cNvSpPr txBox="1"/>
            <p:nvPr/>
          </p:nvSpPr>
          <p:spPr>
            <a:xfrm>
              <a:off x="5817933" y="2747556"/>
              <a:ext cx="77656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3" name="Straight Connector 292"/>
            <p:cNvCxnSpPr/>
            <p:nvPr/>
          </p:nvCxnSpPr>
          <p:spPr>
            <a:xfrm>
              <a:off x="5791784" y="1947110"/>
              <a:ext cx="0" cy="3737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TextBox 293"/>
            <p:cNvSpPr txBox="1"/>
            <p:nvPr/>
          </p:nvSpPr>
          <p:spPr>
            <a:xfrm>
              <a:off x="5817931" y="1944197"/>
              <a:ext cx="87924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I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5" name="Straight Connector 294"/>
            <p:cNvCxnSpPr/>
            <p:nvPr/>
          </p:nvCxnSpPr>
          <p:spPr>
            <a:xfrm>
              <a:off x="5791784" y="1544641"/>
              <a:ext cx="0" cy="3397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TextBox 295"/>
            <p:cNvSpPr txBox="1"/>
            <p:nvPr/>
          </p:nvSpPr>
          <p:spPr>
            <a:xfrm>
              <a:off x="5817931" y="1545061"/>
              <a:ext cx="87924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7" name="Straight Connector 296"/>
            <p:cNvCxnSpPr/>
            <p:nvPr/>
          </p:nvCxnSpPr>
          <p:spPr>
            <a:xfrm>
              <a:off x="5791784" y="980193"/>
              <a:ext cx="0" cy="49742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8" name="TextBox 297"/>
            <p:cNvSpPr txBox="1"/>
            <p:nvPr/>
          </p:nvSpPr>
          <p:spPr>
            <a:xfrm>
              <a:off x="5817931" y="1034052"/>
              <a:ext cx="1170280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VI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9" name="Straight Connector 298"/>
            <p:cNvCxnSpPr/>
            <p:nvPr/>
          </p:nvCxnSpPr>
          <p:spPr>
            <a:xfrm>
              <a:off x="5791784" y="696416"/>
              <a:ext cx="0" cy="2320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0" name="TextBox 299"/>
            <p:cNvSpPr txBox="1"/>
            <p:nvPr/>
          </p:nvSpPr>
          <p:spPr>
            <a:xfrm>
              <a:off x="5817933" y="678548"/>
              <a:ext cx="1033601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IV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1" name="Straight Connector 300"/>
            <p:cNvCxnSpPr/>
            <p:nvPr/>
          </p:nvCxnSpPr>
          <p:spPr>
            <a:xfrm>
              <a:off x="5791784" y="296630"/>
              <a:ext cx="0" cy="3397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2" name="TextBox 301"/>
            <p:cNvSpPr txBox="1"/>
            <p:nvPr/>
          </p:nvSpPr>
          <p:spPr>
            <a:xfrm>
              <a:off x="5817933" y="358010"/>
              <a:ext cx="1033601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VII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2" name="Straight Connector 291"/>
            <p:cNvCxnSpPr/>
            <p:nvPr/>
          </p:nvCxnSpPr>
          <p:spPr>
            <a:xfrm>
              <a:off x="5791784" y="3411085"/>
              <a:ext cx="0" cy="1917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3" name="TextBox 302"/>
            <p:cNvSpPr txBox="1"/>
            <p:nvPr/>
          </p:nvSpPr>
          <p:spPr>
            <a:xfrm>
              <a:off x="5817275" y="3360380"/>
              <a:ext cx="1087595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w variant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4" name="Rectangle 303"/>
          <p:cNvSpPr/>
          <p:nvPr/>
        </p:nvSpPr>
        <p:spPr>
          <a:xfrm>
            <a:off x="266640" y="9202042"/>
            <a:ext cx="6382353" cy="70788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spcBef>
                <a:spcPts val="1200"/>
              </a:spcBef>
            </a:pPr>
            <a:r>
              <a:rPr lang="en-US" sz="10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phylogenetic tree based on the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hole-genome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of the NDV class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I. The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e was constructed in MEGA7 v 7.0.23 using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imum-likelihood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od based on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ral time reversible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del with 1,000 bootstrap replicates. The dataset contains 64 taxa including three Congo </a:t>
            </a:r>
            <a:r>
              <a:rPr lang="en-US" sz="10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s which are </a:t>
            </a:r>
            <a:r>
              <a:rPr lang="en-US" sz="1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dicated in red.</a:t>
            </a:r>
          </a:p>
        </p:txBody>
      </p:sp>
    </p:spTree>
    <p:extLst>
      <p:ext uri="{BB962C8B-B14F-4D97-AF65-F5344CB8AC3E}">
        <p14:creationId xmlns:p14="http://schemas.microsoft.com/office/powerpoint/2010/main" val="16675347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470</Words>
  <Application>Microsoft Office PowerPoint</Application>
  <PresentationFormat>A4 Paper (210x297 mm)</PresentationFormat>
  <Paragraphs>13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gustin Twabela</dc:creator>
  <cp:lastModifiedBy>Augustin Twabela</cp:lastModifiedBy>
  <cp:revision>12</cp:revision>
  <dcterms:created xsi:type="dcterms:W3CDTF">2020-11-20T11:35:12Z</dcterms:created>
  <dcterms:modified xsi:type="dcterms:W3CDTF">2021-01-10T10:47:08Z</dcterms:modified>
</cp:coreProperties>
</file>